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diagrams/data3.xml" ContentType="application/vnd.openxmlformats-officedocument.drawingml.diagramData+xml"/>
  <Override PartName="/ppt/diagrams/layout3.xml" ContentType="application/vnd.openxmlformats-officedocument.drawingml.diagramLayout+xml"/>
  <Override PartName="/ppt/diagrams/quickStyle3.xml" ContentType="application/vnd.openxmlformats-officedocument.drawingml.diagramStyle+xml"/>
  <Override PartName="/ppt/diagrams/colors3.xml" ContentType="application/vnd.openxmlformats-officedocument.drawingml.diagramColors+xml"/>
  <Override PartName="/ppt/diagrams/drawing3.xml" ContentType="application/vnd.ms-office.drawingml.diagramDrawing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diagrams/data4.xml" ContentType="application/vnd.openxmlformats-officedocument.drawingml.diagramData+xml"/>
  <Override PartName="/ppt/diagrams/layout4.xml" ContentType="application/vnd.openxmlformats-officedocument.drawingml.diagramLayout+xml"/>
  <Override PartName="/ppt/diagrams/quickStyle4.xml" ContentType="application/vnd.openxmlformats-officedocument.drawingml.diagramStyle+xml"/>
  <Override PartName="/ppt/diagrams/colors4.xml" ContentType="application/vnd.openxmlformats-officedocument.drawingml.diagramColors+xml"/>
  <Override PartName="/ppt/diagrams/drawing4.xml" ContentType="application/vnd.ms-office.drawingml.diagramDrawing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ppt/diagrams/data5.xml" ContentType="application/vnd.openxmlformats-officedocument.drawingml.diagramData+xml"/>
  <Override PartName="/ppt/diagrams/layout5.xml" ContentType="application/vnd.openxmlformats-officedocument.drawingml.diagramLayout+xml"/>
  <Override PartName="/ppt/diagrams/quickStyle5.xml" ContentType="application/vnd.openxmlformats-officedocument.drawingml.diagramStyle+xml"/>
  <Override PartName="/ppt/diagrams/colors5.xml" ContentType="application/vnd.openxmlformats-officedocument.drawingml.diagramColors+xml"/>
  <Override PartName="/ppt/diagrams/drawing5.xml" ContentType="application/vnd.ms-office.drawingml.diagramDrawing+xml"/>
  <Override PartName="/ppt/notesSlides/notesSlide26.xml" ContentType="application/vnd.openxmlformats-officedocument.presentationml.notesSlide+xml"/>
  <Override PartName="/ppt/diagrams/data6.xml" ContentType="application/vnd.openxmlformats-officedocument.drawingml.diagramData+xml"/>
  <Override PartName="/ppt/diagrams/layout6.xml" ContentType="application/vnd.openxmlformats-officedocument.drawingml.diagramLayout+xml"/>
  <Override PartName="/ppt/diagrams/quickStyle6.xml" ContentType="application/vnd.openxmlformats-officedocument.drawingml.diagramStyle+xml"/>
  <Override PartName="/ppt/diagrams/colors6.xml" ContentType="application/vnd.openxmlformats-officedocument.drawingml.diagramColors+xml"/>
  <Override PartName="/ppt/diagrams/drawing6.xml" ContentType="application/vnd.ms-office.drawingml.diagramDrawing+xml"/>
  <Override PartName="/ppt/notesSlides/notesSlide27.xml" ContentType="application/vnd.openxmlformats-officedocument.presentationml.notesSlide+xml"/>
  <Override PartName="/ppt/diagrams/data7.xml" ContentType="application/vnd.openxmlformats-officedocument.drawingml.diagramData+xml"/>
  <Override PartName="/ppt/diagrams/layout7.xml" ContentType="application/vnd.openxmlformats-officedocument.drawingml.diagramLayout+xml"/>
  <Override PartName="/ppt/diagrams/quickStyle7.xml" ContentType="application/vnd.openxmlformats-officedocument.drawingml.diagramStyle+xml"/>
  <Override PartName="/ppt/diagrams/colors7.xml" ContentType="application/vnd.openxmlformats-officedocument.drawingml.diagramColors+xml"/>
  <Override PartName="/ppt/diagrams/drawing7.xml" ContentType="application/vnd.ms-office.drawingml.diagramDrawing+xml"/>
  <Override PartName="/ppt/notesSlides/notesSlide28.xml" ContentType="application/vnd.openxmlformats-officedocument.presentationml.notesSlide+xml"/>
  <Override PartName="/ppt/diagrams/data8.xml" ContentType="application/vnd.openxmlformats-officedocument.drawingml.diagramData+xml"/>
  <Override PartName="/ppt/diagrams/layout8.xml" ContentType="application/vnd.openxmlformats-officedocument.drawingml.diagramLayout+xml"/>
  <Override PartName="/ppt/diagrams/quickStyle8.xml" ContentType="application/vnd.openxmlformats-officedocument.drawingml.diagramStyle+xml"/>
  <Override PartName="/ppt/diagrams/colors8.xml" ContentType="application/vnd.openxmlformats-officedocument.drawingml.diagramColors+xml"/>
  <Override PartName="/ppt/diagrams/drawing8.xml" ContentType="application/vnd.ms-office.drawingml.diagramDrawing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5" r:id="rId1"/>
  </p:sldMasterIdLst>
  <p:notesMasterIdLst>
    <p:notesMasterId r:id="rId39"/>
  </p:notesMasterIdLst>
  <p:handoutMasterIdLst>
    <p:handoutMasterId r:id="rId40"/>
  </p:handoutMasterIdLst>
  <p:sldIdLst>
    <p:sldId id="378" r:id="rId2"/>
    <p:sldId id="377" r:id="rId3"/>
    <p:sldId id="379" r:id="rId4"/>
    <p:sldId id="318" r:id="rId5"/>
    <p:sldId id="316" r:id="rId6"/>
    <p:sldId id="380" r:id="rId7"/>
    <p:sldId id="382" r:id="rId8"/>
    <p:sldId id="385" r:id="rId9"/>
    <p:sldId id="409" r:id="rId10"/>
    <p:sldId id="373" r:id="rId11"/>
    <p:sldId id="388" r:id="rId12"/>
    <p:sldId id="386" r:id="rId13"/>
    <p:sldId id="410" r:id="rId14"/>
    <p:sldId id="389" r:id="rId15"/>
    <p:sldId id="390" r:id="rId16"/>
    <p:sldId id="391" r:id="rId17"/>
    <p:sldId id="392" r:id="rId18"/>
    <p:sldId id="393" r:id="rId19"/>
    <p:sldId id="415" r:id="rId20"/>
    <p:sldId id="358" r:id="rId21"/>
    <p:sldId id="394" r:id="rId22"/>
    <p:sldId id="395" r:id="rId23"/>
    <p:sldId id="367" r:id="rId24"/>
    <p:sldId id="396" r:id="rId25"/>
    <p:sldId id="397" r:id="rId26"/>
    <p:sldId id="398" r:id="rId27"/>
    <p:sldId id="362" r:id="rId28"/>
    <p:sldId id="399" r:id="rId29"/>
    <p:sldId id="400" r:id="rId30"/>
    <p:sldId id="401" r:id="rId31"/>
    <p:sldId id="402" r:id="rId32"/>
    <p:sldId id="411" r:id="rId33"/>
    <p:sldId id="412" r:id="rId34"/>
    <p:sldId id="405" r:id="rId35"/>
    <p:sldId id="416" r:id="rId36"/>
    <p:sldId id="406" r:id="rId37"/>
    <p:sldId id="407" r:id="rId38"/>
  </p:sldIdLst>
  <p:sldSz cx="9144000" cy="6858000" type="screen4x3"/>
  <p:notesSz cx="6858000" cy="18859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9">
          <p15:clr>
            <a:srgbClr val="A4A3A4"/>
          </p15:clr>
        </p15:guide>
        <p15:guide id="2" orient="horz" pos="791">
          <p15:clr>
            <a:srgbClr val="A4A3A4"/>
          </p15:clr>
        </p15:guide>
        <p15:guide id="3" orient="horz" pos="865">
          <p15:clr>
            <a:srgbClr val="A4A3A4"/>
          </p15:clr>
        </p15:guide>
        <p15:guide id="4" orient="horz" pos="2390">
          <p15:clr>
            <a:srgbClr val="A4A3A4"/>
          </p15:clr>
        </p15:guide>
        <p15:guide id="5" orient="horz" pos="4176">
          <p15:clr>
            <a:srgbClr val="A4A3A4"/>
          </p15:clr>
        </p15:guide>
        <p15:guide id="6" orient="horz" pos="2216">
          <p15:clr>
            <a:srgbClr val="A4A3A4"/>
          </p15:clr>
        </p15:guide>
        <p15:guide id="7" orient="horz" pos="3743">
          <p15:clr>
            <a:srgbClr val="A4A3A4"/>
          </p15:clr>
        </p15:guide>
        <p15:guide id="8" pos="3861">
          <p15:clr>
            <a:srgbClr val="A4A3A4"/>
          </p15:clr>
        </p15:guide>
        <p15:guide id="9" pos="289">
          <p15:clr>
            <a:srgbClr val="A4A3A4"/>
          </p15:clr>
        </p15:guide>
        <p15:guide id="10" pos="2967">
          <p15:clr>
            <a:srgbClr val="A4A3A4"/>
          </p15:clr>
        </p15:guide>
        <p15:guide id="11" pos="2076">
          <p15:clr>
            <a:srgbClr val="A4A3A4"/>
          </p15:clr>
        </p15:guide>
        <p15:guide id="12" pos="5472">
          <p15:clr>
            <a:srgbClr val="A4A3A4"/>
          </p15:clr>
        </p15:guide>
        <p15:guide id="13" pos="3686">
          <p15:clr>
            <a:srgbClr val="A4A3A4"/>
          </p15:clr>
        </p15:guide>
        <p15:guide id="14" pos="2793">
          <p15:clr>
            <a:srgbClr val="A4A3A4"/>
          </p15:clr>
        </p15:guide>
        <p15:guide id="15" pos="190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DF38852-D8F3-3ED9-0121-8F25B1650653}" name="janice.john@einsteinmed.edu" initials="ja" userId="S::urn:spo:guest#janice.john@einsteinmed.edu::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ferran2" initials="m" lastIdx="3" clrIdx="0"/>
  <p:cmAuthor id="2" name="Gabrielle Goldberg" initials="GG" lastIdx="1" clrIdx="1">
    <p:extLst>
      <p:ext uri="{19B8F6BF-5375-455C-9EA6-DF929625EA0E}">
        <p15:presenceInfo xmlns:p15="http://schemas.microsoft.com/office/powerpoint/2012/main" userId="S::gabrielle.goldberg@hofstra.edu::453f9b71-f7a4-4ef4-8e34-bbb69381dfc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ADF"/>
    <a:srgbClr val="C445BA"/>
    <a:srgbClr val="C44598"/>
    <a:srgbClr val="003CA5"/>
    <a:srgbClr val="040404"/>
    <a:srgbClr val="5C0B8A"/>
    <a:srgbClr val="53565A"/>
    <a:srgbClr val="3DAD2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725FC9E-835C-9DC7-8C18-022E0D0559A7}" v="475" dt="2022-04-21T22:06:30.774"/>
    <p1510:client id="{3BE28A49-DE09-4B0E-C28A-EC34D5DAC9C7}" v="479" dt="2022-04-14T19:18:57.849"/>
    <p1510:client id="{7903C268-2EAB-6D07-F8B3-9736B7DAA888}" v="100" dt="2022-04-15T14:40:25.818"/>
    <p1510:client id="{C0851F70-746E-114D-D8A1-FFA033B3D2BE}" v="95" dt="2022-04-13T13:41:43.689"/>
    <p1510:client id="{E57302F7-145D-B7B9-E787-24930494F588}" v="7" dt="2022-04-19T22:53:11.421"/>
    <p1510:client id="{F4B2A369-8FBD-487F-8ABD-0045CE3772B1}" v="9" dt="2022-04-13T14:10:00.69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091"/>
    <p:restoredTop sz="94694"/>
  </p:normalViewPr>
  <p:slideViewPr>
    <p:cSldViewPr snapToGrid="0">
      <p:cViewPr varScale="1">
        <p:scale>
          <a:sx n="121" d="100"/>
          <a:sy n="121" d="100"/>
        </p:scale>
        <p:origin x="2080" y="176"/>
      </p:cViewPr>
      <p:guideLst>
        <p:guide orient="horz" pos="289"/>
        <p:guide orient="horz" pos="791"/>
        <p:guide orient="horz" pos="865"/>
        <p:guide orient="horz" pos="2390"/>
        <p:guide orient="horz" pos="4176"/>
        <p:guide orient="horz" pos="2216"/>
        <p:guide orient="horz" pos="3743"/>
        <p:guide pos="3861"/>
        <p:guide pos="289"/>
        <p:guide pos="2967"/>
        <p:guide pos="2076"/>
        <p:guide pos="5472"/>
        <p:guide pos="3686"/>
        <p:guide pos="2793"/>
        <p:guide pos="190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notesMaster" Target="notesMasters/notesMaster1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presProps" Target="presProps.xml"/><Relationship Id="rId47" Type="http://schemas.microsoft.com/office/2015/10/relationships/revisionInfo" Target="revisionInfo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handoutMaster" Target="handoutMasters/handoutMaster1.xml"/><Relationship Id="rId45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viewProps" Target="viewProps.xml"/><Relationship Id="rId48" Type="http://schemas.microsoft.com/office/2018/10/relationships/authors" Target="authors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microsoft.com/office/2016/11/relationships/changesInfo" Target="changesInfos/changesInfo1.xml"/><Relationship Id="rId20" Type="http://schemas.openxmlformats.org/officeDocument/2006/relationships/slide" Target="slides/slide19.xml"/><Relationship Id="rId41" Type="http://schemas.openxmlformats.org/officeDocument/2006/relationships/commentAuthors" Target="comment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uest User" userId="S::urn:spo:anon#4cf4838ef0fbf4d0dba1e40ac72942b61102bea1b1689e895975c57b98f5ef34::" providerId="AD" clId="Web-{8AC892C6-623F-76D3-DDC4-5C07BAFDBDBE}"/>
    <pc:docChg chg="modSld">
      <pc:chgData name="Guest User" userId="S::urn:spo:anon#4cf4838ef0fbf4d0dba1e40ac72942b61102bea1b1689e895975c57b98f5ef34::" providerId="AD" clId="Web-{8AC892C6-623F-76D3-DDC4-5C07BAFDBDBE}" dt="2022-01-08T14:22:43.382" v="0" actId="14100"/>
      <pc:docMkLst>
        <pc:docMk/>
      </pc:docMkLst>
      <pc:sldChg chg="modSp">
        <pc:chgData name="Guest User" userId="S::urn:spo:anon#4cf4838ef0fbf4d0dba1e40ac72942b61102bea1b1689e895975c57b98f5ef34::" providerId="AD" clId="Web-{8AC892C6-623F-76D3-DDC4-5C07BAFDBDBE}" dt="2022-01-08T14:22:43.382" v="0" actId="14100"/>
        <pc:sldMkLst>
          <pc:docMk/>
          <pc:sldMk cId="3695886494" sldId="377"/>
        </pc:sldMkLst>
        <pc:spChg chg="mod">
          <ac:chgData name="Guest User" userId="S::urn:spo:anon#4cf4838ef0fbf4d0dba1e40ac72942b61102bea1b1689e895975c57b98f5ef34::" providerId="AD" clId="Web-{8AC892C6-623F-76D3-DDC4-5C07BAFDBDBE}" dt="2022-01-08T14:22:43.382" v="0" actId="14100"/>
          <ac:spMkLst>
            <pc:docMk/>
            <pc:sldMk cId="3695886494" sldId="377"/>
            <ac:spMk id="5" creationId="{7CACB6FB-1027-4FD0-8C7E-D2E2B4263D4D}"/>
          </ac:spMkLst>
        </pc:spChg>
      </pc:sldChg>
    </pc:docChg>
  </pc:docChgLst>
  <pc:docChgLst>
    <pc:chgData name="Solis, Gabriela" userId="S::gsolis_northwell.edu#ext#@hofstra.edu::198dd0ac-6fb3-4b59-b455-eeb2e8da8c00" providerId="AD" clId="Web-{2016D851-910C-402B-87A1-F700B08DAEEA}"/>
    <pc:docChg chg="addSld delSld modSld addMainMaster delMainMaster modMainMaster">
      <pc:chgData name="Solis, Gabriela" userId="S::gsolis_northwell.edu#ext#@hofstra.edu::198dd0ac-6fb3-4b59-b455-eeb2e8da8c00" providerId="AD" clId="Web-{2016D851-910C-402B-87A1-F700B08DAEEA}" dt="2021-07-18T15:58:53.495" v="306" actId="14100"/>
      <pc:docMkLst>
        <pc:docMk/>
      </pc:docMkLst>
      <pc:sldChg chg="addSp delSp modSp del mod setBg modClrScheme addAnim delAnim delDesignElem chgLayout">
        <pc:chgData name="Solis, Gabriela" userId="S::gsolis_northwell.edu#ext#@hofstra.edu::198dd0ac-6fb3-4b59-b455-eeb2e8da8c00" providerId="AD" clId="Web-{2016D851-910C-402B-87A1-F700B08DAEEA}" dt="2021-07-18T15:37:51.703" v="71"/>
        <pc:sldMkLst>
          <pc:docMk/>
          <pc:sldMk cId="2655814267" sldId="280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2655814267" sldId="280"/>
            <ac:spMk id="2" creationId="{00000000-0000-0000-0000-000000000000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31:38.316" v="52"/>
          <ac:spMkLst>
            <pc:docMk/>
            <pc:sldMk cId="2655814267" sldId="280"/>
            <ac:spMk id="4" creationId="{4522B21E-B2B9-4C72-9A71-C87EFD137480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31:38.316" v="52"/>
          <ac:spMkLst>
            <pc:docMk/>
            <pc:sldMk cId="2655814267" sldId="280"/>
            <ac:spMk id="5" creationId="{5EB7D2A2-F448-44D4-938C-DC84CBCB3B1E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31:38.316" v="52"/>
          <ac:spMkLst>
            <pc:docMk/>
            <pc:sldMk cId="2655814267" sldId="280"/>
            <ac:spMk id="6" creationId="{871AEA07-1E14-44B4-8E55-64EF049CD66F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28:39.435" v="40"/>
          <ac:spMkLst>
            <pc:docMk/>
            <pc:sldMk cId="2655814267" sldId="280"/>
            <ac:spMk id="7" creationId="{B26EE4FD-480F-42A5-9FEB-DA630457CFB7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28:39.435" v="40"/>
          <ac:spMkLst>
            <pc:docMk/>
            <pc:sldMk cId="2655814267" sldId="280"/>
            <ac:spMk id="9" creationId="{A187062F-BE14-42FC-B06A-607DB23849C3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32:24.052" v="58"/>
          <ac:spMkLst>
            <pc:docMk/>
            <pc:sldMk cId="2655814267" sldId="280"/>
            <ac:spMk id="10" creationId="{4522B21E-B2B9-4C72-9A71-C87EFD137480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28:39.435" v="40"/>
          <ac:spMkLst>
            <pc:docMk/>
            <pc:sldMk cId="2655814267" sldId="280"/>
            <ac:spMk id="11" creationId="{731FE21B-2A45-4BF5-8B03-E12341988774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32:24.052" v="58"/>
          <ac:spMkLst>
            <pc:docMk/>
            <pc:sldMk cId="2655814267" sldId="280"/>
            <ac:spMk id="12" creationId="{5EB7D2A2-F448-44D4-938C-DC84CBCB3B1E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28:39.435" v="40"/>
          <ac:spMkLst>
            <pc:docMk/>
            <pc:sldMk cId="2655814267" sldId="280"/>
            <ac:spMk id="13" creationId="{2DC5A94D-79ED-48F5-9DC5-96CBB507CEC8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28:39.435" v="40"/>
          <ac:spMkLst>
            <pc:docMk/>
            <pc:sldMk cId="2655814267" sldId="280"/>
            <ac:spMk id="15" creationId="{93A3D4BE-AF25-4F9A-9C29-1145CCE24A28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32:24.052" v="58"/>
          <ac:spMkLst>
            <pc:docMk/>
            <pc:sldMk cId="2655814267" sldId="280"/>
            <ac:spMk id="17" creationId="{871AEA07-1E14-44B4-8E55-64EF049CD66F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2655814267" sldId="280"/>
            <ac:spMk id="21" creationId="{934F1179-B481-4F9E-BCA3-AFB972070F83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2655814267" sldId="280"/>
            <ac:spMk id="22" creationId="{827DC2C4-B485-428A-BF4A-472D2967F47F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2655814267" sldId="280"/>
            <ac:spMk id="23" creationId="{EE04B5EB-F158-4507-90DD-BD23620C7CC9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32:24.036" v="57"/>
          <ac:spMkLst>
            <pc:docMk/>
            <pc:sldMk cId="2655814267" sldId="280"/>
            <ac:spMk id="24" creationId="{FFD48BC7-DC40-47DE-87EE-9F4B6ECB9ABB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32:24.036" v="57"/>
          <ac:spMkLst>
            <pc:docMk/>
            <pc:sldMk cId="2655814267" sldId="280"/>
            <ac:spMk id="26" creationId="{E502BBC7-2C76-46F3-BC24-5985BC13DB88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32:24.036" v="57"/>
          <ac:spMkLst>
            <pc:docMk/>
            <pc:sldMk cId="2655814267" sldId="280"/>
            <ac:spMk id="28" creationId="{C7F28D52-2A5F-4D23-81AE-7CB8B591C7AF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32:24.036" v="57"/>
          <ac:spMkLst>
            <pc:docMk/>
            <pc:sldMk cId="2655814267" sldId="280"/>
            <ac:spMk id="30" creationId="{3629484E-3792-4B3D-89AD-7C8A1ED0E0D4}"/>
          </ac:spMkLst>
        </pc:spChg>
        <pc:cxnChg chg="add del">
          <ac:chgData name="Solis, Gabriela" userId="S::gsolis_northwell.edu#ext#@hofstra.edu::198dd0ac-6fb3-4b59-b455-eeb2e8da8c00" providerId="AD" clId="Web-{2016D851-910C-402B-87A1-F700B08DAEEA}" dt="2021-07-18T15:31:38.316" v="52"/>
          <ac:cxnSpMkLst>
            <pc:docMk/>
            <pc:sldMk cId="2655814267" sldId="280"/>
            <ac:cxnSpMk id="8" creationId="{F7C8EA93-3210-4C62-99E9-153C275E3A87}"/>
          </ac:cxnSpMkLst>
        </pc:cxnChg>
        <pc:cxnChg chg="add del">
          <ac:chgData name="Solis, Gabriela" userId="S::gsolis_northwell.edu#ext#@hofstra.edu::198dd0ac-6fb3-4b59-b455-eeb2e8da8c00" providerId="AD" clId="Web-{2016D851-910C-402B-87A1-F700B08DAEEA}" dt="2021-07-18T15:32:24.052" v="58"/>
          <ac:cxnSpMkLst>
            <pc:docMk/>
            <pc:sldMk cId="2655814267" sldId="280"/>
            <ac:cxnSpMk id="19" creationId="{F7C8EA93-3210-4C62-99E9-153C275E3A87}"/>
          </ac:cxnSpMkLst>
        </pc:cxnChg>
      </pc:sldChg>
      <pc:sldChg chg="modSp mod modClrScheme chgLayout">
        <pc:chgData name="Solis, Gabriela" userId="S::gsolis_northwell.edu#ext#@hofstra.edu::198dd0ac-6fb3-4b59-b455-eeb2e8da8c00" providerId="AD" clId="Web-{2016D851-910C-402B-87A1-F700B08DAEEA}" dt="2021-07-18T15:55:22.676" v="259" actId="20577"/>
        <pc:sldMkLst>
          <pc:docMk/>
          <pc:sldMk cId="1780732845" sldId="306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1780732845" sldId="306"/>
            <ac:spMk id="2" creationId="{00000000-0000-0000-0000-000000000000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1780732845" sldId="306"/>
            <ac:spMk id="3" creationId="{00000000-0000-0000-0000-000000000000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1780732845" sldId="306"/>
            <ac:spMk id="5" creationId="{FB3F74D2-1709-4488-9D0C-E4A818C1E9F6}"/>
          </ac:spMkLst>
        </pc:spChg>
        <pc:spChg chg="mod">
          <ac:chgData name="Solis, Gabriela" userId="S::gsolis_northwell.edu#ext#@hofstra.edu::198dd0ac-6fb3-4b59-b455-eeb2e8da8c00" providerId="AD" clId="Web-{2016D851-910C-402B-87A1-F700B08DAEEA}" dt="2021-07-18T15:55:22.676" v="259" actId="20577"/>
          <ac:spMkLst>
            <pc:docMk/>
            <pc:sldMk cId="1780732845" sldId="306"/>
            <ac:spMk id="7" creationId="{5FE5DD88-5FB5-43EA-B299-9C54E6115FE3}"/>
          </ac:spMkLst>
        </pc:spChg>
      </pc:sldChg>
      <pc:sldChg chg="modSp mod modClrScheme chgLayout">
        <pc:chgData name="Solis, Gabriela" userId="S::gsolis_northwell.edu#ext#@hofstra.edu::198dd0ac-6fb3-4b59-b455-eeb2e8da8c00" providerId="AD" clId="Web-{2016D851-910C-402B-87A1-F700B08DAEEA}" dt="2021-07-18T15:35:51.294" v="68"/>
        <pc:sldMkLst>
          <pc:docMk/>
          <pc:sldMk cId="3894987403" sldId="307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3894987403" sldId="307"/>
            <ac:spMk id="2" creationId="{00000000-0000-0000-0000-000000000000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3894987403" sldId="307"/>
            <ac:spMk id="3" creationId="{00000000-0000-0000-0000-000000000000}"/>
          </ac:spMkLst>
        </pc:spChg>
      </pc:sldChg>
      <pc:sldChg chg="addSp delSp modSp mod modClrScheme chgLayout">
        <pc:chgData name="Solis, Gabriela" userId="S::gsolis_northwell.edu#ext#@hofstra.edu::198dd0ac-6fb3-4b59-b455-eeb2e8da8c00" providerId="AD" clId="Web-{2016D851-910C-402B-87A1-F700B08DAEEA}" dt="2021-07-18T15:44:35.627" v="154" actId="20577"/>
        <pc:sldMkLst>
          <pc:docMk/>
          <pc:sldMk cId="659258882" sldId="316"/>
        </pc:sldMkLst>
        <pc:spChg chg="mod ord">
          <ac:chgData name="Solis, Gabriela" userId="S::gsolis_northwell.edu#ext#@hofstra.edu::198dd0ac-6fb3-4b59-b455-eeb2e8da8c00" providerId="AD" clId="Web-{2016D851-910C-402B-87A1-F700B08DAEEA}" dt="2021-07-18T15:44:35.627" v="154" actId="20577"/>
          <ac:spMkLst>
            <pc:docMk/>
            <pc:sldMk cId="659258882" sldId="316"/>
            <ac:spMk id="2" creationId="{00000000-0000-0000-0000-000000000000}"/>
          </ac:spMkLst>
        </pc:spChg>
        <pc:spChg chg="add del mod">
          <ac:chgData name="Solis, Gabriela" userId="S::gsolis_northwell.edu#ext#@hofstra.edu::198dd0ac-6fb3-4b59-b455-eeb2e8da8c00" providerId="AD" clId="Web-{2016D851-910C-402B-87A1-F700B08DAEEA}" dt="2021-07-18T15:17:34.104" v="17"/>
          <ac:spMkLst>
            <pc:docMk/>
            <pc:sldMk cId="659258882" sldId="316"/>
            <ac:spMk id="4" creationId="{EF667105-0092-409D-9857-A40269E13758}"/>
          </ac:spMkLst>
        </pc:spChg>
        <pc:picChg chg="add mod ord">
          <ac:chgData name="Solis, Gabriela" userId="S::gsolis_northwell.edu#ext#@hofstra.edu::198dd0ac-6fb3-4b59-b455-eeb2e8da8c00" providerId="AD" clId="Web-{2016D851-910C-402B-87A1-F700B08DAEEA}" dt="2021-07-18T15:35:51.294" v="68"/>
          <ac:picMkLst>
            <pc:docMk/>
            <pc:sldMk cId="659258882" sldId="316"/>
            <ac:picMk id="5" creationId="{CDF35EC7-FE28-4B97-99F5-11B79C9B045A}"/>
          </ac:picMkLst>
        </pc:picChg>
        <pc:picChg chg="del mod ord">
          <ac:chgData name="Solis, Gabriela" userId="S::gsolis_northwell.edu#ext#@hofstra.edu::198dd0ac-6fb3-4b59-b455-eeb2e8da8c00" providerId="AD" clId="Web-{2016D851-910C-402B-87A1-F700B08DAEEA}" dt="2021-07-18T15:17:04.509" v="16"/>
          <ac:picMkLst>
            <pc:docMk/>
            <pc:sldMk cId="659258882" sldId="316"/>
            <ac:picMk id="7" creationId="{00000000-0000-0000-0000-000000000000}"/>
          </ac:picMkLst>
        </pc:picChg>
      </pc:sldChg>
      <pc:sldChg chg="addSp delSp modSp del mod modClrScheme chgLayout">
        <pc:chgData name="Solis, Gabriela" userId="S::gsolis_northwell.edu#ext#@hofstra.edu::198dd0ac-6fb3-4b59-b455-eeb2e8da8c00" providerId="AD" clId="Web-{2016D851-910C-402B-87A1-F700B08DAEEA}" dt="2021-07-18T15:46:00.363" v="169"/>
        <pc:sldMkLst>
          <pc:docMk/>
          <pc:sldMk cId="1324940015" sldId="317"/>
        </pc:sldMkLst>
        <pc:spChg chg="add del mod">
          <ac:chgData name="Solis, Gabriela" userId="S::gsolis_northwell.edu#ext#@hofstra.edu::198dd0ac-6fb3-4b59-b455-eeb2e8da8c00" providerId="AD" clId="Web-{2016D851-910C-402B-87A1-F700B08DAEEA}" dt="2021-07-18T15:25:05.491" v="21"/>
          <ac:spMkLst>
            <pc:docMk/>
            <pc:sldMk cId="1324940015" sldId="317"/>
            <ac:spMk id="3" creationId="{32EA3110-1E00-4477-8838-CE54F018D313}"/>
          </ac:spMkLst>
        </pc:spChg>
        <pc:spChg chg="add del mod">
          <ac:chgData name="Solis, Gabriela" userId="S::gsolis_northwell.edu#ext#@hofstra.edu::198dd0ac-6fb3-4b59-b455-eeb2e8da8c00" providerId="AD" clId="Web-{2016D851-910C-402B-87A1-F700B08DAEEA}" dt="2021-07-18T15:25:00.663" v="20"/>
          <ac:spMkLst>
            <pc:docMk/>
            <pc:sldMk cId="1324940015" sldId="317"/>
            <ac:spMk id="5" creationId="{B908E605-1A66-4A9C-8C39-CD3D77EB62E9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1324940015" sldId="317"/>
            <ac:spMk id="18434" creationId="{00000000-0000-0000-0000-000000000000}"/>
          </ac:spMkLst>
        </pc:spChg>
        <pc:spChg chg="del">
          <ac:chgData name="Solis, Gabriela" userId="S::gsolis_northwell.edu#ext#@hofstra.edu::198dd0ac-6fb3-4b59-b455-eeb2e8da8c00" providerId="AD" clId="Web-{2016D851-910C-402B-87A1-F700B08DAEEA}" dt="2021-07-18T15:25:49.289" v="30"/>
          <ac:spMkLst>
            <pc:docMk/>
            <pc:sldMk cId="1324940015" sldId="317"/>
            <ac:spMk id="18436" creationId="{00000000-0000-0000-0000-000000000000}"/>
          </ac:spMkLst>
        </pc:spChg>
        <pc:graphicFrameChg chg="del mod ord">
          <ac:chgData name="Solis, Gabriela" userId="S::gsolis_northwell.edu#ext#@hofstra.edu::198dd0ac-6fb3-4b59-b455-eeb2e8da8c00" providerId="AD" clId="Web-{2016D851-910C-402B-87A1-F700B08DAEEA}" dt="2021-07-18T15:24:51.882" v="18"/>
          <ac:graphicFrameMkLst>
            <pc:docMk/>
            <pc:sldMk cId="1324940015" sldId="317"/>
            <ac:graphicFrameMk id="7" creationId="{00000000-0000-0000-0000-000000000000}"/>
          </ac:graphicFrameMkLst>
        </pc:graphicFrameChg>
        <pc:graphicFrameChg chg="del mod ord">
          <ac:chgData name="Solis, Gabriela" userId="S::gsolis_northwell.edu#ext#@hofstra.edu::198dd0ac-6fb3-4b59-b455-eeb2e8da8c00" providerId="AD" clId="Web-{2016D851-910C-402B-87A1-F700B08DAEEA}" dt="2021-07-18T15:24:53.632" v="19"/>
          <ac:graphicFrameMkLst>
            <pc:docMk/>
            <pc:sldMk cId="1324940015" sldId="317"/>
            <ac:graphicFrameMk id="11" creationId="{00000000-0000-0000-0000-000000000000}"/>
          </ac:graphicFrameMkLst>
        </pc:graphicFrameChg>
        <pc:picChg chg="add mod ord">
          <ac:chgData name="Solis, Gabriela" userId="S::gsolis_northwell.edu#ext#@hofstra.edu::198dd0ac-6fb3-4b59-b455-eeb2e8da8c00" providerId="AD" clId="Web-{2016D851-910C-402B-87A1-F700B08DAEEA}" dt="2021-07-18T15:35:51.294" v="68"/>
          <ac:picMkLst>
            <pc:docMk/>
            <pc:sldMk cId="1324940015" sldId="317"/>
            <ac:picMk id="6" creationId="{AFC830DA-EB1D-4E23-AA25-DFCDFE9E4B1A}"/>
          </ac:picMkLst>
        </pc:picChg>
      </pc:sldChg>
      <pc:sldChg chg="modSp mod modClrScheme chgLayout">
        <pc:chgData name="Solis, Gabriela" userId="S::gsolis_northwell.edu#ext#@hofstra.edu::198dd0ac-6fb3-4b59-b455-eeb2e8da8c00" providerId="AD" clId="Web-{2016D851-910C-402B-87A1-F700B08DAEEA}" dt="2021-07-18T15:43:56.172" v="146" actId="20577"/>
        <pc:sldMkLst>
          <pc:docMk/>
          <pc:sldMk cId="3061336521" sldId="318"/>
        </pc:sldMkLst>
        <pc:spChg chg="mod ord">
          <ac:chgData name="Solis, Gabriela" userId="S::gsolis_northwell.edu#ext#@hofstra.edu::198dd0ac-6fb3-4b59-b455-eeb2e8da8c00" providerId="AD" clId="Web-{2016D851-910C-402B-87A1-F700B08DAEEA}" dt="2021-07-18T15:43:56.172" v="146" actId="20577"/>
          <ac:spMkLst>
            <pc:docMk/>
            <pc:sldMk cId="3061336521" sldId="318"/>
            <ac:spMk id="2" creationId="{00000000-0000-0000-0000-000000000000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3061336521" sldId="318"/>
            <ac:spMk id="6" creationId="{00000000-0000-0000-0000-000000000000}"/>
          </ac:spMkLst>
        </pc:spChg>
      </pc:sldChg>
      <pc:sldChg chg="modSp del mod modClrScheme chgLayout">
        <pc:chgData name="Solis, Gabriela" userId="S::gsolis_northwell.edu#ext#@hofstra.edu::198dd0ac-6fb3-4b59-b455-eeb2e8da8c00" providerId="AD" clId="Web-{2016D851-910C-402B-87A1-F700B08DAEEA}" dt="2021-07-18T15:43:41.844" v="143"/>
        <pc:sldMkLst>
          <pc:docMk/>
          <pc:sldMk cId="433975252" sldId="323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433975252" sldId="323"/>
            <ac:spMk id="3" creationId="{00000000-0000-0000-0000-000000000000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433975252" sldId="323"/>
            <ac:spMk id="4" creationId="{00000000-0000-0000-0000-000000000000}"/>
          </ac:spMkLst>
        </pc:spChg>
      </pc:sldChg>
      <pc:sldChg chg="modSp del mod modClrScheme chgLayout">
        <pc:chgData name="Solis, Gabriela" userId="S::gsolis_northwell.edu#ext#@hofstra.edu::198dd0ac-6fb3-4b59-b455-eeb2e8da8c00" providerId="AD" clId="Web-{2016D851-910C-402B-87A1-F700B08DAEEA}" dt="2021-07-18T15:51:14.560" v="226"/>
        <pc:sldMkLst>
          <pc:docMk/>
          <pc:sldMk cId="2417005009" sldId="330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2417005009" sldId="330"/>
            <ac:spMk id="2" creationId="{00000000-0000-0000-0000-000000000000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2417005009" sldId="330"/>
            <ac:spMk id="3" creationId="{00000000-0000-0000-0000-000000000000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2417005009" sldId="330"/>
            <ac:spMk id="5" creationId="{00000000-0000-0000-0000-000000000000}"/>
          </ac:spMkLst>
        </pc:spChg>
      </pc:sldChg>
      <pc:sldChg chg="modSp mod modClrScheme chgLayout">
        <pc:chgData name="Solis, Gabriela" userId="S::gsolis_northwell.edu#ext#@hofstra.edu::198dd0ac-6fb3-4b59-b455-eeb2e8da8c00" providerId="AD" clId="Web-{2016D851-910C-402B-87A1-F700B08DAEEA}" dt="2021-07-18T15:35:51.294" v="68"/>
        <pc:sldMkLst>
          <pc:docMk/>
          <pc:sldMk cId="2930611101" sldId="333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2930611101" sldId="333"/>
            <ac:spMk id="2" creationId="{00000000-0000-0000-0000-000000000000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2930611101" sldId="333"/>
            <ac:spMk id="3" creationId="{00000000-0000-0000-0000-000000000000}"/>
          </ac:spMkLst>
        </pc:spChg>
      </pc:sldChg>
      <pc:sldChg chg="modSp mod modClrScheme chgLayout">
        <pc:chgData name="Solis, Gabriela" userId="S::gsolis_northwell.edu#ext#@hofstra.edu::198dd0ac-6fb3-4b59-b455-eeb2e8da8c00" providerId="AD" clId="Web-{2016D851-910C-402B-87A1-F700B08DAEEA}" dt="2021-07-18T15:35:51.294" v="68"/>
        <pc:sldMkLst>
          <pc:docMk/>
          <pc:sldMk cId="4240967710" sldId="334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4240967710" sldId="334"/>
            <ac:spMk id="2" creationId="{00000000-0000-0000-0000-000000000000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4240967710" sldId="334"/>
            <ac:spMk id="3" creationId="{00000000-0000-0000-0000-000000000000}"/>
          </ac:spMkLst>
        </pc:spChg>
      </pc:sldChg>
      <pc:sldChg chg="modSp mod modClrScheme chgLayout">
        <pc:chgData name="Solis, Gabriela" userId="S::gsolis_northwell.edu#ext#@hofstra.edu::198dd0ac-6fb3-4b59-b455-eeb2e8da8c00" providerId="AD" clId="Web-{2016D851-910C-402B-87A1-F700B08DAEEA}" dt="2021-07-18T15:35:51.294" v="68"/>
        <pc:sldMkLst>
          <pc:docMk/>
          <pc:sldMk cId="2277355623" sldId="336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2277355623" sldId="336"/>
            <ac:spMk id="2" creationId="{00000000-0000-0000-0000-000000000000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2277355623" sldId="336"/>
            <ac:spMk id="3" creationId="{00000000-0000-0000-0000-000000000000}"/>
          </ac:spMkLst>
        </pc:spChg>
      </pc:sldChg>
      <pc:sldChg chg="modSp mod modClrScheme chgLayout">
        <pc:chgData name="Solis, Gabriela" userId="S::gsolis_northwell.edu#ext#@hofstra.edu::198dd0ac-6fb3-4b59-b455-eeb2e8da8c00" providerId="AD" clId="Web-{2016D851-910C-402B-87A1-F700B08DAEEA}" dt="2021-07-18T15:35:51.294" v="68"/>
        <pc:sldMkLst>
          <pc:docMk/>
          <pc:sldMk cId="1708372556" sldId="338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1708372556" sldId="338"/>
            <ac:spMk id="2" creationId="{00000000-0000-0000-0000-000000000000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1708372556" sldId="338"/>
            <ac:spMk id="3" creationId="{00000000-0000-0000-0000-000000000000}"/>
          </ac:spMkLst>
        </pc:spChg>
      </pc:sldChg>
      <pc:sldChg chg="modSp mod modClrScheme chgLayout">
        <pc:chgData name="Solis, Gabriela" userId="S::gsolis_northwell.edu#ext#@hofstra.edu::198dd0ac-6fb3-4b59-b455-eeb2e8da8c00" providerId="AD" clId="Web-{2016D851-910C-402B-87A1-F700B08DAEEA}" dt="2021-07-18T15:35:51.294" v="68"/>
        <pc:sldMkLst>
          <pc:docMk/>
          <pc:sldMk cId="3315398952" sldId="339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3315398952" sldId="339"/>
            <ac:spMk id="2" creationId="{00000000-0000-0000-0000-000000000000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3315398952" sldId="339"/>
            <ac:spMk id="3" creationId="{00000000-0000-0000-0000-000000000000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3315398952" sldId="339"/>
            <ac:spMk id="4" creationId="{00000000-0000-0000-0000-000000000000}"/>
          </ac:spMkLst>
        </pc:spChg>
      </pc:sldChg>
      <pc:sldChg chg="modSp mod modClrScheme chgLayout">
        <pc:chgData name="Solis, Gabriela" userId="S::gsolis_northwell.edu#ext#@hofstra.edu::198dd0ac-6fb3-4b59-b455-eeb2e8da8c00" providerId="AD" clId="Web-{2016D851-910C-402B-87A1-F700B08DAEEA}" dt="2021-07-18T15:35:51.294" v="68"/>
        <pc:sldMkLst>
          <pc:docMk/>
          <pc:sldMk cId="3645599527" sldId="341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3645599527" sldId="341"/>
            <ac:spMk id="2" creationId="{00000000-0000-0000-0000-000000000000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3645599527" sldId="341"/>
            <ac:spMk id="3" creationId="{00000000-0000-0000-0000-000000000000}"/>
          </ac:spMkLst>
        </pc:spChg>
      </pc:sldChg>
      <pc:sldChg chg="modSp mod modClrScheme chgLayout">
        <pc:chgData name="Solis, Gabriela" userId="S::gsolis_northwell.edu#ext#@hofstra.edu::198dd0ac-6fb3-4b59-b455-eeb2e8da8c00" providerId="AD" clId="Web-{2016D851-910C-402B-87A1-F700B08DAEEA}" dt="2021-07-18T15:35:51.294" v="68"/>
        <pc:sldMkLst>
          <pc:docMk/>
          <pc:sldMk cId="337776308" sldId="342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337776308" sldId="342"/>
            <ac:spMk id="2" creationId="{00000000-0000-0000-0000-000000000000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337776308" sldId="342"/>
            <ac:spMk id="3" creationId="{00000000-0000-0000-0000-000000000000}"/>
          </ac:spMkLst>
        </pc:spChg>
      </pc:sldChg>
      <pc:sldChg chg="modSp mod modClrScheme chgLayout">
        <pc:chgData name="Solis, Gabriela" userId="S::gsolis_northwell.edu#ext#@hofstra.edu::198dd0ac-6fb3-4b59-b455-eeb2e8da8c00" providerId="AD" clId="Web-{2016D851-910C-402B-87A1-F700B08DAEEA}" dt="2021-07-18T15:35:51.294" v="68"/>
        <pc:sldMkLst>
          <pc:docMk/>
          <pc:sldMk cId="3832890404" sldId="343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3832890404" sldId="343"/>
            <ac:spMk id="2" creationId="{00000000-0000-0000-0000-000000000000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3832890404" sldId="343"/>
            <ac:spMk id="3" creationId="{00000000-0000-0000-0000-000000000000}"/>
          </ac:spMkLst>
        </pc:spChg>
      </pc:sldChg>
      <pc:sldChg chg="modSp mod modClrScheme chgLayout">
        <pc:chgData name="Solis, Gabriela" userId="S::gsolis_northwell.edu#ext#@hofstra.edu::198dd0ac-6fb3-4b59-b455-eeb2e8da8c00" providerId="AD" clId="Web-{2016D851-910C-402B-87A1-F700B08DAEEA}" dt="2021-07-18T15:35:51.294" v="68"/>
        <pc:sldMkLst>
          <pc:docMk/>
          <pc:sldMk cId="856723955" sldId="344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856723955" sldId="344"/>
            <ac:spMk id="2" creationId="{00000000-0000-0000-0000-000000000000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856723955" sldId="344"/>
            <ac:spMk id="3" creationId="{00000000-0000-0000-0000-000000000000}"/>
          </ac:spMkLst>
        </pc:spChg>
      </pc:sldChg>
      <pc:sldChg chg="modSp mod modClrScheme chgLayout">
        <pc:chgData name="Solis, Gabriela" userId="S::gsolis_northwell.edu#ext#@hofstra.edu::198dd0ac-6fb3-4b59-b455-eeb2e8da8c00" providerId="AD" clId="Web-{2016D851-910C-402B-87A1-F700B08DAEEA}" dt="2021-07-18T15:35:51.294" v="68"/>
        <pc:sldMkLst>
          <pc:docMk/>
          <pc:sldMk cId="1559596806" sldId="346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1559596806" sldId="346"/>
            <ac:spMk id="2" creationId="{00000000-0000-0000-0000-000000000000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1559596806" sldId="346"/>
            <ac:spMk id="3" creationId="{00000000-0000-0000-0000-000000000000}"/>
          </ac:spMkLst>
        </pc:spChg>
      </pc:sldChg>
      <pc:sldChg chg="modSp mod modClrScheme chgLayout">
        <pc:chgData name="Solis, Gabriela" userId="S::gsolis_northwell.edu#ext#@hofstra.edu::198dd0ac-6fb3-4b59-b455-eeb2e8da8c00" providerId="AD" clId="Web-{2016D851-910C-402B-87A1-F700B08DAEEA}" dt="2021-07-18T15:35:51.294" v="68"/>
        <pc:sldMkLst>
          <pc:docMk/>
          <pc:sldMk cId="3787916487" sldId="347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3787916487" sldId="347"/>
            <ac:spMk id="2" creationId="{00000000-0000-0000-0000-000000000000}"/>
          </ac:spMkLst>
        </pc:spChg>
      </pc:sldChg>
      <pc:sldChg chg="addSp delSp modSp mod modClrScheme chgLayout">
        <pc:chgData name="Solis, Gabriela" userId="S::gsolis_northwell.edu#ext#@hofstra.edu::198dd0ac-6fb3-4b59-b455-eeb2e8da8c00" providerId="AD" clId="Web-{2016D851-910C-402B-87A1-F700B08DAEEA}" dt="2021-07-18T15:35:51.294" v="68"/>
        <pc:sldMkLst>
          <pc:docMk/>
          <pc:sldMk cId="1011963421" sldId="351"/>
        </pc:sldMkLst>
        <pc:spChg chg="del">
          <ac:chgData name="Solis, Gabriela" userId="S::gsolis_northwell.edu#ext#@hofstra.edu::198dd0ac-6fb3-4b59-b455-eeb2e8da8c00" providerId="AD" clId="Web-{2016D851-910C-402B-87A1-F700B08DAEEA}" dt="2021-07-18T15:04:54.707" v="14"/>
          <ac:spMkLst>
            <pc:docMk/>
            <pc:sldMk cId="1011963421" sldId="351"/>
            <ac:spMk id="21508" creationId="{00000000-0000-0000-0000-000000000000}"/>
          </ac:spMkLst>
        </pc:spChg>
        <pc:spChg chg="del mod">
          <ac:chgData name="Solis, Gabriela" userId="S::gsolis_northwell.edu#ext#@hofstra.edu::198dd0ac-6fb3-4b59-b455-eeb2e8da8c00" providerId="AD" clId="Web-{2016D851-910C-402B-87A1-F700B08DAEEA}" dt="2021-07-18T14:59:17.776" v="8"/>
          <ac:spMkLst>
            <pc:docMk/>
            <pc:sldMk cId="1011963421" sldId="351"/>
            <ac:spMk id="21509" creationId="{00000000-0000-0000-0000-000000000000}"/>
          </ac:spMkLst>
        </pc:spChg>
        <pc:picChg chg="add mod">
          <ac:chgData name="Solis, Gabriela" userId="S::gsolis_northwell.edu#ext#@hofstra.edu::198dd0ac-6fb3-4b59-b455-eeb2e8da8c00" providerId="AD" clId="Web-{2016D851-910C-402B-87A1-F700B08DAEEA}" dt="2021-07-18T15:05:01.380" v="15" actId="1076"/>
          <ac:picMkLst>
            <pc:docMk/>
            <pc:sldMk cId="1011963421" sldId="351"/>
            <ac:picMk id="2" creationId="{5D9BA558-9E2F-4632-9561-CDC3CCB44311}"/>
          </ac:picMkLst>
        </pc:picChg>
        <pc:picChg chg="del">
          <ac:chgData name="Solis, Gabriela" userId="S::gsolis_northwell.edu#ext#@hofstra.edu::198dd0ac-6fb3-4b59-b455-eeb2e8da8c00" providerId="AD" clId="Web-{2016D851-910C-402B-87A1-F700B08DAEEA}" dt="2021-07-18T14:59:11.479" v="5"/>
          <ac:picMkLst>
            <pc:docMk/>
            <pc:sldMk cId="1011963421" sldId="351"/>
            <ac:picMk id="21506" creationId="{00000000-0000-0000-0000-000000000000}"/>
          </ac:picMkLst>
        </pc:picChg>
        <pc:picChg chg="del">
          <ac:chgData name="Solis, Gabriela" userId="S::gsolis_northwell.edu#ext#@hofstra.edu::198dd0ac-6fb3-4b59-b455-eeb2e8da8c00" providerId="AD" clId="Web-{2016D851-910C-402B-87A1-F700B08DAEEA}" dt="2021-07-18T14:59:09.979" v="4"/>
          <ac:picMkLst>
            <pc:docMk/>
            <pc:sldMk cId="1011963421" sldId="351"/>
            <ac:picMk id="21507" creationId="{00000000-0000-0000-0000-000000000000}"/>
          </ac:picMkLst>
        </pc:picChg>
      </pc:sldChg>
      <pc:sldChg chg="modSp mod modClrScheme chgLayout">
        <pc:chgData name="Solis, Gabriela" userId="S::gsolis_northwell.edu#ext#@hofstra.edu::198dd0ac-6fb3-4b59-b455-eeb2e8da8c00" providerId="AD" clId="Web-{2016D851-910C-402B-87A1-F700B08DAEEA}" dt="2021-07-18T15:35:51.294" v="68"/>
        <pc:sldMkLst>
          <pc:docMk/>
          <pc:sldMk cId="153378708" sldId="352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153378708" sldId="352"/>
            <ac:spMk id="2" creationId="{00000000-0000-0000-0000-000000000000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153378708" sldId="352"/>
            <ac:spMk id="3" creationId="{00000000-0000-0000-0000-000000000000}"/>
          </ac:spMkLst>
        </pc:spChg>
      </pc:sldChg>
      <pc:sldChg chg="modSp del mod modClrScheme chgLayout">
        <pc:chgData name="Solis, Gabriela" userId="S::gsolis_northwell.edu#ext#@hofstra.edu::198dd0ac-6fb3-4b59-b455-eeb2e8da8c00" providerId="AD" clId="Web-{2016D851-910C-402B-87A1-F700B08DAEEA}" dt="2021-07-18T15:40:21.696" v="88"/>
        <pc:sldMkLst>
          <pc:docMk/>
          <pc:sldMk cId="2447000783" sldId="356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2447000783" sldId="356"/>
            <ac:spMk id="2" creationId="{80947263-5C90-4E38-94AA-D7E11C36BD55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2447000783" sldId="356"/>
            <ac:spMk id="3" creationId="{361A62B3-03B4-4733-B136-D667683F9038}"/>
          </ac:spMkLst>
        </pc:spChg>
      </pc:sldChg>
      <pc:sldChg chg="modSp mod modClrScheme chgLayout">
        <pc:chgData name="Solis, Gabriela" userId="S::gsolis_northwell.edu#ext#@hofstra.edu::198dd0ac-6fb3-4b59-b455-eeb2e8da8c00" providerId="AD" clId="Web-{2016D851-910C-402B-87A1-F700B08DAEEA}" dt="2021-07-18T15:35:51.294" v="68"/>
        <pc:sldMkLst>
          <pc:docMk/>
          <pc:sldMk cId="3995300267" sldId="358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3995300267" sldId="358"/>
            <ac:spMk id="2" creationId="{47780179-0182-4210-AB55-A1699228033C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3995300267" sldId="358"/>
            <ac:spMk id="3" creationId="{9A392957-BD48-49DE-8599-0E44A1AE6D05}"/>
          </ac:spMkLst>
        </pc:spChg>
      </pc:sldChg>
      <pc:sldChg chg="modSp mod modClrScheme chgLayout">
        <pc:chgData name="Solis, Gabriela" userId="S::gsolis_northwell.edu#ext#@hofstra.edu::198dd0ac-6fb3-4b59-b455-eeb2e8da8c00" providerId="AD" clId="Web-{2016D851-910C-402B-87A1-F700B08DAEEA}" dt="2021-07-18T15:35:51.294" v="68"/>
        <pc:sldMkLst>
          <pc:docMk/>
          <pc:sldMk cId="2179516864" sldId="359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2179516864" sldId="359"/>
            <ac:spMk id="2" creationId="{AC173730-8FE9-4CEB-8ACB-F4D99DECFFF2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2179516864" sldId="359"/>
            <ac:spMk id="3" creationId="{CC37F49F-5474-41DF-A137-03A487E94D1F}"/>
          </ac:spMkLst>
        </pc:spChg>
      </pc:sldChg>
      <pc:sldChg chg="modSp mod modClrScheme chgLayout">
        <pc:chgData name="Solis, Gabriela" userId="S::gsolis_northwell.edu#ext#@hofstra.edu::198dd0ac-6fb3-4b59-b455-eeb2e8da8c00" providerId="AD" clId="Web-{2016D851-910C-402B-87A1-F700B08DAEEA}" dt="2021-07-18T15:35:51.294" v="68"/>
        <pc:sldMkLst>
          <pc:docMk/>
          <pc:sldMk cId="956818366" sldId="362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956818366" sldId="362"/>
            <ac:spMk id="2" creationId="{47780179-0182-4210-AB55-A1699228033C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956818366" sldId="362"/>
            <ac:spMk id="3" creationId="{9A392957-BD48-49DE-8599-0E44A1AE6D05}"/>
          </ac:spMkLst>
        </pc:spChg>
      </pc:sldChg>
      <pc:sldChg chg="modSp mod modClrScheme chgLayout">
        <pc:chgData name="Solis, Gabriela" userId="S::gsolis_northwell.edu#ext#@hofstra.edu::198dd0ac-6fb3-4b59-b455-eeb2e8da8c00" providerId="AD" clId="Web-{2016D851-910C-402B-87A1-F700B08DAEEA}" dt="2021-07-18T15:35:51.294" v="68"/>
        <pc:sldMkLst>
          <pc:docMk/>
          <pc:sldMk cId="3402779613" sldId="363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3402779613" sldId="363"/>
            <ac:spMk id="2" creationId="{27B06DF6-B7D7-4068-AEE6-707617B3D24E}"/>
          </ac:spMkLst>
        </pc:spChg>
        <pc:picChg chg="mod ord">
          <ac:chgData name="Solis, Gabriela" userId="S::gsolis_northwell.edu#ext#@hofstra.edu::198dd0ac-6fb3-4b59-b455-eeb2e8da8c00" providerId="AD" clId="Web-{2016D851-910C-402B-87A1-F700B08DAEEA}" dt="2021-07-18T15:35:51.294" v="68"/>
          <ac:picMkLst>
            <pc:docMk/>
            <pc:sldMk cId="3402779613" sldId="363"/>
            <ac:picMk id="22" creationId="{67440E68-3A8F-4076-8B8D-10C1CE1DBFE6}"/>
          </ac:picMkLst>
        </pc:picChg>
      </pc:sldChg>
      <pc:sldChg chg="addSp modSp mod modClrScheme chgLayout">
        <pc:chgData name="Solis, Gabriela" userId="S::gsolis_northwell.edu#ext#@hofstra.edu::198dd0ac-6fb3-4b59-b455-eeb2e8da8c00" providerId="AD" clId="Web-{2016D851-910C-402B-87A1-F700B08DAEEA}" dt="2021-07-18T15:50:43.091" v="225" actId="14100"/>
        <pc:sldMkLst>
          <pc:docMk/>
          <pc:sldMk cId="2919230525" sldId="364"/>
        </pc:sldMkLst>
        <pc:spChg chg="mod ord">
          <ac:chgData name="Solis, Gabriela" userId="S::gsolis_northwell.edu#ext#@hofstra.edu::198dd0ac-6fb3-4b59-b455-eeb2e8da8c00" providerId="AD" clId="Web-{2016D851-910C-402B-87A1-F700B08DAEEA}" dt="2021-07-18T15:48:40.931" v="201" actId="20577"/>
          <ac:spMkLst>
            <pc:docMk/>
            <pc:sldMk cId="2919230525" sldId="364"/>
            <ac:spMk id="2" creationId="{CA5A33D6-1DE4-4051-BE84-BE5B9BA99881}"/>
          </ac:spMkLst>
        </pc:spChg>
        <pc:spChg chg="add mod">
          <ac:chgData name="Solis, Gabriela" userId="S::gsolis_northwell.edu#ext#@hofstra.edu::198dd0ac-6fb3-4b59-b455-eeb2e8da8c00" providerId="AD" clId="Web-{2016D851-910C-402B-87A1-F700B08DAEEA}" dt="2021-07-18T15:49:57.230" v="221" actId="20577"/>
          <ac:spMkLst>
            <pc:docMk/>
            <pc:sldMk cId="2919230525" sldId="364"/>
            <ac:spMk id="3" creationId="{5824E19E-D23E-4266-B80F-87F9194F302B}"/>
          </ac:spMkLst>
        </pc:spChg>
        <pc:spChg chg="mod">
          <ac:chgData name="Solis, Gabriela" userId="S::gsolis_northwell.edu#ext#@hofstra.edu::198dd0ac-6fb3-4b59-b455-eeb2e8da8c00" providerId="AD" clId="Web-{2016D851-910C-402B-87A1-F700B08DAEEA}" dt="2021-07-18T15:48:15.180" v="198" actId="20577"/>
          <ac:spMkLst>
            <pc:docMk/>
            <pc:sldMk cId="2919230525" sldId="364"/>
            <ac:spMk id="5" creationId="{CD3CF2C5-43A2-409E-99C0-1EFD9F2AC4DB}"/>
          </ac:spMkLst>
        </pc:spChg>
        <pc:spChg chg="add mod">
          <ac:chgData name="Solis, Gabriela" userId="S::gsolis_northwell.edu#ext#@hofstra.edu::198dd0ac-6fb3-4b59-b455-eeb2e8da8c00" providerId="AD" clId="Web-{2016D851-910C-402B-87A1-F700B08DAEEA}" dt="2021-07-18T15:50:43.091" v="225" actId="14100"/>
          <ac:spMkLst>
            <pc:docMk/>
            <pc:sldMk cId="2919230525" sldId="364"/>
            <ac:spMk id="7" creationId="{4C319D45-7F53-46C9-A916-D04F2852E3B0}"/>
          </ac:spMkLst>
        </pc:spChg>
      </pc:sldChg>
      <pc:sldChg chg="modSp mod modClrScheme chgLayout">
        <pc:chgData name="Solis, Gabriela" userId="S::gsolis_northwell.edu#ext#@hofstra.edu::198dd0ac-6fb3-4b59-b455-eeb2e8da8c00" providerId="AD" clId="Web-{2016D851-910C-402B-87A1-F700B08DAEEA}" dt="2021-07-18T15:35:51.294" v="68"/>
        <pc:sldMkLst>
          <pc:docMk/>
          <pc:sldMk cId="1724564863" sldId="365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1724564863" sldId="365"/>
            <ac:spMk id="2" creationId="{3AAAD477-D9BB-40A4-9449-4D7C7008F428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1724564863" sldId="365"/>
            <ac:spMk id="4" creationId="{FD449185-D6E9-4CB2-A221-9240F7092AAD}"/>
          </ac:spMkLst>
        </pc:spChg>
      </pc:sldChg>
      <pc:sldChg chg="modSp mod modClrScheme chgLayout">
        <pc:chgData name="Solis, Gabriela" userId="S::gsolis_northwell.edu#ext#@hofstra.edu::198dd0ac-6fb3-4b59-b455-eeb2e8da8c00" providerId="AD" clId="Web-{2016D851-910C-402B-87A1-F700B08DAEEA}" dt="2021-07-18T15:35:51.294" v="68"/>
        <pc:sldMkLst>
          <pc:docMk/>
          <pc:sldMk cId="438269467" sldId="366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438269467" sldId="366"/>
            <ac:spMk id="4" creationId="{C13CFC8A-11F4-49EE-866B-B22665827209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438269467" sldId="366"/>
            <ac:spMk id="12" creationId="{86F0CA7B-D052-4F1A-866B-79A03300A989}"/>
          </ac:spMkLst>
        </pc:spChg>
      </pc:sldChg>
      <pc:sldChg chg="modSp mod modClrScheme chgLayout">
        <pc:chgData name="Solis, Gabriela" userId="S::gsolis_northwell.edu#ext#@hofstra.edu::198dd0ac-6fb3-4b59-b455-eeb2e8da8c00" providerId="AD" clId="Web-{2016D851-910C-402B-87A1-F700B08DAEEA}" dt="2021-07-18T15:35:51.294" v="68"/>
        <pc:sldMkLst>
          <pc:docMk/>
          <pc:sldMk cId="2439297039" sldId="367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2439297039" sldId="367"/>
            <ac:spMk id="2" creationId="{9711D05B-1A6A-4785-9233-25614CFC03CE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2439297039" sldId="367"/>
            <ac:spMk id="3" creationId="{01EBB642-A9A1-4273-829D-59C1EBAD2430}"/>
          </ac:spMkLst>
        </pc:spChg>
      </pc:sldChg>
      <pc:sldChg chg="modSp mod modClrScheme chgLayout">
        <pc:chgData name="Solis, Gabriela" userId="S::gsolis_northwell.edu#ext#@hofstra.edu::198dd0ac-6fb3-4b59-b455-eeb2e8da8c00" providerId="AD" clId="Web-{2016D851-910C-402B-87A1-F700B08DAEEA}" dt="2021-07-18T15:35:51.294" v="68"/>
        <pc:sldMkLst>
          <pc:docMk/>
          <pc:sldMk cId="504955433" sldId="371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504955433" sldId="371"/>
            <ac:spMk id="2" creationId="{9058C3B7-053F-4630-AEFD-94D00B3044A6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504955433" sldId="371"/>
            <ac:spMk id="3" creationId="{B6888636-DC58-482E-BB12-5029C1E6DDE2}"/>
          </ac:spMkLst>
        </pc:spChg>
      </pc:sldChg>
      <pc:sldChg chg="modSp mod modClrScheme chgLayout">
        <pc:chgData name="Solis, Gabriela" userId="S::gsolis_northwell.edu#ext#@hofstra.edu::198dd0ac-6fb3-4b59-b455-eeb2e8da8c00" providerId="AD" clId="Web-{2016D851-910C-402B-87A1-F700B08DAEEA}" dt="2021-07-18T15:35:51.294" v="68"/>
        <pc:sldMkLst>
          <pc:docMk/>
          <pc:sldMk cId="36259429" sldId="372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36259429" sldId="372"/>
            <ac:spMk id="2" creationId="{027D955E-96CF-4463-BEDD-8B76AD01995B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36259429" sldId="372"/>
            <ac:spMk id="4" creationId="{1E249DD4-C7D8-4241-A9F3-7E23877347D7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36259429" sldId="372"/>
            <ac:spMk id="5" creationId="{107F1D1A-74D9-4060-AD3B-05832C36F82A}"/>
          </ac:spMkLst>
        </pc:spChg>
      </pc:sldChg>
      <pc:sldChg chg="modSp mod modClrScheme chgLayout">
        <pc:chgData name="Solis, Gabriela" userId="S::gsolis_northwell.edu#ext#@hofstra.edu::198dd0ac-6fb3-4b59-b455-eeb2e8da8c00" providerId="AD" clId="Web-{2016D851-910C-402B-87A1-F700B08DAEEA}" dt="2021-07-18T15:51:49.342" v="234" actId="20577"/>
        <pc:sldMkLst>
          <pc:docMk/>
          <pc:sldMk cId="2418592727" sldId="373"/>
        </pc:sldMkLst>
        <pc:spChg chg="mod ord">
          <ac:chgData name="Solis, Gabriela" userId="S::gsolis_northwell.edu#ext#@hofstra.edu::198dd0ac-6fb3-4b59-b455-eeb2e8da8c00" providerId="AD" clId="Web-{2016D851-910C-402B-87A1-F700B08DAEEA}" dt="2021-07-18T15:51:31.795" v="231" actId="20577"/>
          <ac:spMkLst>
            <pc:docMk/>
            <pc:sldMk cId="2418592727" sldId="373"/>
            <ac:spMk id="2" creationId="{FC7ABD9D-8BDE-4579-A098-9E3D7A18F914}"/>
          </ac:spMkLst>
        </pc:spChg>
        <pc:spChg chg="mod">
          <ac:chgData name="Solis, Gabriela" userId="S::gsolis_northwell.edu#ext#@hofstra.edu::198dd0ac-6fb3-4b59-b455-eeb2e8da8c00" providerId="AD" clId="Web-{2016D851-910C-402B-87A1-F700B08DAEEA}" dt="2021-07-18T15:51:49.342" v="234" actId="20577"/>
          <ac:spMkLst>
            <pc:docMk/>
            <pc:sldMk cId="2418592727" sldId="373"/>
            <ac:spMk id="3" creationId="{AB26ACB8-94F9-48F1-AC83-F44DCA055732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51:43.092" v="232" actId="20577"/>
          <ac:spMkLst>
            <pc:docMk/>
            <pc:sldMk cId="2418592727" sldId="373"/>
            <ac:spMk id="11" creationId="{089DD99E-0D17-4C5D-B955-09FF7808AF36}"/>
          </ac:spMkLst>
        </pc:spChg>
      </pc:sldChg>
      <pc:sldChg chg="modSp del mod modClrScheme chgLayout">
        <pc:chgData name="Solis, Gabriela" userId="S::gsolis_northwell.edu#ext#@hofstra.edu::198dd0ac-6fb3-4b59-b455-eeb2e8da8c00" providerId="AD" clId="Web-{2016D851-910C-402B-87A1-F700B08DAEEA}" dt="2021-07-18T15:53:46.002" v="245"/>
        <pc:sldMkLst>
          <pc:docMk/>
          <pc:sldMk cId="2338641079" sldId="374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2338641079" sldId="374"/>
            <ac:spMk id="2" creationId="{00000000-0000-0000-0000-000000000000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2338641079" sldId="374"/>
            <ac:spMk id="3" creationId="{00000000-0000-0000-0000-000000000000}"/>
          </ac:spMkLst>
        </pc:spChg>
      </pc:sldChg>
      <pc:sldChg chg="modSp mod modClrScheme chgLayout">
        <pc:chgData name="Solis, Gabriela" userId="S::gsolis_northwell.edu#ext#@hofstra.edu::198dd0ac-6fb3-4b59-b455-eeb2e8da8c00" providerId="AD" clId="Web-{2016D851-910C-402B-87A1-F700B08DAEEA}" dt="2021-07-18T15:35:51.294" v="68"/>
        <pc:sldMkLst>
          <pc:docMk/>
          <pc:sldMk cId="3188627780" sldId="375"/>
        </pc:sldMkLst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3188627780" sldId="375"/>
            <ac:spMk id="2" creationId="{00000000-0000-0000-0000-000000000000}"/>
          </ac:spMkLst>
        </pc:spChg>
        <pc:spChg chg="mod ord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3188627780" sldId="375"/>
            <ac:spMk id="3" creationId="{00000000-0000-0000-0000-000000000000}"/>
          </ac:spMkLst>
        </pc:spChg>
      </pc:sldChg>
      <pc:sldChg chg="addSp modSp new del mod setBg modClrScheme modShow chgLayout">
        <pc:chgData name="Solis, Gabriela" userId="S::gsolis_northwell.edu#ext#@hofstra.edu::198dd0ac-6fb3-4b59-b455-eeb2e8da8c00" providerId="AD" clId="Web-{2016D851-910C-402B-87A1-F700B08DAEEA}" dt="2021-07-18T15:29:03.201" v="43"/>
        <pc:sldMkLst>
          <pc:docMk/>
          <pc:sldMk cId="913243407" sldId="376"/>
        </pc:sldMkLst>
        <pc:spChg chg="mod ord">
          <ac:chgData name="Solis, Gabriela" userId="S::gsolis_northwell.edu#ext#@hofstra.edu::198dd0ac-6fb3-4b59-b455-eeb2e8da8c00" providerId="AD" clId="Web-{2016D851-910C-402B-87A1-F700B08DAEEA}" dt="2021-07-18T15:28:01.324" v="36"/>
          <ac:spMkLst>
            <pc:docMk/>
            <pc:sldMk cId="913243407" sldId="376"/>
            <ac:spMk id="2" creationId="{31C4CEFF-11B9-43A4-ACAA-99FE088D1208}"/>
          </ac:spMkLst>
        </pc:spChg>
        <pc:spChg chg="add mod">
          <ac:chgData name="Solis, Gabriela" userId="S::gsolis_northwell.edu#ext#@hofstra.edu::198dd0ac-6fb3-4b59-b455-eeb2e8da8c00" providerId="AD" clId="Web-{2016D851-910C-402B-87A1-F700B08DAEEA}" dt="2021-07-18T15:28:01.324" v="36"/>
          <ac:spMkLst>
            <pc:docMk/>
            <pc:sldMk cId="913243407" sldId="376"/>
            <ac:spMk id="4" creationId="{0F34A6F7-78E8-4B3D-A892-E8EDF782493A}"/>
          </ac:spMkLst>
        </pc:spChg>
        <pc:spChg chg="add">
          <ac:chgData name="Solis, Gabriela" userId="S::gsolis_northwell.edu#ext#@hofstra.edu::198dd0ac-6fb3-4b59-b455-eeb2e8da8c00" providerId="AD" clId="Web-{2016D851-910C-402B-87A1-F700B08DAEEA}" dt="2021-07-18T15:28:01.324" v="36"/>
          <ac:spMkLst>
            <pc:docMk/>
            <pc:sldMk cId="913243407" sldId="376"/>
            <ac:spMk id="9" creationId="{081EA652-8C6A-4E69-BEB9-170809474553}"/>
          </ac:spMkLst>
        </pc:spChg>
        <pc:spChg chg="add">
          <ac:chgData name="Solis, Gabriela" userId="S::gsolis_northwell.edu#ext#@hofstra.edu::198dd0ac-6fb3-4b59-b455-eeb2e8da8c00" providerId="AD" clId="Web-{2016D851-910C-402B-87A1-F700B08DAEEA}" dt="2021-07-18T15:28:01.324" v="36"/>
          <ac:spMkLst>
            <pc:docMk/>
            <pc:sldMk cId="913243407" sldId="376"/>
            <ac:spMk id="11" creationId="{5298780A-33B9-4EA2-8F67-DE68AD62841B}"/>
          </ac:spMkLst>
        </pc:spChg>
        <pc:spChg chg="add">
          <ac:chgData name="Solis, Gabriela" userId="S::gsolis_northwell.edu#ext#@hofstra.edu::198dd0ac-6fb3-4b59-b455-eeb2e8da8c00" providerId="AD" clId="Web-{2016D851-910C-402B-87A1-F700B08DAEEA}" dt="2021-07-18T15:28:01.324" v="36"/>
          <ac:spMkLst>
            <pc:docMk/>
            <pc:sldMk cId="913243407" sldId="376"/>
            <ac:spMk id="13" creationId="{7F488E8B-4E1E-4402-8935-D4E6C02615C7}"/>
          </ac:spMkLst>
        </pc:spChg>
      </pc:sldChg>
      <pc:sldChg chg="new del">
        <pc:chgData name="Solis, Gabriela" userId="S::gsolis_northwell.edu#ext#@hofstra.edu::198dd0ac-6fb3-4b59-b455-eeb2e8da8c00" providerId="AD" clId="Web-{2016D851-910C-402B-87A1-F700B08DAEEA}" dt="2021-07-18T14:38:33.367" v="1"/>
        <pc:sldMkLst>
          <pc:docMk/>
          <pc:sldMk cId="3847156040" sldId="376"/>
        </pc:sldMkLst>
      </pc:sldChg>
      <pc:sldChg chg="addSp delSp modSp new mod setBg modClrScheme delDesignElem chgLayout">
        <pc:chgData name="Solis, Gabriela" userId="S::gsolis_northwell.edu#ext#@hofstra.edu::198dd0ac-6fb3-4b59-b455-eeb2e8da8c00" providerId="AD" clId="Web-{2016D851-910C-402B-87A1-F700B08DAEEA}" dt="2021-07-18T15:40:12.785" v="87" actId="1076"/>
        <pc:sldMkLst>
          <pc:docMk/>
          <pc:sldMk cId="3695886494" sldId="377"/>
        </pc:sldMkLst>
        <pc:spChg chg="add mod">
          <ac:chgData name="Solis, Gabriela" userId="S::gsolis_northwell.edu#ext#@hofstra.edu::198dd0ac-6fb3-4b59-b455-eeb2e8da8c00" providerId="AD" clId="Web-{2016D851-910C-402B-87A1-F700B08DAEEA}" dt="2021-07-18T15:39:51.128" v="84" actId="1076"/>
          <ac:spMkLst>
            <pc:docMk/>
            <pc:sldMk cId="3695886494" sldId="377"/>
            <ac:spMk id="3" creationId="{BE41D8D5-BF1B-48E1-95BE-A2FA1D45D696}"/>
          </ac:spMkLst>
        </pc:spChg>
        <pc:spChg chg="add mod">
          <ac:chgData name="Solis, Gabriela" userId="S::gsolis_northwell.edu#ext#@hofstra.edu::198dd0ac-6fb3-4b59-b455-eeb2e8da8c00" providerId="AD" clId="Web-{2016D851-910C-402B-87A1-F700B08DAEEA}" dt="2021-07-18T15:40:12.785" v="87" actId="1076"/>
          <ac:spMkLst>
            <pc:docMk/>
            <pc:sldMk cId="3695886494" sldId="377"/>
            <ac:spMk id="5" creationId="{7CACB6FB-1027-4FD0-8C7E-D2E2B4263D4D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32:44.178" v="59"/>
          <ac:spMkLst>
            <pc:docMk/>
            <pc:sldMk cId="3695886494" sldId="377"/>
            <ac:spMk id="7" creationId="{AC17DE74-01C9-4859-B65A-85CF999E8580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32:44.178" v="59"/>
          <ac:spMkLst>
            <pc:docMk/>
            <pc:sldMk cId="3695886494" sldId="377"/>
            <ac:spMk id="8" creationId="{068C0432-0E90-4CC1-8CD3-D44A90DF07EF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30:29.610" v="48"/>
          <ac:spMkLst>
            <pc:docMk/>
            <pc:sldMk cId="3695886494" sldId="377"/>
            <ac:spMk id="10" creationId="{2B566528-1B12-4246-9431-5C2D7D081168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30:29.610" v="48"/>
          <ac:spMkLst>
            <pc:docMk/>
            <pc:sldMk cId="3695886494" sldId="377"/>
            <ac:spMk id="12" creationId="{2E80C965-DB6D-4F81-9E9E-B027384D0BD6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3695886494" sldId="377"/>
            <ac:spMk id="13" creationId="{081EA652-8C6A-4E69-BEB9-170809474553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30:29.610" v="48"/>
          <ac:spMkLst>
            <pc:docMk/>
            <pc:sldMk cId="3695886494" sldId="377"/>
            <ac:spMk id="14" creationId="{A580F890-B085-4E95-96AA-55AEBEC5CE6E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3695886494" sldId="377"/>
            <ac:spMk id="15" creationId="{5298780A-33B9-4EA2-8F67-DE68AD62841B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30:29.610" v="48"/>
          <ac:spMkLst>
            <pc:docMk/>
            <pc:sldMk cId="3695886494" sldId="377"/>
            <ac:spMk id="16" creationId="{D3F51FEB-38FB-4F6C-9F7B-2F2AFAB65463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35:51.294" v="68"/>
          <ac:spMkLst>
            <pc:docMk/>
            <pc:sldMk cId="3695886494" sldId="377"/>
            <ac:spMk id="17" creationId="{7F488E8B-4E1E-4402-8935-D4E6C02615C7}"/>
          </ac:spMkLst>
        </pc:spChg>
        <pc:spChg chg="add del">
          <ac:chgData name="Solis, Gabriela" userId="S::gsolis_northwell.edu#ext#@hofstra.edu::198dd0ac-6fb3-4b59-b455-eeb2e8da8c00" providerId="AD" clId="Web-{2016D851-910C-402B-87A1-F700B08DAEEA}" dt="2021-07-18T15:30:29.610" v="48"/>
          <ac:spMkLst>
            <pc:docMk/>
            <pc:sldMk cId="3695886494" sldId="377"/>
            <ac:spMk id="18" creationId="{1E547BA6-BAE0-43BB-A7CA-60F69CE252F0}"/>
          </ac:spMkLst>
        </pc:spChg>
      </pc:sldChg>
      <pc:sldChg chg="addSp modSp new">
        <pc:chgData name="Solis, Gabriela" userId="S::gsolis_northwell.edu#ext#@hofstra.edu::198dd0ac-6fb3-4b59-b455-eeb2e8da8c00" providerId="AD" clId="Web-{2016D851-910C-402B-87A1-F700B08DAEEA}" dt="2021-07-18T15:38:33.689" v="73" actId="20577"/>
        <pc:sldMkLst>
          <pc:docMk/>
          <pc:sldMk cId="278272457" sldId="378"/>
        </pc:sldMkLst>
        <pc:spChg chg="add mod">
          <ac:chgData name="Solis, Gabriela" userId="S::gsolis_northwell.edu#ext#@hofstra.edu::198dd0ac-6fb3-4b59-b455-eeb2e8da8c00" providerId="AD" clId="Web-{2016D851-910C-402B-87A1-F700B08DAEEA}" dt="2021-07-18T15:38:33.689" v="73" actId="20577"/>
          <ac:spMkLst>
            <pc:docMk/>
            <pc:sldMk cId="278272457" sldId="378"/>
            <ac:spMk id="3" creationId="{2B81FEFF-2091-470B-97BD-B2221C0ED1FB}"/>
          </ac:spMkLst>
        </pc:spChg>
      </pc:sldChg>
      <pc:sldChg chg="addSp modSp new">
        <pc:chgData name="Solis, Gabriela" userId="S::gsolis_northwell.edu#ext#@hofstra.edu::198dd0ac-6fb3-4b59-b455-eeb2e8da8c00" providerId="AD" clId="Web-{2016D851-910C-402B-87A1-F700B08DAEEA}" dt="2021-07-18T15:43:24.859" v="142" actId="20577"/>
        <pc:sldMkLst>
          <pc:docMk/>
          <pc:sldMk cId="3150183129" sldId="379"/>
        </pc:sldMkLst>
        <pc:spChg chg="add mod">
          <ac:chgData name="Solis, Gabriela" userId="S::gsolis_northwell.edu#ext#@hofstra.edu::198dd0ac-6fb3-4b59-b455-eeb2e8da8c00" providerId="AD" clId="Web-{2016D851-910C-402B-87A1-F700B08DAEEA}" dt="2021-07-18T15:43:24.859" v="142" actId="20577"/>
          <ac:spMkLst>
            <pc:docMk/>
            <pc:sldMk cId="3150183129" sldId="379"/>
            <ac:spMk id="2" creationId="{DDCED976-2EF0-45FC-8DC8-B1F88B4B36EE}"/>
          </ac:spMkLst>
        </pc:spChg>
      </pc:sldChg>
      <pc:sldChg chg="addSp delSp modSp add replId">
        <pc:chgData name="Solis, Gabriela" userId="S::gsolis_northwell.edu#ext#@hofstra.edu::198dd0ac-6fb3-4b59-b455-eeb2e8da8c00" providerId="AD" clId="Web-{2016D851-910C-402B-87A1-F700B08DAEEA}" dt="2021-07-18T15:45:50.535" v="168" actId="1076"/>
        <pc:sldMkLst>
          <pc:docMk/>
          <pc:sldMk cId="3375007296" sldId="380"/>
        </pc:sldMkLst>
        <pc:spChg chg="mod">
          <ac:chgData name="Solis, Gabriela" userId="S::gsolis_northwell.edu#ext#@hofstra.edu::198dd0ac-6fb3-4b59-b455-eeb2e8da8c00" providerId="AD" clId="Web-{2016D851-910C-402B-87A1-F700B08DAEEA}" dt="2021-07-18T15:45:07.706" v="160" actId="20577"/>
          <ac:spMkLst>
            <pc:docMk/>
            <pc:sldMk cId="3375007296" sldId="380"/>
            <ac:spMk id="2" creationId="{00000000-0000-0000-0000-000000000000}"/>
          </ac:spMkLst>
        </pc:spChg>
        <pc:spChg chg="add del mod">
          <ac:chgData name="Solis, Gabriela" userId="S::gsolis_northwell.edu#ext#@hofstra.edu::198dd0ac-6fb3-4b59-b455-eeb2e8da8c00" providerId="AD" clId="Web-{2016D851-910C-402B-87A1-F700B08DAEEA}" dt="2021-07-18T15:45:33.550" v="166"/>
          <ac:spMkLst>
            <pc:docMk/>
            <pc:sldMk cId="3375007296" sldId="380"/>
            <ac:spMk id="4" creationId="{BD508867-5A49-4031-B430-761376C09069}"/>
          </ac:spMkLst>
        </pc:spChg>
        <pc:picChg chg="del">
          <ac:chgData name="Solis, Gabriela" userId="S::gsolis_northwell.edu#ext#@hofstra.edu::198dd0ac-6fb3-4b59-b455-eeb2e8da8c00" providerId="AD" clId="Web-{2016D851-910C-402B-87A1-F700B08DAEEA}" dt="2021-07-18T15:45:14.550" v="161"/>
          <ac:picMkLst>
            <pc:docMk/>
            <pc:sldMk cId="3375007296" sldId="380"/>
            <ac:picMk id="5" creationId="{CDF35EC7-FE28-4B97-99F5-11B79C9B045A}"/>
          </ac:picMkLst>
        </pc:picChg>
        <pc:picChg chg="add mod">
          <ac:chgData name="Solis, Gabriela" userId="S::gsolis_northwell.edu#ext#@hofstra.edu::198dd0ac-6fb3-4b59-b455-eeb2e8da8c00" providerId="AD" clId="Web-{2016D851-910C-402B-87A1-F700B08DAEEA}" dt="2021-07-18T15:45:50.535" v="168" actId="1076"/>
          <ac:picMkLst>
            <pc:docMk/>
            <pc:sldMk cId="3375007296" sldId="380"/>
            <ac:picMk id="7" creationId="{C881AB2D-3C9A-4D94-8D8A-B5E7537280AA}"/>
          </ac:picMkLst>
        </pc:picChg>
      </pc:sldChg>
      <pc:sldChg chg="new del">
        <pc:chgData name="Solis, Gabriela" userId="S::gsolis_northwell.edu#ext#@hofstra.edu::198dd0ac-6fb3-4b59-b455-eeb2e8da8c00" providerId="AD" clId="Web-{2016D851-910C-402B-87A1-F700B08DAEEA}" dt="2021-07-18T15:46:20.833" v="172"/>
        <pc:sldMkLst>
          <pc:docMk/>
          <pc:sldMk cId="1740473853" sldId="381"/>
        </pc:sldMkLst>
      </pc:sldChg>
      <pc:sldChg chg="modSp add replId">
        <pc:chgData name="Solis, Gabriela" userId="S::gsolis_northwell.edu#ext#@hofstra.edu::198dd0ac-6fb3-4b59-b455-eeb2e8da8c00" providerId="AD" clId="Web-{2016D851-910C-402B-87A1-F700B08DAEEA}" dt="2021-07-18T15:47:40.836" v="192" actId="1076"/>
        <pc:sldMkLst>
          <pc:docMk/>
          <pc:sldMk cId="3071954687" sldId="382"/>
        </pc:sldMkLst>
        <pc:spChg chg="mod">
          <ac:chgData name="Solis, Gabriela" userId="S::gsolis_northwell.edu#ext#@hofstra.edu::198dd0ac-6fb3-4b59-b455-eeb2e8da8c00" providerId="AD" clId="Web-{2016D851-910C-402B-87A1-F700B08DAEEA}" dt="2021-07-18T15:46:42.583" v="176" actId="20577"/>
          <ac:spMkLst>
            <pc:docMk/>
            <pc:sldMk cId="3071954687" sldId="382"/>
            <ac:spMk id="2" creationId="{00000000-0000-0000-0000-000000000000}"/>
          </ac:spMkLst>
        </pc:spChg>
        <pc:spChg chg="mod">
          <ac:chgData name="Solis, Gabriela" userId="S::gsolis_northwell.edu#ext#@hofstra.edu::198dd0ac-6fb3-4b59-b455-eeb2e8da8c00" providerId="AD" clId="Web-{2016D851-910C-402B-87A1-F700B08DAEEA}" dt="2021-07-18T15:47:40.836" v="192" actId="1076"/>
          <ac:spMkLst>
            <pc:docMk/>
            <pc:sldMk cId="3071954687" sldId="382"/>
            <ac:spMk id="6" creationId="{00000000-0000-0000-0000-000000000000}"/>
          </ac:spMkLst>
        </pc:spChg>
      </pc:sldChg>
      <pc:sldChg chg="add replId">
        <pc:chgData name="Solis, Gabriela" userId="S::gsolis_northwell.edu#ext#@hofstra.edu::198dd0ac-6fb3-4b59-b455-eeb2e8da8c00" providerId="AD" clId="Web-{2016D851-910C-402B-87A1-F700B08DAEEA}" dt="2021-07-18T15:47:52.617" v="193"/>
        <pc:sldMkLst>
          <pc:docMk/>
          <pc:sldMk cId="3046613134" sldId="383"/>
        </pc:sldMkLst>
      </pc:sldChg>
      <pc:sldChg chg="new del">
        <pc:chgData name="Solis, Gabriela" userId="S::gsolis_northwell.edu#ext#@hofstra.edu::198dd0ac-6fb3-4b59-b455-eeb2e8da8c00" providerId="AD" clId="Web-{2016D851-910C-402B-87A1-F700B08DAEEA}" dt="2021-07-18T15:52:50.110" v="237"/>
        <pc:sldMkLst>
          <pc:docMk/>
          <pc:sldMk cId="2052147933" sldId="384"/>
        </pc:sldMkLst>
      </pc:sldChg>
      <pc:sldChg chg="modSp add replId">
        <pc:chgData name="Solis, Gabriela" userId="S::gsolis_northwell.edu#ext#@hofstra.edu::198dd0ac-6fb3-4b59-b455-eeb2e8da8c00" providerId="AD" clId="Web-{2016D851-910C-402B-87A1-F700B08DAEEA}" dt="2021-07-18T15:53:32.189" v="244" actId="1076"/>
        <pc:sldMkLst>
          <pc:docMk/>
          <pc:sldMk cId="1807645662" sldId="385"/>
        </pc:sldMkLst>
        <pc:spChg chg="mod">
          <ac:chgData name="Solis, Gabriela" userId="S::gsolis_northwell.edu#ext#@hofstra.edu::198dd0ac-6fb3-4b59-b455-eeb2e8da8c00" providerId="AD" clId="Web-{2016D851-910C-402B-87A1-F700B08DAEEA}" dt="2021-07-18T15:53:32.189" v="244" actId="1076"/>
          <ac:spMkLst>
            <pc:docMk/>
            <pc:sldMk cId="1807645662" sldId="385"/>
            <ac:spMk id="2" creationId="{00000000-0000-0000-0000-000000000000}"/>
          </ac:spMkLst>
        </pc:spChg>
        <pc:spChg chg="mod">
          <ac:chgData name="Solis, Gabriela" userId="S::gsolis_northwell.edu#ext#@hofstra.edu::198dd0ac-6fb3-4b59-b455-eeb2e8da8c00" providerId="AD" clId="Web-{2016D851-910C-402B-87A1-F700B08DAEEA}" dt="2021-07-18T15:53:28.720" v="243" actId="20577"/>
          <ac:spMkLst>
            <pc:docMk/>
            <pc:sldMk cId="1807645662" sldId="385"/>
            <ac:spMk id="6" creationId="{00000000-0000-0000-0000-000000000000}"/>
          </ac:spMkLst>
        </pc:spChg>
      </pc:sldChg>
      <pc:sldChg chg="addSp modSp add replId">
        <pc:chgData name="Solis, Gabriela" userId="S::gsolis_northwell.edu#ext#@hofstra.edu::198dd0ac-6fb3-4b59-b455-eeb2e8da8c00" providerId="AD" clId="Web-{2016D851-910C-402B-87A1-F700B08DAEEA}" dt="2021-07-18T15:58:53.495" v="306" actId="14100"/>
        <pc:sldMkLst>
          <pc:docMk/>
          <pc:sldMk cId="3711734020" sldId="386"/>
        </pc:sldMkLst>
        <pc:spChg chg="mod">
          <ac:chgData name="Solis, Gabriela" userId="S::gsolis_northwell.edu#ext#@hofstra.edu::198dd0ac-6fb3-4b59-b455-eeb2e8da8c00" providerId="AD" clId="Web-{2016D851-910C-402B-87A1-F700B08DAEEA}" dt="2021-07-18T15:57:41.696" v="297" actId="1076"/>
          <ac:spMkLst>
            <pc:docMk/>
            <pc:sldMk cId="3711734020" sldId="386"/>
            <ac:spMk id="2" creationId="{00000000-0000-0000-0000-000000000000}"/>
          </ac:spMkLst>
        </pc:spChg>
        <pc:spChg chg="add mod">
          <ac:chgData name="Solis, Gabriela" userId="S::gsolis_northwell.edu#ext#@hofstra.edu::198dd0ac-6fb3-4b59-b455-eeb2e8da8c00" providerId="AD" clId="Web-{2016D851-910C-402B-87A1-F700B08DAEEA}" dt="2021-07-18T15:57:57.650" v="300" actId="14100"/>
          <ac:spMkLst>
            <pc:docMk/>
            <pc:sldMk cId="3711734020" sldId="386"/>
            <ac:spMk id="3" creationId="{7E531B93-120A-4961-AF55-8A03F7FC04F5}"/>
          </ac:spMkLst>
        </pc:spChg>
        <pc:spChg chg="add mod">
          <ac:chgData name="Solis, Gabriela" userId="S::gsolis_northwell.edu#ext#@hofstra.edu::198dd0ac-6fb3-4b59-b455-eeb2e8da8c00" providerId="AD" clId="Web-{2016D851-910C-402B-87A1-F700B08DAEEA}" dt="2021-07-18T15:58:45.651" v="305" actId="1076"/>
          <ac:spMkLst>
            <pc:docMk/>
            <pc:sldMk cId="3711734020" sldId="386"/>
            <ac:spMk id="4" creationId="{EDF41568-E631-4422-BF69-DBFC18B99030}"/>
          </ac:spMkLst>
        </pc:spChg>
        <pc:spChg chg="mod">
          <ac:chgData name="Solis, Gabriela" userId="S::gsolis_northwell.edu#ext#@hofstra.edu::198dd0ac-6fb3-4b59-b455-eeb2e8da8c00" providerId="AD" clId="Web-{2016D851-910C-402B-87A1-F700B08DAEEA}" dt="2021-07-18T15:58:53.495" v="306" actId="14100"/>
          <ac:spMkLst>
            <pc:docMk/>
            <pc:sldMk cId="3711734020" sldId="386"/>
            <ac:spMk id="6" creationId="{00000000-0000-0000-0000-000000000000}"/>
          </ac:spMkLst>
        </pc:spChg>
      </pc:sldChg>
      <pc:sldMasterChg chg="add del addSldLayout delSldLayout">
        <pc:chgData name="Solis, Gabriela" userId="S::gsolis_northwell.edu#ext#@hofstra.edu::198dd0ac-6fb3-4b59-b455-eeb2e8da8c00" providerId="AD" clId="Web-{2016D851-910C-402B-87A1-F700B08DAEEA}" dt="2021-07-18T15:27:21.870" v="35"/>
        <pc:sldMasterMkLst>
          <pc:docMk/>
          <pc:sldMasterMk cId="3798544658" sldId="2147483648"/>
        </pc:sldMasterMkLst>
        <pc:sldLayoutChg chg="add del">
          <pc:chgData name="Solis, Gabriela" userId="S::gsolis_northwell.edu#ext#@hofstra.edu::198dd0ac-6fb3-4b59-b455-eeb2e8da8c00" providerId="AD" clId="Web-{2016D851-910C-402B-87A1-F700B08DAEEA}" dt="2021-07-18T15:27:21.870" v="35"/>
          <pc:sldLayoutMkLst>
            <pc:docMk/>
            <pc:sldMasterMk cId="3798544658" sldId="2147483648"/>
            <pc:sldLayoutMk cId="439175780" sldId="2147483649"/>
          </pc:sldLayoutMkLst>
        </pc:sldLayoutChg>
        <pc:sldLayoutChg chg="add del">
          <pc:chgData name="Solis, Gabriela" userId="S::gsolis_northwell.edu#ext#@hofstra.edu::198dd0ac-6fb3-4b59-b455-eeb2e8da8c00" providerId="AD" clId="Web-{2016D851-910C-402B-87A1-F700B08DAEEA}" dt="2021-07-18T15:27:21.870" v="35"/>
          <pc:sldLayoutMkLst>
            <pc:docMk/>
            <pc:sldMasterMk cId="3798544658" sldId="2147483648"/>
            <pc:sldLayoutMk cId="793215863" sldId="2147483650"/>
          </pc:sldLayoutMkLst>
        </pc:sldLayoutChg>
        <pc:sldLayoutChg chg="add del">
          <pc:chgData name="Solis, Gabriela" userId="S::gsolis_northwell.edu#ext#@hofstra.edu::198dd0ac-6fb3-4b59-b455-eeb2e8da8c00" providerId="AD" clId="Web-{2016D851-910C-402B-87A1-F700B08DAEEA}" dt="2021-07-18T15:27:21.870" v="35"/>
          <pc:sldLayoutMkLst>
            <pc:docMk/>
            <pc:sldMasterMk cId="3798544658" sldId="2147483648"/>
            <pc:sldLayoutMk cId="4030418260" sldId="2147483651"/>
          </pc:sldLayoutMkLst>
        </pc:sldLayoutChg>
        <pc:sldLayoutChg chg="add del">
          <pc:chgData name="Solis, Gabriela" userId="S::gsolis_northwell.edu#ext#@hofstra.edu::198dd0ac-6fb3-4b59-b455-eeb2e8da8c00" providerId="AD" clId="Web-{2016D851-910C-402B-87A1-F700B08DAEEA}" dt="2021-07-18T15:27:21.870" v="35"/>
          <pc:sldLayoutMkLst>
            <pc:docMk/>
            <pc:sldMasterMk cId="3798544658" sldId="2147483648"/>
            <pc:sldLayoutMk cId="4241450847" sldId="2147483652"/>
          </pc:sldLayoutMkLst>
        </pc:sldLayoutChg>
        <pc:sldLayoutChg chg="add del">
          <pc:chgData name="Solis, Gabriela" userId="S::gsolis_northwell.edu#ext#@hofstra.edu::198dd0ac-6fb3-4b59-b455-eeb2e8da8c00" providerId="AD" clId="Web-{2016D851-910C-402B-87A1-F700B08DAEEA}" dt="2021-07-18T15:27:21.870" v="35"/>
          <pc:sldLayoutMkLst>
            <pc:docMk/>
            <pc:sldMasterMk cId="3798544658" sldId="2147483648"/>
            <pc:sldLayoutMk cId="2980793870" sldId="2147483653"/>
          </pc:sldLayoutMkLst>
        </pc:sldLayoutChg>
        <pc:sldLayoutChg chg="add del">
          <pc:chgData name="Solis, Gabriela" userId="S::gsolis_northwell.edu#ext#@hofstra.edu::198dd0ac-6fb3-4b59-b455-eeb2e8da8c00" providerId="AD" clId="Web-{2016D851-910C-402B-87A1-F700B08DAEEA}" dt="2021-07-18T15:27:21.870" v="35"/>
          <pc:sldLayoutMkLst>
            <pc:docMk/>
            <pc:sldMasterMk cId="3798544658" sldId="2147483648"/>
            <pc:sldLayoutMk cId="1007839563" sldId="2147483654"/>
          </pc:sldLayoutMkLst>
        </pc:sldLayoutChg>
        <pc:sldLayoutChg chg="add del">
          <pc:chgData name="Solis, Gabriela" userId="S::gsolis_northwell.edu#ext#@hofstra.edu::198dd0ac-6fb3-4b59-b455-eeb2e8da8c00" providerId="AD" clId="Web-{2016D851-910C-402B-87A1-F700B08DAEEA}" dt="2021-07-18T15:27:21.870" v="35"/>
          <pc:sldLayoutMkLst>
            <pc:docMk/>
            <pc:sldMasterMk cId="3798544658" sldId="2147483648"/>
            <pc:sldLayoutMk cId="4037749128" sldId="2147483661"/>
          </pc:sldLayoutMkLst>
        </pc:sldLayoutChg>
        <pc:sldLayoutChg chg="add del">
          <pc:chgData name="Solis, Gabriela" userId="S::gsolis_northwell.edu#ext#@hofstra.edu::198dd0ac-6fb3-4b59-b455-eeb2e8da8c00" providerId="AD" clId="Web-{2016D851-910C-402B-87A1-F700B08DAEEA}" dt="2021-07-18T15:27:21.870" v="35"/>
          <pc:sldLayoutMkLst>
            <pc:docMk/>
            <pc:sldMasterMk cId="3798544658" sldId="2147483648"/>
            <pc:sldLayoutMk cId="603156643" sldId="2147483662"/>
          </pc:sldLayoutMkLst>
        </pc:sldLayoutChg>
        <pc:sldLayoutChg chg="add del">
          <pc:chgData name="Solis, Gabriela" userId="S::gsolis_northwell.edu#ext#@hofstra.edu::198dd0ac-6fb3-4b59-b455-eeb2e8da8c00" providerId="AD" clId="Web-{2016D851-910C-402B-87A1-F700B08DAEEA}" dt="2021-07-18T15:27:21.870" v="35"/>
          <pc:sldLayoutMkLst>
            <pc:docMk/>
            <pc:sldMasterMk cId="3798544658" sldId="2147483648"/>
            <pc:sldLayoutMk cId="4168298370" sldId="2147483663"/>
          </pc:sldLayoutMkLst>
        </pc:sldLayoutChg>
        <pc:sldLayoutChg chg="add del">
          <pc:chgData name="Solis, Gabriela" userId="S::gsolis_northwell.edu#ext#@hofstra.edu::198dd0ac-6fb3-4b59-b455-eeb2e8da8c00" providerId="AD" clId="Web-{2016D851-910C-402B-87A1-F700B08DAEEA}" dt="2021-07-18T15:27:21.870" v="35"/>
          <pc:sldLayoutMkLst>
            <pc:docMk/>
            <pc:sldMasterMk cId="3798544658" sldId="2147483648"/>
            <pc:sldLayoutMk cId="2787901955" sldId="2147483664"/>
          </pc:sldLayoutMkLst>
        </pc:sldLayoutChg>
        <pc:sldLayoutChg chg="add del">
          <pc:chgData name="Solis, Gabriela" userId="S::gsolis_northwell.edu#ext#@hofstra.edu::198dd0ac-6fb3-4b59-b455-eeb2e8da8c00" providerId="AD" clId="Web-{2016D851-910C-402B-87A1-F700B08DAEEA}" dt="2021-07-18T15:27:21.870" v="35"/>
          <pc:sldLayoutMkLst>
            <pc:docMk/>
            <pc:sldMasterMk cId="3798544658" sldId="2147483648"/>
            <pc:sldLayoutMk cId="2035668487" sldId="2147483665"/>
          </pc:sldLayoutMkLst>
        </pc:sldLayoutChg>
        <pc:sldLayoutChg chg="add del">
          <pc:chgData name="Solis, Gabriela" userId="S::gsolis_northwell.edu#ext#@hofstra.edu::198dd0ac-6fb3-4b59-b455-eeb2e8da8c00" providerId="AD" clId="Web-{2016D851-910C-402B-87A1-F700B08DAEEA}" dt="2021-07-18T15:27:21.870" v="35"/>
          <pc:sldLayoutMkLst>
            <pc:docMk/>
            <pc:sldMasterMk cId="3798544658" sldId="2147483648"/>
            <pc:sldLayoutMk cId="771343081" sldId="2147483666"/>
          </pc:sldLayoutMkLst>
        </pc:sldLayoutChg>
        <pc:sldLayoutChg chg="add del">
          <pc:chgData name="Solis, Gabriela" userId="S::gsolis_northwell.edu#ext#@hofstra.edu::198dd0ac-6fb3-4b59-b455-eeb2e8da8c00" providerId="AD" clId="Web-{2016D851-910C-402B-87A1-F700B08DAEEA}" dt="2021-07-18T15:27:21.870" v="35"/>
          <pc:sldLayoutMkLst>
            <pc:docMk/>
            <pc:sldMasterMk cId="3798544658" sldId="2147483648"/>
            <pc:sldLayoutMk cId="728542883" sldId="2147483667"/>
          </pc:sldLayoutMkLst>
        </pc:sldLayoutChg>
        <pc:sldLayoutChg chg="add del">
          <pc:chgData name="Solis, Gabriela" userId="S::gsolis_northwell.edu#ext#@hofstra.edu::198dd0ac-6fb3-4b59-b455-eeb2e8da8c00" providerId="AD" clId="Web-{2016D851-910C-402B-87A1-F700B08DAEEA}" dt="2021-07-18T15:27:21.870" v="35"/>
          <pc:sldLayoutMkLst>
            <pc:docMk/>
            <pc:sldMasterMk cId="3798544658" sldId="2147483648"/>
            <pc:sldLayoutMk cId="396188230" sldId="2147483668"/>
          </pc:sldLayoutMkLst>
        </pc:sldLayoutChg>
        <pc:sldLayoutChg chg="add del">
          <pc:chgData name="Solis, Gabriela" userId="S::gsolis_northwell.edu#ext#@hofstra.edu::198dd0ac-6fb3-4b59-b455-eeb2e8da8c00" providerId="AD" clId="Web-{2016D851-910C-402B-87A1-F700B08DAEEA}" dt="2021-07-18T15:27:21.870" v="35"/>
          <pc:sldLayoutMkLst>
            <pc:docMk/>
            <pc:sldMasterMk cId="3798544658" sldId="2147483648"/>
            <pc:sldLayoutMk cId="2163873619" sldId="2147483669"/>
          </pc:sldLayoutMkLst>
        </pc:sldLayoutChg>
        <pc:sldLayoutChg chg="add del">
          <pc:chgData name="Solis, Gabriela" userId="S::gsolis_northwell.edu#ext#@hofstra.edu::198dd0ac-6fb3-4b59-b455-eeb2e8da8c00" providerId="AD" clId="Web-{2016D851-910C-402B-87A1-F700B08DAEEA}" dt="2021-07-18T15:27:21.870" v="35"/>
          <pc:sldLayoutMkLst>
            <pc:docMk/>
            <pc:sldMasterMk cId="3798544658" sldId="2147483648"/>
            <pc:sldLayoutMk cId="1316845049" sldId="2147483670"/>
          </pc:sldLayoutMkLst>
        </pc:sldLayoutChg>
        <pc:sldLayoutChg chg="add del">
          <pc:chgData name="Solis, Gabriela" userId="S::gsolis_northwell.edu#ext#@hofstra.edu::198dd0ac-6fb3-4b59-b455-eeb2e8da8c00" providerId="AD" clId="Web-{2016D851-910C-402B-87A1-F700B08DAEEA}" dt="2021-07-18T15:27:21.870" v="35"/>
          <pc:sldLayoutMkLst>
            <pc:docMk/>
            <pc:sldMasterMk cId="3798544658" sldId="2147483648"/>
            <pc:sldLayoutMk cId="2721357472" sldId="2147483671"/>
          </pc:sldLayoutMkLst>
        </pc:sldLayoutChg>
        <pc:sldLayoutChg chg="add del">
          <pc:chgData name="Solis, Gabriela" userId="S::gsolis_northwell.edu#ext#@hofstra.edu::198dd0ac-6fb3-4b59-b455-eeb2e8da8c00" providerId="AD" clId="Web-{2016D851-910C-402B-87A1-F700B08DAEEA}" dt="2021-07-18T15:27:21.870" v="35"/>
          <pc:sldLayoutMkLst>
            <pc:docMk/>
            <pc:sldMasterMk cId="3798544658" sldId="2147483648"/>
            <pc:sldLayoutMk cId="3924435080" sldId="2147483672"/>
          </pc:sldLayoutMkLst>
        </pc:sldLayoutChg>
        <pc:sldLayoutChg chg="add del">
          <pc:chgData name="Solis, Gabriela" userId="S::gsolis_northwell.edu#ext#@hofstra.edu::198dd0ac-6fb3-4b59-b455-eeb2e8da8c00" providerId="AD" clId="Web-{2016D851-910C-402B-87A1-F700B08DAEEA}" dt="2021-07-18T15:27:21.870" v="35"/>
          <pc:sldLayoutMkLst>
            <pc:docMk/>
            <pc:sldMasterMk cId="3798544658" sldId="2147483648"/>
            <pc:sldLayoutMk cId="3697226015" sldId="2147483673"/>
          </pc:sldLayoutMkLst>
        </pc:sldLayoutChg>
        <pc:sldLayoutChg chg="add del">
          <pc:chgData name="Solis, Gabriela" userId="S::gsolis_northwell.edu#ext#@hofstra.edu::198dd0ac-6fb3-4b59-b455-eeb2e8da8c00" providerId="AD" clId="Web-{2016D851-910C-402B-87A1-F700B08DAEEA}" dt="2021-07-18T15:27:21.870" v="35"/>
          <pc:sldLayoutMkLst>
            <pc:docMk/>
            <pc:sldMasterMk cId="3798544658" sldId="2147483648"/>
            <pc:sldLayoutMk cId="2465856674" sldId="2147483674"/>
          </pc:sldLayoutMkLst>
        </pc:sldLayoutChg>
        <pc:sldLayoutChg chg="add del">
          <pc:chgData name="Solis, Gabriela" userId="S::gsolis_northwell.edu#ext#@hofstra.edu::198dd0ac-6fb3-4b59-b455-eeb2e8da8c00" providerId="AD" clId="Web-{2016D851-910C-402B-87A1-F700B08DAEEA}" dt="2021-07-18T15:27:21.870" v="35"/>
          <pc:sldLayoutMkLst>
            <pc:docMk/>
            <pc:sldMasterMk cId="3798544658" sldId="2147483648"/>
            <pc:sldLayoutMk cId="1790543967" sldId="2147483675"/>
          </pc:sldLayoutMkLst>
        </pc:sldLayoutChg>
        <pc:sldLayoutChg chg="add del">
          <pc:chgData name="Solis, Gabriela" userId="S::gsolis_northwell.edu#ext#@hofstra.edu::198dd0ac-6fb3-4b59-b455-eeb2e8da8c00" providerId="AD" clId="Web-{2016D851-910C-402B-87A1-F700B08DAEEA}" dt="2021-07-18T15:27:21.870" v="35"/>
          <pc:sldLayoutMkLst>
            <pc:docMk/>
            <pc:sldMasterMk cId="3798544658" sldId="2147483648"/>
            <pc:sldLayoutMk cId="392655354" sldId="2147483676"/>
          </pc:sldLayoutMkLst>
        </pc:sldLayoutChg>
      </pc:sldMasterChg>
      <pc:sldMasterChg chg="add del addSldLayout delSldLayout modSldLayout">
        <pc:chgData name="Solis, Gabriela" userId="S::gsolis_northwell.edu#ext#@hofstra.edu::198dd0ac-6fb3-4b59-b455-eeb2e8da8c00" providerId="AD" clId="Web-{2016D851-910C-402B-87A1-F700B08DAEEA}" dt="2021-07-18T14:39:14.993" v="3"/>
        <pc:sldMasterMkLst>
          <pc:docMk/>
          <pc:sldMasterMk cId="695463537" sldId="2147483677"/>
        </pc:sldMasterMkLst>
        <pc:sldLayoutChg chg="add del mod replId">
          <pc:chgData name="Solis, Gabriela" userId="S::gsolis_northwell.edu#ext#@hofstra.edu::198dd0ac-6fb3-4b59-b455-eeb2e8da8c00" providerId="AD" clId="Web-{2016D851-910C-402B-87A1-F700B08DAEEA}" dt="2021-07-18T14:39:14.993" v="3"/>
          <pc:sldLayoutMkLst>
            <pc:docMk/>
            <pc:sldMasterMk cId="695463537" sldId="2147483677"/>
            <pc:sldLayoutMk cId="2237880170" sldId="2147483678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4:39:14.993" v="3"/>
          <pc:sldLayoutMkLst>
            <pc:docMk/>
            <pc:sldMasterMk cId="695463537" sldId="2147483677"/>
            <pc:sldLayoutMk cId="21799982" sldId="2147483679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4:39:14.993" v="3"/>
          <pc:sldLayoutMkLst>
            <pc:docMk/>
            <pc:sldMasterMk cId="695463537" sldId="2147483677"/>
            <pc:sldLayoutMk cId="431548761" sldId="2147483680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4:39:14.993" v="3"/>
          <pc:sldLayoutMkLst>
            <pc:docMk/>
            <pc:sldMasterMk cId="695463537" sldId="2147483677"/>
            <pc:sldLayoutMk cId="1848493124" sldId="2147483681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4:39:14.993" v="3"/>
          <pc:sldLayoutMkLst>
            <pc:docMk/>
            <pc:sldMasterMk cId="695463537" sldId="2147483677"/>
            <pc:sldLayoutMk cId="263666803" sldId="2147483682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4:39:14.993" v="3"/>
          <pc:sldLayoutMkLst>
            <pc:docMk/>
            <pc:sldMasterMk cId="695463537" sldId="2147483677"/>
            <pc:sldLayoutMk cId="1927311584" sldId="2147483683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4:39:14.993" v="3"/>
          <pc:sldLayoutMkLst>
            <pc:docMk/>
            <pc:sldMasterMk cId="695463537" sldId="2147483677"/>
            <pc:sldLayoutMk cId="1011737595" sldId="2147483684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4:39:14.993" v="3"/>
          <pc:sldLayoutMkLst>
            <pc:docMk/>
            <pc:sldMasterMk cId="695463537" sldId="2147483677"/>
            <pc:sldLayoutMk cId="1637298722" sldId="2147483685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4:39:14.993" v="3"/>
          <pc:sldLayoutMkLst>
            <pc:docMk/>
            <pc:sldMasterMk cId="695463537" sldId="2147483677"/>
            <pc:sldLayoutMk cId="746103027" sldId="2147483686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4:39:14.993" v="3"/>
          <pc:sldLayoutMkLst>
            <pc:docMk/>
            <pc:sldMasterMk cId="695463537" sldId="2147483677"/>
            <pc:sldLayoutMk cId="1392914138" sldId="2147483687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4:39:14.993" v="3"/>
          <pc:sldLayoutMkLst>
            <pc:docMk/>
            <pc:sldMasterMk cId="695463537" sldId="2147483677"/>
            <pc:sldLayoutMk cId="2514902292" sldId="2147483688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4:39:14.993" v="3"/>
          <pc:sldLayoutMkLst>
            <pc:docMk/>
            <pc:sldMasterMk cId="695463537" sldId="2147483677"/>
            <pc:sldLayoutMk cId="4191224489" sldId="2147483689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4:39:14.993" v="3"/>
          <pc:sldLayoutMkLst>
            <pc:docMk/>
            <pc:sldMasterMk cId="695463537" sldId="2147483677"/>
            <pc:sldLayoutMk cId="1547547482" sldId="2147483690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4:39:14.993" v="3"/>
          <pc:sldLayoutMkLst>
            <pc:docMk/>
            <pc:sldMasterMk cId="695463537" sldId="2147483677"/>
            <pc:sldLayoutMk cId="1590311162" sldId="2147483691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4:39:14.993" v="3"/>
          <pc:sldLayoutMkLst>
            <pc:docMk/>
            <pc:sldMasterMk cId="695463537" sldId="2147483677"/>
            <pc:sldLayoutMk cId="3802728535" sldId="2147483692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4:39:14.993" v="3"/>
          <pc:sldLayoutMkLst>
            <pc:docMk/>
            <pc:sldMasterMk cId="695463537" sldId="2147483677"/>
            <pc:sldLayoutMk cId="907496361" sldId="2147483693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4:39:14.993" v="3"/>
          <pc:sldLayoutMkLst>
            <pc:docMk/>
            <pc:sldMasterMk cId="695463537" sldId="2147483677"/>
            <pc:sldLayoutMk cId="1336442755" sldId="2147483694"/>
          </pc:sldLayoutMkLst>
        </pc:sldLayoutChg>
      </pc:sldMasterChg>
      <pc:sldMasterChg chg="add del mod setBg addSldLayout delSldLayout modSldLayout">
        <pc:chgData name="Solis, Gabriela" userId="S::gsolis_northwell.edu#ext#@hofstra.edu::198dd0ac-6fb3-4b59-b455-eeb2e8da8c00" providerId="AD" clId="Web-{2016D851-910C-402B-87A1-F700B08DAEEA}" dt="2021-07-18T15:35:51.294" v="68"/>
        <pc:sldMasterMkLst>
          <pc:docMk/>
          <pc:sldMasterMk cId="1343406243" sldId="2147483677"/>
        </pc:sldMasterMkLst>
        <pc:sldLayoutChg chg="add del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1343406243" sldId="2147483677"/>
            <pc:sldLayoutMk cId="1319584029" sldId="2147483678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1343406243" sldId="2147483677"/>
            <pc:sldLayoutMk cId="4035780862" sldId="2147483679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1343406243" sldId="2147483677"/>
            <pc:sldLayoutMk cId="3693081653" sldId="2147483680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1343406243" sldId="2147483677"/>
            <pc:sldLayoutMk cId="3062586774" sldId="2147483681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1343406243" sldId="2147483677"/>
            <pc:sldLayoutMk cId="759664327" sldId="2147483682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1343406243" sldId="2147483677"/>
            <pc:sldLayoutMk cId="2783156083" sldId="2147483683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1343406243" sldId="2147483677"/>
            <pc:sldLayoutMk cId="4074058353" sldId="2147483684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1343406243" sldId="2147483677"/>
            <pc:sldLayoutMk cId="623276261" sldId="2147483685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1343406243" sldId="2147483677"/>
            <pc:sldLayoutMk cId="4067339985" sldId="2147483686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1343406243" sldId="2147483677"/>
            <pc:sldLayoutMk cId="1084921234" sldId="2147483687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1343406243" sldId="2147483677"/>
            <pc:sldLayoutMk cId="2120282739" sldId="2147483688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1343406243" sldId="2147483677"/>
            <pc:sldLayoutMk cId="1790216876" sldId="2147483689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1343406243" sldId="2147483677"/>
            <pc:sldLayoutMk cId="2338621963" sldId="2147483690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1343406243" sldId="2147483677"/>
            <pc:sldLayoutMk cId="3318491744" sldId="2147483691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1343406243" sldId="2147483677"/>
            <pc:sldLayoutMk cId="1338621897" sldId="2147483692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1343406243" sldId="2147483677"/>
            <pc:sldLayoutMk cId="2236853195" sldId="2147483693"/>
          </pc:sldLayoutMkLst>
        </pc:sldLayoutChg>
        <pc:sldLayoutChg chg="add del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1343406243" sldId="2147483677"/>
            <pc:sldLayoutMk cId="523726889" sldId="2147483694"/>
          </pc:sldLayoutMkLst>
        </pc:sldLayoutChg>
      </pc:sldMasterChg>
      <pc:sldMasterChg chg="add addSldLayout modSldLayout">
        <pc:chgData name="Solis, Gabriela" userId="S::gsolis_northwell.edu#ext#@hofstra.edu::198dd0ac-6fb3-4b59-b455-eeb2e8da8c00" providerId="AD" clId="Web-{2016D851-910C-402B-87A1-F700B08DAEEA}" dt="2021-07-18T15:35:51.294" v="68"/>
        <pc:sldMasterMkLst>
          <pc:docMk/>
          <pc:sldMasterMk cId="3448714471" sldId="2147483695"/>
        </pc:sldMasterMkLst>
        <pc:sldLayoutChg chg="add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3448714471" sldId="2147483695"/>
            <pc:sldLayoutMk cId="666550136" sldId="2147483696"/>
          </pc:sldLayoutMkLst>
        </pc:sldLayoutChg>
        <pc:sldLayoutChg chg="add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3448714471" sldId="2147483695"/>
            <pc:sldLayoutMk cId="3913654502" sldId="2147483697"/>
          </pc:sldLayoutMkLst>
        </pc:sldLayoutChg>
        <pc:sldLayoutChg chg="add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3448714471" sldId="2147483695"/>
            <pc:sldLayoutMk cId="3308244237" sldId="2147483698"/>
          </pc:sldLayoutMkLst>
        </pc:sldLayoutChg>
        <pc:sldLayoutChg chg="add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3448714471" sldId="2147483695"/>
            <pc:sldLayoutMk cId="1687265562" sldId="2147483699"/>
          </pc:sldLayoutMkLst>
        </pc:sldLayoutChg>
        <pc:sldLayoutChg chg="add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3448714471" sldId="2147483695"/>
            <pc:sldLayoutMk cId="1963239470" sldId="2147483700"/>
          </pc:sldLayoutMkLst>
        </pc:sldLayoutChg>
        <pc:sldLayoutChg chg="add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3448714471" sldId="2147483695"/>
            <pc:sldLayoutMk cId="2813594893" sldId="2147483701"/>
          </pc:sldLayoutMkLst>
        </pc:sldLayoutChg>
        <pc:sldLayoutChg chg="add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3448714471" sldId="2147483695"/>
            <pc:sldLayoutMk cId="356490746" sldId="2147483702"/>
          </pc:sldLayoutMkLst>
        </pc:sldLayoutChg>
        <pc:sldLayoutChg chg="add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3448714471" sldId="2147483695"/>
            <pc:sldLayoutMk cId="486313649" sldId="2147483703"/>
          </pc:sldLayoutMkLst>
        </pc:sldLayoutChg>
        <pc:sldLayoutChg chg="add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3448714471" sldId="2147483695"/>
            <pc:sldLayoutMk cId="1278152522" sldId="2147483704"/>
          </pc:sldLayoutMkLst>
        </pc:sldLayoutChg>
        <pc:sldLayoutChg chg="add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3448714471" sldId="2147483695"/>
            <pc:sldLayoutMk cId="774919419" sldId="2147483705"/>
          </pc:sldLayoutMkLst>
        </pc:sldLayoutChg>
        <pc:sldLayoutChg chg="add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3448714471" sldId="2147483695"/>
            <pc:sldLayoutMk cId="2305613647" sldId="2147483706"/>
          </pc:sldLayoutMkLst>
        </pc:sldLayoutChg>
        <pc:sldLayoutChg chg="add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3448714471" sldId="2147483695"/>
            <pc:sldLayoutMk cId="4031221868" sldId="2147483707"/>
          </pc:sldLayoutMkLst>
        </pc:sldLayoutChg>
        <pc:sldLayoutChg chg="add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3448714471" sldId="2147483695"/>
            <pc:sldLayoutMk cId="1684858672" sldId="2147483708"/>
          </pc:sldLayoutMkLst>
        </pc:sldLayoutChg>
        <pc:sldLayoutChg chg="add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3448714471" sldId="2147483695"/>
            <pc:sldLayoutMk cId="1385850623" sldId="2147483709"/>
          </pc:sldLayoutMkLst>
        </pc:sldLayoutChg>
        <pc:sldLayoutChg chg="add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3448714471" sldId="2147483695"/>
            <pc:sldLayoutMk cId="2589338492" sldId="2147483710"/>
          </pc:sldLayoutMkLst>
        </pc:sldLayoutChg>
        <pc:sldLayoutChg chg="add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3448714471" sldId="2147483695"/>
            <pc:sldLayoutMk cId="1925324328" sldId="2147483711"/>
          </pc:sldLayoutMkLst>
        </pc:sldLayoutChg>
        <pc:sldLayoutChg chg="add mod replId">
          <pc:chgData name="Solis, Gabriela" userId="S::gsolis_northwell.edu#ext#@hofstra.edu::198dd0ac-6fb3-4b59-b455-eeb2e8da8c00" providerId="AD" clId="Web-{2016D851-910C-402B-87A1-F700B08DAEEA}" dt="2021-07-18T15:35:51.294" v="68"/>
          <pc:sldLayoutMkLst>
            <pc:docMk/>
            <pc:sldMasterMk cId="3448714471" sldId="2147483695"/>
            <pc:sldLayoutMk cId="3452298225" sldId="2147483712"/>
          </pc:sldLayoutMkLst>
        </pc:sldLayoutChg>
      </pc:sldMasterChg>
    </pc:docChg>
  </pc:docChgLst>
  <pc:docChgLst>
    <pc:chgData name="Gabrielle Goldberg" userId="S::gabrielle.goldberg@hofstra.edu::453f9b71-f7a4-4ef4-8e34-bbb69381dfc0" providerId="AD" clId="Web-{25BF3895-FEC8-C9D0-3860-31F148C56734}"/>
    <pc:docChg chg="modSld">
      <pc:chgData name="Gabrielle Goldberg" userId="S::gabrielle.goldberg@hofstra.edu::453f9b71-f7a4-4ef4-8e34-bbb69381dfc0" providerId="AD" clId="Web-{25BF3895-FEC8-C9D0-3860-31F148C56734}" dt="2022-04-04T15:29:43.493" v="12" actId="20577"/>
      <pc:docMkLst>
        <pc:docMk/>
      </pc:docMkLst>
      <pc:sldChg chg="modSp">
        <pc:chgData name="Gabrielle Goldberg" userId="S::gabrielle.goldberg@hofstra.edu::453f9b71-f7a4-4ef4-8e34-bbb69381dfc0" providerId="AD" clId="Web-{25BF3895-FEC8-C9D0-3860-31F148C56734}" dt="2022-04-04T15:29:43.493" v="12" actId="20577"/>
        <pc:sldMkLst>
          <pc:docMk/>
          <pc:sldMk cId="3150183129" sldId="379"/>
        </pc:sldMkLst>
        <pc:graphicFrameChg chg="modGraphic">
          <ac:chgData name="Gabrielle Goldberg" userId="S::gabrielle.goldberg@hofstra.edu::453f9b71-f7a4-4ef4-8e34-bbb69381dfc0" providerId="AD" clId="Web-{25BF3895-FEC8-C9D0-3860-31F148C56734}" dt="2022-04-04T15:29:43.493" v="12" actId="20577"/>
          <ac:graphicFrameMkLst>
            <pc:docMk/>
            <pc:sldMk cId="3150183129" sldId="379"/>
            <ac:graphicFrameMk id="4" creationId="{C1FFCE84-EBCA-4D7F-9C21-DF600EF51E09}"/>
          </ac:graphicFrameMkLst>
        </pc:graphicFrameChg>
      </pc:sldChg>
    </pc:docChg>
  </pc:docChgLst>
  <pc:docChgLst>
    <pc:chgData name="Gabrielle Goldberg" userId="S::gabrielle.goldberg@hofstra.edu::453f9b71-f7a4-4ef4-8e34-bbb69381dfc0" providerId="AD" clId="Web-{F0DBC015-3AFA-1DA8-B850-A44310DD5E32}"/>
    <pc:docChg chg="delSld modSld">
      <pc:chgData name="Gabrielle Goldberg" userId="S::gabrielle.goldberg@hofstra.edu::453f9b71-f7a4-4ef4-8e34-bbb69381dfc0" providerId="AD" clId="Web-{F0DBC015-3AFA-1DA8-B850-A44310DD5E32}" dt="2021-06-30T19:14:40.298" v="4"/>
      <pc:docMkLst>
        <pc:docMk/>
      </pc:docMkLst>
      <pc:sldChg chg="del">
        <pc:chgData name="Gabrielle Goldberg" userId="S::gabrielle.goldberg@hofstra.edu::453f9b71-f7a4-4ef4-8e34-bbb69381dfc0" providerId="AD" clId="Web-{F0DBC015-3AFA-1DA8-B850-A44310DD5E32}" dt="2021-06-30T19:12:34.900" v="0"/>
        <pc:sldMkLst>
          <pc:docMk/>
          <pc:sldMk cId="1404878022" sldId="355"/>
        </pc:sldMkLst>
      </pc:sldChg>
      <pc:sldChg chg="addSp delSp">
        <pc:chgData name="Gabrielle Goldberg" userId="S::gabrielle.goldberg@hofstra.edu::453f9b71-f7a4-4ef4-8e34-bbb69381dfc0" providerId="AD" clId="Web-{F0DBC015-3AFA-1DA8-B850-A44310DD5E32}" dt="2021-06-30T19:13:33.934" v="3"/>
        <pc:sldMkLst>
          <pc:docMk/>
          <pc:sldMk cId="2447000783" sldId="356"/>
        </pc:sldMkLst>
        <pc:spChg chg="add del">
          <ac:chgData name="Gabrielle Goldberg" userId="S::gabrielle.goldberg@hofstra.edu::453f9b71-f7a4-4ef4-8e34-bbb69381dfc0" providerId="AD" clId="Web-{F0DBC015-3AFA-1DA8-B850-A44310DD5E32}" dt="2021-06-30T19:13:33.934" v="3"/>
          <ac:spMkLst>
            <pc:docMk/>
            <pc:sldMk cId="2447000783" sldId="356"/>
            <ac:spMk id="4" creationId="{8F2D1505-6B10-4A0A-ABC2-890ACE1C8E47}"/>
          </ac:spMkLst>
        </pc:spChg>
      </pc:sldChg>
      <pc:sldChg chg="del">
        <pc:chgData name="Gabrielle Goldberg" userId="S::gabrielle.goldberg@hofstra.edu::453f9b71-f7a4-4ef4-8e34-bbb69381dfc0" providerId="AD" clId="Web-{F0DBC015-3AFA-1DA8-B850-A44310DD5E32}" dt="2021-06-30T19:12:39.134" v="1"/>
        <pc:sldMkLst>
          <pc:docMk/>
          <pc:sldMk cId="673837018" sldId="368"/>
        </pc:sldMkLst>
      </pc:sldChg>
      <pc:sldChg chg="del">
        <pc:chgData name="Gabrielle Goldberg" userId="S::gabrielle.goldberg@hofstra.edu::453f9b71-f7a4-4ef4-8e34-bbb69381dfc0" providerId="AD" clId="Web-{F0DBC015-3AFA-1DA8-B850-A44310DD5E32}" dt="2021-06-30T19:14:40.298" v="4"/>
        <pc:sldMkLst>
          <pc:docMk/>
          <pc:sldMk cId="2443411379" sldId="370"/>
        </pc:sldMkLst>
      </pc:sldChg>
    </pc:docChg>
  </pc:docChgLst>
  <pc:docChgLst>
    <pc:chgData name="Gabrielle Goldberg" userId="S::gabrielle.goldberg@hofstra.edu::453f9b71-f7a4-4ef4-8e34-bbb69381dfc0" providerId="AD" clId="Web-{2A44EE98-0380-696A-1435-8CFC95D2E6BC}"/>
    <pc:docChg chg="modSld">
      <pc:chgData name="Gabrielle Goldberg" userId="S::gabrielle.goldberg@hofstra.edu::453f9b71-f7a4-4ef4-8e34-bbb69381dfc0" providerId="AD" clId="Web-{2A44EE98-0380-696A-1435-8CFC95D2E6BC}" dt="2022-04-04T15:27:54.814" v="1" actId="20577"/>
      <pc:docMkLst>
        <pc:docMk/>
      </pc:docMkLst>
      <pc:sldChg chg="modSp">
        <pc:chgData name="Gabrielle Goldberg" userId="S::gabrielle.goldberg@hofstra.edu::453f9b71-f7a4-4ef4-8e34-bbb69381dfc0" providerId="AD" clId="Web-{2A44EE98-0380-696A-1435-8CFC95D2E6BC}" dt="2022-04-04T15:27:54.814" v="1" actId="20577"/>
        <pc:sldMkLst>
          <pc:docMk/>
          <pc:sldMk cId="3150183129" sldId="379"/>
        </pc:sldMkLst>
        <pc:graphicFrameChg chg="modGraphic">
          <ac:chgData name="Gabrielle Goldberg" userId="S::gabrielle.goldberg@hofstra.edu::453f9b71-f7a4-4ef4-8e34-bbb69381dfc0" providerId="AD" clId="Web-{2A44EE98-0380-696A-1435-8CFC95D2E6BC}" dt="2022-04-04T15:27:54.814" v="1" actId="20577"/>
          <ac:graphicFrameMkLst>
            <pc:docMk/>
            <pc:sldMk cId="3150183129" sldId="379"/>
            <ac:graphicFrameMk id="4" creationId="{C1FFCE84-EBCA-4D7F-9C21-DF600EF51E09}"/>
          </ac:graphicFrameMkLst>
        </pc:graphicFrameChg>
      </pc:sldChg>
    </pc:docChg>
  </pc:docChgLst>
  <pc:docChgLst>
    <pc:chgData name="kimberly.kranz@stonybrookmedicine.edu" userId="S::urn:spo:guest#kimberly.kranz@stonybrookmedicine.edu::" providerId="AD" clId="Web-{4768A403-5E62-2F4D-F489-5ABC9113E092}"/>
    <pc:docChg chg="modSld">
      <pc:chgData name="kimberly.kranz@stonybrookmedicine.edu" userId="S::urn:spo:guest#kimberly.kranz@stonybrookmedicine.edu::" providerId="AD" clId="Web-{4768A403-5E62-2F4D-F489-5ABC9113E092}" dt="2021-08-30T00:24:35.759" v="6" actId="20577"/>
      <pc:docMkLst>
        <pc:docMk/>
      </pc:docMkLst>
      <pc:sldChg chg="modSp">
        <pc:chgData name="kimberly.kranz@stonybrookmedicine.edu" userId="S::urn:spo:guest#kimberly.kranz@stonybrookmedicine.edu::" providerId="AD" clId="Web-{4768A403-5E62-2F4D-F489-5ABC9113E092}" dt="2021-08-30T00:24:35.759" v="6" actId="20577"/>
        <pc:sldMkLst>
          <pc:docMk/>
          <pc:sldMk cId="1307065593" sldId="398"/>
        </pc:sldMkLst>
        <pc:spChg chg="mod">
          <ac:chgData name="kimberly.kranz@stonybrookmedicine.edu" userId="S::urn:spo:guest#kimberly.kranz@stonybrookmedicine.edu::" providerId="AD" clId="Web-{4768A403-5E62-2F4D-F489-5ABC9113E092}" dt="2021-08-30T00:23:51.914" v="2" actId="20577"/>
          <ac:spMkLst>
            <pc:docMk/>
            <pc:sldMk cId="1307065593" sldId="398"/>
            <ac:spMk id="3" creationId="{01EBB642-A9A1-4273-829D-59C1EBAD2430}"/>
          </ac:spMkLst>
        </pc:spChg>
        <pc:spChg chg="mod">
          <ac:chgData name="kimberly.kranz@stonybrookmedicine.edu" userId="S::urn:spo:guest#kimberly.kranz@stonybrookmedicine.edu::" providerId="AD" clId="Web-{4768A403-5E62-2F4D-F489-5ABC9113E092}" dt="2021-08-30T00:24:35.759" v="6" actId="20577"/>
          <ac:spMkLst>
            <pc:docMk/>
            <pc:sldMk cId="1307065593" sldId="398"/>
            <ac:spMk id="5" creationId="{4D827504-E1A9-459B-AC84-683A2E7257BC}"/>
          </ac:spMkLst>
        </pc:spChg>
      </pc:sldChg>
    </pc:docChg>
  </pc:docChgLst>
  <pc:docChgLst>
    <pc:chgData name="Guest User" userId="S::urn:spo:anon#4cf4838ef0fbf4d0dba1e40ac72942b61102bea1b1689e895975c57b98f5ef34::" providerId="AD" clId="Web-{FE1BEA36-F7D5-668B-E4BA-5C3256C917B3}"/>
    <pc:docChg chg="modSld">
      <pc:chgData name="Guest User" userId="S::urn:spo:anon#4cf4838ef0fbf4d0dba1e40ac72942b61102bea1b1689e895975c57b98f5ef34::" providerId="AD" clId="Web-{FE1BEA36-F7D5-668B-E4BA-5C3256C917B3}" dt="2022-01-07T14:04:19.517" v="0" actId="14100"/>
      <pc:docMkLst>
        <pc:docMk/>
      </pc:docMkLst>
      <pc:sldChg chg="modSp">
        <pc:chgData name="Guest User" userId="S::urn:spo:anon#4cf4838ef0fbf4d0dba1e40ac72942b61102bea1b1689e895975c57b98f5ef34::" providerId="AD" clId="Web-{FE1BEA36-F7D5-668B-E4BA-5C3256C917B3}" dt="2022-01-07T14:04:19.517" v="0" actId="14100"/>
        <pc:sldMkLst>
          <pc:docMk/>
          <pc:sldMk cId="765348557" sldId="404"/>
        </pc:sldMkLst>
        <pc:picChg chg="mod">
          <ac:chgData name="Guest User" userId="S::urn:spo:anon#4cf4838ef0fbf4d0dba1e40ac72942b61102bea1b1689e895975c57b98f5ef34::" providerId="AD" clId="Web-{FE1BEA36-F7D5-668B-E4BA-5C3256C917B3}" dt="2022-01-07T14:04:19.517" v="0" actId="14100"/>
          <ac:picMkLst>
            <pc:docMk/>
            <pc:sldMk cId="765348557" sldId="404"/>
            <ac:picMk id="10" creationId="{AD189B5F-9199-4378-8933-CD831C7A1BD3}"/>
          </ac:picMkLst>
        </pc:picChg>
      </pc:sldChg>
    </pc:docChg>
  </pc:docChgLst>
  <pc:docChgLst>
    <pc:chgData name="Gabrielle Goldberg" userId="453f9b71-f7a4-4ef4-8e34-bbb69381dfc0" providerId="ADAL" clId="{F4B2A369-8FBD-487F-8ABD-0045CE3772B1}"/>
    <pc:docChg chg="modSld">
      <pc:chgData name="Gabrielle Goldberg" userId="453f9b71-f7a4-4ef4-8e34-bbb69381dfc0" providerId="ADAL" clId="{F4B2A369-8FBD-487F-8ABD-0045CE3772B1}" dt="2022-04-13T14:29:31.386" v="68" actId="20577"/>
      <pc:docMkLst>
        <pc:docMk/>
      </pc:docMkLst>
      <pc:sldChg chg="modSp mod">
        <pc:chgData name="Gabrielle Goldberg" userId="453f9b71-f7a4-4ef4-8e34-bbb69381dfc0" providerId="ADAL" clId="{F4B2A369-8FBD-487F-8ABD-0045CE3772B1}" dt="2022-04-13T14:29:18.375" v="67" actId="20577"/>
        <pc:sldMkLst>
          <pc:docMk/>
          <pc:sldMk cId="3071954687" sldId="382"/>
        </pc:sldMkLst>
        <pc:spChg chg="mod">
          <ac:chgData name="Gabrielle Goldberg" userId="453f9b71-f7a4-4ef4-8e34-bbb69381dfc0" providerId="ADAL" clId="{F4B2A369-8FBD-487F-8ABD-0045CE3772B1}" dt="2022-04-13T14:29:18.375" v="67" actId="20577"/>
          <ac:spMkLst>
            <pc:docMk/>
            <pc:sldMk cId="3071954687" sldId="382"/>
            <ac:spMk id="6" creationId="{00000000-0000-0000-0000-000000000000}"/>
          </ac:spMkLst>
        </pc:spChg>
      </pc:sldChg>
      <pc:sldChg chg="modSp mod">
        <pc:chgData name="Gabrielle Goldberg" userId="453f9b71-f7a4-4ef4-8e34-bbb69381dfc0" providerId="ADAL" clId="{F4B2A369-8FBD-487F-8ABD-0045CE3772B1}" dt="2022-04-13T14:29:31.386" v="68" actId="20577"/>
        <pc:sldMkLst>
          <pc:docMk/>
          <pc:sldMk cId="3711734020" sldId="386"/>
        </pc:sldMkLst>
        <pc:spChg chg="mod">
          <ac:chgData name="Gabrielle Goldberg" userId="453f9b71-f7a4-4ef4-8e34-bbb69381dfc0" providerId="ADAL" clId="{F4B2A369-8FBD-487F-8ABD-0045CE3772B1}" dt="2022-04-13T14:29:31.386" v="68" actId="20577"/>
          <ac:spMkLst>
            <pc:docMk/>
            <pc:sldMk cId="3711734020" sldId="386"/>
            <ac:spMk id="6" creationId="{00000000-0000-0000-0000-000000000000}"/>
          </ac:spMkLst>
        </pc:spChg>
      </pc:sldChg>
      <pc:sldChg chg="modSp mod">
        <pc:chgData name="Gabrielle Goldberg" userId="453f9b71-f7a4-4ef4-8e34-bbb69381dfc0" providerId="ADAL" clId="{F4B2A369-8FBD-487F-8ABD-0045CE3772B1}" dt="2022-04-13T14:10:00.699" v="8" actId="404"/>
        <pc:sldMkLst>
          <pc:docMk/>
          <pc:sldMk cId="1307065593" sldId="398"/>
        </pc:sldMkLst>
        <pc:spChg chg="mod">
          <ac:chgData name="Gabrielle Goldberg" userId="453f9b71-f7a4-4ef4-8e34-bbb69381dfc0" providerId="ADAL" clId="{F4B2A369-8FBD-487F-8ABD-0045CE3772B1}" dt="2022-04-13T14:09:33.653" v="1" actId="404"/>
          <ac:spMkLst>
            <pc:docMk/>
            <pc:sldMk cId="1307065593" sldId="398"/>
            <ac:spMk id="3" creationId="{01EBB642-A9A1-4273-829D-59C1EBAD2430}"/>
          </ac:spMkLst>
        </pc:spChg>
        <pc:spChg chg="mod">
          <ac:chgData name="Gabrielle Goldberg" userId="453f9b71-f7a4-4ef4-8e34-bbb69381dfc0" providerId="ADAL" clId="{F4B2A369-8FBD-487F-8ABD-0045CE3772B1}" dt="2022-04-13T14:10:00.699" v="8" actId="404"/>
          <ac:spMkLst>
            <pc:docMk/>
            <pc:sldMk cId="1307065593" sldId="398"/>
            <ac:spMk id="5" creationId="{4D827504-E1A9-459B-AC84-683A2E7257BC}"/>
          </ac:spMkLst>
        </pc:spChg>
      </pc:sldChg>
      <pc:sldChg chg="modSp mod">
        <pc:chgData name="Gabrielle Goldberg" userId="453f9b71-f7a4-4ef4-8e34-bbb69381dfc0" providerId="ADAL" clId="{F4B2A369-8FBD-487F-8ABD-0045CE3772B1}" dt="2022-04-13T14:28:17.503" v="26" actId="20577"/>
        <pc:sldMkLst>
          <pc:docMk/>
          <pc:sldMk cId="1016746710" sldId="399"/>
        </pc:sldMkLst>
        <pc:spChg chg="mod">
          <ac:chgData name="Gabrielle Goldberg" userId="453f9b71-f7a4-4ef4-8e34-bbb69381dfc0" providerId="ADAL" clId="{F4B2A369-8FBD-487F-8ABD-0045CE3772B1}" dt="2022-04-13T14:28:17.503" v="26" actId="20577"/>
          <ac:spMkLst>
            <pc:docMk/>
            <pc:sldMk cId="1016746710" sldId="399"/>
            <ac:spMk id="3" creationId="{01EBB642-A9A1-4273-829D-59C1EBAD2430}"/>
          </ac:spMkLst>
        </pc:spChg>
      </pc:sldChg>
    </pc:docChg>
  </pc:docChgLst>
  <pc:docChgLst>
    <pc:chgData name="dra.gabrielasolis@gmail.com" userId="S::urn:spo:guest#dra.gabrielasolis@gmail.com::" providerId="AD" clId="Web-{B0022B9C-D30A-55CE-5433-E11B62E6FF18}"/>
    <pc:docChg chg="modSld">
      <pc:chgData name="dra.gabrielasolis@gmail.com" userId="S::urn:spo:guest#dra.gabrielasolis@gmail.com::" providerId="AD" clId="Web-{B0022B9C-D30A-55CE-5433-E11B62E6FF18}" dt="2021-10-04T17:03:46.916" v="5" actId="20577"/>
      <pc:docMkLst>
        <pc:docMk/>
      </pc:docMkLst>
      <pc:sldChg chg="modSp">
        <pc:chgData name="dra.gabrielasolis@gmail.com" userId="S::urn:spo:guest#dra.gabrielasolis@gmail.com::" providerId="AD" clId="Web-{B0022B9C-D30A-55CE-5433-E11B62E6FF18}" dt="2021-10-04T17:03:46.916" v="5" actId="20577"/>
        <pc:sldMkLst>
          <pc:docMk/>
          <pc:sldMk cId="2389432848" sldId="409"/>
        </pc:sldMkLst>
        <pc:spChg chg="mod">
          <ac:chgData name="dra.gabrielasolis@gmail.com" userId="S::urn:spo:guest#dra.gabrielasolis@gmail.com::" providerId="AD" clId="Web-{B0022B9C-D30A-55CE-5433-E11B62E6FF18}" dt="2021-10-04T17:03:46.916" v="5" actId="20577"/>
          <ac:spMkLst>
            <pc:docMk/>
            <pc:sldMk cId="2389432848" sldId="409"/>
            <ac:spMk id="2" creationId="{F5DB7307-1746-4922-9F95-1D256AAE3CCD}"/>
          </ac:spMkLst>
        </pc:spChg>
      </pc:sldChg>
    </pc:docChg>
  </pc:docChgLst>
  <pc:docChgLst>
    <pc:chgData name="Gabrielle Goldberg" userId="S::gabrielle.goldberg@hofstra.edu::453f9b71-f7a4-4ef4-8e34-bbb69381dfc0" providerId="AD" clId="Web-{F6BEE2D8-84E6-86FC-382D-248CD5390E22}"/>
    <pc:docChg chg="addSld delSld modSld sldOrd">
      <pc:chgData name="Gabrielle Goldberg" userId="S::gabrielle.goldberg@hofstra.edu::453f9b71-f7a4-4ef4-8e34-bbb69381dfc0" providerId="AD" clId="Web-{F6BEE2D8-84E6-86FC-382D-248CD5390E22}" dt="2021-07-28T02:17:00.636" v="106" actId="20577"/>
      <pc:docMkLst>
        <pc:docMk/>
      </pc:docMkLst>
      <pc:sldChg chg="modSp">
        <pc:chgData name="Gabrielle Goldberg" userId="S::gabrielle.goldberg@hofstra.edu::453f9b71-f7a4-4ef4-8e34-bbb69381dfc0" providerId="AD" clId="Web-{F6BEE2D8-84E6-86FC-382D-248CD5390E22}" dt="2021-07-28T02:11:12.752" v="90" actId="20577"/>
        <pc:sldMkLst>
          <pc:docMk/>
          <pc:sldMk cId="956818366" sldId="362"/>
        </pc:sldMkLst>
        <pc:spChg chg="mod">
          <ac:chgData name="Gabrielle Goldberg" userId="S::gabrielle.goldberg@hofstra.edu::453f9b71-f7a4-4ef4-8e34-bbb69381dfc0" providerId="AD" clId="Web-{F6BEE2D8-84E6-86FC-382D-248CD5390E22}" dt="2021-07-28T02:11:12.752" v="90" actId="20577"/>
          <ac:spMkLst>
            <pc:docMk/>
            <pc:sldMk cId="956818366" sldId="362"/>
            <ac:spMk id="5" creationId="{B1141BC7-349B-4BD4-A9CA-AE55A6EE3D44}"/>
          </ac:spMkLst>
        </pc:spChg>
      </pc:sldChg>
      <pc:sldChg chg="del">
        <pc:chgData name="Gabrielle Goldberg" userId="S::gabrielle.goldberg@hofstra.edu::453f9b71-f7a4-4ef4-8e34-bbb69381dfc0" providerId="AD" clId="Web-{F6BEE2D8-84E6-86FC-382D-248CD5390E22}" dt="2021-07-27T19:59:45.925" v="0"/>
        <pc:sldMkLst>
          <pc:docMk/>
          <pc:sldMk cId="2919230525" sldId="364"/>
        </pc:sldMkLst>
      </pc:sldChg>
      <pc:sldChg chg="modSp">
        <pc:chgData name="Gabrielle Goldberg" userId="S::gabrielle.goldberg@hofstra.edu::453f9b71-f7a4-4ef4-8e34-bbb69381dfc0" providerId="AD" clId="Web-{F6BEE2D8-84E6-86FC-382D-248CD5390E22}" dt="2021-07-27T20:54:37.938" v="68" actId="20577"/>
        <pc:sldMkLst>
          <pc:docMk/>
          <pc:sldMk cId="2418592727" sldId="373"/>
        </pc:sldMkLst>
        <pc:spChg chg="mod">
          <ac:chgData name="Gabrielle Goldberg" userId="S::gabrielle.goldberg@hofstra.edu::453f9b71-f7a4-4ef4-8e34-bbb69381dfc0" providerId="AD" clId="Web-{F6BEE2D8-84E6-86FC-382D-248CD5390E22}" dt="2021-07-27T20:54:37.938" v="68" actId="20577"/>
          <ac:spMkLst>
            <pc:docMk/>
            <pc:sldMk cId="2418592727" sldId="373"/>
            <ac:spMk id="11" creationId="{089DD99E-0D17-4C5D-B955-09FF7808AF36}"/>
          </ac:spMkLst>
        </pc:spChg>
      </pc:sldChg>
      <pc:sldChg chg="modSp ord">
        <pc:chgData name="Gabrielle Goldberg" userId="S::gabrielle.goldberg@hofstra.edu::453f9b71-f7a4-4ef4-8e34-bbb69381dfc0" providerId="AD" clId="Web-{F6BEE2D8-84E6-86FC-382D-248CD5390E22}" dt="2021-07-27T20:50:24.408" v="67" actId="20577"/>
        <pc:sldMkLst>
          <pc:docMk/>
          <pc:sldMk cId="1807645662" sldId="385"/>
        </pc:sldMkLst>
        <pc:spChg chg="mod">
          <ac:chgData name="Gabrielle Goldberg" userId="S::gabrielle.goldberg@hofstra.edu::453f9b71-f7a4-4ef4-8e34-bbb69381dfc0" providerId="AD" clId="Web-{F6BEE2D8-84E6-86FC-382D-248CD5390E22}" dt="2021-07-27T20:50:10.032" v="64" actId="20577"/>
          <ac:spMkLst>
            <pc:docMk/>
            <pc:sldMk cId="1807645662" sldId="385"/>
            <ac:spMk id="2" creationId="{00000000-0000-0000-0000-000000000000}"/>
          </ac:spMkLst>
        </pc:spChg>
        <pc:spChg chg="mod">
          <ac:chgData name="Gabrielle Goldberg" userId="S::gabrielle.goldberg@hofstra.edu::453f9b71-f7a4-4ef4-8e34-bbb69381dfc0" providerId="AD" clId="Web-{F6BEE2D8-84E6-86FC-382D-248CD5390E22}" dt="2021-07-27T20:50:24.408" v="67" actId="20577"/>
          <ac:spMkLst>
            <pc:docMk/>
            <pc:sldMk cId="1807645662" sldId="385"/>
            <ac:spMk id="6" creationId="{00000000-0000-0000-0000-000000000000}"/>
          </ac:spMkLst>
        </pc:spChg>
      </pc:sldChg>
      <pc:sldChg chg="addSp modSp mod setBg">
        <pc:chgData name="Gabrielle Goldberg" userId="S::gabrielle.goldberg@hofstra.edu::453f9b71-f7a4-4ef4-8e34-bbb69381dfc0" providerId="AD" clId="Web-{F6BEE2D8-84E6-86FC-382D-248CD5390E22}" dt="2021-07-27T21:14:59.838" v="89" actId="1076"/>
        <pc:sldMkLst>
          <pc:docMk/>
          <pc:sldMk cId="198615434" sldId="392"/>
        </pc:sldMkLst>
        <pc:spChg chg="mod">
          <ac:chgData name="Gabrielle Goldberg" userId="S::gabrielle.goldberg@hofstra.edu::453f9b71-f7a4-4ef4-8e34-bbb69381dfc0" providerId="AD" clId="Web-{F6BEE2D8-84E6-86FC-382D-248CD5390E22}" dt="2021-07-27T21:14:34.227" v="76"/>
          <ac:spMkLst>
            <pc:docMk/>
            <pc:sldMk cId="198615434" sldId="392"/>
            <ac:spMk id="2" creationId="{00000000-0000-0000-0000-000000000000}"/>
          </ac:spMkLst>
        </pc:spChg>
        <pc:spChg chg="mod">
          <ac:chgData name="Gabrielle Goldberg" userId="S::gabrielle.goldberg@hofstra.edu::453f9b71-f7a4-4ef4-8e34-bbb69381dfc0" providerId="AD" clId="Web-{F6BEE2D8-84E6-86FC-382D-248CD5390E22}" dt="2021-07-27T21:14:59.838" v="89" actId="1076"/>
          <ac:spMkLst>
            <pc:docMk/>
            <pc:sldMk cId="198615434" sldId="392"/>
            <ac:spMk id="6" creationId="{00000000-0000-0000-0000-000000000000}"/>
          </ac:spMkLst>
        </pc:spChg>
        <pc:spChg chg="add">
          <ac:chgData name="Gabrielle Goldberg" userId="S::gabrielle.goldberg@hofstra.edu::453f9b71-f7a4-4ef4-8e34-bbb69381dfc0" providerId="AD" clId="Web-{F6BEE2D8-84E6-86FC-382D-248CD5390E22}" dt="2021-07-27T21:14:34.227" v="76"/>
          <ac:spMkLst>
            <pc:docMk/>
            <pc:sldMk cId="198615434" sldId="392"/>
            <ac:spMk id="11" creationId="{6A1473A6-3F22-483E-8A30-80B9D2B14592}"/>
          </ac:spMkLst>
        </pc:spChg>
        <pc:grpChg chg="add">
          <ac:chgData name="Gabrielle Goldberg" userId="S::gabrielle.goldberg@hofstra.edu::453f9b71-f7a4-4ef4-8e34-bbb69381dfc0" providerId="AD" clId="Web-{F6BEE2D8-84E6-86FC-382D-248CD5390E22}" dt="2021-07-27T21:14:34.227" v="76"/>
          <ac:grpSpMkLst>
            <pc:docMk/>
            <pc:sldMk cId="198615434" sldId="392"/>
            <ac:grpSpMk id="13" creationId="{AA1375E3-3E53-4D75-BAB7-E5929BFCB25F}"/>
          </ac:grpSpMkLst>
        </pc:grpChg>
      </pc:sldChg>
      <pc:sldChg chg="modSp">
        <pc:chgData name="Gabrielle Goldberg" userId="S::gabrielle.goldberg@hofstra.edu::453f9b71-f7a4-4ef4-8e34-bbb69381dfc0" providerId="AD" clId="Web-{F6BEE2D8-84E6-86FC-382D-248CD5390E22}" dt="2021-07-28T02:17:00.636" v="106" actId="20577"/>
        <pc:sldMkLst>
          <pc:docMk/>
          <pc:sldMk cId="32438913" sldId="401"/>
        </pc:sldMkLst>
        <pc:spChg chg="mod">
          <ac:chgData name="Gabrielle Goldberg" userId="S::gabrielle.goldberg@hofstra.edu::453f9b71-f7a4-4ef4-8e34-bbb69381dfc0" providerId="AD" clId="Web-{F6BEE2D8-84E6-86FC-382D-248CD5390E22}" dt="2021-07-28T02:17:00.636" v="106" actId="20577"/>
          <ac:spMkLst>
            <pc:docMk/>
            <pc:sldMk cId="32438913" sldId="401"/>
            <ac:spMk id="3" creationId="{9A392957-BD48-49DE-8599-0E44A1AE6D05}"/>
          </ac:spMkLst>
        </pc:spChg>
      </pc:sldChg>
      <pc:sldChg chg="addSp delSp modSp del">
        <pc:chgData name="Gabrielle Goldberg" userId="S::gabrielle.goldberg@hofstra.edu::453f9b71-f7a4-4ef4-8e34-bbb69381dfc0" providerId="AD" clId="Web-{F6BEE2D8-84E6-86FC-382D-248CD5390E22}" dt="2021-07-27T20:02:39.804" v="34"/>
        <pc:sldMkLst>
          <pc:docMk/>
          <pc:sldMk cId="819918547" sldId="408"/>
        </pc:sldMkLst>
        <pc:spChg chg="mod">
          <ac:chgData name="Gabrielle Goldberg" userId="S::gabrielle.goldberg@hofstra.edu::453f9b71-f7a4-4ef4-8e34-bbb69381dfc0" providerId="AD" clId="Web-{F6BEE2D8-84E6-86FC-382D-248CD5390E22}" dt="2021-07-27T20:02:27.507" v="29" actId="20577"/>
          <ac:spMkLst>
            <pc:docMk/>
            <pc:sldMk cId="819918547" sldId="408"/>
            <ac:spMk id="3" creationId="{5824E19E-D23E-4266-B80F-87F9194F302B}"/>
          </ac:spMkLst>
        </pc:spChg>
        <pc:spChg chg="add del mod">
          <ac:chgData name="Gabrielle Goldberg" userId="S::gabrielle.goldberg@hofstra.edu::453f9b71-f7a4-4ef4-8e34-bbb69381dfc0" providerId="AD" clId="Web-{F6BEE2D8-84E6-86FC-382D-248CD5390E22}" dt="2021-07-27T20:00:02.753" v="5"/>
          <ac:spMkLst>
            <pc:docMk/>
            <pc:sldMk cId="819918547" sldId="408"/>
            <ac:spMk id="4" creationId="{1DDD05AF-7F7D-4B4B-831E-B0A626535EE0}"/>
          </ac:spMkLst>
        </pc:spChg>
      </pc:sldChg>
      <pc:sldChg chg="addSp delSp modSp add del replId">
        <pc:chgData name="Gabrielle Goldberg" userId="S::gabrielle.goldberg@hofstra.edu::453f9b71-f7a4-4ef4-8e34-bbb69381dfc0" providerId="AD" clId="Web-{F6BEE2D8-84E6-86FC-382D-248CD5390E22}" dt="2021-07-27T20:01:13.224" v="13"/>
        <pc:sldMkLst>
          <pc:docMk/>
          <pc:sldMk cId="1019630946" sldId="409"/>
        </pc:sldMkLst>
        <pc:spChg chg="del mod">
          <ac:chgData name="Gabrielle Goldberg" userId="S::gabrielle.goldberg@hofstra.edu::453f9b71-f7a4-4ef4-8e34-bbb69381dfc0" providerId="AD" clId="Web-{F6BEE2D8-84E6-86FC-382D-248CD5390E22}" dt="2021-07-27T20:00:38.566" v="9"/>
          <ac:spMkLst>
            <pc:docMk/>
            <pc:sldMk cId="1019630946" sldId="409"/>
            <ac:spMk id="2" creationId="{00000000-0000-0000-0000-000000000000}"/>
          </ac:spMkLst>
        </pc:spChg>
        <pc:spChg chg="add">
          <ac:chgData name="Gabrielle Goldberg" userId="S::gabrielle.goldberg@hofstra.edu::453f9b71-f7a4-4ef4-8e34-bbb69381dfc0" providerId="AD" clId="Web-{F6BEE2D8-84E6-86FC-382D-248CD5390E22}" dt="2021-07-27T20:00:35.160" v="7"/>
          <ac:spMkLst>
            <pc:docMk/>
            <pc:sldMk cId="1019630946" sldId="409"/>
            <ac:spMk id="3" creationId="{84CD8672-201E-48AD-AF6D-B88950F8797F}"/>
          </ac:spMkLst>
        </pc:spChg>
        <pc:spChg chg="del mod">
          <ac:chgData name="Gabrielle Goldberg" userId="S::gabrielle.goldberg@hofstra.edu::453f9b71-f7a4-4ef4-8e34-bbb69381dfc0" providerId="AD" clId="Web-{F6BEE2D8-84E6-86FC-382D-248CD5390E22}" dt="2021-07-27T20:00:56.036" v="12"/>
          <ac:spMkLst>
            <pc:docMk/>
            <pc:sldMk cId="1019630946" sldId="409"/>
            <ac:spMk id="6" creationId="{00000000-0000-0000-0000-000000000000}"/>
          </ac:spMkLst>
        </pc:spChg>
        <pc:spChg chg="add del mod">
          <ac:chgData name="Gabrielle Goldberg" userId="S::gabrielle.goldberg@hofstra.edu::453f9b71-f7a4-4ef4-8e34-bbb69381dfc0" providerId="AD" clId="Web-{F6BEE2D8-84E6-86FC-382D-248CD5390E22}" dt="2021-07-27T20:00:40.707" v="10"/>
          <ac:spMkLst>
            <pc:docMk/>
            <pc:sldMk cId="1019630946" sldId="409"/>
            <ac:spMk id="7" creationId="{E878D5F5-7FF5-4717-9CC7-FA3815CC5265}"/>
          </ac:spMkLst>
        </pc:spChg>
        <pc:spChg chg="add mod">
          <ac:chgData name="Gabrielle Goldberg" userId="S::gabrielle.goldberg@hofstra.edu::453f9b71-f7a4-4ef4-8e34-bbb69381dfc0" providerId="AD" clId="Web-{F6BEE2D8-84E6-86FC-382D-248CD5390E22}" dt="2021-07-27T20:00:56.036" v="12"/>
          <ac:spMkLst>
            <pc:docMk/>
            <pc:sldMk cId="1019630946" sldId="409"/>
            <ac:spMk id="9" creationId="{3E100D53-C567-414B-8068-DF1CE52AC4A5}"/>
          </ac:spMkLst>
        </pc:spChg>
      </pc:sldChg>
      <pc:sldChg chg="addSp delSp modSp new ord">
        <pc:chgData name="Gabrielle Goldberg" userId="S::gabrielle.goldberg@hofstra.edu::453f9b71-f7a4-4ef4-8e34-bbb69381dfc0" providerId="AD" clId="Web-{F6BEE2D8-84E6-86FC-382D-248CD5390E22}" dt="2021-07-27T20:47:24.038" v="62" actId="1076"/>
        <pc:sldMkLst>
          <pc:docMk/>
          <pc:sldMk cId="2389432848" sldId="409"/>
        </pc:sldMkLst>
        <pc:spChg chg="mod">
          <ac:chgData name="Gabrielle Goldberg" userId="S::gabrielle.goldberg@hofstra.edu::453f9b71-f7a4-4ef4-8e34-bbb69381dfc0" providerId="AD" clId="Web-{F6BEE2D8-84E6-86FC-382D-248CD5390E22}" dt="2021-07-27T20:47:15.944" v="60" actId="1076"/>
          <ac:spMkLst>
            <pc:docMk/>
            <pc:sldMk cId="2389432848" sldId="409"/>
            <ac:spMk id="2" creationId="{F5DB7307-1746-4922-9F95-1D256AAE3CCD}"/>
          </ac:spMkLst>
        </pc:spChg>
        <pc:spChg chg="mod">
          <ac:chgData name="Gabrielle Goldberg" userId="S::gabrielle.goldberg@hofstra.edu::453f9b71-f7a4-4ef4-8e34-bbb69381dfc0" providerId="AD" clId="Web-{F6BEE2D8-84E6-86FC-382D-248CD5390E22}" dt="2021-07-27T20:47:21.257" v="61" actId="1076"/>
          <ac:spMkLst>
            <pc:docMk/>
            <pc:sldMk cId="2389432848" sldId="409"/>
            <ac:spMk id="3" creationId="{E9EDFBA1-7150-400B-8F65-B9FCC70F6A35}"/>
          </ac:spMkLst>
        </pc:spChg>
        <pc:spChg chg="mod">
          <ac:chgData name="Gabrielle Goldberg" userId="S::gabrielle.goldberg@hofstra.edu::453f9b71-f7a4-4ef4-8e34-bbb69381dfc0" providerId="AD" clId="Web-{F6BEE2D8-84E6-86FC-382D-248CD5390E22}" dt="2021-07-27T20:02:32.460" v="31" actId="20577"/>
          <ac:spMkLst>
            <pc:docMk/>
            <pc:sldMk cId="2389432848" sldId="409"/>
            <ac:spMk id="4" creationId="{CF87B560-4C68-4A2F-B481-48FC61CDA60E}"/>
          </ac:spMkLst>
        </pc:spChg>
        <pc:spChg chg="mod">
          <ac:chgData name="Gabrielle Goldberg" userId="S::gabrielle.goldberg@hofstra.edu::453f9b71-f7a4-4ef4-8e34-bbb69381dfc0" providerId="AD" clId="Web-{F6BEE2D8-84E6-86FC-382D-248CD5390E22}" dt="2021-07-27T20:47:24.038" v="62" actId="1076"/>
          <ac:spMkLst>
            <pc:docMk/>
            <pc:sldMk cId="2389432848" sldId="409"/>
            <ac:spMk id="5" creationId="{A27BCAED-3F39-4CA1-90F6-B019F5180986}"/>
          </ac:spMkLst>
        </pc:spChg>
        <pc:spChg chg="mod">
          <ac:chgData name="Gabrielle Goldberg" userId="S::gabrielle.goldberg@hofstra.edu::453f9b71-f7a4-4ef4-8e34-bbb69381dfc0" providerId="AD" clId="Web-{F6BEE2D8-84E6-86FC-382D-248CD5390E22}" dt="2021-07-27T20:47:05.131" v="59"/>
          <ac:spMkLst>
            <pc:docMk/>
            <pc:sldMk cId="2389432848" sldId="409"/>
            <ac:spMk id="6" creationId="{98B8DFB9-1F78-4DD6-8614-43290A1C6FC8}"/>
          </ac:spMkLst>
        </pc:spChg>
        <pc:spChg chg="add del mod">
          <ac:chgData name="Gabrielle Goldberg" userId="S::gabrielle.goldberg@hofstra.edu::453f9b71-f7a4-4ef4-8e34-bbb69381dfc0" providerId="AD" clId="Web-{F6BEE2D8-84E6-86FC-382D-248CD5390E22}" dt="2021-07-27T20:01:58.162" v="22" actId="20577"/>
          <ac:spMkLst>
            <pc:docMk/>
            <pc:sldMk cId="2389432848" sldId="409"/>
            <ac:spMk id="8" creationId="{DE6E634D-2125-44BD-9263-CAA78BF43F72}"/>
          </ac:spMkLst>
        </pc:spChg>
      </pc:sldChg>
      <pc:sldChg chg="modSp new ord">
        <pc:chgData name="Gabrielle Goldberg" userId="S::gabrielle.goldberg@hofstra.edu::453f9b71-f7a4-4ef4-8e34-bbb69381dfc0" providerId="AD" clId="Web-{F6BEE2D8-84E6-86FC-382D-248CD5390E22}" dt="2021-07-27T20:59:04.969" v="75" actId="20577"/>
        <pc:sldMkLst>
          <pc:docMk/>
          <pc:sldMk cId="3564809918" sldId="410"/>
        </pc:sldMkLst>
        <pc:spChg chg="mod">
          <ac:chgData name="Gabrielle Goldberg" userId="S::gabrielle.goldberg@hofstra.edu::453f9b71-f7a4-4ef4-8e34-bbb69381dfc0" providerId="AD" clId="Web-{F6BEE2D8-84E6-86FC-382D-248CD5390E22}" dt="2021-07-27T20:59:04.969" v="75" actId="20577"/>
          <ac:spMkLst>
            <pc:docMk/>
            <pc:sldMk cId="3564809918" sldId="410"/>
            <ac:spMk id="2" creationId="{1CE1D0ED-644E-4D9E-A6DC-E5004188598F}"/>
          </ac:spMkLst>
        </pc:spChg>
      </pc:sldChg>
    </pc:docChg>
  </pc:docChgLst>
  <pc:docChgLst>
    <pc:chgData name="Gabrielle Goldberg" userId="S::gabrielle.goldberg@hofstra.edu::453f9b71-f7a4-4ef4-8e34-bbb69381dfc0" providerId="AD" clId="Web-{2B0ACB10-1043-4FB3-3E84-021C41B2C513}"/>
    <pc:docChg chg="modSld">
      <pc:chgData name="Gabrielle Goldberg" userId="S::gabrielle.goldberg@hofstra.edu::453f9b71-f7a4-4ef4-8e34-bbb69381dfc0" providerId="AD" clId="Web-{2B0ACB10-1043-4FB3-3E84-021C41B2C513}" dt="2022-03-31T14:55:59.634" v="103" actId="20577"/>
      <pc:docMkLst>
        <pc:docMk/>
      </pc:docMkLst>
      <pc:sldChg chg="modSp">
        <pc:chgData name="Gabrielle Goldberg" userId="S::gabrielle.goldberg@hofstra.edu::453f9b71-f7a4-4ef4-8e34-bbb69381dfc0" providerId="AD" clId="Web-{2B0ACB10-1043-4FB3-3E84-021C41B2C513}" dt="2022-03-31T14:14:03.421" v="12" actId="20577"/>
        <pc:sldMkLst>
          <pc:docMk/>
          <pc:sldMk cId="3061336521" sldId="318"/>
        </pc:sldMkLst>
        <pc:spChg chg="mod">
          <ac:chgData name="Gabrielle Goldberg" userId="S::gabrielle.goldberg@hofstra.edu::453f9b71-f7a4-4ef4-8e34-bbb69381dfc0" providerId="AD" clId="Web-{2B0ACB10-1043-4FB3-3E84-021C41B2C513}" dt="2022-03-31T14:14:03.421" v="12" actId="20577"/>
          <ac:spMkLst>
            <pc:docMk/>
            <pc:sldMk cId="3061336521" sldId="318"/>
            <ac:spMk id="6" creationId="{00000000-0000-0000-0000-000000000000}"/>
          </ac:spMkLst>
        </pc:spChg>
      </pc:sldChg>
      <pc:sldChg chg="modSp">
        <pc:chgData name="Gabrielle Goldberg" userId="S::gabrielle.goldberg@hofstra.edu::453f9b71-f7a4-4ef4-8e34-bbb69381dfc0" providerId="AD" clId="Web-{2B0ACB10-1043-4FB3-3E84-021C41B2C513}" dt="2022-03-31T14:52:47.551" v="59" actId="20577"/>
        <pc:sldMkLst>
          <pc:docMk/>
          <pc:sldMk cId="3995300267" sldId="358"/>
        </pc:sldMkLst>
        <pc:spChg chg="mod">
          <ac:chgData name="Gabrielle Goldberg" userId="S::gabrielle.goldberg@hofstra.edu::453f9b71-f7a4-4ef4-8e34-bbb69381dfc0" providerId="AD" clId="Web-{2B0ACB10-1043-4FB3-3E84-021C41B2C513}" dt="2022-03-31T14:52:40.910" v="57" actId="20577"/>
          <ac:spMkLst>
            <pc:docMk/>
            <pc:sldMk cId="3995300267" sldId="358"/>
            <ac:spMk id="3" creationId="{9A392957-BD48-49DE-8599-0E44A1AE6D05}"/>
          </ac:spMkLst>
        </pc:spChg>
        <pc:spChg chg="mod">
          <ac:chgData name="Gabrielle Goldberg" userId="S::gabrielle.goldberg@hofstra.edu::453f9b71-f7a4-4ef4-8e34-bbb69381dfc0" providerId="AD" clId="Web-{2B0ACB10-1043-4FB3-3E84-021C41B2C513}" dt="2022-03-31T14:52:47.551" v="59" actId="20577"/>
          <ac:spMkLst>
            <pc:docMk/>
            <pc:sldMk cId="3995300267" sldId="358"/>
            <ac:spMk id="5" creationId="{B1141BC7-349B-4BD4-A9CA-AE55A6EE3D44}"/>
          </ac:spMkLst>
        </pc:spChg>
      </pc:sldChg>
      <pc:sldChg chg="modSp">
        <pc:chgData name="Gabrielle Goldberg" userId="S::gabrielle.goldberg@hofstra.edu::453f9b71-f7a4-4ef4-8e34-bbb69381dfc0" providerId="AD" clId="Web-{2B0ACB10-1043-4FB3-3E84-021C41B2C513}" dt="2022-03-31T14:53:07.786" v="62" actId="20577"/>
        <pc:sldMkLst>
          <pc:docMk/>
          <pc:sldMk cId="2439297039" sldId="367"/>
        </pc:sldMkLst>
        <pc:spChg chg="mod">
          <ac:chgData name="Gabrielle Goldberg" userId="S::gabrielle.goldberg@hofstra.edu::453f9b71-f7a4-4ef4-8e34-bbb69381dfc0" providerId="AD" clId="Web-{2B0ACB10-1043-4FB3-3E84-021C41B2C513}" dt="2022-03-31T14:53:07.786" v="62" actId="20577"/>
          <ac:spMkLst>
            <pc:docMk/>
            <pc:sldMk cId="2439297039" sldId="367"/>
            <ac:spMk id="2" creationId="{9711D05B-1A6A-4785-9233-25614CFC03CE}"/>
          </ac:spMkLst>
        </pc:spChg>
      </pc:sldChg>
      <pc:sldChg chg="modSp">
        <pc:chgData name="Gabrielle Goldberg" userId="S::gabrielle.goldberg@hofstra.edu::453f9b71-f7a4-4ef4-8e34-bbb69381dfc0" providerId="AD" clId="Web-{2B0ACB10-1043-4FB3-3E84-021C41B2C513}" dt="2022-03-31T14:12:56.498" v="8" actId="20577"/>
        <pc:sldMkLst>
          <pc:docMk/>
          <pc:sldMk cId="278272457" sldId="378"/>
        </pc:sldMkLst>
        <pc:spChg chg="mod">
          <ac:chgData name="Gabrielle Goldberg" userId="S::gabrielle.goldberg@hofstra.edu::453f9b71-f7a4-4ef4-8e34-bbb69381dfc0" providerId="AD" clId="Web-{2B0ACB10-1043-4FB3-3E84-021C41B2C513}" dt="2022-03-31T14:12:56.498" v="8" actId="20577"/>
          <ac:spMkLst>
            <pc:docMk/>
            <pc:sldMk cId="278272457" sldId="378"/>
            <ac:spMk id="3" creationId="{2B81FEFF-2091-470B-97BD-B2221C0ED1FB}"/>
          </ac:spMkLst>
        </pc:spChg>
      </pc:sldChg>
      <pc:sldChg chg="modSp">
        <pc:chgData name="Gabrielle Goldberg" userId="S::gabrielle.goldberg@hofstra.edu::453f9b71-f7a4-4ef4-8e34-bbb69381dfc0" providerId="AD" clId="Web-{2B0ACB10-1043-4FB3-3E84-021C41B2C513}" dt="2022-03-31T14:14:47" v="20" actId="20577"/>
        <pc:sldMkLst>
          <pc:docMk/>
          <pc:sldMk cId="1807645662" sldId="385"/>
        </pc:sldMkLst>
        <pc:spChg chg="mod">
          <ac:chgData name="Gabrielle Goldberg" userId="S::gabrielle.goldberg@hofstra.edu::453f9b71-f7a4-4ef4-8e34-bbb69381dfc0" providerId="AD" clId="Web-{2B0ACB10-1043-4FB3-3E84-021C41B2C513}" dt="2022-03-31T14:14:47" v="20" actId="20577"/>
          <ac:spMkLst>
            <pc:docMk/>
            <pc:sldMk cId="1807645662" sldId="385"/>
            <ac:spMk id="6" creationId="{00000000-0000-0000-0000-000000000000}"/>
          </ac:spMkLst>
        </pc:spChg>
      </pc:sldChg>
      <pc:sldChg chg="modSp">
        <pc:chgData name="Gabrielle Goldberg" userId="S::gabrielle.goldberg@hofstra.edu::453f9b71-f7a4-4ef4-8e34-bbb69381dfc0" providerId="AD" clId="Web-{2B0ACB10-1043-4FB3-3E84-021C41B2C513}" dt="2022-03-31T14:15:14.157" v="24" actId="20577"/>
        <pc:sldMkLst>
          <pc:docMk/>
          <pc:sldMk cId="3711734020" sldId="386"/>
        </pc:sldMkLst>
        <pc:spChg chg="mod">
          <ac:chgData name="Gabrielle Goldberg" userId="S::gabrielle.goldberg@hofstra.edu::453f9b71-f7a4-4ef4-8e34-bbb69381dfc0" providerId="AD" clId="Web-{2B0ACB10-1043-4FB3-3E84-021C41B2C513}" dt="2022-03-31T14:15:14.157" v="24" actId="20577"/>
          <ac:spMkLst>
            <pc:docMk/>
            <pc:sldMk cId="3711734020" sldId="386"/>
            <ac:spMk id="6" creationId="{00000000-0000-0000-0000-000000000000}"/>
          </ac:spMkLst>
        </pc:spChg>
      </pc:sldChg>
      <pc:sldChg chg="modSp">
        <pc:chgData name="Gabrielle Goldberg" userId="S::gabrielle.goldberg@hofstra.edu::453f9b71-f7a4-4ef4-8e34-bbb69381dfc0" providerId="AD" clId="Web-{2B0ACB10-1043-4FB3-3E84-021C41B2C513}" dt="2022-03-31T14:15:46.470" v="39" actId="20577"/>
        <pc:sldMkLst>
          <pc:docMk/>
          <pc:sldMk cId="156485789" sldId="389"/>
        </pc:sldMkLst>
        <pc:graphicFrameChg chg="modGraphic">
          <ac:chgData name="Gabrielle Goldberg" userId="S::gabrielle.goldberg@hofstra.edu::453f9b71-f7a4-4ef4-8e34-bbb69381dfc0" providerId="AD" clId="Web-{2B0ACB10-1043-4FB3-3E84-021C41B2C513}" dt="2022-03-31T14:15:46.470" v="39" actId="20577"/>
          <ac:graphicFrameMkLst>
            <pc:docMk/>
            <pc:sldMk cId="156485789" sldId="389"/>
            <ac:graphicFrameMk id="8" creationId="{A7BF77DA-70BD-4B1F-8966-83423723D9A4}"/>
          </ac:graphicFrameMkLst>
        </pc:graphicFrameChg>
      </pc:sldChg>
      <pc:sldChg chg="modSp">
        <pc:chgData name="Gabrielle Goldberg" userId="S::gabrielle.goldberg@hofstra.edu::453f9b71-f7a4-4ef4-8e34-bbb69381dfc0" providerId="AD" clId="Web-{2B0ACB10-1043-4FB3-3E84-021C41B2C513}" dt="2022-03-31T14:16:13.862" v="43" actId="20577"/>
        <pc:sldMkLst>
          <pc:docMk/>
          <pc:sldMk cId="1104129155" sldId="390"/>
        </pc:sldMkLst>
        <pc:spChg chg="mod">
          <ac:chgData name="Gabrielle Goldberg" userId="S::gabrielle.goldberg@hofstra.edu::453f9b71-f7a4-4ef4-8e34-bbb69381dfc0" providerId="AD" clId="Web-{2B0ACB10-1043-4FB3-3E84-021C41B2C513}" dt="2022-03-31T14:16:13.862" v="43" actId="20577"/>
          <ac:spMkLst>
            <pc:docMk/>
            <pc:sldMk cId="1104129155" sldId="390"/>
            <ac:spMk id="6" creationId="{00000000-0000-0000-0000-000000000000}"/>
          </ac:spMkLst>
        </pc:spChg>
      </pc:sldChg>
      <pc:sldChg chg="modSp">
        <pc:chgData name="Gabrielle Goldberg" userId="S::gabrielle.goldberg@hofstra.edu::453f9b71-f7a4-4ef4-8e34-bbb69381dfc0" providerId="AD" clId="Web-{2B0ACB10-1043-4FB3-3E84-021C41B2C513}" dt="2022-03-31T14:51:57.972" v="51" actId="20577"/>
        <pc:sldMkLst>
          <pc:docMk/>
          <pc:sldMk cId="4046426465" sldId="391"/>
        </pc:sldMkLst>
        <pc:spChg chg="mod">
          <ac:chgData name="Gabrielle Goldberg" userId="S::gabrielle.goldberg@hofstra.edu::453f9b71-f7a4-4ef4-8e34-bbb69381dfc0" providerId="AD" clId="Web-{2B0ACB10-1043-4FB3-3E84-021C41B2C513}" dt="2022-03-31T14:51:57.972" v="51" actId="20577"/>
          <ac:spMkLst>
            <pc:docMk/>
            <pc:sldMk cId="4046426465" sldId="391"/>
            <ac:spMk id="6" creationId="{00000000-0000-0000-0000-000000000000}"/>
          </ac:spMkLst>
        </pc:spChg>
      </pc:sldChg>
      <pc:sldChg chg="modSp">
        <pc:chgData name="Gabrielle Goldberg" userId="S::gabrielle.goldberg@hofstra.edu::453f9b71-f7a4-4ef4-8e34-bbb69381dfc0" providerId="AD" clId="Web-{2B0ACB10-1043-4FB3-3E84-021C41B2C513}" dt="2022-03-31T14:52:10.785" v="52" actId="20577"/>
        <pc:sldMkLst>
          <pc:docMk/>
          <pc:sldMk cId="2028606082" sldId="393"/>
        </pc:sldMkLst>
        <pc:spChg chg="mod">
          <ac:chgData name="Gabrielle Goldberg" userId="S::gabrielle.goldberg@hofstra.edu::453f9b71-f7a4-4ef4-8e34-bbb69381dfc0" providerId="AD" clId="Web-{2B0ACB10-1043-4FB3-3E84-021C41B2C513}" dt="2022-03-31T14:52:10.785" v="52" actId="20577"/>
          <ac:spMkLst>
            <pc:docMk/>
            <pc:sldMk cId="2028606082" sldId="393"/>
            <ac:spMk id="2" creationId="{00000000-0000-0000-0000-000000000000}"/>
          </ac:spMkLst>
        </pc:spChg>
      </pc:sldChg>
      <pc:sldChg chg="modSp">
        <pc:chgData name="Gabrielle Goldberg" userId="S::gabrielle.goldberg@hofstra.edu::453f9b71-f7a4-4ef4-8e34-bbb69381dfc0" providerId="AD" clId="Web-{2B0ACB10-1043-4FB3-3E84-021C41B2C513}" dt="2022-03-31T14:54:32.180" v="78" actId="20577"/>
        <pc:sldMkLst>
          <pc:docMk/>
          <pc:sldMk cId="1307065593" sldId="398"/>
        </pc:sldMkLst>
        <pc:spChg chg="mod">
          <ac:chgData name="Gabrielle Goldberg" userId="S::gabrielle.goldberg@hofstra.edu::453f9b71-f7a4-4ef4-8e34-bbb69381dfc0" providerId="AD" clId="Web-{2B0ACB10-1043-4FB3-3E84-021C41B2C513}" dt="2022-03-31T14:54:02.115" v="68" actId="20577"/>
          <ac:spMkLst>
            <pc:docMk/>
            <pc:sldMk cId="1307065593" sldId="398"/>
            <ac:spMk id="3" creationId="{01EBB642-A9A1-4273-829D-59C1EBAD2430}"/>
          </ac:spMkLst>
        </pc:spChg>
        <pc:spChg chg="mod">
          <ac:chgData name="Gabrielle Goldberg" userId="S::gabrielle.goldberg@hofstra.edu::453f9b71-f7a4-4ef4-8e34-bbb69381dfc0" providerId="AD" clId="Web-{2B0ACB10-1043-4FB3-3E84-021C41B2C513}" dt="2022-03-31T14:54:32.180" v="78" actId="20577"/>
          <ac:spMkLst>
            <pc:docMk/>
            <pc:sldMk cId="1307065593" sldId="398"/>
            <ac:spMk id="5" creationId="{4D827504-E1A9-459B-AC84-683A2E7257BC}"/>
          </ac:spMkLst>
        </pc:spChg>
      </pc:sldChg>
      <pc:sldChg chg="modSp">
        <pc:chgData name="Gabrielle Goldberg" userId="S::gabrielle.goldberg@hofstra.edu::453f9b71-f7a4-4ef4-8e34-bbb69381dfc0" providerId="AD" clId="Web-{2B0ACB10-1043-4FB3-3E84-021C41B2C513}" dt="2022-03-31T14:55:08.242" v="97" actId="20577"/>
        <pc:sldMkLst>
          <pc:docMk/>
          <pc:sldMk cId="1016746710" sldId="399"/>
        </pc:sldMkLst>
        <pc:spChg chg="mod">
          <ac:chgData name="Gabrielle Goldberg" userId="S::gabrielle.goldberg@hofstra.edu::453f9b71-f7a4-4ef4-8e34-bbb69381dfc0" providerId="AD" clId="Web-{2B0ACB10-1043-4FB3-3E84-021C41B2C513}" dt="2022-03-31T14:55:08.242" v="97" actId="20577"/>
          <ac:spMkLst>
            <pc:docMk/>
            <pc:sldMk cId="1016746710" sldId="399"/>
            <ac:spMk id="3" creationId="{01EBB642-A9A1-4273-829D-59C1EBAD2430}"/>
          </ac:spMkLst>
        </pc:spChg>
      </pc:sldChg>
      <pc:sldChg chg="modSp">
        <pc:chgData name="Gabrielle Goldberg" userId="S::gabrielle.goldberg@hofstra.edu::453f9b71-f7a4-4ef4-8e34-bbb69381dfc0" providerId="AD" clId="Web-{2B0ACB10-1043-4FB3-3E84-021C41B2C513}" dt="2022-03-31T14:55:59.634" v="103" actId="20577"/>
        <pc:sldMkLst>
          <pc:docMk/>
          <pc:sldMk cId="3380947776" sldId="406"/>
        </pc:sldMkLst>
        <pc:graphicFrameChg chg="modGraphic">
          <ac:chgData name="Gabrielle Goldberg" userId="S::gabrielle.goldberg@hofstra.edu::453f9b71-f7a4-4ef4-8e34-bbb69381dfc0" providerId="AD" clId="Web-{2B0ACB10-1043-4FB3-3E84-021C41B2C513}" dt="2022-03-31T14:55:59.634" v="103" actId="20577"/>
          <ac:graphicFrameMkLst>
            <pc:docMk/>
            <pc:sldMk cId="3380947776" sldId="406"/>
            <ac:graphicFrameMk id="5" creationId="{DD58BD53-D491-4E27-8E29-0A4691C5DA68}"/>
          </ac:graphicFrameMkLst>
        </pc:graphicFrameChg>
      </pc:sldChg>
    </pc:docChg>
  </pc:docChgLst>
  <pc:docChgLst>
    <pc:chgData name="Gabrielle Goldberg" userId="S::gabrielle.goldberg@hofstra.edu::453f9b71-f7a4-4ef4-8e34-bbb69381dfc0" providerId="AD" clId="Web-{2EE290C3-EA6A-41EC-4591-00E1548227AB}"/>
    <pc:docChg chg="modSld">
      <pc:chgData name="Gabrielle Goldberg" userId="S::gabrielle.goldberg@hofstra.edu::453f9b71-f7a4-4ef4-8e34-bbb69381dfc0" providerId="AD" clId="Web-{2EE290C3-EA6A-41EC-4591-00E1548227AB}" dt="2022-04-04T13:26:01.723" v="7" actId="20577"/>
      <pc:docMkLst>
        <pc:docMk/>
      </pc:docMkLst>
      <pc:sldChg chg="modSp">
        <pc:chgData name="Gabrielle Goldberg" userId="S::gabrielle.goldberg@hofstra.edu::453f9b71-f7a4-4ef4-8e34-bbb69381dfc0" providerId="AD" clId="Web-{2EE290C3-EA6A-41EC-4591-00E1548227AB}" dt="2022-04-04T13:26:01.723" v="7" actId="20577"/>
        <pc:sldMkLst>
          <pc:docMk/>
          <pc:sldMk cId="278272457" sldId="378"/>
        </pc:sldMkLst>
        <pc:spChg chg="mod">
          <ac:chgData name="Gabrielle Goldberg" userId="S::gabrielle.goldberg@hofstra.edu::453f9b71-f7a4-4ef4-8e34-bbb69381dfc0" providerId="AD" clId="Web-{2EE290C3-EA6A-41EC-4591-00E1548227AB}" dt="2022-04-04T13:26:01.723" v="7" actId="20577"/>
          <ac:spMkLst>
            <pc:docMk/>
            <pc:sldMk cId="278272457" sldId="378"/>
            <ac:spMk id="3" creationId="{2B81FEFF-2091-470B-97BD-B2221C0ED1FB}"/>
          </ac:spMkLst>
        </pc:spChg>
      </pc:sldChg>
      <pc:sldChg chg="modSp">
        <pc:chgData name="Gabrielle Goldberg" userId="S::gabrielle.goldberg@hofstra.edu::453f9b71-f7a4-4ef4-8e34-bbb69381dfc0" providerId="AD" clId="Web-{2EE290C3-EA6A-41EC-4591-00E1548227AB}" dt="2022-04-04T13:25:31.910" v="3" actId="20577"/>
        <pc:sldMkLst>
          <pc:docMk/>
          <pc:sldMk cId="3150183129" sldId="379"/>
        </pc:sldMkLst>
        <pc:graphicFrameChg chg="modGraphic">
          <ac:chgData name="Gabrielle Goldberg" userId="S::gabrielle.goldberg@hofstra.edu::453f9b71-f7a4-4ef4-8e34-bbb69381dfc0" providerId="AD" clId="Web-{2EE290C3-EA6A-41EC-4591-00E1548227AB}" dt="2022-04-04T13:25:31.910" v="3" actId="20577"/>
          <ac:graphicFrameMkLst>
            <pc:docMk/>
            <pc:sldMk cId="3150183129" sldId="379"/>
            <ac:graphicFrameMk id="4" creationId="{C1FFCE84-EBCA-4D7F-9C21-DF600EF51E09}"/>
          </ac:graphicFrameMkLst>
        </pc:graphicFrameChg>
      </pc:sldChg>
    </pc:docChg>
  </pc:docChgLst>
  <pc:docChgLst>
    <pc:chgData name="Gabrielle Goldberg" userId="S::gabrielle.goldberg@hofstra.edu::453f9b71-f7a4-4ef4-8e34-bbb69381dfc0" providerId="AD" clId="Web-{6E7582EC-0E1A-E8CB-BCA8-EDDD8409374F}"/>
    <pc:docChg chg="modSld">
      <pc:chgData name="Gabrielle Goldberg" userId="S::gabrielle.goldberg@hofstra.edu::453f9b71-f7a4-4ef4-8e34-bbb69381dfc0" providerId="AD" clId="Web-{6E7582EC-0E1A-E8CB-BCA8-EDDD8409374F}" dt="2022-03-29T12:29:54.087" v="5" actId="20577"/>
      <pc:docMkLst>
        <pc:docMk/>
      </pc:docMkLst>
      <pc:sldChg chg="modSp">
        <pc:chgData name="Gabrielle Goldberg" userId="S::gabrielle.goldberg@hofstra.edu::453f9b71-f7a4-4ef4-8e34-bbb69381dfc0" providerId="AD" clId="Web-{6E7582EC-0E1A-E8CB-BCA8-EDDD8409374F}" dt="2022-03-29T12:29:54.087" v="5" actId="20577"/>
        <pc:sldMkLst>
          <pc:docMk/>
          <pc:sldMk cId="4046426465" sldId="391"/>
        </pc:sldMkLst>
        <pc:spChg chg="mod">
          <ac:chgData name="Gabrielle Goldberg" userId="S::gabrielle.goldberg@hofstra.edu::453f9b71-f7a4-4ef4-8e34-bbb69381dfc0" providerId="AD" clId="Web-{6E7582EC-0E1A-E8CB-BCA8-EDDD8409374F}" dt="2022-03-29T12:29:54.087" v="5" actId="20577"/>
          <ac:spMkLst>
            <pc:docMk/>
            <pc:sldMk cId="4046426465" sldId="391"/>
            <ac:spMk id="6" creationId="{00000000-0000-0000-0000-000000000000}"/>
          </ac:spMkLst>
        </pc:spChg>
      </pc:sldChg>
    </pc:docChg>
  </pc:docChgLst>
  <pc:docChgLst>
    <pc:chgData name="Gabrielle Goldberg" userId="S::gabrielle.goldberg@hofstra.edu::453f9b71-f7a4-4ef4-8e34-bbb69381dfc0" providerId="AD" clId="Web-{3CEAFCA4-DCEF-7EB0-05CD-908CD55E558D}"/>
    <pc:docChg chg="addSld delSld modSld">
      <pc:chgData name="Gabrielle Goldberg" userId="S::gabrielle.goldberg@hofstra.edu::453f9b71-f7a4-4ef4-8e34-bbb69381dfc0" providerId="AD" clId="Web-{3CEAFCA4-DCEF-7EB0-05CD-908CD55E558D}" dt="2022-01-07T21:36:06.975" v="458"/>
      <pc:docMkLst>
        <pc:docMk/>
      </pc:docMkLst>
      <pc:sldChg chg="addSp delSp modSp">
        <pc:chgData name="Gabrielle Goldberg" userId="S::gabrielle.goldberg@hofstra.edu::453f9b71-f7a4-4ef4-8e34-bbb69381dfc0" providerId="AD" clId="Web-{3CEAFCA4-DCEF-7EB0-05CD-908CD55E558D}" dt="2022-01-07T21:36:06.975" v="458"/>
        <pc:sldMkLst>
          <pc:docMk/>
          <pc:sldMk cId="1011963421" sldId="351"/>
        </pc:sldMkLst>
        <pc:spChg chg="add del mod">
          <ac:chgData name="Gabrielle Goldberg" userId="S::gabrielle.goldberg@hofstra.edu::453f9b71-f7a4-4ef4-8e34-bbb69381dfc0" providerId="AD" clId="Web-{3CEAFCA4-DCEF-7EB0-05CD-908CD55E558D}" dt="2022-01-07T21:36:06.975" v="458"/>
          <ac:spMkLst>
            <pc:docMk/>
            <pc:sldMk cId="1011963421" sldId="351"/>
            <ac:spMk id="4" creationId="{E766636A-4DC2-4EFA-8A1B-8769BD2BB6A3}"/>
          </ac:spMkLst>
        </pc:spChg>
        <pc:spChg chg="mod">
          <ac:chgData name="Gabrielle Goldberg" userId="S::gabrielle.goldberg@hofstra.edu::453f9b71-f7a4-4ef4-8e34-bbb69381dfc0" providerId="AD" clId="Web-{3CEAFCA4-DCEF-7EB0-05CD-908CD55E558D}" dt="2022-01-07T21:34:14.098" v="324" actId="20577"/>
          <ac:spMkLst>
            <pc:docMk/>
            <pc:sldMk cId="1011963421" sldId="351"/>
            <ac:spMk id="7" creationId="{00000000-0000-0000-0000-000000000000}"/>
          </ac:spMkLst>
        </pc:spChg>
      </pc:sldChg>
      <pc:sldChg chg="modSp del">
        <pc:chgData name="Gabrielle Goldberg" userId="S::gabrielle.goldberg@hofstra.edu::453f9b71-f7a4-4ef4-8e34-bbb69381dfc0" providerId="AD" clId="Web-{3CEAFCA4-DCEF-7EB0-05CD-908CD55E558D}" dt="2022-01-07T19:05:59.518" v="193"/>
        <pc:sldMkLst>
          <pc:docMk/>
          <pc:sldMk cId="30129961" sldId="403"/>
        </pc:sldMkLst>
        <pc:graphicFrameChg chg="modGraphic">
          <ac:chgData name="Gabrielle Goldberg" userId="S::gabrielle.goldberg@hofstra.edu::453f9b71-f7a4-4ef4-8e34-bbb69381dfc0" providerId="AD" clId="Web-{3CEAFCA4-DCEF-7EB0-05CD-908CD55E558D}" dt="2022-01-07T17:59:37.838" v="93" actId="20577"/>
          <ac:graphicFrameMkLst>
            <pc:docMk/>
            <pc:sldMk cId="30129961" sldId="403"/>
            <ac:graphicFrameMk id="4" creationId="{C51DE113-5446-4F7D-978E-BD9FDE1AE385}"/>
          </ac:graphicFrameMkLst>
        </pc:graphicFrameChg>
      </pc:sldChg>
      <pc:sldChg chg="addSp modSp del">
        <pc:chgData name="Gabrielle Goldberg" userId="S::gabrielle.goldberg@hofstra.edu::453f9b71-f7a4-4ef4-8e34-bbb69381dfc0" providerId="AD" clId="Web-{3CEAFCA4-DCEF-7EB0-05CD-908CD55E558D}" dt="2022-01-07T19:11:37.384" v="295"/>
        <pc:sldMkLst>
          <pc:docMk/>
          <pc:sldMk cId="765348557" sldId="404"/>
        </pc:sldMkLst>
        <pc:spChg chg="mod">
          <ac:chgData name="Gabrielle Goldberg" userId="S::gabrielle.goldberg@hofstra.edu::453f9b71-f7a4-4ef4-8e34-bbb69381dfc0" providerId="AD" clId="Web-{3CEAFCA4-DCEF-7EB0-05CD-908CD55E558D}" dt="2022-01-07T19:07:42.739" v="258" actId="1076"/>
          <ac:spMkLst>
            <pc:docMk/>
            <pc:sldMk cId="765348557" sldId="404"/>
            <ac:spMk id="3" creationId="{9A392957-BD48-49DE-8599-0E44A1AE6D05}"/>
          </ac:spMkLst>
        </pc:spChg>
        <pc:spChg chg="add">
          <ac:chgData name="Gabrielle Goldberg" userId="S::gabrielle.goldberg@hofstra.edu::453f9b71-f7a4-4ef4-8e34-bbb69381dfc0" providerId="AD" clId="Web-{3CEAFCA4-DCEF-7EB0-05CD-908CD55E558D}" dt="2022-01-07T19:07:43.848" v="259"/>
          <ac:spMkLst>
            <pc:docMk/>
            <pc:sldMk cId="765348557" sldId="404"/>
            <ac:spMk id="4" creationId="{64BCAF22-3EBC-440F-ABB1-8BAC9B5BB35B}"/>
          </ac:spMkLst>
        </pc:spChg>
        <pc:spChg chg="add">
          <ac:chgData name="Gabrielle Goldberg" userId="S::gabrielle.goldberg@hofstra.edu::453f9b71-f7a4-4ef4-8e34-bbb69381dfc0" providerId="AD" clId="Web-{3CEAFCA4-DCEF-7EB0-05CD-908CD55E558D}" dt="2022-01-07T19:07:45.239" v="260"/>
          <ac:spMkLst>
            <pc:docMk/>
            <pc:sldMk cId="765348557" sldId="404"/>
            <ac:spMk id="5" creationId="{2ADDBEBF-F636-429F-96C8-EA653ACE03BB}"/>
          </ac:spMkLst>
        </pc:spChg>
      </pc:sldChg>
      <pc:sldChg chg="addSp delSp modSp new mod setBg">
        <pc:chgData name="Gabrielle Goldberg" userId="S::gabrielle.goldberg@hofstra.edu::453f9b71-f7a4-4ef4-8e34-bbb69381dfc0" providerId="AD" clId="Web-{3CEAFCA4-DCEF-7EB0-05CD-908CD55E558D}" dt="2022-01-07T19:13:28.558" v="319"/>
        <pc:sldMkLst>
          <pc:docMk/>
          <pc:sldMk cId="3459968171" sldId="411"/>
        </pc:sldMkLst>
        <pc:spChg chg="mod">
          <ac:chgData name="Gabrielle Goldberg" userId="S::gabrielle.goldberg@hofstra.edu::453f9b71-f7a4-4ef4-8e34-bbb69381dfc0" providerId="AD" clId="Web-{3CEAFCA4-DCEF-7EB0-05CD-908CD55E558D}" dt="2022-01-07T19:13:28.558" v="319"/>
          <ac:spMkLst>
            <pc:docMk/>
            <pc:sldMk cId="3459968171" sldId="411"/>
            <ac:spMk id="2" creationId="{1B25B5AE-101B-4598-9301-A7C3DA5C0A93}"/>
          </ac:spMkLst>
        </pc:spChg>
        <pc:spChg chg="add del mod">
          <ac:chgData name="Gabrielle Goldberg" userId="S::gabrielle.goldberg@hofstra.edu::453f9b71-f7a4-4ef4-8e34-bbb69381dfc0" providerId="AD" clId="Web-{3CEAFCA4-DCEF-7EB0-05CD-908CD55E558D}" dt="2022-01-07T18:00:03.683" v="99"/>
          <ac:spMkLst>
            <pc:docMk/>
            <pc:sldMk cId="3459968171" sldId="411"/>
            <ac:spMk id="3" creationId="{16311530-CA0B-4349-A973-4E0B94C538C2}"/>
          </ac:spMkLst>
        </pc:spChg>
        <pc:spChg chg="add del">
          <ac:chgData name="Gabrielle Goldberg" userId="S::gabrielle.goldberg@hofstra.edu::453f9b71-f7a4-4ef4-8e34-bbb69381dfc0" providerId="AD" clId="Web-{3CEAFCA4-DCEF-7EB0-05CD-908CD55E558D}" dt="2022-01-07T19:13:28.558" v="319"/>
          <ac:spMkLst>
            <pc:docMk/>
            <pc:sldMk cId="3459968171" sldId="411"/>
            <ac:spMk id="6" creationId="{B819A166-7571-4003-A6B8-B62034C3ED30}"/>
          </ac:spMkLst>
        </pc:spChg>
        <pc:spChg chg="add del">
          <ac:chgData name="Gabrielle Goldberg" userId="S::gabrielle.goldberg@hofstra.edu::453f9b71-f7a4-4ef4-8e34-bbb69381dfc0" providerId="AD" clId="Web-{3CEAFCA4-DCEF-7EB0-05CD-908CD55E558D}" dt="2022-01-07T17:56:09.958" v="67"/>
          <ac:spMkLst>
            <pc:docMk/>
            <pc:sldMk cId="3459968171" sldId="411"/>
            <ac:spMk id="9" creationId="{B819A166-7571-4003-A6B8-B62034C3ED30}"/>
          </ac:spMkLst>
        </pc:spChg>
        <pc:spChg chg="add">
          <ac:chgData name="Gabrielle Goldberg" userId="S::gabrielle.goldberg@hofstra.edu::453f9b71-f7a4-4ef4-8e34-bbb69381dfc0" providerId="AD" clId="Web-{3CEAFCA4-DCEF-7EB0-05CD-908CD55E558D}" dt="2022-01-07T19:13:28.558" v="319"/>
          <ac:spMkLst>
            <pc:docMk/>
            <pc:sldMk cId="3459968171" sldId="411"/>
            <ac:spMk id="12" creationId="{955A2079-FA98-4876-80F0-72364A7D2EA4}"/>
          </ac:spMkLst>
        </pc:spChg>
        <pc:graphicFrameChg chg="add del">
          <ac:chgData name="Gabrielle Goldberg" userId="S::gabrielle.goldberg@hofstra.edu::453f9b71-f7a4-4ef4-8e34-bbb69381dfc0" providerId="AD" clId="Web-{3CEAFCA4-DCEF-7EB0-05CD-908CD55E558D}" dt="2022-01-07T17:56:09.958" v="67"/>
          <ac:graphicFrameMkLst>
            <pc:docMk/>
            <pc:sldMk cId="3459968171" sldId="411"/>
            <ac:graphicFrameMk id="5" creationId="{B9F8C417-9D93-402C-AB90-5C4517DE2AD9}"/>
          </ac:graphicFrameMkLst>
        </pc:graphicFrameChg>
        <pc:graphicFrameChg chg="add mod modGraphic">
          <ac:chgData name="Gabrielle Goldberg" userId="S::gabrielle.goldberg@hofstra.edu::453f9b71-f7a4-4ef4-8e34-bbb69381dfc0" providerId="AD" clId="Web-{3CEAFCA4-DCEF-7EB0-05CD-908CD55E558D}" dt="2022-01-07T19:13:28.558" v="319"/>
          <ac:graphicFrameMkLst>
            <pc:docMk/>
            <pc:sldMk cId="3459968171" sldId="411"/>
            <ac:graphicFrameMk id="7" creationId="{77F6D1B8-AA4D-48AA-A891-C19EDB350E62}"/>
          </ac:graphicFrameMkLst>
        </pc:graphicFrameChg>
      </pc:sldChg>
      <pc:sldChg chg="addSp delSp modSp new mod setBg modClrScheme chgLayout">
        <pc:chgData name="Gabrielle Goldberg" userId="S::gabrielle.goldberg@hofstra.edu::453f9b71-f7a4-4ef4-8e34-bbb69381dfc0" providerId="AD" clId="Web-{3CEAFCA4-DCEF-7EB0-05CD-908CD55E558D}" dt="2022-01-07T19:12:58.604" v="318" actId="20577"/>
        <pc:sldMkLst>
          <pc:docMk/>
          <pc:sldMk cId="162437508" sldId="412"/>
        </pc:sldMkLst>
        <pc:spChg chg="mod ord">
          <ac:chgData name="Gabrielle Goldberg" userId="S::gabrielle.goldberg@hofstra.edu::453f9b71-f7a4-4ef4-8e34-bbb69381dfc0" providerId="AD" clId="Web-{3CEAFCA4-DCEF-7EB0-05CD-908CD55E558D}" dt="2022-01-07T19:10:01.897" v="269"/>
          <ac:spMkLst>
            <pc:docMk/>
            <pc:sldMk cId="162437508" sldId="412"/>
            <ac:spMk id="2" creationId="{DEF982F6-EF45-43D4-9379-C9D0714B15DB}"/>
          </ac:spMkLst>
        </pc:spChg>
        <pc:spChg chg="del mod ord">
          <ac:chgData name="Gabrielle Goldberg" userId="S::gabrielle.goldberg@hofstra.edu::453f9b71-f7a4-4ef4-8e34-bbb69381dfc0" providerId="AD" clId="Web-{3CEAFCA4-DCEF-7EB0-05CD-908CD55E558D}" dt="2022-01-07T19:09:25.694" v="268"/>
          <ac:spMkLst>
            <pc:docMk/>
            <pc:sldMk cId="162437508" sldId="412"/>
            <ac:spMk id="3" creationId="{097700CC-90D3-49D2-913D-0BCCC26579EC}"/>
          </ac:spMkLst>
        </pc:spChg>
        <pc:spChg chg="add mod ord">
          <ac:chgData name="Gabrielle Goldberg" userId="S::gabrielle.goldberg@hofstra.edu::453f9b71-f7a4-4ef4-8e34-bbb69381dfc0" providerId="AD" clId="Web-{3CEAFCA4-DCEF-7EB0-05CD-908CD55E558D}" dt="2022-01-07T19:12:58.604" v="318" actId="20577"/>
          <ac:spMkLst>
            <pc:docMk/>
            <pc:sldMk cId="162437508" sldId="412"/>
            <ac:spMk id="4" creationId="{1F2141DF-2FD7-4677-B650-879DDCE4CE12}"/>
          </ac:spMkLst>
        </pc:spChg>
        <pc:spChg chg="add mod">
          <ac:chgData name="Gabrielle Goldberg" userId="S::gabrielle.goldberg@hofstra.edu::453f9b71-f7a4-4ef4-8e34-bbb69381dfc0" providerId="AD" clId="Web-{3CEAFCA4-DCEF-7EB0-05CD-908CD55E558D}" dt="2022-01-07T19:08:25.177" v="265" actId="20577"/>
          <ac:spMkLst>
            <pc:docMk/>
            <pc:sldMk cId="162437508" sldId="412"/>
            <ac:spMk id="6" creationId="{4F29D8EB-B36E-4E1C-A0A9-F3C87AE78047}"/>
          </ac:spMkLst>
        </pc:spChg>
        <pc:spChg chg="add mod">
          <ac:chgData name="Gabrielle Goldberg" userId="S::gabrielle.goldberg@hofstra.edu::453f9b71-f7a4-4ef4-8e34-bbb69381dfc0" providerId="AD" clId="Web-{3CEAFCA4-DCEF-7EB0-05CD-908CD55E558D}" dt="2022-01-07T19:11:30.837" v="294" actId="1076"/>
          <ac:spMkLst>
            <pc:docMk/>
            <pc:sldMk cId="162437508" sldId="412"/>
            <ac:spMk id="8" creationId="{9F84346E-6A4D-4404-891F-D0F1081382A7}"/>
          </ac:spMkLst>
        </pc:spChg>
        <pc:picChg chg="add mod ord">
          <ac:chgData name="Gabrielle Goldberg" userId="S::gabrielle.goldberg@hofstra.edu::453f9b71-f7a4-4ef4-8e34-bbb69381dfc0" providerId="AD" clId="Web-{3CEAFCA4-DCEF-7EB0-05CD-908CD55E558D}" dt="2022-01-07T19:10:18.242" v="272" actId="14100"/>
          <ac:picMkLst>
            <pc:docMk/>
            <pc:sldMk cId="162437508" sldId="412"/>
            <ac:picMk id="7" creationId="{F01F3D4A-C680-4971-B425-3E45339BB625}"/>
          </ac:picMkLst>
        </pc:picChg>
        <pc:cxnChg chg="add">
          <ac:chgData name="Gabrielle Goldberg" userId="S::gabrielle.goldberg@hofstra.edu::453f9b71-f7a4-4ef4-8e34-bbb69381dfc0" providerId="AD" clId="Web-{3CEAFCA4-DCEF-7EB0-05CD-908CD55E558D}" dt="2022-01-07T19:10:01.897" v="269"/>
          <ac:cxnSpMkLst>
            <pc:docMk/>
            <pc:sldMk cId="162437508" sldId="412"/>
            <ac:cxnSpMk id="12" creationId="{A7F400EE-A8A5-48AF-B4D6-291B52C6F0B0}"/>
          </ac:cxnSpMkLst>
        </pc:cxnChg>
      </pc:sldChg>
    </pc:docChg>
  </pc:docChgLst>
  <pc:docChgLst>
    <pc:chgData name="janice.john@einsteinmed.edu" userId="S::urn:spo:guest#janice.john@einsteinmed.edu::" providerId="AD" clId="Web-{C0851F70-746E-114D-D8A1-FFA033B3D2BE}"/>
    <pc:docChg chg="modSld">
      <pc:chgData name="janice.john@einsteinmed.edu" userId="S::urn:spo:guest#janice.john@einsteinmed.edu::" providerId="AD" clId="Web-{C0851F70-746E-114D-D8A1-FFA033B3D2BE}" dt="2022-04-13T13:41:43.111" v="113" actId="20577"/>
      <pc:docMkLst>
        <pc:docMk/>
      </pc:docMkLst>
      <pc:sldChg chg="delCm">
        <pc:chgData name="janice.john@einsteinmed.edu" userId="S::urn:spo:guest#janice.john@einsteinmed.edu::" providerId="AD" clId="Web-{C0851F70-746E-114D-D8A1-FFA033B3D2BE}" dt="2022-04-13T13:33:36.537" v="1"/>
        <pc:sldMkLst>
          <pc:docMk/>
          <pc:sldMk cId="3061336521" sldId="318"/>
        </pc:sldMkLst>
      </pc:sldChg>
      <pc:sldChg chg="modSp">
        <pc:chgData name="janice.john@einsteinmed.edu" userId="S::urn:spo:guest#janice.john@einsteinmed.edu::" providerId="AD" clId="Web-{C0851F70-746E-114D-D8A1-FFA033B3D2BE}" dt="2022-04-13T13:41:43.111" v="113" actId="20577"/>
        <pc:sldMkLst>
          <pc:docMk/>
          <pc:sldMk cId="956818366" sldId="362"/>
        </pc:sldMkLst>
        <pc:spChg chg="mod">
          <ac:chgData name="janice.john@einsteinmed.edu" userId="S::urn:spo:guest#janice.john@einsteinmed.edu::" providerId="AD" clId="Web-{C0851F70-746E-114D-D8A1-FFA033B3D2BE}" dt="2022-04-13T13:41:43.111" v="113" actId="20577"/>
          <ac:spMkLst>
            <pc:docMk/>
            <pc:sldMk cId="956818366" sldId="362"/>
            <ac:spMk id="3" creationId="{9A392957-BD48-49DE-8599-0E44A1AE6D05}"/>
          </ac:spMkLst>
        </pc:spChg>
      </pc:sldChg>
      <pc:sldChg chg="delCm">
        <pc:chgData name="janice.john@einsteinmed.edu" userId="S::urn:spo:guest#janice.john@einsteinmed.edu::" providerId="AD" clId="Web-{C0851F70-746E-114D-D8A1-FFA033B3D2BE}" dt="2022-04-13T13:33:26.552" v="0"/>
        <pc:sldMkLst>
          <pc:docMk/>
          <pc:sldMk cId="3695886494" sldId="377"/>
        </pc:sldMkLst>
      </pc:sldChg>
      <pc:sldChg chg="modSp delCm">
        <pc:chgData name="janice.john@einsteinmed.edu" userId="S::urn:spo:guest#janice.john@einsteinmed.edu::" providerId="AD" clId="Web-{C0851F70-746E-114D-D8A1-FFA033B3D2BE}" dt="2022-04-13T13:34:41.228" v="5"/>
        <pc:sldMkLst>
          <pc:docMk/>
          <pc:sldMk cId="3071954687" sldId="382"/>
        </pc:sldMkLst>
        <pc:spChg chg="mod">
          <ac:chgData name="janice.john@einsteinmed.edu" userId="S::urn:spo:guest#janice.john@einsteinmed.edu::" providerId="AD" clId="Web-{C0851F70-746E-114D-D8A1-FFA033B3D2BE}" dt="2022-04-13T13:34:13.460" v="4" actId="20577"/>
          <ac:spMkLst>
            <pc:docMk/>
            <pc:sldMk cId="3071954687" sldId="382"/>
            <ac:spMk id="6" creationId="{00000000-0000-0000-0000-000000000000}"/>
          </ac:spMkLst>
        </pc:spChg>
      </pc:sldChg>
      <pc:sldChg chg="modSp delCm modCm">
        <pc:chgData name="janice.john@einsteinmed.edu" userId="S::urn:spo:guest#janice.john@einsteinmed.edu::" providerId="AD" clId="Web-{C0851F70-746E-114D-D8A1-FFA033B3D2BE}" dt="2022-04-13T13:35:10.061" v="13" actId="20577"/>
        <pc:sldMkLst>
          <pc:docMk/>
          <pc:sldMk cId="1807645662" sldId="385"/>
        </pc:sldMkLst>
        <pc:spChg chg="mod">
          <ac:chgData name="janice.john@einsteinmed.edu" userId="S::urn:spo:guest#janice.john@einsteinmed.edu::" providerId="AD" clId="Web-{C0851F70-746E-114D-D8A1-FFA033B3D2BE}" dt="2022-04-13T13:35:10.061" v="13" actId="20577"/>
          <ac:spMkLst>
            <pc:docMk/>
            <pc:sldMk cId="1807645662" sldId="385"/>
            <ac:spMk id="6" creationId="{00000000-0000-0000-0000-000000000000}"/>
          </ac:spMkLst>
        </pc:spChg>
      </pc:sldChg>
      <pc:sldChg chg="modSp delCm modCm">
        <pc:chgData name="janice.john@einsteinmed.edu" userId="S::urn:spo:guest#janice.john@einsteinmed.edu::" providerId="AD" clId="Web-{C0851F70-746E-114D-D8A1-FFA033B3D2BE}" dt="2022-04-13T13:35:35.934" v="21"/>
        <pc:sldMkLst>
          <pc:docMk/>
          <pc:sldMk cId="3711734020" sldId="386"/>
        </pc:sldMkLst>
        <pc:spChg chg="mod">
          <ac:chgData name="janice.john@einsteinmed.edu" userId="S::urn:spo:guest#janice.john@einsteinmed.edu::" providerId="AD" clId="Web-{C0851F70-746E-114D-D8A1-FFA033B3D2BE}" dt="2022-04-13T13:35:35.856" v="20" actId="20577"/>
          <ac:spMkLst>
            <pc:docMk/>
            <pc:sldMk cId="3711734020" sldId="386"/>
            <ac:spMk id="6" creationId="{00000000-0000-0000-0000-000000000000}"/>
          </ac:spMkLst>
        </pc:spChg>
      </pc:sldChg>
      <pc:sldChg chg="modSp delCm modCm">
        <pc:chgData name="janice.john@einsteinmed.edu" userId="S::urn:spo:guest#janice.john@einsteinmed.edu::" providerId="AD" clId="Web-{C0851F70-746E-114D-D8A1-FFA033B3D2BE}" dt="2022-04-13T13:36:08.748" v="38"/>
        <pc:sldMkLst>
          <pc:docMk/>
          <pc:sldMk cId="4046426465" sldId="391"/>
        </pc:sldMkLst>
        <pc:spChg chg="mod">
          <ac:chgData name="janice.john@einsteinmed.edu" userId="S::urn:spo:guest#janice.john@einsteinmed.edu::" providerId="AD" clId="Web-{C0851F70-746E-114D-D8A1-FFA033B3D2BE}" dt="2022-04-13T13:36:08.686" v="37" actId="20577"/>
          <ac:spMkLst>
            <pc:docMk/>
            <pc:sldMk cId="4046426465" sldId="391"/>
            <ac:spMk id="6" creationId="{00000000-0000-0000-0000-000000000000}"/>
          </ac:spMkLst>
        </pc:spChg>
      </pc:sldChg>
      <pc:sldChg chg="modSp delCm modCm">
        <pc:chgData name="janice.john@einsteinmed.edu" userId="S::urn:spo:guest#janice.john@einsteinmed.edu::" providerId="AD" clId="Web-{C0851F70-746E-114D-D8A1-FFA033B3D2BE}" dt="2022-04-13T13:36:48.250" v="47"/>
        <pc:sldMkLst>
          <pc:docMk/>
          <pc:sldMk cId="2028606082" sldId="393"/>
        </pc:sldMkLst>
        <pc:spChg chg="mod">
          <ac:chgData name="janice.john@einsteinmed.edu" userId="S::urn:spo:guest#janice.john@einsteinmed.edu::" providerId="AD" clId="Web-{C0851F70-746E-114D-D8A1-FFA033B3D2BE}" dt="2022-04-13T13:36:48.172" v="46" actId="20577"/>
          <ac:spMkLst>
            <pc:docMk/>
            <pc:sldMk cId="2028606082" sldId="393"/>
            <ac:spMk id="6" creationId="{00000000-0000-0000-0000-000000000000}"/>
          </ac:spMkLst>
        </pc:spChg>
      </pc:sldChg>
      <pc:sldChg chg="modSp delCm">
        <pc:chgData name="janice.john@einsteinmed.edu" userId="S::urn:spo:guest#janice.john@einsteinmed.edu::" providerId="AD" clId="Web-{C0851F70-746E-114D-D8A1-FFA033B3D2BE}" dt="2022-04-13T13:40:28.497" v="97" actId="20577"/>
        <pc:sldMkLst>
          <pc:docMk/>
          <pc:sldMk cId="1307065593" sldId="398"/>
        </pc:sldMkLst>
        <pc:spChg chg="mod">
          <ac:chgData name="janice.john@einsteinmed.edu" userId="S::urn:spo:guest#janice.john@einsteinmed.edu::" providerId="AD" clId="Web-{C0851F70-746E-114D-D8A1-FFA033B3D2BE}" dt="2022-04-13T13:39:43.369" v="90" actId="20577"/>
          <ac:spMkLst>
            <pc:docMk/>
            <pc:sldMk cId="1307065593" sldId="398"/>
            <ac:spMk id="3" creationId="{01EBB642-A9A1-4273-829D-59C1EBAD2430}"/>
          </ac:spMkLst>
        </pc:spChg>
        <pc:spChg chg="mod">
          <ac:chgData name="janice.john@einsteinmed.edu" userId="S::urn:spo:guest#janice.john@einsteinmed.edu::" providerId="AD" clId="Web-{C0851F70-746E-114D-D8A1-FFA033B3D2BE}" dt="2022-04-13T13:40:28.497" v="97" actId="20577"/>
          <ac:spMkLst>
            <pc:docMk/>
            <pc:sldMk cId="1307065593" sldId="398"/>
            <ac:spMk id="5" creationId="{4D827504-E1A9-459B-AC84-683A2E7257BC}"/>
          </ac:spMkLst>
        </pc:spChg>
      </pc:sldChg>
    </pc:docChg>
  </pc:docChgLst>
  <pc:docChgLst>
    <pc:chgData name="Guest User" userId="S::urn:spo:anon#4cf4838ef0fbf4d0dba1e40ac72942b61102bea1b1689e895975c57b98f5ef34::" providerId="AD" clId="Web-{88F18AB7-3FF3-448C-ACFB-43153809A666}"/>
    <pc:docChg chg="modSld">
      <pc:chgData name="Guest User" userId="S::urn:spo:anon#4cf4838ef0fbf4d0dba1e40ac72942b61102bea1b1689e895975c57b98f5ef34::" providerId="AD" clId="Web-{88F18AB7-3FF3-448C-ACFB-43153809A666}" dt="2022-01-06T23:28:30.922" v="275" actId="20577"/>
      <pc:docMkLst>
        <pc:docMk/>
      </pc:docMkLst>
      <pc:sldChg chg="addSp delSp modSp">
        <pc:chgData name="Guest User" userId="S::urn:spo:anon#4cf4838ef0fbf4d0dba1e40ac72942b61102bea1b1689e895975c57b98f5ef34::" providerId="AD" clId="Web-{88F18AB7-3FF3-448C-ACFB-43153809A666}" dt="2022-01-06T23:18:51.517" v="144" actId="14100"/>
        <pc:sldMkLst>
          <pc:docMk/>
          <pc:sldMk cId="1011963421" sldId="351"/>
        </pc:sldMkLst>
        <pc:spChg chg="add mod">
          <ac:chgData name="Guest User" userId="S::urn:spo:anon#4cf4838ef0fbf4d0dba1e40ac72942b61102bea1b1689e895975c57b98f5ef34::" providerId="AD" clId="Web-{88F18AB7-3FF3-448C-ACFB-43153809A666}" dt="2022-01-06T23:04:26.082" v="133" actId="1076"/>
          <ac:spMkLst>
            <pc:docMk/>
            <pc:sldMk cId="1011963421" sldId="351"/>
            <ac:spMk id="3" creationId="{1BE62FCB-5573-45B3-978E-C00C705D52B7}"/>
          </ac:spMkLst>
        </pc:spChg>
        <pc:spChg chg="add del mod">
          <ac:chgData name="Guest User" userId="S::urn:spo:anon#4cf4838ef0fbf4d0dba1e40ac72942b61102bea1b1689e895975c57b98f5ef34::" providerId="AD" clId="Web-{88F18AB7-3FF3-448C-ACFB-43153809A666}" dt="2022-01-06T22:59:41.021" v="72"/>
          <ac:spMkLst>
            <pc:docMk/>
            <pc:sldMk cId="1011963421" sldId="351"/>
            <ac:spMk id="4" creationId="{A1409A20-F842-41BE-9B09-B489B9E055F3}"/>
          </ac:spMkLst>
        </pc:spChg>
        <pc:spChg chg="add mod">
          <ac:chgData name="Guest User" userId="S::urn:spo:anon#4cf4838ef0fbf4d0dba1e40ac72942b61102bea1b1689e895975c57b98f5ef34::" providerId="AD" clId="Web-{88F18AB7-3FF3-448C-ACFB-43153809A666}" dt="2022-01-06T23:03:50.317" v="129" actId="20577"/>
          <ac:spMkLst>
            <pc:docMk/>
            <pc:sldMk cId="1011963421" sldId="351"/>
            <ac:spMk id="5" creationId="{3AE9DC14-8EBE-4E3B-8519-C0441D860449}"/>
          </ac:spMkLst>
        </pc:spChg>
        <pc:spChg chg="add del mod">
          <ac:chgData name="Guest User" userId="S::urn:spo:anon#4cf4838ef0fbf4d0dba1e40ac72942b61102bea1b1689e895975c57b98f5ef34::" providerId="AD" clId="Web-{88F18AB7-3FF3-448C-ACFB-43153809A666}" dt="2022-01-06T23:01:26.130" v="114"/>
          <ac:spMkLst>
            <pc:docMk/>
            <pc:sldMk cId="1011963421" sldId="351"/>
            <ac:spMk id="6" creationId="{0910FA32-33F5-429B-8CEE-C0A6E3ED09A0}"/>
          </ac:spMkLst>
        </pc:spChg>
        <pc:spChg chg="add del mod">
          <ac:chgData name="Guest User" userId="S::urn:spo:anon#4cf4838ef0fbf4d0dba1e40ac72942b61102bea1b1689e895975c57b98f5ef34::" providerId="AD" clId="Web-{88F18AB7-3FF3-448C-ACFB-43153809A666}" dt="2022-01-06T23:01:35.224" v="115"/>
          <ac:spMkLst>
            <pc:docMk/>
            <pc:sldMk cId="1011963421" sldId="351"/>
            <ac:spMk id="8" creationId="{9C01AF27-1827-4502-AEF0-330BCF64AF15}"/>
          </ac:spMkLst>
        </pc:spChg>
        <pc:spChg chg="add mod">
          <ac:chgData name="Guest User" userId="S::urn:spo:anon#4cf4838ef0fbf4d0dba1e40ac72942b61102bea1b1689e895975c57b98f5ef34::" providerId="AD" clId="Web-{88F18AB7-3FF3-448C-ACFB-43153809A666}" dt="2022-01-06T23:04:44.145" v="138" actId="14100"/>
          <ac:spMkLst>
            <pc:docMk/>
            <pc:sldMk cId="1011963421" sldId="351"/>
            <ac:spMk id="9" creationId="{48C35BFE-7B1A-4EA5-9229-2EFD926808A8}"/>
          </ac:spMkLst>
        </pc:spChg>
        <pc:spChg chg="add mod">
          <ac:chgData name="Guest User" userId="S::urn:spo:anon#4cf4838ef0fbf4d0dba1e40ac72942b61102bea1b1689e895975c57b98f5ef34::" providerId="AD" clId="Web-{88F18AB7-3FF3-448C-ACFB-43153809A666}" dt="2022-01-06T23:03:02.005" v="126" actId="1076"/>
          <ac:spMkLst>
            <pc:docMk/>
            <pc:sldMk cId="1011963421" sldId="351"/>
            <ac:spMk id="11" creationId="{6D880126-DD1E-40F6-A3F7-326DDBA2497F}"/>
          </ac:spMkLst>
        </pc:spChg>
        <pc:picChg chg="del">
          <ac:chgData name="Guest User" userId="S::urn:spo:anon#4cf4838ef0fbf4d0dba1e40ac72942b61102bea1b1689e895975c57b98f5ef34::" providerId="AD" clId="Web-{88F18AB7-3FF3-448C-ACFB-43153809A666}" dt="2022-01-06T22:56:01.037" v="0"/>
          <ac:picMkLst>
            <pc:docMk/>
            <pc:sldMk cId="1011963421" sldId="351"/>
            <ac:picMk id="2" creationId="{5D9BA558-9E2F-4632-9561-CDC3CCB44311}"/>
          </ac:picMkLst>
        </pc:picChg>
        <pc:cxnChg chg="add mod">
          <ac:chgData name="Guest User" userId="S::urn:spo:anon#4cf4838ef0fbf4d0dba1e40ac72942b61102bea1b1689e895975c57b98f5ef34::" providerId="AD" clId="Web-{88F18AB7-3FF3-448C-ACFB-43153809A666}" dt="2022-01-06T23:18:51.517" v="144" actId="14100"/>
          <ac:cxnSpMkLst>
            <pc:docMk/>
            <pc:sldMk cId="1011963421" sldId="351"/>
            <ac:cxnSpMk id="10" creationId="{B05DB28F-5C80-4585-9D5B-F54BA378D9C9}"/>
          </ac:cxnSpMkLst>
        </pc:cxnChg>
        <pc:cxnChg chg="add mod">
          <ac:chgData name="Guest User" userId="S::urn:spo:anon#4cf4838ef0fbf4d0dba1e40ac72942b61102bea1b1689e895975c57b98f5ef34::" providerId="AD" clId="Web-{88F18AB7-3FF3-448C-ACFB-43153809A666}" dt="2022-01-06T23:05:04.442" v="139" actId="1076"/>
          <ac:cxnSpMkLst>
            <pc:docMk/>
            <pc:sldMk cId="1011963421" sldId="351"/>
            <ac:cxnSpMk id="12" creationId="{06193CF9-F84B-44A7-B187-1340D6A52411}"/>
          </ac:cxnSpMkLst>
        </pc:cxnChg>
        <pc:cxnChg chg="add mod">
          <ac:chgData name="Guest User" userId="S::urn:spo:anon#4cf4838ef0fbf4d0dba1e40ac72942b61102bea1b1689e895975c57b98f5ef34::" providerId="AD" clId="Web-{88F18AB7-3FF3-448C-ACFB-43153809A666}" dt="2022-01-06T23:18:36.689" v="142" actId="14100"/>
          <ac:cxnSpMkLst>
            <pc:docMk/>
            <pc:sldMk cId="1011963421" sldId="351"/>
            <ac:cxnSpMk id="13" creationId="{C6111CE0-EFA6-4D2B-A665-B58ECF307DAE}"/>
          </ac:cxnSpMkLst>
        </pc:cxnChg>
      </pc:sldChg>
      <pc:sldChg chg="addSp delSp modSp">
        <pc:chgData name="Guest User" userId="S::urn:spo:anon#4cf4838ef0fbf4d0dba1e40ac72942b61102bea1b1689e895975c57b98f5ef34::" providerId="AD" clId="Web-{88F18AB7-3FF3-448C-ACFB-43153809A666}" dt="2022-01-06T23:28:30.922" v="275" actId="20577"/>
        <pc:sldMkLst>
          <pc:docMk/>
          <pc:sldMk cId="30129961" sldId="403"/>
        </pc:sldMkLst>
        <pc:graphicFrameChg chg="add mod modGraphic">
          <ac:chgData name="Guest User" userId="S::urn:spo:anon#4cf4838ef0fbf4d0dba1e40ac72942b61102bea1b1689e895975c57b98f5ef34::" providerId="AD" clId="Web-{88F18AB7-3FF3-448C-ACFB-43153809A666}" dt="2022-01-06T23:28:30.922" v="275" actId="20577"/>
          <ac:graphicFrameMkLst>
            <pc:docMk/>
            <pc:sldMk cId="30129961" sldId="403"/>
            <ac:graphicFrameMk id="4" creationId="{C51DE113-5446-4F7D-978E-BD9FDE1AE385}"/>
          </ac:graphicFrameMkLst>
        </pc:graphicFrameChg>
        <pc:picChg chg="del">
          <ac:chgData name="Guest User" userId="S::urn:spo:anon#4cf4838ef0fbf4d0dba1e40ac72942b61102bea1b1689e895975c57b98f5ef34::" providerId="AD" clId="Web-{88F18AB7-3FF3-448C-ACFB-43153809A666}" dt="2022-01-06T23:24:37.344" v="252"/>
          <ac:picMkLst>
            <pc:docMk/>
            <pc:sldMk cId="30129961" sldId="403"/>
            <ac:picMk id="7" creationId="{76912F38-878A-4D8D-8160-011CBB84C7B3}"/>
          </ac:picMkLst>
        </pc:picChg>
        <pc:cxnChg chg="add">
          <ac:chgData name="Guest User" userId="S::urn:spo:anon#4cf4838ef0fbf4d0dba1e40ac72942b61102bea1b1689e895975c57b98f5ef34::" providerId="AD" clId="Web-{88F18AB7-3FF3-448C-ACFB-43153809A666}" dt="2022-01-06T23:25:02.125" v="256"/>
          <ac:cxnSpMkLst>
            <pc:docMk/>
            <pc:sldMk cId="30129961" sldId="403"/>
            <ac:cxnSpMk id="671" creationId="{2F8957F8-CCDB-49C7-A5A2-547DB92704B9}"/>
          </ac:cxnSpMkLst>
        </pc:cxnChg>
      </pc:sldChg>
      <pc:sldChg chg="modSp">
        <pc:chgData name="Guest User" userId="S::urn:spo:anon#4cf4838ef0fbf4d0dba1e40ac72942b61102bea1b1689e895975c57b98f5ef34::" providerId="AD" clId="Web-{88F18AB7-3FF3-448C-ACFB-43153809A666}" dt="2022-01-06T23:19:51.439" v="146" actId="1076"/>
        <pc:sldMkLst>
          <pc:docMk/>
          <pc:sldMk cId="765348557" sldId="404"/>
        </pc:sldMkLst>
        <pc:spChg chg="mod">
          <ac:chgData name="Guest User" userId="S::urn:spo:anon#4cf4838ef0fbf4d0dba1e40ac72942b61102bea1b1689e895975c57b98f5ef34::" providerId="AD" clId="Web-{88F18AB7-3FF3-448C-ACFB-43153809A666}" dt="2022-01-06T23:19:43.345" v="145" actId="1076"/>
          <ac:spMkLst>
            <pc:docMk/>
            <pc:sldMk cId="765348557" sldId="404"/>
            <ac:spMk id="2" creationId="{47780179-0182-4210-AB55-A1699228033C}"/>
          </ac:spMkLst>
        </pc:spChg>
        <pc:spChg chg="mod">
          <ac:chgData name="Guest User" userId="S::urn:spo:anon#4cf4838ef0fbf4d0dba1e40ac72942b61102bea1b1689e895975c57b98f5ef34::" providerId="AD" clId="Web-{88F18AB7-3FF3-448C-ACFB-43153809A666}" dt="2022-01-06T23:19:51.439" v="146" actId="1076"/>
          <ac:spMkLst>
            <pc:docMk/>
            <pc:sldMk cId="765348557" sldId="404"/>
            <ac:spMk id="3" creationId="{9A392957-BD48-49DE-8599-0E44A1AE6D05}"/>
          </ac:spMkLst>
        </pc:spChg>
      </pc:sldChg>
    </pc:docChg>
  </pc:docChgLst>
  <pc:docChgLst>
    <pc:chgData name="Guest User" userId="S::urn:spo:anon#4cf4838ef0fbf4d0dba1e40ac72942b61102bea1b1689e895975c57b98f5ef34::" providerId="AD" clId="Web-{C7A5DDF9-673C-83A1-5EE2-8C90F7BB037D}"/>
    <pc:docChg chg="modSld">
      <pc:chgData name="Guest User" userId="S::urn:spo:anon#4cf4838ef0fbf4d0dba1e40ac72942b61102bea1b1689e895975c57b98f5ef34::" providerId="AD" clId="Web-{C7A5DDF9-673C-83A1-5EE2-8C90F7BB037D}" dt="2022-01-06T20:14:44.537" v="72"/>
      <pc:docMkLst>
        <pc:docMk/>
      </pc:docMkLst>
      <pc:sldChg chg="delSp modSp">
        <pc:chgData name="Guest User" userId="S::urn:spo:anon#4cf4838ef0fbf4d0dba1e40ac72942b61102bea1b1689e895975c57b98f5ef34::" providerId="AD" clId="Web-{C7A5DDF9-673C-83A1-5EE2-8C90F7BB037D}" dt="2022-01-06T20:14:44.537" v="72"/>
        <pc:sldMkLst>
          <pc:docMk/>
          <pc:sldMk cId="30129961" sldId="403"/>
        </pc:sldMkLst>
        <pc:spChg chg="del mod">
          <ac:chgData name="Guest User" userId="S::urn:spo:anon#4cf4838ef0fbf4d0dba1e40ac72942b61102bea1b1689e895975c57b98f5ef34::" providerId="AD" clId="Web-{C7A5DDF9-673C-83A1-5EE2-8C90F7BB037D}" dt="2022-01-06T20:14:44.537" v="72"/>
          <ac:spMkLst>
            <pc:docMk/>
            <pc:sldMk cId="30129961" sldId="403"/>
            <ac:spMk id="4" creationId="{8D46DD58-53E4-4C88-95F1-6673AA422C71}"/>
          </ac:spMkLst>
        </pc:spChg>
      </pc:sldChg>
      <pc:sldChg chg="addSp delSp modSp">
        <pc:chgData name="Guest User" userId="S::urn:spo:anon#4cf4838ef0fbf4d0dba1e40ac72942b61102bea1b1689e895975c57b98f5ef34::" providerId="AD" clId="Web-{C7A5DDF9-673C-83A1-5EE2-8C90F7BB037D}" dt="2022-01-06T20:13:22.037" v="70" actId="14100"/>
        <pc:sldMkLst>
          <pc:docMk/>
          <pc:sldMk cId="765348557" sldId="404"/>
        </pc:sldMkLst>
        <pc:spChg chg="mod">
          <ac:chgData name="Guest User" userId="S::urn:spo:anon#4cf4838ef0fbf4d0dba1e40ac72942b61102bea1b1689e895975c57b98f5ef34::" providerId="AD" clId="Web-{C7A5DDF9-673C-83A1-5EE2-8C90F7BB037D}" dt="2022-01-06T19:58:23.618" v="4" actId="1076"/>
          <ac:spMkLst>
            <pc:docMk/>
            <pc:sldMk cId="765348557" sldId="404"/>
            <ac:spMk id="3" creationId="{9A392957-BD48-49DE-8599-0E44A1AE6D05}"/>
          </ac:spMkLst>
        </pc:spChg>
        <pc:spChg chg="add del mod">
          <ac:chgData name="Guest User" userId="S::urn:spo:anon#4cf4838ef0fbf4d0dba1e40ac72942b61102bea1b1689e895975c57b98f5ef34::" providerId="AD" clId="Web-{C7A5DDF9-673C-83A1-5EE2-8C90F7BB037D}" dt="2022-01-06T20:05:24.523" v="37"/>
          <ac:spMkLst>
            <pc:docMk/>
            <pc:sldMk cId="765348557" sldId="404"/>
            <ac:spMk id="4" creationId="{4A6EE79C-1013-4F8B-9311-7039D3F4B031}"/>
          </ac:spMkLst>
        </pc:spChg>
        <pc:spChg chg="add mod">
          <ac:chgData name="Guest User" userId="S::urn:spo:anon#4cf4838ef0fbf4d0dba1e40ac72942b61102bea1b1689e895975c57b98f5ef34::" providerId="AD" clId="Web-{C7A5DDF9-673C-83A1-5EE2-8C90F7BB037D}" dt="2022-01-06T20:13:22.037" v="70" actId="14100"/>
          <ac:spMkLst>
            <pc:docMk/>
            <pc:sldMk cId="765348557" sldId="404"/>
            <ac:spMk id="6" creationId="{F1D91F76-5313-4842-9452-42D69B896B49}"/>
          </ac:spMkLst>
        </pc:spChg>
        <pc:spChg chg="add mod">
          <ac:chgData name="Guest User" userId="S::urn:spo:anon#4cf4838ef0fbf4d0dba1e40ac72942b61102bea1b1689e895975c57b98f5ef34::" providerId="AD" clId="Web-{C7A5DDF9-673C-83A1-5EE2-8C90F7BB037D}" dt="2022-01-06T20:07:53.882" v="42" actId="20577"/>
          <ac:spMkLst>
            <pc:docMk/>
            <pc:sldMk cId="765348557" sldId="404"/>
            <ac:spMk id="7" creationId="{864CC123-2189-4700-B359-BD8B478173ED}"/>
          </ac:spMkLst>
        </pc:spChg>
        <pc:spChg chg="add del mod">
          <ac:chgData name="Guest User" userId="S::urn:spo:anon#4cf4838ef0fbf4d0dba1e40ac72942b61102bea1b1689e895975c57b98f5ef34::" providerId="AD" clId="Web-{C7A5DDF9-673C-83A1-5EE2-8C90F7BB037D}" dt="2022-01-06T20:10:04.381" v="46"/>
          <ac:spMkLst>
            <pc:docMk/>
            <pc:sldMk cId="765348557" sldId="404"/>
            <ac:spMk id="8" creationId="{E5ACE256-61F5-4C64-A627-1A88727800C0}"/>
          </ac:spMkLst>
        </pc:spChg>
        <pc:spChg chg="add del mod">
          <ac:chgData name="Guest User" userId="S::urn:spo:anon#4cf4838ef0fbf4d0dba1e40ac72942b61102bea1b1689e895975c57b98f5ef34::" providerId="AD" clId="Web-{C7A5DDF9-673C-83A1-5EE2-8C90F7BB037D}" dt="2022-01-06T20:11:04.741" v="49"/>
          <ac:spMkLst>
            <pc:docMk/>
            <pc:sldMk cId="765348557" sldId="404"/>
            <ac:spMk id="9" creationId="{E617C808-7391-4B01-9031-FDE69BC53A7A}"/>
          </ac:spMkLst>
        </pc:spChg>
        <pc:spChg chg="add mod">
          <ac:chgData name="Guest User" userId="S::urn:spo:anon#4cf4838ef0fbf4d0dba1e40ac72942b61102bea1b1689e895975c57b98f5ef34::" providerId="AD" clId="Web-{C7A5DDF9-673C-83A1-5EE2-8C90F7BB037D}" dt="2022-01-06T20:13:21.303" v="62" actId="20577"/>
          <ac:spMkLst>
            <pc:docMk/>
            <pc:sldMk cId="765348557" sldId="404"/>
            <ac:spMk id="11" creationId="{F3D7450A-500C-4058-9C31-F2F82B81FB7F}"/>
          </ac:spMkLst>
        </pc:spChg>
        <pc:picChg chg="del">
          <ac:chgData name="Guest User" userId="S::urn:spo:anon#4cf4838ef0fbf4d0dba1e40ac72942b61102bea1b1689e895975c57b98f5ef34::" providerId="AD" clId="Web-{C7A5DDF9-673C-83A1-5EE2-8C90F7BB037D}" dt="2022-01-06T20:05:11.632" v="34"/>
          <ac:picMkLst>
            <pc:docMk/>
            <pc:sldMk cId="765348557" sldId="404"/>
            <ac:picMk id="5" creationId="{F0F567F1-15EE-425C-810C-D60580C8B4A4}"/>
          </ac:picMkLst>
        </pc:picChg>
        <pc:picChg chg="add mod">
          <ac:chgData name="Guest User" userId="S::urn:spo:anon#4cf4838ef0fbf4d0dba1e40ac72942b61102bea1b1689e895975c57b98f5ef34::" providerId="AD" clId="Web-{C7A5DDF9-673C-83A1-5EE2-8C90F7BB037D}" dt="2022-01-06T20:13:21.896" v="68" actId="14100"/>
          <ac:picMkLst>
            <pc:docMk/>
            <pc:sldMk cId="765348557" sldId="404"/>
            <ac:picMk id="10" creationId="{AD189B5F-9199-4378-8933-CD831C7A1BD3}"/>
          </ac:picMkLst>
        </pc:picChg>
      </pc:sldChg>
    </pc:docChg>
  </pc:docChgLst>
  <pc:docChgLst>
    <pc:chgData name="kimberly.kranz@stonybrookmedicine.edu" userId="S::urn:spo:guest#kimberly.kranz@stonybrookmedicine.edu::" providerId="AD" clId="Web-{BFEE3E9C-AB13-012D-A4AB-993F0A7E49B1}"/>
    <pc:docChg chg="sldOrd">
      <pc:chgData name="kimberly.kranz@stonybrookmedicine.edu" userId="S::urn:spo:guest#kimberly.kranz@stonybrookmedicine.edu::" providerId="AD" clId="Web-{BFEE3E9C-AB13-012D-A4AB-993F0A7E49B1}" dt="2021-10-04T18:08:37.743" v="1"/>
      <pc:docMkLst>
        <pc:docMk/>
      </pc:docMkLst>
      <pc:sldChg chg="ord">
        <pc:chgData name="kimberly.kranz@stonybrookmedicine.edu" userId="S::urn:spo:guest#kimberly.kranz@stonybrookmedicine.edu::" providerId="AD" clId="Web-{BFEE3E9C-AB13-012D-A4AB-993F0A7E49B1}" dt="2021-10-04T18:08:37.743" v="1"/>
        <pc:sldMkLst>
          <pc:docMk/>
          <pc:sldMk cId="1059714534" sldId="388"/>
        </pc:sldMkLst>
      </pc:sldChg>
    </pc:docChg>
  </pc:docChgLst>
  <pc:docChgLst>
    <pc:chgData name="Gabrielle Goldberg" userId="S::gabrielle.goldberg@hofstra.edu::453f9b71-f7a4-4ef4-8e34-bbb69381dfc0" providerId="AD" clId="Web-{5ACDEDBA-CAA0-4FD4-53E8-83D56EA1B255}"/>
    <pc:docChg chg="modSld">
      <pc:chgData name="Gabrielle Goldberg" userId="S::gabrielle.goldberg@hofstra.edu::453f9b71-f7a4-4ef4-8e34-bbb69381dfc0" providerId="AD" clId="Web-{5ACDEDBA-CAA0-4FD4-53E8-83D56EA1B255}" dt="2021-12-11T17:50:50.304" v="45" actId="1076"/>
      <pc:docMkLst>
        <pc:docMk/>
      </pc:docMkLst>
      <pc:sldChg chg="modSp">
        <pc:chgData name="Gabrielle Goldberg" userId="S::gabrielle.goldberg@hofstra.edu::453f9b71-f7a4-4ef4-8e34-bbb69381dfc0" providerId="AD" clId="Web-{5ACDEDBA-CAA0-4FD4-53E8-83D56EA1B255}" dt="2021-12-11T17:44:26.969" v="0" actId="1076"/>
        <pc:sldMkLst>
          <pc:docMk/>
          <pc:sldMk cId="659258882" sldId="316"/>
        </pc:sldMkLst>
        <pc:spChg chg="mod">
          <ac:chgData name="Gabrielle Goldberg" userId="S::gabrielle.goldberg@hofstra.edu::453f9b71-f7a4-4ef4-8e34-bbb69381dfc0" providerId="AD" clId="Web-{5ACDEDBA-CAA0-4FD4-53E8-83D56EA1B255}" dt="2021-12-11T17:44:26.969" v="0" actId="1076"/>
          <ac:spMkLst>
            <pc:docMk/>
            <pc:sldMk cId="659258882" sldId="316"/>
            <ac:spMk id="4" creationId="{21C1E623-F543-4D3B-8E1A-B50D58553900}"/>
          </ac:spMkLst>
        </pc:spChg>
      </pc:sldChg>
      <pc:sldChg chg="modSp">
        <pc:chgData name="Gabrielle Goldberg" userId="S::gabrielle.goldberg@hofstra.edu::453f9b71-f7a4-4ef4-8e34-bbb69381dfc0" providerId="AD" clId="Web-{5ACDEDBA-CAA0-4FD4-53E8-83D56EA1B255}" dt="2021-12-11T17:50:50.304" v="45" actId="1076"/>
        <pc:sldMkLst>
          <pc:docMk/>
          <pc:sldMk cId="3150183129" sldId="379"/>
        </pc:sldMkLst>
        <pc:graphicFrameChg chg="mod modGraphic">
          <ac:chgData name="Gabrielle Goldberg" userId="S::gabrielle.goldberg@hofstra.edu::453f9b71-f7a4-4ef4-8e34-bbb69381dfc0" providerId="AD" clId="Web-{5ACDEDBA-CAA0-4FD4-53E8-83D56EA1B255}" dt="2021-12-11T17:50:50.304" v="45" actId="1076"/>
          <ac:graphicFrameMkLst>
            <pc:docMk/>
            <pc:sldMk cId="3150183129" sldId="379"/>
            <ac:graphicFrameMk id="4" creationId="{C1FFCE84-EBCA-4D7F-9C21-DF600EF51E09}"/>
          </ac:graphicFrameMkLst>
        </pc:graphicFrameChg>
      </pc:sldChg>
      <pc:sldChg chg="modSp">
        <pc:chgData name="Gabrielle Goldberg" userId="S::gabrielle.goldberg@hofstra.edu::453f9b71-f7a4-4ef4-8e34-bbb69381dfc0" providerId="AD" clId="Web-{5ACDEDBA-CAA0-4FD4-53E8-83D56EA1B255}" dt="2021-12-11T17:44:47.563" v="3" actId="1076"/>
        <pc:sldMkLst>
          <pc:docMk/>
          <pc:sldMk cId="3375007296" sldId="380"/>
        </pc:sldMkLst>
        <pc:spChg chg="mod">
          <ac:chgData name="Gabrielle Goldberg" userId="S::gabrielle.goldberg@hofstra.edu::453f9b71-f7a4-4ef4-8e34-bbb69381dfc0" providerId="AD" clId="Web-{5ACDEDBA-CAA0-4FD4-53E8-83D56EA1B255}" dt="2021-12-11T17:44:47.563" v="3" actId="1076"/>
          <ac:spMkLst>
            <pc:docMk/>
            <pc:sldMk cId="3375007296" sldId="380"/>
            <ac:spMk id="3" creationId="{732813B5-3B16-4C39-9B26-980756C16563}"/>
          </ac:spMkLst>
        </pc:spChg>
        <pc:picChg chg="mod">
          <ac:chgData name="Gabrielle Goldberg" userId="S::gabrielle.goldberg@hofstra.edu::453f9b71-f7a4-4ef4-8e34-bbb69381dfc0" providerId="AD" clId="Web-{5ACDEDBA-CAA0-4FD4-53E8-83D56EA1B255}" dt="2021-12-11T17:44:43.485" v="2" actId="1076"/>
          <ac:picMkLst>
            <pc:docMk/>
            <pc:sldMk cId="3375007296" sldId="380"/>
            <ac:picMk id="7" creationId="{C881AB2D-3C9A-4D94-8D8A-B5E7537280AA}"/>
          </ac:picMkLst>
        </pc:picChg>
      </pc:sldChg>
      <pc:sldChg chg="modSp">
        <pc:chgData name="Gabrielle Goldberg" userId="S::gabrielle.goldberg@hofstra.edu::453f9b71-f7a4-4ef4-8e34-bbb69381dfc0" providerId="AD" clId="Web-{5ACDEDBA-CAA0-4FD4-53E8-83D56EA1B255}" dt="2021-12-11T17:45:34.189" v="7" actId="14100"/>
        <pc:sldMkLst>
          <pc:docMk/>
          <pc:sldMk cId="3614030429" sldId="397"/>
        </pc:sldMkLst>
        <pc:spChg chg="mod">
          <ac:chgData name="Gabrielle Goldberg" userId="S::gabrielle.goldberg@hofstra.edu::453f9b71-f7a4-4ef4-8e34-bbb69381dfc0" providerId="AD" clId="Web-{5ACDEDBA-CAA0-4FD4-53E8-83D56EA1B255}" dt="2021-12-11T17:45:34.189" v="7" actId="14100"/>
          <ac:spMkLst>
            <pc:docMk/>
            <pc:sldMk cId="3614030429" sldId="397"/>
            <ac:spMk id="2" creationId="{9711D05B-1A6A-4785-9233-25614CFC03CE}"/>
          </ac:spMkLst>
        </pc:spChg>
      </pc:sldChg>
      <pc:sldChg chg="addSp modSp">
        <pc:chgData name="Gabrielle Goldberg" userId="S::gabrielle.goldberg@hofstra.edu::453f9b71-f7a4-4ef4-8e34-bbb69381dfc0" providerId="AD" clId="Web-{5ACDEDBA-CAA0-4FD4-53E8-83D56EA1B255}" dt="2021-12-11T17:47:46.254" v="21" actId="1076"/>
        <pc:sldMkLst>
          <pc:docMk/>
          <pc:sldMk cId="2623007478" sldId="405"/>
        </pc:sldMkLst>
        <pc:spChg chg="add mod">
          <ac:chgData name="Gabrielle Goldberg" userId="S::gabrielle.goldberg@hofstra.edu::453f9b71-f7a4-4ef4-8e34-bbb69381dfc0" providerId="AD" clId="Web-{5ACDEDBA-CAA0-4FD4-53E8-83D56EA1B255}" dt="2021-12-11T17:47:46.254" v="21" actId="1076"/>
          <ac:spMkLst>
            <pc:docMk/>
            <pc:sldMk cId="2623007478" sldId="405"/>
            <ac:spMk id="26" creationId="{91F1832B-6891-4A64-8B05-87ACC589EC41}"/>
          </ac:spMkLst>
        </pc:spChg>
      </pc:sldChg>
    </pc:docChg>
  </pc:docChgLst>
  <pc:docChgLst>
    <pc:chgData name="Solis, Gabriela" userId="S::gsolis_northwell.edu#ext#@hofstra.edu::198dd0ac-6fb3-4b59-b455-eeb2e8da8c00" providerId="AD" clId="Web-{3BE28A49-DE09-4B0E-C28A-EC34D5DAC9C7}"/>
    <pc:docChg chg="modSld">
      <pc:chgData name="Solis, Gabriela" userId="S::gsolis_northwell.edu#ext#@hofstra.edu::198dd0ac-6fb3-4b59-b455-eeb2e8da8c00" providerId="AD" clId="Web-{3BE28A49-DE09-4B0E-C28A-EC34D5DAC9C7}" dt="2022-04-14T19:18:56.724" v="308" actId="20577"/>
      <pc:docMkLst>
        <pc:docMk/>
      </pc:docMkLst>
      <pc:sldChg chg="addSp modSp">
        <pc:chgData name="Solis, Gabriela" userId="S::gsolis_northwell.edu#ext#@hofstra.edu::198dd0ac-6fb3-4b59-b455-eeb2e8da8c00" providerId="AD" clId="Web-{3BE28A49-DE09-4B0E-C28A-EC34D5DAC9C7}" dt="2022-04-14T19:18:56.724" v="308" actId="20577"/>
        <pc:sldMkLst>
          <pc:docMk/>
          <pc:sldMk cId="2418592727" sldId="373"/>
        </pc:sldMkLst>
        <pc:spChg chg="mod">
          <ac:chgData name="Solis, Gabriela" userId="S::gsolis_northwell.edu#ext#@hofstra.edu::198dd0ac-6fb3-4b59-b455-eeb2e8da8c00" providerId="AD" clId="Web-{3BE28A49-DE09-4B0E-C28A-EC34D5DAC9C7}" dt="2022-04-14T18:03:47.670" v="0" actId="20577"/>
          <ac:spMkLst>
            <pc:docMk/>
            <pc:sldMk cId="2418592727" sldId="373"/>
            <ac:spMk id="2" creationId="{FC7ABD9D-8BDE-4579-A098-9E3D7A18F914}"/>
          </ac:spMkLst>
        </pc:spChg>
        <pc:spChg chg="mod">
          <ac:chgData name="Solis, Gabriela" userId="S::gsolis_northwell.edu#ext#@hofstra.edu::198dd0ac-6fb3-4b59-b455-eeb2e8da8c00" providerId="AD" clId="Web-{3BE28A49-DE09-4B0E-C28A-EC34D5DAC9C7}" dt="2022-04-14T19:08:57.709" v="282" actId="20577"/>
          <ac:spMkLst>
            <pc:docMk/>
            <pc:sldMk cId="2418592727" sldId="373"/>
            <ac:spMk id="3" creationId="{AB26ACB8-94F9-48F1-AC83-F44DCA055732}"/>
          </ac:spMkLst>
        </pc:spChg>
        <pc:spChg chg="add mod">
          <ac:chgData name="Solis, Gabriela" userId="S::gsolis_northwell.edu#ext#@hofstra.edu::198dd0ac-6fb3-4b59-b455-eeb2e8da8c00" providerId="AD" clId="Web-{3BE28A49-DE09-4B0E-C28A-EC34D5DAC9C7}" dt="2022-04-14T19:18:56.724" v="308" actId="20577"/>
          <ac:spMkLst>
            <pc:docMk/>
            <pc:sldMk cId="2418592727" sldId="373"/>
            <ac:spMk id="4" creationId="{7139FB9B-AEAA-DF4D-FA01-2BFDEEC1256D}"/>
          </ac:spMkLst>
        </pc:spChg>
        <pc:spChg chg="add mod">
          <ac:chgData name="Solis, Gabriela" userId="S::gsolis_northwell.edu#ext#@hofstra.edu::198dd0ac-6fb3-4b59-b455-eeb2e8da8c00" providerId="AD" clId="Web-{3BE28A49-DE09-4B0E-C28A-EC34D5DAC9C7}" dt="2022-04-14T19:09:03.084" v="283" actId="20577"/>
          <ac:spMkLst>
            <pc:docMk/>
            <pc:sldMk cId="2418592727" sldId="373"/>
            <ac:spMk id="5" creationId="{2422B267-CF78-04F0-0FCC-7107B82B1B5C}"/>
          </ac:spMkLst>
        </pc:spChg>
        <pc:spChg chg="mod">
          <ac:chgData name="Solis, Gabriela" userId="S::gsolis_northwell.edu#ext#@hofstra.edu::198dd0ac-6fb3-4b59-b455-eeb2e8da8c00" providerId="AD" clId="Web-{3BE28A49-DE09-4B0E-C28A-EC34D5DAC9C7}" dt="2022-04-14T19:11:51.823" v="300" actId="20577"/>
          <ac:spMkLst>
            <pc:docMk/>
            <pc:sldMk cId="2418592727" sldId="373"/>
            <ac:spMk id="11" creationId="{089DD99E-0D17-4C5D-B955-09FF7808AF36}"/>
          </ac:spMkLst>
        </pc:spChg>
      </pc:sldChg>
      <pc:sldChg chg="modSp">
        <pc:chgData name="Solis, Gabriela" userId="S::gsolis_northwell.edu#ext#@hofstra.edu::198dd0ac-6fb3-4b59-b455-eeb2e8da8c00" providerId="AD" clId="Web-{3BE28A49-DE09-4B0E-C28A-EC34D5DAC9C7}" dt="2022-04-14T18:22:22.231" v="23" actId="20577"/>
        <pc:sldMkLst>
          <pc:docMk/>
          <pc:sldMk cId="3375007296" sldId="380"/>
        </pc:sldMkLst>
        <pc:spChg chg="mod">
          <ac:chgData name="Solis, Gabriela" userId="S::gsolis_northwell.edu#ext#@hofstra.edu::198dd0ac-6fb3-4b59-b455-eeb2e8da8c00" providerId="AD" clId="Web-{3BE28A49-DE09-4B0E-C28A-EC34D5DAC9C7}" dt="2022-04-14T18:22:22.231" v="23" actId="20577"/>
          <ac:spMkLst>
            <pc:docMk/>
            <pc:sldMk cId="3375007296" sldId="380"/>
            <ac:spMk id="2" creationId="{00000000-0000-0000-0000-000000000000}"/>
          </ac:spMkLst>
        </pc:spChg>
      </pc:sldChg>
      <pc:sldChg chg="modSp">
        <pc:chgData name="Solis, Gabriela" userId="S::gsolis_northwell.edu#ext#@hofstra.edu::198dd0ac-6fb3-4b59-b455-eeb2e8da8c00" providerId="AD" clId="Web-{3BE28A49-DE09-4B0E-C28A-EC34D5DAC9C7}" dt="2022-04-14T18:04:40.546" v="9" actId="1076"/>
        <pc:sldMkLst>
          <pc:docMk/>
          <pc:sldMk cId="3711734020" sldId="386"/>
        </pc:sldMkLst>
        <pc:spChg chg="mod">
          <ac:chgData name="Solis, Gabriela" userId="S::gsolis_northwell.edu#ext#@hofstra.edu::198dd0ac-6fb3-4b59-b455-eeb2e8da8c00" providerId="AD" clId="Web-{3BE28A49-DE09-4B0E-C28A-EC34D5DAC9C7}" dt="2022-04-14T18:04:40.546" v="9" actId="1076"/>
          <ac:spMkLst>
            <pc:docMk/>
            <pc:sldMk cId="3711734020" sldId="386"/>
            <ac:spMk id="3" creationId="{7E531B93-120A-4961-AF55-8A03F7FC04F5}"/>
          </ac:spMkLst>
        </pc:spChg>
      </pc:sldChg>
      <pc:sldChg chg="modSp">
        <pc:chgData name="Solis, Gabriela" userId="S::gsolis_northwell.edu#ext#@hofstra.edu::198dd0ac-6fb3-4b59-b455-eeb2e8da8c00" providerId="AD" clId="Web-{3BE28A49-DE09-4B0E-C28A-EC34D5DAC9C7}" dt="2022-04-14T18:32:28.777" v="33" actId="20577"/>
        <pc:sldMkLst>
          <pc:docMk/>
          <pc:sldMk cId="156485789" sldId="389"/>
        </pc:sldMkLst>
        <pc:graphicFrameChg chg="modGraphic">
          <ac:chgData name="Solis, Gabriela" userId="S::gsolis_northwell.edu#ext#@hofstra.edu::198dd0ac-6fb3-4b59-b455-eeb2e8da8c00" providerId="AD" clId="Web-{3BE28A49-DE09-4B0E-C28A-EC34D5DAC9C7}" dt="2022-04-14T18:32:28.777" v="33" actId="20577"/>
          <ac:graphicFrameMkLst>
            <pc:docMk/>
            <pc:sldMk cId="156485789" sldId="389"/>
            <ac:graphicFrameMk id="8" creationId="{A7BF77DA-70BD-4B1F-8966-83423723D9A4}"/>
          </ac:graphicFrameMkLst>
        </pc:graphicFrameChg>
      </pc:sldChg>
      <pc:sldChg chg="modSp">
        <pc:chgData name="Solis, Gabriela" userId="S::gsolis_northwell.edu#ext#@hofstra.edu::198dd0ac-6fb3-4b59-b455-eeb2e8da8c00" providerId="AD" clId="Web-{3BE28A49-DE09-4B0E-C28A-EC34D5DAC9C7}" dt="2022-04-14T18:39:11.163" v="66" actId="20577"/>
        <pc:sldMkLst>
          <pc:docMk/>
          <pc:sldMk cId="3614030429" sldId="397"/>
        </pc:sldMkLst>
        <pc:graphicFrameChg chg="modGraphic">
          <ac:chgData name="Solis, Gabriela" userId="S::gsolis_northwell.edu#ext#@hofstra.edu::198dd0ac-6fb3-4b59-b455-eeb2e8da8c00" providerId="AD" clId="Web-{3BE28A49-DE09-4B0E-C28A-EC34D5DAC9C7}" dt="2022-04-14T18:39:11.163" v="66" actId="20577"/>
          <ac:graphicFrameMkLst>
            <pc:docMk/>
            <pc:sldMk cId="3614030429" sldId="397"/>
            <ac:graphicFrameMk id="5" creationId="{A30DB580-B4D2-4174-8E60-270C1221623D}"/>
          </ac:graphicFrameMkLst>
        </pc:graphicFrameChg>
      </pc:sldChg>
    </pc:docChg>
  </pc:docChgLst>
  <pc:docChgLst>
    <pc:chgData name="Gabrielle Goldberg" userId="S::gabrielle.goldberg@hofstra.edu::453f9b71-f7a4-4ef4-8e34-bbb69381dfc0" providerId="AD" clId="Web-{78A651E5-B4B1-CD51-59E4-6157343E148F}"/>
    <pc:docChg chg="addSld delSld modSld">
      <pc:chgData name="Gabrielle Goldberg" userId="S::gabrielle.goldberg@hofstra.edu::453f9b71-f7a4-4ef4-8e34-bbb69381dfc0" providerId="AD" clId="Web-{78A651E5-B4B1-CD51-59E4-6157343E148F}" dt="2021-07-23T17:47:24.442" v="300" actId="1076"/>
      <pc:docMkLst>
        <pc:docMk/>
      </pc:docMkLst>
      <pc:sldChg chg="modSp">
        <pc:chgData name="Gabrielle Goldberg" userId="S::gabrielle.goldberg@hofstra.edu::453f9b71-f7a4-4ef4-8e34-bbb69381dfc0" providerId="AD" clId="Web-{78A651E5-B4B1-CD51-59E4-6157343E148F}" dt="2021-07-23T17:38:38.186" v="235"/>
        <pc:sldMkLst>
          <pc:docMk/>
          <pc:sldMk cId="2439297039" sldId="367"/>
        </pc:sldMkLst>
        <pc:spChg chg="mod">
          <ac:chgData name="Gabrielle Goldberg" userId="S::gabrielle.goldberg@hofstra.edu::453f9b71-f7a4-4ef4-8e34-bbb69381dfc0" providerId="AD" clId="Web-{78A651E5-B4B1-CD51-59E4-6157343E148F}" dt="2021-07-23T17:38:38.186" v="235"/>
          <ac:spMkLst>
            <pc:docMk/>
            <pc:sldMk cId="2439297039" sldId="367"/>
            <ac:spMk id="3" creationId="{01EBB642-A9A1-4273-829D-59C1EBAD2430}"/>
          </ac:spMkLst>
        </pc:spChg>
      </pc:sldChg>
      <pc:sldChg chg="modSp">
        <pc:chgData name="Gabrielle Goldberg" userId="S::gabrielle.goldberg@hofstra.edu::453f9b71-f7a4-4ef4-8e34-bbb69381dfc0" providerId="AD" clId="Web-{78A651E5-B4B1-CD51-59E4-6157343E148F}" dt="2021-07-23T17:21:48.848" v="0" actId="20577"/>
        <pc:sldMkLst>
          <pc:docMk/>
          <pc:sldMk cId="278272457" sldId="378"/>
        </pc:sldMkLst>
        <pc:spChg chg="mod">
          <ac:chgData name="Gabrielle Goldberg" userId="S::gabrielle.goldberg@hofstra.edu::453f9b71-f7a4-4ef4-8e34-bbb69381dfc0" providerId="AD" clId="Web-{78A651E5-B4B1-CD51-59E4-6157343E148F}" dt="2021-07-23T17:21:48.848" v="0" actId="20577"/>
          <ac:spMkLst>
            <pc:docMk/>
            <pc:sldMk cId="278272457" sldId="378"/>
            <ac:spMk id="3" creationId="{2B81FEFF-2091-470B-97BD-B2221C0ED1FB}"/>
          </ac:spMkLst>
        </pc:spChg>
      </pc:sldChg>
      <pc:sldChg chg="addSp delSp modSp mod setBg">
        <pc:chgData name="Gabrielle Goldberg" userId="S::gabrielle.goldberg@hofstra.edu::453f9b71-f7a4-4ef4-8e34-bbb69381dfc0" providerId="AD" clId="Web-{78A651E5-B4B1-CD51-59E4-6157343E148F}" dt="2021-07-23T17:43:13.651" v="265" actId="1076"/>
        <pc:sldMkLst>
          <pc:docMk/>
          <pc:sldMk cId="3150183129" sldId="379"/>
        </pc:sldMkLst>
        <pc:spChg chg="del mod">
          <ac:chgData name="Gabrielle Goldberg" userId="S::gabrielle.goldberg@hofstra.edu::453f9b71-f7a4-4ef4-8e34-bbb69381dfc0" providerId="AD" clId="Web-{78A651E5-B4B1-CD51-59E4-6157343E148F}" dt="2021-07-23T17:41:45.991" v="251"/>
          <ac:spMkLst>
            <pc:docMk/>
            <pc:sldMk cId="3150183129" sldId="379"/>
            <ac:spMk id="2" creationId="{DDCED976-2EF0-45FC-8DC8-B1F88B4B36EE}"/>
          </ac:spMkLst>
        </pc:spChg>
        <pc:spChg chg="add del">
          <ac:chgData name="Gabrielle Goldberg" userId="S::gabrielle.goldberg@hofstra.edu::453f9b71-f7a4-4ef4-8e34-bbb69381dfc0" providerId="AD" clId="Web-{78A651E5-B4B1-CD51-59E4-6157343E148F}" dt="2021-07-23T17:42:25.039" v="257"/>
          <ac:spMkLst>
            <pc:docMk/>
            <pc:sldMk cId="3150183129" sldId="379"/>
            <ac:spMk id="9" creationId="{6C4028FD-8BAA-4A19-BFDE-594D991B7552}"/>
          </ac:spMkLst>
        </pc:spChg>
        <pc:spChg chg="add">
          <ac:chgData name="Gabrielle Goldberg" userId="S::gabrielle.goldberg@hofstra.edu::453f9b71-f7a4-4ef4-8e34-bbb69381dfc0" providerId="AD" clId="Web-{78A651E5-B4B1-CD51-59E4-6157343E148F}" dt="2021-07-23T17:42:25.039" v="257"/>
          <ac:spMkLst>
            <pc:docMk/>
            <pc:sldMk cId="3150183129" sldId="379"/>
            <ac:spMk id="14" creationId="{6C4028FD-8BAA-4A19-BFDE-594D991B7552}"/>
          </ac:spMkLst>
        </pc:spChg>
        <pc:graphicFrameChg chg="add mod modGraphic">
          <ac:chgData name="Gabrielle Goldberg" userId="S::gabrielle.goldberg@hofstra.edu::453f9b71-f7a4-4ef4-8e34-bbb69381dfc0" providerId="AD" clId="Web-{78A651E5-B4B1-CD51-59E4-6157343E148F}" dt="2021-07-23T17:43:13.651" v="265" actId="1076"/>
          <ac:graphicFrameMkLst>
            <pc:docMk/>
            <pc:sldMk cId="3150183129" sldId="379"/>
            <ac:graphicFrameMk id="4" creationId="{C1FFCE84-EBCA-4D7F-9C21-DF600EF51E09}"/>
          </ac:graphicFrameMkLst>
        </pc:graphicFrameChg>
      </pc:sldChg>
      <pc:sldChg chg="addSp delSp modSp mod setBg">
        <pc:chgData name="Gabrielle Goldberg" userId="S::gabrielle.goldberg@hofstra.edu::453f9b71-f7a4-4ef4-8e34-bbb69381dfc0" providerId="AD" clId="Web-{78A651E5-B4B1-CD51-59E4-6157343E148F}" dt="2021-07-23T17:25:46.342" v="29"/>
        <pc:sldMkLst>
          <pc:docMk/>
          <pc:sldMk cId="156485789" sldId="389"/>
        </pc:sldMkLst>
        <pc:spChg chg="mod">
          <ac:chgData name="Gabrielle Goldberg" userId="S::gabrielle.goldberg@hofstra.edu::453f9b71-f7a4-4ef4-8e34-bbb69381dfc0" providerId="AD" clId="Web-{78A651E5-B4B1-CD51-59E4-6157343E148F}" dt="2021-07-23T17:25:46.342" v="29"/>
          <ac:spMkLst>
            <pc:docMk/>
            <pc:sldMk cId="156485789" sldId="389"/>
            <ac:spMk id="2" creationId="{00000000-0000-0000-0000-000000000000}"/>
          </ac:spMkLst>
        </pc:spChg>
        <pc:spChg chg="del mod">
          <ac:chgData name="Gabrielle Goldberg" userId="S::gabrielle.goldberg@hofstra.edu::453f9b71-f7a4-4ef4-8e34-bbb69381dfc0" providerId="AD" clId="Web-{78A651E5-B4B1-CD51-59E4-6157343E148F}" dt="2021-07-23T17:25:32.435" v="19"/>
          <ac:spMkLst>
            <pc:docMk/>
            <pc:sldMk cId="156485789" sldId="389"/>
            <ac:spMk id="6" creationId="{00000000-0000-0000-0000-000000000000}"/>
          </ac:spMkLst>
        </pc:spChg>
        <pc:graphicFrameChg chg="add">
          <ac:chgData name="Gabrielle Goldberg" userId="S::gabrielle.goldberg@hofstra.edu::453f9b71-f7a4-4ef4-8e34-bbb69381dfc0" providerId="AD" clId="Web-{78A651E5-B4B1-CD51-59E4-6157343E148F}" dt="2021-07-23T17:25:32.435" v="19"/>
          <ac:graphicFrameMkLst>
            <pc:docMk/>
            <pc:sldMk cId="156485789" sldId="389"/>
            <ac:graphicFrameMk id="8" creationId="{A7BF77DA-70BD-4B1F-8966-83423723D9A4}"/>
          </ac:graphicFrameMkLst>
        </pc:graphicFrameChg>
      </pc:sldChg>
      <pc:sldChg chg="modSp">
        <pc:chgData name="Gabrielle Goldberg" userId="S::gabrielle.goldberg@hofstra.edu::453f9b71-f7a4-4ef4-8e34-bbb69381dfc0" providerId="AD" clId="Web-{78A651E5-B4B1-CD51-59E4-6157343E148F}" dt="2021-07-23T17:24:29.354" v="8" actId="20577"/>
        <pc:sldMkLst>
          <pc:docMk/>
          <pc:sldMk cId="198615434" sldId="392"/>
        </pc:sldMkLst>
        <pc:spChg chg="mod">
          <ac:chgData name="Gabrielle Goldberg" userId="S::gabrielle.goldberg@hofstra.edu::453f9b71-f7a4-4ef4-8e34-bbb69381dfc0" providerId="AD" clId="Web-{78A651E5-B4B1-CD51-59E4-6157343E148F}" dt="2021-07-23T17:24:29.354" v="8" actId="20577"/>
          <ac:spMkLst>
            <pc:docMk/>
            <pc:sldMk cId="198615434" sldId="392"/>
            <ac:spMk id="6" creationId="{00000000-0000-0000-0000-000000000000}"/>
          </ac:spMkLst>
        </pc:spChg>
      </pc:sldChg>
      <pc:sldChg chg="addSp delSp modSp">
        <pc:chgData name="Gabrielle Goldberg" userId="S::gabrielle.goldberg@hofstra.edu::453f9b71-f7a4-4ef4-8e34-bbb69381dfc0" providerId="AD" clId="Web-{78A651E5-B4B1-CD51-59E4-6157343E148F}" dt="2021-07-23T17:27:14.236" v="50"/>
        <pc:sldMkLst>
          <pc:docMk/>
          <pc:sldMk cId="807323245" sldId="394"/>
        </pc:sldMkLst>
        <pc:spChg chg="del mod">
          <ac:chgData name="Gabrielle Goldberg" userId="S::gabrielle.goldberg@hofstra.edu::453f9b71-f7a4-4ef4-8e34-bbb69381dfc0" providerId="AD" clId="Web-{78A651E5-B4B1-CD51-59E4-6157343E148F}" dt="2021-07-23T17:27:14.236" v="50"/>
          <ac:spMkLst>
            <pc:docMk/>
            <pc:sldMk cId="807323245" sldId="394"/>
            <ac:spMk id="3" creationId="{9A392957-BD48-49DE-8599-0E44A1AE6D05}"/>
          </ac:spMkLst>
        </pc:spChg>
        <pc:graphicFrameChg chg="add">
          <ac:chgData name="Gabrielle Goldberg" userId="S::gabrielle.goldberg@hofstra.edu::453f9b71-f7a4-4ef4-8e34-bbb69381dfc0" providerId="AD" clId="Web-{78A651E5-B4B1-CD51-59E4-6157343E148F}" dt="2021-07-23T17:27:14.236" v="50"/>
          <ac:graphicFrameMkLst>
            <pc:docMk/>
            <pc:sldMk cId="807323245" sldId="394"/>
            <ac:graphicFrameMk id="8" creationId="{9D32441B-BB1B-4EC3-A3D6-DAB2DF5E11A6}"/>
          </ac:graphicFrameMkLst>
        </pc:graphicFrameChg>
      </pc:sldChg>
      <pc:sldChg chg="addSp delSp modSp mod setBg">
        <pc:chgData name="Gabrielle Goldberg" userId="S::gabrielle.goldberg@hofstra.edu::453f9b71-f7a4-4ef4-8e34-bbb69381dfc0" providerId="AD" clId="Web-{78A651E5-B4B1-CD51-59E4-6157343E148F}" dt="2021-07-23T17:38:24.139" v="234"/>
        <pc:sldMkLst>
          <pc:docMk/>
          <pc:sldMk cId="4176268020" sldId="396"/>
        </pc:sldMkLst>
        <pc:spChg chg="mod">
          <ac:chgData name="Gabrielle Goldberg" userId="S::gabrielle.goldberg@hofstra.edu::453f9b71-f7a4-4ef4-8e34-bbb69381dfc0" providerId="AD" clId="Web-{78A651E5-B4B1-CD51-59E4-6157343E148F}" dt="2021-07-23T17:38:24.139" v="234"/>
          <ac:spMkLst>
            <pc:docMk/>
            <pc:sldMk cId="4176268020" sldId="396"/>
            <ac:spMk id="2" creationId="{9711D05B-1A6A-4785-9233-25614CFC03CE}"/>
          </ac:spMkLst>
        </pc:spChg>
        <pc:spChg chg="mod">
          <ac:chgData name="Gabrielle Goldberg" userId="S::gabrielle.goldberg@hofstra.edu::453f9b71-f7a4-4ef4-8e34-bbb69381dfc0" providerId="AD" clId="Web-{78A651E5-B4B1-CD51-59E4-6157343E148F}" dt="2021-07-23T17:38:24.139" v="234"/>
          <ac:spMkLst>
            <pc:docMk/>
            <pc:sldMk cId="4176268020" sldId="396"/>
            <ac:spMk id="3" creationId="{01EBB642-A9A1-4273-829D-59C1EBAD2430}"/>
          </ac:spMkLst>
        </pc:spChg>
        <pc:spChg chg="mod">
          <ac:chgData name="Gabrielle Goldberg" userId="S::gabrielle.goldberg@hofstra.edu::453f9b71-f7a4-4ef4-8e34-bbb69381dfc0" providerId="AD" clId="Web-{78A651E5-B4B1-CD51-59E4-6157343E148F}" dt="2021-07-23T17:38:24.139" v="234"/>
          <ac:spMkLst>
            <pc:docMk/>
            <pc:sldMk cId="4176268020" sldId="396"/>
            <ac:spMk id="5" creationId="{4D827504-E1A9-459B-AC84-683A2E7257BC}"/>
          </ac:spMkLst>
        </pc:spChg>
        <pc:spChg chg="add del">
          <ac:chgData name="Gabrielle Goldberg" userId="S::gabrielle.goldberg@hofstra.edu::453f9b71-f7a4-4ef4-8e34-bbb69381dfc0" providerId="AD" clId="Web-{78A651E5-B4B1-CD51-59E4-6157343E148F}" dt="2021-07-23T17:38:24.139" v="234"/>
          <ac:spMkLst>
            <pc:docMk/>
            <pc:sldMk cId="4176268020" sldId="396"/>
            <ac:spMk id="10" creationId="{4C608BEB-860E-4094-8511-78603564A75E}"/>
          </ac:spMkLst>
        </pc:spChg>
        <pc:cxnChg chg="add del">
          <ac:chgData name="Gabrielle Goldberg" userId="S::gabrielle.goldberg@hofstra.edu::453f9b71-f7a4-4ef4-8e34-bbb69381dfc0" providerId="AD" clId="Web-{78A651E5-B4B1-CD51-59E4-6157343E148F}" dt="2021-07-23T17:38:24.139" v="234"/>
          <ac:cxnSpMkLst>
            <pc:docMk/>
            <pc:sldMk cId="4176268020" sldId="396"/>
            <ac:cxnSpMk id="12" creationId="{1F16A8D4-FE87-4604-88B2-394B5D1EB437}"/>
          </ac:cxnSpMkLst>
        </pc:cxnChg>
      </pc:sldChg>
      <pc:sldChg chg="addSp delSp modSp mod setBg">
        <pc:chgData name="Gabrielle Goldberg" userId="S::gabrielle.goldberg@hofstra.edu::453f9b71-f7a4-4ef4-8e34-bbb69381dfc0" providerId="AD" clId="Web-{78A651E5-B4B1-CD51-59E4-6157343E148F}" dt="2021-07-23T17:23:20.586" v="2"/>
        <pc:sldMkLst>
          <pc:docMk/>
          <pc:sldMk cId="3614030429" sldId="397"/>
        </pc:sldMkLst>
        <pc:spChg chg="mod">
          <ac:chgData name="Gabrielle Goldberg" userId="S::gabrielle.goldberg@hofstra.edu::453f9b71-f7a4-4ef4-8e34-bbb69381dfc0" providerId="AD" clId="Web-{78A651E5-B4B1-CD51-59E4-6157343E148F}" dt="2021-07-23T17:23:20.586" v="2"/>
          <ac:spMkLst>
            <pc:docMk/>
            <pc:sldMk cId="3614030429" sldId="397"/>
            <ac:spMk id="2" creationId="{9711D05B-1A6A-4785-9233-25614CFC03CE}"/>
          </ac:spMkLst>
        </pc:spChg>
        <pc:spChg chg="del">
          <ac:chgData name="Gabrielle Goldberg" userId="S::gabrielle.goldberg@hofstra.edu::453f9b71-f7a4-4ef4-8e34-bbb69381dfc0" providerId="AD" clId="Web-{78A651E5-B4B1-CD51-59E4-6157343E148F}" dt="2021-07-23T17:23:20.586" v="2"/>
          <ac:spMkLst>
            <pc:docMk/>
            <pc:sldMk cId="3614030429" sldId="397"/>
            <ac:spMk id="3" creationId="{01EBB642-A9A1-4273-829D-59C1EBAD2430}"/>
          </ac:spMkLst>
        </pc:spChg>
        <pc:graphicFrameChg chg="add">
          <ac:chgData name="Gabrielle Goldberg" userId="S::gabrielle.goldberg@hofstra.edu::453f9b71-f7a4-4ef4-8e34-bbb69381dfc0" providerId="AD" clId="Web-{78A651E5-B4B1-CD51-59E4-6157343E148F}" dt="2021-07-23T17:23:20.586" v="2"/>
          <ac:graphicFrameMkLst>
            <pc:docMk/>
            <pc:sldMk cId="3614030429" sldId="397"/>
            <ac:graphicFrameMk id="5" creationId="{A30DB580-B4D2-4174-8E60-270C1221623D}"/>
          </ac:graphicFrameMkLst>
        </pc:graphicFrameChg>
      </pc:sldChg>
      <pc:sldChg chg="modSp">
        <pc:chgData name="Gabrielle Goldberg" userId="S::gabrielle.goldberg@hofstra.edu::453f9b71-f7a4-4ef4-8e34-bbb69381dfc0" providerId="AD" clId="Web-{78A651E5-B4B1-CD51-59E4-6157343E148F}" dt="2021-07-23T17:43:48.043" v="269" actId="1076"/>
        <pc:sldMkLst>
          <pc:docMk/>
          <pc:sldMk cId="1399099135" sldId="402"/>
        </pc:sldMkLst>
        <pc:spChg chg="mod">
          <ac:chgData name="Gabrielle Goldberg" userId="S::gabrielle.goldberg@hofstra.edu::453f9b71-f7a4-4ef4-8e34-bbb69381dfc0" providerId="AD" clId="Web-{78A651E5-B4B1-CD51-59E4-6157343E148F}" dt="2021-07-23T17:43:48.043" v="269" actId="1076"/>
          <ac:spMkLst>
            <pc:docMk/>
            <pc:sldMk cId="1399099135" sldId="402"/>
            <ac:spMk id="2" creationId="{47780179-0182-4210-AB55-A1699228033C}"/>
          </ac:spMkLst>
        </pc:spChg>
      </pc:sldChg>
      <pc:sldChg chg="modSp">
        <pc:chgData name="Gabrielle Goldberg" userId="S::gabrielle.goldberg@hofstra.edu::453f9b71-f7a4-4ef4-8e34-bbb69381dfc0" providerId="AD" clId="Web-{78A651E5-B4B1-CD51-59E4-6157343E148F}" dt="2021-07-23T17:43:59.012" v="270" actId="1076"/>
        <pc:sldMkLst>
          <pc:docMk/>
          <pc:sldMk cId="30129961" sldId="403"/>
        </pc:sldMkLst>
        <pc:picChg chg="mod">
          <ac:chgData name="Gabrielle Goldberg" userId="S::gabrielle.goldberg@hofstra.edu::453f9b71-f7a4-4ef4-8e34-bbb69381dfc0" providerId="AD" clId="Web-{78A651E5-B4B1-CD51-59E4-6157343E148F}" dt="2021-07-23T17:43:59.012" v="270" actId="1076"/>
          <ac:picMkLst>
            <pc:docMk/>
            <pc:sldMk cId="30129961" sldId="403"/>
            <ac:picMk id="7" creationId="{76912F38-878A-4D8D-8160-011CBB84C7B3}"/>
          </ac:picMkLst>
        </pc:picChg>
      </pc:sldChg>
      <pc:sldChg chg="addSp delSp modSp mod setBg">
        <pc:chgData name="Gabrielle Goldberg" userId="S::gabrielle.goldberg@hofstra.edu::453f9b71-f7a4-4ef4-8e34-bbb69381dfc0" providerId="AD" clId="Web-{78A651E5-B4B1-CD51-59E4-6157343E148F}" dt="2021-07-23T17:47:24.442" v="300" actId="1076"/>
        <pc:sldMkLst>
          <pc:docMk/>
          <pc:sldMk cId="765348557" sldId="404"/>
        </pc:sldMkLst>
        <pc:spChg chg="mod">
          <ac:chgData name="Gabrielle Goldberg" userId="S::gabrielle.goldberg@hofstra.edu::453f9b71-f7a4-4ef4-8e34-bbb69381dfc0" providerId="AD" clId="Web-{78A651E5-B4B1-CD51-59E4-6157343E148F}" dt="2021-07-23T17:47:24.442" v="300" actId="1076"/>
          <ac:spMkLst>
            <pc:docMk/>
            <pc:sldMk cId="765348557" sldId="404"/>
            <ac:spMk id="2" creationId="{47780179-0182-4210-AB55-A1699228033C}"/>
          </ac:spMkLst>
        </pc:spChg>
        <pc:spChg chg="mod ord">
          <ac:chgData name="Gabrielle Goldberg" userId="S::gabrielle.goldberg@hofstra.edu::453f9b71-f7a4-4ef4-8e34-bbb69381dfc0" providerId="AD" clId="Web-{78A651E5-B4B1-CD51-59E4-6157343E148F}" dt="2021-07-23T17:47:14.801" v="296"/>
          <ac:spMkLst>
            <pc:docMk/>
            <pc:sldMk cId="765348557" sldId="404"/>
            <ac:spMk id="3" creationId="{9A392957-BD48-49DE-8599-0E44A1AE6D05}"/>
          </ac:spMkLst>
        </pc:spChg>
        <pc:spChg chg="add del">
          <ac:chgData name="Gabrielle Goldberg" userId="S::gabrielle.goldberg@hofstra.edu::453f9b71-f7a4-4ef4-8e34-bbb69381dfc0" providerId="AD" clId="Web-{78A651E5-B4B1-CD51-59E4-6157343E148F}" dt="2021-07-23T17:45:22.062" v="277"/>
          <ac:spMkLst>
            <pc:docMk/>
            <pc:sldMk cId="765348557" sldId="404"/>
            <ac:spMk id="4" creationId="{E8EEF475-465A-420F-8AB0-3C21E5C9D132}"/>
          </ac:spMkLst>
        </pc:spChg>
        <pc:spChg chg="add del">
          <ac:chgData name="Gabrielle Goldberg" userId="S::gabrielle.goldberg@hofstra.edu::453f9b71-f7a4-4ef4-8e34-bbb69381dfc0" providerId="AD" clId="Web-{78A651E5-B4B1-CD51-59E4-6157343E148F}" dt="2021-07-23T17:45:27.609" v="278"/>
          <ac:spMkLst>
            <pc:docMk/>
            <pc:sldMk cId="765348557" sldId="404"/>
            <ac:spMk id="10" creationId="{2C61293E-6EBE-43EF-A52C-9BEBFD7679D4}"/>
          </ac:spMkLst>
        </pc:spChg>
        <pc:spChg chg="add del">
          <ac:chgData name="Gabrielle Goldberg" userId="S::gabrielle.goldberg@hofstra.edu::453f9b71-f7a4-4ef4-8e34-bbb69381dfc0" providerId="AD" clId="Web-{78A651E5-B4B1-CD51-59E4-6157343E148F}" dt="2021-07-23T17:45:27.609" v="278"/>
          <ac:spMkLst>
            <pc:docMk/>
            <pc:sldMk cId="765348557" sldId="404"/>
            <ac:spMk id="12" creationId="{21540236-BFD5-4A9D-8840-4703E7F76825}"/>
          </ac:spMkLst>
        </pc:spChg>
        <pc:picChg chg="mod ord">
          <ac:chgData name="Gabrielle Goldberg" userId="S::gabrielle.goldberg@hofstra.edu::453f9b71-f7a4-4ef4-8e34-bbb69381dfc0" providerId="AD" clId="Web-{78A651E5-B4B1-CD51-59E4-6157343E148F}" dt="2021-07-23T17:47:07.098" v="292" actId="14100"/>
          <ac:picMkLst>
            <pc:docMk/>
            <pc:sldMk cId="765348557" sldId="404"/>
            <ac:picMk id="5" creationId="{F0F567F1-15EE-425C-810C-D60580C8B4A4}"/>
          </ac:picMkLst>
        </pc:picChg>
        <pc:cxnChg chg="add del">
          <ac:chgData name="Gabrielle Goldberg" userId="S::gabrielle.goldberg@hofstra.edu::453f9b71-f7a4-4ef4-8e34-bbb69381dfc0" providerId="AD" clId="Web-{78A651E5-B4B1-CD51-59E4-6157343E148F}" dt="2021-07-23T17:45:52.282" v="281"/>
          <ac:cxnSpMkLst>
            <pc:docMk/>
            <pc:sldMk cId="765348557" sldId="404"/>
            <ac:cxnSpMk id="14" creationId="{A7F400EE-A8A5-48AF-B4D6-291B52C6F0B0}"/>
          </ac:cxnSpMkLst>
        </pc:cxnChg>
        <pc:cxnChg chg="add del">
          <ac:chgData name="Gabrielle Goldberg" userId="S::gabrielle.goldberg@hofstra.edu::453f9b71-f7a4-4ef4-8e34-bbb69381dfc0" providerId="AD" clId="Web-{78A651E5-B4B1-CD51-59E4-6157343E148F}" dt="2021-07-23T17:45:17.093" v="275"/>
          <ac:cxnSpMkLst>
            <pc:docMk/>
            <pc:sldMk cId="765348557" sldId="404"/>
            <ac:cxnSpMk id="17" creationId="{A7F400EE-A8A5-48AF-B4D6-291B52C6F0B0}"/>
          </ac:cxnSpMkLst>
        </pc:cxnChg>
        <pc:cxnChg chg="add del">
          <ac:chgData name="Gabrielle Goldberg" userId="S::gabrielle.goldberg@hofstra.edu::453f9b71-f7a4-4ef4-8e34-bbb69381dfc0" providerId="AD" clId="Web-{78A651E5-B4B1-CD51-59E4-6157343E148F}" dt="2021-07-23T17:47:00.598" v="291"/>
          <ac:cxnSpMkLst>
            <pc:docMk/>
            <pc:sldMk cId="765348557" sldId="404"/>
            <ac:cxnSpMk id="19" creationId="{A7F400EE-A8A5-48AF-B4D6-291B52C6F0B0}"/>
          </ac:cxnSpMkLst>
        </pc:cxnChg>
        <pc:cxnChg chg="add">
          <ac:chgData name="Gabrielle Goldberg" userId="S::gabrielle.goldberg@hofstra.edu::453f9b71-f7a4-4ef4-8e34-bbb69381dfc0" providerId="AD" clId="Web-{78A651E5-B4B1-CD51-59E4-6157343E148F}" dt="2021-07-23T17:47:00.598" v="291"/>
          <ac:cxnSpMkLst>
            <pc:docMk/>
            <pc:sldMk cId="765348557" sldId="404"/>
            <ac:cxnSpMk id="24" creationId="{A7F400EE-A8A5-48AF-B4D6-291B52C6F0B0}"/>
          </ac:cxnSpMkLst>
        </pc:cxnChg>
      </pc:sldChg>
      <pc:sldChg chg="addSp delSp">
        <pc:chgData name="Gabrielle Goldberg" userId="S::gabrielle.goldberg@hofstra.edu::453f9b71-f7a4-4ef4-8e34-bbb69381dfc0" providerId="AD" clId="Web-{78A651E5-B4B1-CD51-59E4-6157343E148F}" dt="2021-07-23T17:22:57.741" v="1"/>
        <pc:sldMkLst>
          <pc:docMk/>
          <pc:sldMk cId="2623007478" sldId="405"/>
        </pc:sldMkLst>
        <pc:spChg chg="del">
          <ac:chgData name="Gabrielle Goldberg" userId="S::gabrielle.goldberg@hofstra.edu::453f9b71-f7a4-4ef4-8e34-bbb69381dfc0" providerId="AD" clId="Web-{78A651E5-B4B1-CD51-59E4-6157343E148F}" dt="2021-07-23T17:22:57.741" v="1"/>
          <ac:spMkLst>
            <pc:docMk/>
            <pc:sldMk cId="2623007478" sldId="405"/>
            <ac:spMk id="3" creationId="{9A392957-BD48-49DE-8599-0E44A1AE6D05}"/>
          </ac:spMkLst>
        </pc:spChg>
        <pc:graphicFrameChg chg="add">
          <ac:chgData name="Gabrielle Goldberg" userId="S::gabrielle.goldberg@hofstra.edu::453f9b71-f7a4-4ef4-8e34-bbb69381dfc0" providerId="AD" clId="Web-{78A651E5-B4B1-CD51-59E4-6157343E148F}" dt="2021-07-23T17:22:57.741" v="1"/>
          <ac:graphicFrameMkLst>
            <pc:docMk/>
            <pc:sldMk cId="2623007478" sldId="405"/>
            <ac:graphicFrameMk id="5" creationId="{FB2B1999-E146-48D9-993B-7224F4B2C90C}"/>
          </ac:graphicFrameMkLst>
        </pc:graphicFrameChg>
      </pc:sldChg>
      <pc:sldChg chg="addSp delSp modSp mod setBg">
        <pc:chgData name="Gabrielle Goldberg" userId="S::gabrielle.goldberg@hofstra.edu::453f9b71-f7a4-4ef4-8e34-bbb69381dfc0" providerId="AD" clId="Web-{78A651E5-B4B1-CD51-59E4-6157343E148F}" dt="2021-07-23T17:27:39.690" v="51"/>
        <pc:sldMkLst>
          <pc:docMk/>
          <pc:sldMk cId="3380947776" sldId="406"/>
        </pc:sldMkLst>
        <pc:spChg chg="mod">
          <ac:chgData name="Gabrielle Goldberg" userId="S::gabrielle.goldberg@hofstra.edu::453f9b71-f7a4-4ef4-8e34-bbb69381dfc0" providerId="AD" clId="Web-{78A651E5-B4B1-CD51-59E4-6157343E148F}" dt="2021-07-23T17:27:39.690" v="51"/>
          <ac:spMkLst>
            <pc:docMk/>
            <pc:sldMk cId="3380947776" sldId="406"/>
            <ac:spMk id="2" creationId="{47780179-0182-4210-AB55-A1699228033C}"/>
          </ac:spMkLst>
        </pc:spChg>
        <pc:spChg chg="del">
          <ac:chgData name="Gabrielle Goldberg" userId="S::gabrielle.goldberg@hofstra.edu::453f9b71-f7a4-4ef4-8e34-bbb69381dfc0" providerId="AD" clId="Web-{78A651E5-B4B1-CD51-59E4-6157343E148F}" dt="2021-07-23T17:27:39.690" v="51"/>
          <ac:spMkLst>
            <pc:docMk/>
            <pc:sldMk cId="3380947776" sldId="406"/>
            <ac:spMk id="3" creationId="{9A392957-BD48-49DE-8599-0E44A1AE6D05}"/>
          </ac:spMkLst>
        </pc:spChg>
        <pc:graphicFrameChg chg="add">
          <ac:chgData name="Gabrielle Goldberg" userId="S::gabrielle.goldberg@hofstra.edu::453f9b71-f7a4-4ef4-8e34-bbb69381dfc0" providerId="AD" clId="Web-{78A651E5-B4B1-CD51-59E4-6157343E148F}" dt="2021-07-23T17:27:39.690" v="51"/>
          <ac:graphicFrameMkLst>
            <pc:docMk/>
            <pc:sldMk cId="3380947776" sldId="406"/>
            <ac:graphicFrameMk id="5" creationId="{DD58BD53-D491-4E27-8E29-0A4691C5DA68}"/>
          </ac:graphicFrameMkLst>
        </pc:graphicFrameChg>
      </pc:sldChg>
      <pc:sldChg chg="addSp delSp modSp mod setBg">
        <pc:chgData name="Gabrielle Goldberg" userId="S::gabrielle.goldberg@hofstra.edu::453f9b71-f7a4-4ef4-8e34-bbb69381dfc0" providerId="AD" clId="Web-{78A651E5-B4B1-CD51-59E4-6157343E148F}" dt="2021-07-23T17:35:02.677" v="209" actId="1076"/>
        <pc:sldMkLst>
          <pc:docMk/>
          <pc:sldMk cId="1455224235" sldId="407"/>
        </pc:sldMkLst>
        <pc:spChg chg="mod">
          <ac:chgData name="Gabrielle Goldberg" userId="S::gabrielle.goldberg@hofstra.edu::453f9b71-f7a4-4ef4-8e34-bbb69381dfc0" providerId="AD" clId="Web-{78A651E5-B4B1-CD51-59E4-6157343E148F}" dt="2021-07-23T17:34:19.207" v="191" actId="20577"/>
          <ac:spMkLst>
            <pc:docMk/>
            <pc:sldMk cId="1455224235" sldId="407"/>
            <ac:spMk id="2" creationId="{47780179-0182-4210-AB55-A1699228033C}"/>
          </ac:spMkLst>
        </pc:spChg>
        <pc:spChg chg="del mod">
          <ac:chgData name="Gabrielle Goldberg" userId="S::gabrielle.goldberg@hofstra.edu::453f9b71-f7a4-4ef4-8e34-bbb69381dfc0" providerId="AD" clId="Web-{78A651E5-B4B1-CD51-59E4-6157343E148F}" dt="2021-07-23T17:33:20.267" v="168"/>
          <ac:spMkLst>
            <pc:docMk/>
            <pc:sldMk cId="1455224235" sldId="407"/>
            <ac:spMk id="3" creationId="{9A392957-BD48-49DE-8599-0E44A1AE6D05}"/>
          </ac:spMkLst>
        </pc:spChg>
        <pc:spChg chg="add mod">
          <ac:chgData name="Gabrielle Goldberg" userId="S::gabrielle.goldberg@hofstra.edu::453f9b71-f7a4-4ef4-8e34-bbb69381dfc0" providerId="AD" clId="Web-{78A651E5-B4B1-CD51-59E4-6157343E148F}" dt="2021-07-23T17:35:02.677" v="209" actId="1076"/>
          <ac:spMkLst>
            <pc:docMk/>
            <pc:sldMk cId="1455224235" sldId="407"/>
            <ac:spMk id="174" creationId="{EE82F5CD-5D44-44C5-99D2-7F62A3C64B55}"/>
          </ac:spMkLst>
        </pc:spChg>
        <pc:graphicFrameChg chg="add mod modGraphic">
          <ac:chgData name="Gabrielle Goldberg" userId="S::gabrielle.goldberg@hofstra.edu::453f9b71-f7a4-4ef4-8e34-bbb69381dfc0" providerId="AD" clId="Web-{78A651E5-B4B1-CD51-59E4-6157343E148F}" dt="2021-07-23T17:34:58.771" v="208" actId="1076"/>
          <ac:graphicFrameMkLst>
            <pc:docMk/>
            <pc:sldMk cId="1455224235" sldId="407"/>
            <ac:graphicFrameMk id="5" creationId="{0ADEBD4D-C405-418D-A69A-EFB34A29C241}"/>
          </ac:graphicFrameMkLst>
        </pc:graphicFrameChg>
      </pc:sldChg>
      <pc:sldChg chg="modSp add del replId">
        <pc:chgData name="Gabrielle Goldberg" userId="S::gabrielle.goldberg@hofstra.edu::453f9b71-f7a4-4ef4-8e34-bbb69381dfc0" providerId="AD" clId="Web-{78A651E5-B4B1-CD51-59E4-6157343E148F}" dt="2021-07-23T17:33:24.314" v="169"/>
        <pc:sldMkLst>
          <pc:docMk/>
          <pc:sldMk cId="1809120222" sldId="408"/>
        </pc:sldMkLst>
        <pc:spChg chg="mod">
          <ac:chgData name="Gabrielle Goldberg" userId="S::gabrielle.goldberg@hofstra.edu::453f9b71-f7a4-4ef4-8e34-bbb69381dfc0" providerId="AD" clId="Web-{78A651E5-B4B1-CD51-59E4-6157343E148F}" dt="2021-07-23T17:32:48.250" v="163" actId="20577"/>
          <ac:spMkLst>
            <pc:docMk/>
            <pc:sldMk cId="1809120222" sldId="408"/>
            <ac:spMk id="2" creationId="{47780179-0182-4210-AB55-A1699228033C}"/>
          </ac:spMkLst>
        </pc:spChg>
      </pc:sldChg>
    </pc:docChg>
  </pc:docChgLst>
  <pc:docChgLst>
    <pc:chgData name="Gabrielle Goldberg" userId="S::gabrielle.goldberg@hofstra.edu::453f9b71-f7a4-4ef4-8e34-bbb69381dfc0" providerId="AD" clId="Web-{0CFDDC16-2F90-7817-56FF-27F32BEA1A63}"/>
    <pc:docChg chg="modSld">
      <pc:chgData name="Gabrielle Goldberg" userId="S::gabrielle.goldberg@hofstra.edu::453f9b71-f7a4-4ef4-8e34-bbb69381dfc0" providerId="AD" clId="Web-{0CFDDC16-2F90-7817-56FF-27F32BEA1A63}" dt="2022-04-01T16:51:04.617" v="52" actId="20577"/>
      <pc:docMkLst>
        <pc:docMk/>
      </pc:docMkLst>
      <pc:sldChg chg="modSp">
        <pc:chgData name="Gabrielle Goldberg" userId="S::gabrielle.goldberg@hofstra.edu::453f9b71-f7a4-4ef4-8e34-bbb69381dfc0" providerId="AD" clId="Web-{0CFDDC16-2F90-7817-56FF-27F32BEA1A63}" dt="2022-04-01T16:51:04.617" v="52" actId="20577"/>
        <pc:sldMkLst>
          <pc:docMk/>
          <pc:sldMk cId="3150183129" sldId="379"/>
        </pc:sldMkLst>
        <pc:graphicFrameChg chg="modGraphic">
          <ac:chgData name="Gabrielle Goldberg" userId="S::gabrielle.goldberg@hofstra.edu::453f9b71-f7a4-4ef4-8e34-bbb69381dfc0" providerId="AD" clId="Web-{0CFDDC16-2F90-7817-56FF-27F32BEA1A63}" dt="2022-04-01T16:51:04.617" v="52" actId="20577"/>
          <ac:graphicFrameMkLst>
            <pc:docMk/>
            <pc:sldMk cId="3150183129" sldId="379"/>
            <ac:graphicFrameMk id="4" creationId="{C1FFCE84-EBCA-4D7F-9C21-DF600EF51E09}"/>
          </ac:graphicFrameMkLst>
        </pc:graphicFrameChg>
      </pc:sldChg>
      <pc:sldChg chg="modSp">
        <pc:chgData name="Gabrielle Goldberg" userId="S::gabrielle.goldberg@hofstra.edu::453f9b71-f7a4-4ef4-8e34-bbb69381dfc0" providerId="AD" clId="Web-{0CFDDC16-2F90-7817-56FF-27F32BEA1A63}" dt="2022-03-31T15:37:15.186" v="2" actId="20577"/>
        <pc:sldMkLst>
          <pc:docMk/>
          <pc:sldMk cId="3071954687" sldId="382"/>
        </pc:sldMkLst>
        <pc:spChg chg="mod">
          <ac:chgData name="Gabrielle Goldberg" userId="S::gabrielle.goldberg@hofstra.edu::453f9b71-f7a4-4ef4-8e34-bbb69381dfc0" providerId="AD" clId="Web-{0CFDDC16-2F90-7817-56FF-27F32BEA1A63}" dt="2022-03-31T15:37:15.186" v="2" actId="20577"/>
          <ac:spMkLst>
            <pc:docMk/>
            <pc:sldMk cId="3071954687" sldId="382"/>
            <ac:spMk id="6" creationId="{00000000-0000-0000-0000-000000000000}"/>
          </ac:spMkLst>
        </pc:spChg>
      </pc:sldChg>
      <pc:sldChg chg="modSp">
        <pc:chgData name="Gabrielle Goldberg" userId="S::gabrielle.goldberg@hofstra.edu::453f9b71-f7a4-4ef4-8e34-bbb69381dfc0" providerId="AD" clId="Web-{0CFDDC16-2F90-7817-56FF-27F32BEA1A63}" dt="2022-03-31T15:37:44.702" v="5" actId="20577"/>
        <pc:sldMkLst>
          <pc:docMk/>
          <pc:sldMk cId="3711734020" sldId="386"/>
        </pc:sldMkLst>
        <pc:spChg chg="mod">
          <ac:chgData name="Gabrielle Goldberg" userId="S::gabrielle.goldberg@hofstra.edu::453f9b71-f7a4-4ef4-8e34-bbb69381dfc0" providerId="AD" clId="Web-{0CFDDC16-2F90-7817-56FF-27F32BEA1A63}" dt="2022-03-31T15:37:44.702" v="5" actId="20577"/>
          <ac:spMkLst>
            <pc:docMk/>
            <pc:sldMk cId="3711734020" sldId="386"/>
            <ac:spMk id="6" creationId="{00000000-0000-0000-0000-000000000000}"/>
          </ac:spMkLst>
        </pc:spChg>
      </pc:sldChg>
    </pc:docChg>
  </pc:docChgLst>
  <pc:docChgLst>
    <pc:chgData name="Guest User" userId="S::urn:spo:anon#4cf4838ef0fbf4d0dba1e40ac72942b61102bea1b1689e895975c57b98f5ef34::" providerId="AD" clId="Web-{E48879E2-9FA4-147E-0075-94BFBD57A781}"/>
    <pc:docChg chg="modSld">
      <pc:chgData name="Guest User" userId="S::urn:spo:anon#4cf4838ef0fbf4d0dba1e40ac72942b61102bea1b1689e895975c57b98f5ef34::" providerId="AD" clId="Web-{E48879E2-9FA4-147E-0075-94BFBD57A781}" dt="2022-01-04T17:45:53.386" v="10" actId="20577"/>
      <pc:docMkLst>
        <pc:docMk/>
      </pc:docMkLst>
      <pc:sldChg chg="modSp">
        <pc:chgData name="Guest User" userId="S::urn:spo:anon#4cf4838ef0fbf4d0dba1e40ac72942b61102bea1b1689e895975c57b98f5ef34::" providerId="AD" clId="Web-{E48879E2-9FA4-147E-0075-94BFBD57A781}" dt="2022-01-04T17:44:57.293" v="4" actId="20577"/>
        <pc:sldMkLst>
          <pc:docMk/>
          <pc:sldMk cId="659258882" sldId="316"/>
        </pc:sldMkLst>
        <pc:spChg chg="mod">
          <ac:chgData name="Guest User" userId="S::urn:spo:anon#4cf4838ef0fbf4d0dba1e40ac72942b61102bea1b1689e895975c57b98f5ef34::" providerId="AD" clId="Web-{E48879E2-9FA4-147E-0075-94BFBD57A781}" dt="2022-01-04T17:44:57.293" v="4" actId="20577"/>
          <ac:spMkLst>
            <pc:docMk/>
            <pc:sldMk cId="659258882" sldId="316"/>
            <ac:spMk id="4" creationId="{21C1E623-F543-4D3B-8E1A-B50D58553900}"/>
          </ac:spMkLst>
        </pc:spChg>
      </pc:sldChg>
      <pc:sldChg chg="modSp">
        <pc:chgData name="Guest User" userId="S::urn:spo:anon#4cf4838ef0fbf4d0dba1e40ac72942b61102bea1b1689e895975c57b98f5ef34::" providerId="AD" clId="Web-{E48879E2-9FA4-147E-0075-94BFBD57A781}" dt="2022-01-04T17:45:53.386" v="10" actId="20577"/>
        <pc:sldMkLst>
          <pc:docMk/>
          <pc:sldMk cId="3375007296" sldId="380"/>
        </pc:sldMkLst>
        <pc:spChg chg="mod">
          <ac:chgData name="Guest User" userId="S::urn:spo:anon#4cf4838ef0fbf4d0dba1e40ac72942b61102bea1b1689e895975c57b98f5ef34::" providerId="AD" clId="Web-{E48879E2-9FA4-147E-0075-94BFBD57A781}" dt="2022-01-04T17:45:53.386" v="10" actId="20577"/>
          <ac:spMkLst>
            <pc:docMk/>
            <pc:sldMk cId="3375007296" sldId="380"/>
            <ac:spMk id="3" creationId="{732813B5-3B16-4C39-9B26-980756C16563}"/>
          </ac:spMkLst>
        </pc:spChg>
      </pc:sldChg>
    </pc:docChg>
  </pc:docChgLst>
  <pc:docChgLst>
    <pc:chgData name="Gabrielle Goldberg" userId="S::gabrielle.goldberg@hofstra.edu::453f9b71-f7a4-4ef4-8e34-bbb69381dfc0" providerId="AD" clId="Web-{D0CAAC44-2942-2635-E26F-5D5844A6360B}"/>
    <pc:docChg chg="modSld">
      <pc:chgData name="Gabrielle Goldberg" userId="S::gabrielle.goldberg@hofstra.edu::453f9b71-f7a4-4ef4-8e34-bbb69381dfc0" providerId="AD" clId="Web-{D0CAAC44-2942-2635-E26F-5D5844A6360B}" dt="2022-03-30T12:06:03.846" v="245" actId="20577"/>
      <pc:docMkLst>
        <pc:docMk/>
      </pc:docMkLst>
      <pc:sldChg chg="modSp">
        <pc:chgData name="Gabrielle Goldberg" userId="S::gabrielle.goldberg@hofstra.edu::453f9b71-f7a4-4ef4-8e34-bbb69381dfc0" providerId="AD" clId="Web-{D0CAAC44-2942-2635-E26F-5D5844A6360B}" dt="2022-03-29T12:50:33.233" v="183" actId="20577"/>
        <pc:sldMkLst>
          <pc:docMk/>
          <pc:sldMk cId="3995300267" sldId="358"/>
        </pc:sldMkLst>
        <pc:spChg chg="mod">
          <ac:chgData name="Gabrielle Goldberg" userId="S::gabrielle.goldberg@hofstra.edu::453f9b71-f7a4-4ef4-8e34-bbb69381dfc0" providerId="AD" clId="Web-{D0CAAC44-2942-2635-E26F-5D5844A6360B}" dt="2022-03-29T12:50:33.233" v="183" actId="20577"/>
          <ac:spMkLst>
            <pc:docMk/>
            <pc:sldMk cId="3995300267" sldId="358"/>
            <ac:spMk id="3" creationId="{9A392957-BD48-49DE-8599-0E44A1AE6D05}"/>
          </ac:spMkLst>
        </pc:spChg>
        <pc:spChg chg="mod">
          <ac:chgData name="Gabrielle Goldberg" userId="S::gabrielle.goldberg@hofstra.edu::453f9b71-f7a4-4ef4-8e34-bbb69381dfc0" providerId="AD" clId="Web-{D0CAAC44-2942-2635-E26F-5D5844A6360B}" dt="2022-03-29T12:50:10.576" v="177" actId="1076"/>
          <ac:spMkLst>
            <pc:docMk/>
            <pc:sldMk cId="3995300267" sldId="358"/>
            <ac:spMk id="5" creationId="{B1141BC7-349B-4BD4-A9CA-AE55A6EE3D44}"/>
          </ac:spMkLst>
        </pc:spChg>
      </pc:sldChg>
      <pc:sldChg chg="modSp">
        <pc:chgData name="Gabrielle Goldberg" userId="S::gabrielle.goldberg@hofstra.edu::453f9b71-f7a4-4ef4-8e34-bbb69381dfc0" providerId="AD" clId="Web-{D0CAAC44-2942-2635-E26F-5D5844A6360B}" dt="2022-03-29T12:46:33.680" v="119" actId="20577"/>
        <pc:sldMkLst>
          <pc:docMk/>
          <pc:sldMk cId="956818366" sldId="362"/>
        </pc:sldMkLst>
        <pc:spChg chg="mod">
          <ac:chgData name="Gabrielle Goldberg" userId="S::gabrielle.goldberg@hofstra.edu::453f9b71-f7a4-4ef4-8e34-bbb69381dfc0" providerId="AD" clId="Web-{D0CAAC44-2942-2635-E26F-5D5844A6360B}" dt="2022-03-29T12:46:33.680" v="119" actId="20577"/>
          <ac:spMkLst>
            <pc:docMk/>
            <pc:sldMk cId="956818366" sldId="362"/>
            <ac:spMk id="3" creationId="{9A392957-BD48-49DE-8599-0E44A1AE6D05}"/>
          </ac:spMkLst>
        </pc:spChg>
        <pc:spChg chg="mod">
          <ac:chgData name="Gabrielle Goldberg" userId="S::gabrielle.goldberg@hofstra.edu::453f9b71-f7a4-4ef4-8e34-bbb69381dfc0" providerId="AD" clId="Web-{D0CAAC44-2942-2635-E26F-5D5844A6360B}" dt="2022-03-29T12:44:57.240" v="100" actId="1076"/>
          <ac:spMkLst>
            <pc:docMk/>
            <pc:sldMk cId="956818366" sldId="362"/>
            <ac:spMk id="5" creationId="{B1141BC7-349B-4BD4-A9CA-AE55A6EE3D44}"/>
          </ac:spMkLst>
        </pc:spChg>
      </pc:sldChg>
      <pc:sldChg chg="modSp">
        <pc:chgData name="Gabrielle Goldberg" userId="S::gabrielle.goldberg@hofstra.edu::453f9b71-f7a4-4ef4-8e34-bbb69381dfc0" providerId="AD" clId="Web-{D0CAAC44-2942-2635-E26F-5D5844A6360B}" dt="2022-03-29T12:52:59.768" v="217"/>
        <pc:sldMkLst>
          <pc:docMk/>
          <pc:sldMk cId="2418592727" sldId="373"/>
        </pc:sldMkLst>
        <pc:spChg chg="mod">
          <ac:chgData name="Gabrielle Goldberg" userId="S::gabrielle.goldberg@hofstra.edu::453f9b71-f7a4-4ef4-8e34-bbb69381dfc0" providerId="AD" clId="Web-{D0CAAC44-2942-2635-E26F-5D5844A6360B}" dt="2022-03-29T12:52:55.565" v="216"/>
          <ac:spMkLst>
            <pc:docMk/>
            <pc:sldMk cId="2418592727" sldId="373"/>
            <ac:spMk id="3" creationId="{AB26ACB8-94F9-48F1-AC83-F44DCA055732}"/>
          </ac:spMkLst>
        </pc:spChg>
        <pc:spChg chg="mod">
          <ac:chgData name="Gabrielle Goldberg" userId="S::gabrielle.goldberg@hofstra.edu::453f9b71-f7a4-4ef4-8e34-bbb69381dfc0" providerId="AD" clId="Web-{D0CAAC44-2942-2635-E26F-5D5844A6360B}" dt="2022-03-29T12:52:59.768" v="217"/>
          <ac:spMkLst>
            <pc:docMk/>
            <pc:sldMk cId="2418592727" sldId="373"/>
            <ac:spMk id="11" creationId="{089DD99E-0D17-4C5D-B955-09FF7808AF36}"/>
          </ac:spMkLst>
        </pc:spChg>
      </pc:sldChg>
      <pc:sldChg chg="modSp">
        <pc:chgData name="Gabrielle Goldberg" userId="S::gabrielle.goldberg@hofstra.edu::453f9b71-f7a4-4ef4-8e34-bbb69381dfc0" providerId="AD" clId="Web-{D0CAAC44-2942-2635-E26F-5D5844A6360B}" dt="2022-03-29T12:52:30.783" v="215"/>
        <pc:sldMkLst>
          <pc:docMk/>
          <pc:sldMk cId="3071954687" sldId="382"/>
        </pc:sldMkLst>
        <pc:spChg chg="mod">
          <ac:chgData name="Gabrielle Goldberg" userId="S::gabrielle.goldberg@hofstra.edu::453f9b71-f7a4-4ef4-8e34-bbb69381dfc0" providerId="AD" clId="Web-{D0CAAC44-2942-2635-E26F-5D5844A6360B}" dt="2022-03-29T12:52:30.783" v="215"/>
          <ac:spMkLst>
            <pc:docMk/>
            <pc:sldMk cId="3071954687" sldId="382"/>
            <ac:spMk id="6" creationId="{00000000-0000-0000-0000-000000000000}"/>
          </ac:spMkLst>
        </pc:spChg>
      </pc:sldChg>
      <pc:sldChg chg="modSp">
        <pc:chgData name="Gabrielle Goldberg" userId="S::gabrielle.goldberg@hofstra.edu::453f9b71-f7a4-4ef4-8e34-bbb69381dfc0" providerId="AD" clId="Web-{D0CAAC44-2942-2635-E26F-5D5844A6360B}" dt="2022-03-29T12:40:46.468" v="20" actId="1076"/>
        <pc:sldMkLst>
          <pc:docMk/>
          <pc:sldMk cId="3711734020" sldId="386"/>
        </pc:sldMkLst>
        <pc:spChg chg="mod">
          <ac:chgData name="Gabrielle Goldberg" userId="S::gabrielle.goldberg@hofstra.edu::453f9b71-f7a4-4ef4-8e34-bbb69381dfc0" providerId="AD" clId="Web-{D0CAAC44-2942-2635-E26F-5D5844A6360B}" dt="2022-03-29T12:40:46.468" v="20" actId="1076"/>
          <ac:spMkLst>
            <pc:docMk/>
            <pc:sldMk cId="3711734020" sldId="386"/>
            <ac:spMk id="3" creationId="{7E531B93-120A-4961-AF55-8A03F7FC04F5}"/>
          </ac:spMkLst>
        </pc:spChg>
        <pc:spChg chg="mod">
          <ac:chgData name="Gabrielle Goldberg" userId="S::gabrielle.goldberg@hofstra.edu::453f9b71-f7a4-4ef4-8e34-bbb69381dfc0" providerId="AD" clId="Web-{D0CAAC44-2942-2635-E26F-5D5844A6360B}" dt="2022-03-29T12:40:34.155" v="19" actId="20577"/>
          <ac:spMkLst>
            <pc:docMk/>
            <pc:sldMk cId="3711734020" sldId="386"/>
            <ac:spMk id="6" creationId="{00000000-0000-0000-0000-000000000000}"/>
          </ac:spMkLst>
        </pc:spChg>
      </pc:sldChg>
      <pc:sldChg chg="modSp">
        <pc:chgData name="Gabrielle Goldberg" userId="S::gabrielle.goldberg@hofstra.edu::453f9b71-f7a4-4ef4-8e34-bbb69381dfc0" providerId="AD" clId="Web-{D0CAAC44-2942-2635-E26F-5D5844A6360B}" dt="2022-03-29T12:51:07.640" v="202" actId="20577"/>
        <pc:sldMkLst>
          <pc:docMk/>
          <pc:sldMk cId="1104129155" sldId="390"/>
        </pc:sldMkLst>
        <pc:spChg chg="mod">
          <ac:chgData name="Gabrielle Goldberg" userId="S::gabrielle.goldberg@hofstra.edu::453f9b71-f7a4-4ef4-8e34-bbb69381dfc0" providerId="AD" clId="Web-{D0CAAC44-2942-2635-E26F-5D5844A6360B}" dt="2022-03-29T12:51:07.640" v="202" actId="20577"/>
          <ac:spMkLst>
            <pc:docMk/>
            <pc:sldMk cId="1104129155" sldId="390"/>
            <ac:spMk id="6" creationId="{00000000-0000-0000-0000-000000000000}"/>
          </ac:spMkLst>
        </pc:spChg>
      </pc:sldChg>
      <pc:sldChg chg="modSp">
        <pc:chgData name="Gabrielle Goldberg" userId="S::gabrielle.goldberg@hofstra.edu::453f9b71-f7a4-4ef4-8e34-bbb69381dfc0" providerId="AD" clId="Web-{D0CAAC44-2942-2635-E26F-5D5844A6360B}" dt="2022-03-29T12:54:33.849" v="237" actId="1076"/>
        <pc:sldMkLst>
          <pc:docMk/>
          <pc:sldMk cId="2028606082" sldId="393"/>
        </pc:sldMkLst>
        <pc:spChg chg="mod">
          <ac:chgData name="Gabrielle Goldberg" userId="S::gabrielle.goldberg@hofstra.edu::453f9b71-f7a4-4ef4-8e34-bbb69381dfc0" providerId="AD" clId="Web-{D0CAAC44-2942-2635-E26F-5D5844A6360B}" dt="2022-03-29T12:54:28.114" v="235" actId="20577"/>
          <ac:spMkLst>
            <pc:docMk/>
            <pc:sldMk cId="2028606082" sldId="393"/>
            <ac:spMk id="6" creationId="{00000000-0000-0000-0000-000000000000}"/>
          </ac:spMkLst>
        </pc:spChg>
        <pc:cxnChg chg="mod">
          <ac:chgData name="Gabrielle Goldberg" userId="S::gabrielle.goldberg@hofstra.edu::453f9b71-f7a4-4ef4-8e34-bbb69381dfc0" providerId="AD" clId="Web-{D0CAAC44-2942-2635-E26F-5D5844A6360B}" dt="2022-03-29T12:54:33.849" v="237" actId="1076"/>
          <ac:cxnSpMkLst>
            <pc:docMk/>
            <pc:sldMk cId="2028606082" sldId="393"/>
            <ac:cxnSpMk id="3" creationId="{50D20C01-B162-4BB1-9410-4384BA49EF18}"/>
          </ac:cxnSpMkLst>
        </pc:cxnChg>
        <pc:cxnChg chg="mod">
          <ac:chgData name="Gabrielle Goldberg" userId="S::gabrielle.goldberg@hofstra.edu::453f9b71-f7a4-4ef4-8e34-bbb69381dfc0" providerId="AD" clId="Web-{D0CAAC44-2942-2635-E26F-5D5844A6360B}" dt="2022-03-29T12:53:57.660" v="229" actId="1076"/>
          <ac:cxnSpMkLst>
            <pc:docMk/>
            <pc:sldMk cId="2028606082" sldId="393"/>
            <ac:cxnSpMk id="5" creationId="{A3B1B14B-3E1F-484D-A15D-FF88316AF03C}"/>
          </ac:cxnSpMkLst>
        </pc:cxnChg>
        <pc:cxnChg chg="mod">
          <ac:chgData name="Gabrielle Goldberg" userId="S::gabrielle.goldberg@hofstra.edu::453f9b71-f7a4-4ef4-8e34-bbb69381dfc0" providerId="AD" clId="Web-{D0CAAC44-2942-2635-E26F-5D5844A6360B}" dt="2022-03-29T12:54:03.223" v="230" actId="1076"/>
          <ac:cxnSpMkLst>
            <pc:docMk/>
            <pc:sldMk cId="2028606082" sldId="393"/>
            <ac:cxnSpMk id="7" creationId="{F3F43E86-CED6-4534-B585-4256BFDCB905}"/>
          </ac:cxnSpMkLst>
        </pc:cxnChg>
        <pc:cxnChg chg="mod">
          <ac:chgData name="Gabrielle Goldberg" userId="S::gabrielle.goldberg@hofstra.edu::453f9b71-f7a4-4ef4-8e34-bbb69381dfc0" providerId="AD" clId="Web-{D0CAAC44-2942-2635-E26F-5D5844A6360B}" dt="2022-03-29T12:53:46.722" v="227" actId="1076"/>
          <ac:cxnSpMkLst>
            <pc:docMk/>
            <pc:sldMk cId="2028606082" sldId="393"/>
            <ac:cxnSpMk id="8" creationId="{38AFD662-4CE6-4E58-B479-7342D3F5DF1D}"/>
          </ac:cxnSpMkLst>
        </pc:cxnChg>
        <pc:cxnChg chg="mod">
          <ac:chgData name="Gabrielle Goldberg" userId="S::gabrielle.goldberg@hofstra.edu::453f9b71-f7a4-4ef4-8e34-bbb69381dfc0" providerId="AD" clId="Web-{D0CAAC44-2942-2635-E26F-5D5844A6360B}" dt="2022-03-29T12:53:51.894" v="228" actId="1076"/>
          <ac:cxnSpMkLst>
            <pc:docMk/>
            <pc:sldMk cId="2028606082" sldId="393"/>
            <ac:cxnSpMk id="11" creationId="{0875CED3-5085-49C6-9ECD-F750A56F5CC8}"/>
          </ac:cxnSpMkLst>
        </pc:cxnChg>
      </pc:sldChg>
      <pc:sldChg chg="modSp">
        <pc:chgData name="Gabrielle Goldberg" userId="S::gabrielle.goldberg@hofstra.edu::453f9b71-f7a4-4ef4-8e34-bbb69381dfc0" providerId="AD" clId="Web-{D0CAAC44-2942-2635-E26F-5D5844A6360B}" dt="2022-03-29T12:51:47.266" v="212" actId="1076"/>
        <pc:sldMkLst>
          <pc:docMk/>
          <pc:sldMk cId="3470372529" sldId="395"/>
        </pc:sldMkLst>
        <pc:spChg chg="mod">
          <ac:chgData name="Gabrielle Goldberg" userId="S::gabrielle.goldberg@hofstra.edu::453f9b71-f7a4-4ef4-8e34-bbb69381dfc0" providerId="AD" clId="Web-{D0CAAC44-2942-2635-E26F-5D5844A6360B}" dt="2022-03-29T12:51:47.266" v="212" actId="1076"/>
          <ac:spMkLst>
            <pc:docMk/>
            <pc:sldMk cId="3470372529" sldId="395"/>
            <ac:spMk id="3" creationId="{9A392957-BD48-49DE-8599-0E44A1AE6D05}"/>
          </ac:spMkLst>
        </pc:spChg>
      </pc:sldChg>
      <pc:sldChg chg="modSp">
        <pc:chgData name="Gabrielle Goldberg" userId="S::gabrielle.goldberg@hofstra.edu::453f9b71-f7a4-4ef4-8e34-bbb69381dfc0" providerId="AD" clId="Web-{D0CAAC44-2942-2635-E26F-5D5844A6360B}" dt="2022-03-30T12:06:03.846" v="245" actId="20577"/>
        <pc:sldMkLst>
          <pc:docMk/>
          <pc:sldMk cId="32438913" sldId="401"/>
        </pc:sldMkLst>
        <pc:spChg chg="mod">
          <ac:chgData name="Gabrielle Goldberg" userId="S::gabrielle.goldberg@hofstra.edu::453f9b71-f7a4-4ef4-8e34-bbb69381dfc0" providerId="AD" clId="Web-{D0CAAC44-2942-2635-E26F-5D5844A6360B}" dt="2022-03-30T12:06:03.846" v="245" actId="20577"/>
          <ac:spMkLst>
            <pc:docMk/>
            <pc:sldMk cId="32438913" sldId="401"/>
            <ac:spMk id="3" creationId="{9A392957-BD48-49DE-8599-0E44A1AE6D05}"/>
          </ac:spMkLst>
        </pc:spChg>
      </pc:sldChg>
      <pc:sldChg chg="modSp">
        <pc:chgData name="Gabrielle Goldberg" userId="S::gabrielle.goldberg@hofstra.edu::453f9b71-f7a4-4ef4-8e34-bbb69381dfc0" providerId="AD" clId="Web-{D0CAAC44-2942-2635-E26F-5D5844A6360B}" dt="2022-03-29T12:55:55.710" v="240" actId="20577"/>
        <pc:sldMkLst>
          <pc:docMk/>
          <pc:sldMk cId="1455224235" sldId="407"/>
        </pc:sldMkLst>
        <pc:spChg chg="mod">
          <ac:chgData name="Gabrielle Goldberg" userId="S::gabrielle.goldberg@hofstra.edu::453f9b71-f7a4-4ef4-8e34-bbb69381dfc0" providerId="AD" clId="Web-{D0CAAC44-2942-2635-E26F-5D5844A6360B}" dt="2022-03-29T12:55:46.929" v="238" actId="20577"/>
          <ac:spMkLst>
            <pc:docMk/>
            <pc:sldMk cId="1455224235" sldId="407"/>
            <ac:spMk id="174" creationId="{EE82F5CD-5D44-44C5-99D2-7F62A3C64B55}"/>
          </ac:spMkLst>
        </pc:spChg>
        <pc:graphicFrameChg chg="modGraphic">
          <ac:chgData name="Gabrielle Goldberg" userId="S::gabrielle.goldberg@hofstra.edu::453f9b71-f7a4-4ef4-8e34-bbb69381dfc0" providerId="AD" clId="Web-{D0CAAC44-2942-2635-E26F-5D5844A6360B}" dt="2022-03-29T12:55:55.710" v="240" actId="20577"/>
          <ac:graphicFrameMkLst>
            <pc:docMk/>
            <pc:sldMk cId="1455224235" sldId="407"/>
            <ac:graphicFrameMk id="5" creationId="{0ADEBD4D-C405-418D-A69A-EFB34A29C241}"/>
          </ac:graphicFrameMkLst>
        </pc:graphicFrameChg>
      </pc:sldChg>
    </pc:docChg>
  </pc:docChgLst>
  <pc:docChgLst>
    <pc:chgData name="Gabrielle Goldberg" userId="S::gabrielle.goldberg@hofstra.edu::453f9b71-f7a4-4ef4-8e34-bbb69381dfc0" providerId="AD" clId="Web-{2B853225-C1B8-7DB8-DFB2-C7385CA22B0E}"/>
    <pc:docChg chg="modSld">
      <pc:chgData name="Gabrielle Goldberg" userId="S::gabrielle.goldberg@hofstra.edu::453f9b71-f7a4-4ef4-8e34-bbb69381dfc0" providerId="AD" clId="Web-{2B853225-C1B8-7DB8-DFB2-C7385CA22B0E}" dt="2021-05-11T15:54:50.659" v="0" actId="20577"/>
      <pc:docMkLst>
        <pc:docMk/>
      </pc:docMkLst>
      <pc:sldChg chg="modSp">
        <pc:chgData name="Gabrielle Goldberg" userId="S::gabrielle.goldberg@hofstra.edu::453f9b71-f7a4-4ef4-8e34-bbb69381dfc0" providerId="AD" clId="Web-{2B853225-C1B8-7DB8-DFB2-C7385CA22B0E}" dt="2021-05-11T15:54:50.659" v="0" actId="20577"/>
        <pc:sldMkLst>
          <pc:docMk/>
          <pc:sldMk cId="2655814267" sldId="280"/>
        </pc:sldMkLst>
        <pc:spChg chg="mod">
          <ac:chgData name="Gabrielle Goldberg" userId="S::gabrielle.goldberg@hofstra.edu::453f9b71-f7a4-4ef4-8e34-bbb69381dfc0" providerId="AD" clId="Web-{2B853225-C1B8-7DB8-DFB2-C7385CA22B0E}" dt="2021-05-11T15:54:50.659" v="0" actId="20577"/>
          <ac:spMkLst>
            <pc:docMk/>
            <pc:sldMk cId="2655814267" sldId="280"/>
            <ac:spMk id="2" creationId="{00000000-0000-0000-0000-000000000000}"/>
          </ac:spMkLst>
        </pc:spChg>
      </pc:sldChg>
    </pc:docChg>
  </pc:docChgLst>
  <pc:docChgLst>
    <pc:chgData name="Gabrielle Goldberg" userId="S::gabrielle.goldberg@hofstra.edu::453f9b71-f7a4-4ef4-8e34-bbb69381dfc0" providerId="AD" clId="Web-{F120F07A-6C65-656D-DAD1-40597E6BE0B0}"/>
    <pc:docChg chg="addSld delSld">
      <pc:chgData name="Gabrielle Goldberg" userId="S::gabrielle.goldberg@hofstra.edu::453f9b71-f7a4-4ef4-8e34-bbb69381dfc0" providerId="AD" clId="Web-{F120F07A-6C65-656D-DAD1-40597E6BE0B0}" dt="2021-07-27T19:53:07.918" v="5"/>
      <pc:docMkLst>
        <pc:docMk/>
      </pc:docMkLst>
      <pc:sldChg chg="add del">
        <pc:chgData name="Gabrielle Goldberg" userId="S::gabrielle.goldberg@hofstra.edu::453f9b71-f7a4-4ef4-8e34-bbb69381dfc0" providerId="AD" clId="Web-{F120F07A-6C65-656D-DAD1-40597E6BE0B0}" dt="2021-07-27T19:53:07.918" v="5"/>
        <pc:sldMkLst>
          <pc:docMk/>
          <pc:sldMk cId="3046613134" sldId="383"/>
        </pc:sldMkLst>
      </pc:sldChg>
      <pc:sldChg chg="add replId">
        <pc:chgData name="Gabrielle Goldberg" userId="S::gabrielle.goldberg@hofstra.edu::453f9b71-f7a4-4ef4-8e34-bbb69381dfc0" providerId="AD" clId="Web-{F120F07A-6C65-656D-DAD1-40597E6BE0B0}" dt="2021-07-27T19:52:22.712" v="2"/>
        <pc:sldMkLst>
          <pc:docMk/>
          <pc:sldMk cId="819918547" sldId="408"/>
        </pc:sldMkLst>
      </pc:sldChg>
      <pc:sldChg chg="new del">
        <pc:chgData name="Gabrielle Goldberg" userId="S::gabrielle.goldberg@hofstra.edu::453f9b71-f7a4-4ef4-8e34-bbb69381dfc0" providerId="AD" clId="Web-{F120F07A-6C65-656D-DAD1-40597E6BE0B0}" dt="2021-07-27T19:52:44.417" v="4"/>
        <pc:sldMkLst>
          <pc:docMk/>
          <pc:sldMk cId="915248709" sldId="409"/>
        </pc:sldMkLst>
      </pc:sldChg>
    </pc:docChg>
  </pc:docChgLst>
  <pc:docChgLst>
    <pc:chgData name="dra.gabrielasolis@gmail.com" userId="S::urn:spo:guest#dra.gabrielasolis@gmail.com::" providerId="AD" clId="Web-{45224825-C9EE-E9F4-84B4-0E973000F4E8}"/>
    <pc:docChg chg="modSld">
      <pc:chgData name="dra.gabrielasolis@gmail.com" userId="S::urn:spo:guest#dra.gabrielasolis@gmail.com::" providerId="AD" clId="Web-{45224825-C9EE-E9F4-84B4-0E973000F4E8}" dt="2021-10-10T14:57:34.474" v="109" actId="20577"/>
      <pc:docMkLst>
        <pc:docMk/>
      </pc:docMkLst>
      <pc:sldChg chg="addSp delSp modSp">
        <pc:chgData name="dra.gabrielasolis@gmail.com" userId="S::urn:spo:guest#dra.gabrielasolis@gmail.com::" providerId="AD" clId="Web-{45224825-C9EE-E9F4-84B4-0E973000F4E8}" dt="2021-10-10T14:57:28.739" v="107" actId="20577"/>
        <pc:sldMkLst>
          <pc:docMk/>
          <pc:sldMk cId="659258882" sldId="316"/>
        </pc:sldMkLst>
        <pc:spChg chg="del">
          <ac:chgData name="dra.gabrielasolis@gmail.com" userId="S::urn:spo:guest#dra.gabrielasolis@gmail.com::" providerId="AD" clId="Web-{45224825-C9EE-E9F4-84B4-0E973000F4E8}" dt="2021-10-10T14:43:11.757" v="0"/>
          <ac:spMkLst>
            <pc:docMk/>
            <pc:sldMk cId="659258882" sldId="316"/>
            <ac:spMk id="3" creationId="{D96639EA-5FFF-401B-9EEE-47DDDC48ADCC}"/>
          </ac:spMkLst>
        </pc:spChg>
        <pc:spChg chg="add mod">
          <ac:chgData name="dra.gabrielasolis@gmail.com" userId="S::urn:spo:guest#dra.gabrielasolis@gmail.com::" providerId="AD" clId="Web-{45224825-C9EE-E9F4-84B4-0E973000F4E8}" dt="2021-10-10T14:57:28.739" v="107" actId="20577"/>
          <ac:spMkLst>
            <pc:docMk/>
            <pc:sldMk cId="659258882" sldId="316"/>
            <ac:spMk id="4" creationId="{21C1E623-F543-4D3B-8E1A-B50D58553900}"/>
          </ac:spMkLst>
        </pc:spChg>
      </pc:sldChg>
      <pc:sldChg chg="addSp modSp">
        <pc:chgData name="dra.gabrielasolis@gmail.com" userId="S::urn:spo:guest#dra.gabrielasolis@gmail.com::" providerId="AD" clId="Web-{45224825-C9EE-E9F4-84B4-0E973000F4E8}" dt="2021-10-10T14:57:34.474" v="109" actId="20577"/>
        <pc:sldMkLst>
          <pc:docMk/>
          <pc:sldMk cId="3375007296" sldId="380"/>
        </pc:sldMkLst>
        <pc:spChg chg="mod">
          <ac:chgData name="dra.gabrielasolis@gmail.com" userId="S::urn:spo:guest#dra.gabrielasolis@gmail.com::" providerId="AD" clId="Web-{45224825-C9EE-E9F4-84B4-0E973000F4E8}" dt="2021-10-10T14:54:42.084" v="68" actId="1076"/>
          <ac:spMkLst>
            <pc:docMk/>
            <pc:sldMk cId="3375007296" sldId="380"/>
            <ac:spMk id="2" creationId="{00000000-0000-0000-0000-000000000000}"/>
          </ac:spMkLst>
        </pc:spChg>
        <pc:spChg chg="add mod">
          <ac:chgData name="dra.gabrielasolis@gmail.com" userId="S::urn:spo:guest#dra.gabrielasolis@gmail.com::" providerId="AD" clId="Web-{45224825-C9EE-E9F4-84B4-0E973000F4E8}" dt="2021-10-10T14:57:34.474" v="109" actId="20577"/>
          <ac:spMkLst>
            <pc:docMk/>
            <pc:sldMk cId="3375007296" sldId="380"/>
            <ac:spMk id="3" creationId="{732813B5-3B16-4C39-9B26-980756C16563}"/>
          </ac:spMkLst>
        </pc:spChg>
        <pc:picChg chg="mod">
          <ac:chgData name="dra.gabrielasolis@gmail.com" userId="S::urn:spo:guest#dra.gabrielasolis@gmail.com::" providerId="AD" clId="Web-{45224825-C9EE-E9F4-84B4-0E973000F4E8}" dt="2021-10-10T14:57:17.771" v="102" actId="1076"/>
          <ac:picMkLst>
            <pc:docMk/>
            <pc:sldMk cId="3375007296" sldId="380"/>
            <ac:picMk id="7" creationId="{C881AB2D-3C9A-4D94-8D8A-B5E7537280AA}"/>
          </ac:picMkLst>
        </pc:picChg>
      </pc:sldChg>
    </pc:docChg>
  </pc:docChgLst>
  <pc:docChgLst>
    <pc:chgData name="gsolis@northwell.edu" userId="S::urn:spo:guest#gsolis@northwell.edu::" providerId="AD" clId="Web-{52DDB257-F378-2867-64A8-37E4181BA42D}"/>
    <pc:docChg chg="modSld sldOrd">
      <pc:chgData name="gsolis@northwell.edu" userId="S::urn:spo:guest#gsolis@northwell.edu::" providerId="AD" clId="Web-{52DDB257-F378-2867-64A8-37E4181BA42D}" dt="2021-06-20T21:42:08.478" v="692" actId="1076"/>
      <pc:docMkLst>
        <pc:docMk/>
      </pc:docMkLst>
      <pc:sldChg chg="modSp">
        <pc:chgData name="gsolis@northwell.edu" userId="S::urn:spo:guest#gsolis@northwell.edu::" providerId="AD" clId="Web-{52DDB257-F378-2867-64A8-37E4181BA42D}" dt="2021-06-20T21:37:19.259" v="647" actId="1076"/>
        <pc:sldMkLst>
          <pc:docMk/>
          <pc:sldMk cId="2655814267" sldId="280"/>
        </pc:sldMkLst>
        <pc:spChg chg="mod">
          <ac:chgData name="gsolis@northwell.edu" userId="S::urn:spo:guest#gsolis@northwell.edu::" providerId="AD" clId="Web-{52DDB257-F378-2867-64A8-37E4181BA42D}" dt="2021-06-20T21:37:19.259" v="647" actId="1076"/>
          <ac:spMkLst>
            <pc:docMk/>
            <pc:sldMk cId="2655814267" sldId="280"/>
            <ac:spMk id="2" creationId="{00000000-0000-0000-0000-000000000000}"/>
          </ac:spMkLst>
        </pc:spChg>
        <pc:picChg chg="mod">
          <ac:chgData name="gsolis@northwell.edu" userId="S::urn:spo:guest#gsolis@northwell.edu::" providerId="AD" clId="Web-{52DDB257-F378-2867-64A8-37E4181BA42D}" dt="2021-06-20T21:37:05.930" v="644" actId="1076"/>
          <ac:picMkLst>
            <pc:docMk/>
            <pc:sldMk cId="2655814267" sldId="280"/>
            <ac:picMk id="3" creationId="{0E6D56A4-A98E-4D77-A303-68A45419F08C}"/>
          </ac:picMkLst>
        </pc:picChg>
      </pc:sldChg>
      <pc:sldChg chg="modSp">
        <pc:chgData name="gsolis@northwell.edu" userId="S::urn:spo:guest#gsolis@northwell.edu::" providerId="AD" clId="Web-{52DDB257-F378-2867-64A8-37E4181BA42D}" dt="2021-06-20T21:00:02.410" v="194" actId="1076"/>
        <pc:sldMkLst>
          <pc:docMk/>
          <pc:sldMk cId="1780732845" sldId="306"/>
        </pc:sldMkLst>
        <pc:spChg chg="mod">
          <ac:chgData name="gsolis@northwell.edu" userId="S::urn:spo:guest#gsolis@northwell.edu::" providerId="AD" clId="Web-{52DDB257-F378-2867-64A8-37E4181BA42D}" dt="2021-06-20T20:59:55.003" v="193" actId="1076"/>
          <ac:spMkLst>
            <pc:docMk/>
            <pc:sldMk cId="1780732845" sldId="306"/>
            <ac:spMk id="2" creationId="{00000000-0000-0000-0000-000000000000}"/>
          </ac:spMkLst>
        </pc:spChg>
        <pc:spChg chg="mod">
          <ac:chgData name="gsolis@northwell.edu" userId="S::urn:spo:guest#gsolis@northwell.edu::" providerId="AD" clId="Web-{52DDB257-F378-2867-64A8-37E4181BA42D}" dt="2021-06-20T20:59:50.003" v="192" actId="1076"/>
          <ac:spMkLst>
            <pc:docMk/>
            <pc:sldMk cId="1780732845" sldId="306"/>
            <ac:spMk id="3" creationId="{00000000-0000-0000-0000-000000000000}"/>
          </ac:spMkLst>
        </pc:spChg>
        <pc:spChg chg="mod">
          <ac:chgData name="gsolis@northwell.edu" userId="S::urn:spo:guest#gsolis@northwell.edu::" providerId="AD" clId="Web-{52DDB257-F378-2867-64A8-37E4181BA42D}" dt="2021-06-20T20:59:29.110" v="190" actId="1076"/>
          <ac:spMkLst>
            <pc:docMk/>
            <pc:sldMk cId="1780732845" sldId="306"/>
            <ac:spMk id="5" creationId="{FB3F74D2-1709-4488-9D0C-E4A818C1E9F6}"/>
          </ac:spMkLst>
        </pc:spChg>
        <pc:spChg chg="mod">
          <ac:chgData name="gsolis@northwell.edu" userId="S::urn:spo:guest#gsolis@northwell.edu::" providerId="AD" clId="Web-{52DDB257-F378-2867-64A8-37E4181BA42D}" dt="2021-06-20T20:59:23.637" v="189" actId="1076"/>
          <ac:spMkLst>
            <pc:docMk/>
            <pc:sldMk cId="1780732845" sldId="306"/>
            <ac:spMk id="6" creationId="{F190CA81-2449-4A22-8842-2F0EA8C68F64}"/>
          </ac:spMkLst>
        </pc:spChg>
        <pc:spChg chg="mod">
          <ac:chgData name="gsolis@northwell.edu" userId="S::urn:spo:guest#gsolis@northwell.edu::" providerId="AD" clId="Web-{52DDB257-F378-2867-64A8-37E4181BA42D}" dt="2021-06-20T21:00:02.410" v="194" actId="1076"/>
          <ac:spMkLst>
            <pc:docMk/>
            <pc:sldMk cId="1780732845" sldId="306"/>
            <ac:spMk id="7" creationId="{5FE5DD88-5FB5-43EA-B299-9C54E6115FE3}"/>
          </ac:spMkLst>
        </pc:spChg>
      </pc:sldChg>
      <pc:sldChg chg="modSp">
        <pc:chgData name="gsolis@northwell.edu" userId="S::urn:spo:guest#gsolis@northwell.edu::" providerId="AD" clId="Web-{52DDB257-F378-2867-64A8-37E4181BA42D}" dt="2021-06-20T21:40:09.456" v="673" actId="20577"/>
        <pc:sldMkLst>
          <pc:docMk/>
          <pc:sldMk cId="3894987403" sldId="307"/>
        </pc:sldMkLst>
        <pc:spChg chg="mod">
          <ac:chgData name="gsolis@northwell.edu" userId="S::urn:spo:guest#gsolis@northwell.edu::" providerId="AD" clId="Web-{52DDB257-F378-2867-64A8-37E4181BA42D}" dt="2021-06-20T21:40:09.456" v="673" actId="20577"/>
          <ac:spMkLst>
            <pc:docMk/>
            <pc:sldMk cId="3894987403" sldId="307"/>
            <ac:spMk id="2" creationId="{00000000-0000-0000-0000-000000000000}"/>
          </ac:spMkLst>
        </pc:spChg>
        <pc:spChg chg="mod">
          <ac:chgData name="gsolis@northwell.edu" userId="S::urn:spo:guest#gsolis@northwell.edu::" providerId="AD" clId="Web-{52DDB257-F378-2867-64A8-37E4181BA42D}" dt="2021-06-20T21:13:53.572" v="329" actId="1076"/>
          <ac:spMkLst>
            <pc:docMk/>
            <pc:sldMk cId="3894987403" sldId="307"/>
            <ac:spMk id="3" creationId="{00000000-0000-0000-0000-000000000000}"/>
          </ac:spMkLst>
        </pc:spChg>
      </pc:sldChg>
      <pc:sldChg chg="modSp">
        <pc:chgData name="gsolis@northwell.edu" userId="S::urn:spo:guest#gsolis@northwell.edu::" providerId="AD" clId="Web-{52DDB257-F378-2867-64A8-37E4181BA42D}" dt="2021-06-20T21:00:30.522" v="196" actId="14100"/>
        <pc:sldMkLst>
          <pc:docMk/>
          <pc:sldMk cId="659258882" sldId="316"/>
        </pc:sldMkLst>
        <pc:spChg chg="mod">
          <ac:chgData name="gsolis@northwell.edu" userId="S::urn:spo:guest#gsolis@northwell.edu::" providerId="AD" clId="Web-{52DDB257-F378-2867-64A8-37E4181BA42D}" dt="2021-06-20T20:44:21.666" v="43" actId="20577"/>
          <ac:spMkLst>
            <pc:docMk/>
            <pc:sldMk cId="659258882" sldId="316"/>
            <ac:spMk id="2" creationId="{00000000-0000-0000-0000-000000000000}"/>
          </ac:spMkLst>
        </pc:spChg>
        <pc:picChg chg="mod">
          <ac:chgData name="gsolis@northwell.edu" userId="S::urn:spo:guest#gsolis@northwell.edu::" providerId="AD" clId="Web-{52DDB257-F378-2867-64A8-37E4181BA42D}" dt="2021-06-20T21:00:30.522" v="196" actId="14100"/>
          <ac:picMkLst>
            <pc:docMk/>
            <pc:sldMk cId="659258882" sldId="316"/>
            <ac:picMk id="7" creationId="{00000000-0000-0000-0000-000000000000}"/>
          </ac:picMkLst>
        </pc:picChg>
      </pc:sldChg>
      <pc:sldChg chg="modSp">
        <pc:chgData name="gsolis@northwell.edu" userId="S::urn:spo:guest#gsolis@northwell.edu::" providerId="AD" clId="Web-{52DDB257-F378-2867-64A8-37E4181BA42D}" dt="2021-06-20T20:46:05.769" v="61" actId="1076"/>
        <pc:sldMkLst>
          <pc:docMk/>
          <pc:sldMk cId="1324940015" sldId="317"/>
        </pc:sldMkLst>
        <pc:spChg chg="mod">
          <ac:chgData name="gsolis@northwell.edu" userId="S::urn:spo:guest#gsolis@northwell.edu::" providerId="AD" clId="Web-{52DDB257-F378-2867-64A8-37E4181BA42D}" dt="2021-06-20T20:45:52.502" v="58" actId="20577"/>
          <ac:spMkLst>
            <pc:docMk/>
            <pc:sldMk cId="1324940015" sldId="317"/>
            <ac:spMk id="18434" creationId="{00000000-0000-0000-0000-000000000000}"/>
          </ac:spMkLst>
        </pc:spChg>
        <pc:graphicFrameChg chg="mod">
          <ac:chgData name="gsolis@northwell.edu" userId="S::urn:spo:guest#gsolis@northwell.edu::" providerId="AD" clId="Web-{52DDB257-F378-2867-64A8-37E4181BA42D}" dt="2021-06-20T20:46:00.581" v="59" actId="1076"/>
          <ac:graphicFrameMkLst>
            <pc:docMk/>
            <pc:sldMk cId="1324940015" sldId="317"/>
            <ac:graphicFrameMk id="7" creationId="{00000000-0000-0000-0000-000000000000}"/>
          </ac:graphicFrameMkLst>
        </pc:graphicFrameChg>
        <pc:graphicFrameChg chg="mod">
          <ac:chgData name="gsolis@northwell.edu" userId="S::urn:spo:guest#gsolis@northwell.edu::" providerId="AD" clId="Web-{52DDB257-F378-2867-64A8-37E4181BA42D}" dt="2021-06-20T20:46:05.769" v="61" actId="1076"/>
          <ac:graphicFrameMkLst>
            <pc:docMk/>
            <pc:sldMk cId="1324940015" sldId="317"/>
            <ac:graphicFrameMk id="11" creationId="{00000000-0000-0000-0000-000000000000}"/>
          </ac:graphicFrameMkLst>
        </pc:graphicFrameChg>
      </pc:sldChg>
      <pc:sldChg chg="modSp">
        <pc:chgData name="gsolis@northwell.edu" userId="S::urn:spo:guest#gsolis@northwell.edu::" providerId="AD" clId="Web-{52DDB257-F378-2867-64A8-37E4181BA42D}" dt="2021-06-20T21:39:22.578" v="666" actId="20577"/>
        <pc:sldMkLst>
          <pc:docMk/>
          <pc:sldMk cId="3061336521" sldId="318"/>
        </pc:sldMkLst>
        <pc:spChg chg="mod">
          <ac:chgData name="gsolis@northwell.edu" userId="S::urn:spo:guest#gsolis@northwell.edu::" providerId="AD" clId="Web-{52DDB257-F378-2867-64A8-37E4181BA42D}" dt="2021-06-20T21:39:22.578" v="666" actId="20577"/>
          <ac:spMkLst>
            <pc:docMk/>
            <pc:sldMk cId="3061336521" sldId="318"/>
            <ac:spMk id="2" creationId="{00000000-0000-0000-0000-000000000000}"/>
          </ac:spMkLst>
        </pc:spChg>
        <pc:spChg chg="mod">
          <ac:chgData name="gsolis@northwell.edu" userId="S::urn:spo:guest#gsolis@northwell.edu::" providerId="AD" clId="Web-{52DDB257-F378-2867-64A8-37E4181BA42D}" dt="2021-06-20T20:42:16.440" v="30" actId="20577"/>
          <ac:spMkLst>
            <pc:docMk/>
            <pc:sldMk cId="3061336521" sldId="318"/>
            <ac:spMk id="6" creationId="{00000000-0000-0000-0000-000000000000}"/>
          </ac:spMkLst>
        </pc:spChg>
        <pc:picChg chg="mod">
          <ac:chgData name="gsolis@northwell.edu" userId="S::urn:spo:guest#gsolis@northwell.edu::" providerId="AD" clId="Web-{52DDB257-F378-2867-64A8-37E4181BA42D}" dt="2021-06-20T20:42:22.299" v="32" actId="14100"/>
          <ac:picMkLst>
            <pc:docMk/>
            <pc:sldMk cId="3061336521" sldId="318"/>
            <ac:picMk id="4100" creationId="{00000000-0000-0000-0000-000000000000}"/>
          </ac:picMkLst>
        </pc:picChg>
      </pc:sldChg>
      <pc:sldChg chg="modSp">
        <pc:chgData name="gsolis@northwell.edu" userId="S::urn:spo:guest#gsolis@northwell.edu::" providerId="AD" clId="Web-{52DDB257-F378-2867-64A8-37E4181BA42D}" dt="2021-06-20T20:44:03.227" v="42" actId="20577"/>
        <pc:sldMkLst>
          <pc:docMk/>
          <pc:sldMk cId="433975252" sldId="323"/>
        </pc:sldMkLst>
        <pc:spChg chg="mod">
          <ac:chgData name="gsolis@northwell.edu" userId="S::urn:spo:guest#gsolis@northwell.edu::" providerId="AD" clId="Web-{52DDB257-F378-2867-64A8-37E4181BA42D}" dt="2021-06-20T20:44:03.227" v="42" actId="20577"/>
          <ac:spMkLst>
            <pc:docMk/>
            <pc:sldMk cId="433975252" sldId="323"/>
            <ac:spMk id="3" creationId="{00000000-0000-0000-0000-000000000000}"/>
          </ac:spMkLst>
        </pc:spChg>
      </pc:sldChg>
      <pc:sldChg chg="delSp modSp">
        <pc:chgData name="gsolis@northwell.edu" userId="S::urn:spo:guest#gsolis@northwell.edu::" providerId="AD" clId="Web-{52DDB257-F378-2867-64A8-37E4181BA42D}" dt="2021-06-20T20:48:31.027" v="90" actId="1076"/>
        <pc:sldMkLst>
          <pc:docMk/>
          <pc:sldMk cId="2417005009" sldId="330"/>
        </pc:sldMkLst>
        <pc:spChg chg="mod">
          <ac:chgData name="gsolis@northwell.edu" userId="S::urn:spo:guest#gsolis@northwell.edu::" providerId="AD" clId="Web-{52DDB257-F378-2867-64A8-37E4181BA42D}" dt="2021-06-20T20:47:03.928" v="73" actId="20577"/>
          <ac:spMkLst>
            <pc:docMk/>
            <pc:sldMk cId="2417005009" sldId="330"/>
            <ac:spMk id="2" creationId="{00000000-0000-0000-0000-000000000000}"/>
          </ac:spMkLst>
        </pc:spChg>
        <pc:spChg chg="mod">
          <ac:chgData name="gsolis@northwell.edu" userId="S::urn:spo:guest#gsolis@northwell.edu::" providerId="AD" clId="Web-{52DDB257-F378-2867-64A8-37E4181BA42D}" dt="2021-06-20T20:48:26.870" v="89" actId="1076"/>
          <ac:spMkLst>
            <pc:docMk/>
            <pc:sldMk cId="2417005009" sldId="330"/>
            <ac:spMk id="3" creationId="{00000000-0000-0000-0000-000000000000}"/>
          </ac:spMkLst>
        </pc:spChg>
        <pc:spChg chg="mod">
          <ac:chgData name="gsolis@northwell.edu" userId="S::urn:spo:guest#gsolis@northwell.edu::" providerId="AD" clId="Web-{52DDB257-F378-2867-64A8-37E4181BA42D}" dt="2021-06-20T20:48:31.027" v="90" actId="1076"/>
          <ac:spMkLst>
            <pc:docMk/>
            <pc:sldMk cId="2417005009" sldId="330"/>
            <ac:spMk id="5" creationId="{00000000-0000-0000-0000-000000000000}"/>
          </ac:spMkLst>
        </pc:spChg>
        <pc:picChg chg="del mod">
          <ac:chgData name="gsolis@northwell.edu" userId="S::urn:spo:guest#gsolis@northwell.edu::" providerId="AD" clId="Web-{52DDB257-F378-2867-64A8-37E4181BA42D}" dt="2021-06-20T20:48:22.573" v="88"/>
          <ac:picMkLst>
            <pc:docMk/>
            <pc:sldMk cId="2417005009" sldId="330"/>
            <ac:picMk id="1026" creationId="{00000000-0000-0000-0000-000000000000}"/>
          </ac:picMkLst>
        </pc:picChg>
        <pc:picChg chg="del mod">
          <ac:chgData name="gsolis@northwell.edu" userId="S::urn:spo:guest#gsolis@northwell.edu::" providerId="AD" clId="Web-{52DDB257-F378-2867-64A8-37E4181BA42D}" dt="2021-06-20T20:48:21.698" v="87"/>
          <ac:picMkLst>
            <pc:docMk/>
            <pc:sldMk cId="2417005009" sldId="330"/>
            <ac:picMk id="1028" creationId="{00000000-0000-0000-0000-000000000000}"/>
          </ac:picMkLst>
        </pc:picChg>
      </pc:sldChg>
      <pc:sldChg chg="modSp">
        <pc:chgData name="gsolis@northwell.edu" userId="S::urn:spo:guest#gsolis@northwell.edu::" providerId="AD" clId="Web-{52DDB257-F378-2867-64A8-37E4181BA42D}" dt="2021-06-20T21:06:05.416" v="273" actId="20577"/>
        <pc:sldMkLst>
          <pc:docMk/>
          <pc:sldMk cId="2930611101" sldId="333"/>
        </pc:sldMkLst>
        <pc:spChg chg="mod">
          <ac:chgData name="gsolis@northwell.edu" userId="S::urn:spo:guest#gsolis@northwell.edu::" providerId="AD" clId="Web-{52DDB257-F378-2867-64A8-37E4181BA42D}" dt="2021-06-20T21:05:07.538" v="260" actId="20577"/>
          <ac:spMkLst>
            <pc:docMk/>
            <pc:sldMk cId="2930611101" sldId="333"/>
            <ac:spMk id="2" creationId="{00000000-0000-0000-0000-000000000000}"/>
          </ac:spMkLst>
        </pc:spChg>
        <pc:spChg chg="mod">
          <ac:chgData name="gsolis@northwell.edu" userId="S::urn:spo:guest#gsolis@northwell.edu::" providerId="AD" clId="Web-{52DDB257-F378-2867-64A8-37E4181BA42D}" dt="2021-06-20T21:06:05.416" v="273" actId="20577"/>
          <ac:spMkLst>
            <pc:docMk/>
            <pc:sldMk cId="2930611101" sldId="333"/>
            <ac:spMk id="3" creationId="{00000000-0000-0000-0000-000000000000}"/>
          </ac:spMkLst>
        </pc:spChg>
      </pc:sldChg>
      <pc:sldChg chg="modSp">
        <pc:chgData name="gsolis@northwell.edu" userId="S::urn:spo:guest#gsolis@northwell.edu::" providerId="AD" clId="Web-{52DDB257-F378-2867-64A8-37E4181BA42D}" dt="2021-06-20T21:27:24.372" v="510" actId="20577"/>
        <pc:sldMkLst>
          <pc:docMk/>
          <pc:sldMk cId="4240967710" sldId="334"/>
        </pc:sldMkLst>
        <pc:spChg chg="mod">
          <ac:chgData name="gsolis@northwell.edu" userId="S::urn:spo:guest#gsolis@northwell.edu::" providerId="AD" clId="Web-{52DDB257-F378-2867-64A8-37E4181BA42D}" dt="2021-06-20T21:27:24.372" v="510" actId="20577"/>
          <ac:spMkLst>
            <pc:docMk/>
            <pc:sldMk cId="4240967710" sldId="334"/>
            <ac:spMk id="2" creationId="{00000000-0000-0000-0000-000000000000}"/>
          </ac:spMkLst>
        </pc:spChg>
        <pc:spChg chg="mod">
          <ac:chgData name="gsolis@northwell.edu" userId="S::urn:spo:guest#gsolis@northwell.edu::" providerId="AD" clId="Web-{52DDB257-F378-2867-64A8-37E4181BA42D}" dt="2021-06-20T21:26:01.663" v="499" actId="20577"/>
          <ac:spMkLst>
            <pc:docMk/>
            <pc:sldMk cId="4240967710" sldId="334"/>
            <ac:spMk id="3" creationId="{00000000-0000-0000-0000-000000000000}"/>
          </ac:spMkLst>
        </pc:spChg>
      </pc:sldChg>
      <pc:sldChg chg="modSp">
        <pc:chgData name="gsolis@northwell.edu" userId="S::urn:spo:guest#gsolis@northwell.edu::" providerId="AD" clId="Web-{52DDB257-F378-2867-64A8-37E4181BA42D}" dt="2021-06-20T21:29:16.570" v="557" actId="1076"/>
        <pc:sldMkLst>
          <pc:docMk/>
          <pc:sldMk cId="2277355623" sldId="336"/>
        </pc:sldMkLst>
        <pc:spChg chg="mod">
          <ac:chgData name="gsolis@northwell.edu" userId="S::urn:spo:guest#gsolis@northwell.edu::" providerId="AD" clId="Web-{52DDB257-F378-2867-64A8-37E4181BA42D}" dt="2021-06-20T21:29:11.492" v="556" actId="20577"/>
          <ac:spMkLst>
            <pc:docMk/>
            <pc:sldMk cId="2277355623" sldId="336"/>
            <ac:spMk id="2" creationId="{00000000-0000-0000-0000-000000000000}"/>
          </ac:spMkLst>
        </pc:spChg>
        <pc:spChg chg="mod">
          <ac:chgData name="gsolis@northwell.edu" userId="S::urn:spo:guest#gsolis@northwell.edu::" providerId="AD" clId="Web-{52DDB257-F378-2867-64A8-37E4181BA42D}" dt="2021-06-20T21:29:16.570" v="557" actId="1076"/>
          <ac:spMkLst>
            <pc:docMk/>
            <pc:sldMk cId="2277355623" sldId="336"/>
            <ac:spMk id="3" creationId="{00000000-0000-0000-0000-000000000000}"/>
          </ac:spMkLst>
        </pc:spChg>
      </pc:sldChg>
      <pc:sldChg chg="modSp">
        <pc:chgData name="gsolis@northwell.edu" userId="S::urn:spo:guest#gsolis@northwell.edu::" providerId="AD" clId="Web-{52DDB257-F378-2867-64A8-37E4181BA42D}" dt="2021-06-20T21:40:20.175" v="674" actId="20577"/>
        <pc:sldMkLst>
          <pc:docMk/>
          <pc:sldMk cId="1708372556" sldId="338"/>
        </pc:sldMkLst>
        <pc:spChg chg="mod">
          <ac:chgData name="gsolis@northwell.edu" userId="S::urn:spo:guest#gsolis@northwell.edu::" providerId="AD" clId="Web-{52DDB257-F378-2867-64A8-37E4181BA42D}" dt="2021-06-20T21:40:20.175" v="674" actId="20577"/>
          <ac:spMkLst>
            <pc:docMk/>
            <pc:sldMk cId="1708372556" sldId="338"/>
            <ac:spMk id="2" creationId="{00000000-0000-0000-0000-000000000000}"/>
          </ac:spMkLst>
        </pc:spChg>
        <pc:spChg chg="mod">
          <ac:chgData name="gsolis@northwell.edu" userId="S::urn:spo:guest#gsolis@northwell.edu::" providerId="AD" clId="Web-{52DDB257-F378-2867-64A8-37E4181BA42D}" dt="2021-06-20T21:02:51.593" v="211" actId="20577"/>
          <ac:spMkLst>
            <pc:docMk/>
            <pc:sldMk cId="1708372556" sldId="338"/>
            <ac:spMk id="3" creationId="{00000000-0000-0000-0000-000000000000}"/>
          </ac:spMkLst>
        </pc:spChg>
      </pc:sldChg>
      <pc:sldChg chg="modSp">
        <pc:chgData name="gsolis@northwell.edu" userId="S::urn:spo:guest#gsolis@northwell.edu::" providerId="AD" clId="Web-{52DDB257-F378-2867-64A8-37E4181BA42D}" dt="2021-06-20T21:04:53.256" v="258" actId="1076"/>
        <pc:sldMkLst>
          <pc:docMk/>
          <pc:sldMk cId="3315398952" sldId="339"/>
        </pc:sldMkLst>
        <pc:spChg chg="mod">
          <ac:chgData name="gsolis@northwell.edu" userId="S::urn:spo:guest#gsolis@northwell.edu::" providerId="AD" clId="Web-{52DDB257-F378-2867-64A8-37E4181BA42D}" dt="2021-06-20T21:04:53.256" v="258" actId="1076"/>
          <ac:spMkLst>
            <pc:docMk/>
            <pc:sldMk cId="3315398952" sldId="339"/>
            <ac:spMk id="2" creationId="{00000000-0000-0000-0000-000000000000}"/>
          </ac:spMkLst>
        </pc:spChg>
        <pc:spChg chg="mod">
          <ac:chgData name="gsolis@northwell.edu" userId="S::urn:spo:guest#gsolis@northwell.edu::" providerId="AD" clId="Web-{52DDB257-F378-2867-64A8-37E4181BA42D}" dt="2021-06-20T21:03:33.157" v="215" actId="1076"/>
          <ac:spMkLst>
            <pc:docMk/>
            <pc:sldMk cId="3315398952" sldId="339"/>
            <ac:spMk id="3" creationId="{00000000-0000-0000-0000-000000000000}"/>
          </ac:spMkLst>
        </pc:spChg>
      </pc:sldChg>
      <pc:sldChg chg="modSp">
        <pc:chgData name="gsolis@northwell.edu" userId="S::urn:spo:guest#gsolis@northwell.edu::" providerId="AD" clId="Web-{52DDB257-F378-2867-64A8-37E4181BA42D}" dt="2021-06-20T21:35:19.576" v="630" actId="1076"/>
        <pc:sldMkLst>
          <pc:docMk/>
          <pc:sldMk cId="3645599527" sldId="341"/>
        </pc:sldMkLst>
        <pc:spChg chg="mod">
          <ac:chgData name="gsolis@northwell.edu" userId="S::urn:spo:guest#gsolis@northwell.edu::" providerId="AD" clId="Web-{52DDB257-F378-2867-64A8-37E4181BA42D}" dt="2021-06-20T21:35:19.576" v="630" actId="1076"/>
          <ac:spMkLst>
            <pc:docMk/>
            <pc:sldMk cId="3645599527" sldId="341"/>
            <ac:spMk id="2" creationId="{00000000-0000-0000-0000-000000000000}"/>
          </ac:spMkLst>
        </pc:spChg>
        <pc:spChg chg="mod">
          <ac:chgData name="gsolis@northwell.edu" userId="S::urn:spo:guest#gsolis@northwell.edu::" providerId="AD" clId="Web-{52DDB257-F378-2867-64A8-37E4181BA42D}" dt="2021-06-20T21:35:12.029" v="629" actId="1076"/>
          <ac:spMkLst>
            <pc:docMk/>
            <pc:sldMk cId="3645599527" sldId="341"/>
            <ac:spMk id="3" creationId="{00000000-0000-0000-0000-000000000000}"/>
          </ac:spMkLst>
        </pc:spChg>
      </pc:sldChg>
      <pc:sldChg chg="modSp">
        <pc:chgData name="gsolis@northwell.edu" userId="S::urn:spo:guest#gsolis@northwell.edu::" providerId="AD" clId="Web-{52DDB257-F378-2867-64A8-37E4181BA42D}" dt="2021-06-20T21:40:49.239" v="682" actId="20577"/>
        <pc:sldMkLst>
          <pc:docMk/>
          <pc:sldMk cId="337776308" sldId="342"/>
        </pc:sldMkLst>
        <pc:spChg chg="mod">
          <ac:chgData name="gsolis@northwell.edu" userId="S::urn:spo:guest#gsolis@northwell.edu::" providerId="AD" clId="Web-{52DDB257-F378-2867-64A8-37E4181BA42D}" dt="2021-06-20T21:40:45.270" v="681" actId="20577"/>
          <ac:spMkLst>
            <pc:docMk/>
            <pc:sldMk cId="337776308" sldId="342"/>
            <ac:spMk id="2" creationId="{00000000-0000-0000-0000-000000000000}"/>
          </ac:spMkLst>
        </pc:spChg>
        <pc:spChg chg="mod">
          <ac:chgData name="gsolis@northwell.edu" userId="S::urn:spo:guest#gsolis@northwell.edu::" providerId="AD" clId="Web-{52DDB257-F378-2867-64A8-37E4181BA42D}" dt="2021-06-20T21:40:49.239" v="682" actId="20577"/>
          <ac:spMkLst>
            <pc:docMk/>
            <pc:sldMk cId="337776308" sldId="342"/>
            <ac:spMk id="3" creationId="{00000000-0000-0000-0000-000000000000}"/>
          </ac:spMkLst>
        </pc:spChg>
      </pc:sldChg>
      <pc:sldChg chg="modSp">
        <pc:chgData name="gsolis@northwell.edu" userId="S::urn:spo:guest#gsolis@northwell.edu::" providerId="AD" clId="Web-{52DDB257-F378-2867-64A8-37E4181BA42D}" dt="2021-06-20T21:08:56.868" v="289" actId="14100"/>
        <pc:sldMkLst>
          <pc:docMk/>
          <pc:sldMk cId="3832890404" sldId="343"/>
        </pc:sldMkLst>
        <pc:spChg chg="mod">
          <ac:chgData name="gsolis@northwell.edu" userId="S::urn:spo:guest#gsolis@northwell.edu::" providerId="AD" clId="Web-{52DDB257-F378-2867-64A8-37E4181BA42D}" dt="2021-06-20T21:08:56.868" v="289" actId="14100"/>
          <ac:spMkLst>
            <pc:docMk/>
            <pc:sldMk cId="3832890404" sldId="343"/>
            <ac:spMk id="2" creationId="{00000000-0000-0000-0000-000000000000}"/>
          </ac:spMkLst>
        </pc:spChg>
        <pc:spChg chg="mod">
          <ac:chgData name="gsolis@northwell.edu" userId="S::urn:spo:guest#gsolis@northwell.edu::" providerId="AD" clId="Web-{52DDB257-F378-2867-64A8-37E4181BA42D}" dt="2021-06-20T21:08:48.911" v="288" actId="1076"/>
          <ac:spMkLst>
            <pc:docMk/>
            <pc:sldMk cId="3832890404" sldId="343"/>
            <ac:spMk id="3" creationId="{00000000-0000-0000-0000-000000000000}"/>
          </ac:spMkLst>
        </pc:spChg>
      </pc:sldChg>
      <pc:sldChg chg="modSp">
        <pc:chgData name="gsolis@northwell.edu" userId="S::urn:spo:guest#gsolis@northwell.edu::" providerId="AD" clId="Web-{52DDB257-F378-2867-64A8-37E4181BA42D}" dt="2021-06-20T21:34:22.385" v="620" actId="20577"/>
        <pc:sldMkLst>
          <pc:docMk/>
          <pc:sldMk cId="856723955" sldId="344"/>
        </pc:sldMkLst>
        <pc:spChg chg="mod">
          <ac:chgData name="gsolis@northwell.edu" userId="S::urn:spo:guest#gsolis@northwell.edu::" providerId="AD" clId="Web-{52DDB257-F378-2867-64A8-37E4181BA42D}" dt="2021-06-20T21:33:20.632" v="608" actId="20577"/>
          <ac:spMkLst>
            <pc:docMk/>
            <pc:sldMk cId="856723955" sldId="344"/>
            <ac:spMk id="2" creationId="{00000000-0000-0000-0000-000000000000}"/>
          </ac:spMkLst>
        </pc:spChg>
        <pc:spChg chg="mod">
          <ac:chgData name="gsolis@northwell.edu" userId="S::urn:spo:guest#gsolis@northwell.edu::" providerId="AD" clId="Web-{52DDB257-F378-2867-64A8-37E4181BA42D}" dt="2021-06-20T21:34:22.385" v="620" actId="20577"/>
          <ac:spMkLst>
            <pc:docMk/>
            <pc:sldMk cId="856723955" sldId="344"/>
            <ac:spMk id="5" creationId="{8F448598-3DD3-4B0F-BD4F-4068CF736EEB}"/>
          </ac:spMkLst>
        </pc:spChg>
      </pc:sldChg>
      <pc:sldChg chg="modSp">
        <pc:chgData name="gsolis@northwell.edu" userId="S::urn:spo:guest#gsolis@northwell.edu::" providerId="AD" clId="Web-{52DDB257-F378-2867-64A8-37E4181BA42D}" dt="2021-06-20T21:01:35.510" v="204" actId="20577"/>
        <pc:sldMkLst>
          <pc:docMk/>
          <pc:sldMk cId="1559596806" sldId="346"/>
        </pc:sldMkLst>
        <pc:spChg chg="mod">
          <ac:chgData name="gsolis@northwell.edu" userId="S::urn:spo:guest#gsolis@northwell.edu::" providerId="AD" clId="Web-{52DDB257-F378-2867-64A8-37E4181BA42D}" dt="2021-06-20T21:01:14.946" v="201" actId="20577"/>
          <ac:spMkLst>
            <pc:docMk/>
            <pc:sldMk cId="1559596806" sldId="346"/>
            <ac:spMk id="2" creationId="{00000000-0000-0000-0000-000000000000}"/>
          </ac:spMkLst>
        </pc:spChg>
        <pc:spChg chg="mod">
          <ac:chgData name="gsolis@northwell.edu" userId="S::urn:spo:guest#gsolis@northwell.edu::" providerId="AD" clId="Web-{52DDB257-F378-2867-64A8-37E4181BA42D}" dt="2021-06-20T21:01:35.510" v="204" actId="20577"/>
          <ac:spMkLst>
            <pc:docMk/>
            <pc:sldMk cId="1559596806" sldId="346"/>
            <ac:spMk id="3" creationId="{00000000-0000-0000-0000-000000000000}"/>
          </ac:spMkLst>
        </pc:spChg>
      </pc:sldChg>
      <pc:sldChg chg="delSp modSp">
        <pc:chgData name="gsolis@northwell.edu" userId="S::urn:spo:guest#gsolis@northwell.edu::" providerId="AD" clId="Web-{52DDB257-F378-2867-64A8-37E4181BA42D}" dt="2021-06-20T21:18:19.622" v="391" actId="20577"/>
        <pc:sldMkLst>
          <pc:docMk/>
          <pc:sldMk cId="3787916487" sldId="347"/>
        </pc:sldMkLst>
        <pc:spChg chg="mod">
          <ac:chgData name="gsolis@northwell.edu" userId="S::urn:spo:guest#gsolis@northwell.edu::" providerId="AD" clId="Web-{52DDB257-F378-2867-64A8-37E4181BA42D}" dt="2021-06-20T21:18:19.622" v="391" actId="20577"/>
          <ac:spMkLst>
            <pc:docMk/>
            <pc:sldMk cId="3787916487" sldId="347"/>
            <ac:spMk id="2" creationId="{00000000-0000-0000-0000-000000000000}"/>
          </ac:spMkLst>
        </pc:spChg>
        <pc:spChg chg="mod">
          <ac:chgData name="gsolis@northwell.edu" userId="S::urn:spo:guest#gsolis@northwell.edu::" providerId="AD" clId="Web-{52DDB257-F378-2867-64A8-37E4181BA42D}" dt="2021-06-20T21:18:10.919" v="390" actId="1076"/>
          <ac:spMkLst>
            <pc:docMk/>
            <pc:sldMk cId="3787916487" sldId="347"/>
            <ac:spMk id="3" creationId="{6866170B-82BB-4384-8302-2D55D82788DE}"/>
          </ac:spMkLst>
        </pc:spChg>
        <pc:spChg chg="mod">
          <ac:chgData name="gsolis@northwell.edu" userId="S::urn:spo:guest#gsolis@northwell.edu::" providerId="AD" clId="Web-{52DDB257-F378-2867-64A8-37E4181BA42D}" dt="2021-06-20T21:18:07.887" v="389" actId="1076"/>
          <ac:spMkLst>
            <pc:docMk/>
            <pc:sldMk cId="3787916487" sldId="347"/>
            <ac:spMk id="5" creationId="{996A3E5F-7D00-42D2-A937-2D6849ED6B2F}"/>
          </ac:spMkLst>
        </pc:spChg>
        <pc:picChg chg="del">
          <ac:chgData name="gsolis@northwell.edu" userId="S::urn:spo:guest#gsolis@northwell.edu::" providerId="AD" clId="Web-{52DDB257-F378-2867-64A8-37E4181BA42D}" dt="2021-06-20T21:17:53.480" v="386"/>
          <ac:picMkLst>
            <pc:docMk/>
            <pc:sldMk cId="3787916487" sldId="347"/>
            <ac:picMk id="2050" creationId="{00000000-0000-0000-0000-000000000000}"/>
          </ac:picMkLst>
        </pc:picChg>
        <pc:picChg chg="del">
          <ac:chgData name="gsolis@northwell.edu" userId="S::urn:spo:guest#gsolis@northwell.edu::" providerId="AD" clId="Web-{52DDB257-F378-2867-64A8-37E4181BA42D}" dt="2021-06-20T21:17:50.996" v="384"/>
          <ac:picMkLst>
            <pc:docMk/>
            <pc:sldMk cId="3787916487" sldId="347"/>
            <ac:picMk id="2052" creationId="{00000000-0000-0000-0000-000000000000}"/>
          </ac:picMkLst>
        </pc:picChg>
        <pc:picChg chg="del">
          <ac:chgData name="gsolis@northwell.edu" userId="S::urn:spo:guest#gsolis@northwell.edu::" providerId="AD" clId="Web-{52DDB257-F378-2867-64A8-37E4181BA42D}" dt="2021-06-20T21:17:51.996" v="385"/>
          <ac:picMkLst>
            <pc:docMk/>
            <pc:sldMk cId="3787916487" sldId="347"/>
            <ac:picMk id="2054" creationId="{00000000-0000-0000-0000-000000000000}"/>
          </ac:picMkLst>
        </pc:picChg>
        <pc:picChg chg="del">
          <ac:chgData name="gsolis@northwell.edu" userId="S::urn:spo:guest#gsolis@northwell.edu::" providerId="AD" clId="Web-{52DDB257-F378-2867-64A8-37E4181BA42D}" dt="2021-06-20T21:17:54.511" v="387"/>
          <ac:picMkLst>
            <pc:docMk/>
            <pc:sldMk cId="3787916487" sldId="347"/>
            <ac:picMk id="2056" creationId="{00000000-0000-0000-0000-000000000000}"/>
          </ac:picMkLst>
        </pc:picChg>
        <pc:picChg chg="del">
          <ac:chgData name="gsolis@northwell.edu" userId="S::urn:spo:guest#gsolis@northwell.edu::" providerId="AD" clId="Web-{52DDB257-F378-2867-64A8-37E4181BA42D}" dt="2021-06-20T21:17:44.386" v="381"/>
          <ac:picMkLst>
            <pc:docMk/>
            <pc:sldMk cId="3787916487" sldId="347"/>
            <ac:picMk id="2060" creationId="{00000000-0000-0000-0000-000000000000}"/>
          </ac:picMkLst>
        </pc:picChg>
        <pc:picChg chg="del">
          <ac:chgData name="gsolis@northwell.edu" userId="S::urn:spo:guest#gsolis@northwell.edu::" providerId="AD" clId="Web-{52DDB257-F378-2867-64A8-37E4181BA42D}" dt="2021-06-20T21:17:48.433" v="382"/>
          <ac:picMkLst>
            <pc:docMk/>
            <pc:sldMk cId="3787916487" sldId="347"/>
            <ac:picMk id="2062" creationId="{00000000-0000-0000-0000-000000000000}"/>
          </ac:picMkLst>
        </pc:picChg>
        <pc:picChg chg="del">
          <ac:chgData name="gsolis@northwell.edu" userId="S::urn:spo:guest#gsolis@northwell.edu::" providerId="AD" clId="Web-{52DDB257-F378-2867-64A8-37E4181BA42D}" dt="2021-06-20T21:17:49.636" v="383"/>
          <ac:picMkLst>
            <pc:docMk/>
            <pc:sldMk cId="3787916487" sldId="347"/>
            <ac:picMk id="2064" creationId="{00000000-0000-0000-0000-000000000000}"/>
          </ac:picMkLst>
        </pc:picChg>
      </pc:sldChg>
      <pc:sldChg chg="modSp ord">
        <pc:chgData name="gsolis@northwell.edu" userId="S::urn:spo:guest#gsolis@northwell.edu::" providerId="AD" clId="Web-{52DDB257-F378-2867-64A8-37E4181BA42D}" dt="2021-06-20T21:41:38.554" v="690" actId="14100"/>
        <pc:sldMkLst>
          <pc:docMk/>
          <pc:sldMk cId="1011963421" sldId="351"/>
        </pc:sldMkLst>
        <pc:spChg chg="mod">
          <ac:chgData name="gsolis@northwell.edu" userId="S::urn:spo:guest#gsolis@northwell.edu::" providerId="AD" clId="Web-{52DDB257-F378-2867-64A8-37E4181BA42D}" dt="2021-06-20T21:11:33.799" v="303" actId="20577"/>
          <ac:spMkLst>
            <pc:docMk/>
            <pc:sldMk cId="1011963421" sldId="351"/>
            <ac:spMk id="7" creationId="{00000000-0000-0000-0000-000000000000}"/>
          </ac:spMkLst>
        </pc:spChg>
        <pc:spChg chg="mod">
          <ac:chgData name="gsolis@northwell.edu" userId="S::urn:spo:guest#gsolis@northwell.edu::" providerId="AD" clId="Web-{52DDB257-F378-2867-64A8-37E4181BA42D}" dt="2021-06-20T21:41:38.554" v="690" actId="14100"/>
          <ac:spMkLst>
            <pc:docMk/>
            <pc:sldMk cId="1011963421" sldId="351"/>
            <ac:spMk id="21509" creationId="{00000000-0000-0000-0000-000000000000}"/>
          </ac:spMkLst>
        </pc:spChg>
        <pc:picChg chg="mod">
          <ac:chgData name="gsolis@northwell.edu" userId="S::urn:spo:guest#gsolis@northwell.edu::" providerId="AD" clId="Web-{52DDB257-F378-2867-64A8-37E4181BA42D}" dt="2021-06-20T21:41:29.632" v="688" actId="14100"/>
          <ac:picMkLst>
            <pc:docMk/>
            <pc:sldMk cId="1011963421" sldId="351"/>
            <ac:picMk id="21507" creationId="{00000000-0000-0000-0000-000000000000}"/>
          </ac:picMkLst>
        </pc:picChg>
      </pc:sldChg>
      <pc:sldChg chg="modSp ord">
        <pc:chgData name="gsolis@northwell.edu" userId="S::urn:spo:guest#gsolis@northwell.edu::" providerId="AD" clId="Web-{52DDB257-F378-2867-64A8-37E4181BA42D}" dt="2021-06-20T21:13:16.023" v="324" actId="20577"/>
        <pc:sldMkLst>
          <pc:docMk/>
          <pc:sldMk cId="153378708" sldId="352"/>
        </pc:sldMkLst>
        <pc:spChg chg="mod">
          <ac:chgData name="gsolis@northwell.edu" userId="S::urn:spo:guest#gsolis@northwell.edu::" providerId="AD" clId="Web-{52DDB257-F378-2867-64A8-37E4181BA42D}" dt="2021-06-20T21:13:16.023" v="324" actId="20577"/>
          <ac:spMkLst>
            <pc:docMk/>
            <pc:sldMk cId="153378708" sldId="352"/>
            <ac:spMk id="2" creationId="{00000000-0000-0000-0000-000000000000}"/>
          </ac:spMkLst>
        </pc:spChg>
        <pc:spChg chg="mod">
          <ac:chgData name="gsolis@northwell.edu" userId="S::urn:spo:guest#gsolis@northwell.edu::" providerId="AD" clId="Web-{52DDB257-F378-2867-64A8-37E4181BA42D}" dt="2021-06-20T21:11:49.846" v="318" actId="20577"/>
          <ac:spMkLst>
            <pc:docMk/>
            <pc:sldMk cId="153378708" sldId="352"/>
            <ac:spMk id="3" creationId="{00000000-0000-0000-0000-000000000000}"/>
          </ac:spMkLst>
        </pc:spChg>
      </pc:sldChg>
      <pc:sldChg chg="modSp">
        <pc:chgData name="gsolis@northwell.edu" userId="S::urn:spo:guest#gsolis@northwell.edu::" providerId="AD" clId="Web-{52DDB257-F378-2867-64A8-37E4181BA42D}" dt="2021-06-20T21:38:55.873" v="664" actId="20577"/>
        <pc:sldMkLst>
          <pc:docMk/>
          <pc:sldMk cId="1404878022" sldId="355"/>
        </pc:sldMkLst>
        <pc:spChg chg="mod">
          <ac:chgData name="gsolis@northwell.edu" userId="S::urn:spo:guest#gsolis@northwell.edu::" providerId="AD" clId="Web-{52DDB257-F378-2867-64A8-37E4181BA42D}" dt="2021-06-20T21:38:55.873" v="664" actId="20577"/>
          <ac:spMkLst>
            <pc:docMk/>
            <pc:sldMk cId="1404878022" sldId="355"/>
            <ac:spMk id="2" creationId="{2DBC60E2-B8DF-4DE8-A781-CAA5CD0F9025}"/>
          </ac:spMkLst>
        </pc:spChg>
      </pc:sldChg>
      <pc:sldChg chg="modSp">
        <pc:chgData name="gsolis@northwell.edu" userId="S::urn:spo:guest#gsolis@northwell.edu::" providerId="AD" clId="Web-{52DDB257-F378-2867-64A8-37E4181BA42D}" dt="2021-06-20T21:39:03.217" v="665" actId="20577"/>
        <pc:sldMkLst>
          <pc:docMk/>
          <pc:sldMk cId="2447000783" sldId="356"/>
        </pc:sldMkLst>
        <pc:spChg chg="mod">
          <ac:chgData name="gsolis@northwell.edu" userId="S::urn:spo:guest#gsolis@northwell.edu::" providerId="AD" clId="Web-{52DDB257-F378-2867-64A8-37E4181BA42D}" dt="2021-06-20T21:39:03.217" v="665" actId="20577"/>
          <ac:spMkLst>
            <pc:docMk/>
            <pc:sldMk cId="2447000783" sldId="356"/>
            <ac:spMk id="2" creationId="{80947263-5C90-4E38-94AA-D7E11C36BD55}"/>
          </ac:spMkLst>
        </pc:spChg>
        <pc:spChg chg="mod">
          <ac:chgData name="gsolis@northwell.edu" userId="S::urn:spo:guest#gsolis@northwell.edu::" providerId="AD" clId="Web-{52DDB257-F378-2867-64A8-37E4181BA42D}" dt="2021-06-20T20:43:46.898" v="40" actId="20577"/>
          <ac:spMkLst>
            <pc:docMk/>
            <pc:sldMk cId="2447000783" sldId="356"/>
            <ac:spMk id="3" creationId="{361A62B3-03B4-4733-B136-D667683F9038}"/>
          </ac:spMkLst>
        </pc:spChg>
      </pc:sldChg>
      <pc:sldChg chg="modSp">
        <pc:chgData name="gsolis@northwell.edu" userId="S::urn:spo:guest#gsolis@northwell.edu::" providerId="AD" clId="Web-{52DDB257-F378-2867-64A8-37E4181BA42D}" dt="2021-06-20T21:42:08.478" v="692" actId="1076"/>
        <pc:sldMkLst>
          <pc:docMk/>
          <pc:sldMk cId="3995300267" sldId="358"/>
        </pc:sldMkLst>
        <pc:spChg chg="mod">
          <ac:chgData name="gsolis@northwell.edu" userId="S::urn:spo:guest#gsolis@northwell.edu::" providerId="AD" clId="Web-{52DDB257-F378-2867-64A8-37E4181BA42D}" dt="2021-06-20T21:42:08.478" v="692" actId="1076"/>
          <ac:spMkLst>
            <pc:docMk/>
            <pc:sldMk cId="3995300267" sldId="358"/>
            <ac:spMk id="2" creationId="{47780179-0182-4210-AB55-A1699228033C}"/>
          </ac:spMkLst>
        </pc:spChg>
        <pc:spChg chg="mod">
          <ac:chgData name="gsolis@northwell.edu" userId="S::urn:spo:guest#gsolis@northwell.edu::" providerId="AD" clId="Web-{52DDB257-F378-2867-64A8-37E4181BA42D}" dt="2021-06-20T21:08:17.220" v="283" actId="1076"/>
          <ac:spMkLst>
            <pc:docMk/>
            <pc:sldMk cId="3995300267" sldId="358"/>
            <ac:spMk id="3" creationId="{9A392957-BD48-49DE-8599-0E44A1AE6D05}"/>
          </ac:spMkLst>
        </pc:spChg>
        <pc:spChg chg="mod">
          <ac:chgData name="gsolis@northwell.edu" userId="S::urn:spo:guest#gsolis@northwell.edu::" providerId="AD" clId="Web-{52DDB257-F378-2867-64A8-37E4181BA42D}" dt="2021-06-20T21:08:08.141" v="282" actId="20577"/>
          <ac:spMkLst>
            <pc:docMk/>
            <pc:sldMk cId="3995300267" sldId="358"/>
            <ac:spMk id="5" creationId="{B1141BC7-349B-4BD4-A9CA-AE55A6EE3D44}"/>
          </ac:spMkLst>
        </pc:spChg>
        <pc:spChg chg="mod">
          <ac:chgData name="gsolis@northwell.edu" userId="S::urn:spo:guest#gsolis@northwell.edu::" providerId="AD" clId="Web-{52DDB257-F378-2867-64A8-37E4181BA42D}" dt="2021-06-20T21:07:50.812" v="280" actId="1076"/>
          <ac:spMkLst>
            <pc:docMk/>
            <pc:sldMk cId="3995300267" sldId="358"/>
            <ac:spMk id="6" creationId="{F3F3D626-C811-4A4E-852E-878C7BE355E5}"/>
          </ac:spMkLst>
        </pc:spChg>
        <pc:spChg chg="mod">
          <ac:chgData name="gsolis@northwell.edu" userId="S::urn:spo:guest#gsolis@northwell.edu::" providerId="AD" clId="Web-{52DDB257-F378-2867-64A8-37E4181BA42D}" dt="2021-06-20T21:07:55.062" v="281" actId="1076"/>
          <ac:spMkLst>
            <pc:docMk/>
            <pc:sldMk cId="3995300267" sldId="358"/>
            <ac:spMk id="7" creationId="{2DB2EEFF-530F-4694-B201-0A930B600A3C}"/>
          </ac:spMkLst>
        </pc:spChg>
      </pc:sldChg>
      <pc:sldChg chg="modSp">
        <pc:chgData name="gsolis@northwell.edu" userId="S::urn:spo:guest#gsolis@northwell.edu::" providerId="AD" clId="Web-{52DDB257-F378-2867-64A8-37E4181BA42D}" dt="2021-06-20T21:41:00.865" v="683" actId="20577"/>
        <pc:sldMkLst>
          <pc:docMk/>
          <pc:sldMk cId="2179516864" sldId="359"/>
        </pc:sldMkLst>
        <pc:spChg chg="mod">
          <ac:chgData name="gsolis@northwell.edu" userId="S::urn:spo:guest#gsolis@northwell.edu::" providerId="AD" clId="Web-{52DDB257-F378-2867-64A8-37E4181BA42D}" dt="2021-06-20T21:41:00.865" v="683" actId="20577"/>
          <ac:spMkLst>
            <pc:docMk/>
            <pc:sldMk cId="2179516864" sldId="359"/>
            <ac:spMk id="2" creationId="{AC173730-8FE9-4CEB-8ACB-F4D99DECFFF2}"/>
          </ac:spMkLst>
        </pc:spChg>
        <pc:spChg chg="mod">
          <ac:chgData name="gsolis@northwell.edu" userId="S::urn:spo:guest#gsolis@northwell.edu::" providerId="AD" clId="Web-{52DDB257-F378-2867-64A8-37E4181BA42D}" dt="2021-06-20T21:19:24.688" v="403" actId="1076"/>
          <ac:spMkLst>
            <pc:docMk/>
            <pc:sldMk cId="2179516864" sldId="359"/>
            <ac:spMk id="3" creationId="{CC37F49F-5474-41DF-A137-03A487E94D1F}"/>
          </ac:spMkLst>
        </pc:spChg>
      </pc:sldChg>
      <pc:sldChg chg="modSp">
        <pc:chgData name="gsolis@northwell.edu" userId="S::urn:spo:guest#gsolis@northwell.edu::" providerId="AD" clId="Web-{52DDB257-F378-2867-64A8-37E4181BA42D}" dt="2021-06-20T21:24:40.690" v="467" actId="20577"/>
        <pc:sldMkLst>
          <pc:docMk/>
          <pc:sldMk cId="956818366" sldId="362"/>
        </pc:sldMkLst>
        <pc:spChg chg="mod">
          <ac:chgData name="gsolis@northwell.edu" userId="S::urn:spo:guest#gsolis@northwell.edu::" providerId="AD" clId="Web-{52DDB257-F378-2867-64A8-37E4181BA42D}" dt="2021-06-20T21:23:53" v="457" actId="20577"/>
          <ac:spMkLst>
            <pc:docMk/>
            <pc:sldMk cId="956818366" sldId="362"/>
            <ac:spMk id="2" creationId="{47780179-0182-4210-AB55-A1699228033C}"/>
          </ac:spMkLst>
        </pc:spChg>
        <pc:spChg chg="mod">
          <ac:chgData name="gsolis@northwell.edu" userId="S::urn:spo:guest#gsolis@northwell.edu::" providerId="AD" clId="Web-{52DDB257-F378-2867-64A8-37E4181BA42D}" dt="2021-06-20T21:24:40.690" v="467" actId="20577"/>
          <ac:spMkLst>
            <pc:docMk/>
            <pc:sldMk cId="956818366" sldId="362"/>
            <ac:spMk id="3" creationId="{9A392957-BD48-49DE-8599-0E44A1AE6D05}"/>
          </ac:spMkLst>
        </pc:spChg>
        <pc:spChg chg="mod">
          <ac:chgData name="gsolis@northwell.edu" userId="S::urn:spo:guest#gsolis@northwell.edu::" providerId="AD" clId="Web-{52DDB257-F378-2867-64A8-37E4181BA42D}" dt="2021-06-20T21:24:27.346" v="462" actId="20577"/>
          <ac:spMkLst>
            <pc:docMk/>
            <pc:sldMk cId="956818366" sldId="362"/>
            <ac:spMk id="5" creationId="{B1141BC7-349B-4BD4-A9CA-AE55A6EE3D44}"/>
          </ac:spMkLst>
        </pc:spChg>
        <pc:spChg chg="mod">
          <ac:chgData name="gsolis@northwell.edu" userId="S::urn:spo:guest#gsolis@northwell.edu::" providerId="AD" clId="Web-{52DDB257-F378-2867-64A8-37E4181BA42D}" dt="2021-06-20T21:24:04.079" v="459" actId="1076"/>
          <ac:spMkLst>
            <pc:docMk/>
            <pc:sldMk cId="956818366" sldId="362"/>
            <ac:spMk id="6" creationId="{F3F3D626-C811-4A4E-852E-878C7BE355E5}"/>
          </ac:spMkLst>
        </pc:spChg>
        <pc:spChg chg="mod">
          <ac:chgData name="gsolis@northwell.edu" userId="S::urn:spo:guest#gsolis@northwell.edu::" providerId="AD" clId="Web-{52DDB257-F378-2867-64A8-37E4181BA42D}" dt="2021-06-20T21:24:09.032" v="460" actId="1076"/>
          <ac:spMkLst>
            <pc:docMk/>
            <pc:sldMk cId="956818366" sldId="362"/>
            <ac:spMk id="7" creationId="{2DB2EEFF-530F-4694-B201-0A930B600A3C}"/>
          </ac:spMkLst>
        </pc:spChg>
      </pc:sldChg>
      <pc:sldChg chg="modSp">
        <pc:chgData name="gsolis@northwell.edu" userId="S::urn:spo:guest#gsolis@northwell.edu::" providerId="AD" clId="Web-{52DDB257-F378-2867-64A8-37E4181BA42D}" dt="2021-06-20T21:33:07.303" v="605" actId="20577"/>
        <pc:sldMkLst>
          <pc:docMk/>
          <pc:sldMk cId="3402779613" sldId="363"/>
        </pc:sldMkLst>
        <pc:spChg chg="mod">
          <ac:chgData name="gsolis@northwell.edu" userId="S::urn:spo:guest#gsolis@northwell.edu::" providerId="AD" clId="Web-{52DDB257-F378-2867-64A8-37E4181BA42D}" dt="2021-06-20T21:30:01.135" v="563" actId="14100"/>
          <ac:spMkLst>
            <pc:docMk/>
            <pc:sldMk cId="3402779613" sldId="363"/>
            <ac:spMk id="2" creationId="{27B06DF6-B7D7-4068-AEE6-707617B3D24E}"/>
          </ac:spMkLst>
        </pc:spChg>
        <pc:spChg chg="mod">
          <ac:chgData name="gsolis@northwell.edu" userId="S::urn:spo:guest#gsolis@northwell.edu::" providerId="AD" clId="Web-{52DDB257-F378-2867-64A8-37E4181BA42D}" dt="2021-06-20T21:33:07.303" v="605" actId="20577"/>
          <ac:spMkLst>
            <pc:docMk/>
            <pc:sldMk cId="3402779613" sldId="363"/>
            <ac:spMk id="3" creationId="{1F51E178-D5AB-4F91-8EB6-98ABE269B5EE}"/>
          </ac:spMkLst>
        </pc:spChg>
        <pc:picChg chg="mod">
          <ac:chgData name="gsolis@northwell.edu" userId="S::urn:spo:guest#gsolis@northwell.edu::" providerId="AD" clId="Web-{52DDB257-F378-2867-64A8-37E4181BA42D}" dt="2021-06-20T21:30:06.432" v="564" actId="1076"/>
          <ac:picMkLst>
            <pc:docMk/>
            <pc:sldMk cId="3402779613" sldId="363"/>
            <ac:picMk id="22" creationId="{67440E68-3A8F-4076-8B8D-10C1CE1DBFE6}"/>
          </ac:picMkLst>
        </pc:picChg>
      </pc:sldChg>
      <pc:sldChg chg="modSp">
        <pc:chgData name="gsolis@northwell.edu" userId="S::urn:spo:guest#gsolis@northwell.edu::" providerId="AD" clId="Web-{52DDB257-F378-2867-64A8-37E4181BA42D}" dt="2021-06-20T21:39:54.595" v="672" actId="1076"/>
        <pc:sldMkLst>
          <pc:docMk/>
          <pc:sldMk cId="2919230525" sldId="364"/>
        </pc:sldMkLst>
        <pc:spChg chg="mod">
          <ac:chgData name="gsolis@northwell.edu" userId="S::urn:spo:guest#gsolis@northwell.edu::" providerId="AD" clId="Web-{52DDB257-F378-2867-64A8-37E4181BA42D}" dt="2021-06-20T21:39:51.126" v="671" actId="1076"/>
          <ac:spMkLst>
            <pc:docMk/>
            <pc:sldMk cId="2919230525" sldId="364"/>
            <ac:spMk id="2" creationId="{CA5A33D6-1DE4-4051-BE84-BE5B9BA99881}"/>
          </ac:spMkLst>
        </pc:spChg>
        <pc:spChg chg="mod">
          <ac:chgData name="gsolis@northwell.edu" userId="S::urn:spo:guest#gsolis@northwell.edu::" providerId="AD" clId="Web-{52DDB257-F378-2867-64A8-37E4181BA42D}" dt="2021-06-20T21:39:54.595" v="672" actId="1076"/>
          <ac:spMkLst>
            <pc:docMk/>
            <pc:sldMk cId="2919230525" sldId="364"/>
            <ac:spMk id="5" creationId="{CD3CF2C5-43A2-409E-99C0-1EFD9F2AC4DB}"/>
          </ac:spMkLst>
        </pc:spChg>
      </pc:sldChg>
      <pc:sldChg chg="modSp">
        <pc:chgData name="gsolis@northwell.edu" userId="S::urn:spo:guest#gsolis@northwell.edu::" providerId="AD" clId="Web-{52DDB257-F378-2867-64A8-37E4181BA42D}" dt="2021-06-20T21:33:00.271" v="604" actId="20577"/>
        <pc:sldMkLst>
          <pc:docMk/>
          <pc:sldMk cId="1724564863" sldId="365"/>
        </pc:sldMkLst>
        <pc:spChg chg="mod">
          <ac:chgData name="gsolis@northwell.edu" userId="S::urn:spo:guest#gsolis@northwell.edu::" providerId="AD" clId="Web-{52DDB257-F378-2867-64A8-37E4181BA42D}" dt="2021-06-20T21:33:00.271" v="604" actId="20577"/>
          <ac:spMkLst>
            <pc:docMk/>
            <pc:sldMk cId="1724564863" sldId="365"/>
            <ac:spMk id="2" creationId="{3AAAD477-D9BB-40A4-9449-4D7C7008F428}"/>
          </ac:spMkLst>
        </pc:spChg>
        <pc:spChg chg="mod">
          <ac:chgData name="gsolis@northwell.edu" userId="S::urn:spo:guest#gsolis@northwell.edu::" providerId="AD" clId="Web-{52DDB257-F378-2867-64A8-37E4181BA42D}" dt="2021-06-20T21:32:43.536" v="603" actId="14100"/>
          <ac:spMkLst>
            <pc:docMk/>
            <pc:sldMk cId="1724564863" sldId="365"/>
            <ac:spMk id="4" creationId="{FD449185-D6E9-4CB2-A221-9240F7092AAD}"/>
          </ac:spMkLst>
        </pc:spChg>
      </pc:sldChg>
      <pc:sldChg chg="modSp">
        <pc:chgData name="gsolis@northwell.edu" userId="S::urn:spo:guest#gsolis@northwell.edu::" providerId="AD" clId="Web-{52DDB257-F378-2867-64A8-37E4181BA42D}" dt="2021-06-20T21:32:09.159" v="599" actId="20577"/>
        <pc:sldMkLst>
          <pc:docMk/>
          <pc:sldMk cId="438269467" sldId="366"/>
        </pc:sldMkLst>
        <pc:spChg chg="mod">
          <ac:chgData name="gsolis@northwell.edu" userId="S::urn:spo:guest#gsolis@northwell.edu::" providerId="AD" clId="Web-{52DDB257-F378-2867-64A8-37E4181BA42D}" dt="2021-06-20T21:32:09.159" v="599" actId="20577"/>
          <ac:spMkLst>
            <pc:docMk/>
            <pc:sldMk cId="438269467" sldId="366"/>
            <ac:spMk id="4" creationId="{C13CFC8A-11F4-49EE-866B-B22665827209}"/>
          </ac:spMkLst>
        </pc:spChg>
        <pc:spChg chg="mod">
          <ac:chgData name="gsolis@northwell.edu" userId="S::urn:spo:guest#gsolis@northwell.edu::" providerId="AD" clId="Web-{52DDB257-F378-2867-64A8-37E4181BA42D}" dt="2021-06-20T21:30:53.388" v="579" actId="20577"/>
          <ac:spMkLst>
            <pc:docMk/>
            <pc:sldMk cId="438269467" sldId="366"/>
            <ac:spMk id="12" creationId="{86F0CA7B-D052-4F1A-866B-79A03300A989}"/>
          </ac:spMkLst>
        </pc:spChg>
        <pc:picChg chg="mod">
          <ac:chgData name="gsolis@northwell.edu" userId="S::urn:spo:guest#gsolis@northwell.edu::" providerId="AD" clId="Web-{52DDB257-F378-2867-64A8-37E4181BA42D}" dt="2021-06-20T21:30:59.435" v="582" actId="1076"/>
          <ac:picMkLst>
            <pc:docMk/>
            <pc:sldMk cId="438269467" sldId="366"/>
            <ac:picMk id="7" creationId="{85B4209A-3B5E-48A8-98B8-591F671B2D6F}"/>
          </ac:picMkLst>
        </pc:picChg>
      </pc:sldChg>
      <pc:sldChg chg="modSp">
        <pc:chgData name="gsolis@northwell.edu" userId="S::urn:spo:guest#gsolis@northwell.edu::" providerId="AD" clId="Web-{52DDB257-F378-2867-64A8-37E4181BA42D}" dt="2021-06-20T21:41:14.037" v="686" actId="20577"/>
        <pc:sldMkLst>
          <pc:docMk/>
          <pc:sldMk cId="2439297039" sldId="367"/>
        </pc:sldMkLst>
        <pc:spChg chg="mod">
          <ac:chgData name="gsolis@northwell.edu" userId="S::urn:spo:guest#gsolis@northwell.edu::" providerId="AD" clId="Web-{52DDB257-F378-2867-64A8-37E4181BA42D}" dt="2021-06-20T21:41:14.037" v="686" actId="20577"/>
          <ac:spMkLst>
            <pc:docMk/>
            <pc:sldMk cId="2439297039" sldId="367"/>
            <ac:spMk id="2" creationId="{9711D05B-1A6A-4785-9233-25614CFC03CE}"/>
          </ac:spMkLst>
        </pc:spChg>
        <pc:spChg chg="mod">
          <ac:chgData name="gsolis@northwell.edu" userId="S::urn:spo:guest#gsolis@northwell.edu::" providerId="AD" clId="Web-{52DDB257-F378-2867-64A8-37E4181BA42D}" dt="2021-06-20T21:15:30.640" v="354" actId="20577"/>
          <ac:spMkLst>
            <pc:docMk/>
            <pc:sldMk cId="2439297039" sldId="367"/>
            <ac:spMk id="3" creationId="{01EBB642-A9A1-4273-829D-59C1EBAD2430}"/>
          </ac:spMkLst>
        </pc:spChg>
        <pc:spChg chg="mod">
          <ac:chgData name="gsolis@northwell.edu" userId="S::urn:spo:guest#gsolis@northwell.edu::" providerId="AD" clId="Web-{52DDB257-F378-2867-64A8-37E4181BA42D}" dt="2021-06-20T21:15:46.109" v="355" actId="1076"/>
          <ac:spMkLst>
            <pc:docMk/>
            <pc:sldMk cId="2439297039" sldId="367"/>
            <ac:spMk id="7" creationId="{518690C3-F36E-4B17-A613-A958D8C0D4FC}"/>
          </ac:spMkLst>
        </pc:spChg>
      </pc:sldChg>
      <pc:sldChg chg="modSp">
        <pc:chgData name="gsolis@northwell.edu" userId="S::urn:spo:guest#gsolis@northwell.edu::" providerId="AD" clId="Web-{52DDB257-F378-2867-64A8-37E4181BA42D}" dt="2021-06-20T21:38:46.092" v="663" actId="1076"/>
        <pc:sldMkLst>
          <pc:docMk/>
          <pc:sldMk cId="673837018" sldId="368"/>
        </pc:sldMkLst>
        <pc:spChg chg="mod">
          <ac:chgData name="gsolis@northwell.edu" userId="S::urn:spo:guest#gsolis@northwell.edu::" providerId="AD" clId="Web-{52DDB257-F378-2867-64A8-37E4181BA42D}" dt="2021-06-20T20:42:55.770" v="33" actId="20577"/>
          <ac:spMkLst>
            <pc:docMk/>
            <pc:sldMk cId="673837018" sldId="368"/>
            <ac:spMk id="2" creationId="{705284E1-1F71-4FFA-81F8-09D940C3ABC8}"/>
          </ac:spMkLst>
        </pc:spChg>
        <pc:spChg chg="mod">
          <ac:chgData name="gsolis@northwell.edu" userId="S::urn:spo:guest#gsolis@northwell.edu::" providerId="AD" clId="Web-{52DDB257-F378-2867-64A8-37E4181BA42D}" dt="2021-06-20T21:38:46.092" v="663" actId="1076"/>
          <ac:spMkLst>
            <pc:docMk/>
            <pc:sldMk cId="673837018" sldId="368"/>
            <ac:spMk id="5" creationId="{BCDD241D-CA6C-4A65-8F29-B169586FA680}"/>
          </ac:spMkLst>
        </pc:spChg>
        <pc:spChg chg="mod">
          <ac:chgData name="gsolis@northwell.edu" userId="S::urn:spo:guest#gsolis@northwell.edu::" providerId="AD" clId="Web-{52DDB257-F378-2867-64A8-37E4181BA42D}" dt="2021-06-20T21:38:42.044" v="662" actId="1076"/>
          <ac:spMkLst>
            <pc:docMk/>
            <pc:sldMk cId="673837018" sldId="368"/>
            <ac:spMk id="9" creationId="{9CB767A6-5C79-4B20-8321-B927BAC24C81}"/>
          </ac:spMkLst>
        </pc:spChg>
        <pc:picChg chg="mod">
          <ac:chgData name="gsolis@northwell.edu" userId="S::urn:spo:guest#gsolis@northwell.edu::" providerId="AD" clId="Web-{52DDB257-F378-2867-64A8-37E4181BA42D}" dt="2021-06-20T21:38:11.824" v="658" actId="1076"/>
          <ac:picMkLst>
            <pc:docMk/>
            <pc:sldMk cId="673837018" sldId="368"/>
            <ac:picMk id="4" creationId="{03279B56-8CDF-4C90-B875-48253C0BBB56}"/>
          </ac:picMkLst>
        </pc:picChg>
      </pc:sldChg>
      <pc:sldChg chg="modSp">
        <pc:chgData name="gsolis@northwell.edu" userId="S::urn:spo:guest#gsolis@northwell.edu::" providerId="AD" clId="Web-{52DDB257-F378-2867-64A8-37E4181BA42D}" dt="2021-06-20T21:36:30.412" v="640" actId="1076"/>
        <pc:sldMkLst>
          <pc:docMk/>
          <pc:sldMk cId="2443411379" sldId="370"/>
        </pc:sldMkLst>
        <pc:spChg chg="mod">
          <ac:chgData name="gsolis@northwell.edu" userId="S::urn:spo:guest#gsolis@northwell.edu::" providerId="AD" clId="Web-{52DDB257-F378-2867-64A8-37E4181BA42D}" dt="2021-06-20T21:35:47.175" v="633" actId="20577"/>
          <ac:spMkLst>
            <pc:docMk/>
            <pc:sldMk cId="2443411379" sldId="370"/>
            <ac:spMk id="2" creationId="{705284E1-1F71-4FFA-81F8-09D940C3ABC8}"/>
          </ac:spMkLst>
        </pc:spChg>
        <pc:spChg chg="mod">
          <ac:chgData name="gsolis@northwell.edu" userId="S::urn:spo:guest#gsolis@northwell.edu::" providerId="AD" clId="Web-{52DDB257-F378-2867-64A8-37E4181BA42D}" dt="2021-06-20T21:36:30.412" v="640" actId="1076"/>
          <ac:spMkLst>
            <pc:docMk/>
            <pc:sldMk cId="2443411379" sldId="370"/>
            <ac:spMk id="6" creationId="{F3C68E8F-123F-496C-927A-C332423E50B6}"/>
          </ac:spMkLst>
        </pc:spChg>
        <pc:spChg chg="mod">
          <ac:chgData name="gsolis@northwell.edu" userId="S::urn:spo:guest#gsolis@northwell.edu::" providerId="AD" clId="Web-{52DDB257-F378-2867-64A8-37E4181BA42D}" dt="2021-06-20T21:36:21.709" v="639" actId="1076"/>
          <ac:spMkLst>
            <pc:docMk/>
            <pc:sldMk cId="2443411379" sldId="370"/>
            <ac:spMk id="8" creationId="{88AC11C6-E5F0-453F-9B73-EF7461D58CBE}"/>
          </ac:spMkLst>
        </pc:spChg>
      </pc:sldChg>
      <pc:sldChg chg="modSp">
        <pc:chgData name="gsolis@northwell.edu" userId="S::urn:spo:guest#gsolis@northwell.edu::" providerId="AD" clId="Web-{52DDB257-F378-2867-64A8-37E4181BA42D}" dt="2021-06-20T21:27:14.871" v="509" actId="1076"/>
        <pc:sldMkLst>
          <pc:docMk/>
          <pc:sldMk cId="504955433" sldId="371"/>
        </pc:sldMkLst>
        <pc:spChg chg="mod">
          <ac:chgData name="gsolis@northwell.edu" userId="S::urn:spo:guest#gsolis@northwell.edu::" providerId="AD" clId="Web-{52DDB257-F378-2867-64A8-37E4181BA42D}" dt="2021-06-20T21:27:04.589" v="507" actId="20577"/>
          <ac:spMkLst>
            <pc:docMk/>
            <pc:sldMk cId="504955433" sldId="371"/>
            <ac:spMk id="2" creationId="{9058C3B7-053F-4630-AEFD-94D00B3044A6}"/>
          </ac:spMkLst>
        </pc:spChg>
        <pc:spChg chg="mod">
          <ac:chgData name="gsolis@northwell.edu" userId="S::urn:spo:guest#gsolis@northwell.edu::" providerId="AD" clId="Web-{52DDB257-F378-2867-64A8-37E4181BA42D}" dt="2021-06-20T21:27:14.871" v="509" actId="1076"/>
          <ac:spMkLst>
            <pc:docMk/>
            <pc:sldMk cId="504955433" sldId="371"/>
            <ac:spMk id="3" creationId="{B6888636-DC58-482E-BB12-5029C1E6DDE2}"/>
          </ac:spMkLst>
        </pc:spChg>
        <pc:picChg chg="mod">
          <ac:chgData name="gsolis@northwell.edu" userId="S::urn:spo:guest#gsolis@northwell.edu::" providerId="AD" clId="Web-{52DDB257-F378-2867-64A8-37E4181BA42D}" dt="2021-06-20T21:27:11.355" v="508" actId="1076"/>
          <ac:picMkLst>
            <pc:docMk/>
            <pc:sldMk cId="504955433" sldId="371"/>
            <ac:picMk id="5" creationId="{B663C4E1-35D8-4479-AB72-DDC2854BB560}"/>
          </ac:picMkLst>
        </pc:picChg>
      </pc:sldChg>
      <pc:sldChg chg="modSp">
        <pc:chgData name="gsolis@northwell.edu" userId="S::urn:spo:guest#gsolis@northwell.edu::" providerId="AD" clId="Web-{52DDB257-F378-2867-64A8-37E4181BA42D}" dt="2021-06-20T21:41:49.070" v="691" actId="20577"/>
        <pc:sldMkLst>
          <pc:docMk/>
          <pc:sldMk cId="36259429" sldId="372"/>
        </pc:sldMkLst>
        <pc:spChg chg="mod">
          <ac:chgData name="gsolis@northwell.edu" userId="S::urn:spo:guest#gsolis@northwell.edu::" providerId="AD" clId="Web-{52DDB257-F378-2867-64A8-37E4181BA42D}" dt="2021-06-20T21:41:49.070" v="691" actId="20577"/>
          <ac:spMkLst>
            <pc:docMk/>
            <pc:sldMk cId="36259429" sldId="372"/>
            <ac:spMk id="2" creationId="{027D955E-96CF-4463-BEDD-8B76AD01995B}"/>
          </ac:spMkLst>
        </pc:spChg>
        <pc:spChg chg="mod">
          <ac:chgData name="gsolis@northwell.edu" userId="S::urn:spo:guest#gsolis@northwell.edu::" providerId="AD" clId="Web-{52DDB257-F378-2867-64A8-37E4181BA42D}" dt="2021-06-20T21:22:20.511" v="440" actId="20577"/>
          <ac:spMkLst>
            <pc:docMk/>
            <pc:sldMk cId="36259429" sldId="372"/>
            <ac:spMk id="4" creationId="{1E249DD4-C7D8-4241-A9F3-7E23877347D7}"/>
          </ac:spMkLst>
        </pc:spChg>
        <pc:spChg chg="mod">
          <ac:chgData name="gsolis@northwell.edu" userId="S::urn:spo:guest#gsolis@northwell.edu::" providerId="AD" clId="Web-{52DDB257-F378-2867-64A8-37E4181BA42D}" dt="2021-06-20T21:22:49.075" v="449" actId="20577"/>
          <ac:spMkLst>
            <pc:docMk/>
            <pc:sldMk cId="36259429" sldId="372"/>
            <ac:spMk id="5" creationId="{107F1D1A-74D9-4060-AD3B-05832C36F82A}"/>
          </ac:spMkLst>
        </pc:spChg>
      </pc:sldChg>
      <pc:sldChg chg="addSp modSp">
        <pc:chgData name="gsolis@northwell.edu" userId="S::urn:spo:guest#gsolis@northwell.edu::" providerId="AD" clId="Web-{52DDB257-F378-2867-64A8-37E4181BA42D}" dt="2021-06-20T20:52:27.435" v="147" actId="14100"/>
        <pc:sldMkLst>
          <pc:docMk/>
          <pc:sldMk cId="2418592727" sldId="373"/>
        </pc:sldMkLst>
        <pc:spChg chg="mod">
          <ac:chgData name="gsolis@northwell.edu" userId="S::urn:spo:guest#gsolis@northwell.edu::" providerId="AD" clId="Web-{52DDB257-F378-2867-64A8-37E4181BA42D}" dt="2021-06-20T20:51:29.213" v="137" actId="20577"/>
          <ac:spMkLst>
            <pc:docMk/>
            <pc:sldMk cId="2418592727" sldId="373"/>
            <ac:spMk id="2" creationId="{FC7ABD9D-8BDE-4579-A098-9E3D7A18F914}"/>
          </ac:spMkLst>
        </pc:spChg>
        <pc:spChg chg="add mod">
          <ac:chgData name="gsolis@northwell.edu" userId="S::urn:spo:guest#gsolis@northwell.edu::" providerId="AD" clId="Web-{52DDB257-F378-2867-64A8-37E4181BA42D}" dt="2021-06-20T20:52:27.435" v="147" actId="14100"/>
          <ac:spMkLst>
            <pc:docMk/>
            <pc:sldMk cId="2418592727" sldId="373"/>
            <ac:spMk id="3" creationId="{AB26ACB8-94F9-48F1-AC83-F44DCA055732}"/>
          </ac:spMkLst>
        </pc:spChg>
        <pc:spChg chg="mod">
          <ac:chgData name="gsolis@northwell.edu" userId="S::urn:spo:guest#gsolis@northwell.edu::" providerId="AD" clId="Web-{52DDB257-F378-2867-64A8-37E4181BA42D}" dt="2021-06-20T20:52:23.419" v="146" actId="14100"/>
          <ac:spMkLst>
            <pc:docMk/>
            <pc:sldMk cId="2418592727" sldId="373"/>
            <ac:spMk id="11" creationId="{089DD99E-0D17-4C5D-B955-09FF7808AF36}"/>
          </ac:spMkLst>
        </pc:spChg>
      </pc:sldChg>
      <pc:sldChg chg="modSp">
        <pc:chgData name="gsolis@northwell.edu" userId="S::urn:spo:guest#gsolis@northwell.edu::" providerId="AD" clId="Web-{52DDB257-F378-2867-64A8-37E4181BA42D}" dt="2021-06-20T21:00:13.255" v="195" actId="20577"/>
        <pc:sldMkLst>
          <pc:docMk/>
          <pc:sldMk cId="2338641079" sldId="374"/>
        </pc:sldMkLst>
        <pc:spChg chg="mod">
          <ac:chgData name="gsolis@northwell.edu" userId="S::urn:spo:guest#gsolis@northwell.edu::" providerId="AD" clId="Web-{52DDB257-F378-2867-64A8-37E4181BA42D}" dt="2021-06-20T21:00:13.255" v="195" actId="20577"/>
          <ac:spMkLst>
            <pc:docMk/>
            <pc:sldMk cId="2338641079" sldId="374"/>
            <ac:spMk id="2" creationId="{00000000-0000-0000-0000-000000000000}"/>
          </ac:spMkLst>
        </pc:spChg>
        <pc:spChg chg="mod">
          <ac:chgData name="gsolis@northwell.edu" userId="S::urn:spo:guest#gsolis@northwell.edu::" providerId="AD" clId="Web-{52DDB257-F378-2867-64A8-37E4181BA42D}" dt="2021-06-20T20:54:06.768" v="167" actId="20577"/>
          <ac:spMkLst>
            <pc:docMk/>
            <pc:sldMk cId="2338641079" sldId="374"/>
            <ac:spMk id="3" creationId="{00000000-0000-0000-0000-000000000000}"/>
          </ac:spMkLst>
        </pc:spChg>
      </pc:sldChg>
      <pc:sldChg chg="modSp">
        <pc:chgData name="gsolis@northwell.edu" userId="S::urn:spo:guest#gsolis@northwell.edu::" providerId="AD" clId="Web-{52DDB257-F378-2867-64A8-37E4181BA42D}" dt="2021-06-20T21:00:55.226" v="199" actId="20577"/>
        <pc:sldMkLst>
          <pc:docMk/>
          <pc:sldMk cId="3188627780" sldId="375"/>
        </pc:sldMkLst>
        <pc:spChg chg="mod">
          <ac:chgData name="gsolis@northwell.edu" userId="S::urn:spo:guest#gsolis@northwell.edu::" providerId="AD" clId="Web-{52DDB257-F378-2867-64A8-37E4181BA42D}" dt="2021-06-20T21:00:42.116" v="197" actId="20577"/>
          <ac:spMkLst>
            <pc:docMk/>
            <pc:sldMk cId="3188627780" sldId="375"/>
            <ac:spMk id="2" creationId="{00000000-0000-0000-0000-000000000000}"/>
          </ac:spMkLst>
        </pc:spChg>
        <pc:spChg chg="mod">
          <ac:chgData name="gsolis@northwell.edu" userId="S::urn:spo:guest#gsolis@northwell.edu::" providerId="AD" clId="Web-{52DDB257-F378-2867-64A8-37E4181BA42D}" dt="2021-06-20T21:00:55.226" v="199" actId="20577"/>
          <ac:spMkLst>
            <pc:docMk/>
            <pc:sldMk cId="3188627780" sldId="375"/>
            <ac:spMk id="4" creationId="{3E180195-0311-4728-AB96-0C60748A963B}"/>
          </ac:spMkLst>
        </pc:spChg>
      </pc:sldChg>
    </pc:docChg>
  </pc:docChgLst>
  <pc:docChgLst>
    <pc:chgData name="Gabrielle Goldberg" userId="S::gabrielle.goldberg@hofstra.edu::453f9b71-f7a4-4ef4-8e34-bbb69381dfc0" providerId="AD" clId="Web-{95BA158B-3472-08EB-1A24-87C3D6C26869}"/>
    <pc:docChg chg="addSld delSld modSld">
      <pc:chgData name="Gabrielle Goldberg" userId="S::gabrielle.goldberg@hofstra.edu::453f9b71-f7a4-4ef4-8e34-bbb69381dfc0" providerId="AD" clId="Web-{95BA158B-3472-08EB-1A24-87C3D6C26869}" dt="2022-01-09T16:13:18.790" v="276" actId="20577"/>
      <pc:docMkLst>
        <pc:docMk/>
      </pc:docMkLst>
      <pc:sldChg chg="addSp modSp mod setBg">
        <pc:chgData name="Gabrielle Goldberg" userId="S::gabrielle.goldberg@hofstra.edu::453f9b71-f7a4-4ef4-8e34-bbb69381dfc0" providerId="AD" clId="Web-{95BA158B-3472-08EB-1A24-87C3D6C26869}" dt="2022-01-09T15:44:42.656" v="202"/>
        <pc:sldMkLst>
          <pc:docMk/>
          <pc:sldMk cId="659258882" sldId="316"/>
        </pc:sldMkLst>
        <pc:spChg chg="mod">
          <ac:chgData name="Gabrielle Goldberg" userId="S::gabrielle.goldberg@hofstra.edu::453f9b71-f7a4-4ef4-8e34-bbb69381dfc0" providerId="AD" clId="Web-{95BA158B-3472-08EB-1A24-87C3D6C26869}" dt="2022-01-09T15:44:42.656" v="202"/>
          <ac:spMkLst>
            <pc:docMk/>
            <pc:sldMk cId="659258882" sldId="316"/>
            <ac:spMk id="2" creationId="{00000000-0000-0000-0000-000000000000}"/>
          </ac:spMkLst>
        </pc:spChg>
        <pc:spChg chg="mod">
          <ac:chgData name="Gabrielle Goldberg" userId="S::gabrielle.goldberg@hofstra.edu::453f9b71-f7a4-4ef4-8e34-bbb69381dfc0" providerId="AD" clId="Web-{95BA158B-3472-08EB-1A24-87C3D6C26869}" dt="2022-01-09T15:44:42.656" v="202"/>
          <ac:spMkLst>
            <pc:docMk/>
            <pc:sldMk cId="659258882" sldId="316"/>
            <ac:spMk id="4" creationId="{21C1E623-F543-4D3B-8E1A-B50D58553900}"/>
          </ac:spMkLst>
        </pc:spChg>
        <pc:spChg chg="add">
          <ac:chgData name="Gabrielle Goldberg" userId="S::gabrielle.goldberg@hofstra.edu::453f9b71-f7a4-4ef4-8e34-bbb69381dfc0" providerId="AD" clId="Web-{95BA158B-3472-08EB-1A24-87C3D6C26869}" dt="2022-01-09T15:44:42.656" v="202"/>
          <ac:spMkLst>
            <pc:docMk/>
            <pc:sldMk cId="659258882" sldId="316"/>
            <ac:spMk id="10" creationId="{2B97F24A-32CE-4C1C-A50D-3016B394DCFB}"/>
          </ac:spMkLst>
        </pc:spChg>
        <pc:spChg chg="add">
          <ac:chgData name="Gabrielle Goldberg" userId="S::gabrielle.goldberg@hofstra.edu::453f9b71-f7a4-4ef4-8e34-bbb69381dfc0" providerId="AD" clId="Web-{95BA158B-3472-08EB-1A24-87C3D6C26869}" dt="2022-01-09T15:44:42.656" v="202"/>
          <ac:spMkLst>
            <pc:docMk/>
            <pc:sldMk cId="659258882" sldId="316"/>
            <ac:spMk id="12" creationId="{CD8B4F24-440B-49E9-B85D-733523DC064B}"/>
          </ac:spMkLst>
        </pc:spChg>
        <pc:picChg chg="mod ord">
          <ac:chgData name="Gabrielle Goldberg" userId="S::gabrielle.goldberg@hofstra.edu::453f9b71-f7a4-4ef4-8e34-bbb69381dfc0" providerId="AD" clId="Web-{95BA158B-3472-08EB-1A24-87C3D6C26869}" dt="2022-01-09T15:44:42.656" v="202"/>
          <ac:picMkLst>
            <pc:docMk/>
            <pc:sldMk cId="659258882" sldId="316"/>
            <ac:picMk id="5" creationId="{CDF35EC7-FE28-4B97-99F5-11B79C9B045A}"/>
          </ac:picMkLst>
        </pc:picChg>
      </pc:sldChg>
      <pc:sldChg chg="modSp del">
        <pc:chgData name="Gabrielle Goldberg" userId="S::gabrielle.goldberg@hofstra.edu::453f9b71-f7a4-4ef4-8e34-bbb69381dfc0" providerId="AD" clId="Web-{95BA158B-3472-08EB-1A24-87C3D6C26869}" dt="2022-01-09T15:35:22.339" v="184"/>
        <pc:sldMkLst>
          <pc:docMk/>
          <pc:sldMk cId="1011963421" sldId="351"/>
        </pc:sldMkLst>
        <pc:spChg chg="mod">
          <ac:chgData name="Gabrielle Goldberg" userId="S::gabrielle.goldberg@hofstra.edu::453f9b71-f7a4-4ef4-8e34-bbb69381dfc0" providerId="AD" clId="Web-{95BA158B-3472-08EB-1A24-87C3D6C26869}" dt="2022-01-09T15:27:29.967" v="1" actId="20577"/>
          <ac:spMkLst>
            <pc:docMk/>
            <pc:sldMk cId="1011963421" sldId="351"/>
            <ac:spMk id="7" creationId="{00000000-0000-0000-0000-000000000000}"/>
          </ac:spMkLst>
        </pc:spChg>
      </pc:sldChg>
      <pc:sldChg chg="modSp">
        <pc:chgData name="Gabrielle Goldberg" userId="S::gabrielle.goldberg@hofstra.edu::453f9b71-f7a4-4ef4-8e34-bbb69381dfc0" providerId="AD" clId="Web-{95BA158B-3472-08EB-1A24-87C3D6C26869}" dt="2022-01-09T16:02:16.969" v="213" actId="20577"/>
        <pc:sldMkLst>
          <pc:docMk/>
          <pc:sldMk cId="3459968171" sldId="411"/>
        </pc:sldMkLst>
        <pc:spChg chg="mod">
          <ac:chgData name="Gabrielle Goldberg" userId="S::gabrielle.goldberg@hofstra.edu::453f9b71-f7a4-4ef4-8e34-bbb69381dfc0" providerId="AD" clId="Web-{95BA158B-3472-08EB-1A24-87C3D6C26869}" dt="2022-01-09T16:02:16.969" v="213" actId="20577"/>
          <ac:spMkLst>
            <pc:docMk/>
            <pc:sldMk cId="3459968171" sldId="411"/>
            <ac:spMk id="2" creationId="{1B25B5AE-101B-4598-9301-A7C3DA5C0A93}"/>
          </ac:spMkLst>
        </pc:spChg>
      </pc:sldChg>
      <pc:sldChg chg="addSp delSp modSp mod modClrScheme delDesignElem chgLayout">
        <pc:chgData name="Gabrielle Goldberg" userId="S::gabrielle.goldberg@hofstra.edu::453f9b71-f7a4-4ef4-8e34-bbb69381dfc0" providerId="AD" clId="Web-{95BA158B-3472-08EB-1A24-87C3D6C26869}" dt="2022-01-09T16:04:44.072" v="255" actId="1076"/>
        <pc:sldMkLst>
          <pc:docMk/>
          <pc:sldMk cId="162437508" sldId="412"/>
        </pc:sldMkLst>
        <pc:spChg chg="mod ord">
          <ac:chgData name="Gabrielle Goldberg" userId="S::gabrielle.goldberg@hofstra.edu::453f9b71-f7a4-4ef4-8e34-bbb69381dfc0" providerId="AD" clId="Web-{95BA158B-3472-08EB-1A24-87C3D6C26869}" dt="2022-01-09T16:03:09.722" v="227" actId="20577"/>
          <ac:spMkLst>
            <pc:docMk/>
            <pc:sldMk cId="162437508" sldId="412"/>
            <ac:spMk id="2" creationId="{DEF982F6-EF45-43D4-9379-C9D0714B15DB}"/>
          </ac:spMkLst>
        </pc:spChg>
        <pc:spChg chg="del mod ord">
          <ac:chgData name="Gabrielle Goldberg" userId="S::gabrielle.goldberg@hofstra.edu::453f9b71-f7a4-4ef4-8e34-bbb69381dfc0" providerId="AD" clId="Web-{95BA158B-3472-08EB-1A24-87C3D6C26869}" dt="2022-01-09T16:01:36.357" v="206"/>
          <ac:spMkLst>
            <pc:docMk/>
            <pc:sldMk cId="162437508" sldId="412"/>
            <ac:spMk id="4" creationId="{1F2141DF-2FD7-4677-B650-879DDCE4CE12}"/>
          </ac:spMkLst>
        </pc:spChg>
        <pc:spChg chg="add del mod ord">
          <ac:chgData name="Gabrielle Goldberg" userId="S::gabrielle.goldberg@hofstra.edu::453f9b71-f7a4-4ef4-8e34-bbb69381dfc0" providerId="AD" clId="Web-{95BA158B-3472-08EB-1A24-87C3D6C26869}" dt="2022-01-09T16:02:44.861" v="225"/>
          <ac:spMkLst>
            <pc:docMk/>
            <pc:sldMk cId="162437508" sldId="412"/>
            <ac:spMk id="5" creationId="{51CA8824-B909-4AC5-BC01-6A9216C30F4C}"/>
          </ac:spMkLst>
        </pc:spChg>
        <pc:spChg chg="del">
          <ac:chgData name="Gabrielle Goldberg" userId="S::gabrielle.goldberg@hofstra.edu::453f9b71-f7a4-4ef4-8e34-bbb69381dfc0" providerId="AD" clId="Web-{95BA158B-3472-08EB-1A24-87C3D6C26869}" dt="2022-01-09T16:01:12.387" v="204"/>
          <ac:spMkLst>
            <pc:docMk/>
            <pc:sldMk cId="162437508" sldId="412"/>
            <ac:spMk id="8" creationId="{9F84346E-6A4D-4404-891F-D0F1081382A7}"/>
          </ac:spMkLst>
        </pc:spChg>
        <pc:spChg chg="add mod">
          <ac:chgData name="Gabrielle Goldberg" userId="S::gabrielle.goldberg@hofstra.edu::453f9b71-f7a4-4ef4-8e34-bbb69381dfc0" providerId="AD" clId="Web-{95BA158B-3472-08EB-1A24-87C3D6C26869}" dt="2022-01-09T16:01:43.280" v="209" actId="20577"/>
          <ac:spMkLst>
            <pc:docMk/>
            <pc:sldMk cId="162437508" sldId="412"/>
            <ac:spMk id="10" creationId="{A24E8223-70D1-41D8-9E71-20F6F80F3BA3}"/>
          </ac:spMkLst>
        </pc:spChg>
        <pc:spChg chg="add del">
          <ac:chgData name="Gabrielle Goldberg" userId="S::gabrielle.goldberg@hofstra.edu::453f9b71-f7a4-4ef4-8e34-bbb69381dfc0" providerId="AD" clId="Web-{95BA158B-3472-08EB-1A24-87C3D6C26869}" dt="2022-01-09T16:02:44.861" v="225"/>
          <ac:spMkLst>
            <pc:docMk/>
            <pc:sldMk cId="162437508" sldId="412"/>
            <ac:spMk id="16" creationId="{BACC6370-2D7E-4714-9D71-7542949D7D5D}"/>
          </ac:spMkLst>
        </pc:spChg>
        <pc:spChg chg="add del">
          <ac:chgData name="Gabrielle Goldberg" userId="S::gabrielle.goldberg@hofstra.edu::453f9b71-f7a4-4ef4-8e34-bbb69381dfc0" providerId="AD" clId="Web-{95BA158B-3472-08EB-1A24-87C3D6C26869}" dt="2022-01-09T16:02:44.861" v="225"/>
          <ac:spMkLst>
            <pc:docMk/>
            <pc:sldMk cId="162437508" sldId="412"/>
            <ac:spMk id="18" creationId="{256B2C21-A230-48C0-8DF1-C46611373C44}"/>
          </ac:spMkLst>
        </pc:spChg>
        <pc:spChg chg="add mod">
          <ac:chgData name="Gabrielle Goldberg" userId="S::gabrielle.goldberg@hofstra.edu::453f9b71-f7a4-4ef4-8e34-bbb69381dfc0" providerId="AD" clId="Web-{95BA158B-3472-08EB-1A24-87C3D6C26869}" dt="2022-01-09T16:04:44.072" v="255" actId="1076"/>
          <ac:spMkLst>
            <pc:docMk/>
            <pc:sldMk cId="162437508" sldId="412"/>
            <ac:spMk id="19" creationId="{9B180ABE-F388-4A99-A29D-DADED593A780}"/>
          </ac:spMkLst>
        </pc:spChg>
        <pc:spChg chg="add del">
          <ac:chgData name="Gabrielle Goldberg" userId="S::gabrielle.goldberg@hofstra.edu::453f9b71-f7a4-4ef4-8e34-bbb69381dfc0" providerId="AD" clId="Web-{95BA158B-3472-08EB-1A24-87C3D6C26869}" dt="2022-01-09T16:02:44.861" v="225"/>
          <ac:spMkLst>
            <pc:docMk/>
            <pc:sldMk cId="162437508" sldId="412"/>
            <ac:spMk id="20" creationId="{3847E18C-932D-4C95-AABA-FEC7C9499AD7}"/>
          </ac:spMkLst>
        </pc:spChg>
        <pc:spChg chg="add del">
          <ac:chgData name="Gabrielle Goldberg" userId="S::gabrielle.goldberg@hofstra.edu::453f9b71-f7a4-4ef4-8e34-bbb69381dfc0" providerId="AD" clId="Web-{95BA158B-3472-08EB-1A24-87C3D6C26869}" dt="2022-01-09T16:02:44.861" v="225"/>
          <ac:spMkLst>
            <pc:docMk/>
            <pc:sldMk cId="162437508" sldId="412"/>
            <ac:spMk id="22" creationId="{3150CB11-0C61-439E-910F-5787759E72A0}"/>
          </ac:spMkLst>
        </pc:spChg>
        <pc:spChg chg="add del">
          <ac:chgData name="Gabrielle Goldberg" userId="S::gabrielle.goldberg@hofstra.edu::453f9b71-f7a4-4ef4-8e34-bbb69381dfc0" providerId="AD" clId="Web-{95BA158B-3472-08EB-1A24-87C3D6C26869}" dt="2022-01-09T16:02:44.861" v="225"/>
          <ac:spMkLst>
            <pc:docMk/>
            <pc:sldMk cId="162437508" sldId="412"/>
            <ac:spMk id="24" creationId="{43F8A58B-5155-44CE-A5FF-7647B47D0A7A}"/>
          </ac:spMkLst>
        </pc:spChg>
        <pc:spChg chg="add del">
          <ac:chgData name="Gabrielle Goldberg" userId="S::gabrielle.goldberg@hofstra.edu::453f9b71-f7a4-4ef4-8e34-bbb69381dfc0" providerId="AD" clId="Web-{95BA158B-3472-08EB-1A24-87C3D6C26869}" dt="2022-01-09T16:02:44.861" v="225"/>
          <ac:spMkLst>
            <pc:docMk/>
            <pc:sldMk cId="162437508" sldId="412"/>
            <ac:spMk id="26" creationId="{443F2ACA-E6D6-4028-82DD-F03C262D5DE6}"/>
          </ac:spMkLst>
        </pc:spChg>
        <pc:graphicFrameChg chg="add del">
          <ac:chgData name="Gabrielle Goldberg" userId="S::gabrielle.goldberg@hofstra.edu::453f9b71-f7a4-4ef4-8e34-bbb69381dfc0" providerId="AD" clId="Web-{95BA158B-3472-08EB-1A24-87C3D6C26869}" dt="2022-01-09T16:02:44.861" v="225"/>
          <ac:graphicFrameMkLst>
            <pc:docMk/>
            <pc:sldMk cId="162437508" sldId="412"/>
            <ac:graphicFrameMk id="13" creationId="{6873C00F-0415-49E3-8AD1-D81E7635E88C}"/>
          </ac:graphicFrameMkLst>
        </pc:graphicFrameChg>
        <pc:picChg chg="del">
          <ac:chgData name="Gabrielle Goldberg" userId="S::gabrielle.goldberg@hofstra.edu::453f9b71-f7a4-4ef4-8e34-bbb69381dfc0" providerId="AD" clId="Web-{95BA158B-3472-08EB-1A24-87C3D6C26869}" dt="2022-01-09T16:01:07.949" v="203"/>
          <ac:picMkLst>
            <pc:docMk/>
            <pc:sldMk cId="162437508" sldId="412"/>
            <ac:picMk id="7" creationId="{F01F3D4A-C680-4971-B425-3E45339BB625}"/>
          </ac:picMkLst>
        </pc:picChg>
        <pc:cxnChg chg="del">
          <ac:chgData name="Gabrielle Goldberg" userId="S::gabrielle.goldberg@hofstra.edu::453f9b71-f7a4-4ef4-8e34-bbb69381dfc0" providerId="AD" clId="Web-{95BA158B-3472-08EB-1A24-87C3D6C26869}" dt="2022-01-09T16:01:27.701" v="205"/>
          <ac:cxnSpMkLst>
            <pc:docMk/>
            <pc:sldMk cId="162437508" sldId="412"/>
            <ac:cxnSpMk id="12" creationId="{A7F400EE-A8A5-48AF-B4D6-291B52C6F0B0}"/>
          </ac:cxnSpMkLst>
        </pc:cxnChg>
      </pc:sldChg>
      <pc:sldChg chg="new del">
        <pc:chgData name="Gabrielle Goldberg" userId="S::gabrielle.goldberg@hofstra.edu::453f9b71-f7a4-4ef4-8e34-bbb69381dfc0" providerId="AD" clId="Web-{95BA158B-3472-08EB-1A24-87C3D6C26869}" dt="2022-01-09T15:29:21.255" v="6"/>
        <pc:sldMkLst>
          <pc:docMk/>
          <pc:sldMk cId="3253622433" sldId="413"/>
        </pc:sldMkLst>
      </pc:sldChg>
      <pc:sldChg chg="modSp new del">
        <pc:chgData name="Gabrielle Goldberg" userId="S::gabrielle.goldberg@hofstra.edu::453f9b71-f7a4-4ef4-8e34-bbb69381dfc0" providerId="AD" clId="Web-{95BA158B-3472-08EB-1A24-87C3D6C26869}" dt="2022-01-09T15:30:15.367" v="13"/>
        <pc:sldMkLst>
          <pc:docMk/>
          <pc:sldMk cId="1790698313" sldId="414"/>
        </pc:sldMkLst>
        <pc:spChg chg="mod">
          <ac:chgData name="Gabrielle Goldberg" userId="S::gabrielle.goldberg@hofstra.edu::453f9b71-f7a4-4ef4-8e34-bbb69381dfc0" providerId="AD" clId="Web-{95BA158B-3472-08EB-1A24-87C3D6C26869}" dt="2022-01-09T15:29:45.084" v="11" actId="20577"/>
          <ac:spMkLst>
            <pc:docMk/>
            <pc:sldMk cId="1790698313" sldId="414"/>
            <ac:spMk id="2" creationId="{428EB73C-5303-4513-BFAB-FECBDE8613F5}"/>
          </ac:spMkLst>
        </pc:spChg>
      </pc:sldChg>
      <pc:sldChg chg="new del">
        <pc:chgData name="Gabrielle Goldberg" userId="S::gabrielle.goldberg@hofstra.edu::453f9b71-f7a4-4ef4-8e34-bbb69381dfc0" providerId="AD" clId="Web-{95BA158B-3472-08EB-1A24-87C3D6C26869}" dt="2022-01-09T15:29:06.020" v="4"/>
        <pc:sldMkLst>
          <pc:docMk/>
          <pc:sldMk cId="1871149838" sldId="414"/>
        </pc:sldMkLst>
      </pc:sldChg>
      <pc:sldChg chg="addSp delSp modSp add mod replId modClrScheme chgLayout">
        <pc:chgData name="Gabrielle Goldberg" userId="S::gabrielle.goldberg@hofstra.edu::453f9b71-f7a4-4ef4-8e34-bbb69381dfc0" providerId="AD" clId="Web-{95BA158B-3472-08EB-1A24-87C3D6C26869}" dt="2022-01-09T16:13:18.790" v="276" actId="20577"/>
        <pc:sldMkLst>
          <pc:docMk/>
          <pc:sldMk cId="1387611884" sldId="415"/>
        </pc:sldMkLst>
        <pc:spChg chg="add del mod ord">
          <ac:chgData name="Gabrielle Goldberg" userId="S::gabrielle.goldberg@hofstra.edu::453f9b71-f7a4-4ef4-8e34-bbb69381dfc0" providerId="AD" clId="Web-{95BA158B-3472-08EB-1A24-87C3D6C26869}" dt="2022-01-09T15:30:40.635" v="22"/>
          <ac:spMkLst>
            <pc:docMk/>
            <pc:sldMk cId="1387611884" sldId="415"/>
            <ac:spMk id="2" creationId="{6BE7249C-B962-4015-876E-D11A42A21EF1}"/>
          </ac:spMkLst>
        </pc:spChg>
        <pc:spChg chg="del">
          <ac:chgData name="Gabrielle Goldberg" userId="S::gabrielle.goldberg@hofstra.edu::453f9b71-f7a4-4ef4-8e34-bbb69381dfc0" providerId="AD" clId="Web-{95BA158B-3472-08EB-1A24-87C3D6C26869}" dt="2022-01-09T15:30:19.524" v="14"/>
          <ac:spMkLst>
            <pc:docMk/>
            <pc:sldMk cId="1387611884" sldId="415"/>
            <ac:spMk id="3" creationId="{1BE62FCB-5573-45B3-978E-C00C705D52B7}"/>
          </ac:spMkLst>
        </pc:spChg>
        <pc:spChg chg="add mod ord">
          <ac:chgData name="Gabrielle Goldberg" userId="S::gabrielle.goldberg@hofstra.edu::453f9b71-f7a4-4ef4-8e34-bbb69381dfc0" providerId="AD" clId="Web-{95BA158B-3472-08EB-1A24-87C3D6C26869}" dt="2022-01-09T16:13:18.790" v="276" actId="20577"/>
          <ac:spMkLst>
            <pc:docMk/>
            <pc:sldMk cId="1387611884" sldId="415"/>
            <ac:spMk id="4" creationId="{76A99C90-F5FF-4D70-B824-644F0A4974E6}"/>
          </ac:spMkLst>
        </pc:spChg>
        <pc:spChg chg="del">
          <ac:chgData name="Gabrielle Goldberg" userId="S::gabrielle.goldberg@hofstra.edu::453f9b71-f7a4-4ef4-8e34-bbb69381dfc0" providerId="AD" clId="Web-{95BA158B-3472-08EB-1A24-87C3D6C26869}" dt="2022-01-09T15:30:21.696" v="16"/>
          <ac:spMkLst>
            <pc:docMk/>
            <pc:sldMk cId="1387611884" sldId="415"/>
            <ac:spMk id="5" creationId="{3AE9DC14-8EBE-4E3B-8519-C0441D860449}"/>
          </ac:spMkLst>
        </pc:spChg>
        <pc:spChg chg="mod">
          <ac:chgData name="Gabrielle Goldberg" userId="S::gabrielle.goldberg@hofstra.edu::453f9b71-f7a4-4ef4-8e34-bbb69381dfc0" providerId="AD" clId="Web-{95BA158B-3472-08EB-1A24-87C3D6C26869}" dt="2022-01-09T16:11:08.704" v="256" actId="20577"/>
          <ac:spMkLst>
            <pc:docMk/>
            <pc:sldMk cId="1387611884" sldId="415"/>
            <ac:spMk id="7" creationId="{00000000-0000-0000-0000-000000000000}"/>
          </ac:spMkLst>
        </pc:spChg>
        <pc:spChg chg="del">
          <ac:chgData name="Gabrielle Goldberg" userId="S::gabrielle.goldberg@hofstra.edu::453f9b71-f7a4-4ef4-8e34-bbb69381dfc0" providerId="AD" clId="Web-{95BA158B-3472-08EB-1A24-87C3D6C26869}" dt="2022-01-09T15:30:24.071" v="18"/>
          <ac:spMkLst>
            <pc:docMk/>
            <pc:sldMk cId="1387611884" sldId="415"/>
            <ac:spMk id="9" creationId="{48C35BFE-7B1A-4EA5-9229-2EFD926808A8}"/>
          </ac:spMkLst>
        </pc:spChg>
        <pc:spChg chg="del">
          <ac:chgData name="Gabrielle Goldberg" userId="S::gabrielle.goldberg@hofstra.edu::453f9b71-f7a4-4ef4-8e34-bbb69381dfc0" providerId="AD" clId="Web-{95BA158B-3472-08EB-1A24-87C3D6C26869}" dt="2022-01-09T15:30:26.618" v="20"/>
          <ac:spMkLst>
            <pc:docMk/>
            <pc:sldMk cId="1387611884" sldId="415"/>
            <ac:spMk id="11" creationId="{6D880126-DD1E-40F6-A3F7-326DDBA2497F}"/>
          </ac:spMkLst>
        </pc:spChg>
        <pc:cxnChg chg="del">
          <ac:chgData name="Gabrielle Goldberg" userId="S::gabrielle.goldberg@hofstra.edu::453f9b71-f7a4-4ef4-8e34-bbb69381dfc0" providerId="AD" clId="Web-{95BA158B-3472-08EB-1A24-87C3D6C26869}" dt="2022-01-09T15:30:24.962" v="19"/>
          <ac:cxnSpMkLst>
            <pc:docMk/>
            <pc:sldMk cId="1387611884" sldId="415"/>
            <ac:cxnSpMk id="10" creationId="{B05DB28F-5C80-4585-9D5B-F54BA378D9C9}"/>
          </ac:cxnSpMkLst>
        </pc:cxnChg>
        <pc:cxnChg chg="del">
          <ac:chgData name="Gabrielle Goldberg" userId="S::gabrielle.goldberg@hofstra.edu::453f9b71-f7a4-4ef4-8e34-bbb69381dfc0" providerId="AD" clId="Web-{95BA158B-3472-08EB-1A24-87C3D6C26869}" dt="2022-01-09T15:30:22.524" v="17"/>
          <ac:cxnSpMkLst>
            <pc:docMk/>
            <pc:sldMk cId="1387611884" sldId="415"/>
            <ac:cxnSpMk id="12" creationId="{06193CF9-F84B-44A7-B187-1340D6A52411}"/>
          </ac:cxnSpMkLst>
        </pc:cxnChg>
        <pc:cxnChg chg="del">
          <ac:chgData name="Gabrielle Goldberg" userId="S::gabrielle.goldberg@hofstra.edu::453f9b71-f7a4-4ef4-8e34-bbb69381dfc0" providerId="AD" clId="Web-{95BA158B-3472-08EB-1A24-87C3D6C26869}" dt="2022-01-09T15:30:20.352" v="15"/>
          <ac:cxnSpMkLst>
            <pc:docMk/>
            <pc:sldMk cId="1387611884" sldId="415"/>
            <ac:cxnSpMk id="13" creationId="{C6111CE0-EFA6-4D2B-A665-B58ECF307DAE}"/>
          </ac:cxnSpMkLst>
        </pc:cxnChg>
      </pc:sldChg>
    </pc:docChg>
  </pc:docChgLst>
  <pc:docChgLst>
    <pc:chgData name="kimberly.kranz@stonybrookmedicine.edu" userId="S::urn:spo:guest#kimberly.kranz@stonybrookmedicine.edu::" providerId="AD" clId="Web-{1ADADB44-EF6F-3F0E-113E-B701DBF00299}"/>
    <pc:docChg chg="modSld">
      <pc:chgData name="kimberly.kranz@stonybrookmedicine.edu" userId="S::urn:spo:guest#kimberly.kranz@stonybrookmedicine.edu::" providerId="AD" clId="Web-{1ADADB44-EF6F-3F0E-113E-B701DBF00299}" dt="2021-10-11T16:31:51.719" v="11" actId="20577"/>
      <pc:docMkLst>
        <pc:docMk/>
      </pc:docMkLst>
      <pc:sldChg chg="modSp">
        <pc:chgData name="kimberly.kranz@stonybrookmedicine.edu" userId="S::urn:spo:guest#kimberly.kranz@stonybrookmedicine.edu::" providerId="AD" clId="Web-{1ADADB44-EF6F-3F0E-113E-B701DBF00299}" dt="2021-10-11T16:31:51.719" v="11" actId="20577"/>
        <pc:sldMkLst>
          <pc:docMk/>
          <pc:sldMk cId="2439297039" sldId="367"/>
        </pc:sldMkLst>
        <pc:spChg chg="mod">
          <ac:chgData name="kimberly.kranz@stonybrookmedicine.edu" userId="S::urn:spo:guest#kimberly.kranz@stonybrookmedicine.edu::" providerId="AD" clId="Web-{1ADADB44-EF6F-3F0E-113E-B701DBF00299}" dt="2021-10-11T16:31:51.719" v="11" actId="20577"/>
          <ac:spMkLst>
            <pc:docMk/>
            <pc:sldMk cId="2439297039" sldId="367"/>
            <ac:spMk id="3" creationId="{01EBB642-A9A1-4273-829D-59C1EBAD2430}"/>
          </ac:spMkLst>
        </pc:spChg>
      </pc:sldChg>
      <pc:sldChg chg="modSp">
        <pc:chgData name="kimberly.kranz@stonybrookmedicine.edu" userId="S::urn:spo:guest#kimberly.kranz@stonybrookmedicine.edu::" providerId="AD" clId="Web-{1ADADB44-EF6F-3F0E-113E-B701DBF00299}" dt="2021-10-11T16:06:41.089" v="4" actId="20577"/>
        <pc:sldMkLst>
          <pc:docMk/>
          <pc:sldMk cId="3695886494" sldId="377"/>
        </pc:sldMkLst>
        <pc:spChg chg="mod">
          <ac:chgData name="kimberly.kranz@stonybrookmedicine.edu" userId="S::urn:spo:guest#kimberly.kranz@stonybrookmedicine.edu::" providerId="AD" clId="Web-{1ADADB44-EF6F-3F0E-113E-B701DBF00299}" dt="2021-10-11T16:06:41.089" v="4" actId="20577"/>
          <ac:spMkLst>
            <pc:docMk/>
            <pc:sldMk cId="3695886494" sldId="377"/>
            <ac:spMk id="5" creationId="{7CACB6FB-1027-4FD0-8C7E-D2E2B4263D4D}"/>
          </ac:spMkLst>
        </pc:spChg>
      </pc:sldChg>
      <pc:sldChg chg="modSp">
        <pc:chgData name="kimberly.kranz@stonybrookmedicine.edu" userId="S::urn:spo:guest#kimberly.kranz@stonybrookmedicine.edu::" providerId="AD" clId="Web-{1ADADB44-EF6F-3F0E-113E-B701DBF00299}" dt="2021-10-11T16:14:45.585" v="6" actId="20577"/>
        <pc:sldMkLst>
          <pc:docMk/>
          <pc:sldMk cId="1104129155" sldId="390"/>
        </pc:sldMkLst>
        <pc:spChg chg="mod">
          <ac:chgData name="kimberly.kranz@stonybrookmedicine.edu" userId="S::urn:spo:guest#kimberly.kranz@stonybrookmedicine.edu::" providerId="AD" clId="Web-{1ADADB44-EF6F-3F0E-113E-B701DBF00299}" dt="2021-10-11T16:14:45.585" v="6" actId="20577"/>
          <ac:spMkLst>
            <pc:docMk/>
            <pc:sldMk cId="1104129155" sldId="390"/>
            <ac:spMk id="6" creationId="{00000000-0000-0000-0000-000000000000}"/>
          </ac:spMkLst>
        </pc:spChg>
      </pc:sldChg>
      <pc:sldChg chg="modSp">
        <pc:chgData name="kimberly.kranz@stonybrookmedicine.edu" userId="S::urn:spo:guest#kimberly.kranz@stonybrookmedicine.edu::" providerId="AD" clId="Web-{1ADADB44-EF6F-3F0E-113E-B701DBF00299}" dt="2021-10-11T16:18:09.356" v="8" actId="20577"/>
        <pc:sldMkLst>
          <pc:docMk/>
          <pc:sldMk cId="198615434" sldId="392"/>
        </pc:sldMkLst>
        <pc:spChg chg="mod">
          <ac:chgData name="kimberly.kranz@stonybrookmedicine.edu" userId="S::urn:spo:guest#kimberly.kranz@stonybrookmedicine.edu::" providerId="AD" clId="Web-{1ADADB44-EF6F-3F0E-113E-B701DBF00299}" dt="2021-10-11T16:18:09.356" v="8" actId="20577"/>
          <ac:spMkLst>
            <pc:docMk/>
            <pc:sldMk cId="198615434" sldId="392"/>
            <ac:spMk id="6" creationId="{00000000-0000-0000-0000-000000000000}"/>
          </ac:spMkLst>
        </pc:spChg>
      </pc:sldChg>
    </pc:docChg>
  </pc:docChgLst>
  <pc:docChgLst>
    <pc:chgData name="dra.gabrielasolis@gmail.com" userId="S::urn:spo:guest#dra.gabrielasolis@gmail.com::" providerId="AD" clId="Web-{1A08A5F9-82A6-A790-C6BA-FE6DD6B6E5D4}"/>
    <pc:docChg chg="modSld">
      <pc:chgData name="dra.gabrielasolis@gmail.com" userId="S::urn:spo:guest#dra.gabrielasolis@gmail.com::" providerId="AD" clId="Web-{1A08A5F9-82A6-A790-C6BA-FE6DD6B6E5D4}" dt="2021-10-10T15:22:28.526" v="159" actId="20577"/>
      <pc:docMkLst>
        <pc:docMk/>
      </pc:docMkLst>
      <pc:sldChg chg="modSp">
        <pc:chgData name="dra.gabrielasolis@gmail.com" userId="S::urn:spo:guest#dra.gabrielasolis@gmail.com::" providerId="AD" clId="Web-{1A08A5F9-82A6-A790-C6BA-FE6DD6B6E5D4}" dt="2021-10-10T15:20:36.884" v="149" actId="20577"/>
        <pc:sldMkLst>
          <pc:docMk/>
          <pc:sldMk cId="659258882" sldId="316"/>
        </pc:sldMkLst>
        <pc:spChg chg="mod">
          <ac:chgData name="dra.gabrielasolis@gmail.com" userId="S::urn:spo:guest#dra.gabrielasolis@gmail.com::" providerId="AD" clId="Web-{1A08A5F9-82A6-A790-C6BA-FE6DD6B6E5D4}" dt="2021-10-10T15:20:36.884" v="149" actId="20577"/>
          <ac:spMkLst>
            <pc:docMk/>
            <pc:sldMk cId="659258882" sldId="316"/>
            <ac:spMk id="4" creationId="{21C1E623-F543-4D3B-8E1A-B50D58553900}"/>
          </ac:spMkLst>
        </pc:spChg>
      </pc:sldChg>
      <pc:sldChg chg="modSp">
        <pc:chgData name="dra.gabrielasolis@gmail.com" userId="S::urn:spo:guest#dra.gabrielasolis@gmail.com::" providerId="AD" clId="Web-{1A08A5F9-82A6-A790-C6BA-FE6DD6B6E5D4}" dt="2021-10-10T15:22:28.526" v="159" actId="20577"/>
        <pc:sldMkLst>
          <pc:docMk/>
          <pc:sldMk cId="3375007296" sldId="380"/>
        </pc:sldMkLst>
        <pc:spChg chg="mod">
          <ac:chgData name="dra.gabrielasolis@gmail.com" userId="S::urn:spo:guest#dra.gabrielasolis@gmail.com::" providerId="AD" clId="Web-{1A08A5F9-82A6-A790-C6BA-FE6DD6B6E5D4}" dt="2021-10-10T15:22:28.526" v="159" actId="20577"/>
          <ac:spMkLst>
            <pc:docMk/>
            <pc:sldMk cId="3375007296" sldId="380"/>
            <ac:spMk id="3" creationId="{732813B5-3B16-4C39-9B26-980756C16563}"/>
          </ac:spMkLst>
        </pc:spChg>
      </pc:sldChg>
    </pc:docChg>
  </pc:docChgLst>
  <pc:docChgLst>
    <pc:chgData name="Guest User" userId="S::urn:spo:anon#4cf4838ef0fbf4d0dba1e40ac72942b61102bea1b1689e895975c57b98f5ef34::" providerId="AD" clId="Web-{5999C776-94F2-C19F-87DF-59A92685C54C}"/>
    <pc:docChg chg="modSld">
      <pc:chgData name="Guest User" userId="S::urn:spo:anon#4cf4838ef0fbf4d0dba1e40ac72942b61102bea1b1689e895975c57b98f5ef34::" providerId="AD" clId="Web-{5999C776-94F2-C19F-87DF-59A92685C54C}" dt="2022-01-04T18:10:36.241" v="3" actId="1076"/>
      <pc:docMkLst>
        <pc:docMk/>
      </pc:docMkLst>
      <pc:sldChg chg="modSp">
        <pc:chgData name="Guest User" userId="S::urn:spo:anon#4cf4838ef0fbf4d0dba1e40ac72942b61102bea1b1689e895975c57b98f5ef34::" providerId="AD" clId="Web-{5999C776-94F2-C19F-87DF-59A92685C54C}" dt="2022-01-04T18:03:57.429" v="0" actId="20577"/>
        <pc:sldMkLst>
          <pc:docMk/>
          <pc:sldMk cId="659258882" sldId="316"/>
        </pc:sldMkLst>
        <pc:spChg chg="mod">
          <ac:chgData name="Guest User" userId="S::urn:spo:anon#4cf4838ef0fbf4d0dba1e40ac72942b61102bea1b1689e895975c57b98f5ef34::" providerId="AD" clId="Web-{5999C776-94F2-C19F-87DF-59A92685C54C}" dt="2022-01-04T18:03:57.429" v="0" actId="20577"/>
          <ac:spMkLst>
            <pc:docMk/>
            <pc:sldMk cId="659258882" sldId="316"/>
            <ac:spMk id="4" creationId="{21C1E623-F543-4D3B-8E1A-B50D58553900}"/>
          </ac:spMkLst>
        </pc:spChg>
      </pc:sldChg>
      <pc:sldChg chg="modSp">
        <pc:chgData name="Guest User" userId="S::urn:spo:anon#4cf4838ef0fbf4d0dba1e40ac72942b61102bea1b1689e895975c57b98f5ef34::" providerId="AD" clId="Web-{5999C776-94F2-C19F-87DF-59A92685C54C}" dt="2022-01-04T18:10:36.241" v="3" actId="1076"/>
        <pc:sldMkLst>
          <pc:docMk/>
          <pc:sldMk cId="1011963421" sldId="351"/>
        </pc:sldMkLst>
        <pc:picChg chg="mod">
          <ac:chgData name="Guest User" userId="S::urn:spo:anon#4cf4838ef0fbf4d0dba1e40ac72942b61102bea1b1689e895975c57b98f5ef34::" providerId="AD" clId="Web-{5999C776-94F2-C19F-87DF-59A92685C54C}" dt="2022-01-04T18:10:36.241" v="3" actId="1076"/>
          <ac:picMkLst>
            <pc:docMk/>
            <pc:sldMk cId="1011963421" sldId="351"/>
            <ac:picMk id="2" creationId="{5D9BA558-9E2F-4632-9561-CDC3CCB44311}"/>
          </ac:picMkLst>
        </pc:picChg>
      </pc:sldChg>
      <pc:sldChg chg="modSp">
        <pc:chgData name="Guest User" userId="S::urn:spo:anon#4cf4838ef0fbf4d0dba1e40ac72942b61102bea1b1689e895975c57b98f5ef34::" providerId="AD" clId="Web-{5999C776-94F2-C19F-87DF-59A92685C54C}" dt="2022-01-04T18:04:05.351" v="1" actId="20577"/>
        <pc:sldMkLst>
          <pc:docMk/>
          <pc:sldMk cId="3375007296" sldId="380"/>
        </pc:sldMkLst>
        <pc:spChg chg="mod">
          <ac:chgData name="Guest User" userId="S::urn:spo:anon#4cf4838ef0fbf4d0dba1e40ac72942b61102bea1b1689e895975c57b98f5ef34::" providerId="AD" clId="Web-{5999C776-94F2-C19F-87DF-59A92685C54C}" dt="2022-01-04T18:04:05.351" v="1" actId="20577"/>
          <ac:spMkLst>
            <pc:docMk/>
            <pc:sldMk cId="3375007296" sldId="380"/>
            <ac:spMk id="3" creationId="{732813B5-3B16-4C39-9B26-980756C16563}"/>
          </ac:spMkLst>
        </pc:spChg>
      </pc:sldChg>
      <pc:sldChg chg="addSp">
        <pc:chgData name="Guest User" userId="S::urn:spo:anon#4cf4838ef0fbf4d0dba1e40ac72942b61102bea1b1689e895975c57b98f5ef34::" providerId="AD" clId="Web-{5999C776-94F2-C19F-87DF-59A92685C54C}" dt="2022-01-04T18:09:33.163" v="2"/>
        <pc:sldMkLst>
          <pc:docMk/>
          <pc:sldMk cId="30129961" sldId="403"/>
        </pc:sldMkLst>
        <pc:spChg chg="add">
          <ac:chgData name="Guest User" userId="S::urn:spo:anon#4cf4838ef0fbf4d0dba1e40ac72942b61102bea1b1689e895975c57b98f5ef34::" providerId="AD" clId="Web-{5999C776-94F2-C19F-87DF-59A92685C54C}" dt="2022-01-04T18:09:33.163" v="2"/>
          <ac:spMkLst>
            <pc:docMk/>
            <pc:sldMk cId="30129961" sldId="403"/>
            <ac:spMk id="4" creationId="{8D46DD58-53E4-4C88-95F1-6673AA422C71}"/>
          </ac:spMkLst>
        </pc:spChg>
      </pc:sldChg>
    </pc:docChg>
  </pc:docChgLst>
  <pc:docChgLst>
    <pc:chgData name="janice.john@einsteinmed.edu" userId="S::urn:spo:guest#janice.john@einsteinmed.edu::" providerId="AD" clId="Web-{70A5FECA-C0A0-A34E-63EC-E16EBDBB222D}"/>
    <pc:docChg chg="mod modSld">
      <pc:chgData name="janice.john@einsteinmed.edu" userId="S::urn:spo:guest#janice.john@einsteinmed.edu::" providerId="AD" clId="Web-{70A5FECA-C0A0-A34E-63EC-E16EBDBB222D}" dt="2022-04-12T12:11:28.570" v="12"/>
      <pc:docMkLst>
        <pc:docMk/>
      </pc:docMkLst>
      <pc:sldChg chg="addCm">
        <pc:chgData name="janice.john@einsteinmed.edu" userId="S::urn:spo:guest#janice.john@einsteinmed.edu::" providerId="AD" clId="Web-{70A5FECA-C0A0-A34E-63EC-E16EBDBB222D}" dt="2022-04-12T12:04:21.323" v="1"/>
        <pc:sldMkLst>
          <pc:docMk/>
          <pc:sldMk cId="3061336521" sldId="318"/>
        </pc:sldMkLst>
      </pc:sldChg>
      <pc:sldChg chg="modSp">
        <pc:chgData name="janice.john@einsteinmed.edu" userId="S::urn:spo:guest#janice.john@einsteinmed.edu::" providerId="AD" clId="Web-{70A5FECA-C0A0-A34E-63EC-E16EBDBB222D}" dt="2022-04-12T12:11:27.585" v="11" actId="14100"/>
        <pc:sldMkLst>
          <pc:docMk/>
          <pc:sldMk cId="2418592727" sldId="373"/>
        </pc:sldMkLst>
        <pc:spChg chg="mod">
          <ac:chgData name="janice.john@einsteinmed.edu" userId="S::urn:spo:guest#janice.john@einsteinmed.edu::" providerId="AD" clId="Web-{70A5FECA-C0A0-A34E-63EC-E16EBDBB222D}" dt="2022-04-12T12:11:27.585" v="11" actId="14100"/>
          <ac:spMkLst>
            <pc:docMk/>
            <pc:sldMk cId="2418592727" sldId="373"/>
            <ac:spMk id="3" creationId="{AB26ACB8-94F9-48F1-AC83-F44DCA055732}"/>
          </ac:spMkLst>
        </pc:spChg>
      </pc:sldChg>
      <pc:sldChg chg="addCm">
        <pc:chgData name="janice.john@einsteinmed.edu" userId="S::urn:spo:guest#janice.john@einsteinmed.edu::" providerId="AD" clId="Web-{70A5FECA-C0A0-A34E-63EC-E16EBDBB222D}" dt="2022-04-12T12:04:48.105" v="2"/>
        <pc:sldMkLst>
          <pc:docMk/>
          <pc:sldMk cId="3695886494" sldId="377"/>
        </pc:sldMkLst>
      </pc:sldChg>
      <pc:sldChg chg="addCm">
        <pc:chgData name="janice.john@einsteinmed.edu" userId="S::urn:spo:guest#janice.john@einsteinmed.edu::" providerId="AD" clId="Web-{70A5FECA-C0A0-A34E-63EC-E16EBDBB222D}" dt="2022-04-12T12:07:47.766" v="3"/>
        <pc:sldMkLst>
          <pc:docMk/>
          <pc:sldMk cId="3071954687" sldId="382"/>
        </pc:sldMkLst>
      </pc:sldChg>
      <pc:sldChg chg="addCm">
        <pc:chgData name="janice.john@einsteinmed.edu" userId="S::urn:spo:guest#janice.john@einsteinmed.edu::" providerId="AD" clId="Web-{70A5FECA-C0A0-A34E-63EC-E16EBDBB222D}" dt="2022-04-12T12:09:25.097" v="5"/>
        <pc:sldMkLst>
          <pc:docMk/>
          <pc:sldMk cId="1807645662" sldId="385"/>
        </pc:sldMkLst>
      </pc:sldChg>
      <pc:sldChg chg="modSp addCm delCm">
        <pc:chgData name="janice.john@einsteinmed.edu" userId="S::urn:spo:guest#janice.john@einsteinmed.edu::" providerId="AD" clId="Web-{70A5FECA-C0A0-A34E-63EC-E16EBDBB222D}" dt="2022-04-12T12:11:28.570" v="12"/>
        <pc:sldMkLst>
          <pc:docMk/>
          <pc:sldMk cId="2389432848" sldId="409"/>
        </pc:sldMkLst>
        <pc:spChg chg="mod">
          <ac:chgData name="janice.john@einsteinmed.edu" userId="S::urn:spo:guest#janice.john@einsteinmed.edu::" providerId="AD" clId="Web-{70A5FECA-C0A0-A34E-63EC-E16EBDBB222D}" dt="2022-04-12T12:10:00.052" v="6" actId="14100"/>
          <ac:spMkLst>
            <pc:docMk/>
            <pc:sldMk cId="2389432848" sldId="409"/>
            <ac:spMk id="6" creationId="{98B8DFB9-1F78-4DD6-8614-43290A1C6FC8}"/>
          </ac:spMkLst>
        </pc:spChg>
      </pc:sldChg>
    </pc:docChg>
  </pc:docChgLst>
  <pc:docChgLst>
    <pc:chgData name="gsolis@northwell.edu" userId="S::urn:spo:guest#gsolis@northwell.edu::" providerId="AD" clId="Web-{E2DA2B76-1027-4740-18C9-552C3BAF7850}"/>
    <pc:docChg chg="modSld">
      <pc:chgData name="gsolis@northwell.edu" userId="S::urn:spo:guest#gsolis@northwell.edu::" providerId="AD" clId="Web-{E2DA2B76-1027-4740-18C9-552C3BAF7850}" dt="2021-06-18T19:49:59.701" v="300" actId="20577"/>
      <pc:docMkLst>
        <pc:docMk/>
      </pc:docMkLst>
      <pc:sldChg chg="modSp">
        <pc:chgData name="gsolis@northwell.edu" userId="S::urn:spo:guest#gsolis@northwell.edu::" providerId="AD" clId="Web-{E2DA2B76-1027-4740-18C9-552C3BAF7850}" dt="2021-06-18T19:33:54.040" v="101" actId="1076"/>
        <pc:sldMkLst>
          <pc:docMk/>
          <pc:sldMk cId="1780732845" sldId="306"/>
        </pc:sldMkLst>
        <pc:spChg chg="mod">
          <ac:chgData name="gsolis@northwell.edu" userId="S::urn:spo:guest#gsolis@northwell.edu::" providerId="AD" clId="Web-{E2DA2B76-1027-4740-18C9-552C3BAF7850}" dt="2021-06-18T19:32:32.335" v="80" actId="20577"/>
          <ac:spMkLst>
            <pc:docMk/>
            <pc:sldMk cId="1780732845" sldId="306"/>
            <ac:spMk id="2" creationId="{00000000-0000-0000-0000-000000000000}"/>
          </ac:spMkLst>
        </pc:spChg>
        <pc:spChg chg="mod">
          <ac:chgData name="gsolis@northwell.edu" userId="S::urn:spo:guest#gsolis@northwell.edu::" providerId="AD" clId="Web-{E2DA2B76-1027-4740-18C9-552C3BAF7850}" dt="2021-06-18T19:32:55.523" v="85" actId="14100"/>
          <ac:spMkLst>
            <pc:docMk/>
            <pc:sldMk cId="1780732845" sldId="306"/>
            <ac:spMk id="3" creationId="{00000000-0000-0000-0000-000000000000}"/>
          </ac:spMkLst>
        </pc:spChg>
        <pc:spChg chg="mod">
          <ac:chgData name="gsolis@northwell.edu" userId="S::urn:spo:guest#gsolis@northwell.edu::" providerId="AD" clId="Web-{E2DA2B76-1027-4740-18C9-552C3BAF7850}" dt="2021-06-18T19:33:41.727" v="99" actId="1076"/>
          <ac:spMkLst>
            <pc:docMk/>
            <pc:sldMk cId="1780732845" sldId="306"/>
            <ac:spMk id="5" creationId="{FB3F74D2-1709-4488-9D0C-E4A818C1E9F6}"/>
          </ac:spMkLst>
        </pc:spChg>
        <pc:spChg chg="mod">
          <ac:chgData name="gsolis@northwell.edu" userId="S::urn:spo:guest#gsolis@northwell.edu::" providerId="AD" clId="Web-{E2DA2B76-1027-4740-18C9-552C3BAF7850}" dt="2021-06-18T19:33:54.040" v="101" actId="1076"/>
          <ac:spMkLst>
            <pc:docMk/>
            <pc:sldMk cId="1780732845" sldId="306"/>
            <ac:spMk id="6" creationId="{F190CA81-2449-4A22-8842-2F0EA8C68F64}"/>
          </ac:spMkLst>
        </pc:spChg>
        <pc:spChg chg="mod">
          <ac:chgData name="gsolis@northwell.edu" userId="S::urn:spo:guest#gsolis@northwell.edu::" providerId="AD" clId="Web-{E2DA2B76-1027-4740-18C9-552C3BAF7850}" dt="2021-06-18T19:33:34.508" v="98" actId="20577"/>
          <ac:spMkLst>
            <pc:docMk/>
            <pc:sldMk cId="1780732845" sldId="306"/>
            <ac:spMk id="7" creationId="{5FE5DD88-5FB5-43EA-B299-9C54E6115FE3}"/>
          </ac:spMkLst>
        </pc:spChg>
      </pc:sldChg>
      <pc:sldChg chg="modSp">
        <pc:chgData name="gsolis@northwell.edu" userId="S::urn:spo:guest#gsolis@northwell.edu::" providerId="AD" clId="Web-{E2DA2B76-1027-4740-18C9-552C3BAF7850}" dt="2021-06-18T19:28:10.858" v="40" actId="20577"/>
        <pc:sldMkLst>
          <pc:docMk/>
          <pc:sldMk cId="3061336521" sldId="318"/>
        </pc:sldMkLst>
        <pc:spChg chg="mod">
          <ac:chgData name="gsolis@northwell.edu" userId="S::urn:spo:guest#gsolis@northwell.edu::" providerId="AD" clId="Web-{E2DA2B76-1027-4740-18C9-552C3BAF7850}" dt="2021-06-18T19:28:10.858" v="40" actId="20577"/>
          <ac:spMkLst>
            <pc:docMk/>
            <pc:sldMk cId="3061336521" sldId="318"/>
            <ac:spMk id="6" creationId="{00000000-0000-0000-0000-000000000000}"/>
          </ac:spMkLst>
        </pc:spChg>
      </pc:sldChg>
      <pc:sldChg chg="modSp">
        <pc:chgData name="gsolis@northwell.edu" userId="S::urn:spo:guest#gsolis@northwell.edu::" providerId="AD" clId="Web-{E2DA2B76-1027-4740-18C9-552C3BAF7850}" dt="2021-06-18T19:48:36.699" v="285" actId="20577"/>
        <pc:sldMkLst>
          <pc:docMk/>
          <pc:sldMk cId="4240967710" sldId="334"/>
        </pc:sldMkLst>
        <pc:spChg chg="mod">
          <ac:chgData name="gsolis@northwell.edu" userId="S::urn:spo:guest#gsolis@northwell.edu::" providerId="AD" clId="Web-{E2DA2B76-1027-4740-18C9-552C3BAF7850}" dt="2021-06-18T19:48:36.699" v="285" actId="20577"/>
          <ac:spMkLst>
            <pc:docMk/>
            <pc:sldMk cId="4240967710" sldId="334"/>
            <ac:spMk id="3" creationId="{00000000-0000-0000-0000-000000000000}"/>
          </ac:spMkLst>
        </pc:spChg>
      </pc:sldChg>
      <pc:sldChg chg="modSp">
        <pc:chgData name="gsolis@northwell.edu" userId="S::urn:spo:guest#gsolis@northwell.edu::" providerId="AD" clId="Web-{E2DA2B76-1027-4740-18C9-552C3BAF7850}" dt="2021-06-18T19:49:59.701" v="300" actId="20577"/>
        <pc:sldMkLst>
          <pc:docMk/>
          <pc:sldMk cId="337776308" sldId="342"/>
        </pc:sldMkLst>
        <pc:spChg chg="mod">
          <ac:chgData name="gsolis@northwell.edu" userId="S::urn:spo:guest#gsolis@northwell.edu::" providerId="AD" clId="Web-{E2DA2B76-1027-4740-18C9-552C3BAF7850}" dt="2021-06-18T19:49:59.701" v="300" actId="20577"/>
          <ac:spMkLst>
            <pc:docMk/>
            <pc:sldMk cId="337776308" sldId="342"/>
            <ac:spMk id="3" creationId="{00000000-0000-0000-0000-000000000000}"/>
          </ac:spMkLst>
        </pc:spChg>
      </pc:sldChg>
      <pc:sldChg chg="modSp">
        <pc:chgData name="gsolis@northwell.edu" userId="S::urn:spo:guest#gsolis@northwell.edu::" providerId="AD" clId="Web-{E2DA2B76-1027-4740-18C9-552C3BAF7850}" dt="2021-06-18T19:46:26.634" v="269" actId="20577"/>
        <pc:sldMkLst>
          <pc:docMk/>
          <pc:sldMk cId="3832890404" sldId="343"/>
        </pc:sldMkLst>
        <pc:spChg chg="mod">
          <ac:chgData name="gsolis@northwell.edu" userId="S::urn:spo:guest#gsolis@northwell.edu::" providerId="AD" clId="Web-{E2DA2B76-1027-4740-18C9-552C3BAF7850}" dt="2021-06-18T19:46:26.634" v="269" actId="20577"/>
          <ac:spMkLst>
            <pc:docMk/>
            <pc:sldMk cId="3832890404" sldId="343"/>
            <ac:spMk id="3" creationId="{00000000-0000-0000-0000-000000000000}"/>
          </ac:spMkLst>
        </pc:spChg>
      </pc:sldChg>
      <pc:sldChg chg="modSp">
        <pc:chgData name="gsolis@northwell.edu" userId="S::urn:spo:guest#gsolis@northwell.edu::" providerId="AD" clId="Web-{E2DA2B76-1027-4740-18C9-552C3BAF7850}" dt="2021-06-18T19:42:43.880" v="251" actId="20577"/>
        <pc:sldMkLst>
          <pc:docMk/>
          <pc:sldMk cId="1559596806" sldId="346"/>
        </pc:sldMkLst>
        <pc:spChg chg="mod">
          <ac:chgData name="gsolis@northwell.edu" userId="S::urn:spo:guest#gsolis@northwell.edu::" providerId="AD" clId="Web-{E2DA2B76-1027-4740-18C9-552C3BAF7850}" dt="2021-06-18T19:42:43.880" v="251" actId="20577"/>
          <ac:spMkLst>
            <pc:docMk/>
            <pc:sldMk cId="1559596806" sldId="346"/>
            <ac:spMk id="3" creationId="{00000000-0000-0000-0000-000000000000}"/>
          </ac:spMkLst>
        </pc:spChg>
      </pc:sldChg>
      <pc:sldChg chg="modSp">
        <pc:chgData name="gsolis@northwell.edu" userId="S::urn:spo:guest#gsolis@northwell.edu::" providerId="AD" clId="Web-{E2DA2B76-1027-4740-18C9-552C3BAF7850}" dt="2021-06-18T19:19:41.141" v="19" actId="20577"/>
        <pc:sldMkLst>
          <pc:docMk/>
          <pc:sldMk cId="2447000783" sldId="356"/>
        </pc:sldMkLst>
        <pc:spChg chg="mod">
          <ac:chgData name="gsolis@northwell.edu" userId="S::urn:spo:guest#gsolis@northwell.edu::" providerId="AD" clId="Web-{E2DA2B76-1027-4740-18C9-552C3BAF7850}" dt="2021-06-18T19:19:41.141" v="19" actId="20577"/>
          <ac:spMkLst>
            <pc:docMk/>
            <pc:sldMk cId="2447000783" sldId="356"/>
            <ac:spMk id="3" creationId="{361A62B3-03B4-4733-B136-D667683F9038}"/>
          </ac:spMkLst>
        </pc:spChg>
      </pc:sldChg>
      <pc:sldChg chg="modSp">
        <pc:chgData name="gsolis@northwell.edu" userId="S::urn:spo:guest#gsolis@northwell.edu::" providerId="AD" clId="Web-{E2DA2B76-1027-4740-18C9-552C3BAF7850}" dt="2021-06-18T19:46:04.056" v="267" actId="20577"/>
        <pc:sldMkLst>
          <pc:docMk/>
          <pc:sldMk cId="3995300267" sldId="358"/>
        </pc:sldMkLst>
        <pc:spChg chg="mod">
          <ac:chgData name="gsolis@northwell.edu" userId="S::urn:spo:guest#gsolis@northwell.edu::" providerId="AD" clId="Web-{E2DA2B76-1027-4740-18C9-552C3BAF7850}" dt="2021-06-18T19:46:04.056" v="267" actId="20577"/>
          <ac:spMkLst>
            <pc:docMk/>
            <pc:sldMk cId="3995300267" sldId="358"/>
            <ac:spMk id="5" creationId="{B1141BC7-349B-4BD4-A9CA-AE55A6EE3D44}"/>
          </ac:spMkLst>
        </pc:spChg>
      </pc:sldChg>
      <pc:sldChg chg="modSp">
        <pc:chgData name="gsolis@northwell.edu" userId="S::urn:spo:guest#gsolis@northwell.edu::" providerId="AD" clId="Web-{E2DA2B76-1027-4740-18C9-552C3BAF7850}" dt="2021-06-18T19:47:48.261" v="278" actId="1076"/>
        <pc:sldMkLst>
          <pc:docMk/>
          <pc:sldMk cId="956818366" sldId="362"/>
        </pc:sldMkLst>
        <pc:spChg chg="mod">
          <ac:chgData name="gsolis@northwell.edu" userId="S::urn:spo:guest#gsolis@northwell.edu::" providerId="AD" clId="Web-{E2DA2B76-1027-4740-18C9-552C3BAF7850}" dt="2021-06-18T19:47:35.620" v="276" actId="1076"/>
          <ac:spMkLst>
            <pc:docMk/>
            <pc:sldMk cId="956818366" sldId="362"/>
            <ac:spMk id="5" creationId="{B1141BC7-349B-4BD4-A9CA-AE55A6EE3D44}"/>
          </ac:spMkLst>
        </pc:spChg>
        <pc:spChg chg="mod">
          <ac:chgData name="gsolis@northwell.edu" userId="S::urn:spo:guest#gsolis@northwell.edu::" providerId="AD" clId="Web-{E2DA2B76-1027-4740-18C9-552C3BAF7850}" dt="2021-06-18T19:47:43.042" v="277" actId="1076"/>
          <ac:spMkLst>
            <pc:docMk/>
            <pc:sldMk cId="956818366" sldId="362"/>
            <ac:spMk id="6" creationId="{F3F3D626-C811-4A4E-852E-878C7BE355E5}"/>
          </ac:spMkLst>
        </pc:spChg>
        <pc:spChg chg="mod">
          <ac:chgData name="gsolis@northwell.edu" userId="S::urn:spo:guest#gsolis@northwell.edu::" providerId="AD" clId="Web-{E2DA2B76-1027-4740-18C9-552C3BAF7850}" dt="2021-06-18T19:47:48.261" v="278" actId="1076"/>
          <ac:spMkLst>
            <pc:docMk/>
            <pc:sldMk cId="956818366" sldId="362"/>
            <ac:spMk id="7" creationId="{2DB2EEFF-530F-4694-B201-0A930B600A3C}"/>
          </ac:spMkLst>
        </pc:spChg>
      </pc:sldChg>
      <pc:sldChg chg="delSp modSp">
        <pc:chgData name="gsolis@northwell.edu" userId="S::urn:spo:guest#gsolis@northwell.edu::" providerId="AD" clId="Web-{E2DA2B76-1027-4740-18C9-552C3BAF7850}" dt="2021-06-18T19:13:26.806" v="15" actId="1076"/>
        <pc:sldMkLst>
          <pc:docMk/>
          <pc:sldMk cId="1724564863" sldId="365"/>
        </pc:sldMkLst>
        <pc:spChg chg="mod">
          <ac:chgData name="gsolis@northwell.edu" userId="S::urn:spo:guest#gsolis@northwell.edu::" providerId="AD" clId="Web-{E2DA2B76-1027-4740-18C9-552C3BAF7850}" dt="2021-06-18T19:13:26.806" v="15" actId="1076"/>
          <ac:spMkLst>
            <pc:docMk/>
            <pc:sldMk cId="1724564863" sldId="365"/>
            <ac:spMk id="2" creationId="{3AAAD477-D9BB-40A4-9449-4D7C7008F428}"/>
          </ac:spMkLst>
        </pc:spChg>
        <pc:spChg chg="mod">
          <ac:chgData name="gsolis@northwell.edu" userId="S::urn:spo:guest#gsolis@northwell.edu::" providerId="AD" clId="Web-{E2DA2B76-1027-4740-18C9-552C3BAF7850}" dt="2021-06-18T19:13:24.024" v="14" actId="14100"/>
          <ac:spMkLst>
            <pc:docMk/>
            <pc:sldMk cId="1724564863" sldId="365"/>
            <ac:spMk id="4" creationId="{FD449185-D6E9-4CB2-A221-9240F7092AAD}"/>
          </ac:spMkLst>
        </pc:spChg>
        <pc:picChg chg="del mod">
          <ac:chgData name="gsolis@northwell.edu" userId="S::urn:spo:guest#gsolis@northwell.edu::" providerId="AD" clId="Web-{E2DA2B76-1027-4740-18C9-552C3BAF7850}" dt="2021-06-18T19:13:15.665" v="12"/>
          <ac:picMkLst>
            <pc:docMk/>
            <pc:sldMk cId="1724564863" sldId="365"/>
            <ac:picMk id="7" creationId="{CEABE3DD-A04C-48F5-AF6D-C01E8A3C1E49}"/>
          </ac:picMkLst>
        </pc:picChg>
      </pc:sldChg>
      <pc:sldChg chg="modSp">
        <pc:chgData name="gsolis@northwell.edu" userId="S::urn:spo:guest#gsolis@northwell.edu::" providerId="AD" clId="Web-{E2DA2B76-1027-4740-18C9-552C3BAF7850}" dt="2021-06-18T19:49:50.076" v="297" actId="1076"/>
        <pc:sldMkLst>
          <pc:docMk/>
          <pc:sldMk cId="504955433" sldId="371"/>
        </pc:sldMkLst>
        <pc:spChg chg="mod">
          <ac:chgData name="gsolis@northwell.edu" userId="S::urn:spo:guest#gsolis@northwell.edu::" providerId="AD" clId="Web-{E2DA2B76-1027-4740-18C9-552C3BAF7850}" dt="2021-06-18T19:49:50.076" v="297" actId="1076"/>
          <ac:spMkLst>
            <pc:docMk/>
            <pc:sldMk cId="504955433" sldId="371"/>
            <ac:spMk id="2" creationId="{9058C3B7-053F-4630-AEFD-94D00B3044A6}"/>
          </ac:spMkLst>
        </pc:spChg>
        <pc:spChg chg="mod">
          <ac:chgData name="gsolis@northwell.edu" userId="S::urn:spo:guest#gsolis@northwell.edu::" providerId="AD" clId="Web-{E2DA2B76-1027-4740-18C9-552C3BAF7850}" dt="2021-06-18T19:49:13.278" v="289" actId="20577"/>
          <ac:spMkLst>
            <pc:docMk/>
            <pc:sldMk cId="504955433" sldId="371"/>
            <ac:spMk id="3" creationId="{B6888636-DC58-482E-BB12-5029C1E6DDE2}"/>
          </ac:spMkLst>
        </pc:spChg>
        <pc:picChg chg="mod">
          <ac:chgData name="gsolis@northwell.edu" userId="S::urn:spo:guest#gsolis@northwell.edu::" providerId="AD" clId="Web-{E2DA2B76-1027-4740-18C9-552C3BAF7850}" dt="2021-06-18T19:49:27.841" v="290" actId="1076"/>
          <ac:picMkLst>
            <pc:docMk/>
            <pc:sldMk cId="504955433" sldId="371"/>
            <ac:picMk id="5" creationId="{B663C4E1-35D8-4479-AB72-DDC2854BB560}"/>
          </ac:picMkLst>
        </pc:picChg>
      </pc:sldChg>
      <pc:sldChg chg="delSp modSp">
        <pc:chgData name="gsolis@northwell.edu" userId="S::urn:spo:guest#gsolis@northwell.edu::" providerId="AD" clId="Web-{E2DA2B76-1027-4740-18C9-552C3BAF7850}" dt="2021-06-18T19:02:46.887" v="5" actId="20577"/>
        <pc:sldMkLst>
          <pc:docMk/>
          <pc:sldMk cId="2418592727" sldId="373"/>
        </pc:sldMkLst>
        <pc:spChg chg="mod">
          <ac:chgData name="gsolis@northwell.edu" userId="S::urn:spo:guest#gsolis@northwell.edu::" providerId="AD" clId="Web-{E2DA2B76-1027-4740-18C9-552C3BAF7850}" dt="2021-06-18T19:02:46.887" v="5" actId="20577"/>
          <ac:spMkLst>
            <pc:docMk/>
            <pc:sldMk cId="2418592727" sldId="373"/>
            <ac:spMk id="11" creationId="{089DD99E-0D17-4C5D-B955-09FF7808AF36}"/>
          </ac:spMkLst>
        </pc:spChg>
        <pc:picChg chg="del">
          <ac:chgData name="gsolis@northwell.edu" userId="S::urn:spo:guest#gsolis@northwell.edu::" providerId="AD" clId="Web-{E2DA2B76-1027-4740-18C9-552C3BAF7850}" dt="2021-06-18T19:02:22.074" v="0"/>
          <ac:picMkLst>
            <pc:docMk/>
            <pc:sldMk cId="2418592727" sldId="373"/>
            <ac:picMk id="12" creationId="{C617A0FE-ADFB-4E2A-BB31-4308A8F76809}"/>
          </ac:picMkLst>
        </pc:picChg>
      </pc:sldChg>
      <pc:sldChg chg="modSp">
        <pc:chgData name="gsolis@northwell.edu" userId="S::urn:spo:guest#gsolis@northwell.edu::" providerId="AD" clId="Web-{E2DA2B76-1027-4740-18C9-552C3BAF7850}" dt="2021-06-18T19:41:25.129" v="243" actId="20577"/>
        <pc:sldMkLst>
          <pc:docMk/>
          <pc:sldMk cId="2338641079" sldId="374"/>
        </pc:sldMkLst>
        <pc:spChg chg="mod">
          <ac:chgData name="gsolis@northwell.edu" userId="S::urn:spo:guest#gsolis@northwell.edu::" providerId="AD" clId="Web-{E2DA2B76-1027-4740-18C9-552C3BAF7850}" dt="2021-06-18T19:41:25.129" v="243" actId="20577"/>
          <ac:spMkLst>
            <pc:docMk/>
            <pc:sldMk cId="2338641079" sldId="374"/>
            <ac:spMk id="2" creationId="{00000000-0000-0000-0000-000000000000}"/>
          </ac:spMkLst>
        </pc:spChg>
        <pc:spChg chg="mod">
          <ac:chgData name="gsolis@northwell.edu" userId="S::urn:spo:guest#gsolis@northwell.edu::" providerId="AD" clId="Web-{E2DA2B76-1027-4740-18C9-552C3BAF7850}" dt="2021-06-18T19:32:04.912" v="76" actId="20577"/>
          <ac:spMkLst>
            <pc:docMk/>
            <pc:sldMk cId="2338641079" sldId="374"/>
            <ac:spMk id="3" creationId="{00000000-0000-0000-0000-000000000000}"/>
          </ac:spMkLst>
        </pc:spChg>
      </pc:sldChg>
      <pc:sldChg chg="delSp modSp">
        <pc:chgData name="gsolis@northwell.edu" userId="S::urn:spo:guest#gsolis@northwell.edu::" providerId="AD" clId="Web-{E2DA2B76-1027-4740-18C9-552C3BAF7850}" dt="2021-06-18T19:37:50.187" v="152" actId="1076"/>
        <pc:sldMkLst>
          <pc:docMk/>
          <pc:sldMk cId="3188627780" sldId="375"/>
        </pc:sldMkLst>
        <pc:spChg chg="mod">
          <ac:chgData name="gsolis@northwell.edu" userId="S::urn:spo:guest#gsolis@northwell.edu::" providerId="AD" clId="Web-{E2DA2B76-1027-4740-18C9-552C3BAF7850}" dt="2021-06-18T19:37:50.187" v="152" actId="1076"/>
          <ac:spMkLst>
            <pc:docMk/>
            <pc:sldMk cId="3188627780" sldId="375"/>
            <ac:spMk id="4" creationId="{3E180195-0311-4728-AB96-0C60748A963B}"/>
          </ac:spMkLst>
        </pc:spChg>
        <pc:picChg chg="del mod">
          <ac:chgData name="gsolis@northwell.edu" userId="S::urn:spo:guest#gsolis@northwell.edu::" providerId="AD" clId="Web-{E2DA2B76-1027-4740-18C9-552C3BAF7850}" dt="2021-06-18T19:36:07.435" v="120"/>
          <ac:picMkLst>
            <pc:docMk/>
            <pc:sldMk cId="3188627780" sldId="375"/>
            <ac:picMk id="7" creationId="{DA9CFBB8-E7DA-4287-B772-97F808D5FE2A}"/>
          </ac:picMkLst>
        </pc:picChg>
      </pc:sldChg>
    </pc:docChg>
  </pc:docChgLst>
  <pc:docChgLst>
    <pc:chgData name="Gabrielle Goldberg" userId="S::gabrielle.goldberg@hofstra.edu::453f9b71-f7a4-4ef4-8e34-bbb69381dfc0" providerId="AD" clId="Web-{64617B73-D78D-4FEC-71CE-6530644E54A5}"/>
    <pc:docChg chg="addSld modSld">
      <pc:chgData name="Gabrielle Goldberg" userId="S::gabrielle.goldberg@hofstra.edu::453f9b71-f7a4-4ef4-8e34-bbb69381dfc0" providerId="AD" clId="Web-{64617B73-D78D-4FEC-71CE-6530644E54A5}" dt="2022-04-07T17:26:49.750" v="214" actId="20577"/>
      <pc:docMkLst>
        <pc:docMk/>
      </pc:docMkLst>
      <pc:sldChg chg="modSp">
        <pc:chgData name="Gabrielle Goldberg" userId="S::gabrielle.goldberg@hofstra.edu::453f9b71-f7a4-4ef4-8e34-bbb69381dfc0" providerId="AD" clId="Web-{64617B73-D78D-4FEC-71CE-6530644E54A5}" dt="2022-04-07T17:05:50.744" v="1" actId="20577"/>
        <pc:sldMkLst>
          <pc:docMk/>
          <pc:sldMk cId="278272457" sldId="378"/>
        </pc:sldMkLst>
        <pc:spChg chg="mod">
          <ac:chgData name="Gabrielle Goldberg" userId="S::gabrielle.goldberg@hofstra.edu::453f9b71-f7a4-4ef4-8e34-bbb69381dfc0" providerId="AD" clId="Web-{64617B73-D78D-4FEC-71CE-6530644E54A5}" dt="2022-04-07T17:05:50.744" v="1" actId="20577"/>
          <ac:spMkLst>
            <pc:docMk/>
            <pc:sldMk cId="278272457" sldId="378"/>
            <ac:spMk id="3" creationId="{2B81FEFF-2091-470B-97BD-B2221C0ED1FB}"/>
          </ac:spMkLst>
        </pc:spChg>
      </pc:sldChg>
      <pc:sldChg chg="modSp">
        <pc:chgData name="Gabrielle Goldberg" userId="S::gabrielle.goldberg@hofstra.edu::453f9b71-f7a4-4ef4-8e34-bbb69381dfc0" providerId="AD" clId="Web-{64617B73-D78D-4FEC-71CE-6530644E54A5}" dt="2022-04-07T17:07:55.091" v="41" actId="20577"/>
        <pc:sldMkLst>
          <pc:docMk/>
          <pc:sldMk cId="3380947776" sldId="406"/>
        </pc:sldMkLst>
        <pc:graphicFrameChg chg="modGraphic">
          <ac:chgData name="Gabrielle Goldberg" userId="S::gabrielle.goldberg@hofstra.edu::453f9b71-f7a4-4ef4-8e34-bbb69381dfc0" providerId="AD" clId="Web-{64617B73-D78D-4FEC-71CE-6530644E54A5}" dt="2022-04-07T17:07:55.091" v="41" actId="20577"/>
          <ac:graphicFrameMkLst>
            <pc:docMk/>
            <pc:sldMk cId="3380947776" sldId="406"/>
            <ac:graphicFrameMk id="5" creationId="{DD58BD53-D491-4E27-8E29-0A4691C5DA68}"/>
          </ac:graphicFrameMkLst>
        </pc:graphicFrameChg>
      </pc:sldChg>
      <pc:sldChg chg="modSp new">
        <pc:chgData name="Gabrielle Goldberg" userId="S::gabrielle.goldberg@hofstra.edu::453f9b71-f7a4-4ef4-8e34-bbb69381dfc0" providerId="AD" clId="Web-{64617B73-D78D-4FEC-71CE-6530644E54A5}" dt="2022-04-07T17:26:49.750" v="214" actId="20577"/>
        <pc:sldMkLst>
          <pc:docMk/>
          <pc:sldMk cId="2584455186" sldId="416"/>
        </pc:sldMkLst>
        <pc:spChg chg="mod">
          <ac:chgData name="Gabrielle Goldberg" userId="S::gabrielle.goldberg@hofstra.edu::453f9b71-f7a4-4ef4-8e34-bbb69381dfc0" providerId="AD" clId="Web-{64617B73-D78D-4FEC-71CE-6530644E54A5}" dt="2022-04-07T17:11:10.956" v="64" actId="20577"/>
          <ac:spMkLst>
            <pc:docMk/>
            <pc:sldMk cId="2584455186" sldId="416"/>
            <ac:spMk id="2" creationId="{DCDED9B5-6E86-C20B-6B9E-3F1C72E80612}"/>
          </ac:spMkLst>
        </pc:spChg>
        <pc:spChg chg="mod">
          <ac:chgData name="Gabrielle Goldberg" userId="S::gabrielle.goldberg@hofstra.edu::453f9b71-f7a4-4ef4-8e34-bbb69381dfc0" providerId="AD" clId="Web-{64617B73-D78D-4FEC-71CE-6530644E54A5}" dt="2022-04-07T17:26:49.750" v="214" actId="20577"/>
          <ac:spMkLst>
            <pc:docMk/>
            <pc:sldMk cId="2584455186" sldId="416"/>
            <ac:spMk id="3" creationId="{E4AACC01-B4DC-53C5-CD7E-B49F8C033DB8}"/>
          </ac:spMkLst>
        </pc:spChg>
      </pc:sldChg>
    </pc:docChg>
  </pc:docChgLst>
  <pc:docChgLst>
    <pc:chgData name="Solis, Gabriela" userId="S::gsolis_northwell.edu#ext#@hofstra.edu::198dd0ac-6fb3-4b59-b455-eeb2e8da8c00" providerId="AD" clId="Web-{32711967-A104-8244-803B-26A273E17983}"/>
    <pc:docChg chg="addSld delSld modSld">
      <pc:chgData name="Solis, Gabriela" userId="S::gsolis_northwell.edu#ext#@hofstra.edu::198dd0ac-6fb3-4b59-b455-eeb2e8da8c00" providerId="AD" clId="Web-{32711967-A104-8244-803B-26A273E17983}" dt="2021-07-18T18:47:40.188" v="614"/>
      <pc:docMkLst>
        <pc:docMk/>
      </pc:docMkLst>
      <pc:sldChg chg="del">
        <pc:chgData name="Solis, Gabriela" userId="S::gsolis_northwell.edu#ext#@hofstra.edu::198dd0ac-6fb3-4b59-b455-eeb2e8da8c00" providerId="AD" clId="Web-{32711967-A104-8244-803B-26A273E17983}" dt="2021-07-18T17:50:41.106" v="34"/>
        <pc:sldMkLst>
          <pc:docMk/>
          <pc:sldMk cId="1780732845" sldId="306"/>
        </pc:sldMkLst>
      </pc:sldChg>
      <pc:sldChg chg="del">
        <pc:chgData name="Solis, Gabriela" userId="S::gsolis_northwell.edu#ext#@hofstra.edu::198dd0ac-6fb3-4b59-b455-eeb2e8da8c00" providerId="AD" clId="Web-{32711967-A104-8244-803B-26A273E17983}" dt="2021-07-18T18:18:58.694" v="329"/>
        <pc:sldMkLst>
          <pc:docMk/>
          <pc:sldMk cId="3894987403" sldId="307"/>
        </pc:sldMkLst>
      </pc:sldChg>
      <pc:sldChg chg="del">
        <pc:chgData name="Solis, Gabriela" userId="S::gsolis_northwell.edu#ext#@hofstra.edu::198dd0ac-6fb3-4b59-b455-eeb2e8da8c00" providerId="AD" clId="Web-{32711967-A104-8244-803B-26A273E17983}" dt="2021-07-18T18:03:59.893" v="193"/>
        <pc:sldMkLst>
          <pc:docMk/>
          <pc:sldMk cId="2930611101" sldId="333"/>
        </pc:sldMkLst>
      </pc:sldChg>
      <pc:sldChg chg="del">
        <pc:chgData name="Solis, Gabriela" userId="S::gsolis_northwell.edu#ext#@hofstra.edu::198dd0ac-6fb3-4b59-b455-eeb2e8da8c00" providerId="AD" clId="Web-{32711967-A104-8244-803B-26A273E17983}" dt="2021-07-18T18:27:52.017" v="421"/>
        <pc:sldMkLst>
          <pc:docMk/>
          <pc:sldMk cId="4240967710" sldId="334"/>
        </pc:sldMkLst>
      </pc:sldChg>
      <pc:sldChg chg="del">
        <pc:chgData name="Solis, Gabriela" userId="S::gsolis_northwell.edu#ext#@hofstra.edu::198dd0ac-6fb3-4b59-b455-eeb2e8da8c00" providerId="AD" clId="Web-{32711967-A104-8244-803B-26A273E17983}" dt="2021-07-18T18:40:06.631" v="548"/>
        <pc:sldMkLst>
          <pc:docMk/>
          <pc:sldMk cId="2277355623" sldId="336"/>
        </pc:sldMkLst>
      </pc:sldChg>
      <pc:sldChg chg="modSp add del">
        <pc:chgData name="Solis, Gabriela" userId="S::gsolis_northwell.edu#ext#@hofstra.edu::198dd0ac-6fb3-4b59-b455-eeb2e8da8c00" providerId="AD" clId="Web-{32711967-A104-8244-803B-26A273E17983}" dt="2021-07-18T18:00:35.624" v="144"/>
        <pc:sldMkLst>
          <pc:docMk/>
          <pc:sldMk cId="1708372556" sldId="338"/>
        </pc:sldMkLst>
        <pc:spChg chg="mod">
          <ac:chgData name="Solis, Gabriela" userId="S::gsolis_northwell.edu#ext#@hofstra.edu::198dd0ac-6fb3-4b59-b455-eeb2e8da8c00" providerId="AD" clId="Web-{32711967-A104-8244-803B-26A273E17983}" dt="2021-07-18T17:58:42.543" v="128" actId="20577"/>
          <ac:spMkLst>
            <pc:docMk/>
            <pc:sldMk cId="1708372556" sldId="338"/>
            <ac:spMk id="2" creationId="{00000000-0000-0000-0000-000000000000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7:59:02.747" v="132" actId="1076"/>
          <ac:spMkLst>
            <pc:docMk/>
            <pc:sldMk cId="1708372556" sldId="338"/>
            <ac:spMk id="3" creationId="{00000000-0000-0000-0000-000000000000}"/>
          </ac:spMkLst>
        </pc:spChg>
      </pc:sldChg>
      <pc:sldChg chg="modSp del">
        <pc:chgData name="Solis, Gabriela" userId="S::gsolis_northwell.edu#ext#@hofstra.edu::198dd0ac-6fb3-4b59-b455-eeb2e8da8c00" providerId="AD" clId="Web-{32711967-A104-8244-803B-26A273E17983}" dt="2021-07-18T18:00:40.077" v="145"/>
        <pc:sldMkLst>
          <pc:docMk/>
          <pc:sldMk cId="3315398952" sldId="339"/>
        </pc:sldMkLst>
        <pc:spChg chg="mod">
          <ac:chgData name="Solis, Gabriela" userId="S::gsolis_northwell.edu#ext#@hofstra.edu::198dd0ac-6fb3-4b59-b455-eeb2e8da8c00" providerId="AD" clId="Web-{32711967-A104-8244-803B-26A273E17983}" dt="2021-07-18T17:58:27.543" v="126" actId="1076"/>
          <ac:spMkLst>
            <pc:docMk/>
            <pc:sldMk cId="3315398952" sldId="339"/>
            <ac:spMk id="3" creationId="{00000000-0000-0000-0000-000000000000}"/>
          </ac:spMkLst>
        </pc:spChg>
      </pc:sldChg>
      <pc:sldChg chg="del">
        <pc:chgData name="Solis, Gabriela" userId="S::gsolis_northwell.edu#ext#@hofstra.edu::198dd0ac-6fb3-4b59-b455-eeb2e8da8c00" providerId="AD" clId="Web-{32711967-A104-8244-803B-26A273E17983}" dt="2021-07-18T18:47:40.188" v="614"/>
        <pc:sldMkLst>
          <pc:docMk/>
          <pc:sldMk cId="3645599527" sldId="341"/>
        </pc:sldMkLst>
      </pc:sldChg>
      <pc:sldChg chg="del">
        <pc:chgData name="Solis, Gabriela" userId="S::gsolis_northwell.edu#ext#@hofstra.edu::198dd0ac-6fb3-4b59-b455-eeb2e8da8c00" providerId="AD" clId="Web-{32711967-A104-8244-803B-26A273E17983}" dt="2021-07-18T18:39:07.364" v="537"/>
        <pc:sldMkLst>
          <pc:docMk/>
          <pc:sldMk cId="337776308" sldId="342"/>
        </pc:sldMkLst>
      </pc:sldChg>
      <pc:sldChg chg="del">
        <pc:chgData name="Solis, Gabriela" userId="S::gsolis_northwell.edu#ext#@hofstra.edu::198dd0ac-6fb3-4b59-b455-eeb2e8da8c00" providerId="AD" clId="Web-{32711967-A104-8244-803B-26A273E17983}" dt="2021-07-18T18:18:11.068" v="318"/>
        <pc:sldMkLst>
          <pc:docMk/>
          <pc:sldMk cId="3832890404" sldId="343"/>
        </pc:sldMkLst>
      </pc:sldChg>
      <pc:sldChg chg="del">
        <pc:chgData name="Solis, Gabriela" userId="S::gsolis_northwell.edu#ext#@hofstra.edu::198dd0ac-6fb3-4b59-b455-eeb2e8da8c00" providerId="AD" clId="Web-{32711967-A104-8244-803B-26A273E17983}" dt="2021-07-18T18:46:50.765" v="604"/>
        <pc:sldMkLst>
          <pc:docMk/>
          <pc:sldMk cId="856723955" sldId="344"/>
        </pc:sldMkLst>
      </pc:sldChg>
      <pc:sldChg chg="del">
        <pc:chgData name="Solis, Gabriela" userId="S::gsolis_northwell.edu#ext#@hofstra.edu::198dd0ac-6fb3-4b59-b455-eeb2e8da8c00" providerId="AD" clId="Web-{32711967-A104-8244-803B-26A273E17983}" dt="2021-07-18T17:54:23.928" v="70"/>
        <pc:sldMkLst>
          <pc:docMk/>
          <pc:sldMk cId="1559596806" sldId="346"/>
        </pc:sldMkLst>
      </pc:sldChg>
      <pc:sldChg chg="del">
        <pc:chgData name="Solis, Gabriela" userId="S::gsolis_northwell.edu#ext#@hofstra.edu::198dd0ac-6fb3-4b59-b455-eeb2e8da8c00" providerId="AD" clId="Web-{32711967-A104-8244-803B-26A273E17983}" dt="2021-07-18T18:23:05.043" v="372"/>
        <pc:sldMkLst>
          <pc:docMk/>
          <pc:sldMk cId="3787916487" sldId="347"/>
        </pc:sldMkLst>
      </pc:sldChg>
      <pc:sldChg chg="del">
        <pc:chgData name="Solis, Gabriela" userId="S::gsolis_northwell.edu#ext#@hofstra.edu::198dd0ac-6fb3-4b59-b455-eeb2e8da8c00" providerId="AD" clId="Web-{32711967-A104-8244-803B-26A273E17983}" dt="2021-07-18T18:12:29.186" v="282"/>
        <pc:sldMkLst>
          <pc:docMk/>
          <pc:sldMk cId="153378708" sldId="352"/>
        </pc:sldMkLst>
      </pc:sldChg>
      <pc:sldChg chg="modSp">
        <pc:chgData name="Solis, Gabriela" userId="S::gsolis_northwell.edu#ext#@hofstra.edu::198dd0ac-6fb3-4b59-b455-eeb2e8da8c00" providerId="AD" clId="Web-{32711967-A104-8244-803B-26A273E17983}" dt="2021-07-18T18:13:36.687" v="299" actId="20577"/>
        <pc:sldMkLst>
          <pc:docMk/>
          <pc:sldMk cId="3995300267" sldId="358"/>
        </pc:sldMkLst>
        <pc:spChg chg="mod">
          <ac:chgData name="Solis, Gabriela" userId="S::gsolis_northwell.edu#ext#@hofstra.edu::198dd0ac-6fb3-4b59-b455-eeb2e8da8c00" providerId="AD" clId="Web-{32711967-A104-8244-803B-26A273E17983}" dt="2021-07-18T18:13:36.687" v="299" actId="20577"/>
          <ac:spMkLst>
            <pc:docMk/>
            <pc:sldMk cId="3995300267" sldId="358"/>
            <ac:spMk id="2" creationId="{47780179-0182-4210-AB55-A1699228033C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8:13:04.358" v="289"/>
          <ac:spMkLst>
            <pc:docMk/>
            <pc:sldMk cId="3995300267" sldId="358"/>
            <ac:spMk id="6" creationId="{F3F3D626-C811-4A4E-852E-878C7BE355E5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8:13:27.421" v="296" actId="1076"/>
          <ac:spMkLst>
            <pc:docMk/>
            <pc:sldMk cId="3995300267" sldId="358"/>
            <ac:spMk id="7" creationId="{2DB2EEFF-530F-4694-B201-0A930B600A3C}"/>
          </ac:spMkLst>
        </pc:spChg>
      </pc:sldChg>
      <pc:sldChg chg="del">
        <pc:chgData name="Solis, Gabriela" userId="S::gsolis_northwell.edu#ext#@hofstra.edu::198dd0ac-6fb3-4b59-b455-eeb2e8da8c00" providerId="AD" clId="Web-{32711967-A104-8244-803B-26A273E17983}" dt="2021-07-18T18:23:51.091" v="381"/>
        <pc:sldMkLst>
          <pc:docMk/>
          <pc:sldMk cId="2179516864" sldId="359"/>
        </pc:sldMkLst>
      </pc:sldChg>
      <pc:sldChg chg="modSp">
        <pc:chgData name="Solis, Gabriela" userId="S::gsolis_northwell.edu#ext#@hofstra.edu::198dd0ac-6fb3-4b59-b455-eeb2e8da8c00" providerId="AD" clId="Web-{32711967-A104-8244-803B-26A273E17983}" dt="2021-07-18T18:26:40.547" v="413" actId="20577"/>
        <pc:sldMkLst>
          <pc:docMk/>
          <pc:sldMk cId="956818366" sldId="362"/>
        </pc:sldMkLst>
        <pc:spChg chg="mod">
          <ac:chgData name="Solis, Gabriela" userId="S::gsolis_northwell.edu#ext#@hofstra.edu::198dd0ac-6fb3-4b59-b455-eeb2e8da8c00" providerId="AD" clId="Web-{32711967-A104-8244-803B-26A273E17983}" dt="2021-07-18T18:26:40.547" v="413" actId="20577"/>
          <ac:spMkLst>
            <pc:docMk/>
            <pc:sldMk cId="956818366" sldId="362"/>
            <ac:spMk id="2" creationId="{47780179-0182-4210-AB55-A1699228033C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8:26:05.828" v="407"/>
          <ac:spMkLst>
            <pc:docMk/>
            <pc:sldMk cId="956818366" sldId="362"/>
            <ac:spMk id="6" creationId="{F3F3D626-C811-4A4E-852E-878C7BE355E5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8:26:23.328" v="411" actId="1076"/>
          <ac:spMkLst>
            <pc:docMk/>
            <pc:sldMk cId="956818366" sldId="362"/>
            <ac:spMk id="7" creationId="{2DB2EEFF-530F-4694-B201-0A930B600A3C}"/>
          </ac:spMkLst>
        </pc:spChg>
      </pc:sldChg>
      <pc:sldChg chg="modSp del">
        <pc:chgData name="Solis, Gabriela" userId="S::gsolis_northwell.edu#ext#@hofstra.edu::198dd0ac-6fb3-4b59-b455-eeb2e8da8c00" providerId="AD" clId="Web-{32711967-A104-8244-803B-26A273E17983}" dt="2021-07-18T18:42:38.416" v="568"/>
        <pc:sldMkLst>
          <pc:docMk/>
          <pc:sldMk cId="3402779613" sldId="363"/>
        </pc:sldMkLst>
        <pc:spChg chg="mod">
          <ac:chgData name="Solis, Gabriela" userId="S::gsolis_northwell.edu#ext#@hofstra.edu::198dd0ac-6fb3-4b59-b455-eeb2e8da8c00" providerId="AD" clId="Web-{32711967-A104-8244-803B-26A273E17983}" dt="2021-07-18T18:40:56.304" v="550" actId="1076"/>
          <ac:spMkLst>
            <pc:docMk/>
            <pc:sldMk cId="3402779613" sldId="363"/>
            <ac:spMk id="3" creationId="{1F51E178-D5AB-4F91-8EB6-98ABE269B5EE}"/>
          </ac:spMkLst>
        </pc:spChg>
      </pc:sldChg>
      <pc:sldChg chg="del">
        <pc:chgData name="Solis, Gabriela" userId="S::gsolis_northwell.edu#ext#@hofstra.edu::198dd0ac-6fb3-4b59-b455-eeb2e8da8c00" providerId="AD" clId="Web-{32711967-A104-8244-803B-26A273E17983}" dt="2021-07-18T18:46:18.858" v="597"/>
        <pc:sldMkLst>
          <pc:docMk/>
          <pc:sldMk cId="1724564863" sldId="365"/>
        </pc:sldMkLst>
      </pc:sldChg>
      <pc:sldChg chg="del">
        <pc:chgData name="Solis, Gabriela" userId="S::gsolis_northwell.edu#ext#@hofstra.edu::198dd0ac-6fb3-4b59-b455-eeb2e8da8c00" providerId="AD" clId="Web-{32711967-A104-8244-803B-26A273E17983}" dt="2021-07-18T18:45:13.763" v="585"/>
        <pc:sldMkLst>
          <pc:docMk/>
          <pc:sldMk cId="438269467" sldId="366"/>
        </pc:sldMkLst>
      </pc:sldChg>
      <pc:sldChg chg="delSp modSp">
        <pc:chgData name="Solis, Gabriela" userId="S::gsolis_northwell.edu#ext#@hofstra.edu::198dd0ac-6fb3-4b59-b455-eeb2e8da8c00" providerId="AD" clId="Web-{32711967-A104-8244-803B-26A273E17983}" dt="2021-07-18T18:19:18.054" v="333" actId="20577"/>
        <pc:sldMkLst>
          <pc:docMk/>
          <pc:sldMk cId="2439297039" sldId="367"/>
        </pc:sldMkLst>
        <pc:spChg chg="mod">
          <ac:chgData name="Solis, Gabriela" userId="S::gsolis_northwell.edu#ext#@hofstra.edu::198dd0ac-6fb3-4b59-b455-eeb2e8da8c00" providerId="AD" clId="Web-{32711967-A104-8244-803B-26A273E17983}" dt="2021-07-18T18:19:18.054" v="333" actId="20577"/>
          <ac:spMkLst>
            <pc:docMk/>
            <pc:sldMk cId="2439297039" sldId="367"/>
            <ac:spMk id="2" creationId="{9711D05B-1A6A-4785-9233-25614CFC03CE}"/>
          </ac:spMkLst>
        </pc:spChg>
        <pc:spChg chg="del">
          <ac:chgData name="Solis, Gabriela" userId="S::gsolis_northwell.edu#ext#@hofstra.edu::198dd0ac-6fb3-4b59-b455-eeb2e8da8c00" providerId="AD" clId="Web-{32711967-A104-8244-803B-26A273E17983}" dt="2021-07-18T18:19:04.803" v="330"/>
          <ac:spMkLst>
            <pc:docMk/>
            <pc:sldMk cId="2439297039" sldId="367"/>
            <ac:spMk id="7" creationId="{518690C3-F36E-4B17-A613-A958D8C0D4FC}"/>
          </ac:spMkLst>
        </pc:spChg>
      </pc:sldChg>
      <pc:sldChg chg="del">
        <pc:chgData name="Solis, Gabriela" userId="S::gsolis_northwell.edu#ext#@hofstra.edu::198dd0ac-6fb3-4b59-b455-eeb2e8da8c00" providerId="AD" clId="Web-{32711967-A104-8244-803B-26A273E17983}" dt="2021-07-18T18:37:30.722" v="528"/>
        <pc:sldMkLst>
          <pc:docMk/>
          <pc:sldMk cId="504955433" sldId="371"/>
        </pc:sldMkLst>
      </pc:sldChg>
      <pc:sldChg chg="del">
        <pc:chgData name="Solis, Gabriela" userId="S::gsolis_northwell.edu#ext#@hofstra.edu::198dd0ac-6fb3-4b59-b455-eeb2e8da8c00" providerId="AD" clId="Web-{32711967-A104-8244-803B-26A273E17983}" dt="2021-07-18T18:25:51.499" v="403"/>
        <pc:sldMkLst>
          <pc:docMk/>
          <pc:sldMk cId="36259429" sldId="372"/>
        </pc:sldMkLst>
      </pc:sldChg>
      <pc:sldChg chg="delSp del">
        <pc:chgData name="Solis, Gabriela" userId="S::gsolis_northwell.edu#ext#@hofstra.edu::198dd0ac-6fb3-4b59-b455-eeb2e8da8c00" providerId="AD" clId="Web-{32711967-A104-8244-803B-26A273E17983}" dt="2021-07-18T17:52:32.316" v="54"/>
        <pc:sldMkLst>
          <pc:docMk/>
          <pc:sldMk cId="3188627780" sldId="375"/>
        </pc:sldMkLst>
        <pc:spChg chg="del">
          <ac:chgData name="Solis, Gabriela" userId="S::gsolis_northwell.edu#ext#@hofstra.edu::198dd0ac-6fb3-4b59-b455-eeb2e8da8c00" providerId="AD" clId="Web-{32711967-A104-8244-803B-26A273E17983}" dt="2021-07-18T17:51:20.435" v="42"/>
          <ac:spMkLst>
            <pc:docMk/>
            <pc:sldMk cId="3188627780" sldId="375"/>
            <ac:spMk id="6" creationId="{60AF6881-2C5A-497B-A838-BB30395303C2}"/>
          </ac:spMkLst>
        </pc:spChg>
      </pc:sldChg>
      <pc:sldChg chg="addSp modSp">
        <pc:chgData name="Solis, Gabriela" userId="S::gsolis_northwell.edu#ext#@hofstra.edu::198dd0ac-6fb3-4b59-b455-eeb2e8da8c00" providerId="AD" clId="Web-{32711967-A104-8244-803B-26A273E17983}" dt="2021-07-18T17:50:23.137" v="33" actId="1076"/>
        <pc:sldMkLst>
          <pc:docMk/>
          <pc:sldMk cId="3711734020" sldId="386"/>
        </pc:sldMkLst>
        <pc:spChg chg="mod">
          <ac:chgData name="Solis, Gabriela" userId="S::gsolis_northwell.edu#ext#@hofstra.edu::198dd0ac-6fb3-4b59-b455-eeb2e8da8c00" providerId="AD" clId="Web-{32711967-A104-8244-803B-26A273E17983}" dt="2021-07-18T17:49:20.041" v="19" actId="14100"/>
          <ac:spMkLst>
            <pc:docMk/>
            <pc:sldMk cId="3711734020" sldId="386"/>
            <ac:spMk id="2" creationId="{00000000-0000-0000-0000-000000000000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7:50:23.137" v="33" actId="1076"/>
          <ac:spMkLst>
            <pc:docMk/>
            <pc:sldMk cId="3711734020" sldId="386"/>
            <ac:spMk id="3" creationId="{7E531B93-120A-4961-AF55-8A03F7FC04F5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7:48:09.524" v="14" actId="1076"/>
          <ac:spMkLst>
            <pc:docMk/>
            <pc:sldMk cId="3711734020" sldId="386"/>
            <ac:spMk id="4" creationId="{EDF41568-E631-4422-BF69-DBFC18B99030}"/>
          </ac:spMkLst>
        </pc:spChg>
        <pc:spChg chg="add mod">
          <ac:chgData name="Solis, Gabriela" userId="S::gsolis_northwell.edu#ext#@hofstra.edu::198dd0ac-6fb3-4b59-b455-eeb2e8da8c00" providerId="AD" clId="Web-{32711967-A104-8244-803B-26A273E17983}" dt="2021-07-18T17:46:00.225" v="7" actId="20577"/>
          <ac:spMkLst>
            <pc:docMk/>
            <pc:sldMk cId="3711734020" sldId="386"/>
            <ac:spMk id="5" creationId="{FD80AC44-A8FF-4E8D-832C-51B1FCE7B9D8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7:50:13.105" v="32" actId="14100"/>
          <ac:spMkLst>
            <pc:docMk/>
            <pc:sldMk cId="3711734020" sldId="386"/>
            <ac:spMk id="6" creationId="{00000000-0000-0000-0000-000000000000}"/>
          </ac:spMkLst>
        </pc:spChg>
      </pc:sldChg>
      <pc:sldChg chg="new del">
        <pc:chgData name="Solis, Gabriela" userId="S::gsolis_northwell.edu#ext#@hofstra.edu::198dd0ac-6fb3-4b59-b455-eeb2e8da8c00" providerId="AD" clId="Web-{32711967-A104-8244-803B-26A273E17983}" dt="2021-07-18T17:50:58.450" v="37"/>
        <pc:sldMkLst>
          <pc:docMk/>
          <pc:sldMk cId="2941210197" sldId="387"/>
        </pc:sldMkLst>
      </pc:sldChg>
      <pc:sldChg chg="modSp add replId">
        <pc:chgData name="Solis, Gabriela" userId="S::gsolis_northwell.edu#ext#@hofstra.edu::198dd0ac-6fb3-4b59-b455-eeb2e8da8c00" providerId="AD" clId="Web-{32711967-A104-8244-803B-26A273E17983}" dt="2021-07-18T17:52:05.019" v="53" actId="20577"/>
        <pc:sldMkLst>
          <pc:docMk/>
          <pc:sldMk cId="1059714534" sldId="388"/>
        </pc:sldMkLst>
        <pc:spChg chg="mod">
          <ac:chgData name="Solis, Gabriela" userId="S::gsolis_northwell.edu#ext#@hofstra.edu::198dd0ac-6fb3-4b59-b455-eeb2e8da8c00" providerId="AD" clId="Web-{32711967-A104-8244-803B-26A273E17983}" dt="2021-07-18T17:51:15.372" v="41" actId="20577"/>
          <ac:spMkLst>
            <pc:docMk/>
            <pc:sldMk cId="1059714534" sldId="388"/>
            <ac:spMk id="2" creationId="{00000000-0000-0000-0000-000000000000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7:52:05.019" v="53" actId="20577"/>
          <ac:spMkLst>
            <pc:docMk/>
            <pc:sldMk cId="1059714534" sldId="388"/>
            <ac:spMk id="6" creationId="{00000000-0000-0000-0000-000000000000}"/>
          </ac:spMkLst>
        </pc:spChg>
      </pc:sldChg>
      <pc:sldChg chg="modSp add replId">
        <pc:chgData name="Solis, Gabriela" userId="S::gsolis_northwell.edu#ext#@hofstra.edu::198dd0ac-6fb3-4b59-b455-eeb2e8da8c00" providerId="AD" clId="Web-{32711967-A104-8244-803B-26A273E17983}" dt="2021-07-18T17:54:17.475" v="69" actId="20577"/>
        <pc:sldMkLst>
          <pc:docMk/>
          <pc:sldMk cId="156485789" sldId="389"/>
        </pc:sldMkLst>
        <pc:spChg chg="mod">
          <ac:chgData name="Solis, Gabriela" userId="S::gsolis_northwell.edu#ext#@hofstra.edu::198dd0ac-6fb3-4b59-b455-eeb2e8da8c00" providerId="AD" clId="Web-{32711967-A104-8244-803B-26A273E17983}" dt="2021-07-18T17:52:55.833" v="59" actId="20577"/>
          <ac:spMkLst>
            <pc:docMk/>
            <pc:sldMk cId="156485789" sldId="389"/>
            <ac:spMk id="2" creationId="{00000000-0000-0000-0000-000000000000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7:54:17.475" v="69" actId="20577"/>
          <ac:spMkLst>
            <pc:docMk/>
            <pc:sldMk cId="156485789" sldId="389"/>
            <ac:spMk id="6" creationId="{00000000-0000-0000-0000-000000000000}"/>
          </ac:spMkLst>
        </pc:spChg>
      </pc:sldChg>
      <pc:sldChg chg="modSp add replId">
        <pc:chgData name="Solis, Gabriela" userId="S::gsolis_northwell.edu#ext#@hofstra.edu::198dd0ac-6fb3-4b59-b455-eeb2e8da8c00" providerId="AD" clId="Web-{32711967-A104-8244-803B-26A273E17983}" dt="2021-07-18T17:56:58.869" v="119" actId="1076"/>
        <pc:sldMkLst>
          <pc:docMk/>
          <pc:sldMk cId="1104129155" sldId="390"/>
        </pc:sldMkLst>
        <pc:spChg chg="mod">
          <ac:chgData name="Solis, Gabriela" userId="S::gsolis_northwell.edu#ext#@hofstra.edu::198dd0ac-6fb3-4b59-b455-eeb2e8da8c00" providerId="AD" clId="Web-{32711967-A104-8244-803B-26A273E17983}" dt="2021-07-18T17:56:30.056" v="111" actId="1076"/>
          <ac:spMkLst>
            <pc:docMk/>
            <pc:sldMk cId="1104129155" sldId="390"/>
            <ac:spMk id="2" creationId="{00000000-0000-0000-0000-000000000000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7:56:58.869" v="119" actId="1076"/>
          <ac:spMkLst>
            <pc:docMk/>
            <pc:sldMk cId="1104129155" sldId="390"/>
            <ac:spMk id="6" creationId="{00000000-0000-0000-0000-000000000000}"/>
          </ac:spMkLst>
        </pc:spChg>
      </pc:sldChg>
      <pc:sldChg chg="add del replId">
        <pc:chgData name="Solis, Gabriela" userId="S::gsolis_northwell.edu#ext#@hofstra.edu::198dd0ac-6fb3-4b59-b455-eeb2e8da8c00" providerId="AD" clId="Web-{32711967-A104-8244-803B-26A273E17983}" dt="2021-07-18T17:58:12.339" v="124"/>
        <pc:sldMkLst>
          <pc:docMk/>
          <pc:sldMk cId="1278391770" sldId="391"/>
        </pc:sldMkLst>
      </pc:sldChg>
      <pc:sldChg chg="modSp add replId">
        <pc:chgData name="Solis, Gabriela" userId="S::gsolis_northwell.edu#ext#@hofstra.edu::198dd0ac-6fb3-4b59-b455-eeb2e8da8c00" providerId="AD" clId="Web-{32711967-A104-8244-803B-26A273E17983}" dt="2021-07-18T18:00:29.592" v="143" actId="1076"/>
        <pc:sldMkLst>
          <pc:docMk/>
          <pc:sldMk cId="4046426465" sldId="391"/>
        </pc:sldMkLst>
        <pc:spChg chg="mod">
          <ac:chgData name="Solis, Gabriela" userId="S::gsolis_northwell.edu#ext#@hofstra.edu::198dd0ac-6fb3-4b59-b455-eeb2e8da8c00" providerId="AD" clId="Web-{32711967-A104-8244-803B-26A273E17983}" dt="2021-07-18T17:59:48.732" v="139" actId="20577"/>
          <ac:spMkLst>
            <pc:docMk/>
            <pc:sldMk cId="4046426465" sldId="391"/>
            <ac:spMk id="2" creationId="{00000000-0000-0000-0000-000000000000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8:00:29.592" v="143" actId="1076"/>
          <ac:spMkLst>
            <pc:docMk/>
            <pc:sldMk cId="4046426465" sldId="391"/>
            <ac:spMk id="6" creationId="{00000000-0000-0000-0000-000000000000}"/>
          </ac:spMkLst>
        </pc:spChg>
      </pc:sldChg>
      <pc:sldChg chg="modSp add replId">
        <pc:chgData name="Solis, Gabriela" userId="S::gsolis_northwell.edu#ext#@hofstra.edu::198dd0ac-6fb3-4b59-b455-eeb2e8da8c00" providerId="AD" clId="Web-{32711967-A104-8244-803B-26A273E17983}" dt="2021-07-18T18:03:38.565" v="192" actId="14100"/>
        <pc:sldMkLst>
          <pc:docMk/>
          <pc:sldMk cId="198615434" sldId="392"/>
        </pc:sldMkLst>
        <pc:spChg chg="mod">
          <ac:chgData name="Solis, Gabriela" userId="S::gsolis_northwell.edu#ext#@hofstra.edu::198dd0ac-6fb3-4b59-b455-eeb2e8da8c00" providerId="AD" clId="Web-{32711967-A104-8244-803B-26A273E17983}" dt="2021-07-18T18:01:12.999" v="150" actId="20577"/>
          <ac:spMkLst>
            <pc:docMk/>
            <pc:sldMk cId="198615434" sldId="392"/>
            <ac:spMk id="2" creationId="{00000000-0000-0000-0000-000000000000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8:03:38.565" v="192" actId="14100"/>
          <ac:spMkLst>
            <pc:docMk/>
            <pc:sldMk cId="198615434" sldId="392"/>
            <ac:spMk id="6" creationId="{00000000-0000-0000-0000-000000000000}"/>
          </ac:spMkLst>
        </pc:spChg>
      </pc:sldChg>
      <pc:sldChg chg="addSp modSp add replId">
        <pc:chgData name="Solis, Gabriela" userId="S::gsolis_northwell.edu#ext#@hofstra.edu::198dd0ac-6fb3-4b59-b455-eeb2e8da8c00" providerId="AD" clId="Web-{32711967-A104-8244-803B-26A273E17983}" dt="2021-07-18T18:12:19.435" v="281" actId="1076"/>
        <pc:sldMkLst>
          <pc:docMk/>
          <pc:sldMk cId="2028606082" sldId="393"/>
        </pc:sldMkLst>
        <pc:spChg chg="mod">
          <ac:chgData name="Solis, Gabriela" userId="S::gsolis_northwell.edu#ext#@hofstra.edu::198dd0ac-6fb3-4b59-b455-eeb2e8da8c00" providerId="AD" clId="Web-{32711967-A104-8244-803B-26A273E17983}" dt="2021-07-18T18:04:22.925" v="198" actId="20577"/>
          <ac:spMkLst>
            <pc:docMk/>
            <pc:sldMk cId="2028606082" sldId="393"/>
            <ac:spMk id="2" creationId="{00000000-0000-0000-0000-000000000000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8:12:17.123" v="280" actId="20577"/>
          <ac:spMkLst>
            <pc:docMk/>
            <pc:sldMk cId="2028606082" sldId="393"/>
            <ac:spMk id="6" creationId="{00000000-0000-0000-0000-000000000000}"/>
          </ac:spMkLst>
        </pc:spChg>
        <pc:cxnChg chg="add mod">
          <ac:chgData name="Solis, Gabriela" userId="S::gsolis_northwell.edu#ext#@hofstra.edu::198dd0ac-6fb3-4b59-b455-eeb2e8da8c00" providerId="AD" clId="Web-{32711967-A104-8244-803B-26A273E17983}" dt="2021-07-18T18:11:07.012" v="268" actId="1076"/>
          <ac:cxnSpMkLst>
            <pc:docMk/>
            <pc:sldMk cId="2028606082" sldId="393"/>
            <ac:cxnSpMk id="3" creationId="{50D20C01-B162-4BB1-9410-4384BA49EF18}"/>
          </ac:cxnSpMkLst>
        </pc:cxnChg>
        <pc:cxnChg chg="add mod">
          <ac:chgData name="Solis, Gabriela" userId="S::gsolis_northwell.edu#ext#@hofstra.edu::198dd0ac-6fb3-4b59-b455-eeb2e8da8c00" providerId="AD" clId="Web-{32711967-A104-8244-803B-26A273E17983}" dt="2021-07-18T18:11:11.699" v="269" actId="1076"/>
          <ac:cxnSpMkLst>
            <pc:docMk/>
            <pc:sldMk cId="2028606082" sldId="393"/>
            <ac:cxnSpMk id="5" creationId="{A3B1B14B-3E1F-484D-A15D-FF88316AF03C}"/>
          </ac:cxnSpMkLst>
        </pc:cxnChg>
        <pc:cxnChg chg="add mod">
          <ac:chgData name="Solis, Gabriela" userId="S::gsolis_northwell.edu#ext#@hofstra.edu::198dd0ac-6fb3-4b59-b455-eeb2e8da8c00" providerId="AD" clId="Web-{32711967-A104-8244-803B-26A273E17983}" dt="2021-07-18T18:11:14.903" v="270" actId="1076"/>
          <ac:cxnSpMkLst>
            <pc:docMk/>
            <pc:sldMk cId="2028606082" sldId="393"/>
            <ac:cxnSpMk id="7" creationId="{F3F43E86-CED6-4534-B585-4256BFDCB905}"/>
          </ac:cxnSpMkLst>
        </pc:cxnChg>
        <pc:cxnChg chg="add mod">
          <ac:chgData name="Solis, Gabriela" userId="S::gsolis_northwell.edu#ext#@hofstra.edu::198dd0ac-6fb3-4b59-b455-eeb2e8da8c00" providerId="AD" clId="Web-{32711967-A104-8244-803B-26A273E17983}" dt="2021-07-18T18:11:23.903" v="271" actId="1076"/>
          <ac:cxnSpMkLst>
            <pc:docMk/>
            <pc:sldMk cId="2028606082" sldId="393"/>
            <ac:cxnSpMk id="8" creationId="{38AFD662-4CE6-4E58-B479-7342D3F5DF1D}"/>
          </ac:cxnSpMkLst>
        </pc:cxnChg>
        <pc:cxnChg chg="add mod">
          <ac:chgData name="Solis, Gabriela" userId="S::gsolis_northwell.edu#ext#@hofstra.edu::198dd0ac-6fb3-4b59-b455-eeb2e8da8c00" providerId="AD" clId="Web-{32711967-A104-8244-803B-26A273E17983}" dt="2021-07-18T18:11:31.778" v="273" actId="1076"/>
          <ac:cxnSpMkLst>
            <pc:docMk/>
            <pc:sldMk cId="2028606082" sldId="393"/>
            <ac:cxnSpMk id="9" creationId="{73C94A57-C434-42FA-A4A1-F916F81A6687}"/>
          </ac:cxnSpMkLst>
        </pc:cxnChg>
        <pc:cxnChg chg="add mod">
          <ac:chgData name="Solis, Gabriela" userId="S::gsolis_northwell.edu#ext#@hofstra.edu::198dd0ac-6fb3-4b59-b455-eeb2e8da8c00" providerId="AD" clId="Web-{32711967-A104-8244-803B-26A273E17983}" dt="2021-07-18T18:12:19.435" v="281" actId="1076"/>
          <ac:cxnSpMkLst>
            <pc:docMk/>
            <pc:sldMk cId="2028606082" sldId="393"/>
            <ac:cxnSpMk id="10" creationId="{25C888BA-02F1-4E49-8370-3C0FCA500A51}"/>
          </ac:cxnSpMkLst>
        </pc:cxnChg>
        <pc:cxnChg chg="add mod">
          <ac:chgData name="Solis, Gabriela" userId="S::gsolis_northwell.edu#ext#@hofstra.edu::198dd0ac-6fb3-4b59-b455-eeb2e8da8c00" providerId="AD" clId="Web-{32711967-A104-8244-803B-26A273E17983}" dt="2021-07-18T18:12:03.310" v="278" actId="1076"/>
          <ac:cxnSpMkLst>
            <pc:docMk/>
            <pc:sldMk cId="2028606082" sldId="393"/>
            <ac:cxnSpMk id="11" creationId="{0875CED3-5085-49C6-9ECD-F750A56F5CC8}"/>
          </ac:cxnSpMkLst>
        </pc:cxnChg>
      </pc:sldChg>
      <pc:sldChg chg="delSp modSp add replId">
        <pc:chgData name="Solis, Gabriela" userId="S::gsolis_northwell.edu#ext#@hofstra.edu::198dd0ac-6fb3-4b59-b455-eeb2e8da8c00" providerId="AD" clId="Web-{32711967-A104-8244-803B-26A273E17983}" dt="2021-07-18T18:18:02.755" v="317" actId="14100"/>
        <pc:sldMkLst>
          <pc:docMk/>
          <pc:sldMk cId="807323245" sldId="394"/>
        </pc:sldMkLst>
        <pc:spChg chg="mod">
          <ac:chgData name="Solis, Gabriela" userId="S::gsolis_northwell.edu#ext#@hofstra.edu::198dd0ac-6fb3-4b59-b455-eeb2e8da8c00" providerId="AD" clId="Web-{32711967-A104-8244-803B-26A273E17983}" dt="2021-07-18T18:17:51.958" v="315" actId="14100"/>
          <ac:spMkLst>
            <pc:docMk/>
            <pc:sldMk cId="807323245" sldId="394"/>
            <ac:spMk id="2" creationId="{47780179-0182-4210-AB55-A1699228033C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8:18:02.755" v="317" actId="14100"/>
          <ac:spMkLst>
            <pc:docMk/>
            <pc:sldMk cId="807323245" sldId="394"/>
            <ac:spMk id="3" creationId="{9A392957-BD48-49DE-8599-0E44A1AE6D05}"/>
          </ac:spMkLst>
        </pc:spChg>
        <pc:spChg chg="del mod">
          <ac:chgData name="Solis, Gabriela" userId="S::gsolis_northwell.edu#ext#@hofstra.edu::198dd0ac-6fb3-4b59-b455-eeb2e8da8c00" providerId="AD" clId="Web-{32711967-A104-8244-803B-26A273E17983}" dt="2021-07-18T18:17:17.379" v="306"/>
          <ac:spMkLst>
            <pc:docMk/>
            <pc:sldMk cId="807323245" sldId="394"/>
            <ac:spMk id="5" creationId="{B1141BC7-349B-4BD4-A9CA-AE55A6EE3D44}"/>
          </ac:spMkLst>
        </pc:spChg>
        <pc:spChg chg="del">
          <ac:chgData name="Solis, Gabriela" userId="S::gsolis_northwell.edu#ext#@hofstra.edu::198dd0ac-6fb3-4b59-b455-eeb2e8da8c00" providerId="AD" clId="Web-{32711967-A104-8244-803B-26A273E17983}" dt="2021-07-18T18:17:27.379" v="311"/>
          <ac:spMkLst>
            <pc:docMk/>
            <pc:sldMk cId="807323245" sldId="394"/>
            <ac:spMk id="6" creationId="{F3F3D626-C811-4A4E-852E-878C7BE355E5}"/>
          </ac:spMkLst>
        </pc:spChg>
        <pc:spChg chg="del mod">
          <ac:chgData name="Solis, Gabriela" userId="S::gsolis_northwell.edu#ext#@hofstra.edu::198dd0ac-6fb3-4b59-b455-eeb2e8da8c00" providerId="AD" clId="Web-{32711967-A104-8244-803B-26A273E17983}" dt="2021-07-18T18:17:25.645" v="310"/>
          <ac:spMkLst>
            <pc:docMk/>
            <pc:sldMk cId="807323245" sldId="394"/>
            <ac:spMk id="7" creationId="{2DB2EEFF-530F-4694-B201-0A930B600A3C}"/>
          </ac:spMkLst>
        </pc:spChg>
      </pc:sldChg>
      <pc:sldChg chg="modSp add replId">
        <pc:chgData name="Solis, Gabriela" userId="S::gsolis_northwell.edu#ext#@hofstra.edu::198dd0ac-6fb3-4b59-b455-eeb2e8da8c00" providerId="AD" clId="Web-{32711967-A104-8244-803B-26A273E17983}" dt="2021-07-18T18:18:52.600" v="328" actId="20577"/>
        <pc:sldMkLst>
          <pc:docMk/>
          <pc:sldMk cId="3470372529" sldId="395"/>
        </pc:sldMkLst>
        <pc:spChg chg="mod">
          <ac:chgData name="Solis, Gabriela" userId="S::gsolis_northwell.edu#ext#@hofstra.edu::198dd0ac-6fb3-4b59-b455-eeb2e8da8c00" providerId="AD" clId="Web-{32711967-A104-8244-803B-26A273E17983}" dt="2021-07-18T18:18:31.678" v="322" actId="20577"/>
          <ac:spMkLst>
            <pc:docMk/>
            <pc:sldMk cId="3470372529" sldId="395"/>
            <ac:spMk id="2" creationId="{47780179-0182-4210-AB55-A1699228033C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8:18:52.600" v="328" actId="20577"/>
          <ac:spMkLst>
            <pc:docMk/>
            <pc:sldMk cId="3470372529" sldId="395"/>
            <ac:spMk id="3" creationId="{9A392957-BD48-49DE-8599-0E44A1AE6D05}"/>
          </ac:spMkLst>
        </pc:spChg>
      </pc:sldChg>
      <pc:sldChg chg="addSp modSp add replId">
        <pc:chgData name="Solis, Gabriela" userId="S::gsolis_northwell.edu#ext#@hofstra.edu::198dd0ac-6fb3-4b59-b455-eeb2e8da8c00" providerId="AD" clId="Web-{32711967-A104-8244-803B-26A273E17983}" dt="2021-07-18T18:22:50.964" v="371" actId="14100"/>
        <pc:sldMkLst>
          <pc:docMk/>
          <pc:sldMk cId="4176268020" sldId="396"/>
        </pc:sldMkLst>
        <pc:spChg chg="mod">
          <ac:chgData name="Solis, Gabriela" userId="S::gsolis_northwell.edu#ext#@hofstra.edu::198dd0ac-6fb3-4b59-b455-eeb2e8da8c00" providerId="AD" clId="Web-{32711967-A104-8244-803B-26A273E17983}" dt="2021-07-18T18:21:28.275" v="350" actId="14100"/>
          <ac:spMkLst>
            <pc:docMk/>
            <pc:sldMk cId="4176268020" sldId="396"/>
            <ac:spMk id="2" creationId="{9711D05B-1A6A-4785-9233-25614CFC03CE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8:22:50.964" v="371" actId="14100"/>
          <ac:spMkLst>
            <pc:docMk/>
            <pc:sldMk cId="4176268020" sldId="396"/>
            <ac:spMk id="3" creationId="{01EBB642-A9A1-4273-829D-59C1EBAD2430}"/>
          </ac:spMkLst>
        </pc:spChg>
        <pc:spChg chg="add mod">
          <ac:chgData name="Solis, Gabriela" userId="S::gsolis_northwell.edu#ext#@hofstra.edu::198dd0ac-6fb3-4b59-b455-eeb2e8da8c00" providerId="AD" clId="Web-{32711967-A104-8244-803B-26A273E17983}" dt="2021-07-18T18:22:37.292" v="368" actId="1076"/>
          <ac:spMkLst>
            <pc:docMk/>
            <pc:sldMk cId="4176268020" sldId="396"/>
            <ac:spMk id="5" creationId="{4D827504-E1A9-459B-AC84-683A2E7257BC}"/>
          </ac:spMkLst>
        </pc:spChg>
      </pc:sldChg>
      <pc:sldChg chg="modSp add replId">
        <pc:chgData name="Solis, Gabriela" userId="S::gsolis_northwell.edu#ext#@hofstra.edu::198dd0ac-6fb3-4b59-b455-eeb2e8da8c00" providerId="AD" clId="Web-{32711967-A104-8244-803B-26A273E17983}" dt="2021-07-18T18:28:19.893" v="423" actId="20577"/>
        <pc:sldMkLst>
          <pc:docMk/>
          <pc:sldMk cId="3614030429" sldId="397"/>
        </pc:sldMkLst>
        <pc:spChg chg="mod">
          <ac:chgData name="Solis, Gabriela" userId="S::gsolis_northwell.edu#ext#@hofstra.edu::198dd0ac-6fb3-4b59-b455-eeb2e8da8c00" providerId="AD" clId="Web-{32711967-A104-8244-803B-26A273E17983}" dt="2021-07-18T18:23:56.044" v="382" actId="14100"/>
          <ac:spMkLst>
            <pc:docMk/>
            <pc:sldMk cId="3614030429" sldId="397"/>
            <ac:spMk id="2" creationId="{9711D05B-1A6A-4785-9233-25614CFC03CE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8:28:19.893" v="423" actId="20577"/>
          <ac:spMkLst>
            <pc:docMk/>
            <pc:sldMk cId="3614030429" sldId="397"/>
            <ac:spMk id="3" creationId="{01EBB642-A9A1-4273-829D-59C1EBAD2430}"/>
          </ac:spMkLst>
        </pc:spChg>
      </pc:sldChg>
      <pc:sldChg chg="modSp add replId">
        <pc:chgData name="Solis, Gabriela" userId="S::gsolis_northwell.edu#ext#@hofstra.edu::198dd0ac-6fb3-4b59-b455-eeb2e8da8c00" providerId="AD" clId="Web-{32711967-A104-8244-803B-26A273E17983}" dt="2021-07-18T18:25:41.609" v="402" actId="20577"/>
        <pc:sldMkLst>
          <pc:docMk/>
          <pc:sldMk cId="1307065593" sldId="398"/>
        </pc:sldMkLst>
        <pc:spChg chg="mod">
          <ac:chgData name="Solis, Gabriela" userId="S::gsolis_northwell.edu#ext#@hofstra.edu::198dd0ac-6fb3-4b59-b455-eeb2e8da8c00" providerId="AD" clId="Web-{32711967-A104-8244-803B-26A273E17983}" dt="2021-07-18T18:25:41.609" v="402" actId="20577"/>
          <ac:spMkLst>
            <pc:docMk/>
            <pc:sldMk cId="1307065593" sldId="398"/>
            <ac:spMk id="2" creationId="{9711D05B-1A6A-4785-9233-25614CFC03CE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8:24:58.608" v="396" actId="1076"/>
          <ac:spMkLst>
            <pc:docMk/>
            <pc:sldMk cId="1307065593" sldId="398"/>
            <ac:spMk id="3" creationId="{01EBB642-A9A1-4273-829D-59C1EBAD2430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8:25:31.811" v="401" actId="1076"/>
          <ac:spMkLst>
            <pc:docMk/>
            <pc:sldMk cId="1307065593" sldId="398"/>
            <ac:spMk id="5" creationId="{4D827504-E1A9-459B-AC84-683A2E7257BC}"/>
          </ac:spMkLst>
        </pc:spChg>
      </pc:sldChg>
      <pc:sldChg chg="modSp add replId">
        <pc:chgData name="Solis, Gabriela" userId="S::gsolis_northwell.edu#ext#@hofstra.edu::198dd0ac-6fb3-4b59-b455-eeb2e8da8c00" providerId="AD" clId="Web-{32711967-A104-8244-803B-26A273E17983}" dt="2021-07-18T18:28:01.565" v="422" actId="20577"/>
        <pc:sldMkLst>
          <pc:docMk/>
          <pc:sldMk cId="1016746710" sldId="399"/>
        </pc:sldMkLst>
        <pc:spChg chg="mod">
          <ac:chgData name="Solis, Gabriela" userId="S::gsolis_northwell.edu#ext#@hofstra.edu::198dd0ac-6fb3-4b59-b455-eeb2e8da8c00" providerId="AD" clId="Web-{32711967-A104-8244-803B-26A273E17983}" dt="2021-07-18T18:27:26.501" v="418" actId="20577"/>
          <ac:spMkLst>
            <pc:docMk/>
            <pc:sldMk cId="1016746710" sldId="399"/>
            <ac:spMk id="2" creationId="{9711D05B-1A6A-4785-9233-25614CFC03CE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8:28:01.565" v="422" actId="20577"/>
          <ac:spMkLst>
            <pc:docMk/>
            <pc:sldMk cId="1016746710" sldId="399"/>
            <ac:spMk id="3" creationId="{01EBB642-A9A1-4273-829D-59C1EBAD2430}"/>
          </ac:spMkLst>
        </pc:spChg>
      </pc:sldChg>
      <pc:sldChg chg="addSp delSp modSp add mod replId setBg">
        <pc:chgData name="Solis, Gabriela" userId="S::gsolis_northwell.edu#ext#@hofstra.edu::198dd0ac-6fb3-4b59-b455-eeb2e8da8c00" providerId="AD" clId="Web-{32711967-A104-8244-803B-26A273E17983}" dt="2021-07-18T18:37:37.066" v="529" actId="20577"/>
        <pc:sldMkLst>
          <pc:docMk/>
          <pc:sldMk cId="2130972081" sldId="400"/>
        </pc:sldMkLst>
        <pc:spChg chg="mod">
          <ac:chgData name="Solis, Gabriela" userId="S::gsolis_northwell.edu#ext#@hofstra.edu::198dd0ac-6fb3-4b59-b455-eeb2e8da8c00" providerId="AD" clId="Web-{32711967-A104-8244-803B-26A273E17983}" dt="2021-07-18T18:37:37.066" v="529" actId="20577"/>
          <ac:spMkLst>
            <pc:docMk/>
            <pc:sldMk cId="2130972081" sldId="400"/>
            <ac:spMk id="2" creationId="{9711D05B-1A6A-4785-9233-25614CFC03CE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8:37:13.612" v="527" actId="20577"/>
          <ac:spMkLst>
            <pc:docMk/>
            <pc:sldMk cId="2130972081" sldId="400"/>
            <ac:spMk id="3" creationId="{01EBB642-A9A1-4273-829D-59C1EBAD2430}"/>
          </ac:spMkLst>
        </pc:spChg>
        <pc:spChg chg="add del">
          <ac:chgData name="Solis, Gabriela" userId="S::gsolis_northwell.edu#ext#@hofstra.edu::198dd0ac-6fb3-4b59-b455-eeb2e8da8c00" providerId="AD" clId="Web-{32711967-A104-8244-803B-26A273E17983}" dt="2021-07-18T18:32:21.149" v="467"/>
          <ac:spMkLst>
            <pc:docMk/>
            <pc:sldMk cId="2130972081" sldId="400"/>
            <ac:spMk id="7" creationId="{73DE2CFE-42F2-48F0-8706-5264E012B10C}"/>
          </ac:spMkLst>
        </pc:spChg>
        <pc:spChg chg="add del">
          <ac:chgData name="Solis, Gabriela" userId="S::gsolis_northwell.edu#ext#@hofstra.edu::198dd0ac-6fb3-4b59-b455-eeb2e8da8c00" providerId="AD" clId="Web-{32711967-A104-8244-803B-26A273E17983}" dt="2021-07-18T18:32:26.150" v="469"/>
          <ac:spMkLst>
            <pc:docMk/>
            <pc:sldMk cId="2130972081" sldId="400"/>
            <ac:spMk id="8" creationId="{2B97F24A-32CE-4C1C-A50D-3016B394DCFB}"/>
          </ac:spMkLst>
        </pc:spChg>
        <pc:spChg chg="add del">
          <ac:chgData name="Solis, Gabriela" userId="S::gsolis_northwell.edu#ext#@hofstra.edu::198dd0ac-6fb3-4b59-b455-eeb2e8da8c00" providerId="AD" clId="Web-{32711967-A104-8244-803B-26A273E17983}" dt="2021-07-18T18:32:26.150" v="469"/>
          <ac:spMkLst>
            <pc:docMk/>
            <pc:sldMk cId="2130972081" sldId="400"/>
            <ac:spMk id="9" creationId="{6357EC4F-235E-4222-A36F-C7878ACE37F2}"/>
          </ac:spMkLst>
        </pc:spChg>
        <pc:spChg chg="add del">
          <ac:chgData name="Solis, Gabriela" userId="S::gsolis_northwell.edu#ext#@hofstra.edu::198dd0ac-6fb3-4b59-b455-eeb2e8da8c00" providerId="AD" clId="Web-{32711967-A104-8244-803B-26A273E17983}" dt="2021-07-18T18:32:10.915" v="465"/>
          <ac:spMkLst>
            <pc:docMk/>
            <pc:sldMk cId="2130972081" sldId="400"/>
            <ac:spMk id="10" creationId="{5E39A796-BE83-48B1-B33F-35C4A32AAB57}"/>
          </ac:spMkLst>
        </pc:spChg>
        <pc:spChg chg="add del">
          <ac:chgData name="Solis, Gabriela" userId="S::gsolis_northwell.edu#ext#@hofstra.edu::198dd0ac-6fb3-4b59-b455-eeb2e8da8c00" providerId="AD" clId="Web-{32711967-A104-8244-803B-26A273E17983}" dt="2021-07-18T18:32:34.134" v="471"/>
          <ac:spMkLst>
            <pc:docMk/>
            <pc:sldMk cId="2130972081" sldId="400"/>
            <ac:spMk id="11" creationId="{2B566528-1B12-4246-9431-5C2D7D081168}"/>
          </ac:spMkLst>
        </pc:spChg>
        <pc:spChg chg="add del">
          <ac:chgData name="Solis, Gabriela" userId="S::gsolis_northwell.edu#ext#@hofstra.edu::198dd0ac-6fb3-4b59-b455-eeb2e8da8c00" providerId="AD" clId="Web-{32711967-A104-8244-803B-26A273E17983}" dt="2021-07-18T18:32:10.915" v="465"/>
          <ac:spMkLst>
            <pc:docMk/>
            <pc:sldMk cId="2130972081" sldId="400"/>
            <ac:spMk id="12" creationId="{72F84B47-E267-4194-8194-831DB7B5547F}"/>
          </ac:spMkLst>
        </pc:spChg>
        <pc:grpChg chg="add del">
          <ac:chgData name="Solis, Gabriela" userId="S::gsolis_northwell.edu#ext#@hofstra.edu::198dd0ac-6fb3-4b59-b455-eeb2e8da8c00" providerId="AD" clId="Web-{32711967-A104-8244-803B-26A273E17983}" dt="2021-07-18T18:32:34.134" v="471"/>
          <ac:grpSpMkLst>
            <pc:docMk/>
            <pc:sldMk cId="2130972081" sldId="400"/>
            <ac:grpSpMk id="15" creationId="{828A5161-06F1-46CF-8AD7-844680A59E13}"/>
          </ac:grpSpMkLst>
        </pc:grpChg>
        <pc:grpChg chg="add del">
          <ac:chgData name="Solis, Gabriela" userId="S::gsolis_northwell.edu#ext#@hofstra.edu::198dd0ac-6fb3-4b59-b455-eeb2e8da8c00" providerId="AD" clId="Web-{32711967-A104-8244-803B-26A273E17983}" dt="2021-07-18T18:32:34.134" v="471"/>
          <ac:grpSpMkLst>
            <pc:docMk/>
            <pc:sldMk cId="2130972081" sldId="400"/>
            <ac:grpSpMk id="16" creationId="{5995D10D-E9C9-47DB-AE7E-801FEF38F5C9}"/>
          </ac:grpSpMkLst>
        </pc:grpChg>
        <pc:picChg chg="add del mod">
          <ac:chgData name="Solis, Gabriela" userId="S::gsolis_northwell.edu#ext#@hofstra.edu::198dd0ac-6fb3-4b59-b455-eeb2e8da8c00" providerId="AD" clId="Web-{32711967-A104-8244-803B-26A273E17983}" dt="2021-07-18T18:36:37.346" v="514"/>
          <ac:picMkLst>
            <pc:docMk/>
            <pc:sldMk cId="2130972081" sldId="400"/>
            <ac:picMk id="5" creationId="{40D4D99A-E9C4-4448-B1F4-C36E9FCD738E}"/>
          </ac:picMkLst>
        </pc:picChg>
      </pc:sldChg>
      <pc:sldChg chg="modSp add replId">
        <pc:chgData name="Solis, Gabriela" userId="S::gsolis_northwell.edu#ext#@hofstra.edu::198dd0ac-6fb3-4b59-b455-eeb2e8da8c00" providerId="AD" clId="Web-{32711967-A104-8244-803B-26A273E17983}" dt="2021-07-18T18:39:01.192" v="536" actId="20577"/>
        <pc:sldMkLst>
          <pc:docMk/>
          <pc:sldMk cId="32438913" sldId="401"/>
        </pc:sldMkLst>
        <pc:spChg chg="mod">
          <ac:chgData name="Solis, Gabriela" userId="S::gsolis_northwell.edu#ext#@hofstra.edu::198dd0ac-6fb3-4b59-b455-eeb2e8da8c00" providerId="AD" clId="Web-{32711967-A104-8244-803B-26A273E17983}" dt="2021-07-18T18:38:40.676" v="533" actId="20577"/>
          <ac:spMkLst>
            <pc:docMk/>
            <pc:sldMk cId="32438913" sldId="401"/>
            <ac:spMk id="2" creationId="{47780179-0182-4210-AB55-A1699228033C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8:39:01.192" v="536" actId="20577"/>
          <ac:spMkLst>
            <pc:docMk/>
            <pc:sldMk cId="32438913" sldId="401"/>
            <ac:spMk id="3" creationId="{9A392957-BD48-49DE-8599-0E44A1AE6D05}"/>
          </ac:spMkLst>
        </pc:spChg>
      </pc:sldChg>
      <pc:sldChg chg="modSp add replId">
        <pc:chgData name="Solis, Gabriela" userId="S::gsolis_northwell.edu#ext#@hofstra.edu::198dd0ac-6fb3-4b59-b455-eeb2e8da8c00" providerId="AD" clId="Web-{32711967-A104-8244-803B-26A273E17983}" dt="2021-07-18T18:39:48.553" v="547" actId="1076"/>
        <pc:sldMkLst>
          <pc:docMk/>
          <pc:sldMk cId="1399099135" sldId="402"/>
        </pc:sldMkLst>
        <pc:spChg chg="mod">
          <ac:chgData name="Solis, Gabriela" userId="S::gsolis_northwell.edu#ext#@hofstra.edu::198dd0ac-6fb3-4b59-b455-eeb2e8da8c00" providerId="AD" clId="Web-{32711967-A104-8244-803B-26A273E17983}" dt="2021-07-18T18:39:29.037" v="542" actId="20577"/>
          <ac:spMkLst>
            <pc:docMk/>
            <pc:sldMk cId="1399099135" sldId="402"/>
            <ac:spMk id="2" creationId="{47780179-0182-4210-AB55-A1699228033C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8:39:48.553" v="547" actId="1076"/>
          <ac:spMkLst>
            <pc:docMk/>
            <pc:sldMk cId="1399099135" sldId="402"/>
            <ac:spMk id="3" creationId="{9A392957-BD48-49DE-8599-0E44A1AE6D05}"/>
          </ac:spMkLst>
        </pc:spChg>
      </pc:sldChg>
      <pc:sldChg chg="addSp modSp add replId">
        <pc:chgData name="Solis, Gabriela" userId="S::gsolis_northwell.edu#ext#@hofstra.edu::198dd0ac-6fb3-4b59-b455-eeb2e8da8c00" providerId="AD" clId="Web-{32711967-A104-8244-803B-26A273E17983}" dt="2021-07-18T18:42:26.634" v="567" actId="1076"/>
        <pc:sldMkLst>
          <pc:docMk/>
          <pc:sldMk cId="30129961" sldId="403"/>
        </pc:sldMkLst>
        <pc:spChg chg="mod">
          <ac:chgData name="Solis, Gabriela" userId="S::gsolis_northwell.edu#ext#@hofstra.edu::198dd0ac-6fb3-4b59-b455-eeb2e8da8c00" providerId="AD" clId="Web-{32711967-A104-8244-803B-26A273E17983}" dt="2021-07-18T18:41:10.851" v="554" actId="20577"/>
          <ac:spMkLst>
            <pc:docMk/>
            <pc:sldMk cId="30129961" sldId="403"/>
            <ac:spMk id="2" creationId="{47780179-0182-4210-AB55-A1699228033C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8:42:17.618" v="564" actId="20577"/>
          <ac:spMkLst>
            <pc:docMk/>
            <pc:sldMk cId="30129961" sldId="403"/>
            <ac:spMk id="3" creationId="{9A392957-BD48-49DE-8599-0E44A1AE6D05}"/>
          </ac:spMkLst>
        </pc:spChg>
        <pc:spChg chg="add mod">
          <ac:chgData name="Solis, Gabriela" userId="S::gsolis_northwell.edu#ext#@hofstra.edu::198dd0ac-6fb3-4b59-b455-eeb2e8da8c00" providerId="AD" clId="Web-{32711967-A104-8244-803B-26A273E17983}" dt="2021-07-18T18:41:49.915" v="559" actId="1076"/>
          <ac:spMkLst>
            <pc:docMk/>
            <pc:sldMk cId="30129961" sldId="403"/>
            <ac:spMk id="5" creationId="{056AC829-0ADE-4228-B60C-B4AD25C34B65}"/>
          </ac:spMkLst>
        </pc:spChg>
        <pc:picChg chg="add mod">
          <ac:chgData name="Solis, Gabriela" userId="S::gsolis_northwell.edu#ext#@hofstra.edu::198dd0ac-6fb3-4b59-b455-eeb2e8da8c00" providerId="AD" clId="Web-{32711967-A104-8244-803B-26A273E17983}" dt="2021-07-18T18:42:26.634" v="567" actId="1076"/>
          <ac:picMkLst>
            <pc:docMk/>
            <pc:sldMk cId="30129961" sldId="403"/>
            <ac:picMk id="7" creationId="{76912F38-878A-4D8D-8160-011CBB84C7B3}"/>
          </ac:picMkLst>
        </pc:picChg>
      </pc:sldChg>
      <pc:sldChg chg="addSp modSp add replId">
        <pc:chgData name="Solis, Gabriela" userId="S::gsolis_northwell.edu#ext#@hofstra.edu::198dd0ac-6fb3-4b59-b455-eeb2e8da8c00" providerId="AD" clId="Web-{32711967-A104-8244-803B-26A273E17983}" dt="2021-07-18T18:45:02.309" v="584"/>
        <pc:sldMkLst>
          <pc:docMk/>
          <pc:sldMk cId="765348557" sldId="404"/>
        </pc:sldMkLst>
        <pc:spChg chg="mod">
          <ac:chgData name="Solis, Gabriela" userId="S::gsolis_northwell.edu#ext#@hofstra.edu::198dd0ac-6fb3-4b59-b455-eeb2e8da8c00" providerId="AD" clId="Web-{32711967-A104-8244-803B-26A273E17983}" dt="2021-07-18T18:44:51.512" v="583" actId="1076"/>
          <ac:spMkLst>
            <pc:docMk/>
            <pc:sldMk cId="765348557" sldId="404"/>
            <ac:spMk id="2" creationId="{47780179-0182-4210-AB55-A1699228033C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8:44:45.887" v="582" actId="1076"/>
          <ac:spMkLst>
            <pc:docMk/>
            <pc:sldMk cId="765348557" sldId="404"/>
            <ac:spMk id="3" creationId="{9A392957-BD48-49DE-8599-0E44A1AE6D05}"/>
          </ac:spMkLst>
        </pc:spChg>
        <pc:picChg chg="add">
          <ac:chgData name="Solis, Gabriela" userId="S::gsolis_northwell.edu#ext#@hofstra.edu::198dd0ac-6fb3-4b59-b455-eeb2e8da8c00" providerId="AD" clId="Web-{32711967-A104-8244-803B-26A273E17983}" dt="2021-07-18T18:45:02.309" v="584"/>
          <ac:picMkLst>
            <pc:docMk/>
            <pc:sldMk cId="765348557" sldId="404"/>
            <ac:picMk id="5" creationId="{F0F567F1-15EE-425C-810C-D60580C8B4A4}"/>
          </ac:picMkLst>
        </pc:picChg>
      </pc:sldChg>
      <pc:sldChg chg="modSp add replId">
        <pc:chgData name="Solis, Gabriela" userId="S::gsolis_northwell.edu#ext#@hofstra.edu::198dd0ac-6fb3-4b59-b455-eeb2e8da8c00" providerId="AD" clId="Web-{32711967-A104-8244-803B-26A273E17983}" dt="2021-07-18T18:46:13.248" v="596" actId="20577"/>
        <pc:sldMkLst>
          <pc:docMk/>
          <pc:sldMk cId="2623007478" sldId="405"/>
        </pc:sldMkLst>
        <pc:spChg chg="mod">
          <ac:chgData name="Solis, Gabriela" userId="S::gsolis_northwell.edu#ext#@hofstra.edu::198dd0ac-6fb3-4b59-b455-eeb2e8da8c00" providerId="AD" clId="Web-{32711967-A104-8244-803B-26A273E17983}" dt="2021-07-18T18:46:13.248" v="596" actId="20577"/>
          <ac:spMkLst>
            <pc:docMk/>
            <pc:sldMk cId="2623007478" sldId="405"/>
            <ac:spMk id="2" creationId="{47780179-0182-4210-AB55-A1699228033C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8:46:09.561" v="595" actId="1076"/>
          <ac:spMkLst>
            <pc:docMk/>
            <pc:sldMk cId="2623007478" sldId="405"/>
            <ac:spMk id="3" creationId="{9A392957-BD48-49DE-8599-0E44A1AE6D05}"/>
          </ac:spMkLst>
        </pc:spChg>
      </pc:sldChg>
      <pc:sldChg chg="modSp add replId">
        <pc:chgData name="Solis, Gabriela" userId="S::gsolis_northwell.edu#ext#@hofstra.edu::198dd0ac-6fb3-4b59-b455-eeb2e8da8c00" providerId="AD" clId="Web-{32711967-A104-8244-803B-26A273E17983}" dt="2021-07-18T18:46:49.390" v="603" actId="20577"/>
        <pc:sldMkLst>
          <pc:docMk/>
          <pc:sldMk cId="3380947776" sldId="406"/>
        </pc:sldMkLst>
        <pc:spChg chg="mod">
          <ac:chgData name="Solis, Gabriela" userId="S::gsolis_northwell.edu#ext#@hofstra.edu::198dd0ac-6fb3-4b59-b455-eeb2e8da8c00" providerId="AD" clId="Web-{32711967-A104-8244-803B-26A273E17983}" dt="2021-07-18T18:46:37.155" v="601" actId="20577"/>
          <ac:spMkLst>
            <pc:docMk/>
            <pc:sldMk cId="3380947776" sldId="406"/>
            <ac:spMk id="2" creationId="{47780179-0182-4210-AB55-A1699228033C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8:46:49.390" v="603" actId="20577"/>
          <ac:spMkLst>
            <pc:docMk/>
            <pc:sldMk cId="3380947776" sldId="406"/>
            <ac:spMk id="3" creationId="{9A392957-BD48-49DE-8599-0E44A1AE6D05}"/>
          </ac:spMkLst>
        </pc:spChg>
      </pc:sldChg>
      <pc:sldChg chg="modSp add replId">
        <pc:chgData name="Solis, Gabriela" userId="S::gsolis_northwell.edu#ext#@hofstra.edu::198dd0ac-6fb3-4b59-b455-eeb2e8da8c00" providerId="AD" clId="Web-{32711967-A104-8244-803B-26A273E17983}" dt="2021-07-18T18:47:35.141" v="613" actId="20577"/>
        <pc:sldMkLst>
          <pc:docMk/>
          <pc:sldMk cId="1455224235" sldId="407"/>
        </pc:sldMkLst>
        <pc:spChg chg="mod">
          <ac:chgData name="Solis, Gabriela" userId="S::gsolis_northwell.edu#ext#@hofstra.edu::198dd0ac-6fb3-4b59-b455-eeb2e8da8c00" providerId="AD" clId="Web-{32711967-A104-8244-803B-26A273E17983}" dt="2021-07-18T18:47:23.656" v="610" actId="1076"/>
          <ac:spMkLst>
            <pc:docMk/>
            <pc:sldMk cId="1455224235" sldId="407"/>
            <ac:spMk id="2" creationId="{47780179-0182-4210-AB55-A1699228033C}"/>
          </ac:spMkLst>
        </pc:spChg>
        <pc:spChg chg="mod">
          <ac:chgData name="Solis, Gabriela" userId="S::gsolis_northwell.edu#ext#@hofstra.edu::198dd0ac-6fb3-4b59-b455-eeb2e8da8c00" providerId="AD" clId="Web-{32711967-A104-8244-803B-26A273E17983}" dt="2021-07-18T18:47:35.141" v="613" actId="20577"/>
          <ac:spMkLst>
            <pc:docMk/>
            <pc:sldMk cId="1455224235" sldId="407"/>
            <ac:spMk id="3" creationId="{9A392957-BD48-49DE-8599-0E44A1AE6D05}"/>
          </ac:spMkLst>
        </pc:spChg>
      </pc:sldChg>
    </pc:docChg>
  </pc:docChgLst>
  <pc:docChgLst>
    <pc:chgData name="janice.john@einsteinmed.edu" userId="S::urn:spo:guest#janice.john@einsteinmed.edu::" providerId="AD" clId="Web-{7E16B724-D67E-644F-25A2-4F2E7E5E1AF1}"/>
    <pc:docChg chg="modSld">
      <pc:chgData name="janice.john@einsteinmed.edu" userId="S::urn:spo:guest#janice.john@einsteinmed.edu::" providerId="AD" clId="Web-{7E16B724-D67E-644F-25A2-4F2E7E5E1AF1}" dt="2022-04-12T13:40:36.301" v="69"/>
      <pc:docMkLst>
        <pc:docMk/>
      </pc:docMkLst>
      <pc:sldChg chg="addCm delCm">
        <pc:chgData name="janice.john@einsteinmed.edu" userId="S::urn:spo:guest#janice.john@einsteinmed.edu::" providerId="AD" clId="Web-{7E16B724-D67E-644F-25A2-4F2E7E5E1AF1}" dt="2022-04-12T13:40:36.301" v="69"/>
        <pc:sldMkLst>
          <pc:docMk/>
          <pc:sldMk cId="3711734020" sldId="386"/>
        </pc:sldMkLst>
      </pc:sldChg>
      <pc:sldChg chg="addCm">
        <pc:chgData name="janice.john@einsteinmed.edu" userId="S::urn:spo:guest#janice.john@einsteinmed.edu::" providerId="AD" clId="Web-{7E16B724-D67E-644F-25A2-4F2E7E5E1AF1}" dt="2022-04-12T12:17:13.865" v="3"/>
        <pc:sldMkLst>
          <pc:docMk/>
          <pc:sldMk cId="4046426465" sldId="391"/>
        </pc:sldMkLst>
      </pc:sldChg>
      <pc:sldChg chg="addCm">
        <pc:chgData name="janice.john@einsteinmed.edu" userId="S::urn:spo:guest#janice.john@einsteinmed.edu::" providerId="AD" clId="Web-{7E16B724-D67E-644F-25A2-4F2E7E5E1AF1}" dt="2022-04-12T12:19:06.258" v="4"/>
        <pc:sldMkLst>
          <pc:docMk/>
          <pc:sldMk cId="2028606082" sldId="393"/>
        </pc:sldMkLst>
      </pc:sldChg>
      <pc:sldChg chg="modSp addCm">
        <pc:chgData name="janice.john@einsteinmed.edu" userId="S::urn:spo:guest#janice.john@einsteinmed.edu::" providerId="AD" clId="Web-{7E16B724-D67E-644F-25A2-4F2E7E5E1AF1}" dt="2022-04-12T12:42:29.935" v="63" actId="20577"/>
        <pc:sldMkLst>
          <pc:docMk/>
          <pc:sldMk cId="1307065593" sldId="398"/>
        </pc:sldMkLst>
        <pc:spChg chg="mod">
          <ac:chgData name="janice.john@einsteinmed.edu" userId="S::urn:spo:guest#janice.john@einsteinmed.edu::" providerId="AD" clId="Web-{7E16B724-D67E-644F-25A2-4F2E7E5E1AF1}" dt="2022-04-12T12:41:08.293" v="47" actId="20577"/>
          <ac:spMkLst>
            <pc:docMk/>
            <pc:sldMk cId="1307065593" sldId="398"/>
            <ac:spMk id="3" creationId="{01EBB642-A9A1-4273-829D-59C1EBAD2430}"/>
          </ac:spMkLst>
        </pc:spChg>
        <pc:spChg chg="mod">
          <ac:chgData name="janice.john@einsteinmed.edu" userId="S::urn:spo:guest#janice.john@einsteinmed.edu::" providerId="AD" clId="Web-{7E16B724-D67E-644F-25A2-4F2E7E5E1AF1}" dt="2022-04-12T12:42:29.935" v="63" actId="20577"/>
          <ac:spMkLst>
            <pc:docMk/>
            <pc:sldMk cId="1307065593" sldId="398"/>
            <ac:spMk id="5" creationId="{4D827504-E1A9-459B-AC84-683A2E7257BC}"/>
          </ac:spMkLst>
        </pc:spChg>
      </pc:sldChg>
      <pc:sldChg chg="modSp">
        <pc:chgData name="janice.john@einsteinmed.edu" userId="S::urn:spo:guest#janice.john@einsteinmed.edu::" providerId="AD" clId="Web-{7E16B724-D67E-644F-25A2-4F2E7E5E1AF1}" dt="2022-04-12T12:42:53.295" v="65" actId="20577"/>
        <pc:sldMkLst>
          <pc:docMk/>
          <pc:sldMk cId="1016746710" sldId="399"/>
        </pc:sldMkLst>
        <pc:spChg chg="mod">
          <ac:chgData name="janice.john@einsteinmed.edu" userId="S::urn:spo:guest#janice.john@einsteinmed.edu::" providerId="AD" clId="Web-{7E16B724-D67E-644F-25A2-4F2E7E5E1AF1}" dt="2022-04-12T12:42:53.295" v="65" actId="20577"/>
          <ac:spMkLst>
            <pc:docMk/>
            <pc:sldMk cId="1016746710" sldId="399"/>
            <ac:spMk id="3" creationId="{01EBB642-A9A1-4273-829D-59C1EBAD2430}"/>
          </ac:spMkLst>
        </pc:spChg>
      </pc:sldChg>
      <pc:sldChg chg="modSp">
        <pc:chgData name="janice.john@einsteinmed.edu" userId="S::urn:spo:guest#janice.john@einsteinmed.edu::" providerId="AD" clId="Web-{7E16B724-D67E-644F-25A2-4F2E7E5E1AF1}" dt="2022-04-12T12:43:38.281" v="68" actId="20577"/>
        <pc:sldMkLst>
          <pc:docMk/>
          <pc:sldMk cId="1399099135" sldId="402"/>
        </pc:sldMkLst>
        <pc:spChg chg="mod">
          <ac:chgData name="janice.john@einsteinmed.edu" userId="S::urn:spo:guest#janice.john@einsteinmed.edu::" providerId="AD" clId="Web-{7E16B724-D67E-644F-25A2-4F2E7E5E1AF1}" dt="2022-04-12T12:43:38.281" v="68" actId="20577"/>
          <ac:spMkLst>
            <pc:docMk/>
            <pc:sldMk cId="1399099135" sldId="402"/>
            <ac:spMk id="3" creationId="{9A392957-BD48-49DE-8599-0E44A1AE6D05}"/>
          </ac:spMkLst>
        </pc:spChg>
      </pc:sldChg>
    </pc:docChg>
  </pc:docChgLst>
  <pc:docChgLst>
    <pc:chgData name="Gabrielle Goldberg" userId="S::gabrielle.goldberg@hofstra.edu::453f9b71-f7a4-4ef4-8e34-bbb69381dfc0" providerId="AD" clId="Web-{2725FC9E-835C-9DC7-8C18-022E0D0559A7}"/>
    <pc:docChg chg="modSld">
      <pc:chgData name="Gabrielle Goldberg" userId="S::gabrielle.goldberg@hofstra.edu::453f9b71-f7a4-4ef4-8e34-bbb69381dfc0" providerId="AD" clId="Web-{2725FC9E-835C-9DC7-8C18-022E0D0559A7}" dt="2022-04-21T22:06:30.774" v="332" actId="20577"/>
      <pc:docMkLst>
        <pc:docMk/>
      </pc:docMkLst>
      <pc:sldChg chg="modSp">
        <pc:chgData name="Gabrielle Goldberg" userId="S::gabrielle.goldberg@hofstra.edu::453f9b71-f7a4-4ef4-8e34-bbb69381dfc0" providerId="AD" clId="Web-{2725FC9E-835C-9DC7-8C18-022E0D0559A7}" dt="2022-04-21T20:51:39.038" v="5" actId="20577"/>
        <pc:sldMkLst>
          <pc:docMk/>
          <pc:sldMk cId="2418592727" sldId="373"/>
        </pc:sldMkLst>
        <pc:spChg chg="mod">
          <ac:chgData name="Gabrielle Goldberg" userId="S::gabrielle.goldberg@hofstra.edu::453f9b71-f7a4-4ef4-8e34-bbb69381dfc0" providerId="AD" clId="Web-{2725FC9E-835C-9DC7-8C18-022E0D0559A7}" dt="2022-04-21T20:51:39.038" v="5" actId="20577"/>
          <ac:spMkLst>
            <pc:docMk/>
            <pc:sldMk cId="2418592727" sldId="373"/>
            <ac:spMk id="5" creationId="{2422B267-CF78-04F0-0FCC-7107B82B1B5C}"/>
          </ac:spMkLst>
        </pc:spChg>
      </pc:sldChg>
      <pc:sldChg chg="addSp delSp modSp">
        <pc:chgData name="Gabrielle Goldberg" userId="S::gabrielle.goldberg@hofstra.edu::453f9b71-f7a4-4ef4-8e34-bbb69381dfc0" providerId="AD" clId="Web-{2725FC9E-835C-9DC7-8C18-022E0D0559A7}" dt="2022-04-21T21:51:27.637" v="327" actId="20577"/>
        <pc:sldMkLst>
          <pc:docMk/>
          <pc:sldMk cId="3375007296" sldId="380"/>
        </pc:sldMkLst>
        <pc:spChg chg="mod">
          <ac:chgData name="Gabrielle Goldberg" userId="S::gabrielle.goldberg@hofstra.edu::453f9b71-f7a4-4ef4-8e34-bbb69381dfc0" providerId="AD" clId="Web-{2725FC9E-835C-9DC7-8C18-022E0D0559A7}" dt="2022-04-21T21:29:38.326" v="287" actId="20577"/>
          <ac:spMkLst>
            <pc:docMk/>
            <pc:sldMk cId="3375007296" sldId="380"/>
            <ac:spMk id="2" creationId="{00000000-0000-0000-0000-000000000000}"/>
          </ac:spMkLst>
        </pc:spChg>
        <pc:spChg chg="del">
          <ac:chgData name="Gabrielle Goldberg" userId="S::gabrielle.goldberg@hofstra.edu::453f9b71-f7a4-4ef4-8e34-bbb69381dfc0" providerId="AD" clId="Web-{2725FC9E-835C-9DC7-8C18-022E0D0559A7}" dt="2022-04-21T21:22:10.368" v="115"/>
          <ac:spMkLst>
            <pc:docMk/>
            <pc:sldMk cId="3375007296" sldId="380"/>
            <ac:spMk id="3" creationId="{732813B5-3B16-4C39-9B26-980756C16563}"/>
          </ac:spMkLst>
        </pc:spChg>
        <pc:spChg chg="add mod">
          <ac:chgData name="Gabrielle Goldberg" userId="S::gabrielle.goldberg@hofstra.edu::453f9b71-f7a4-4ef4-8e34-bbb69381dfc0" providerId="AD" clId="Web-{2725FC9E-835C-9DC7-8C18-022E0D0559A7}" dt="2022-04-21T21:51:27.637" v="327" actId="20577"/>
          <ac:spMkLst>
            <pc:docMk/>
            <pc:sldMk cId="3375007296" sldId="380"/>
            <ac:spMk id="4" creationId="{682D95C8-4312-5A8A-7ED5-8D5288D73915}"/>
          </ac:spMkLst>
        </pc:spChg>
        <pc:picChg chg="del">
          <ac:chgData name="Gabrielle Goldberg" userId="S::gabrielle.goldberg@hofstra.edu::453f9b71-f7a4-4ef4-8e34-bbb69381dfc0" providerId="AD" clId="Web-{2725FC9E-835C-9DC7-8C18-022E0D0559A7}" dt="2022-04-21T21:22:08.025" v="114"/>
          <ac:picMkLst>
            <pc:docMk/>
            <pc:sldMk cId="3375007296" sldId="380"/>
            <ac:picMk id="7" creationId="{C881AB2D-3C9A-4D94-8D8A-B5E7537280AA}"/>
          </ac:picMkLst>
        </pc:picChg>
      </pc:sldChg>
      <pc:sldChg chg="modSp">
        <pc:chgData name="Gabrielle Goldberg" userId="S::gabrielle.goldberg@hofstra.edu::453f9b71-f7a4-4ef4-8e34-bbb69381dfc0" providerId="AD" clId="Web-{2725FC9E-835C-9DC7-8C18-022E0D0559A7}" dt="2022-04-21T21:08:50.818" v="113" actId="20577"/>
        <pc:sldMkLst>
          <pc:docMk/>
          <pc:sldMk cId="2130972081" sldId="400"/>
        </pc:sldMkLst>
        <pc:spChg chg="mod">
          <ac:chgData name="Gabrielle Goldberg" userId="S::gabrielle.goldberg@hofstra.edu::453f9b71-f7a4-4ef4-8e34-bbb69381dfc0" providerId="AD" clId="Web-{2725FC9E-835C-9DC7-8C18-022E0D0559A7}" dt="2022-04-21T21:08:50.818" v="113" actId="20577"/>
          <ac:spMkLst>
            <pc:docMk/>
            <pc:sldMk cId="2130972081" sldId="400"/>
            <ac:spMk id="3" creationId="{01EBB642-A9A1-4273-829D-59C1EBAD2430}"/>
          </ac:spMkLst>
        </pc:spChg>
      </pc:sldChg>
      <pc:sldChg chg="modSp">
        <pc:chgData name="Gabrielle Goldberg" userId="S::gabrielle.goldberg@hofstra.edu::453f9b71-f7a4-4ef4-8e34-bbb69381dfc0" providerId="AD" clId="Web-{2725FC9E-835C-9DC7-8C18-022E0D0559A7}" dt="2022-04-21T22:06:30.774" v="332" actId="20577"/>
        <pc:sldMkLst>
          <pc:docMk/>
          <pc:sldMk cId="2389432848" sldId="409"/>
        </pc:sldMkLst>
        <pc:spChg chg="mod">
          <ac:chgData name="Gabrielle Goldberg" userId="S::gabrielle.goldberg@hofstra.edu::453f9b71-f7a4-4ef4-8e34-bbb69381dfc0" providerId="AD" clId="Web-{2725FC9E-835C-9DC7-8C18-022E0D0559A7}" dt="2022-04-21T22:06:30.774" v="332" actId="20577"/>
          <ac:spMkLst>
            <pc:docMk/>
            <pc:sldMk cId="2389432848" sldId="409"/>
            <ac:spMk id="3" creationId="{E9EDFBA1-7150-400B-8F65-B9FCC70F6A35}"/>
          </ac:spMkLst>
        </pc:spChg>
      </pc:sldChg>
    </pc:docChg>
  </pc:docChgLst>
  <pc:docChgLst>
    <pc:chgData name="Gabrielle Goldberg" userId="S::gabrielle.goldberg@hofstra.edu::453f9b71-f7a4-4ef4-8e34-bbb69381dfc0" providerId="AD" clId="Web-{43383DA8-5D41-9816-ED70-1E1642166D98}"/>
    <pc:docChg chg="modSld">
      <pc:chgData name="Gabrielle Goldberg" userId="S::gabrielle.goldberg@hofstra.edu::453f9b71-f7a4-4ef4-8e34-bbb69381dfc0" providerId="AD" clId="Web-{43383DA8-5D41-9816-ED70-1E1642166D98}" dt="2021-07-09T20:10:56.102" v="24"/>
      <pc:docMkLst>
        <pc:docMk/>
      </pc:docMkLst>
      <pc:sldChg chg="delSp">
        <pc:chgData name="Gabrielle Goldberg" userId="S::gabrielle.goldberg@hofstra.edu::453f9b71-f7a4-4ef4-8e34-bbb69381dfc0" providerId="AD" clId="Web-{43383DA8-5D41-9816-ED70-1E1642166D98}" dt="2021-07-09T20:10:56.102" v="24"/>
        <pc:sldMkLst>
          <pc:docMk/>
          <pc:sldMk cId="2655814267" sldId="280"/>
        </pc:sldMkLst>
        <pc:picChg chg="del">
          <ac:chgData name="Gabrielle Goldberg" userId="S::gabrielle.goldberg@hofstra.edu::453f9b71-f7a4-4ef4-8e34-bbb69381dfc0" providerId="AD" clId="Web-{43383DA8-5D41-9816-ED70-1E1642166D98}" dt="2021-07-09T20:10:56.102" v="24"/>
          <ac:picMkLst>
            <pc:docMk/>
            <pc:sldMk cId="2655814267" sldId="280"/>
            <ac:picMk id="3" creationId="{0E6D56A4-A98E-4D77-A303-68A45419F08C}"/>
          </ac:picMkLst>
        </pc:picChg>
      </pc:sldChg>
      <pc:sldChg chg="delSp">
        <pc:chgData name="Gabrielle Goldberg" userId="S::gabrielle.goldberg@hofstra.edu::453f9b71-f7a4-4ef4-8e34-bbb69381dfc0" providerId="AD" clId="Web-{43383DA8-5D41-9816-ED70-1E1642166D98}" dt="2021-07-09T20:08:13.598" v="0"/>
        <pc:sldMkLst>
          <pc:docMk/>
          <pc:sldMk cId="3061336521" sldId="318"/>
        </pc:sldMkLst>
        <pc:picChg chg="del">
          <ac:chgData name="Gabrielle Goldberg" userId="S::gabrielle.goldberg@hofstra.edu::453f9b71-f7a4-4ef4-8e34-bbb69381dfc0" providerId="AD" clId="Web-{43383DA8-5D41-9816-ED70-1E1642166D98}" dt="2021-07-09T20:08:13.598" v="0"/>
          <ac:picMkLst>
            <pc:docMk/>
            <pc:sldMk cId="3061336521" sldId="318"/>
            <ac:picMk id="4100" creationId="{00000000-0000-0000-0000-000000000000}"/>
          </ac:picMkLst>
        </pc:picChg>
      </pc:sldChg>
      <pc:sldChg chg="addSp delSp modSp">
        <pc:chgData name="Gabrielle Goldberg" userId="S::gabrielle.goldberg@hofstra.edu::453f9b71-f7a4-4ef4-8e34-bbb69381dfc0" providerId="AD" clId="Web-{43383DA8-5D41-9816-ED70-1E1642166D98}" dt="2021-07-09T20:09:30.006" v="23"/>
        <pc:sldMkLst>
          <pc:docMk/>
          <pc:sldMk cId="3188627780" sldId="375"/>
        </pc:sldMkLst>
        <pc:spChg chg="mod">
          <ac:chgData name="Gabrielle Goldberg" userId="S::gabrielle.goldberg@hofstra.edu::453f9b71-f7a4-4ef4-8e34-bbb69381dfc0" providerId="AD" clId="Web-{43383DA8-5D41-9816-ED70-1E1642166D98}" dt="2021-07-09T20:09:26.663" v="22" actId="14100"/>
          <ac:spMkLst>
            <pc:docMk/>
            <pc:sldMk cId="3188627780" sldId="375"/>
            <ac:spMk id="4" creationId="{3E180195-0311-4728-AB96-0C60748A963B}"/>
          </ac:spMkLst>
        </pc:spChg>
        <pc:spChg chg="add">
          <ac:chgData name="Gabrielle Goldberg" userId="S::gabrielle.goldberg@hofstra.edu::453f9b71-f7a4-4ef4-8e34-bbb69381dfc0" providerId="AD" clId="Web-{43383DA8-5D41-9816-ED70-1E1642166D98}" dt="2021-07-09T20:09:30.006" v="23"/>
          <ac:spMkLst>
            <pc:docMk/>
            <pc:sldMk cId="3188627780" sldId="375"/>
            <ac:spMk id="6" creationId="{60AF6881-2C5A-497B-A838-BB30395303C2}"/>
          </ac:spMkLst>
        </pc:spChg>
        <pc:picChg chg="del">
          <ac:chgData name="Gabrielle Goldberg" userId="S::gabrielle.goldberg@hofstra.edu::453f9b71-f7a4-4ef4-8e34-bbb69381dfc0" providerId="AD" clId="Web-{43383DA8-5D41-9816-ED70-1E1642166D98}" dt="2021-07-09T20:08:48.646" v="1"/>
          <ac:picMkLst>
            <pc:docMk/>
            <pc:sldMk cId="3188627780" sldId="375"/>
            <ac:picMk id="5" creationId="{8FC6DC4D-72BB-4BBC-8CF2-373459AD3C6E}"/>
          </ac:picMkLst>
        </pc:picChg>
      </pc:sldChg>
    </pc:docChg>
  </pc:docChgLst>
  <pc:docChgLst>
    <pc:chgData name="Solis, Gabriela" userId="S::gsolis_northwell.edu#ext#@hofstra.edu::198dd0ac-6fb3-4b59-b455-eeb2e8da8c00" providerId="AD" clId="Web-{0E634F0B-6D55-E1F1-860C-DC588274B8E0}"/>
    <pc:docChg chg="modSld">
      <pc:chgData name="Solis, Gabriela" userId="S::gsolis_northwell.edu#ext#@hofstra.edu::198dd0ac-6fb3-4b59-b455-eeb2e8da8c00" providerId="AD" clId="Web-{0E634F0B-6D55-E1F1-860C-DC588274B8E0}" dt="2021-08-30T15:08:55.481" v="3" actId="1076"/>
      <pc:docMkLst>
        <pc:docMk/>
      </pc:docMkLst>
      <pc:sldChg chg="addSp modSp">
        <pc:chgData name="Solis, Gabriela" userId="S::gsolis_northwell.edu#ext#@hofstra.edu::198dd0ac-6fb3-4b59-b455-eeb2e8da8c00" providerId="AD" clId="Web-{0E634F0B-6D55-E1F1-860C-DC588274B8E0}" dt="2021-08-30T15:08:55.481" v="3" actId="1076"/>
        <pc:sldMkLst>
          <pc:docMk/>
          <pc:sldMk cId="659258882" sldId="316"/>
        </pc:sldMkLst>
        <pc:spChg chg="add mod">
          <ac:chgData name="Solis, Gabriela" userId="S::gsolis_northwell.edu#ext#@hofstra.edu::198dd0ac-6fb3-4b59-b455-eeb2e8da8c00" providerId="AD" clId="Web-{0E634F0B-6D55-E1F1-860C-DC588274B8E0}" dt="2021-08-30T15:08:55.481" v="3" actId="1076"/>
          <ac:spMkLst>
            <pc:docMk/>
            <pc:sldMk cId="659258882" sldId="316"/>
            <ac:spMk id="3" creationId="{D96639EA-5FFF-401B-9EEE-47DDDC48ADCC}"/>
          </ac:spMkLst>
        </pc:spChg>
      </pc:sldChg>
    </pc:docChg>
  </pc:docChgLst>
  <pc:docChgLst>
    <pc:chgData name="Gabrielle Goldberg" userId="S::gabrielle.goldberg@hofstra.edu::453f9b71-f7a4-4ef4-8e34-bbb69381dfc0" providerId="AD" clId="Web-{ADA0ADB2-0F63-50B9-459A-537D4BB99377}"/>
    <pc:docChg chg="modSld">
      <pc:chgData name="Gabrielle Goldberg" userId="S::gabrielle.goldberg@hofstra.edu::453f9b71-f7a4-4ef4-8e34-bbb69381dfc0" providerId="AD" clId="Web-{ADA0ADB2-0F63-50B9-459A-537D4BB99377}" dt="2022-04-01T16:47:28.944" v="0" actId="20577"/>
      <pc:docMkLst>
        <pc:docMk/>
      </pc:docMkLst>
      <pc:sldChg chg="modSp">
        <pc:chgData name="Gabrielle Goldberg" userId="S::gabrielle.goldberg@hofstra.edu::453f9b71-f7a4-4ef4-8e34-bbb69381dfc0" providerId="AD" clId="Web-{ADA0ADB2-0F63-50B9-459A-537D4BB99377}" dt="2022-04-01T16:47:28.944" v="0" actId="20577"/>
        <pc:sldMkLst>
          <pc:docMk/>
          <pc:sldMk cId="3150183129" sldId="379"/>
        </pc:sldMkLst>
        <pc:graphicFrameChg chg="modGraphic">
          <ac:chgData name="Gabrielle Goldberg" userId="S::gabrielle.goldberg@hofstra.edu::453f9b71-f7a4-4ef4-8e34-bbb69381dfc0" providerId="AD" clId="Web-{ADA0ADB2-0F63-50B9-459A-537D4BB99377}" dt="2022-04-01T16:47:28.944" v="0" actId="20577"/>
          <ac:graphicFrameMkLst>
            <pc:docMk/>
            <pc:sldMk cId="3150183129" sldId="379"/>
            <ac:graphicFrameMk id="4" creationId="{C1FFCE84-EBCA-4D7F-9C21-DF600EF51E09}"/>
          </ac:graphicFrameMkLst>
        </pc:graphicFrameChg>
      </pc:sldChg>
    </pc:docChg>
  </pc:docChgLst>
  <pc:docChgLst>
    <pc:chgData name="Gabrielle Goldberg" userId="S::gabrielle.goldberg@hofstra.edu::453f9b71-f7a4-4ef4-8e34-bbb69381dfc0" providerId="AD" clId="Web-{7903C268-2EAB-6D07-F8B3-9736B7DAA888}"/>
    <pc:docChg chg="modSld">
      <pc:chgData name="Gabrielle Goldberg" userId="S::gabrielle.goldberg@hofstra.edu::453f9b71-f7a4-4ef4-8e34-bbb69381dfc0" providerId="AD" clId="Web-{7903C268-2EAB-6D07-F8B3-9736B7DAA888}" dt="2022-04-15T14:45:08.371" v="107" actId="20577"/>
      <pc:docMkLst>
        <pc:docMk/>
      </pc:docMkLst>
      <pc:sldChg chg="modSp">
        <pc:chgData name="Gabrielle Goldberg" userId="S::gabrielle.goldberg@hofstra.edu::453f9b71-f7a4-4ef4-8e34-bbb69381dfc0" providerId="AD" clId="Web-{7903C268-2EAB-6D07-F8B3-9736B7DAA888}" dt="2022-04-15T14:21:53.825" v="70" actId="20577"/>
        <pc:sldMkLst>
          <pc:docMk/>
          <pc:sldMk cId="3695886494" sldId="377"/>
        </pc:sldMkLst>
        <pc:spChg chg="mod">
          <ac:chgData name="Gabrielle Goldberg" userId="S::gabrielle.goldberg@hofstra.edu::453f9b71-f7a4-4ef4-8e34-bbb69381dfc0" providerId="AD" clId="Web-{7903C268-2EAB-6D07-F8B3-9736B7DAA888}" dt="2022-04-15T14:21:53.825" v="70" actId="20577"/>
          <ac:spMkLst>
            <pc:docMk/>
            <pc:sldMk cId="3695886494" sldId="377"/>
            <ac:spMk id="5" creationId="{7CACB6FB-1027-4FD0-8C7E-D2E2B4263D4D}"/>
          </ac:spMkLst>
        </pc:spChg>
      </pc:sldChg>
      <pc:sldChg chg="modSp">
        <pc:chgData name="Gabrielle Goldberg" userId="S::gabrielle.goldberg@hofstra.edu::453f9b71-f7a4-4ef4-8e34-bbb69381dfc0" providerId="AD" clId="Web-{7903C268-2EAB-6D07-F8B3-9736B7DAA888}" dt="2022-04-15T14:22:30.342" v="77" actId="20577"/>
        <pc:sldMkLst>
          <pc:docMk/>
          <pc:sldMk cId="3375007296" sldId="380"/>
        </pc:sldMkLst>
        <pc:spChg chg="mod">
          <ac:chgData name="Gabrielle Goldberg" userId="S::gabrielle.goldberg@hofstra.edu::453f9b71-f7a4-4ef4-8e34-bbb69381dfc0" providerId="AD" clId="Web-{7903C268-2EAB-6D07-F8B3-9736B7DAA888}" dt="2022-04-15T14:22:30.342" v="77" actId="20577"/>
          <ac:spMkLst>
            <pc:docMk/>
            <pc:sldMk cId="3375007296" sldId="380"/>
            <ac:spMk id="2" creationId="{00000000-0000-0000-0000-000000000000}"/>
          </ac:spMkLst>
        </pc:spChg>
      </pc:sldChg>
      <pc:sldChg chg="modSp">
        <pc:chgData name="Gabrielle Goldberg" userId="S::gabrielle.goldberg@hofstra.edu::453f9b71-f7a4-4ef4-8e34-bbb69381dfc0" providerId="AD" clId="Web-{7903C268-2EAB-6D07-F8B3-9736B7DAA888}" dt="2022-04-15T14:45:08.371" v="107" actId="20577"/>
        <pc:sldMkLst>
          <pc:docMk/>
          <pc:sldMk cId="156485789" sldId="389"/>
        </pc:sldMkLst>
        <pc:graphicFrameChg chg="modGraphic">
          <ac:chgData name="Gabrielle Goldberg" userId="S::gabrielle.goldberg@hofstra.edu::453f9b71-f7a4-4ef4-8e34-bbb69381dfc0" providerId="AD" clId="Web-{7903C268-2EAB-6D07-F8B3-9736B7DAA888}" dt="2022-04-15T14:45:08.371" v="107" actId="20577"/>
          <ac:graphicFrameMkLst>
            <pc:docMk/>
            <pc:sldMk cId="156485789" sldId="389"/>
            <ac:graphicFrameMk id="8" creationId="{A7BF77DA-70BD-4B1F-8966-83423723D9A4}"/>
          </ac:graphicFrameMkLst>
        </pc:graphicFrameChg>
      </pc:sldChg>
      <pc:sldChg chg="modSp">
        <pc:chgData name="Gabrielle Goldberg" userId="S::gabrielle.goldberg@hofstra.edu::453f9b71-f7a4-4ef4-8e34-bbb69381dfc0" providerId="AD" clId="Web-{7903C268-2EAB-6D07-F8B3-9736B7DAA888}" dt="2022-04-15T14:40:25.818" v="98" actId="20577"/>
        <pc:sldMkLst>
          <pc:docMk/>
          <pc:sldMk cId="2389432848" sldId="409"/>
        </pc:sldMkLst>
        <pc:spChg chg="mod">
          <ac:chgData name="Gabrielle Goldberg" userId="S::gabrielle.goldberg@hofstra.edu::453f9b71-f7a4-4ef4-8e34-bbb69381dfc0" providerId="AD" clId="Web-{7903C268-2EAB-6D07-F8B3-9736B7DAA888}" dt="2022-04-15T14:40:25.818" v="98" actId="20577"/>
          <ac:spMkLst>
            <pc:docMk/>
            <pc:sldMk cId="2389432848" sldId="409"/>
            <ac:spMk id="3" creationId="{E9EDFBA1-7150-400B-8F65-B9FCC70F6A35}"/>
          </ac:spMkLst>
        </pc:spChg>
        <pc:spChg chg="mod">
          <ac:chgData name="Gabrielle Goldberg" userId="S::gabrielle.goldberg@hofstra.edu::453f9b71-f7a4-4ef4-8e34-bbb69381dfc0" providerId="AD" clId="Web-{7903C268-2EAB-6D07-F8B3-9736B7DAA888}" dt="2022-04-15T14:40:18.834" v="97"/>
          <ac:spMkLst>
            <pc:docMk/>
            <pc:sldMk cId="2389432848" sldId="409"/>
            <ac:spMk id="5" creationId="{A27BCAED-3F39-4CA1-90F6-B019F5180986}"/>
          </ac:spMkLst>
        </pc:spChg>
      </pc:sldChg>
    </pc:docChg>
  </pc:docChgLst>
  <pc:docChgLst>
    <pc:chgData name="Solis, Gabriela" userId="S::gsolis_northwell.edu#ext#@hofstra.edu::198dd0ac-6fb3-4b59-b455-eeb2e8da8c00" providerId="AD" clId="Web-{E57302F7-145D-B7B9-E787-24930494F588}"/>
    <pc:docChg chg="modSld">
      <pc:chgData name="Solis, Gabriela" userId="S::gsolis_northwell.edu#ext#@hofstra.edu::198dd0ac-6fb3-4b59-b455-eeb2e8da8c00" providerId="AD" clId="Web-{E57302F7-145D-B7B9-E787-24930494F588}" dt="2022-04-19T22:53:11.171" v="5" actId="20577"/>
      <pc:docMkLst>
        <pc:docMk/>
      </pc:docMkLst>
      <pc:sldChg chg="modSp">
        <pc:chgData name="Solis, Gabriela" userId="S::gsolis_northwell.edu#ext#@hofstra.edu::198dd0ac-6fb3-4b59-b455-eeb2e8da8c00" providerId="AD" clId="Web-{E57302F7-145D-B7B9-E787-24930494F588}" dt="2022-04-19T22:53:11.171" v="5" actId="20577"/>
        <pc:sldMkLst>
          <pc:docMk/>
          <pc:sldMk cId="2389432848" sldId="409"/>
        </pc:sldMkLst>
        <pc:spChg chg="mod">
          <ac:chgData name="Solis, Gabriela" userId="S::gsolis_northwell.edu#ext#@hofstra.edu::198dd0ac-6fb3-4b59-b455-eeb2e8da8c00" providerId="AD" clId="Web-{E57302F7-145D-B7B9-E787-24930494F588}" dt="2022-04-19T22:53:11.171" v="5" actId="20577"/>
          <ac:spMkLst>
            <pc:docMk/>
            <pc:sldMk cId="2389432848" sldId="409"/>
            <ac:spMk id="4" creationId="{CF87B560-4C68-4A2F-B481-48FC61CDA60E}"/>
          </ac:spMkLst>
        </pc:spChg>
      </pc:sldChg>
    </pc:docChg>
  </pc:docChgLst>
  <pc:docChgLst>
    <pc:chgData name="Guest User" userId="S::urn:spo:anon#4cf4838ef0fbf4d0dba1e40ac72942b61102bea1b1689e895975c57b98f5ef34::" providerId="AD" clId="Web-{7AE1226E-6819-6533-6B46-448F324A7504}"/>
    <pc:docChg chg="modSld">
      <pc:chgData name="Guest User" userId="S::urn:spo:anon#4cf4838ef0fbf4d0dba1e40ac72942b61102bea1b1689e895975c57b98f5ef34::" providerId="AD" clId="Web-{7AE1226E-6819-6533-6B46-448F324A7504}" dt="2022-01-07T21:39:21.561" v="338" actId="20577"/>
      <pc:docMkLst>
        <pc:docMk/>
      </pc:docMkLst>
      <pc:sldChg chg="addSp delSp modSp modNotes">
        <pc:chgData name="Guest User" userId="S::urn:spo:anon#4cf4838ef0fbf4d0dba1e40ac72942b61102bea1b1689e895975c57b98f5ef34::" providerId="AD" clId="Web-{7AE1226E-6819-6533-6B46-448F324A7504}" dt="2022-01-07T21:39:21.561" v="338" actId="20577"/>
        <pc:sldMkLst>
          <pc:docMk/>
          <pc:sldMk cId="1011963421" sldId="351"/>
        </pc:sldMkLst>
        <pc:spChg chg="add del mod">
          <ac:chgData name="Guest User" userId="S::urn:spo:anon#4cf4838ef0fbf4d0dba1e40ac72942b61102bea1b1689e895975c57b98f5ef34::" providerId="AD" clId="Web-{7AE1226E-6819-6533-6B46-448F324A7504}" dt="2022-01-07T21:34:04.139" v="213"/>
          <ac:spMkLst>
            <pc:docMk/>
            <pc:sldMk cId="1011963421" sldId="351"/>
            <ac:spMk id="2" creationId="{615A83C4-76B5-4FA9-B2B1-5425CB17F46C}"/>
          </ac:spMkLst>
        </pc:spChg>
        <pc:spChg chg="add mod">
          <ac:chgData name="Guest User" userId="S::urn:spo:anon#4cf4838ef0fbf4d0dba1e40ac72942b61102bea1b1689e895975c57b98f5ef34::" providerId="AD" clId="Web-{7AE1226E-6819-6533-6B46-448F324A7504}" dt="2022-01-07T21:39:21.561" v="338" actId="20577"/>
          <ac:spMkLst>
            <pc:docMk/>
            <pc:sldMk cId="1011963421" sldId="351"/>
            <ac:spMk id="6" creationId="{0930DA7B-D557-49D6-8C7F-07AB68A8383B}"/>
          </ac:spMkLst>
        </pc:spChg>
      </pc:sldChg>
    </pc:docChg>
  </pc:docChgLst>
  <pc:docChgLst>
    <pc:chgData name="Gabrielle Goldberg" userId="S::gabrielle.goldberg@hofstra.edu::453f9b71-f7a4-4ef4-8e34-bbb69381dfc0" providerId="AD" clId="Web-{44F7C71A-CD40-A848-8BE9-A90FB693BC91}"/>
    <pc:docChg chg="modSld">
      <pc:chgData name="Gabrielle Goldberg" userId="S::gabrielle.goldberg@hofstra.edu::453f9b71-f7a4-4ef4-8e34-bbb69381dfc0" providerId="AD" clId="Web-{44F7C71A-CD40-A848-8BE9-A90FB693BC91}" dt="2022-04-11T12:30:25.240" v="4" actId="20577"/>
      <pc:docMkLst>
        <pc:docMk/>
      </pc:docMkLst>
      <pc:sldChg chg="modSp">
        <pc:chgData name="Gabrielle Goldberg" userId="S::gabrielle.goldberg@hofstra.edu::453f9b71-f7a4-4ef4-8e34-bbb69381dfc0" providerId="AD" clId="Web-{44F7C71A-CD40-A848-8BE9-A90FB693BC91}" dt="2022-04-11T12:30:25.240" v="4" actId="20577"/>
        <pc:sldMkLst>
          <pc:docMk/>
          <pc:sldMk cId="3061336521" sldId="318"/>
        </pc:sldMkLst>
        <pc:spChg chg="mod">
          <ac:chgData name="Gabrielle Goldberg" userId="S::gabrielle.goldberg@hofstra.edu::453f9b71-f7a4-4ef4-8e34-bbb69381dfc0" providerId="AD" clId="Web-{44F7C71A-CD40-A848-8BE9-A90FB693BC91}" dt="2022-04-11T12:30:25.240" v="4" actId="20577"/>
          <ac:spMkLst>
            <pc:docMk/>
            <pc:sldMk cId="3061336521" sldId="318"/>
            <ac:spMk id="6" creationId="{00000000-0000-0000-0000-000000000000}"/>
          </ac:spMkLst>
        </pc:spChg>
      </pc:sldChg>
    </pc:docChg>
  </pc:docChgLst>
</pc:chgInfo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colorful5">
  <dgm:title val=""/>
  <dgm:desc val=""/>
  <dgm:catLst>
    <dgm:cat type="colorful" pri="10500"/>
  </dgm:catLst>
  <dgm:styleLbl name="node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/>
      <a:schemeClr val="accent6"/>
    </dgm:fillClrLst>
    <dgm:linClrLst>
      <a:schemeClr val="accent5"/>
      <a:schemeClr val="accent6"/>
    </dgm:linClrLst>
    <dgm:effectClrLst/>
    <dgm:txLinClrLst/>
    <dgm:txFillClrLst/>
    <dgm:txEffectClrLst/>
  </dgm:styleLbl>
  <dgm:styleLbl name="ln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6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1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3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4.xml><?xml version="1.0" encoding="utf-8"?>
<dgm:colorsDef xmlns:dgm="http://schemas.openxmlformats.org/drawingml/2006/diagram" xmlns:a="http://schemas.openxmlformats.org/drawingml/2006/main" uniqueId="urn:microsoft.com/office/officeart/2005/8/colors/colorful2">
  <dgm:title val=""/>
  <dgm:desc val=""/>
  <dgm:catLst>
    <dgm:cat type="colorful" pri="10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2"/>
      <a:schemeClr val="accent3"/>
    </dgm:fillClrLst>
    <dgm:linClrLst>
      <a:schemeClr val="accent2"/>
      <a:schemeClr val="accent3"/>
    </dgm:linClrLst>
    <dgm:effectClrLst/>
    <dgm:txLinClrLst/>
    <dgm:txFillClrLst/>
    <dgm:txEffectClrLst/>
  </dgm:styleLbl>
  <dgm:styleLbl name="ln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2">
        <a:alpha val="50000"/>
      </a:schemeClr>
      <a:schemeClr val="accent3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2">
        <a:tint val="50000"/>
      </a:schemeClr>
      <a:schemeClr val="accent3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2"/>
      <a:schemeClr val="accent3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2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3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2">
        <a:tint val="90000"/>
      </a:schemeClr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2">
        <a:tint val="7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2">
        <a:tint val="50000"/>
      </a:schemeClr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5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2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5.xml><?xml version="1.0" encoding="utf-8"?>
<dgm:colorsDef xmlns:dgm="http://schemas.openxmlformats.org/drawingml/2006/diagram" xmlns:a="http://schemas.openxmlformats.org/drawingml/2006/main" uniqueId="urn:microsoft.com/office/officeart/2005/8/colors/colorful5">
  <dgm:title val=""/>
  <dgm:desc val=""/>
  <dgm:catLst>
    <dgm:cat type="colorful" pri="10500"/>
  </dgm:catLst>
  <dgm:styleLbl name="node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/>
      <a:schemeClr val="accent6"/>
    </dgm:fillClrLst>
    <dgm:linClrLst>
      <a:schemeClr val="accent5"/>
      <a:schemeClr val="accent6"/>
    </dgm:linClrLst>
    <dgm:effectClrLst/>
    <dgm:txLinClrLst/>
    <dgm:txFillClrLst/>
    <dgm:txEffectClrLst/>
  </dgm:styleLbl>
  <dgm:styleLbl name="ln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6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1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6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7.xml><?xml version="1.0" encoding="utf-8"?>
<dgm:colorsDef xmlns:dgm="http://schemas.openxmlformats.org/drawingml/2006/diagram" xmlns:a="http://schemas.openxmlformats.org/drawingml/2006/main" uniqueId="urn:microsoft.com/office/officeart/2005/8/colors/colorful5">
  <dgm:title val=""/>
  <dgm:desc val=""/>
  <dgm:catLst>
    <dgm:cat type="colorful" pri="10500"/>
  </dgm:catLst>
  <dgm:styleLbl name="node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/>
      <a:schemeClr val="accent6"/>
    </dgm:fillClrLst>
    <dgm:linClrLst>
      <a:schemeClr val="accent5"/>
      <a:schemeClr val="accent6"/>
    </dgm:linClrLst>
    <dgm:effectClrLst/>
    <dgm:txLinClrLst/>
    <dgm:txFillClrLst/>
    <dgm:txEffectClrLst/>
  </dgm:styleLbl>
  <dgm:styleLbl name="ln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6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1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8.xml><?xml version="1.0" encoding="utf-8"?>
<dgm:colorsDef xmlns:dgm="http://schemas.openxmlformats.org/drawingml/2006/diagram" xmlns:a="http://schemas.openxmlformats.org/drawingml/2006/main" uniqueId="urn:microsoft.com/office/officeart/2005/8/colors/colorful5">
  <dgm:title val=""/>
  <dgm:desc val=""/>
  <dgm:catLst>
    <dgm:cat type="colorful" pri="10500"/>
  </dgm:catLst>
  <dgm:styleLbl name="node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/>
      <a:schemeClr val="accent6"/>
    </dgm:fillClrLst>
    <dgm:linClrLst>
      <a:schemeClr val="accent5"/>
      <a:schemeClr val="accent6"/>
    </dgm:linClrLst>
    <dgm:effectClrLst/>
    <dgm:txLinClrLst/>
    <dgm:txFillClrLst/>
    <dgm:txEffectClrLst/>
  </dgm:styleLbl>
  <dgm:styleLbl name="ln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6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1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E14A3875-188F-43AF-B07F-5FE5A4C89B7D}" type="doc">
      <dgm:prSet loTypeId="urn:microsoft.com/office/officeart/2005/8/layout/list1" loCatId="list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5D4DBBEE-6265-4C7E-BDD8-3F506070D21D}">
      <dgm:prSet/>
      <dgm:spPr/>
      <dgm:t>
        <a:bodyPr/>
        <a:lstStyle/>
        <a:p>
          <a:r>
            <a:rPr lang="en-US" b="1" u="sng" dirty="0"/>
            <a:t>Goals:</a:t>
          </a:r>
          <a:r>
            <a:rPr lang="en-US" b="1" dirty="0"/>
            <a:t>​</a:t>
          </a:r>
        </a:p>
      </dgm:t>
    </dgm:pt>
    <dgm:pt modelId="{3267DAF5-24F4-4474-93E3-5BC2400F9B48}" type="parTrans" cxnId="{C7328E1E-8289-43D9-8F74-D5460CE218F0}">
      <dgm:prSet/>
      <dgm:spPr/>
      <dgm:t>
        <a:bodyPr/>
        <a:lstStyle/>
        <a:p>
          <a:endParaRPr lang="en-US"/>
        </a:p>
      </dgm:t>
    </dgm:pt>
    <dgm:pt modelId="{7D536A34-3587-4591-9B0F-5DA1C0342C32}" type="sibTrans" cxnId="{C7328E1E-8289-43D9-8F74-D5460CE218F0}">
      <dgm:prSet/>
      <dgm:spPr/>
      <dgm:t>
        <a:bodyPr/>
        <a:lstStyle/>
        <a:p>
          <a:endParaRPr lang="en-US"/>
        </a:p>
      </dgm:t>
    </dgm:pt>
    <dgm:pt modelId="{AD5B5E39-3F31-433C-B654-BE509666DE7D}">
      <dgm:prSet/>
      <dgm:spPr/>
      <dgm:t>
        <a:bodyPr/>
        <a:lstStyle/>
        <a:p>
          <a:r>
            <a:rPr lang="en-US" b="1" u="sng" dirty="0"/>
            <a:t>Learning Objectives:</a:t>
          </a:r>
          <a:r>
            <a:rPr lang="en-US" b="1" dirty="0"/>
            <a:t>​</a:t>
          </a:r>
        </a:p>
      </dgm:t>
    </dgm:pt>
    <dgm:pt modelId="{A8542FD1-D2FD-4C94-B430-6B41E80AB5EB}" type="parTrans" cxnId="{99FE848A-5359-4304-BF95-B675F0FBDCB1}">
      <dgm:prSet/>
      <dgm:spPr/>
      <dgm:t>
        <a:bodyPr/>
        <a:lstStyle/>
        <a:p>
          <a:endParaRPr lang="en-US"/>
        </a:p>
      </dgm:t>
    </dgm:pt>
    <dgm:pt modelId="{E7163326-1B35-4D5E-99A4-8BC2C06D06EE}" type="sibTrans" cxnId="{99FE848A-5359-4304-BF95-B675F0FBDCB1}">
      <dgm:prSet/>
      <dgm:spPr/>
      <dgm:t>
        <a:bodyPr/>
        <a:lstStyle/>
        <a:p>
          <a:endParaRPr lang="en-US"/>
        </a:p>
      </dgm:t>
    </dgm:pt>
    <dgm:pt modelId="{852CEEF3-DE01-48CB-8E37-561A01287E24}">
      <dgm:prSet phldr="0"/>
      <dgm:spPr/>
      <dgm:t>
        <a:bodyPr/>
        <a:lstStyle/>
        <a:p>
          <a:pPr algn="l" rtl="0"/>
          <a:r>
            <a:rPr lang="en-US" dirty="0">
              <a:latin typeface="Calibri Light" panose="020F0302020204030204"/>
            </a:rPr>
            <a:t> </a:t>
          </a:r>
          <a:r>
            <a:rPr lang="en-US" dirty="0"/>
            <a:t>Describe the importance of the geriatric assessment in the care of older adults.</a:t>
          </a:r>
        </a:p>
      </dgm:t>
    </dgm:pt>
    <dgm:pt modelId="{648CD573-46D3-4F5D-81B2-18DB3B5A6C50}" type="parTrans" cxnId="{32E76737-84DE-4319-86D5-A65D29954AEF}">
      <dgm:prSet/>
      <dgm:spPr/>
    </dgm:pt>
    <dgm:pt modelId="{7FF43EEE-DA28-498B-827D-53540C48F8CC}" type="sibTrans" cxnId="{32E76737-84DE-4319-86D5-A65D29954AEF}">
      <dgm:prSet/>
      <dgm:spPr/>
    </dgm:pt>
    <dgm:pt modelId="{2B7E9998-1B89-4932-A56C-C94E5050AB64}">
      <dgm:prSet phldr="0"/>
      <dgm:spPr/>
      <dgm:t>
        <a:bodyPr/>
        <a:lstStyle/>
        <a:p>
          <a:pPr algn="l" rtl="0"/>
          <a:r>
            <a:rPr lang="en-US" dirty="0">
              <a:latin typeface="Calibri Light" panose="020F0302020204030204"/>
            </a:rPr>
            <a:t> </a:t>
          </a:r>
          <a:r>
            <a:rPr lang="en-US" dirty="0"/>
            <a:t>Describe how to conduct a geriatric assessment using the </a:t>
          </a:r>
          <a:r>
            <a:rPr lang="en-US" dirty="0">
              <a:latin typeface="Calibri Light" panose="020F0302020204030204"/>
            </a:rPr>
            <a:t>4Ms Framework:</a:t>
          </a:r>
          <a:r>
            <a:rPr lang="en-US" dirty="0"/>
            <a:t> Mind/Memory, Medications, Mobility, Matters Most.</a:t>
          </a:r>
        </a:p>
      </dgm:t>
    </dgm:pt>
    <dgm:pt modelId="{E9DFE081-FF48-4F33-A408-AC8D7DE2E1E5}" type="parTrans" cxnId="{4FE1C708-42E6-458A-AD5A-3D2539910723}">
      <dgm:prSet/>
      <dgm:spPr/>
    </dgm:pt>
    <dgm:pt modelId="{FB0E994A-67F9-411D-A047-3A90814E2D28}" type="sibTrans" cxnId="{4FE1C708-42E6-458A-AD5A-3D2539910723}">
      <dgm:prSet/>
      <dgm:spPr/>
    </dgm:pt>
    <dgm:pt modelId="{6C20AF03-A279-4834-A76B-714186EE283E}">
      <dgm:prSet phldr="0"/>
      <dgm:spPr/>
      <dgm:t>
        <a:bodyPr/>
        <a:lstStyle/>
        <a:p>
          <a:pPr algn="l" rtl="0"/>
          <a:r>
            <a:rPr lang="en-US" dirty="0">
              <a:latin typeface="Calibri Light" panose="020F0302020204030204"/>
            </a:rPr>
            <a:t> </a:t>
          </a:r>
          <a:r>
            <a:rPr lang="en-US" dirty="0"/>
            <a:t>Apply the skills learned to patient scenarios.</a:t>
          </a:r>
        </a:p>
      </dgm:t>
    </dgm:pt>
    <dgm:pt modelId="{21D7647F-8A7A-4670-B182-BECB4A57582F}" type="parTrans" cxnId="{390F95EF-D164-4AD2-9099-5BC9722BB7AB}">
      <dgm:prSet/>
      <dgm:spPr/>
    </dgm:pt>
    <dgm:pt modelId="{4C3AEF15-40A2-4001-8DEE-C025BF9C7FF6}" type="sibTrans" cxnId="{390F95EF-D164-4AD2-9099-5BC9722BB7AB}">
      <dgm:prSet/>
      <dgm:spPr/>
    </dgm:pt>
    <dgm:pt modelId="{E5D22D07-EB1D-4911-B071-FD51FEF01A0D}">
      <dgm:prSet phldr="0"/>
      <dgm:spPr/>
      <dgm:t>
        <a:bodyPr/>
        <a:lstStyle/>
        <a:p>
          <a:pPr rtl="0"/>
          <a:r>
            <a:rPr lang="en-US" b="0" u="none" dirty="0">
              <a:latin typeface="Calibri Light" panose="020F0302020204030204"/>
            </a:rPr>
            <a:t>Gain</a:t>
          </a:r>
          <a:r>
            <a:rPr lang="en-US" b="0" u="none" dirty="0"/>
            <a:t> the comfort, knowledge</a:t>
          </a:r>
          <a:r>
            <a:rPr lang="en-US" b="0" u="none"/>
            <a:t>, </a:t>
          </a:r>
          <a:r>
            <a:rPr lang="en-US" b="0" u="none">
              <a:latin typeface="Calibri Light" panose="020F0302020204030204"/>
            </a:rPr>
            <a:t>and </a:t>
          </a:r>
          <a:r>
            <a:rPr lang="en-US" b="0" u="none" dirty="0">
              <a:latin typeface="Calibri Light" panose="020F0302020204030204"/>
            </a:rPr>
            <a:t>skills</a:t>
          </a:r>
          <a:r>
            <a:rPr lang="en-US" b="0" u="none" dirty="0"/>
            <a:t> necessary for conducting </a:t>
          </a:r>
          <a:r>
            <a:rPr lang="en-US" b="0" u="none" dirty="0">
              <a:latin typeface="Calibri Light" panose="020F0302020204030204"/>
            </a:rPr>
            <a:t>a</a:t>
          </a:r>
          <a:r>
            <a:rPr lang="en-US" b="0" u="none" dirty="0"/>
            <a:t> geriatric assessment</a:t>
          </a:r>
        </a:p>
      </dgm:t>
    </dgm:pt>
    <dgm:pt modelId="{2E887F1F-AAE5-4C57-ACA2-02F0EAA666F9}" type="parTrans" cxnId="{A7A6D94A-5611-4FC4-BFAA-5994CC82DD0C}">
      <dgm:prSet/>
      <dgm:spPr/>
    </dgm:pt>
    <dgm:pt modelId="{1A4159B6-4459-479F-A163-E58098B0B57E}" type="sibTrans" cxnId="{A7A6D94A-5611-4FC4-BFAA-5994CC82DD0C}">
      <dgm:prSet/>
      <dgm:spPr/>
    </dgm:pt>
    <dgm:pt modelId="{CF988B18-1BD2-4A6B-A0DD-7F74131AD74B}">
      <dgm:prSet phldr="0"/>
      <dgm:spPr/>
      <dgm:t>
        <a:bodyPr/>
        <a:lstStyle/>
        <a:p>
          <a:pPr rtl="0"/>
          <a:r>
            <a:rPr lang="en-US" b="0" u="none" dirty="0">
              <a:latin typeface="Calibri Light" panose="020F0302020204030204"/>
            </a:rPr>
            <a:t>Apply</a:t>
          </a:r>
          <a:r>
            <a:rPr lang="en-US" b="0" u="none" dirty="0"/>
            <a:t> the 4Ms</a:t>
          </a:r>
          <a:r>
            <a:rPr lang="en-US" b="0" u="none" dirty="0">
              <a:latin typeface="Calibri Light" panose="020F0302020204030204"/>
            </a:rPr>
            <a:t> framework</a:t>
          </a:r>
          <a:r>
            <a:rPr lang="en-US" b="0" u="none" dirty="0"/>
            <a:t> </a:t>
          </a:r>
          <a:r>
            <a:rPr lang="en-US" b="0" u="none" dirty="0">
              <a:latin typeface="Calibri Light" panose="020F0302020204030204"/>
            </a:rPr>
            <a:t>to complete</a:t>
          </a:r>
          <a:r>
            <a:rPr lang="en-US" b="0" u="none" dirty="0"/>
            <a:t> a Geriatric Assessment during a clinical encounter with an older adult</a:t>
          </a:r>
        </a:p>
      </dgm:t>
    </dgm:pt>
    <dgm:pt modelId="{DEECE331-9FF2-4A68-8651-E865F5245FB0}" type="parTrans" cxnId="{C1B15970-1EA9-4E8F-AD9E-2D44F37A86A7}">
      <dgm:prSet/>
      <dgm:spPr/>
    </dgm:pt>
    <dgm:pt modelId="{681F388E-515B-4EB1-B7C9-1B82119301CB}" type="sibTrans" cxnId="{C1B15970-1EA9-4E8F-AD9E-2D44F37A86A7}">
      <dgm:prSet/>
      <dgm:spPr/>
    </dgm:pt>
    <dgm:pt modelId="{A7A2CBC5-019A-439D-8027-84E43F908BBD}" type="pres">
      <dgm:prSet presAssocID="{E14A3875-188F-43AF-B07F-5FE5A4C89B7D}" presName="linear" presStyleCnt="0">
        <dgm:presLayoutVars>
          <dgm:dir/>
          <dgm:animLvl val="lvl"/>
          <dgm:resizeHandles val="exact"/>
        </dgm:presLayoutVars>
      </dgm:prSet>
      <dgm:spPr/>
    </dgm:pt>
    <dgm:pt modelId="{EE41FE87-408D-4811-9F1F-A130A670CF0C}" type="pres">
      <dgm:prSet presAssocID="{5D4DBBEE-6265-4C7E-BDD8-3F506070D21D}" presName="parentLin" presStyleCnt="0"/>
      <dgm:spPr/>
    </dgm:pt>
    <dgm:pt modelId="{487A4456-E2E2-4B15-B2E6-2EB6291AF291}" type="pres">
      <dgm:prSet presAssocID="{5D4DBBEE-6265-4C7E-BDD8-3F506070D21D}" presName="parentLeftMargin" presStyleLbl="node1" presStyleIdx="0" presStyleCnt="2"/>
      <dgm:spPr/>
    </dgm:pt>
    <dgm:pt modelId="{CCA8E483-EF29-487C-934F-FE40AC870AFB}" type="pres">
      <dgm:prSet presAssocID="{5D4DBBEE-6265-4C7E-BDD8-3F506070D21D}" presName="parentText" presStyleLbl="node1" presStyleIdx="0" presStyleCnt="2">
        <dgm:presLayoutVars>
          <dgm:chMax val="0"/>
          <dgm:bulletEnabled val="1"/>
        </dgm:presLayoutVars>
      </dgm:prSet>
      <dgm:spPr/>
    </dgm:pt>
    <dgm:pt modelId="{2270629D-7352-486D-83E6-D53F9FEDBFFE}" type="pres">
      <dgm:prSet presAssocID="{5D4DBBEE-6265-4C7E-BDD8-3F506070D21D}" presName="negativeSpace" presStyleCnt="0"/>
      <dgm:spPr/>
    </dgm:pt>
    <dgm:pt modelId="{63E578B1-CA20-412B-BA29-3D5EECC1794F}" type="pres">
      <dgm:prSet presAssocID="{5D4DBBEE-6265-4C7E-BDD8-3F506070D21D}" presName="childText" presStyleLbl="conFgAcc1" presStyleIdx="0" presStyleCnt="2">
        <dgm:presLayoutVars>
          <dgm:bulletEnabled val="1"/>
        </dgm:presLayoutVars>
      </dgm:prSet>
      <dgm:spPr/>
    </dgm:pt>
    <dgm:pt modelId="{98EBD716-9B41-43DC-9BA4-4CB15B810133}" type="pres">
      <dgm:prSet presAssocID="{7D536A34-3587-4591-9B0F-5DA1C0342C32}" presName="spaceBetweenRectangles" presStyleCnt="0"/>
      <dgm:spPr/>
    </dgm:pt>
    <dgm:pt modelId="{B7633AF6-937F-4D27-A910-B5EB08A38809}" type="pres">
      <dgm:prSet presAssocID="{AD5B5E39-3F31-433C-B654-BE509666DE7D}" presName="parentLin" presStyleCnt="0"/>
      <dgm:spPr/>
    </dgm:pt>
    <dgm:pt modelId="{21E5755D-3587-4334-A732-1BBC3B179767}" type="pres">
      <dgm:prSet presAssocID="{AD5B5E39-3F31-433C-B654-BE509666DE7D}" presName="parentLeftMargin" presStyleLbl="node1" presStyleIdx="0" presStyleCnt="2"/>
      <dgm:spPr/>
    </dgm:pt>
    <dgm:pt modelId="{87B9EDF3-1CC9-4217-8C60-8FD36C210050}" type="pres">
      <dgm:prSet presAssocID="{AD5B5E39-3F31-433C-B654-BE509666DE7D}" presName="parentText" presStyleLbl="node1" presStyleIdx="1" presStyleCnt="2">
        <dgm:presLayoutVars>
          <dgm:chMax val="0"/>
          <dgm:bulletEnabled val="1"/>
        </dgm:presLayoutVars>
      </dgm:prSet>
      <dgm:spPr/>
    </dgm:pt>
    <dgm:pt modelId="{C44FB6CA-EE2D-4CC6-A0F8-32195A4D571F}" type="pres">
      <dgm:prSet presAssocID="{AD5B5E39-3F31-433C-B654-BE509666DE7D}" presName="negativeSpace" presStyleCnt="0"/>
      <dgm:spPr/>
    </dgm:pt>
    <dgm:pt modelId="{6D6B8878-16C9-4FD6-BA2B-AB8493B513D4}" type="pres">
      <dgm:prSet presAssocID="{AD5B5E39-3F31-433C-B654-BE509666DE7D}" presName="childText" presStyleLbl="conFgAcc1" presStyleIdx="1" presStyleCnt="2">
        <dgm:presLayoutVars>
          <dgm:bulletEnabled val="1"/>
        </dgm:presLayoutVars>
      </dgm:prSet>
      <dgm:spPr/>
    </dgm:pt>
  </dgm:ptLst>
  <dgm:cxnLst>
    <dgm:cxn modelId="{4FE1C708-42E6-458A-AD5A-3D2539910723}" srcId="{AD5B5E39-3F31-433C-B654-BE509666DE7D}" destId="{2B7E9998-1B89-4932-A56C-C94E5050AB64}" srcOrd="1" destOrd="0" parTransId="{E9DFE081-FF48-4F33-A408-AC8D7DE2E1E5}" sibTransId="{FB0E994A-67F9-411D-A047-3A90814E2D28}"/>
    <dgm:cxn modelId="{C7328E1E-8289-43D9-8F74-D5460CE218F0}" srcId="{E14A3875-188F-43AF-B07F-5FE5A4C89B7D}" destId="{5D4DBBEE-6265-4C7E-BDD8-3F506070D21D}" srcOrd="0" destOrd="0" parTransId="{3267DAF5-24F4-4474-93E3-5BC2400F9B48}" sibTransId="{7D536A34-3587-4591-9B0F-5DA1C0342C32}"/>
    <dgm:cxn modelId="{32E76737-84DE-4319-86D5-A65D29954AEF}" srcId="{AD5B5E39-3F31-433C-B654-BE509666DE7D}" destId="{852CEEF3-DE01-48CB-8E37-561A01287E24}" srcOrd="0" destOrd="0" parTransId="{648CD573-46D3-4F5D-81B2-18DB3B5A6C50}" sibTransId="{7FF43EEE-DA28-498B-827D-53540C48F8CC}"/>
    <dgm:cxn modelId="{A7A6D94A-5611-4FC4-BFAA-5994CC82DD0C}" srcId="{5D4DBBEE-6265-4C7E-BDD8-3F506070D21D}" destId="{E5D22D07-EB1D-4911-B071-FD51FEF01A0D}" srcOrd="0" destOrd="0" parTransId="{2E887F1F-AAE5-4C57-ACA2-02F0EAA666F9}" sibTransId="{1A4159B6-4459-479F-A163-E58098B0B57E}"/>
    <dgm:cxn modelId="{6B028F4B-6E73-45B7-9B6D-D2CF69A7748F}" type="presOf" srcId="{5D4DBBEE-6265-4C7E-BDD8-3F506070D21D}" destId="{CCA8E483-EF29-487C-934F-FE40AC870AFB}" srcOrd="1" destOrd="0" presId="urn:microsoft.com/office/officeart/2005/8/layout/list1"/>
    <dgm:cxn modelId="{C1B15970-1EA9-4E8F-AD9E-2D44F37A86A7}" srcId="{5D4DBBEE-6265-4C7E-BDD8-3F506070D21D}" destId="{CF988B18-1BD2-4A6B-A0DD-7F74131AD74B}" srcOrd="1" destOrd="0" parTransId="{DEECE331-9FF2-4A68-8651-E865F5245FB0}" sibTransId="{681F388E-515B-4EB1-B7C9-1B82119301CB}"/>
    <dgm:cxn modelId="{529F7780-827A-4DAB-92A3-340FB9E4D0D3}" type="presOf" srcId="{2B7E9998-1B89-4932-A56C-C94E5050AB64}" destId="{6D6B8878-16C9-4FD6-BA2B-AB8493B513D4}" srcOrd="0" destOrd="1" presId="urn:microsoft.com/office/officeart/2005/8/layout/list1"/>
    <dgm:cxn modelId="{99FE848A-5359-4304-BF95-B675F0FBDCB1}" srcId="{E14A3875-188F-43AF-B07F-5FE5A4C89B7D}" destId="{AD5B5E39-3F31-433C-B654-BE509666DE7D}" srcOrd="1" destOrd="0" parTransId="{A8542FD1-D2FD-4C94-B430-6B41E80AB5EB}" sibTransId="{E7163326-1B35-4D5E-99A4-8BC2C06D06EE}"/>
    <dgm:cxn modelId="{9617C092-0D6C-46AD-8054-1B459D544615}" type="presOf" srcId="{AD5B5E39-3F31-433C-B654-BE509666DE7D}" destId="{87B9EDF3-1CC9-4217-8C60-8FD36C210050}" srcOrd="1" destOrd="0" presId="urn:microsoft.com/office/officeart/2005/8/layout/list1"/>
    <dgm:cxn modelId="{1A408F98-972E-4EF6-8FA2-6EC6A6D3A23E}" type="presOf" srcId="{CF988B18-1BD2-4A6B-A0DD-7F74131AD74B}" destId="{63E578B1-CA20-412B-BA29-3D5EECC1794F}" srcOrd="0" destOrd="1" presId="urn:microsoft.com/office/officeart/2005/8/layout/list1"/>
    <dgm:cxn modelId="{34D67EB1-F28C-4CB2-A6D6-8A90158CB141}" type="presOf" srcId="{AD5B5E39-3F31-433C-B654-BE509666DE7D}" destId="{21E5755D-3587-4334-A732-1BBC3B179767}" srcOrd="0" destOrd="0" presId="urn:microsoft.com/office/officeart/2005/8/layout/list1"/>
    <dgm:cxn modelId="{52A9CCC3-7125-450B-A8E2-E4A331CDEA51}" type="presOf" srcId="{6C20AF03-A279-4834-A76B-714186EE283E}" destId="{6D6B8878-16C9-4FD6-BA2B-AB8493B513D4}" srcOrd="0" destOrd="2" presId="urn:microsoft.com/office/officeart/2005/8/layout/list1"/>
    <dgm:cxn modelId="{7A9EA9CC-FB3D-40D7-BBC1-8BFAFFC6CC70}" type="presOf" srcId="{5D4DBBEE-6265-4C7E-BDD8-3F506070D21D}" destId="{487A4456-E2E2-4B15-B2E6-2EB6291AF291}" srcOrd="0" destOrd="0" presId="urn:microsoft.com/office/officeart/2005/8/layout/list1"/>
    <dgm:cxn modelId="{99FC87DE-DBD1-4FE5-8E01-AB1EDA5CECF0}" type="presOf" srcId="{852CEEF3-DE01-48CB-8E37-561A01287E24}" destId="{6D6B8878-16C9-4FD6-BA2B-AB8493B513D4}" srcOrd="0" destOrd="0" presId="urn:microsoft.com/office/officeart/2005/8/layout/list1"/>
    <dgm:cxn modelId="{D655B9EA-37CA-437F-B212-99F9BC20614E}" type="presOf" srcId="{E5D22D07-EB1D-4911-B071-FD51FEF01A0D}" destId="{63E578B1-CA20-412B-BA29-3D5EECC1794F}" srcOrd="0" destOrd="0" presId="urn:microsoft.com/office/officeart/2005/8/layout/list1"/>
    <dgm:cxn modelId="{3B210EEB-0BE0-4AD3-A74C-642501971D9B}" type="presOf" srcId="{E14A3875-188F-43AF-B07F-5FE5A4C89B7D}" destId="{A7A2CBC5-019A-439D-8027-84E43F908BBD}" srcOrd="0" destOrd="0" presId="urn:microsoft.com/office/officeart/2005/8/layout/list1"/>
    <dgm:cxn modelId="{390F95EF-D164-4AD2-9099-5BC9722BB7AB}" srcId="{AD5B5E39-3F31-433C-B654-BE509666DE7D}" destId="{6C20AF03-A279-4834-A76B-714186EE283E}" srcOrd="2" destOrd="0" parTransId="{21D7647F-8A7A-4670-B182-BECB4A57582F}" sibTransId="{4C3AEF15-40A2-4001-8DEE-C025BF9C7FF6}"/>
    <dgm:cxn modelId="{25CFCBF8-0789-433E-A710-65DA888DB199}" type="presParOf" srcId="{A7A2CBC5-019A-439D-8027-84E43F908BBD}" destId="{EE41FE87-408D-4811-9F1F-A130A670CF0C}" srcOrd="0" destOrd="0" presId="urn:microsoft.com/office/officeart/2005/8/layout/list1"/>
    <dgm:cxn modelId="{0E523A5E-DDB1-4279-B360-6B5CD3EE9E90}" type="presParOf" srcId="{EE41FE87-408D-4811-9F1F-A130A670CF0C}" destId="{487A4456-E2E2-4B15-B2E6-2EB6291AF291}" srcOrd="0" destOrd="0" presId="urn:microsoft.com/office/officeart/2005/8/layout/list1"/>
    <dgm:cxn modelId="{19BD2A1A-8A9E-4BE2-B649-13C87B246FC2}" type="presParOf" srcId="{EE41FE87-408D-4811-9F1F-A130A670CF0C}" destId="{CCA8E483-EF29-487C-934F-FE40AC870AFB}" srcOrd="1" destOrd="0" presId="urn:microsoft.com/office/officeart/2005/8/layout/list1"/>
    <dgm:cxn modelId="{12F6E1F0-E370-420D-B6A4-16E55461092B}" type="presParOf" srcId="{A7A2CBC5-019A-439D-8027-84E43F908BBD}" destId="{2270629D-7352-486D-83E6-D53F9FEDBFFE}" srcOrd="1" destOrd="0" presId="urn:microsoft.com/office/officeart/2005/8/layout/list1"/>
    <dgm:cxn modelId="{53579AC2-14B8-4823-9138-4942050D7F12}" type="presParOf" srcId="{A7A2CBC5-019A-439D-8027-84E43F908BBD}" destId="{63E578B1-CA20-412B-BA29-3D5EECC1794F}" srcOrd="2" destOrd="0" presId="urn:microsoft.com/office/officeart/2005/8/layout/list1"/>
    <dgm:cxn modelId="{81BBC416-AF3B-4CD3-83B1-E5407E68191E}" type="presParOf" srcId="{A7A2CBC5-019A-439D-8027-84E43F908BBD}" destId="{98EBD716-9B41-43DC-9BA4-4CB15B810133}" srcOrd="3" destOrd="0" presId="urn:microsoft.com/office/officeart/2005/8/layout/list1"/>
    <dgm:cxn modelId="{34BE1447-BF09-4ADB-A45A-C84EAC3EC59D}" type="presParOf" srcId="{A7A2CBC5-019A-439D-8027-84E43F908BBD}" destId="{B7633AF6-937F-4D27-A910-B5EB08A38809}" srcOrd="4" destOrd="0" presId="urn:microsoft.com/office/officeart/2005/8/layout/list1"/>
    <dgm:cxn modelId="{48F1F123-4EFC-4745-9A12-F70211989162}" type="presParOf" srcId="{B7633AF6-937F-4D27-A910-B5EB08A38809}" destId="{21E5755D-3587-4334-A732-1BBC3B179767}" srcOrd="0" destOrd="0" presId="urn:microsoft.com/office/officeart/2005/8/layout/list1"/>
    <dgm:cxn modelId="{440E3A98-A94B-4BE6-8C16-34EF1B4D37AC}" type="presParOf" srcId="{B7633AF6-937F-4D27-A910-B5EB08A38809}" destId="{87B9EDF3-1CC9-4217-8C60-8FD36C210050}" srcOrd="1" destOrd="0" presId="urn:microsoft.com/office/officeart/2005/8/layout/list1"/>
    <dgm:cxn modelId="{CF714F26-CE21-4A47-BD02-759E6D2AD8F2}" type="presParOf" srcId="{A7A2CBC5-019A-439D-8027-84E43F908BBD}" destId="{C44FB6CA-EE2D-4CC6-A0F8-32195A4D571F}" srcOrd="5" destOrd="0" presId="urn:microsoft.com/office/officeart/2005/8/layout/list1"/>
    <dgm:cxn modelId="{C3090262-5B8B-4502-97B1-29365DB7C8E2}" type="presParOf" srcId="{A7A2CBC5-019A-439D-8027-84E43F908BBD}" destId="{6D6B8878-16C9-4FD6-BA2B-AB8493B513D4}" srcOrd="6" destOrd="0" presId="urn:microsoft.com/office/officeart/2005/8/layout/list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9DB5CE74-0046-434A-A675-76D0CCA7D273}" type="doc">
      <dgm:prSet loTypeId="urn:microsoft.com/office/officeart/2005/8/layout/vList2" loCatId="list" qsTypeId="urn:microsoft.com/office/officeart/2005/8/quickstyle/simple1" qsCatId="simple" csTypeId="urn:microsoft.com/office/officeart/2005/8/colors/colorful5" csCatId="colorful" phldr="1"/>
      <dgm:spPr/>
      <dgm:t>
        <a:bodyPr/>
        <a:lstStyle/>
        <a:p>
          <a:endParaRPr lang="en-US"/>
        </a:p>
      </dgm:t>
    </dgm:pt>
    <dgm:pt modelId="{5E6C8AC2-35C2-42CE-A129-4819D523F9EC}">
      <dgm:prSet/>
      <dgm:spPr/>
      <dgm:t>
        <a:bodyPr/>
        <a:lstStyle/>
        <a:p>
          <a:r>
            <a:rPr lang="en-US" dirty="0"/>
            <a:t>Use memory and mood screening assessment tools as part of your geriatric assessment visit to evaluate for cognitive decline or depression.</a:t>
          </a:r>
        </a:p>
      </dgm:t>
    </dgm:pt>
    <dgm:pt modelId="{966D2A19-1B40-4CDB-AC96-995F0F0BE6FC}" type="parTrans" cxnId="{3436EF14-D20C-417A-A8B2-F359B6A4E9D8}">
      <dgm:prSet/>
      <dgm:spPr/>
      <dgm:t>
        <a:bodyPr/>
        <a:lstStyle/>
        <a:p>
          <a:endParaRPr lang="en-US"/>
        </a:p>
      </dgm:t>
    </dgm:pt>
    <dgm:pt modelId="{D035B9B0-C6F5-407A-8ABE-CA0D3C089D45}" type="sibTrans" cxnId="{3436EF14-D20C-417A-A8B2-F359B6A4E9D8}">
      <dgm:prSet/>
      <dgm:spPr/>
      <dgm:t>
        <a:bodyPr/>
        <a:lstStyle/>
        <a:p>
          <a:endParaRPr lang="en-US"/>
        </a:p>
      </dgm:t>
    </dgm:pt>
    <dgm:pt modelId="{7E3EF142-DC91-48F0-B374-C55F760639D6}">
      <dgm:prSet/>
      <dgm:spPr/>
      <dgm:t>
        <a:bodyPr/>
        <a:lstStyle/>
        <a:p>
          <a:pPr rtl="0"/>
          <a:r>
            <a:rPr lang="en-US" dirty="0"/>
            <a:t>Hospitalized patients are at risk for delirium</a:t>
          </a:r>
        </a:p>
        <a:p>
          <a:pPr rtl="0"/>
          <a:r>
            <a:rPr lang="en-US" dirty="0"/>
            <a:t>- The Confusion Assessment Method (CAM) is a standardized evidence-based tool </a:t>
          </a:r>
          <a:r>
            <a:rPr lang="en-US" dirty="0">
              <a:latin typeface="Calibri Light" panose="020F0302020204030204"/>
            </a:rPr>
            <a:t>used</a:t>
          </a:r>
          <a:r>
            <a:rPr lang="en-US" dirty="0"/>
            <a:t> to </a:t>
          </a:r>
          <a:r>
            <a:rPr lang="en-US" dirty="0">
              <a:latin typeface="Calibri Light" panose="020F0302020204030204"/>
            </a:rPr>
            <a:t>screen for</a:t>
          </a:r>
          <a:r>
            <a:rPr lang="en-US" dirty="0"/>
            <a:t> delirium. </a:t>
          </a:r>
        </a:p>
      </dgm:t>
    </dgm:pt>
    <dgm:pt modelId="{F337B2CF-DF6D-45D2-85CE-D61977827B08}" type="parTrans" cxnId="{26D1B71C-7245-47B2-97A7-664153F463C2}">
      <dgm:prSet/>
      <dgm:spPr/>
      <dgm:t>
        <a:bodyPr/>
        <a:lstStyle/>
        <a:p>
          <a:endParaRPr lang="en-US"/>
        </a:p>
      </dgm:t>
    </dgm:pt>
    <dgm:pt modelId="{F3D2F4D4-CFDA-4A87-B264-6F11CFA5AF1C}" type="sibTrans" cxnId="{26D1B71C-7245-47B2-97A7-664153F463C2}">
      <dgm:prSet/>
      <dgm:spPr/>
      <dgm:t>
        <a:bodyPr/>
        <a:lstStyle/>
        <a:p>
          <a:endParaRPr lang="en-US"/>
        </a:p>
      </dgm:t>
    </dgm:pt>
    <dgm:pt modelId="{EE42F288-008E-48C7-BD9E-0706B546FA7E}">
      <dgm:prSet/>
      <dgm:spPr/>
      <dgm:t>
        <a:bodyPr/>
        <a:lstStyle/>
        <a:p>
          <a:r>
            <a:rPr lang="en-US" dirty="0"/>
            <a:t>Screening tools can be used to monitor treatment response or progression of disease. </a:t>
          </a:r>
        </a:p>
      </dgm:t>
    </dgm:pt>
    <dgm:pt modelId="{01E526E7-4C52-4D5A-BCFE-F0BCEB942782}" type="parTrans" cxnId="{5EB9B92E-F976-4355-B63A-F15881AAF364}">
      <dgm:prSet/>
      <dgm:spPr/>
      <dgm:t>
        <a:bodyPr/>
        <a:lstStyle/>
        <a:p>
          <a:endParaRPr lang="en-US"/>
        </a:p>
      </dgm:t>
    </dgm:pt>
    <dgm:pt modelId="{C1228F5D-1928-49ED-95A3-BA1F1EC665FE}" type="sibTrans" cxnId="{5EB9B92E-F976-4355-B63A-F15881AAF364}">
      <dgm:prSet/>
      <dgm:spPr/>
      <dgm:t>
        <a:bodyPr/>
        <a:lstStyle/>
        <a:p>
          <a:endParaRPr lang="en-US"/>
        </a:p>
      </dgm:t>
    </dgm:pt>
    <dgm:pt modelId="{F9AA1FBB-301D-46CF-9E77-997ADD85F037}" type="pres">
      <dgm:prSet presAssocID="{9DB5CE74-0046-434A-A675-76D0CCA7D273}" presName="linear" presStyleCnt="0">
        <dgm:presLayoutVars>
          <dgm:animLvl val="lvl"/>
          <dgm:resizeHandles val="exact"/>
        </dgm:presLayoutVars>
      </dgm:prSet>
      <dgm:spPr/>
    </dgm:pt>
    <dgm:pt modelId="{C97CEB4D-FFBD-472D-A5D0-C8D6563C94FC}" type="pres">
      <dgm:prSet presAssocID="{5E6C8AC2-35C2-42CE-A129-4819D523F9EC}" presName="parentText" presStyleLbl="node1" presStyleIdx="0" presStyleCnt="3">
        <dgm:presLayoutVars>
          <dgm:chMax val="0"/>
          <dgm:bulletEnabled val="1"/>
        </dgm:presLayoutVars>
      </dgm:prSet>
      <dgm:spPr/>
    </dgm:pt>
    <dgm:pt modelId="{986FDB77-601C-4B8B-9AD6-01D09ACFDE2C}" type="pres">
      <dgm:prSet presAssocID="{D035B9B0-C6F5-407A-8ABE-CA0D3C089D45}" presName="spacer" presStyleCnt="0"/>
      <dgm:spPr/>
    </dgm:pt>
    <dgm:pt modelId="{3A02DBF4-80B1-497D-8F5C-25337D53CF3F}" type="pres">
      <dgm:prSet presAssocID="{7E3EF142-DC91-48F0-B374-C55F760639D6}" presName="parentText" presStyleLbl="node1" presStyleIdx="1" presStyleCnt="3">
        <dgm:presLayoutVars>
          <dgm:chMax val="0"/>
          <dgm:bulletEnabled val="1"/>
        </dgm:presLayoutVars>
      </dgm:prSet>
      <dgm:spPr/>
    </dgm:pt>
    <dgm:pt modelId="{25AEB38B-2BD8-4870-ACE1-7ECC3DB504BE}" type="pres">
      <dgm:prSet presAssocID="{F3D2F4D4-CFDA-4A87-B264-6F11CFA5AF1C}" presName="spacer" presStyleCnt="0"/>
      <dgm:spPr/>
    </dgm:pt>
    <dgm:pt modelId="{FC647B1D-8D91-46AB-8508-FC7F5C934004}" type="pres">
      <dgm:prSet presAssocID="{EE42F288-008E-48C7-BD9E-0706B546FA7E}" presName="parentText" presStyleLbl="node1" presStyleIdx="2" presStyleCnt="3">
        <dgm:presLayoutVars>
          <dgm:chMax val="0"/>
          <dgm:bulletEnabled val="1"/>
        </dgm:presLayoutVars>
      </dgm:prSet>
      <dgm:spPr/>
    </dgm:pt>
  </dgm:ptLst>
  <dgm:cxnLst>
    <dgm:cxn modelId="{3436EF14-D20C-417A-A8B2-F359B6A4E9D8}" srcId="{9DB5CE74-0046-434A-A675-76D0CCA7D273}" destId="{5E6C8AC2-35C2-42CE-A129-4819D523F9EC}" srcOrd="0" destOrd="0" parTransId="{966D2A19-1B40-4CDB-AC96-995F0F0BE6FC}" sibTransId="{D035B9B0-C6F5-407A-8ABE-CA0D3C089D45}"/>
    <dgm:cxn modelId="{98E69216-6393-413E-8B15-DA8C97E1A939}" type="presOf" srcId="{5E6C8AC2-35C2-42CE-A129-4819D523F9EC}" destId="{C97CEB4D-FFBD-472D-A5D0-C8D6563C94FC}" srcOrd="0" destOrd="0" presId="urn:microsoft.com/office/officeart/2005/8/layout/vList2"/>
    <dgm:cxn modelId="{26D1B71C-7245-47B2-97A7-664153F463C2}" srcId="{9DB5CE74-0046-434A-A675-76D0CCA7D273}" destId="{7E3EF142-DC91-48F0-B374-C55F760639D6}" srcOrd="1" destOrd="0" parTransId="{F337B2CF-DF6D-45D2-85CE-D61977827B08}" sibTransId="{F3D2F4D4-CFDA-4A87-B264-6F11CFA5AF1C}"/>
    <dgm:cxn modelId="{5EB9B92E-F976-4355-B63A-F15881AAF364}" srcId="{9DB5CE74-0046-434A-A675-76D0CCA7D273}" destId="{EE42F288-008E-48C7-BD9E-0706B546FA7E}" srcOrd="2" destOrd="0" parTransId="{01E526E7-4C52-4D5A-BCFE-F0BCEB942782}" sibTransId="{C1228F5D-1928-49ED-95A3-BA1F1EC665FE}"/>
    <dgm:cxn modelId="{C3AAF956-2556-4E5F-AB37-06F40B0CCCEB}" type="presOf" srcId="{7E3EF142-DC91-48F0-B374-C55F760639D6}" destId="{3A02DBF4-80B1-497D-8F5C-25337D53CF3F}" srcOrd="0" destOrd="0" presId="urn:microsoft.com/office/officeart/2005/8/layout/vList2"/>
    <dgm:cxn modelId="{1200A65A-B6F6-48B5-AE38-8E5A6EC341F9}" type="presOf" srcId="{9DB5CE74-0046-434A-A675-76D0CCA7D273}" destId="{F9AA1FBB-301D-46CF-9E77-997ADD85F037}" srcOrd="0" destOrd="0" presId="urn:microsoft.com/office/officeart/2005/8/layout/vList2"/>
    <dgm:cxn modelId="{3B3635F4-A39F-4228-9BF9-43E7F1567634}" type="presOf" srcId="{EE42F288-008E-48C7-BD9E-0706B546FA7E}" destId="{FC647B1D-8D91-46AB-8508-FC7F5C934004}" srcOrd="0" destOrd="0" presId="urn:microsoft.com/office/officeart/2005/8/layout/vList2"/>
    <dgm:cxn modelId="{05AD2647-7F43-4E7C-AE91-4F1176D8673A}" type="presParOf" srcId="{F9AA1FBB-301D-46CF-9E77-997ADD85F037}" destId="{C97CEB4D-FFBD-472D-A5D0-C8D6563C94FC}" srcOrd="0" destOrd="0" presId="urn:microsoft.com/office/officeart/2005/8/layout/vList2"/>
    <dgm:cxn modelId="{D008A3BC-CA5D-4451-A5E3-B76D43707B4B}" type="presParOf" srcId="{F9AA1FBB-301D-46CF-9E77-997ADD85F037}" destId="{986FDB77-601C-4B8B-9AD6-01D09ACFDE2C}" srcOrd="1" destOrd="0" presId="urn:microsoft.com/office/officeart/2005/8/layout/vList2"/>
    <dgm:cxn modelId="{DDDA3CA6-403A-4755-A8E0-212B18B57B99}" type="presParOf" srcId="{F9AA1FBB-301D-46CF-9E77-997ADD85F037}" destId="{3A02DBF4-80B1-497D-8F5C-25337D53CF3F}" srcOrd="2" destOrd="0" presId="urn:microsoft.com/office/officeart/2005/8/layout/vList2"/>
    <dgm:cxn modelId="{4B300574-1B9D-4092-8A50-1B88CA15FB8B}" type="presParOf" srcId="{F9AA1FBB-301D-46CF-9E77-997ADD85F037}" destId="{25AEB38B-2BD8-4870-ACE1-7ECC3DB504BE}" srcOrd="3" destOrd="0" presId="urn:microsoft.com/office/officeart/2005/8/layout/vList2"/>
    <dgm:cxn modelId="{3E952652-6D29-4818-8AEF-061587F2ADB8}" type="presParOf" srcId="{F9AA1FBB-301D-46CF-9E77-997ADD85F037}" destId="{FC647B1D-8D91-46AB-8508-FC7F5C934004}" srcOrd="4" destOrd="0" presId="urn:microsoft.com/office/officeart/2005/8/layout/vList2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3.xml><?xml version="1.0" encoding="utf-8"?>
<dgm:dataModel xmlns:dgm="http://schemas.openxmlformats.org/drawingml/2006/diagram" xmlns:a="http://schemas.openxmlformats.org/drawingml/2006/main">
  <dgm:ptLst>
    <dgm:pt modelId="{0D6F9390-DD2F-49B7-AE71-CEBFA2558914}" type="doc">
      <dgm:prSet loTypeId="urn:microsoft.com/office/officeart/2005/8/layout/vList2" loCatId="list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EC228A8F-8036-413E-9BE2-15B9FA63400F}">
      <dgm:prSet/>
      <dgm:spPr/>
      <dgm:t>
        <a:bodyPr/>
        <a:lstStyle/>
        <a:p>
          <a:r>
            <a:rPr lang="en-US" b="1" dirty="0"/>
            <a:t>Changes to medications</a:t>
          </a:r>
          <a:r>
            <a:rPr lang="en-US" dirty="0"/>
            <a:t> occur during hospitalizations and other medical visits – medications </a:t>
          </a:r>
          <a:r>
            <a:rPr lang="en-US" b="1" dirty="0"/>
            <a:t>must be reviewed at each visit</a:t>
          </a:r>
          <a:endParaRPr lang="en-US" dirty="0"/>
        </a:p>
      </dgm:t>
    </dgm:pt>
    <dgm:pt modelId="{9D27D043-2FFE-4490-80B2-9D59C2933D02}" type="parTrans" cxnId="{F84CA9C5-44B1-4CA1-B49F-85152DD5DB0D}">
      <dgm:prSet/>
      <dgm:spPr/>
      <dgm:t>
        <a:bodyPr/>
        <a:lstStyle/>
        <a:p>
          <a:endParaRPr lang="en-US"/>
        </a:p>
      </dgm:t>
    </dgm:pt>
    <dgm:pt modelId="{EEBCDEBD-4740-46FC-A1CF-2FB026B95962}" type="sibTrans" cxnId="{F84CA9C5-44B1-4CA1-B49F-85152DD5DB0D}">
      <dgm:prSet/>
      <dgm:spPr/>
      <dgm:t>
        <a:bodyPr/>
        <a:lstStyle/>
        <a:p>
          <a:endParaRPr lang="en-US"/>
        </a:p>
      </dgm:t>
    </dgm:pt>
    <dgm:pt modelId="{9D9F3DB6-551A-4358-AE68-C980E9310E5E}">
      <dgm:prSet/>
      <dgm:spPr/>
      <dgm:t>
        <a:bodyPr/>
        <a:lstStyle/>
        <a:p>
          <a:r>
            <a:rPr lang="en-US" dirty="0"/>
            <a:t>Having actual medication bottles at visit may provide insight into patient adherence</a:t>
          </a:r>
        </a:p>
      </dgm:t>
    </dgm:pt>
    <dgm:pt modelId="{18A6C550-E44E-4AC0-8D90-1019AC7FD738}" type="parTrans" cxnId="{239A5025-8E6A-4692-A2FD-143884E6C48A}">
      <dgm:prSet/>
      <dgm:spPr/>
      <dgm:t>
        <a:bodyPr/>
        <a:lstStyle/>
        <a:p>
          <a:endParaRPr lang="en-US"/>
        </a:p>
      </dgm:t>
    </dgm:pt>
    <dgm:pt modelId="{1CA6D31C-DE0D-4CD5-B073-16E6C9240874}" type="sibTrans" cxnId="{239A5025-8E6A-4692-A2FD-143884E6C48A}">
      <dgm:prSet/>
      <dgm:spPr/>
      <dgm:t>
        <a:bodyPr/>
        <a:lstStyle/>
        <a:p>
          <a:endParaRPr lang="en-US"/>
        </a:p>
      </dgm:t>
    </dgm:pt>
    <dgm:pt modelId="{3630E9F5-4C76-4BE7-AEEC-A2A47A908BB1}">
      <dgm:prSet/>
      <dgm:spPr/>
      <dgm:t>
        <a:bodyPr/>
        <a:lstStyle/>
        <a:p>
          <a:r>
            <a:rPr lang="en-US" dirty="0"/>
            <a:t>Aspects to consider regarding medications:</a:t>
          </a:r>
        </a:p>
      </dgm:t>
    </dgm:pt>
    <dgm:pt modelId="{4C79A599-9451-4EC8-B686-EDF38BBAC563}" type="parTrans" cxnId="{00648A5F-CEE5-4757-9519-E3B3148B903C}">
      <dgm:prSet/>
      <dgm:spPr/>
      <dgm:t>
        <a:bodyPr/>
        <a:lstStyle/>
        <a:p>
          <a:endParaRPr lang="en-US"/>
        </a:p>
      </dgm:t>
    </dgm:pt>
    <dgm:pt modelId="{F30FCCC0-D610-4AEE-B6FA-66D61723EAE1}" type="sibTrans" cxnId="{00648A5F-CEE5-4757-9519-E3B3148B903C}">
      <dgm:prSet/>
      <dgm:spPr/>
      <dgm:t>
        <a:bodyPr/>
        <a:lstStyle/>
        <a:p>
          <a:endParaRPr lang="en-US"/>
        </a:p>
      </dgm:t>
    </dgm:pt>
    <dgm:pt modelId="{BF08B153-FA20-40E4-9C3A-A069BC45F89D}">
      <dgm:prSet/>
      <dgm:spPr/>
      <dgm:t>
        <a:bodyPr/>
        <a:lstStyle/>
        <a:p>
          <a:r>
            <a:rPr lang="en-US" dirty="0"/>
            <a:t>Beers Criteria</a:t>
          </a:r>
        </a:p>
      </dgm:t>
    </dgm:pt>
    <dgm:pt modelId="{9792507D-5EDA-4B43-81F5-690CFE913F00}" type="parTrans" cxnId="{DBE0B7FD-F816-43A6-B873-B70DE2096B68}">
      <dgm:prSet/>
      <dgm:spPr/>
      <dgm:t>
        <a:bodyPr/>
        <a:lstStyle/>
        <a:p>
          <a:endParaRPr lang="en-US"/>
        </a:p>
      </dgm:t>
    </dgm:pt>
    <dgm:pt modelId="{4A123CA5-E70B-434B-8BD4-7BB36F4A67A4}" type="sibTrans" cxnId="{DBE0B7FD-F816-43A6-B873-B70DE2096B68}">
      <dgm:prSet/>
      <dgm:spPr/>
      <dgm:t>
        <a:bodyPr/>
        <a:lstStyle/>
        <a:p>
          <a:endParaRPr lang="en-US"/>
        </a:p>
      </dgm:t>
    </dgm:pt>
    <dgm:pt modelId="{00C2A3CA-AEB9-4457-AB89-46003FEFBEFD}">
      <dgm:prSet/>
      <dgm:spPr/>
      <dgm:t>
        <a:bodyPr/>
        <a:lstStyle/>
        <a:p>
          <a:r>
            <a:rPr lang="en-US" dirty="0"/>
            <a:t>Polypharmacy </a:t>
          </a:r>
        </a:p>
      </dgm:t>
    </dgm:pt>
    <dgm:pt modelId="{477412CD-B0A0-4E70-80A7-85744DB4AAA3}" type="parTrans" cxnId="{90128920-99E4-44E1-B301-B8D7ED83A8D9}">
      <dgm:prSet/>
      <dgm:spPr/>
      <dgm:t>
        <a:bodyPr/>
        <a:lstStyle/>
        <a:p>
          <a:endParaRPr lang="en-US"/>
        </a:p>
      </dgm:t>
    </dgm:pt>
    <dgm:pt modelId="{01B5243E-127A-4F11-9496-5CCE8E98F3BF}" type="sibTrans" cxnId="{90128920-99E4-44E1-B301-B8D7ED83A8D9}">
      <dgm:prSet/>
      <dgm:spPr/>
      <dgm:t>
        <a:bodyPr/>
        <a:lstStyle/>
        <a:p>
          <a:endParaRPr lang="en-US"/>
        </a:p>
      </dgm:t>
    </dgm:pt>
    <dgm:pt modelId="{0CDF7EB7-2348-4601-97E8-BF162B1C1221}">
      <dgm:prSet/>
      <dgm:spPr/>
      <dgm:t>
        <a:bodyPr/>
        <a:lstStyle/>
        <a:p>
          <a:r>
            <a:rPr lang="en-US" dirty="0"/>
            <a:t>Adverse reactions caused by individual medications/drug-drug interactions</a:t>
          </a:r>
        </a:p>
      </dgm:t>
    </dgm:pt>
    <dgm:pt modelId="{107AC915-60E2-4818-8D59-8434ACD87C57}" type="parTrans" cxnId="{5966D9B2-6F56-49E6-BE48-4A15F576FC21}">
      <dgm:prSet/>
      <dgm:spPr/>
      <dgm:t>
        <a:bodyPr/>
        <a:lstStyle/>
        <a:p>
          <a:endParaRPr lang="en-US"/>
        </a:p>
      </dgm:t>
    </dgm:pt>
    <dgm:pt modelId="{C2A28CDA-00AE-4F37-8643-A65B864B49BE}" type="sibTrans" cxnId="{5966D9B2-6F56-49E6-BE48-4A15F576FC21}">
      <dgm:prSet/>
      <dgm:spPr/>
      <dgm:t>
        <a:bodyPr/>
        <a:lstStyle/>
        <a:p>
          <a:endParaRPr lang="en-US"/>
        </a:p>
      </dgm:t>
    </dgm:pt>
    <dgm:pt modelId="{F737E6CA-BB91-4A23-BAF0-A08B5DDE39CC}">
      <dgm:prSet/>
      <dgm:spPr/>
      <dgm:t>
        <a:bodyPr/>
        <a:lstStyle/>
        <a:p>
          <a:r>
            <a:rPr lang="en-US" dirty="0"/>
            <a:t>Changes in pharmacokinetics as we age</a:t>
          </a:r>
        </a:p>
      </dgm:t>
    </dgm:pt>
    <dgm:pt modelId="{3A32D71E-B31B-4102-A8C2-2026B271FC47}" type="parTrans" cxnId="{50968F66-6EFF-44C5-9E04-B850FCF9C3BA}">
      <dgm:prSet/>
      <dgm:spPr/>
      <dgm:t>
        <a:bodyPr/>
        <a:lstStyle/>
        <a:p>
          <a:endParaRPr lang="en-US"/>
        </a:p>
      </dgm:t>
    </dgm:pt>
    <dgm:pt modelId="{A480D5EA-462E-4575-B420-97099A66168F}" type="sibTrans" cxnId="{50968F66-6EFF-44C5-9E04-B850FCF9C3BA}">
      <dgm:prSet/>
      <dgm:spPr/>
      <dgm:t>
        <a:bodyPr/>
        <a:lstStyle/>
        <a:p>
          <a:endParaRPr lang="en-US"/>
        </a:p>
      </dgm:t>
    </dgm:pt>
    <dgm:pt modelId="{772843BA-2FE2-4BC4-B560-51A5D69A79B0}" type="pres">
      <dgm:prSet presAssocID="{0D6F9390-DD2F-49B7-AE71-CEBFA2558914}" presName="linear" presStyleCnt="0">
        <dgm:presLayoutVars>
          <dgm:animLvl val="lvl"/>
          <dgm:resizeHandles val="exact"/>
        </dgm:presLayoutVars>
      </dgm:prSet>
      <dgm:spPr/>
    </dgm:pt>
    <dgm:pt modelId="{10AF9E04-2DAF-4B5E-8AA5-8F549E2A4F3D}" type="pres">
      <dgm:prSet presAssocID="{EC228A8F-8036-413E-9BE2-15B9FA63400F}" presName="parentText" presStyleLbl="node1" presStyleIdx="0" presStyleCnt="3">
        <dgm:presLayoutVars>
          <dgm:chMax val="0"/>
          <dgm:bulletEnabled val="1"/>
        </dgm:presLayoutVars>
      </dgm:prSet>
      <dgm:spPr/>
    </dgm:pt>
    <dgm:pt modelId="{D2E4005E-8FFB-49F8-88A7-573DC2A53DEA}" type="pres">
      <dgm:prSet presAssocID="{EEBCDEBD-4740-46FC-A1CF-2FB026B95962}" presName="spacer" presStyleCnt="0"/>
      <dgm:spPr/>
    </dgm:pt>
    <dgm:pt modelId="{AC0877B4-858A-4ADF-985C-59355A165343}" type="pres">
      <dgm:prSet presAssocID="{9D9F3DB6-551A-4358-AE68-C980E9310E5E}" presName="parentText" presStyleLbl="node1" presStyleIdx="1" presStyleCnt="3">
        <dgm:presLayoutVars>
          <dgm:chMax val="0"/>
          <dgm:bulletEnabled val="1"/>
        </dgm:presLayoutVars>
      </dgm:prSet>
      <dgm:spPr/>
    </dgm:pt>
    <dgm:pt modelId="{9B133221-6968-42E2-859D-DEB3F81EAB7D}" type="pres">
      <dgm:prSet presAssocID="{1CA6D31C-DE0D-4CD5-B073-16E6C9240874}" presName="spacer" presStyleCnt="0"/>
      <dgm:spPr/>
    </dgm:pt>
    <dgm:pt modelId="{CF9B7A5F-7E82-4680-AEB9-72B3EC3C2534}" type="pres">
      <dgm:prSet presAssocID="{3630E9F5-4C76-4BE7-AEEC-A2A47A908BB1}" presName="parentText" presStyleLbl="node1" presStyleIdx="2" presStyleCnt="3">
        <dgm:presLayoutVars>
          <dgm:chMax val="0"/>
          <dgm:bulletEnabled val="1"/>
        </dgm:presLayoutVars>
      </dgm:prSet>
      <dgm:spPr/>
    </dgm:pt>
    <dgm:pt modelId="{C760E194-0288-4519-B5A3-B23A401B8504}" type="pres">
      <dgm:prSet presAssocID="{3630E9F5-4C76-4BE7-AEEC-A2A47A908BB1}" presName="childText" presStyleLbl="revTx" presStyleIdx="0" presStyleCnt="1">
        <dgm:presLayoutVars>
          <dgm:bulletEnabled val="1"/>
        </dgm:presLayoutVars>
      </dgm:prSet>
      <dgm:spPr/>
    </dgm:pt>
  </dgm:ptLst>
  <dgm:cxnLst>
    <dgm:cxn modelId="{90128920-99E4-44E1-B301-B8D7ED83A8D9}" srcId="{3630E9F5-4C76-4BE7-AEEC-A2A47A908BB1}" destId="{00C2A3CA-AEB9-4457-AB89-46003FEFBEFD}" srcOrd="1" destOrd="0" parTransId="{477412CD-B0A0-4E70-80A7-85744DB4AAA3}" sibTransId="{01B5243E-127A-4F11-9496-5CCE8E98F3BF}"/>
    <dgm:cxn modelId="{239A5025-8E6A-4692-A2FD-143884E6C48A}" srcId="{0D6F9390-DD2F-49B7-AE71-CEBFA2558914}" destId="{9D9F3DB6-551A-4358-AE68-C980E9310E5E}" srcOrd="1" destOrd="0" parTransId="{18A6C550-E44E-4AC0-8D90-1019AC7FD738}" sibTransId="{1CA6D31C-DE0D-4CD5-B073-16E6C9240874}"/>
    <dgm:cxn modelId="{8713D748-9E9A-4CE2-AEA8-73266D633370}" type="presOf" srcId="{0CDF7EB7-2348-4601-97E8-BF162B1C1221}" destId="{C760E194-0288-4519-B5A3-B23A401B8504}" srcOrd="0" destOrd="2" presId="urn:microsoft.com/office/officeart/2005/8/layout/vList2"/>
    <dgm:cxn modelId="{CB038E51-5C45-4CEC-9F04-A84086940C7E}" type="presOf" srcId="{EC228A8F-8036-413E-9BE2-15B9FA63400F}" destId="{10AF9E04-2DAF-4B5E-8AA5-8F549E2A4F3D}" srcOrd="0" destOrd="0" presId="urn:microsoft.com/office/officeart/2005/8/layout/vList2"/>
    <dgm:cxn modelId="{00648A5F-CEE5-4757-9519-E3B3148B903C}" srcId="{0D6F9390-DD2F-49B7-AE71-CEBFA2558914}" destId="{3630E9F5-4C76-4BE7-AEEC-A2A47A908BB1}" srcOrd="2" destOrd="0" parTransId="{4C79A599-9451-4EC8-B686-EDF38BBAC563}" sibTransId="{F30FCCC0-D610-4AEE-B6FA-66D61723EAE1}"/>
    <dgm:cxn modelId="{58ECB265-C559-41CF-992B-3DD136A2C660}" type="presOf" srcId="{0D6F9390-DD2F-49B7-AE71-CEBFA2558914}" destId="{772843BA-2FE2-4BC4-B560-51A5D69A79B0}" srcOrd="0" destOrd="0" presId="urn:microsoft.com/office/officeart/2005/8/layout/vList2"/>
    <dgm:cxn modelId="{50968F66-6EFF-44C5-9E04-B850FCF9C3BA}" srcId="{3630E9F5-4C76-4BE7-AEEC-A2A47A908BB1}" destId="{F737E6CA-BB91-4A23-BAF0-A08B5DDE39CC}" srcOrd="3" destOrd="0" parTransId="{3A32D71E-B31B-4102-A8C2-2026B271FC47}" sibTransId="{A480D5EA-462E-4575-B420-97099A66168F}"/>
    <dgm:cxn modelId="{F820086B-7E82-470D-B0A8-DA1E1C7F2284}" type="presOf" srcId="{9D9F3DB6-551A-4358-AE68-C980E9310E5E}" destId="{AC0877B4-858A-4ADF-985C-59355A165343}" srcOrd="0" destOrd="0" presId="urn:microsoft.com/office/officeart/2005/8/layout/vList2"/>
    <dgm:cxn modelId="{37E24A6F-F0C9-4F90-9E3C-9E52858D8311}" type="presOf" srcId="{3630E9F5-4C76-4BE7-AEEC-A2A47A908BB1}" destId="{CF9B7A5F-7E82-4680-AEB9-72B3EC3C2534}" srcOrd="0" destOrd="0" presId="urn:microsoft.com/office/officeart/2005/8/layout/vList2"/>
    <dgm:cxn modelId="{01B3F491-BB87-402B-B8AA-36DF3EC5B211}" type="presOf" srcId="{00C2A3CA-AEB9-4457-AB89-46003FEFBEFD}" destId="{C760E194-0288-4519-B5A3-B23A401B8504}" srcOrd="0" destOrd="1" presId="urn:microsoft.com/office/officeart/2005/8/layout/vList2"/>
    <dgm:cxn modelId="{F0D6DEA4-4FEB-4395-8B69-2A86EF9333F3}" type="presOf" srcId="{F737E6CA-BB91-4A23-BAF0-A08B5DDE39CC}" destId="{C760E194-0288-4519-B5A3-B23A401B8504}" srcOrd="0" destOrd="3" presId="urn:microsoft.com/office/officeart/2005/8/layout/vList2"/>
    <dgm:cxn modelId="{5966D9B2-6F56-49E6-BE48-4A15F576FC21}" srcId="{3630E9F5-4C76-4BE7-AEEC-A2A47A908BB1}" destId="{0CDF7EB7-2348-4601-97E8-BF162B1C1221}" srcOrd="2" destOrd="0" parTransId="{107AC915-60E2-4818-8D59-8434ACD87C57}" sibTransId="{C2A28CDA-00AE-4F37-8643-A65B864B49BE}"/>
    <dgm:cxn modelId="{F84CA9C5-44B1-4CA1-B49F-85152DD5DB0D}" srcId="{0D6F9390-DD2F-49B7-AE71-CEBFA2558914}" destId="{EC228A8F-8036-413E-9BE2-15B9FA63400F}" srcOrd="0" destOrd="0" parTransId="{9D27D043-2FFE-4490-80B2-9D59C2933D02}" sibTransId="{EEBCDEBD-4740-46FC-A1CF-2FB026B95962}"/>
    <dgm:cxn modelId="{DBE0B7FD-F816-43A6-B873-B70DE2096B68}" srcId="{3630E9F5-4C76-4BE7-AEEC-A2A47A908BB1}" destId="{BF08B153-FA20-40E4-9C3A-A069BC45F89D}" srcOrd="0" destOrd="0" parTransId="{9792507D-5EDA-4B43-81F5-690CFE913F00}" sibTransId="{4A123CA5-E70B-434B-8BD4-7BB36F4A67A4}"/>
    <dgm:cxn modelId="{DE5117FF-FF54-4E06-89C6-B54E7FE2D217}" type="presOf" srcId="{BF08B153-FA20-40E4-9C3A-A069BC45F89D}" destId="{C760E194-0288-4519-B5A3-B23A401B8504}" srcOrd="0" destOrd="0" presId="urn:microsoft.com/office/officeart/2005/8/layout/vList2"/>
    <dgm:cxn modelId="{1EF4CA2E-D342-48FB-BADD-D638DA2BE3D4}" type="presParOf" srcId="{772843BA-2FE2-4BC4-B560-51A5D69A79B0}" destId="{10AF9E04-2DAF-4B5E-8AA5-8F549E2A4F3D}" srcOrd="0" destOrd="0" presId="urn:microsoft.com/office/officeart/2005/8/layout/vList2"/>
    <dgm:cxn modelId="{5EC7E8A9-DBA9-4DF4-866B-2FC462997E95}" type="presParOf" srcId="{772843BA-2FE2-4BC4-B560-51A5D69A79B0}" destId="{D2E4005E-8FFB-49F8-88A7-573DC2A53DEA}" srcOrd="1" destOrd="0" presId="urn:microsoft.com/office/officeart/2005/8/layout/vList2"/>
    <dgm:cxn modelId="{0941189E-2704-4321-9AE6-81BC5FAEE281}" type="presParOf" srcId="{772843BA-2FE2-4BC4-B560-51A5D69A79B0}" destId="{AC0877B4-858A-4ADF-985C-59355A165343}" srcOrd="2" destOrd="0" presId="urn:microsoft.com/office/officeart/2005/8/layout/vList2"/>
    <dgm:cxn modelId="{031AE0A9-B86C-42E6-AB29-B8FD8D7C6640}" type="presParOf" srcId="{772843BA-2FE2-4BC4-B560-51A5D69A79B0}" destId="{9B133221-6968-42E2-859D-DEB3F81EAB7D}" srcOrd="3" destOrd="0" presId="urn:microsoft.com/office/officeart/2005/8/layout/vList2"/>
    <dgm:cxn modelId="{03A9E7F9-E42F-4DCC-83E0-0B46C0FD9209}" type="presParOf" srcId="{772843BA-2FE2-4BC4-B560-51A5D69A79B0}" destId="{CF9B7A5F-7E82-4680-AEB9-72B3EC3C2534}" srcOrd="4" destOrd="0" presId="urn:microsoft.com/office/officeart/2005/8/layout/vList2"/>
    <dgm:cxn modelId="{9FA2AC2E-C36A-415E-B83D-880280E1FE16}" type="presParOf" srcId="{772843BA-2FE2-4BC4-B560-51A5D69A79B0}" destId="{C760E194-0288-4519-B5A3-B23A401B8504}" srcOrd="5" destOrd="0" presId="urn:microsoft.com/office/officeart/2005/8/layout/vList2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4.xml><?xml version="1.0" encoding="utf-8"?>
<dgm:dataModel xmlns:dgm="http://schemas.openxmlformats.org/drawingml/2006/diagram" xmlns:a="http://schemas.openxmlformats.org/drawingml/2006/main">
  <dgm:ptLst>
    <dgm:pt modelId="{1FE72C36-4B28-476F-978C-16E86A468260}" type="doc">
      <dgm:prSet loTypeId="urn:microsoft.com/office/officeart/2005/8/layout/process4" loCatId="process" qsTypeId="urn:microsoft.com/office/officeart/2005/8/quickstyle/simple1" qsCatId="simple" csTypeId="urn:microsoft.com/office/officeart/2005/8/colors/colorful2" csCatId="colorful"/>
      <dgm:spPr/>
      <dgm:t>
        <a:bodyPr/>
        <a:lstStyle/>
        <a:p>
          <a:endParaRPr lang="en-US"/>
        </a:p>
      </dgm:t>
    </dgm:pt>
    <dgm:pt modelId="{CB3AF1EA-5F8D-4C79-AA88-B7CE7A43820C}">
      <dgm:prSet/>
      <dgm:spPr/>
      <dgm:t>
        <a:bodyPr/>
        <a:lstStyle/>
        <a:p>
          <a:pPr rtl="0"/>
          <a:r>
            <a:rPr lang="en-US" dirty="0"/>
            <a:t>All older adults should be screened yearly </a:t>
          </a:r>
          <a:r>
            <a:rPr lang="en-US" dirty="0">
              <a:latin typeface="Calibri Light" panose="020F0302020204030204"/>
            </a:rPr>
            <a:t>and ideally on every visit for</a:t>
          </a:r>
          <a:r>
            <a:rPr lang="en-US" dirty="0"/>
            <a:t> </a:t>
          </a:r>
        </a:p>
      </dgm:t>
    </dgm:pt>
    <dgm:pt modelId="{2828BD33-0B11-464C-AA35-0908CB98AA4D}" type="parTrans" cxnId="{FF7A235E-9BA0-4DD0-ADE7-DF55F78569BE}">
      <dgm:prSet/>
      <dgm:spPr/>
      <dgm:t>
        <a:bodyPr/>
        <a:lstStyle/>
        <a:p>
          <a:endParaRPr lang="en-US"/>
        </a:p>
      </dgm:t>
    </dgm:pt>
    <dgm:pt modelId="{98CD2501-1C69-4F49-B26A-DB89B2F28061}" type="sibTrans" cxnId="{FF7A235E-9BA0-4DD0-ADE7-DF55F78569BE}">
      <dgm:prSet/>
      <dgm:spPr/>
      <dgm:t>
        <a:bodyPr/>
        <a:lstStyle/>
        <a:p>
          <a:endParaRPr lang="en-US"/>
        </a:p>
      </dgm:t>
    </dgm:pt>
    <dgm:pt modelId="{D5B270F4-0C06-4F9D-A7B8-6CBDD6035384}">
      <dgm:prSet/>
      <dgm:spPr/>
      <dgm:t>
        <a:bodyPr/>
        <a:lstStyle/>
        <a:p>
          <a:r>
            <a:rPr lang="en-US" dirty="0"/>
            <a:t>Falls</a:t>
          </a:r>
        </a:p>
      </dgm:t>
    </dgm:pt>
    <dgm:pt modelId="{C7F0049D-C6A9-4046-BD0F-9AF71EB2F89E}" type="parTrans" cxnId="{72657D9D-831E-48CA-A71F-90F959780CEB}">
      <dgm:prSet/>
      <dgm:spPr/>
      <dgm:t>
        <a:bodyPr/>
        <a:lstStyle/>
        <a:p>
          <a:endParaRPr lang="en-US"/>
        </a:p>
      </dgm:t>
    </dgm:pt>
    <dgm:pt modelId="{F0BF3FD5-3358-4F78-A859-7770169CEF70}" type="sibTrans" cxnId="{72657D9D-831E-48CA-A71F-90F959780CEB}">
      <dgm:prSet/>
      <dgm:spPr/>
      <dgm:t>
        <a:bodyPr/>
        <a:lstStyle/>
        <a:p>
          <a:endParaRPr lang="en-US"/>
        </a:p>
      </dgm:t>
    </dgm:pt>
    <dgm:pt modelId="{34658169-0911-47E7-B867-D77609489493}">
      <dgm:prSet/>
      <dgm:spPr/>
      <dgm:t>
        <a:bodyPr/>
        <a:lstStyle/>
        <a:p>
          <a:r>
            <a:rPr lang="en-US" dirty="0"/>
            <a:t>Frequency</a:t>
          </a:r>
        </a:p>
      </dgm:t>
    </dgm:pt>
    <dgm:pt modelId="{F5791894-BCB1-4540-8063-691D18C031DB}" type="parTrans" cxnId="{603FDA90-0ECD-4257-BE7A-B3C08372C891}">
      <dgm:prSet/>
      <dgm:spPr/>
      <dgm:t>
        <a:bodyPr/>
        <a:lstStyle/>
        <a:p>
          <a:endParaRPr lang="en-US"/>
        </a:p>
      </dgm:t>
    </dgm:pt>
    <dgm:pt modelId="{74B7A06D-7B48-4428-990C-E5420E23528B}" type="sibTrans" cxnId="{603FDA90-0ECD-4257-BE7A-B3C08372C891}">
      <dgm:prSet/>
      <dgm:spPr/>
      <dgm:t>
        <a:bodyPr/>
        <a:lstStyle/>
        <a:p>
          <a:endParaRPr lang="en-US"/>
        </a:p>
      </dgm:t>
    </dgm:pt>
    <dgm:pt modelId="{5792EAFB-52B8-4234-A841-A28A023D37ED}">
      <dgm:prSet/>
      <dgm:spPr/>
      <dgm:t>
        <a:bodyPr/>
        <a:lstStyle/>
        <a:p>
          <a:r>
            <a:rPr lang="en-US" dirty="0"/>
            <a:t>Difficulties in gait or balance</a:t>
          </a:r>
        </a:p>
      </dgm:t>
    </dgm:pt>
    <dgm:pt modelId="{000DA78B-34D5-4234-B2DA-277760516414}" type="parTrans" cxnId="{F3B02D55-3E17-4DBD-B678-14AC2B7AB287}">
      <dgm:prSet/>
      <dgm:spPr/>
      <dgm:t>
        <a:bodyPr/>
        <a:lstStyle/>
        <a:p>
          <a:endParaRPr lang="en-US"/>
        </a:p>
      </dgm:t>
    </dgm:pt>
    <dgm:pt modelId="{EECEE0F6-7BE7-464E-9927-5B087AD17542}" type="sibTrans" cxnId="{F3B02D55-3E17-4DBD-B678-14AC2B7AB287}">
      <dgm:prSet/>
      <dgm:spPr/>
      <dgm:t>
        <a:bodyPr/>
        <a:lstStyle/>
        <a:p>
          <a:endParaRPr lang="en-US"/>
        </a:p>
      </dgm:t>
    </dgm:pt>
    <dgm:pt modelId="{D511A45B-F0E9-4C95-8CA6-82B890E5F0E3}">
      <dgm:prSet/>
      <dgm:spPr/>
      <dgm:t>
        <a:bodyPr/>
        <a:lstStyle/>
        <a:p>
          <a:r>
            <a:rPr lang="en-US" dirty="0"/>
            <a:t>Most important consideration is history of previous fall</a:t>
          </a:r>
        </a:p>
      </dgm:t>
    </dgm:pt>
    <dgm:pt modelId="{9D07C424-03FA-4720-BAFF-2A1703F4EBB2}" type="parTrans" cxnId="{BD642A75-6EF5-4238-9975-A4D0B9ACFB17}">
      <dgm:prSet/>
      <dgm:spPr/>
      <dgm:t>
        <a:bodyPr/>
        <a:lstStyle/>
        <a:p>
          <a:endParaRPr lang="en-US"/>
        </a:p>
      </dgm:t>
    </dgm:pt>
    <dgm:pt modelId="{B28D08B3-957A-4113-8842-4FAE635270A0}" type="sibTrans" cxnId="{BD642A75-6EF5-4238-9975-A4D0B9ACFB17}">
      <dgm:prSet/>
      <dgm:spPr/>
      <dgm:t>
        <a:bodyPr/>
        <a:lstStyle/>
        <a:p>
          <a:endParaRPr lang="en-US"/>
        </a:p>
      </dgm:t>
    </dgm:pt>
    <dgm:pt modelId="{403060E0-1DCB-4D6F-883F-B7D17D684E18}" type="pres">
      <dgm:prSet presAssocID="{1FE72C36-4B28-476F-978C-16E86A468260}" presName="Name0" presStyleCnt="0">
        <dgm:presLayoutVars>
          <dgm:dir/>
          <dgm:animLvl val="lvl"/>
          <dgm:resizeHandles val="exact"/>
        </dgm:presLayoutVars>
      </dgm:prSet>
      <dgm:spPr/>
    </dgm:pt>
    <dgm:pt modelId="{D19BE5F6-3443-49A8-9A44-67C1EB7236AD}" type="pres">
      <dgm:prSet presAssocID="{D511A45B-F0E9-4C95-8CA6-82B890E5F0E3}" presName="boxAndChildren" presStyleCnt="0"/>
      <dgm:spPr/>
    </dgm:pt>
    <dgm:pt modelId="{436932E2-3971-46F3-B630-7D4526867AE9}" type="pres">
      <dgm:prSet presAssocID="{D511A45B-F0E9-4C95-8CA6-82B890E5F0E3}" presName="parentTextBox" presStyleLbl="node1" presStyleIdx="0" presStyleCnt="2"/>
      <dgm:spPr/>
    </dgm:pt>
    <dgm:pt modelId="{6B8A8743-C854-4927-941B-B2BAE33910B4}" type="pres">
      <dgm:prSet presAssocID="{98CD2501-1C69-4F49-B26A-DB89B2F28061}" presName="sp" presStyleCnt="0"/>
      <dgm:spPr/>
    </dgm:pt>
    <dgm:pt modelId="{A6C2D2C0-B8E3-4E4E-AA69-A5C67B187AA8}" type="pres">
      <dgm:prSet presAssocID="{CB3AF1EA-5F8D-4C79-AA88-B7CE7A43820C}" presName="arrowAndChildren" presStyleCnt="0"/>
      <dgm:spPr/>
    </dgm:pt>
    <dgm:pt modelId="{BECE7B91-1110-4968-9E51-73992033A19F}" type="pres">
      <dgm:prSet presAssocID="{CB3AF1EA-5F8D-4C79-AA88-B7CE7A43820C}" presName="parentTextArrow" presStyleLbl="node1" presStyleIdx="0" presStyleCnt="2"/>
      <dgm:spPr/>
    </dgm:pt>
    <dgm:pt modelId="{69993709-72A8-4D97-B316-4713817BB2CE}" type="pres">
      <dgm:prSet presAssocID="{CB3AF1EA-5F8D-4C79-AA88-B7CE7A43820C}" presName="arrow" presStyleLbl="node1" presStyleIdx="1" presStyleCnt="2"/>
      <dgm:spPr/>
    </dgm:pt>
    <dgm:pt modelId="{C9BB200A-B102-4C92-94BC-AB57F6B537DB}" type="pres">
      <dgm:prSet presAssocID="{CB3AF1EA-5F8D-4C79-AA88-B7CE7A43820C}" presName="descendantArrow" presStyleCnt="0"/>
      <dgm:spPr/>
    </dgm:pt>
    <dgm:pt modelId="{4E05B6C6-7E42-48CE-AB4A-4CBC2D248630}" type="pres">
      <dgm:prSet presAssocID="{D5B270F4-0C06-4F9D-A7B8-6CBDD6035384}" presName="childTextArrow" presStyleLbl="fgAccFollowNode1" presStyleIdx="0" presStyleCnt="3">
        <dgm:presLayoutVars>
          <dgm:bulletEnabled val="1"/>
        </dgm:presLayoutVars>
      </dgm:prSet>
      <dgm:spPr/>
    </dgm:pt>
    <dgm:pt modelId="{C45E72CE-60D5-4067-8F01-E43FDF138B55}" type="pres">
      <dgm:prSet presAssocID="{34658169-0911-47E7-B867-D77609489493}" presName="childTextArrow" presStyleLbl="fgAccFollowNode1" presStyleIdx="1" presStyleCnt="3">
        <dgm:presLayoutVars>
          <dgm:bulletEnabled val="1"/>
        </dgm:presLayoutVars>
      </dgm:prSet>
      <dgm:spPr/>
    </dgm:pt>
    <dgm:pt modelId="{5E61AFC8-56A1-479A-8649-7A172B262C41}" type="pres">
      <dgm:prSet presAssocID="{5792EAFB-52B8-4234-A841-A28A023D37ED}" presName="childTextArrow" presStyleLbl="fgAccFollowNode1" presStyleIdx="2" presStyleCnt="3">
        <dgm:presLayoutVars>
          <dgm:bulletEnabled val="1"/>
        </dgm:presLayoutVars>
      </dgm:prSet>
      <dgm:spPr/>
    </dgm:pt>
  </dgm:ptLst>
  <dgm:cxnLst>
    <dgm:cxn modelId="{33C45532-DF3C-4B37-8C84-1F26F8EEA879}" type="presOf" srcId="{34658169-0911-47E7-B867-D77609489493}" destId="{C45E72CE-60D5-4067-8F01-E43FDF138B55}" srcOrd="0" destOrd="0" presId="urn:microsoft.com/office/officeart/2005/8/layout/process4"/>
    <dgm:cxn modelId="{87685F41-3F91-49CC-A1C6-A7EF128770E8}" type="presOf" srcId="{CB3AF1EA-5F8D-4C79-AA88-B7CE7A43820C}" destId="{BECE7B91-1110-4968-9E51-73992033A19F}" srcOrd="0" destOrd="0" presId="urn:microsoft.com/office/officeart/2005/8/layout/process4"/>
    <dgm:cxn modelId="{0E787441-4CBA-4906-A755-56B3BBABBBDE}" type="presOf" srcId="{D511A45B-F0E9-4C95-8CA6-82B890E5F0E3}" destId="{436932E2-3971-46F3-B630-7D4526867AE9}" srcOrd="0" destOrd="0" presId="urn:microsoft.com/office/officeart/2005/8/layout/process4"/>
    <dgm:cxn modelId="{F3B02D55-3E17-4DBD-B678-14AC2B7AB287}" srcId="{CB3AF1EA-5F8D-4C79-AA88-B7CE7A43820C}" destId="{5792EAFB-52B8-4234-A841-A28A023D37ED}" srcOrd="2" destOrd="0" parTransId="{000DA78B-34D5-4234-B2DA-277760516414}" sibTransId="{EECEE0F6-7BE7-464E-9927-5B087AD17542}"/>
    <dgm:cxn modelId="{FF7A235E-9BA0-4DD0-ADE7-DF55F78569BE}" srcId="{1FE72C36-4B28-476F-978C-16E86A468260}" destId="{CB3AF1EA-5F8D-4C79-AA88-B7CE7A43820C}" srcOrd="0" destOrd="0" parTransId="{2828BD33-0B11-464C-AA35-0908CB98AA4D}" sibTransId="{98CD2501-1C69-4F49-B26A-DB89B2F28061}"/>
    <dgm:cxn modelId="{36182374-8BC4-4AC0-B9C0-26BAD4BB7D25}" type="presOf" srcId="{5792EAFB-52B8-4234-A841-A28A023D37ED}" destId="{5E61AFC8-56A1-479A-8649-7A172B262C41}" srcOrd="0" destOrd="0" presId="urn:microsoft.com/office/officeart/2005/8/layout/process4"/>
    <dgm:cxn modelId="{BD642A75-6EF5-4238-9975-A4D0B9ACFB17}" srcId="{1FE72C36-4B28-476F-978C-16E86A468260}" destId="{D511A45B-F0E9-4C95-8CA6-82B890E5F0E3}" srcOrd="1" destOrd="0" parTransId="{9D07C424-03FA-4720-BAFF-2A1703F4EBB2}" sibTransId="{B28D08B3-957A-4113-8842-4FAE635270A0}"/>
    <dgm:cxn modelId="{603FDA90-0ECD-4257-BE7A-B3C08372C891}" srcId="{CB3AF1EA-5F8D-4C79-AA88-B7CE7A43820C}" destId="{34658169-0911-47E7-B867-D77609489493}" srcOrd="1" destOrd="0" parTransId="{F5791894-BCB1-4540-8063-691D18C031DB}" sibTransId="{74B7A06D-7B48-4428-990C-E5420E23528B}"/>
    <dgm:cxn modelId="{72657D9D-831E-48CA-A71F-90F959780CEB}" srcId="{CB3AF1EA-5F8D-4C79-AA88-B7CE7A43820C}" destId="{D5B270F4-0C06-4F9D-A7B8-6CBDD6035384}" srcOrd="0" destOrd="0" parTransId="{C7F0049D-C6A9-4046-BD0F-9AF71EB2F89E}" sibTransId="{F0BF3FD5-3358-4F78-A859-7770169CEF70}"/>
    <dgm:cxn modelId="{E64B38C1-5C36-4F24-9ECB-8F244E9B9EC5}" type="presOf" srcId="{D5B270F4-0C06-4F9D-A7B8-6CBDD6035384}" destId="{4E05B6C6-7E42-48CE-AB4A-4CBC2D248630}" srcOrd="0" destOrd="0" presId="urn:microsoft.com/office/officeart/2005/8/layout/process4"/>
    <dgm:cxn modelId="{498E23C2-BF57-4478-88A9-A563A12240C3}" type="presOf" srcId="{1FE72C36-4B28-476F-978C-16E86A468260}" destId="{403060E0-1DCB-4D6F-883F-B7D17D684E18}" srcOrd="0" destOrd="0" presId="urn:microsoft.com/office/officeart/2005/8/layout/process4"/>
    <dgm:cxn modelId="{534DD9C7-4E9F-41FB-89D0-23A8E6CF6ECE}" type="presOf" srcId="{CB3AF1EA-5F8D-4C79-AA88-B7CE7A43820C}" destId="{69993709-72A8-4D97-B316-4713817BB2CE}" srcOrd="1" destOrd="0" presId="urn:microsoft.com/office/officeart/2005/8/layout/process4"/>
    <dgm:cxn modelId="{F7B0FD92-15CB-4458-93BF-9B60D1DA89AE}" type="presParOf" srcId="{403060E0-1DCB-4D6F-883F-B7D17D684E18}" destId="{D19BE5F6-3443-49A8-9A44-67C1EB7236AD}" srcOrd="0" destOrd="0" presId="urn:microsoft.com/office/officeart/2005/8/layout/process4"/>
    <dgm:cxn modelId="{EDA63440-D8A9-4A3D-9FE2-300C68E5CB30}" type="presParOf" srcId="{D19BE5F6-3443-49A8-9A44-67C1EB7236AD}" destId="{436932E2-3971-46F3-B630-7D4526867AE9}" srcOrd="0" destOrd="0" presId="urn:microsoft.com/office/officeart/2005/8/layout/process4"/>
    <dgm:cxn modelId="{29F1D3BB-8F73-4B4B-821F-C6644271796C}" type="presParOf" srcId="{403060E0-1DCB-4D6F-883F-B7D17D684E18}" destId="{6B8A8743-C854-4927-941B-B2BAE33910B4}" srcOrd="1" destOrd="0" presId="urn:microsoft.com/office/officeart/2005/8/layout/process4"/>
    <dgm:cxn modelId="{6208B09A-919F-4FDE-A377-3B57C51D38A9}" type="presParOf" srcId="{403060E0-1DCB-4D6F-883F-B7D17D684E18}" destId="{A6C2D2C0-B8E3-4E4E-AA69-A5C67B187AA8}" srcOrd="2" destOrd="0" presId="urn:microsoft.com/office/officeart/2005/8/layout/process4"/>
    <dgm:cxn modelId="{F438919E-1139-4A3A-9EE9-4001587F7EA6}" type="presParOf" srcId="{A6C2D2C0-B8E3-4E4E-AA69-A5C67B187AA8}" destId="{BECE7B91-1110-4968-9E51-73992033A19F}" srcOrd="0" destOrd="0" presId="urn:microsoft.com/office/officeart/2005/8/layout/process4"/>
    <dgm:cxn modelId="{663DC027-F9FE-4CF5-AD08-08B6AC097896}" type="presParOf" srcId="{A6C2D2C0-B8E3-4E4E-AA69-A5C67B187AA8}" destId="{69993709-72A8-4D97-B316-4713817BB2CE}" srcOrd="1" destOrd="0" presId="urn:microsoft.com/office/officeart/2005/8/layout/process4"/>
    <dgm:cxn modelId="{D5D26A59-7653-4340-9803-ACC674F44A7B}" type="presParOf" srcId="{A6C2D2C0-B8E3-4E4E-AA69-A5C67B187AA8}" destId="{C9BB200A-B102-4C92-94BC-AB57F6B537DB}" srcOrd="2" destOrd="0" presId="urn:microsoft.com/office/officeart/2005/8/layout/process4"/>
    <dgm:cxn modelId="{1DC959C6-0A33-4265-8196-D8BB0643C48D}" type="presParOf" srcId="{C9BB200A-B102-4C92-94BC-AB57F6B537DB}" destId="{4E05B6C6-7E42-48CE-AB4A-4CBC2D248630}" srcOrd="0" destOrd="0" presId="urn:microsoft.com/office/officeart/2005/8/layout/process4"/>
    <dgm:cxn modelId="{64C82EB6-ECDF-44A4-BE20-DE6ABAD37433}" type="presParOf" srcId="{C9BB200A-B102-4C92-94BC-AB57F6B537DB}" destId="{C45E72CE-60D5-4067-8F01-E43FDF138B55}" srcOrd="1" destOrd="0" presId="urn:microsoft.com/office/officeart/2005/8/layout/process4"/>
    <dgm:cxn modelId="{828C4738-1733-4498-BB1E-DE4A6E27917C}" type="presParOf" srcId="{C9BB200A-B102-4C92-94BC-AB57F6B537DB}" destId="{5E61AFC8-56A1-479A-8649-7A172B262C41}" srcOrd="2" destOrd="0" presId="urn:microsoft.com/office/officeart/2005/8/layout/process4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5.xml><?xml version="1.0" encoding="utf-8"?>
<dgm:dataModel xmlns:dgm="http://schemas.openxmlformats.org/drawingml/2006/diagram" xmlns:a="http://schemas.openxmlformats.org/drawingml/2006/main">
  <dgm:ptLst>
    <dgm:pt modelId="{E8B6A816-21A2-4E3F-80DA-91F7BBC24B0C}" type="doc">
      <dgm:prSet loTypeId="urn:microsoft.com/office/officeart/2005/8/layout/vList2" loCatId="list" qsTypeId="urn:microsoft.com/office/officeart/2005/8/quickstyle/simple1" qsCatId="simple" csTypeId="urn:microsoft.com/office/officeart/2005/8/colors/colorful5" csCatId="colorful" phldr="1"/>
      <dgm:spPr/>
      <dgm:t>
        <a:bodyPr/>
        <a:lstStyle/>
        <a:p>
          <a:endParaRPr lang="en-US"/>
        </a:p>
      </dgm:t>
    </dgm:pt>
    <dgm:pt modelId="{EB02FDCB-6E04-4B00-BF28-2D869CA7A248}">
      <dgm:prSet/>
      <dgm:spPr/>
      <dgm:t>
        <a:bodyPr/>
        <a:lstStyle/>
        <a:p>
          <a:pPr rtl="0"/>
          <a:r>
            <a:rPr lang="en-US" dirty="0"/>
            <a:t>Most Limited</a:t>
          </a:r>
          <a:r>
            <a:rPr lang="en-US" dirty="0">
              <a:latin typeface="Calibri Light" panose="020F0302020204030204"/>
            </a:rPr>
            <a:t> as often refers to very specific, uncommon clinical scenario</a:t>
          </a:r>
          <a:endParaRPr lang="en-US" dirty="0"/>
        </a:p>
      </dgm:t>
    </dgm:pt>
    <dgm:pt modelId="{BC963C60-FB51-4A05-8CC2-DD42D67CF01E}" type="parTrans" cxnId="{51307672-2743-4C94-AD35-7994E4EA2D9E}">
      <dgm:prSet/>
      <dgm:spPr/>
      <dgm:t>
        <a:bodyPr/>
        <a:lstStyle/>
        <a:p>
          <a:endParaRPr lang="en-US"/>
        </a:p>
      </dgm:t>
    </dgm:pt>
    <dgm:pt modelId="{1E46DE6D-26FC-404F-A03D-E4034DEF3475}" type="sibTrans" cxnId="{51307672-2743-4C94-AD35-7994E4EA2D9E}">
      <dgm:prSet/>
      <dgm:spPr/>
      <dgm:t>
        <a:bodyPr/>
        <a:lstStyle/>
        <a:p>
          <a:endParaRPr lang="en-US"/>
        </a:p>
      </dgm:t>
    </dgm:pt>
    <dgm:pt modelId="{A629EE57-14F3-42B0-85F7-E6BB3CC80872}">
      <dgm:prSet/>
      <dgm:spPr/>
      <dgm:t>
        <a:bodyPr/>
        <a:lstStyle/>
        <a:p>
          <a:r>
            <a:rPr lang="en-US" dirty="0"/>
            <a:t>Health Care Proxy</a:t>
          </a:r>
        </a:p>
      </dgm:t>
    </dgm:pt>
    <dgm:pt modelId="{2B046238-2A30-4757-997D-7689E387B904}" type="parTrans" cxnId="{50060636-3DB3-4B7E-B281-EFDCBA31DC67}">
      <dgm:prSet/>
      <dgm:spPr/>
      <dgm:t>
        <a:bodyPr/>
        <a:lstStyle/>
        <a:p>
          <a:endParaRPr lang="en-US"/>
        </a:p>
      </dgm:t>
    </dgm:pt>
    <dgm:pt modelId="{304487AF-9702-4ED4-BB5F-F2075BB5680C}" type="sibTrans" cxnId="{50060636-3DB3-4B7E-B281-EFDCBA31DC67}">
      <dgm:prSet/>
      <dgm:spPr/>
      <dgm:t>
        <a:bodyPr/>
        <a:lstStyle/>
        <a:p>
          <a:endParaRPr lang="en-US"/>
        </a:p>
      </dgm:t>
    </dgm:pt>
    <dgm:pt modelId="{4F8DA38B-1187-4CC5-90AA-523C65798E46}">
      <dgm:prSet/>
      <dgm:spPr/>
      <dgm:t>
        <a:bodyPr/>
        <a:lstStyle/>
        <a:p>
          <a:pPr rtl="0"/>
          <a:r>
            <a:rPr lang="en-US" dirty="0"/>
            <a:t>Advance Care </a:t>
          </a:r>
          <a:r>
            <a:rPr lang="en-US" dirty="0">
              <a:latin typeface="Calibri Light" panose="020F0302020204030204"/>
            </a:rPr>
            <a:t>Plan </a:t>
          </a:r>
          <a:endParaRPr lang="en-US" dirty="0"/>
        </a:p>
      </dgm:t>
    </dgm:pt>
    <dgm:pt modelId="{F6BC3F22-C8FC-4390-B3D1-5CFCDE8D0D0E}" type="parTrans" cxnId="{D0D2596F-A2B0-4CAE-9868-D961E15BD672}">
      <dgm:prSet/>
      <dgm:spPr/>
      <dgm:t>
        <a:bodyPr/>
        <a:lstStyle/>
        <a:p>
          <a:endParaRPr lang="en-US"/>
        </a:p>
      </dgm:t>
    </dgm:pt>
    <dgm:pt modelId="{483B17E0-1129-47B5-BFBC-C71BAC0A5E18}" type="sibTrans" cxnId="{D0D2596F-A2B0-4CAE-9868-D961E15BD672}">
      <dgm:prSet/>
      <dgm:spPr/>
      <dgm:t>
        <a:bodyPr/>
        <a:lstStyle/>
        <a:p>
          <a:endParaRPr lang="en-US"/>
        </a:p>
      </dgm:t>
    </dgm:pt>
    <dgm:pt modelId="{CDCF6CCD-4CF4-4BF0-9472-63CAF2DD396B}">
      <dgm:prSet phldr="0"/>
      <dgm:spPr/>
      <dgm:t>
        <a:bodyPr/>
        <a:lstStyle/>
        <a:p>
          <a:pPr rtl="0"/>
          <a:r>
            <a:rPr lang="en-US" dirty="0"/>
            <a:t>Living Will</a:t>
          </a:r>
        </a:p>
      </dgm:t>
    </dgm:pt>
    <dgm:pt modelId="{7568531C-306F-4F66-A400-3ED4E30B1073}" type="parTrans" cxnId="{DC5D7D10-8E48-4B30-B022-31A18FFC3F03}">
      <dgm:prSet/>
      <dgm:spPr/>
    </dgm:pt>
    <dgm:pt modelId="{0060695A-37A6-42B7-A7B2-9C051C135353}" type="sibTrans" cxnId="{DC5D7D10-8E48-4B30-B022-31A18FFC3F03}">
      <dgm:prSet/>
      <dgm:spPr/>
    </dgm:pt>
    <dgm:pt modelId="{44C83A2E-AB9C-4CF1-BCDF-D1530FBB762B}">
      <dgm:prSet phldr="0"/>
      <dgm:spPr/>
      <dgm:t>
        <a:bodyPr/>
        <a:lstStyle/>
        <a:p>
          <a:pPr rtl="0"/>
          <a:r>
            <a:rPr lang="en-US" dirty="0">
              <a:latin typeface="Calibri Light" panose="020F0302020204030204"/>
            </a:rPr>
            <a:t>Includes</a:t>
          </a:r>
          <a:r>
            <a:rPr lang="en-US" dirty="0"/>
            <a:t> </a:t>
          </a:r>
          <a:r>
            <a:rPr lang="en-US" dirty="0">
              <a:latin typeface="Calibri Light" panose="020F0302020204030204"/>
            </a:rPr>
            <a:t>wishes as well as appointment</a:t>
          </a:r>
          <a:r>
            <a:rPr lang="en-US" dirty="0"/>
            <a:t> of </a:t>
          </a:r>
          <a:r>
            <a:rPr lang="en-US" dirty="0">
              <a:latin typeface="Calibri Light" panose="020F0302020204030204"/>
            </a:rPr>
            <a:t>HCP</a:t>
          </a:r>
        </a:p>
      </dgm:t>
    </dgm:pt>
    <dgm:pt modelId="{EEA83DF4-F67F-46DA-98C8-3FFAF5C18371}" type="parTrans" cxnId="{96FB148E-3649-4364-8AC4-0A330C250188}">
      <dgm:prSet/>
      <dgm:spPr/>
    </dgm:pt>
    <dgm:pt modelId="{ED96324C-DE60-4E0A-9C73-0B6B6096897A}" type="sibTrans" cxnId="{96FB148E-3649-4364-8AC4-0A330C250188}">
      <dgm:prSet/>
      <dgm:spPr/>
    </dgm:pt>
    <dgm:pt modelId="{6B4ADDD8-98EF-43DB-AE9D-EE324B7896DD}">
      <dgm:prSet phldr="0"/>
      <dgm:spPr/>
      <dgm:t>
        <a:bodyPr/>
        <a:lstStyle/>
        <a:p>
          <a:r>
            <a:rPr lang="en-US" dirty="0"/>
            <a:t>Most </a:t>
          </a:r>
          <a:r>
            <a:rPr lang="en-US" dirty="0">
              <a:latin typeface="Calibri Light" panose="020F0302020204030204"/>
            </a:rPr>
            <a:t>Comprehensive</a:t>
          </a:r>
          <a:endParaRPr lang="en-US" dirty="0"/>
        </a:p>
      </dgm:t>
    </dgm:pt>
    <dgm:pt modelId="{6A70900D-FB09-4831-B25D-1FDBC52AE7B7}" type="parTrans" cxnId="{6A5B7316-6AAA-4B2C-BA52-E0FBE3D42405}">
      <dgm:prSet/>
      <dgm:spPr/>
    </dgm:pt>
    <dgm:pt modelId="{3F335B06-AAB6-4E50-A32F-ACE8AD3BAABB}" type="sibTrans" cxnId="{6A5B7316-6AAA-4B2C-BA52-E0FBE3D42405}">
      <dgm:prSet/>
      <dgm:spPr/>
    </dgm:pt>
    <dgm:pt modelId="{458A263A-DE9C-44E9-A8DC-2237E0A6B8EE}">
      <dgm:prSet phldr="0"/>
      <dgm:spPr/>
      <dgm:t>
        <a:bodyPr/>
        <a:lstStyle/>
        <a:p>
          <a:pPr rtl="0"/>
          <a:r>
            <a:rPr lang="en-US" dirty="0">
              <a:latin typeface="Calibri Light" panose="020F0302020204030204"/>
            </a:rPr>
            <a:t>Medical Orders</a:t>
          </a:r>
        </a:p>
      </dgm:t>
    </dgm:pt>
    <dgm:pt modelId="{6A4CF231-7EE0-4AA8-AEF0-A5B6C5689721}" type="parTrans" cxnId="{B7423747-2019-46CE-8BD5-D92EA88341D2}">
      <dgm:prSet/>
      <dgm:spPr/>
    </dgm:pt>
    <dgm:pt modelId="{A09D7DD7-C969-4A54-827F-AD07AEE990B1}" type="sibTrans" cxnId="{B7423747-2019-46CE-8BD5-D92EA88341D2}">
      <dgm:prSet/>
      <dgm:spPr/>
    </dgm:pt>
    <dgm:pt modelId="{496EC581-A779-4D2C-A01D-7191AF22EF0C}">
      <dgm:prSet phldr="0"/>
      <dgm:spPr/>
      <dgm:t>
        <a:bodyPr/>
        <a:lstStyle/>
        <a:p>
          <a:pPr rtl="0"/>
          <a:r>
            <a:rPr lang="en-US" dirty="0">
              <a:latin typeface="Calibri Light" panose="020F0302020204030204"/>
            </a:rPr>
            <a:t>DNR/DNI</a:t>
          </a:r>
        </a:p>
      </dgm:t>
    </dgm:pt>
    <dgm:pt modelId="{8E83DF9F-9FCA-429B-B7B1-CB9AF27B8021}" type="parTrans" cxnId="{E9067B98-B8CE-4714-8DC8-AC4B288E9D22}">
      <dgm:prSet/>
      <dgm:spPr/>
    </dgm:pt>
    <dgm:pt modelId="{FE8B48B1-D3E9-47EE-82E1-293A88D57DF4}" type="sibTrans" cxnId="{E9067B98-B8CE-4714-8DC8-AC4B288E9D22}">
      <dgm:prSet/>
      <dgm:spPr/>
    </dgm:pt>
    <dgm:pt modelId="{F10C0CD6-7928-403E-8F9B-FEA03BD9D2CE}">
      <dgm:prSet phldr="0"/>
      <dgm:spPr/>
      <dgm:t>
        <a:bodyPr/>
        <a:lstStyle/>
        <a:p>
          <a:r>
            <a:rPr lang="en-US" dirty="0">
              <a:latin typeface="Calibri Light" panose="020F0302020204030204"/>
            </a:rPr>
            <a:t>MOLST</a:t>
          </a:r>
          <a:endParaRPr lang="en-US" dirty="0"/>
        </a:p>
      </dgm:t>
    </dgm:pt>
    <dgm:pt modelId="{CEF8ECFC-2D25-4C16-8558-4C714BD7DAF0}" type="parTrans" cxnId="{F88CC276-A468-4EDB-8C9A-96FF3A5A5F05}">
      <dgm:prSet/>
      <dgm:spPr/>
    </dgm:pt>
    <dgm:pt modelId="{B5CA54DE-09FD-469E-ACA1-F1DC247CB4D0}" type="sibTrans" cxnId="{F88CC276-A468-4EDB-8C9A-96FF3A5A5F05}">
      <dgm:prSet/>
      <dgm:spPr/>
    </dgm:pt>
    <dgm:pt modelId="{44A42486-C1F8-4838-9D36-4AADA440298C}">
      <dgm:prSet phldr="0"/>
      <dgm:spPr/>
      <dgm:t>
        <a:bodyPr/>
        <a:lstStyle/>
        <a:p>
          <a:pPr rtl="0"/>
          <a:r>
            <a:rPr lang="en-US" dirty="0">
              <a:latin typeface="Calibri Light" panose="020F0302020204030204"/>
            </a:rPr>
            <a:t>Applicability varies by state</a:t>
          </a:r>
        </a:p>
      </dgm:t>
    </dgm:pt>
    <dgm:pt modelId="{C24784DF-FEBF-4D3E-BC68-64EA11B99B91}" type="parTrans" cxnId="{2C5BAF72-F3FF-43A2-98DA-BD379C4254AF}">
      <dgm:prSet/>
      <dgm:spPr/>
    </dgm:pt>
    <dgm:pt modelId="{82D6E4A2-9606-43D0-99C0-09E8CDCE71B4}" type="sibTrans" cxnId="{2C5BAF72-F3FF-43A2-98DA-BD379C4254AF}">
      <dgm:prSet/>
      <dgm:spPr/>
    </dgm:pt>
    <dgm:pt modelId="{7DC8E9A8-308D-47EC-BA6F-0A0DD5F06970}">
      <dgm:prSet phldr="0"/>
      <dgm:spPr/>
      <dgm:t>
        <a:bodyPr/>
        <a:lstStyle/>
        <a:p>
          <a:pPr rtl="0"/>
          <a:r>
            <a:rPr lang="en-US" dirty="0">
              <a:latin typeface="Calibri Light" panose="020F0302020204030204"/>
            </a:rPr>
            <a:t>Durable Power of Attorney for Healthcare</a:t>
          </a:r>
        </a:p>
      </dgm:t>
    </dgm:pt>
    <dgm:pt modelId="{D70FB07E-CE2A-4550-B844-A1B017319A96}" type="parTrans" cxnId="{BFF3402C-4DC7-461D-8CE9-C1F960AEEDCB}">
      <dgm:prSet/>
      <dgm:spPr/>
    </dgm:pt>
    <dgm:pt modelId="{6518BEBA-4DF7-471B-A0CC-9DBC6953FD10}" type="sibTrans" cxnId="{BFF3402C-4DC7-461D-8CE9-C1F960AEEDCB}">
      <dgm:prSet/>
      <dgm:spPr/>
    </dgm:pt>
    <dgm:pt modelId="{E5516D9B-A0ED-429F-B282-CB8B419DABA3}">
      <dgm:prSet phldr="0"/>
      <dgm:spPr/>
      <dgm:t>
        <a:bodyPr/>
        <a:lstStyle/>
        <a:p>
          <a:pPr rtl="0"/>
          <a:r>
            <a:rPr lang="en-US" dirty="0"/>
            <a:t>5 Wishes </a:t>
          </a:r>
          <a:endParaRPr lang="en-US" dirty="0">
            <a:latin typeface="Calibri Light" panose="020F0302020204030204"/>
          </a:endParaRPr>
        </a:p>
      </dgm:t>
    </dgm:pt>
    <dgm:pt modelId="{2C7BA11A-A164-4FCD-B9E2-F600916EF5E3}" type="parTrans" cxnId="{797E1889-67EC-4141-A038-FDD03C80B9A8}">
      <dgm:prSet/>
      <dgm:spPr/>
    </dgm:pt>
    <dgm:pt modelId="{D01CEA3A-804C-411D-B6CB-21FD75622B89}" type="sibTrans" cxnId="{797E1889-67EC-4141-A038-FDD03C80B9A8}">
      <dgm:prSet/>
      <dgm:spPr/>
    </dgm:pt>
    <dgm:pt modelId="{409276A2-4D61-4D7C-BAE0-DAF69D6862FC}" type="pres">
      <dgm:prSet presAssocID="{E8B6A816-21A2-4E3F-80DA-91F7BBC24B0C}" presName="linear" presStyleCnt="0">
        <dgm:presLayoutVars>
          <dgm:animLvl val="lvl"/>
          <dgm:resizeHandles val="exact"/>
        </dgm:presLayoutVars>
      </dgm:prSet>
      <dgm:spPr/>
    </dgm:pt>
    <dgm:pt modelId="{6FA29F4E-5EE0-473C-8D3F-6F46F251FE29}" type="pres">
      <dgm:prSet presAssocID="{CDCF6CCD-4CF4-4BF0-9472-63CAF2DD396B}" presName="parentText" presStyleLbl="node1" presStyleIdx="0" presStyleCnt="4">
        <dgm:presLayoutVars>
          <dgm:chMax val="0"/>
          <dgm:bulletEnabled val="1"/>
        </dgm:presLayoutVars>
      </dgm:prSet>
      <dgm:spPr/>
    </dgm:pt>
    <dgm:pt modelId="{BF2F4E81-20C8-4FF8-9440-07A456E5AD32}" type="pres">
      <dgm:prSet presAssocID="{CDCF6CCD-4CF4-4BF0-9472-63CAF2DD396B}" presName="childText" presStyleLbl="revTx" presStyleIdx="0" presStyleCnt="4">
        <dgm:presLayoutVars>
          <dgm:bulletEnabled val="1"/>
        </dgm:presLayoutVars>
      </dgm:prSet>
      <dgm:spPr/>
    </dgm:pt>
    <dgm:pt modelId="{1EC99BCF-341F-4281-B8FA-B5ED4CA36149}" type="pres">
      <dgm:prSet presAssocID="{A629EE57-14F3-42B0-85F7-E6BB3CC80872}" presName="parentText" presStyleLbl="node1" presStyleIdx="1" presStyleCnt="4">
        <dgm:presLayoutVars>
          <dgm:chMax val="0"/>
          <dgm:bulletEnabled val="1"/>
        </dgm:presLayoutVars>
      </dgm:prSet>
      <dgm:spPr/>
    </dgm:pt>
    <dgm:pt modelId="{D7397A06-3D1C-4358-9755-2A3F85A14B71}" type="pres">
      <dgm:prSet presAssocID="{A629EE57-14F3-42B0-85F7-E6BB3CC80872}" presName="childText" presStyleLbl="revTx" presStyleIdx="1" presStyleCnt="4">
        <dgm:presLayoutVars>
          <dgm:bulletEnabled val="1"/>
        </dgm:presLayoutVars>
      </dgm:prSet>
      <dgm:spPr/>
    </dgm:pt>
    <dgm:pt modelId="{45876708-A133-4E40-95D5-CB51BF5D56A8}" type="pres">
      <dgm:prSet presAssocID="{4F8DA38B-1187-4CC5-90AA-523C65798E46}" presName="parentText" presStyleLbl="node1" presStyleIdx="2" presStyleCnt="4">
        <dgm:presLayoutVars>
          <dgm:chMax val="0"/>
          <dgm:bulletEnabled val="1"/>
        </dgm:presLayoutVars>
      </dgm:prSet>
      <dgm:spPr/>
    </dgm:pt>
    <dgm:pt modelId="{16DACAB5-FFE8-4C7D-BC0E-2D97DD1D01EB}" type="pres">
      <dgm:prSet presAssocID="{4F8DA38B-1187-4CC5-90AA-523C65798E46}" presName="childText" presStyleLbl="revTx" presStyleIdx="2" presStyleCnt="4">
        <dgm:presLayoutVars>
          <dgm:bulletEnabled val="1"/>
        </dgm:presLayoutVars>
      </dgm:prSet>
      <dgm:spPr/>
    </dgm:pt>
    <dgm:pt modelId="{EC463F86-71ED-43C1-B649-54D38585F1D2}" type="pres">
      <dgm:prSet presAssocID="{458A263A-DE9C-44E9-A8DC-2237E0A6B8EE}" presName="parentText" presStyleLbl="node1" presStyleIdx="3" presStyleCnt="4">
        <dgm:presLayoutVars>
          <dgm:chMax val="0"/>
          <dgm:bulletEnabled val="1"/>
        </dgm:presLayoutVars>
      </dgm:prSet>
      <dgm:spPr/>
    </dgm:pt>
    <dgm:pt modelId="{1F6C8B97-1BB1-4F06-B01C-C66ADA29B0AD}" type="pres">
      <dgm:prSet presAssocID="{458A263A-DE9C-44E9-A8DC-2237E0A6B8EE}" presName="childText" presStyleLbl="revTx" presStyleIdx="3" presStyleCnt="4">
        <dgm:presLayoutVars>
          <dgm:bulletEnabled val="1"/>
        </dgm:presLayoutVars>
      </dgm:prSet>
      <dgm:spPr/>
    </dgm:pt>
  </dgm:ptLst>
  <dgm:cxnLst>
    <dgm:cxn modelId="{91A7380A-5FC9-4868-9CE4-4F5C87A5EEAD}" type="presOf" srcId="{E8B6A816-21A2-4E3F-80DA-91F7BBC24B0C}" destId="{409276A2-4D61-4D7C-BAE0-DAF69D6862FC}" srcOrd="0" destOrd="0" presId="urn:microsoft.com/office/officeart/2005/8/layout/vList2"/>
    <dgm:cxn modelId="{DC5D7D10-8E48-4B30-B022-31A18FFC3F03}" srcId="{E8B6A816-21A2-4E3F-80DA-91F7BBC24B0C}" destId="{CDCF6CCD-4CF4-4BF0-9472-63CAF2DD396B}" srcOrd="0" destOrd="0" parTransId="{7568531C-306F-4F66-A400-3ED4E30B1073}" sibTransId="{0060695A-37A6-42B7-A7B2-9C051C135353}"/>
    <dgm:cxn modelId="{6A5B7316-6AAA-4B2C-BA52-E0FBE3D42405}" srcId="{4F8DA38B-1187-4CC5-90AA-523C65798E46}" destId="{6B4ADDD8-98EF-43DB-AE9D-EE324B7896DD}" srcOrd="0" destOrd="0" parTransId="{6A70900D-FB09-4831-B25D-1FDBC52AE7B7}" sibTransId="{3F335B06-AAB6-4E50-A32F-ACE8AD3BAABB}"/>
    <dgm:cxn modelId="{6F96011A-5BA7-4857-BB45-8A05CF4737C6}" type="presOf" srcId="{44A42486-C1F8-4838-9D36-4AADA440298C}" destId="{BF2F4E81-20C8-4FF8-9440-07A456E5AD32}" srcOrd="0" destOrd="1" presId="urn:microsoft.com/office/officeart/2005/8/layout/vList2"/>
    <dgm:cxn modelId="{D1DF461C-F891-4565-8FFF-E87E995C953F}" type="presOf" srcId="{6B4ADDD8-98EF-43DB-AE9D-EE324B7896DD}" destId="{16DACAB5-FFE8-4C7D-BC0E-2D97DD1D01EB}" srcOrd="0" destOrd="0" presId="urn:microsoft.com/office/officeart/2005/8/layout/vList2"/>
    <dgm:cxn modelId="{8694611D-6699-4FBA-A44D-79549D438008}" type="presOf" srcId="{CDCF6CCD-4CF4-4BF0-9472-63CAF2DD396B}" destId="{6FA29F4E-5EE0-473C-8D3F-6F46F251FE29}" srcOrd="0" destOrd="0" presId="urn:microsoft.com/office/officeart/2005/8/layout/vList2"/>
    <dgm:cxn modelId="{E5DAB025-29D6-475D-B664-4E6251DE89E3}" type="presOf" srcId="{458A263A-DE9C-44E9-A8DC-2237E0A6B8EE}" destId="{EC463F86-71ED-43C1-B649-54D38585F1D2}" srcOrd="0" destOrd="0" presId="urn:microsoft.com/office/officeart/2005/8/layout/vList2"/>
    <dgm:cxn modelId="{BFF3402C-4DC7-461D-8CE9-C1F960AEEDCB}" srcId="{A629EE57-14F3-42B0-85F7-E6BB3CC80872}" destId="{7DC8E9A8-308D-47EC-BA6F-0A0DD5F06970}" srcOrd="0" destOrd="0" parTransId="{D70FB07E-CE2A-4550-B844-A1B017319A96}" sibTransId="{6518BEBA-4DF7-471B-A0CC-9DBC6953FD10}"/>
    <dgm:cxn modelId="{50060636-3DB3-4B7E-B281-EFDCBA31DC67}" srcId="{E8B6A816-21A2-4E3F-80DA-91F7BBC24B0C}" destId="{A629EE57-14F3-42B0-85F7-E6BB3CC80872}" srcOrd="1" destOrd="0" parTransId="{2B046238-2A30-4757-997D-7689E387B904}" sibTransId="{304487AF-9702-4ED4-BB5F-F2075BB5680C}"/>
    <dgm:cxn modelId="{B7423747-2019-46CE-8BD5-D92EA88341D2}" srcId="{E8B6A816-21A2-4E3F-80DA-91F7BBC24B0C}" destId="{458A263A-DE9C-44E9-A8DC-2237E0A6B8EE}" srcOrd="3" destOrd="0" parTransId="{6A4CF231-7EE0-4AA8-AEF0-A5B6C5689721}" sibTransId="{A09D7DD7-C969-4A54-827F-AD07AEE990B1}"/>
    <dgm:cxn modelId="{3FF7935D-ED2B-476F-A11D-68A262971F0E}" type="presOf" srcId="{4F8DA38B-1187-4CC5-90AA-523C65798E46}" destId="{45876708-A133-4E40-95D5-CB51BF5D56A8}" srcOrd="0" destOrd="0" presId="urn:microsoft.com/office/officeart/2005/8/layout/vList2"/>
    <dgm:cxn modelId="{5B31446E-560F-4404-8316-B2F88929F0F0}" type="presOf" srcId="{496EC581-A779-4D2C-A01D-7191AF22EF0C}" destId="{1F6C8B97-1BB1-4F06-B01C-C66ADA29B0AD}" srcOrd="0" destOrd="0" presId="urn:microsoft.com/office/officeart/2005/8/layout/vList2"/>
    <dgm:cxn modelId="{D0D2596F-A2B0-4CAE-9868-D961E15BD672}" srcId="{E8B6A816-21A2-4E3F-80DA-91F7BBC24B0C}" destId="{4F8DA38B-1187-4CC5-90AA-523C65798E46}" srcOrd="2" destOrd="0" parTransId="{F6BC3F22-C8FC-4390-B3D1-5CFCDE8D0D0E}" sibTransId="{483B17E0-1129-47B5-BFBC-C71BAC0A5E18}"/>
    <dgm:cxn modelId="{51307672-2743-4C94-AD35-7994E4EA2D9E}" srcId="{CDCF6CCD-4CF4-4BF0-9472-63CAF2DD396B}" destId="{EB02FDCB-6E04-4B00-BF28-2D869CA7A248}" srcOrd="0" destOrd="0" parTransId="{BC963C60-FB51-4A05-8CC2-DD42D67CF01E}" sibTransId="{1E46DE6D-26FC-404F-A03D-E4034DEF3475}"/>
    <dgm:cxn modelId="{2C5BAF72-F3FF-43A2-98DA-BD379C4254AF}" srcId="{CDCF6CCD-4CF4-4BF0-9472-63CAF2DD396B}" destId="{44A42486-C1F8-4838-9D36-4AADA440298C}" srcOrd="1" destOrd="0" parTransId="{C24784DF-FEBF-4D3E-BC68-64EA11B99B91}" sibTransId="{82D6E4A2-9606-43D0-99C0-09E8CDCE71B4}"/>
    <dgm:cxn modelId="{F88CC276-A468-4EDB-8C9A-96FF3A5A5F05}" srcId="{458A263A-DE9C-44E9-A8DC-2237E0A6B8EE}" destId="{F10C0CD6-7928-403E-8F9B-FEA03BD9D2CE}" srcOrd="1" destOrd="0" parTransId="{CEF8ECFC-2D25-4C16-8558-4C714BD7DAF0}" sibTransId="{B5CA54DE-09FD-469E-ACA1-F1DC247CB4D0}"/>
    <dgm:cxn modelId="{D781CA7A-2AC7-41A6-86E2-7688EAC1CE71}" type="presOf" srcId="{44C83A2E-AB9C-4CF1-BCDF-D1530FBB762B}" destId="{16DACAB5-FFE8-4C7D-BC0E-2D97DD1D01EB}" srcOrd="0" destOrd="2" presId="urn:microsoft.com/office/officeart/2005/8/layout/vList2"/>
    <dgm:cxn modelId="{797E1889-67EC-4141-A038-FDD03C80B9A8}" srcId="{4F8DA38B-1187-4CC5-90AA-523C65798E46}" destId="{E5516D9B-A0ED-429F-B282-CB8B419DABA3}" srcOrd="1" destOrd="0" parTransId="{2C7BA11A-A164-4FCD-B9E2-F600916EF5E3}" sibTransId="{D01CEA3A-804C-411D-B6CB-21FD75622B89}"/>
    <dgm:cxn modelId="{9C1F278B-014E-4A2C-B54D-768D2180B369}" type="presOf" srcId="{E5516D9B-A0ED-429F-B282-CB8B419DABA3}" destId="{16DACAB5-FFE8-4C7D-BC0E-2D97DD1D01EB}" srcOrd="0" destOrd="1" presId="urn:microsoft.com/office/officeart/2005/8/layout/vList2"/>
    <dgm:cxn modelId="{96FB148E-3649-4364-8AC4-0A330C250188}" srcId="{E5516D9B-A0ED-429F-B282-CB8B419DABA3}" destId="{44C83A2E-AB9C-4CF1-BCDF-D1530FBB762B}" srcOrd="0" destOrd="0" parTransId="{EEA83DF4-F67F-46DA-98C8-3FFAF5C18371}" sibTransId="{ED96324C-DE60-4E0A-9C73-0B6B6096897A}"/>
    <dgm:cxn modelId="{E9067B98-B8CE-4714-8DC8-AC4B288E9D22}" srcId="{458A263A-DE9C-44E9-A8DC-2237E0A6B8EE}" destId="{496EC581-A779-4D2C-A01D-7191AF22EF0C}" srcOrd="0" destOrd="0" parTransId="{8E83DF9F-9FCA-429B-B7B1-CB9AF27B8021}" sibTransId="{FE8B48B1-D3E9-47EE-82E1-293A88D57DF4}"/>
    <dgm:cxn modelId="{DBDCD69D-EA46-421B-AF0E-35C1F1D4A304}" type="presOf" srcId="{F10C0CD6-7928-403E-8F9B-FEA03BD9D2CE}" destId="{1F6C8B97-1BB1-4F06-B01C-C66ADA29B0AD}" srcOrd="0" destOrd="1" presId="urn:microsoft.com/office/officeart/2005/8/layout/vList2"/>
    <dgm:cxn modelId="{DF6A80B7-8F50-4B36-BB7C-0081054CD0D8}" type="presOf" srcId="{A629EE57-14F3-42B0-85F7-E6BB3CC80872}" destId="{1EC99BCF-341F-4281-B8FA-B5ED4CA36149}" srcOrd="0" destOrd="0" presId="urn:microsoft.com/office/officeart/2005/8/layout/vList2"/>
    <dgm:cxn modelId="{BA44AFF4-DB4F-44D7-B8CB-45AF0E52A922}" type="presOf" srcId="{EB02FDCB-6E04-4B00-BF28-2D869CA7A248}" destId="{BF2F4E81-20C8-4FF8-9440-07A456E5AD32}" srcOrd="0" destOrd="0" presId="urn:microsoft.com/office/officeart/2005/8/layout/vList2"/>
    <dgm:cxn modelId="{947D49F6-25EA-4DB3-8062-CA75CB1179C5}" type="presOf" srcId="{7DC8E9A8-308D-47EC-BA6F-0A0DD5F06970}" destId="{D7397A06-3D1C-4358-9755-2A3F85A14B71}" srcOrd="0" destOrd="0" presId="urn:microsoft.com/office/officeart/2005/8/layout/vList2"/>
    <dgm:cxn modelId="{B0588F07-CA5B-40A7-AEAC-4EEBD016EA71}" type="presParOf" srcId="{409276A2-4D61-4D7C-BAE0-DAF69D6862FC}" destId="{6FA29F4E-5EE0-473C-8D3F-6F46F251FE29}" srcOrd="0" destOrd="0" presId="urn:microsoft.com/office/officeart/2005/8/layout/vList2"/>
    <dgm:cxn modelId="{29E6CD8F-52AF-4DEE-B19C-DC2011BA4FEB}" type="presParOf" srcId="{409276A2-4D61-4D7C-BAE0-DAF69D6862FC}" destId="{BF2F4E81-20C8-4FF8-9440-07A456E5AD32}" srcOrd="1" destOrd="0" presId="urn:microsoft.com/office/officeart/2005/8/layout/vList2"/>
    <dgm:cxn modelId="{A3799A73-E286-49FB-87B8-5C0C75CC2CE9}" type="presParOf" srcId="{409276A2-4D61-4D7C-BAE0-DAF69D6862FC}" destId="{1EC99BCF-341F-4281-B8FA-B5ED4CA36149}" srcOrd="2" destOrd="0" presId="urn:microsoft.com/office/officeart/2005/8/layout/vList2"/>
    <dgm:cxn modelId="{B29868F6-5898-41A3-8529-277CC78B283D}" type="presParOf" srcId="{409276A2-4D61-4D7C-BAE0-DAF69D6862FC}" destId="{D7397A06-3D1C-4358-9755-2A3F85A14B71}" srcOrd="3" destOrd="0" presId="urn:microsoft.com/office/officeart/2005/8/layout/vList2"/>
    <dgm:cxn modelId="{BF29B745-46AC-4909-A0C9-52BC0DC2ECE9}" type="presParOf" srcId="{409276A2-4D61-4D7C-BAE0-DAF69D6862FC}" destId="{45876708-A133-4E40-95D5-CB51BF5D56A8}" srcOrd="4" destOrd="0" presId="urn:microsoft.com/office/officeart/2005/8/layout/vList2"/>
    <dgm:cxn modelId="{F0BCD0C7-E0E8-43D6-9F49-C78F5EE7D1C4}" type="presParOf" srcId="{409276A2-4D61-4D7C-BAE0-DAF69D6862FC}" destId="{16DACAB5-FFE8-4C7D-BC0E-2D97DD1D01EB}" srcOrd="5" destOrd="0" presId="urn:microsoft.com/office/officeart/2005/8/layout/vList2"/>
    <dgm:cxn modelId="{3A452EDB-0FEE-4E1B-8548-C12F0FE93510}" type="presParOf" srcId="{409276A2-4D61-4D7C-BAE0-DAF69D6862FC}" destId="{EC463F86-71ED-43C1-B649-54D38585F1D2}" srcOrd="6" destOrd="0" presId="urn:microsoft.com/office/officeart/2005/8/layout/vList2"/>
    <dgm:cxn modelId="{CFF94240-FFB1-4E60-890B-334BF8A9F079}" type="presParOf" srcId="{409276A2-4D61-4D7C-BAE0-DAF69D6862FC}" destId="{1F6C8B97-1BB1-4F06-B01C-C66ADA29B0AD}" srcOrd="7" destOrd="0" presId="urn:microsoft.com/office/officeart/2005/8/layout/vList2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6.xml><?xml version="1.0" encoding="utf-8"?>
<dgm:dataModel xmlns:dgm="http://schemas.openxmlformats.org/drawingml/2006/diagram" xmlns:a="http://schemas.openxmlformats.org/drawingml/2006/main">
  <dgm:ptLst>
    <dgm:pt modelId="{48C30C0E-F162-44CF-8811-58945B76F2B0}" type="doc">
      <dgm:prSet loTypeId="urn:microsoft.com/office/officeart/2005/8/layout/vList5" loCatId="list" qsTypeId="urn:microsoft.com/office/officeart/2005/8/quickstyle/simple1" qsCatId="simple" csTypeId="urn:microsoft.com/office/officeart/2005/8/colors/accent1_2" csCatId="accent1"/>
      <dgm:spPr/>
      <dgm:t>
        <a:bodyPr/>
        <a:lstStyle/>
        <a:p>
          <a:endParaRPr lang="en-US"/>
        </a:p>
      </dgm:t>
    </dgm:pt>
    <dgm:pt modelId="{9CB7DE7D-1AAF-4235-A5DF-A2E08052671C}">
      <dgm:prSet/>
      <dgm:spPr/>
      <dgm:t>
        <a:bodyPr/>
        <a:lstStyle/>
        <a:p>
          <a:r>
            <a:rPr lang="en-US" b="1" dirty="0"/>
            <a:t>Wish</a:t>
          </a:r>
          <a:r>
            <a:rPr lang="en-US" dirty="0"/>
            <a:t> </a:t>
          </a:r>
          <a:r>
            <a:rPr lang="en-US" b="1" dirty="0"/>
            <a:t>1: </a:t>
          </a:r>
          <a:endParaRPr lang="en-US" dirty="0"/>
        </a:p>
      </dgm:t>
    </dgm:pt>
    <dgm:pt modelId="{0488966E-1C98-4A12-8B85-5A7B31D0FF58}" type="parTrans" cxnId="{76C9FAA1-A107-4C35-9264-185E7AB95DEB}">
      <dgm:prSet/>
      <dgm:spPr/>
      <dgm:t>
        <a:bodyPr/>
        <a:lstStyle/>
        <a:p>
          <a:endParaRPr lang="en-US"/>
        </a:p>
      </dgm:t>
    </dgm:pt>
    <dgm:pt modelId="{1C220F60-6425-4453-9BD3-0F622A1E2F58}" type="sibTrans" cxnId="{76C9FAA1-A107-4C35-9264-185E7AB95DEB}">
      <dgm:prSet/>
      <dgm:spPr/>
      <dgm:t>
        <a:bodyPr/>
        <a:lstStyle/>
        <a:p>
          <a:endParaRPr lang="en-US"/>
        </a:p>
      </dgm:t>
    </dgm:pt>
    <dgm:pt modelId="{685FF22B-A628-42D5-8950-CCA3EE019177}">
      <dgm:prSet/>
      <dgm:spPr/>
      <dgm:t>
        <a:bodyPr/>
        <a:lstStyle/>
        <a:p>
          <a:r>
            <a:rPr lang="en-US" dirty="0"/>
            <a:t>The Person I Want to Make Care Decisions for Me When I Can't.</a:t>
          </a:r>
        </a:p>
      </dgm:t>
    </dgm:pt>
    <dgm:pt modelId="{045F1E47-CFA1-47E9-801C-DEA30AF84A03}" type="parTrans" cxnId="{2DFEB0F1-C7CE-4D41-A57E-3CE4332BA283}">
      <dgm:prSet/>
      <dgm:spPr/>
      <dgm:t>
        <a:bodyPr/>
        <a:lstStyle/>
        <a:p>
          <a:endParaRPr lang="en-US"/>
        </a:p>
      </dgm:t>
    </dgm:pt>
    <dgm:pt modelId="{CFCD8918-1609-4F91-B55B-500CACA06E9A}" type="sibTrans" cxnId="{2DFEB0F1-C7CE-4D41-A57E-3CE4332BA283}">
      <dgm:prSet/>
      <dgm:spPr/>
      <dgm:t>
        <a:bodyPr/>
        <a:lstStyle/>
        <a:p>
          <a:endParaRPr lang="en-US"/>
        </a:p>
      </dgm:t>
    </dgm:pt>
    <dgm:pt modelId="{0D931406-5540-437A-B14C-C1C80527CE44}">
      <dgm:prSet/>
      <dgm:spPr/>
      <dgm:t>
        <a:bodyPr/>
        <a:lstStyle/>
        <a:p>
          <a:r>
            <a:rPr lang="en-US" b="1" dirty="0"/>
            <a:t>Wish</a:t>
          </a:r>
          <a:r>
            <a:rPr lang="en-US" dirty="0"/>
            <a:t> </a:t>
          </a:r>
          <a:r>
            <a:rPr lang="en-US" b="1" dirty="0"/>
            <a:t>2: </a:t>
          </a:r>
          <a:endParaRPr lang="en-US" dirty="0"/>
        </a:p>
      </dgm:t>
    </dgm:pt>
    <dgm:pt modelId="{5BEADFC8-F631-4500-A421-56360BC7354A}" type="parTrans" cxnId="{6AD496DE-6588-4B93-9E1A-1275B6106254}">
      <dgm:prSet/>
      <dgm:spPr/>
      <dgm:t>
        <a:bodyPr/>
        <a:lstStyle/>
        <a:p>
          <a:endParaRPr lang="en-US"/>
        </a:p>
      </dgm:t>
    </dgm:pt>
    <dgm:pt modelId="{124C2673-DAF8-48A6-8312-0FC3AA256BBE}" type="sibTrans" cxnId="{6AD496DE-6588-4B93-9E1A-1275B6106254}">
      <dgm:prSet/>
      <dgm:spPr/>
      <dgm:t>
        <a:bodyPr/>
        <a:lstStyle/>
        <a:p>
          <a:endParaRPr lang="en-US"/>
        </a:p>
      </dgm:t>
    </dgm:pt>
    <dgm:pt modelId="{12B910E1-F335-465D-80BB-CCB3BC56F2AA}">
      <dgm:prSet/>
      <dgm:spPr/>
      <dgm:t>
        <a:bodyPr/>
        <a:lstStyle/>
        <a:p>
          <a:r>
            <a:rPr lang="en-US" dirty="0"/>
            <a:t>The Kind of Medical Treatment I Want or Don't Want. </a:t>
          </a:r>
        </a:p>
      </dgm:t>
    </dgm:pt>
    <dgm:pt modelId="{A0A16404-6446-42D3-9239-A245C5EE314A}" type="parTrans" cxnId="{154A34EB-770A-4BE1-83D0-47E6D8120F98}">
      <dgm:prSet/>
      <dgm:spPr/>
      <dgm:t>
        <a:bodyPr/>
        <a:lstStyle/>
        <a:p>
          <a:endParaRPr lang="en-US"/>
        </a:p>
      </dgm:t>
    </dgm:pt>
    <dgm:pt modelId="{0587653C-62A7-4667-BF7F-5AC18259D060}" type="sibTrans" cxnId="{154A34EB-770A-4BE1-83D0-47E6D8120F98}">
      <dgm:prSet/>
      <dgm:spPr/>
      <dgm:t>
        <a:bodyPr/>
        <a:lstStyle/>
        <a:p>
          <a:endParaRPr lang="en-US"/>
        </a:p>
      </dgm:t>
    </dgm:pt>
    <dgm:pt modelId="{66F08BD6-B222-4320-8FC9-B9A107354EC6}">
      <dgm:prSet/>
      <dgm:spPr/>
      <dgm:t>
        <a:bodyPr/>
        <a:lstStyle/>
        <a:p>
          <a:r>
            <a:rPr lang="en-US" b="1" dirty="0"/>
            <a:t>Wish</a:t>
          </a:r>
          <a:r>
            <a:rPr lang="en-US" dirty="0"/>
            <a:t> </a:t>
          </a:r>
          <a:r>
            <a:rPr lang="en-US" b="1" dirty="0"/>
            <a:t>3: </a:t>
          </a:r>
          <a:endParaRPr lang="en-US" dirty="0"/>
        </a:p>
      </dgm:t>
    </dgm:pt>
    <dgm:pt modelId="{3B13B177-3763-4029-8D41-F94427ACF74F}" type="parTrans" cxnId="{D28C2B6B-A7B9-4E39-91DA-4899A97E9801}">
      <dgm:prSet/>
      <dgm:spPr/>
      <dgm:t>
        <a:bodyPr/>
        <a:lstStyle/>
        <a:p>
          <a:endParaRPr lang="en-US"/>
        </a:p>
      </dgm:t>
    </dgm:pt>
    <dgm:pt modelId="{083BEAFE-E215-43B9-AA4A-9066401E070D}" type="sibTrans" cxnId="{D28C2B6B-A7B9-4E39-91DA-4899A97E9801}">
      <dgm:prSet/>
      <dgm:spPr/>
      <dgm:t>
        <a:bodyPr/>
        <a:lstStyle/>
        <a:p>
          <a:endParaRPr lang="en-US"/>
        </a:p>
      </dgm:t>
    </dgm:pt>
    <dgm:pt modelId="{76982F28-A6A6-433F-BBD8-EADA1CB2C168}">
      <dgm:prSet/>
      <dgm:spPr/>
      <dgm:t>
        <a:bodyPr/>
        <a:lstStyle/>
        <a:p>
          <a:r>
            <a:rPr lang="en-US" dirty="0"/>
            <a:t>How Comfortable I Want to Be. </a:t>
          </a:r>
        </a:p>
      </dgm:t>
    </dgm:pt>
    <dgm:pt modelId="{CDD35868-5765-4E4A-9D78-D0D7E3C89F10}" type="parTrans" cxnId="{C1BBE6DD-853A-4C3F-9814-349977B97824}">
      <dgm:prSet/>
      <dgm:spPr/>
      <dgm:t>
        <a:bodyPr/>
        <a:lstStyle/>
        <a:p>
          <a:endParaRPr lang="en-US"/>
        </a:p>
      </dgm:t>
    </dgm:pt>
    <dgm:pt modelId="{656C0783-58F8-4B24-81BD-161985B31DC5}" type="sibTrans" cxnId="{C1BBE6DD-853A-4C3F-9814-349977B97824}">
      <dgm:prSet/>
      <dgm:spPr/>
      <dgm:t>
        <a:bodyPr/>
        <a:lstStyle/>
        <a:p>
          <a:endParaRPr lang="en-US"/>
        </a:p>
      </dgm:t>
    </dgm:pt>
    <dgm:pt modelId="{746BD541-D70F-4C35-8B6F-59438F512D13}">
      <dgm:prSet/>
      <dgm:spPr/>
      <dgm:t>
        <a:bodyPr/>
        <a:lstStyle/>
        <a:p>
          <a:r>
            <a:rPr lang="en-US" b="1" dirty="0"/>
            <a:t>Wish 4: </a:t>
          </a:r>
          <a:endParaRPr lang="en-US" dirty="0"/>
        </a:p>
      </dgm:t>
    </dgm:pt>
    <dgm:pt modelId="{BCD65126-58C2-49A5-A6CC-1231E72255BF}" type="parTrans" cxnId="{C184CD41-B9B7-45C7-82A1-F06D0F109F87}">
      <dgm:prSet/>
      <dgm:spPr/>
      <dgm:t>
        <a:bodyPr/>
        <a:lstStyle/>
        <a:p>
          <a:endParaRPr lang="en-US"/>
        </a:p>
      </dgm:t>
    </dgm:pt>
    <dgm:pt modelId="{C319246F-C801-4430-B8BA-F692C0C090F2}" type="sibTrans" cxnId="{C184CD41-B9B7-45C7-82A1-F06D0F109F87}">
      <dgm:prSet/>
      <dgm:spPr/>
      <dgm:t>
        <a:bodyPr/>
        <a:lstStyle/>
        <a:p>
          <a:endParaRPr lang="en-US"/>
        </a:p>
      </dgm:t>
    </dgm:pt>
    <dgm:pt modelId="{8AA1F0AA-4B0A-4896-91A8-C553D4A45C7F}">
      <dgm:prSet/>
      <dgm:spPr/>
      <dgm:t>
        <a:bodyPr/>
        <a:lstStyle/>
        <a:p>
          <a:r>
            <a:rPr lang="en-US" dirty="0"/>
            <a:t>How I Want People to Treat Me. </a:t>
          </a:r>
        </a:p>
      </dgm:t>
    </dgm:pt>
    <dgm:pt modelId="{EDA1C2D7-63C1-4C0F-BFD8-05D8A2B77E14}" type="parTrans" cxnId="{81731D5F-FFBC-429F-B046-8CD01F4AEC0A}">
      <dgm:prSet/>
      <dgm:spPr/>
      <dgm:t>
        <a:bodyPr/>
        <a:lstStyle/>
        <a:p>
          <a:endParaRPr lang="en-US"/>
        </a:p>
      </dgm:t>
    </dgm:pt>
    <dgm:pt modelId="{4832AD86-FC13-4745-997C-C48DD0F580A2}" type="sibTrans" cxnId="{81731D5F-FFBC-429F-B046-8CD01F4AEC0A}">
      <dgm:prSet/>
      <dgm:spPr/>
      <dgm:t>
        <a:bodyPr/>
        <a:lstStyle/>
        <a:p>
          <a:endParaRPr lang="en-US"/>
        </a:p>
      </dgm:t>
    </dgm:pt>
    <dgm:pt modelId="{7707F3B9-B2F4-4FE3-94A5-F0956266DF71}">
      <dgm:prSet/>
      <dgm:spPr/>
      <dgm:t>
        <a:bodyPr/>
        <a:lstStyle/>
        <a:p>
          <a:r>
            <a:rPr lang="en-US" b="1" dirty="0"/>
            <a:t>Wish 5</a:t>
          </a:r>
          <a:r>
            <a:rPr lang="en-US" dirty="0"/>
            <a:t>: </a:t>
          </a:r>
        </a:p>
      </dgm:t>
    </dgm:pt>
    <dgm:pt modelId="{EC7BE96F-BD1A-4816-A234-2948A681EC13}" type="parTrans" cxnId="{A7DE5BE8-DB5B-4EB7-B3E6-A4690384859C}">
      <dgm:prSet/>
      <dgm:spPr/>
      <dgm:t>
        <a:bodyPr/>
        <a:lstStyle/>
        <a:p>
          <a:endParaRPr lang="en-US"/>
        </a:p>
      </dgm:t>
    </dgm:pt>
    <dgm:pt modelId="{C618261B-210D-478B-B88D-AB6FC902E920}" type="sibTrans" cxnId="{A7DE5BE8-DB5B-4EB7-B3E6-A4690384859C}">
      <dgm:prSet/>
      <dgm:spPr/>
      <dgm:t>
        <a:bodyPr/>
        <a:lstStyle/>
        <a:p>
          <a:endParaRPr lang="en-US"/>
        </a:p>
      </dgm:t>
    </dgm:pt>
    <dgm:pt modelId="{23B12A47-6EF7-4E19-AE72-8BC9CEF4A266}">
      <dgm:prSet/>
      <dgm:spPr/>
      <dgm:t>
        <a:bodyPr/>
        <a:lstStyle/>
        <a:p>
          <a:r>
            <a:rPr lang="en-US" dirty="0"/>
            <a:t>What I Want My Loved Ones to Know.</a:t>
          </a:r>
        </a:p>
      </dgm:t>
    </dgm:pt>
    <dgm:pt modelId="{31CE8D51-7302-49D9-94AD-FF229FFD1958}" type="parTrans" cxnId="{110FF00F-746D-4415-B520-96E666C31A46}">
      <dgm:prSet/>
      <dgm:spPr/>
      <dgm:t>
        <a:bodyPr/>
        <a:lstStyle/>
        <a:p>
          <a:endParaRPr lang="en-US"/>
        </a:p>
      </dgm:t>
    </dgm:pt>
    <dgm:pt modelId="{860CB84E-F313-4D91-A3E1-1FEDD9097776}" type="sibTrans" cxnId="{110FF00F-746D-4415-B520-96E666C31A46}">
      <dgm:prSet/>
      <dgm:spPr/>
      <dgm:t>
        <a:bodyPr/>
        <a:lstStyle/>
        <a:p>
          <a:endParaRPr lang="en-US"/>
        </a:p>
      </dgm:t>
    </dgm:pt>
    <dgm:pt modelId="{0A889618-029A-4DED-A860-12BA07A17B0A}" type="pres">
      <dgm:prSet presAssocID="{48C30C0E-F162-44CF-8811-58945B76F2B0}" presName="Name0" presStyleCnt="0">
        <dgm:presLayoutVars>
          <dgm:dir/>
          <dgm:animLvl val="lvl"/>
          <dgm:resizeHandles val="exact"/>
        </dgm:presLayoutVars>
      </dgm:prSet>
      <dgm:spPr/>
    </dgm:pt>
    <dgm:pt modelId="{C1E14EF0-E48E-4E2D-87C3-9A54C783410D}" type="pres">
      <dgm:prSet presAssocID="{9CB7DE7D-1AAF-4235-A5DF-A2E08052671C}" presName="linNode" presStyleCnt="0"/>
      <dgm:spPr/>
    </dgm:pt>
    <dgm:pt modelId="{906258DB-6FC9-4D3D-B180-8972FF31F239}" type="pres">
      <dgm:prSet presAssocID="{9CB7DE7D-1AAF-4235-A5DF-A2E08052671C}" presName="parentText" presStyleLbl="node1" presStyleIdx="0" presStyleCnt="5">
        <dgm:presLayoutVars>
          <dgm:chMax val="1"/>
          <dgm:bulletEnabled val="1"/>
        </dgm:presLayoutVars>
      </dgm:prSet>
      <dgm:spPr/>
    </dgm:pt>
    <dgm:pt modelId="{B04C2D1F-AA0C-431E-B913-BD15A5A68341}" type="pres">
      <dgm:prSet presAssocID="{9CB7DE7D-1AAF-4235-A5DF-A2E08052671C}" presName="descendantText" presStyleLbl="alignAccFollowNode1" presStyleIdx="0" presStyleCnt="5">
        <dgm:presLayoutVars>
          <dgm:bulletEnabled val="1"/>
        </dgm:presLayoutVars>
      </dgm:prSet>
      <dgm:spPr/>
    </dgm:pt>
    <dgm:pt modelId="{92394CE6-EF9D-4935-94B0-736EDC4DF209}" type="pres">
      <dgm:prSet presAssocID="{1C220F60-6425-4453-9BD3-0F622A1E2F58}" presName="sp" presStyleCnt="0"/>
      <dgm:spPr/>
    </dgm:pt>
    <dgm:pt modelId="{E2D3D8C1-B92F-4ADC-9701-59510057D34F}" type="pres">
      <dgm:prSet presAssocID="{0D931406-5540-437A-B14C-C1C80527CE44}" presName="linNode" presStyleCnt="0"/>
      <dgm:spPr/>
    </dgm:pt>
    <dgm:pt modelId="{69DD7001-72C9-4BDC-BAD1-6A0EC562260E}" type="pres">
      <dgm:prSet presAssocID="{0D931406-5540-437A-B14C-C1C80527CE44}" presName="parentText" presStyleLbl="node1" presStyleIdx="1" presStyleCnt="5">
        <dgm:presLayoutVars>
          <dgm:chMax val="1"/>
          <dgm:bulletEnabled val="1"/>
        </dgm:presLayoutVars>
      </dgm:prSet>
      <dgm:spPr/>
    </dgm:pt>
    <dgm:pt modelId="{050E84B2-B3B6-4FB3-8E57-7B93FD0BD6AB}" type="pres">
      <dgm:prSet presAssocID="{0D931406-5540-437A-B14C-C1C80527CE44}" presName="descendantText" presStyleLbl="alignAccFollowNode1" presStyleIdx="1" presStyleCnt="5">
        <dgm:presLayoutVars>
          <dgm:bulletEnabled val="1"/>
        </dgm:presLayoutVars>
      </dgm:prSet>
      <dgm:spPr/>
    </dgm:pt>
    <dgm:pt modelId="{25702A04-7024-4828-928F-AE0690B592D6}" type="pres">
      <dgm:prSet presAssocID="{124C2673-DAF8-48A6-8312-0FC3AA256BBE}" presName="sp" presStyleCnt="0"/>
      <dgm:spPr/>
    </dgm:pt>
    <dgm:pt modelId="{258EADC5-F5A4-41A5-BA34-C8285409AB1B}" type="pres">
      <dgm:prSet presAssocID="{66F08BD6-B222-4320-8FC9-B9A107354EC6}" presName="linNode" presStyleCnt="0"/>
      <dgm:spPr/>
    </dgm:pt>
    <dgm:pt modelId="{6BF90CC7-7F3B-4561-AB5C-0A0995681E49}" type="pres">
      <dgm:prSet presAssocID="{66F08BD6-B222-4320-8FC9-B9A107354EC6}" presName="parentText" presStyleLbl="node1" presStyleIdx="2" presStyleCnt="5">
        <dgm:presLayoutVars>
          <dgm:chMax val="1"/>
          <dgm:bulletEnabled val="1"/>
        </dgm:presLayoutVars>
      </dgm:prSet>
      <dgm:spPr/>
    </dgm:pt>
    <dgm:pt modelId="{6358C847-9F3F-487A-A8BB-4C78CF3449D3}" type="pres">
      <dgm:prSet presAssocID="{66F08BD6-B222-4320-8FC9-B9A107354EC6}" presName="descendantText" presStyleLbl="alignAccFollowNode1" presStyleIdx="2" presStyleCnt="5">
        <dgm:presLayoutVars>
          <dgm:bulletEnabled val="1"/>
        </dgm:presLayoutVars>
      </dgm:prSet>
      <dgm:spPr/>
    </dgm:pt>
    <dgm:pt modelId="{530FC899-5758-451C-A59C-72BEA6C71315}" type="pres">
      <dgm:prSet presAssocID="{083BEAFE-E215-43B9-AA4A-9066401E070D}" presName="sp" presStyleCnt="0"/>
      <dgm:spPr/>
    </dgm:pt>
    <dgm:pt modelId="{59641A91-1F9B-4239-AA99-4DB756DCDE15}" type="pres">
      <dgm:prSet presAssocID="{746BD541-D70F-4C35-8B6F-59438F512D13}" presName="linNode" presStyleCnt="0"/>
      <dgm:spPr/>
    </dgm:pt>
    <dgm:pt modelId="{788D4F97-436C-48B9-A7F5-A4329330DBEC}" type="pres">
      <dgm:prSet presAssocID="{746BD541-D70F-4C35-8B6F-59438F512D13}" presName="parentText" presStyleLbl="node1" presStyleIdx="3" presStyleCnt="5">
        <dgm:presLayoutVars>
          <dgm:chMax val="1"/>
          <dgm:bulletEnabled val="1"/>
        </dgm:presLayoutVars>
      </dgm:prSet>
      <dgm:spPr/>
    </dgm:pt>
    <dgm:pt modelId="{38764332-774A-4377-B7DC-D7E55AF52C83}" type="pres">
      <dgm:prSet presAssocID="{746BD541-D70F-4C35-8B6F-59438F512D13}" presName="descendantText" presStyleLbl="alignAccFollowNode1" presStyleIdx="3" presStyleCnt="5">
        <dgm:presLayoutVars>
          <dgm:bulletEnabled val="1"/>
        </dgm:presLayoutVars>
      </dgm:prSet>
      <dgm:spPr/>
    </dgm:pt>
    <dgm:pt modelId="{3898CBF1-A18E-4D76-8707-3A9EA6C585FA}" type="pres">
      <dgm:prSet presAssocID="{C319246F-C801-4430-B8BA-F692C0C090F2}" presName="sp" presStyleCnt="0"/>
      <dgm:spPr/>
    </dgm:pt>
    <dgm:pt modelId="{872EAC2C-5796-413C-9163-AB201842DA62}" type="pres">
      <dgm:prSet presAssocID="{7707F3B9-B2F4-4FE3-94A5-F0956266DF71}" presName="linNode" presStyleCnt="0"/>
      <dgm:spPr/>
    </dgm:pt>
    <dgm:pt modelId="{FE6B50C1-CC06-45B9-BAE2-6AD10635FB58}" type="pres">
      <dgm:prSet presAssocID="{7707F3B9-B2F4-4FE3-94A5-F0956266DF71}" presName="parentText" presStyleLbl="node1" presStyleIdx="4" presStyleCnt="5">
        <dgm:presLayoutVars>
          <dgm:chMax val="1"/>
          <dgm:bulletEnabled val="1"/>
        </dgm:presLayoutVars>
      </dgm:prSet>
      <dgm:spPr/>
    </dgm:pt>
    <dgm:pt modelId="{355B8FFA-D55C-4F28-951A-8F8D0024F412}" type="pres">
      <dgm:prSet presAssocID="{7707F3B9-B2F4-4FE3-94A5-F0956266DF71}" presName="descendantText" presStyleLbl="alignAccFollowNode1" presStyleIdx="4" presStyleCnt="5">
        <dgm:presLayoutVars>
          <dgm:bulletEnabled val="1"/>
        </dgm:presLayoutVars>
      </dgm:prSet>
      <dgm:spPr/>
    </dgm:pt>
  </dgm:ptLst>
  <dgm:cxnLst>
    <dgm:cxn modelId="{43177308-A7E0-4EB2-B2F9-3E909BB58F40}" type="presOf" srcId="{7707F3B9-B2F4-4FE3-94A5-F0956266DF71}" destId="{FE6B50C1-CC06-45B9-BAE2-6AD10635FB58}" srcOrd="0" destOrd="0" presId="urn:microsoft.com/office/officeart/2005/8/layout/vList5"/>
    <dgm:cxn modelId="{110FF00F-746D-4415-B520-96E666C31A46}" srcId="{7707F3B9-B2F4-4FE3-94A5-F0956266DF71}" destId="{23B12A47-6EF7-4E19-AE72-8BC9CEF4A266}" srcOrd="0" destOrd="0" parTransId="{31CE8D51-7302-49D9-94AD-FF229FFD1958}" sibTransId="{860CB84E-F313-4D91-A3E1-1FEDD9097776}"/>
    <dgm:cxn modelId="{1FFC3713-42EF-4BF5-A270-85E8B4B548F2}" type="presOf" srcId="{48C30C0E-F162-44CF-8811-58945B76F2B0}" destId="{0A889618-029A-4DED-A860-12BA07A17B0A}" srcOrd="0" destOrd="0" presId="urn:microsoft.com/office/officeart/2005/8/layout/vList5"/>
    <dgm:cxn modelId="{4715493A-A952-4525-8239-CF95B01E2279}" type="presOf" srcId="{12B910E1-F335-465D-80BB-CCB3BC56F2AA}" destId="{050E84B2-B3B6-4FB3-8E57-7B93FD0BD6AB}" srcOrd="0" destOrd="0" presId="urn:microsoft.com/office/officeart/2005/8/layout/vList5"/>
    <dgm:cxn modelId="{883BE33F-53F9-4883-B0B7-29AA0613F6C3}" type="presOf" srcId="{685FF22B-A628-42D5-8950-CCA3EE019177}" destId="{B04C2D1F-AA0C-431E-B913-BD15A5A68341}" srcOrd="0" destOrd="0" presId="urn:microsoft.com/office/officeart/2005/8/layout/vList5"/>
    <dgm:cxn modelId="{C184CD41-B9B7-45C7-82A1-F06D0F109F87}" srcId="{48C30C0E-F162-44CF-8811-58945B76F2B0}" destId="{746BD541-D70F-4C35-8B6F-59438F512D13}" srcOrd="3" destOrd="0" parTransId="{BCD65126-58C2-49A5-A6CC-1231E72255BF}" sibTransId="{C319246F-C801-4430-B8BA-F692C0C090F2}"/>
    <dgm:cxn modelId="{ECC9805E-1810-40C5-9FD3-8C581069B5B2}" type="presOf" srcId="{8AA1F0AA-4B0A-4896-91A8-C553D4A45C7F}" destId="{38764332-774A-4377-B7DC-D7E55AF52C83}" srcOrd="0" destOrd="0" presId="urn:microsoft.com/office/officeart/2005/8/layout/vList5"/>
    <dgm:cxn modelId="{81731D5F-FFBC-429F-B046-8CD01F4AEC0A}" srcId="{746BD541-D70F-4C35-8B6F-59438F512D13}" destId="{8AA1F0AA-4B0A-4896-91A8-C553D4A45C7F}" srcOrd="0" destOrd="0" parTransId="{EDA1C2D7-63C1-4C0F-BFD8-05D8A2B77E14}" sibTransId="{4832AD86-FC13-4745-997C-C48DD0F580A2}"/>
    <dgm:cxn modelId="{D28C2B6B-A7B9-4E39-91DA-4899A97E9801}" srcId="{48C30C0E-F162-44CF-8811-58945B76F2B0}" destId="{66F08BD6-B222-4320-8FC9-B9A107354EC6}" srcOrd="2" destOrd="0" parTransId="{3B13B177-3763-4029-8D41-F94427ACF74F}" sibTransId="{083BEAFE-E215-43B9-AA4A-9066401E070D}"/>
    <dgm:cxn modelId="{128DE46C-09CF-451A-9503-2114E06CCAAB}" type="presOf" srcId="{746BD541-D70F-4C35-8B6F-59438F512D13}" destId="{788D4F97-436C-48B9-A7F5-A4329330DBEC}" srcOrd="0" destOrd="0" presId="urn:microsoft.com/office/officeart/2005/8/layout/vList5"/>
    <dgm:cxn modelId="{232ABC94-6F84-4F7E-8F81-44C9AA95F506}" type="presOf" srcId="{66F08BD6-B222-4320-8FC9-B9A107354EC6}" destId="{6BF90CC7-7F3B-4561-AB5C-0A0995681E49}" srcOrd="0" destOrd="0" presId="urn:microsoft.com/office/officeart/2005/8/layout/vList5"/>
    <dgm:cxn modelId="{9146FAA0-5A6B-4850-B96A-919A20FC78C5}" type="presOf" srcId="{0D931406-5540-437A-B14C-C1C80527CE44}" destId="{69DD7001-72C9-4BDC-BAD1-6A0EC562260E}" srcOrd="0" destOrd="0" presId="urn:microsoft.com/office/officeart/2005/8/layout/vList5"/>
    <dgm:cxn modelId="{76C9FAA1-A107-4C35-9264-185E7AB95DEB}" srcId="{48C30C0E-F162-44CF-8811-58945B76F2B0}" destId="{9CB7DE7D-1AAF-4235-A5DF-A2E08052671C}" srcOrd="0" destOrd="0" parTransId="{0488966E-1C98-4A12-8B85-5A7B31D0FF58}" sibTransId="{1C220F60-6425-4453-9BD3-0F622A1E2F58}"/>
    <dgm:cxn modelId="{77D183A2-042C-4F64-92CA-0521E56BCFCD}" type="presOf" srcId="{23B12A47-6EF7-4E19-AE72-8BC9CEF4A266}" destId="{355B8FFA-D55C-4F28-951A-8F8D0024F412}" srcOrd="0" destOrd="0" presId="urn:microsoft.com/office/officeart/2005/8/layout/vList5"/>
    <dgm:cxn modelId="{C1BBE6DD-853A-4C3F-9814-349977B97824}" srcId="{66F08BD6-B222-4320-8FC9-B9A107354EC6}" destId="{76982F28-A6A6-433F-BBD8-EADA1CB2C168}" srcOrd="0" destOrd="0" parTransId="{CDD35868-5765-4E4A-9D78-D0D7E3C89F10}" sibTransId="{656C0783-58F8-4B24-81BD-161985B31DC5}"/>
    <dgm:cxn modelId="{6AD496DE-6588-4B93-9E1A-1275B6106254}" srcId="{48C30C0E-F162-44CF-8811-58945B76F2B0}" destId="{0D931406-5540-437A-B14C-C1C80527CE44}" srcOrd="1" destOrd="0" parTransId="{5BEADFC8-F631-4500-A421-56360BC7354A}" sibTransId="{124C2673-DAF8-48A6-8312-0FC3AA256BBE}"/>
    <dgm:cxn modelId="{A7DE5BE8-DB5B-4EB7-B3E6-A4690384859C}" srcId="{48C30C0E-F162-44CF-8811-58945B76F2B0}" destId="{7707F3B9-B2F4-4FE3-94A5-F0956266DF71}" srcOrd="4" destOrd="0" parTransId="{EC7BE96F-BD1A-4816-A234-2948A681EC13}" sibTransId="{C618261B-210D-478B-B88D-AB6FC902E920}"/>
    <dgm:cxn modelId="{154A34EB-770A-4BE1-83D0-47E6D8120F98}" srcId="{0D931406-5540-437A-B14C-C1C80527CE44}" destId="{12B910E1-F335-465D-80BB-CCB3BC56F2AA}" srcOrd="0" destOrd="0" parTransId="{A0A16404-6446-42D3-9239-A245C5EE314A}" sibTransId="{0587653C-62A7-4667-BF7F-5AC18259D060}"/>
    <dgm:cxn modelId="{D204EAEE-2F34-4957-80A5-F3F32B8673DB}" type="presOf" srcId="{9CB7DE7D-1AAF-4235-A5DF-A2E08052671C}" destId="{906258DB-6FC9-4D3D-B180-8972FF31F239}" srcOrd="0" destOrd="0" presId="urn:microsoft.com/office/officeart/2005/8/layout/vList5"/>
    <dgm:cxn modelId="{46D38DF0-49AE-4F4B-BF1D-D2CA72E8E038}" type="presOf" srcId="{76982F28-A6A6-433F-BBD8-EADA1CB2C168}" destId="{6358C847-9F3F-487A-A8BB-4C78CF3449D3}" srcOrd="0" destOrd="0" presId="urn:microsoft.com/office/officeart/2005/8/layout/vList5"/>
    <dgm:cxn modelId="{2DFEB0F1-C7CE-4D41-A57E-3CE4332BA283}" srcId="{9CB7DE7D-1AAF-4235-A5DF-A2E08052671C}" destId="{685FF22B-A628-42D5-8950-CCA3EE019177}" srcOrd="0" destOrd="0" parTransId="{045F1E47-CFA1-47E9-801C-DEA30AF84A03}" sibTransId="{CFCD8918-1609-4F91-B55B-500CACA06E9A}"/>
    <dgm:cxn modelId="{519571AF-0CF1-46E6-8488-0157A7F4BA66}" type="presParOf" srcId="{0A889618-029A-4DED-A860-12BA07A17B0A}" destId="{C1E14EF0-E48E-4E2D-87C3-9A54C783410D}" srcOrd="0" destOrd="0" presId="urn:microsoft.com/office/officeart/2005/8/layout/vList5"/>
    <dgm:cxn modelId="{EC6EE730-A17E-4F3F-B576-60DDF5FAFD78}" type="presParOf" srcId="{C1E14EF0-E48E-4E2D-87C3-9A54C783410D}" destId="{906258DB-6FC9-4D3D-B180-8972FF31F239}" srcOrd="0" destOrd="0" presId="urn:microsoft.com/office/officeart/2005/8/layout/vList5"/>
    <dgm:cxn modelId="{5B6121A2-951A-4FEA-A152-ABD0140EA4B3}" type="presParOf" srcId="{C1E14EF0-E48E-4E2D-87C3-9A54C783410D}" destId="{B04C2D1F-AA0C-431E-B913-BD15A5A68341}" srcOrd="1" destOrd="0" presId="urn:microsoft.com/office/officeart/2005/8/layout/vList5"/>
    <dgm:cxn modelId="{147CE877-95DF-437A-B4EF-4CE015E5DD8C}" type="presParOf" srcId="{0A889618-029A-4DED-A860-12BA07A17B0A}" destId="{92394CE6-EF9D-4935-94B0-736EDC4DF209}" srcOrd="1" destOrd="0" presId="urn:microsoft.com/office/officeart/2005/8/layout/vList5"/>
    <dgm:cxn modelId="{384CA4D5-F085-4D04-B93B-4A543259026D}" type="presParOf" srcId="{0A889618-029A-4DED-A860-12BA07A17B0A}" destId="{E2D3D8C1-B92F-4ADC-9701-59510057D34F}" srcOrd="2" destOrd="0" presId="urn:microsoft.com/office/officeart/2005/8/layout/vList5"/>
    <dgm:cxn modelId="{AE0B69A1-86AE-46F7-AB6E-5161D928BA30}" type="presParOf" srcId="{E2D3D8C1-B92F-4ADC-9701-59510057D34F}" destId="{69DD7001-72C9-4BDC-BAD1-6A0EC562260E}" srcOrd="0" destOrd="0" presId="urn:microsoft.com/office/officeart/2005/8/layout/vList5"/>
    <dgm:cxn modelId="{556AE1FA-73B6-4AF8-B15F-9F2E5181F41F}" type="presParOf" srcId="{E2D3D8C1-B92F-4ADC-9701-59510057D34F}" destId="{050E84B2-B3B6-4FB3-8E57-7B93FD0BD6AB}" srcOrd="1" destOrd="0" presId="urn:microsoft.com/office/officeart/2005/8/layout/vList5"/>
    <dgm:cxn modelId="{2AB0E0C7-F130-4179-8B92-FFA381439EB0}" type="presParOf" srcId="{0A889618-029A-4DED-A860-12BA07A17B0A}" destId="{25702A04-7024-4828-928F-AE0690B592D6}" srcOrd="3" destOrd="0" presId="urn:microsoft.com/office/officeart/2005/8/layout/vList5"/>
    <dgm:cxn modelId="{10FAF9EC-133C-46BC-ADF6-EDAFC4295DAB}" type="presParOf" srcId="{0A889618-029A-4DED-A860-12BA07A17B0A}" destId="{258EADC5-F5A4-41A5-BA34-C8285409AB1B}" srcOrd="4" destOrd="0" presId="urn:microsoft.com/office/officeart/2005/8/layout/vList5"/>
    <dgm:cxn modelId="{F4CAF593-8A3C-4CB9-A950-03DF5C29A026}" type="presParOf" srcId="{258EADC5-F5A4-41A5-BA34-C8285409AB1B}" destId="{6BF90CC7-7F3B-4561-AB5C-0A0995681E49}" srcOrd="0" destOrd="0" presId="urn:microsoft.com/office/officeart/2005/8/layout/vList5"/>
    <dgm:cxn modelId="{90161DF5-3F43-4FE5-B01F-60BC833F52CE}" type="presParOf" srcId="{258EADC5-F5A4-41A5-BA34-C8285409AB1B}" destId="{6358C847-9F3F-487A-A8BB-4C78CF3449D3}" srcOrd="1" destOrd="0" presId="urn:microsoft.com/office/officeart/2005/8/layout/vList5"/>
    <dgm:cxn modelId="{D8EB1524-90AE-4940-AB18-E504015C768E}" type="presParOf" srcId="{0A889618-029A-4DED-A860-12BA07A17B0A}" destId="{530FC899-5758-451C-A59C-72BEA6C71315}" srcOrd="5" destOrd="0" presId="urn:microsoft.com/office/officeart/2005/8/layout/vList5"/>
    <dgm:cxn modelId="{F91CAE7C-D5E2-4DEA-9A40-687E9CD51C44}" type="presParOf" srcId="{0A889618-029A-4DED-A860-12BA07A17B0A}" destId="{59641A91-1F9B-4239-AA99-4DB756DCDE15}" srcOrd="6" destOrd="0" presId="urn:microsoft.com/office/officeart/2005/8/layout/vList5"/>
    <dgm:cxn modelId="{83342253-42AC-4D8A-89F0-3717D1206641}" type="presParOf" srcId="{59641A91-1F9B-4239-AA99-4DB756DCDE15}" destId="{788D4F97-436C-48B9-A7F5-A4329330DBEC}" srcOrd="0" destOrd="0" presId="urn:microsoft.com/office/officeart/2005/8/layout/vList5"/>
    <dgm:cxn modelId="{DB68F4D7-FE1D-4D33-84BA-8030812BF17C}" type="presParOf" srcId="{59641A91-1F9B-4239-AA99-4DB756DCDE15}" destId="{38764332-774A-4377-B7DC-D7E55AF52C83}" srcOrd="1" destOrd="0" presId="urn:microsoft.com/office/officeart/2005/8/layout/vList5"/>
    <dgm:cxn modelId="{7AB1B1F9-ED35-4858-8AC4-61134F23A3F0}" type="presParOf" srcId="{0A889618-029A-4DED-A860-12BA07A17B0A}" destId="{3898CBF1-A18E-4D76-8707-3A9EA6C585FA}" srcOrd="7" destOrd="0" presId="urn:microsoft.com/office/officeart/2005/8/layout/vList5"/>
    <dgm:cxn modelId="{5000637D-F9F9-419D-9F7E-09A101EF3685}" type="presParOf" srcId="{0A889618-029A-4DED-A860-12BA07A17B0A}" destId="{872EAC2C-5796-413C-9163-AB201842DA62}" srcOrd="8" destOrd="0" presId="urn:microsoft.com/office/officeart/2005/8/layout/vList5"/>
    <dgm:cxn modelId="{E46AF048-E371-4D67-81A7-C7CBFBCD3DE7}" type="presParOf" srcId="{872EAC2C-5796-413C-9163-AB201842DA62}" destId="{FE6B50C1-CC06-45B9-BAE2-6AD10635FB58}" srcOrd="0" destOrd="0" presId="urn:microsoft.com/office/officeart/2005/8/layout/vList5"/>
    <dgm:cxn modelId="{9E1AC452-838F-44BF-A726-C222C7400060}" type="presParOf" srcId="{872EAC2C-5796-413C-9163-AB201842DA62}" destId="{355B8FFA-D55C-4F28-951A-8F8D0024F412}" srcOrd="1" destOrd="0" presId="urn:microsoft.com/office/officeart/2005/8/layout/vList5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7.xml><?xml version="1.0" encoding="utf-8"?>
<dgm:dataModel xmlns:dgm="http://schemas.openxmlformats.org/drawingml/2006/diagram" xmlns:a="http://schemas.openxmlformats.org/drawingml/2006/main">
  <dgm:ptLst>
    <dgm:pt modelId="{65B89763-8761-4972-ADEB-0B07A63C54BB}" type="doc">
      <dgm:prSet loTypeId="urn:microsoft.com/office/officeart/2005/8/layout/vList2" loCatId="list" qsTypeId="urn:microsoft.com/office/officeart/2005/8/quickstyle/simple1" qsCatId="simple" csTypeId="urn:microsoft.com/office/officeart/2005/8/colors/colorful5" csCatId="colorful" phldr="1"/>
      <dgm:spPr/>
      <dgm:t>
        <a:bodyPr/>
        <a:lstStyle/>
        <a:p>
          <a:endParaRPr lang="en-US"/>
        </a:p>
      </dgm:t>
    </dgm:pt>
    <dgm:pt modelId="{B3FBBC27-DBB7-4A6D-B3E3-EB3C37827851}">
      <dgm:prSet/>
      <dgm:spPr/>
      <dgm:t>
        <a:bodyPr/>
        <a:lstStyle/>
        <a:p>
          <a:r>
            <a:rPr lang="en-US" dirty="0"/>
            <a:t>Care of older adults is </a:t>
          </a:r>
          <a:r>
            <a:rPr lang="en-US" b="1" dirty="0"/>
            <a:t>complex</a:t>
          </a:r>
          <a:r>
            <a:rPr lang="en-US" dirty="0"/>
            <a:t> and requires a </a:t>
          </a:r>
          <a:r>
            <a:rPr lang="en-US" b="1" dirty="0"/>
            <a:t>multimodal, interprofessional approach</a:t>
          </a:r>
          <a:r>
            <a:rPr lang="en-US" dirty="0"/>
            <a:t> with the goal to </a:t>
          </a:r>
          <a:r>
            <a:rPr lang="en-US" b="1" dirty="0"/>
            <a:t>maintain function and quality of life</a:t>
          </a:r>
          <a:r>
            <a:rPr lang="en-US" dirty="0"/>
            <a:t>.</a:t>
          </a:r>
        </a:p>
      </dgm:t>
    </dgm:pt>
    <dgm:pt modelId="{BB4FF2A6-566C-44BF-ACD0-257F060BA44E}" type="parTrans" cxnId="{80F31738-E160-4F01-BD45-0C213D779A6E}">
      <dgm:prSet/>
      <dgm:spPr/>
      <dgm:t>
        <a:bodyPr/>
        <a:lstStyle/>
        <a:p>
          <a:endParaRPr lang="en-US"/>
        </a:p>
      </dgm:t>
    </dgm:pt>
    <dgm:pt modelId="{7B0EE161-EBFB-488D-8230-AA627EB9F177}" type="sibTrans" cxnId="{80F31738-E160-4F01-BD45-0C213D779A6E}">
      <dgm:prSet/>
      <dgm:spPr/>
      <dgm:t>
        <a:bodyPr/>
        <a:lstStyle/>
        <a:p>
          <a:endParaRPr lang="en-US"/>
        </a:p>
      </dgm:t>
    </dgm:pt>
    <dgm:pt modelId="{50ED738B-B134-46AD-B6A8-00759D170214}">
      <dgm:prSet phldr="0"/>
      <dgm:spPr/>
      <dgm:t>
        <a:bodyPr/>
        <a:lstStyle/>
        <a:p>
          <a:pPr rtl="0"/>
          <a:r>
            <a:rPr lang="en-US" dirty="0">
              <a:latin typeface="Calibri Light" panose="020F0302020204030204"/>
            </a:rPr>
            <a:t>The</a:t>
          </a:r>
          <a:r>
            <a:rPr lang="en-US" b="1" dirty="0">
              <a:latin typeface="Calibri Light" panose="020F0302020204030204"/>
            </a:rPr>
            <a:t> 4Ms Framework</a:t>
          </a:r>
          <a:r>
            <a:rPr lang="en-US" dirty="0">
              <a:latin typeface="Calibri Light" panose="020F0302020204030204"/>
            </a:rPr>
            <a:t> provides an easy to remember approach to the care of the older adult</a:t>
          </a:r>
        </a:p>
      </dgm:t>
    </dgm:pt>
    <dgm:pt modelId="{B41AFC0F-F0DE-4BE9-9CCF-9277992810F2}" type="parTrans" cxnId="{30174B55-9C56-41C7-8D33-2A60F9D9AE40}">
      <dgm:prSet/>
      <dgm:spPr/>
      <dgm:t>
        <a:bodyPr/>
        <a:lstStyle/>
        <a:p>
          <a:endParaRPr lang="en-US"/>
        </a:p>
      </dgm:t>
    </dgm:pt>
    <dgm:pt modelId="{5F733861-5581-40CA-B34C-A0EF8EF031AD}" type="sibTrans" cxnId="{30174B55-9C56-41C7-8D33-2A60F9D9AE40}">
      <dgm:prSet/>
      <dgm:spPr/>
      <dgm:t>
        <a:bodyPr/>
        <a:lstStyle/>
        <a:p>
          <a:endParaRPr lang="en-US"/>
        </a:p>
      </dgm:t>
    </dgm:pt>
    <dgm:pt modelId="{38E20C12-4383-430B-BB0B-BA5036611AB3}" type="pres">
      <dgm:prSet presAssocID="{65B89763-8761-4972-ADEB-0B07A63C54BB}" presName="linear" presStyleCnt="0">
        <dgm:presLayoutVars>
          <dgm:animLvl val="lvl"/>
          <dgm:resizeHandles val="exact"/>
        </dgm:presLayoutVars>
      </dgm:prSet>
      <dgm:spPr/>
    </dgm:pt>
    <dgm:pt modelId="{C3927CAF-1FDB-4164-AE21-F2C81D8A5A11}" type="pres">
      <dgm:prSet presAssocID="{B3FBBC27-DBB7-4A6D-B3E3-EB3C37827851}" presName="parentText" presStyleLbl="node1" presStyleIdx="0" presStyleCnt="2">
        <dgm:presLayoutVars>
          <dgm:chMax val="0"/>
          <dgm:bulletEnabled val="1"/>
        </dgm:presLayoutVars>
      </dgm:prSet>
      <dgm:spPr/>
    </dgm:pt>
    <dgm:pt modelId="{91CB50EB-6DC3-470D-942A-C0C6AC9C870B}" type="pres">
      <dgm:prSet presAssocID="{7B0EE161-EBFB-488D-8230-AA627EB9F177}" presName="spacer" presStyleCnt="0"/>
      <dgm:spPr/>
    </dgm:pt>
    <dgm:pt modelId="{AFC5DA36-22FA-4FDE-9399-7B599EFC5914}" type="pres">
      <dgm:prSet presAssocID="{50ED738B-B134-46AD-B6A8-00759D170214}" presName="parentText" presStyleLbl="node1" presStyleIdx="1" presStyleCnt="2">
        <dgm:presLayoutVars>
          <dgm:chMax val="0"/>
          <dgm:bulletEnabled val="1"/>
        </dgm:presLayoutVars>
      </dgm:prSet>
      <dgm:spPr/>
    </dgm:pt>
  </dgm:ptLst>
  <dgm:cxnLst>
    <dgm:cxn modelId="{46449630-DB40-451A-92B9-0E9D2075C18E}" type="presOf" srcId="{65B89763-8761-4972-ADEB-0B07A63C54BB}" destId="{38E20C12-4383-430B-BB0B-BA5036611AB3}" srcOrd="0" destOrd="0" presId="urn:microsoft.com/office/officeart/2005/8/layout/vList2"/>
    <dgm:cxn modelId="{80F31738-E160-4F01-BD45-0C213D779A6E}" srcId="{65B89763-8761-4972-ADEB-0B07A63C54BB}" destId="{B3FBBC27-DBB7-4A6D-B3E3-EB3C37827851}" srcOrd="0" destOrd="0" parTransId="{BB4FF2A6-566C-44BF-ACD0-257F060BA44E}" sibTransId="{7B0EE161-EBFB-488D-8230-AA627EB9F177}"/>
    <dgm:cxn modelId="{22686D39-C416-4502-ACF8-B3A09FDAEBC0}" type="presOf" srcId="{B3FBBC27-DBB7-4A6D-B3E3-EB3C37827851}" destId="{C3927CAF-1FDB-4164-AE21-F2C81D8A5A11}" srcOrd="0" destOrd="0" presId="urn:microsoft.com/office/officeart/2005/8/layout/vList2"/>
    <dgm:cxn modelId="{D7EBD13A-D693-41BF-9BCF-802D79B1829A}" type="presOf" srcId="{50ED738B-B134-46AD-B6A8-00759D170214}" destId="{AFC5DA36-22FA-4FDE-9399-7B599EFC5914}" srcOrd="0" destOrd="0" presId="urn:microsoft.com/office/officeart/2005/8/layout/vList2"/>
    <dgm:cxn modelId="{30174B55-9C56-41C7-8D33-2A60F9D9AE40}" srcId="{65B89763-8761-4972-ADEB-0B07A63C54BB}" destId="{50ED738B-B134-46AD-B6A8-00759D170214}" srcOrd="1" destOrd="0" parTransId="{B41AFC0F-F0DE-4BE9-9CCF-9277992810F2}" sibTransId="{5F733861-5581-40CA-B34C-A0EF8EF031AD}"/>
    <dgm:cxn modelId="{DEFCE687-D2DA-4233-AA67-8689DECE6BBC}" type="presParOf" srcId="{38E20C12-4383-430B-BB0B-BA5036611AB3}" destId="{C3927CAF-1FDB-4164-AE21-F2C81D8A5A11}" srcOrd="0" destOrd="0" presId="urn:microsoft.com/office/officeart/2005/8/layout/vList2"/>
    <dgm:cxn modelId="{292BE76C-A078-41A2-8F63-5E2C93A52A8B}" type="presParOf" srcId="{38E20C12-4383-430B-BB0B-BA5036611AB3}" destId="{91CB50EB-6DC3-470D-942A-C0C6AC9C870B}" srcOrd="1" destOrd="0" presId="urn:microsoft.com/office/officeart/2005/8/layout/vList2"/>
    <dgm:cxn modelId="{D87D66EE-8ED7-4351-9680-2671E44FBB1E}" type="presParOf" srcId="{38E20C12-4383-430B-BB0B-BA5036611AB3}" destId="{AFC5DA36-22FA-4FDE-9399-7B599EFC5914}" srcOrd="2" destOrd="0" presId="urn:microsoft.com/office/officeart/2005/8/layout/vList2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8.xml><?xml version="1.0" encoding="utf-8"?>
<dgm:dataModel xmlns:dgm="http://schemas.openxmlformats.org/drawingml/2006/diagram" xmlns:a="http://schemas.openxmlformats.org/drawingml/2006/main">
  <dgm:ptLst>
    <dgm:pt modelId="{B22FE172-9650-4213-A126-4DAFF7D9264C}" type="doc">
      <dgm:prSet loTypeId="urn:microsoft.com/office/officeart/2005/8/layout/vList2" loCatId="list" qsTypeId="urn:microsoft.com/office/officeart/2005/8/quickstyle/simple1" qsCatId="simple" csTypeId="urn:microsoft.com/office/officeart/2005/8/colors/colorful5" csCatId="colorful" phldr="1"/>
      <dgm:spPr/>
      <dgm:t>
        <a:bodyPr/>
        <a:lstStyle/>
        <a:p>
          <a:endParaRPr lang="en-US"/>
        </a:p>
      </dgm:t>
    </dgm:pt>
    <dgm:pt modelId="{6421CACD-D613-4BBD-9855-27C729F2B0A2}">
      <dgm:prSet/>
      <dgm:spPr/>
      <dgm:t>
        <a:bodyPr/>
        <a:lstStyle/>
        <a:p>
          <a:r>
            <a:rPr lang="en-US" b="1" dirty="0"/>
            <a:t>M</a:t>
          </a:r>
          <a:r>
            <a:rPr lang="en-US" dirty="0"/>
            <a:t>ind/</a:t>
          </a:r>
          <a:r>
            <a:rPr lang="en-US" b="1" dirty="0"/>
            <a:t>M</a:t>
          </a:r>
          <a:r>
            <a:rPr lang="en-US" dirty="0"/>
            <a:t>emory </a:t>
          </a:r>
        </a:p>
      </dgm:t>
    </dgm:pt>
    <dgm:pt modelId="{6470A128-DE56-4228-B9C7-21CC2626D27E}" type="parTrans" cxnId="{C59C55F4-B4BB-4805-9665-56063F4AA872}">
      <dgm:prSet/>
      <dgm:spPr/>
      <dgm:t>
        <a:bodyPr/>
        <a:lstStyle/>
        <a:p>
          <a:endParaRPr lang="en-US"/>
        </a:p>
      </dgm:t>
    </dgm:pt>
    <dgm:pt modelId="{37842568-C138-43D5-8EDB-350564CB37A3}" type="sibTrans" cxnId="{C59C55F4-B4BB-4805-9665-56063F4AA872}">
      <dgm:prSet/>
      <dgm:spPr/>
      <dgm:t>
        <a:bodyPr/>
        <a:lstStyle/>
        <a:p>
          <a:endParaRPr lang="en-US"/>
        </a:p>
      </dgm:t>
    </dgm:pt>
    <dgm:pt modelId="{1715B2B6-F513-492E-95B1-9381C99795CF}">
      <dgm:prSet/>
      <dgm:spPr/>
      <dgm:t>
        <a:bodyPr/>
        <a:lstStyle/>
        <a:p>
          <a:r>
            <a:rPr lang="en-US" dirty="0"/>
            <a:t>Cognition Assessment</a:t>
          </a:r>
        </a:p>
      </dgm:t>
    </dgm:pt>
    <dgm:pt modelId="{DA994818-D7D7-402E-9F20-DF63A2BD2551}" type="parTrans" cxnId="{2F7858C9-9584-4137-8757-B8AF2038DB14}">
      <dgm:prSet/>
      <dgm:spPr/>
      <dgm:t>
        <a:bodyPr/>
        <a:lstStyle/>
        <a:p>
          <a:endParaRPr lang="en-US"/>
        </a:p>
      </dgm:t>
    </dgm:pt>
    <dgm:pt modelId="{0F9C46BF-DEB0-459E-A201-4F7C5258FB32}" type="sibTrans" cxnId="{2F7858C9-9584-4137-8757-B8AF2038DB14}">
      <dgm:prSet/>
      <dgm:spPr/>
      <dgm:t>
        <a:bodyPr/>
        <a:lstStyle/>
        <a:p>
          <a:endParaRPr lang="en-US"/>
        </a:p>
      </dgm:t>
    </dgm:pt>
    <dgm:pt modelId="{77198C55-A7DF-4788-9380-EE1BEEF9E66E}">
      <dgm:prSet/>
      <dgm:spPr/>
      <dgm:t>
        <a:bodyPr/>
        <a:lstStyle/>
        <a:p>
          <a:r>
            <a:rPr lang="en-US" b="0" dirty="0"/>
            <a:t>M</a:t>
          </a:r>
          <a:r>
            <a:rPr lang="en-US" dirty="0"/>
            <a:t>ood assessment</a:t>
          </a:r>
        </a:p>
      </dgm:t>
    </dgm:pt>
    <dgm:pt modelId="{BEF28244-A62A-4DD9-80D7-AFDC0D41DF4F}" type="parTrans" cxnId="{1DDE743B-EECF-44BF-804E-0A45F4916174}">
      <dgm:prSet/>
      <dgm:spPr/>
      <dgm:t>
        <a:bodyPr/>
        <a:lstStyle/>
        <a:p>
          <a:endParaRPr lang="en-US"/>
        </a:p>
      </dgm:t>
    </dgm:pt>
    <dgm:pt modelId="{6BD7DCBB-D2C8-4F15-A97E-12C52C8798AC}" type="sibTrans" cxnId="{1DDE743B-EECF-44BF-804E-0A45F4916174}">
      <dgm:prSet/>
      <dgm:spPr/>
      <dgm:t>
        <a:bodyPr/>
        <a:lstStyle/>
        <a:p>
          <a:endParaRPr lang="en-US"/>
        </a:p>
      </dgm:t>
    </dgm:pt>
    <dgm:pt modelId="{C0AFE18C-8645-4352-935E-25CB71553E6D}">
      <dgm:prSet/>
      <dgm:spPr/>
      <dgm:t>
        <a:bodyPr/>
        <a:lstStyle/>
        <a:p>
          <a:r>
            <a:rPr lang="en-US" b="1" dirty="0"/>
            <a:t>M</a:t>
          </a:r>
          <a:r>
            <a:rPr lang="en-US" dirty="0"/>
            <a:t>edication review </a:t>
          </a:r>
        </a:p>
      </dgm:t>
    </dgm:pt>
    <dgm:pt modelId="{D70B6580-0CEA-455B-8DBF-D5D01D061EED}" type="parTrans" cxnId="{28B4157B-AF3C-47A4-9A87-9C83309EB1CF}">
      <dgm:prSet/>
      <dgm:spPr/>
      <dgm:t>
        <a:bodyPr/>
        <a:lstStyle/>
        <a:p>
          <a:endParaRPr lang="en-US"/>
        </a:p>
      </dgm:t>
    </dgm:pt>
    <dgm:pt modelId="{706F1DC1-3ABB-45A9-9F00-44CB6ADA6C22}" type="sibTrans" cxnId="{28B4157B-AF3C-47A4-9A87-9C83309EB1CF}">
      <dgm:prSet/>
      <dgm:spPr/>
      <dgm:t>
        <a:bodyPr/>
        <a:lstStyle/>
        <a:p>
          <a:endParaRPr lang="en-US"/>
        </a:p>
      </dgm:t>
    </dgm:pt>
    <dgm:pt modelId="{5136C4F7-C660-4081-88C0-0CE355692A01}">
      <dgm:prSet/>
      <dgm:spPr/>
      <dgm:t>
        <a:bodyPr/>
        <a:lstStyle/>
        <a:p>
          <a:r>
            <a:rPr lang="en-US" dirty="0"/>
            <a:t>Mindful prescribing</a:t>
          </a:r>
        </a:p>
      </dgm:t>
    </dgm:pt>
    <dgm:pt modelId="{DA541E9F-C344-4808-ACC1-1A85407DE997}" type="parTrans" cxnId="{7AE5FB48-AFB4-4A90-83AC-2D668C6D2409}">
      <dgm:prSet/>
      <dgm:spPr/>
      <dgm:t>
        <a:bodyPr/>
        <a:lstStyle/>
        <a:p>
          <a:endParaRPr lang="en-US"/>
        </a:p>
      </dgm:t>
    </dgm:pt>
    <dgm:pt modelId="{20237B4D-5749-4C8F-8E50-C7F78DD14C2E}" type="sibTrans" cxnId="{7AE5FB48-AFB4-4A90-83AC-2D668C6D2409}">
      <dgm:prSet/>
      <dgm:spPr/>
      <dgm:t>
        <a:bodyPr/>
        <a:lstStyle/>
        <a:p>
          <a:endParaRPr lang="en-US"/>
        </a:p>
      </dgm:t>
    </dgm:pt>
    <dgm:pt modelId="{F5043FAC-E8A4-4CFF-A1CA-F98D3632BB3B}">
      <dgm:prSet/>
      <dgm:spPr/>
      <dgm:t>
        <a:bodyPr/>
        <a:lstStyle/>
        <a:p>
          <a:r>
            <a:rPr lang="en-US" b="1" dirty="0"/>
            <a:t>M</a:t>
          </a:r>
          <a:r>
            <a:rPr lang="en-US" dirty="0"/>
            <a:t>obility </a:t>
          </a:r>
        </a:p>
      </dgm:t>
    </dgm:pt>
    <dgm:pt modelId="{D34F30E7-63C8-4AF1-B13A-C9C5C5146254}" type="parTrans" cxnId="{67A3DDBB-313F-4C4D-AAB1-36C0D6A5AA86}">
      <dgm:prSet/>
      <dgm:spPr/>
      <dgm:t>
        <a:bodyPr/>
        <a:lstStyle/>
        <a:p>
          <a:endParaRPr lang="en-US"/>
        </a:p>
      </dgm:t>
    </dgm:pt>
    <dgm:pt modelId="{20339FB1-C0C0-4FE0-AA41-ABD55BD45101}" type="sibTrans" cxnId="{67A3DDBB-313F-4C4D-AAB1-36C0D6A5AA86}">
      <dgm:prSet/>
      <dgm:spPr/>
      <dgm:t>
        <a:bodyPr/>
        <a:lstStyle/>
        <a:p>
          <a:endParaRPr lang="en-US"/>
        </a:p>
      </dgm:t>
    </dgm:pt>
    <dgm:pt modelId="{5DF24335-E18E-4DED-8DD1-EF31CFE659CE}">
      <dgm:prSet/>
      <dgm:spPr/>
      <dgm:t>
        <a:bodyPr/>
        <a:lstStyle/>
        <a:p>
          <a:r>
            <a:rPr lang="en-US" dirty="0"/>
            <a:t>Functional Assessment</a:t>
          </a:r>
        </a:p>
      </dgm:t>
    </dgm:pt>
    <dgm:pt modelId="{B789FCD8-8848-444F-871A-E3767A650175}" type="parTrans" cxnId="{5FE6EC76-3EA9-485A-B6A4-0CC69F8FBD06}">
      <dgm:prSet/>
      <dgm:spPr/>
      <dgm:t>
        <a:bodyPr/>
        <a:lstStyle/>
        <a:p>
          <a:endParaRPr lang="en-US"/>
        </a:p>
      </dgm:t>
    </dgm:pt>
    <dgm:pt modelId="{6558C6A3-8415-42E8-81B1-C135E77437EA}" type="sibTrans" cxnId="{5FE6EC76-3EA9-485A-B6A4-0CC69F8FBD06}">
      <dgm:prSet/>
      <dgm:spPr/>
      <dgm:t>
        <a:bodyPr/>
        <a:lstStyle/>
        <a:p>
          <a:endParaRPr lang="en-US"/>
        </a:p>
      </dgm:t>
    </dgm:pt>
    <dgm:pt modelId="{23C891E8-1EF5-4F84-A4DE-ED69C9CFDAED}">
      <dgm:prSet/>
      <dgm:spPr/>
      <dgm:t>
        <a:bodyPr/>
        <a:lstStyle/>
        <a:p>
          <a:r>
            <a:rPr lang="en-US" dirty="0"/>
            <a:t>Falls Risk Assessment</a:t>
          </a:r>
        </a:p>
      </dgm:t>
    </dgm:pt>
    <dgm:pt modelId="{AEFEC252-5015-44E2-B98F-D89F4982FF73}" type="parTrans" cxnId="{C4C975C3-19D1-4448-BCD7-978A3D8C402D}">
      <dgm:prSet/>
      <dgm:spPr/>
      <dgm:t>
        <a:bodyPr/>
        <a:lstStyle/>
        <a:p>
          <a:endParaRPr lang="en-US"/>
        </a:p>
      </dgm:t>
    </dgm:pt>
    <dgm:pt modelId="{C6A30BBC-6159-40FD-9CD1-410BDDEC3B5D}" type="sibTrans" cxnId="{C4C975C3-19D1-4448-BCD7-978A3D8C402D}">
      <dgm:prSet/>
      <dgm:spPr/>
      <dgm:t>
        <a:bodyPr/>
        <a:lstStyle/>
        <a:p>
          <a:endParaRPr lang="en-US"/>
        </a:p>
      </dgm:t>
    </dgm:pt>
    <dgm:pt modelId="{D3C3B93F-4C8D-4C37-AD78-B614A838FA01}">
      <dgm:prSet/>
      <dgm:spPr/>
      <dgm:t>
        <a:bodyPr/>
        <a:lstStyle/>
        <a:p>
          <a:r>
            <a:rPr lang="en-US" b="1" dirty="0"/>
            <a:t>M</a:t>
          </a:r>
          <a:r>
            <a:rPr lang="en-US" dirty="0"/>
            <a:t>atters Most</a:t>
          </a:r>
        </a:p>
      </dgm:t>
    </dgm:pt>
    <dgm:pt modelId="{82A10275-120B-4F9E-B195-2F0FB166C371}" type="parTrans" cxnId="{DC2A7D35-239A-4EC3-9256-AA0A70947624}">
      <dgm:prSet/>
      <dgm:spPr/>
      <dgm:t>
        <a:bodyPr/>
        <a:lstStyle/>
        <a:p>
          <a:endParaRPr lang="en-US"/>
        </a:p>
      </dgm:t>
    </dgm:pt>
    <dgm:pt modelId="{FB9D019F-CF11-4904-8E5F-DB7F9649FF91}" type="sibTrans" cxnId="{DC2A7D35-239A-4EC3-9256-AA0A70947624}">
      <dgm:prSet/>
      <dgm:spPr/>
      <dgm:t>
        <a:bodyPr/>
        <a:lstStyle/>
        <a:p>
          <a:endParaRPr lang="en-US"/>
        </a:p>
      </dgm:t>
    </dgm:pt>
    <dgm:pt modelId="{EB1CC63F-F277-41F3-8EA2-85C20610E50F}">
      <dgm:prSet phldr="0"/>
      <dgm:spPr/>
      <dgm:t>
        <a:bodyPr/>
        <a:lstStyle/>
        <a:p>
          <a:pPr rtl="0"/>
          <a:r>
            <a:rPr lang="en-US" dirty="0">
              <a:latin typeface="Calibri Light" panose="020F0302020204030204"/>
            </a:rPr>
            <a:t>Advance Care Planning</a:t>
          </a:r>
        </a:p>
      </dgm:t>
    </dgm:pt>
    <dgm:pt modelId="{04EEC747-0670-4587-9267-FE89192EE4BF}" type="parTrans" cxnId="{E0F87988-7A00-415C-8300-267009436520}">
      <dgm:prSet/>
      <dgm:spPr/>
    </dgm:pt>
    <dgm:pt modelId="{2CC96941-95D5-465A-8BDF-A215A74DC4F9}" type="sibTrans" cxnId="{E0F87988-7A00-415C-8300-267009436520}">
      <dgm:prSet/>
      <dgm:spPr/>
    </dgm:pt>
    <dgm:pt modelId="{A2150DE7-7B7D-4BFA-BDF3-120B6F52162E}" type="pres">
      <dgm:prSet presAssocID="{B22FE172-9650-4213-A126-4DAFF7D9264C}" presName="linear" presStyleCnt="0">
        <dgm:presLayoutVars>
          <dgm:animLvl val="lvl"/>
          <dgm:resizeHandles val="exact"/>
        </dgm:presLayoutVars>
      </dgm:prSet>
      <dgm:spPr/>
    </dgm:pt>
    <dgm:pt modelId="{EC181DF9-FAB8-4DE5-B5DA-2D2177BC5084}" type="pres">
      <dgm:prSet presAssocID="{6421CACD-D613-4BBD-9855-27C729F2B0A2}" presName="parentText" presStyleLbl="node1" presStyleIdx="0" presStyleCnt="4">
        <dgm:presLayoutVars>
          <dgm:chMax val="0"/>
          <dgm:bulletEnabled val="1"/>
        </dgm:presLayoutVars>
      </dgm:prSet>
      <dgm:spPr/>
    </dgm:pt>
    <dgm:pt modelId="{BE6D830B-DE30-46EB-B08F-42BCD7901A27}" type="pres">
      <dgm:prSet presAssocID="{6421CACD-D613-4BBD-9855-27C729F2B0A2}" presName="childText" presStyleLbl="revTx" presStyleIdx="0" presStyleCnt="4">
        <dgm:presLayoutVars>
          <dgm:bulletEnabled val="1"/>
        </dgm:presLayoutVars>
      </dgm:prSet>
      <dgm:spPr/>
    </dgm:pt>
    <dgm:pt modelId="{57EDF7AA-05BB-41D3-BCCF-AB3FCECE4D24}" type="pres">
      <dgm:prSet presAssocID="{C0AFE18C-8645-4352-935E-25CB71553E6D}" presName="parentText" presStyleLbl="node1" presStyleIdx="1" presStyleCnt="4">
        <dgm:presLayoutVars>
          <dgm:chMax val="0"/>
          <dgm:bulletEnabled val="1"/>
        </dgm:presLayoutVars>
      </dgm:prSet>
      <dgm:spPr/>
    </dgm:pt>
    <dgm:pt modelId="{BEF668EE-6D79-45B1-B632-90B0A010430A}" type="pres">
      <dgm:prSet presAssocID="{C0AFE18C-8645-4352-935E-25CB71553E6D}" presName="childText" presStyleLbl="revTx" presStyleIdx="1" presStyleCnt="4">
        <dgm:presLayoutVars>
          <dgm:bulletEnabled val="1"/>
        </dgm:presLayoutVars>
      </dgm:prSet>
      <dgm:spPr/>
    </dgm:pt>
    <dgm:pt modelId="{AB5C436F-B83D-46E6-88A7-9A421EB8D305}" type="pres">
      <dgm:prSet presAssocID="{F5043FAC-E8A4-4CFF-A1CA-F98D3632BB3B}" presName="parentText" presStyleLbl="node1" presStyleIdx="2" presStyleCnt="4">
        <dgm:presLayoutVars>
          <dgm:chMax val="0"/>
          <dgm:bulletEnabled val="1"/>
        </dgm:presLayoutVars>
      </dgm:prSet>
      <dgm:spPr/>
    </dgm:pt>
    <dgm:pt modelId="{AE7994C9-782F-49CA-A8D4-40163FE1C350}" type="pres">
      <dgm:prSet presAssocID="{F5043FAC-E8A4-4CFF-A1CA-F98D3632BB3B}" presName="childText" presStyleLbl="revTx" presStyleIdx="2" presStyleCnt="4">
        <dgm:presLayoutVars>
          <dgm:bulletEnabled val="1"/>
        </dgm:presLayoutVars>
      </dgm:prSet>
      <dgm:spPr/>
    </dgm:pt>
    <dgm:pt modelId="{6E584825-4964-4151-9D6D-A8E5CEC423AC}" type="pres">
      <dgm:prSet presAssocID="{D3C3B93F-4C8D-4C37-AD78-B614A838FA01}" presName="parentText" presStyleLbl="node1" presStyleIdx="3" presStyleCnt="4">
        <dgm:presLayoutVars>
          <dgm:chMax val="0"/>
          <dgm:bulletEnabled val="1"/>
        </dgm:presLayoutVars>
      </dgm:prSet>
      <dgm:spPr/>
    </dgm:pt>
    <dgm:pt modelId="{E631D655-7AD4-4EB2-BD30-0DC26F7F8981}" type="pres">
      <dgm:prSet presAssocID="{D3C3B93F-4C8D-4C37-AD78-B614A838FA01}" presName="childText" presStyleLbl="revTx" presStyleIdx="3" presStyleCnt="4">
        <dgm:presLayoutVars>
          <dgm:bulletEnabled val="1"/>
        </dgm:presLayoutVars>
      </dgm:prSet>
      <dgm:spPr/>
    </dgm:pt>
  </dgm:ptLst>
  <dgm:cxnLst>
    <dgm:cxn modelId="{6ECDCC01-3E97-44FA-9665-49F9E36F5CDA}" type="presOf" srcId="{1715B2B6-F513-492E-95B1-9381C99795CF}" destId="{BE6D830B-DE30-46EB-B08F-42BCD7901A27}" srcOrd="0" destOrd="0" presId="urn:microsoft.com/office/officeart/2005/8/layout/vList2"/>
    <dgm:cxn modelId="{31FA061A-0CB5-4708-8038-CE8A5B09A799}" type="presOf" srcId="{77198C55-A7DF-4788-9380-EE1BEEF9E66E}" destId="{BE6D830B-DE30-46EB-B08F-42BCD7901A27}" srcOrd="0" destOrd="1" presId="urn:microsoft.com/office/officeart/2005/8/layout/vList2"/>
    <dgm:cxn modelId="{DC2A7D35-239A-4EC3-9256-AA0A70947624}" srcId="{B22FE172-9650-4213-A126-4DAFF7D9264C}" destId="{D3C3B93F-4C8D-4C37-AD78-B614A838FA01}" srcOrd="3" destOrd="0" parTransId="{82A10275-120B-4F9E-B195-2F0FB166C371}" sibTransId="{FB9D019F-CF11-4904-8E5F-DB7F9649FF91}"/>
    <dgm:cxn modelId="{EC68383A-4D4C-4AF9-8D96-7E7B5EDB5996}" type="presOf" srcId="{D3C3B93F-4C8D-4C37-AD78-B614A838FA01}" destId="{6E584825-4964-4151-9D6D-A8E5CEC423AC}" srcOrd="0" destOrd="0" presId="urn:microsoft.com/office/officeart/2005/8/layout/vList2"/>
    <dgm:cxn modelId="{B9CB613B-5A5F-42DA-887C-AA53B696EB86}" type="presOf" srcId="{EB1CC63F-F277-41F3-8EA2-85C20610E50F}" destId="{E631D655-7AD4-4EB2-BD30-0DC26F7F8981}" srcOrd="0" destOrd="0" presId="urn:microsoft.com/office/officeart/2005/8/layout/vList2"/>
    <dgm:cxn modelId="{1DDE743B-EECF-44BF-804E-0A45F4916174}" srcId="{6421CACD-D613-4BBD-9855-27C729F2B0A2}" destId="{77198C55-A7DF-4788-9380-EE1BEEF9E66E}" srcOrd="1" destOrd="0" parTransId="{BEF28244-A62A-4DD9-80D7-AFDC0D41DF4F}" sibTransId="{6BD7DCBB-D2C8-4F15-A97E-12C52C8798AC}"/>
    <dgm:cxn modelId="{7AE5FB48-AFB4-4A90-83AC-2D668C6D2409}" srcId="{C0AFE18C-8645-4352-935E-25CB71553E6D}" destId="{5136C4F7-C660-4081-88C0-0CE355692A01}" srcOrd="0" destOrd="0" parTransId="{DA541E9F-C344-4808-ACC1-1A85407DE997}" sibTransId="{20237B4D-5749-4C8F-8E50-C7F78DD14C2E}"/>
    <dgm:cxn modelId="{5FE6EC76-3EA9-485A-B6A4-0CC69F8FBD06}" srcId="{F5043FAC-E8A4-4CFF-A1CA-F98D3632BB3B}" destId="{5DF24335-E18E-4DED-8DD1-EF31CFE659CE}" srcOrd="0" destOrd="0" parTransId="{B789FCD8-8848-444F-871A-E3767A650175}" sibTransId="{6558C6A3-8415-42E8-81B1-C135E77437EA}"/>
    <dgm:cxn modelId="{28B4157B-AF3C-47A4-9A87-9C83309EB1CF}" srcId="{B22FE172-9650-4213-A126-4DAFF7D9264C}" destId="{C0AFE18C-8645-4352-935E-25CB71553E6D}" srcOrd="1" destOrd="0" parTransId="{D70B6580-0CEA-455B-8DBF-D5D01D061EED}" sibTransId="{706F1DC1-3ABB-45A9-9F00-44CB6ADA6C22}"/>
    <dgm:cxn modelId="{E0F87988-7A00-415C-8300-267009436520}" srcId="{D3C3B93F-4C8D-4C37-AD78-B614A838FA01}" destId="{EB1CC63F-F277-41F3-8EA2-85C20610E50F}" srcOrd="0" destOrd="0" parTransId="{04EEC747-0670-4587-9267-FE89192EE4BF}" sibTransId="{2CC96941-95D5-465A-8BDF-A215A74DC4F9}"/>
    <dgm:cxn modelId="{31F2B58D-CEC0-41B6-BAC9-1D25ABFC0D43}" type="presOf" srcId="{F5043FAC-E8A4-4CFF-A1CA-F98D3632BB3B}" destId="{AB5C436F-B83D-46E6-88A7-9A421EB8D305}" srcOrd="0" destOrd="0" presId="urn:microsoft.com/office/officeart/2005/8/layout/vList2"/>
    <dgm:cxn modelId="{7E032193-9914-46F0-9075-81997EA24F90}" type="presOf" srcId="{5136C4F7-C660-4081-88C0-0CE355692A01}" destId="{BEF668EE-6D79-45B1-B632-90B0A010430A}" srcOrd="0" destOrd="0" presId="urn:microsoft.com/office/officeart/2005/8/layout/vList2"/>
    <dgm:cxn modelId="{14AC6CB0-1986-4391-B40C-B2F995B5113F}" type="presOf" srcId="{5DF24335-E18E-4DED-8DD1-EF31CFE659CE}" destId="{AE7994C9-782F-49CA-A8D4-40163FE1C350}" srcOrd="0" destOrd="0" presId="urn:microsoft.com/office/officeart/2005/8/layout/vList2"/>
    <dgm:cxn modelId="{67A3DDBB-313F-4C4D-AAB1-36C0D6A5AA86}" srcId="{B22FE172-9650-4213-A126-4DAFF7D9264C}" destId="{F5043FAC-E8A4-4CFF-A1CA-F98D3632BB3B}" srcOrd="2" destOrd="0" parTransId="{D34F30E7-63C8-4AF1-B13A-C9C5C5146254}" sibTransId="{20339FB1-C0C0-4FE0-AA41-ABD55BD45101}"/>
    <dgm:cxn modelId="{C4C975C3-19D1-4448-BCD7-978A3D8C402D}" srcId="{F5043FAC-E8A4-4CFF-A1CA-F98D3632BB3B}" destId="{23C891E8-1EF5-4F84-A4DE-ED69C9CFDAED}" srcOrd="1" destOrd="0" parTransId="{AEFEC252-5015-44E2-B98F-D89F4982FF73}" sibTransId="{C6A30BBC-6159-40FD-9CD1-410BDDEC3B5D}"/>
    <dgm:cxn modelId="{E19396C3-C11D-4F80-8356-5569E5795D31}" type="presOf" srcId="{C0AFE18C-8645-4352-935E-25CB71553E6D}" destId="{57EDF7AA-05BB-41D3-BCCF-AB3FCECE4D24}" srcOrd="0" destOrd="0" presId="urn:microsoft.com/office/officeart/2005/8/layout/vList2"/>
    <dgm:cxn modelId="{263FB7C6-4367-4C88-BAD6-2780D8F541C5}" type="presOf" srcId="{23C891E8-1EF5-4F84-A4DE-ED69C9CFDAED}" destId="{AE7994C9-782F-49CA-A8D4-40163FE1C350}" srcOrd="0" destOrd="1" presId="urn:microsoft.com/office/officeart/2005/8/layout/vList2"/>
    <dgm:cxn modelId="{2F7858C9-9584-4137-8757-B8AF2038DB14}" srcId="{6421CACD-D613-4BBD-9855-27C729F2B0A2}" destId="{1715B2B6-F513-492E-95B1-9381C99795CF}" srcOrd="0" destOrd="0" parTransId="{DA994818-D7D7-402E-9F20-DF63A2BD2551}" sibTransId="{0F9C46BF-DEB0-459E-A201-4F7C5258FB32}"/>
    <dgm:cxn modelId="{D77F60D3-C7FE-4D47-8308-19B51E6CB659}" type="presOf" srcId="{B22FE172-9650-4213-A126-4DAFF7D9264C}" destId="{A2150DE7-7B7D-4BFA-BDF3-120B6F52162E}" srcOrd="0" destOrd="0" presId="urn:microsoft.com/office/officeart/2005/8/layout/vList2"/>
    <dgm:cxn modelId="{EDAB61ED-F0E8-4489-B467-D04D1ACCF0D0}" type="presOf" srcId="{6421CACD-D613-4BBD-9855-27C729F2B0A2}" destId="{EC181DF9-FAB8-4DE5-B5DA-2D2177BC5084}" srcOrd="0" destOrd="0" presId="urn:microsoft.com/office/officeart/2005/8/layout/vList2"/>
    <dgm:cxn modelId="{C59C55F4-B4BB-4805-9665-56063F4AA872}" srcId="{B22FE172-9650-4213-A126-4DAFF7D9264C}" destId="{6421CACD-D613-4BBD-9855-27C729F2B0A2}" srcOrd="0" destOrd="0" parTransId="{6470A128-DE56-4228-B9C7-21CC2626D27E}" sibTransId="{37842568-C138-43D5-8EDB-350564CB37A3}"/>
    <dgm:cxn modelId="{0EA30C86-56EB-4FF6-9B31-FD393DF94373}" type="presParOf" srcId="{A2150DE7-7B7D-4BFA-BDF3-120B6F52162E}" destId="{EC181DF9-FAB8-4DE5-B5DA-2D2177BC5084}" srcOrd="0" destOrd="0" presId="urn:microsoft.com/office/officeart/2005/8/layout/vList2"/>
    <dgm:cxn modelId="{318167D3-49B9-4D9A-9385-14BBF1EB3FF8}" type="presParOf" srcId="{A2150DE7-7B7D-4BFA-BDF3-120B6F52162E}" destId="{BE6D830B-DE30-46EB-B08F-42BCD7901A27}" srcOrd="1" destOrd="0" presId="urn:microsoft.com/office/officeart/2005/8/layout/vList2"/>
    <dgm:cxn modelId="{5F256A69-5E78-4B13-B522-B0DB721F9BD0}" type="presParOf" srcId="{A2150DE7-7B7D-4BFA-BDF3-120B6F52162E}" destId="{57EDF7AA-05BB-41D3-BCCF-AB3FCECE4D24}" srcOrd="2" destOrd="0" presId="urn:microsoft.com/office/officeart/2005/8/layout/vList2"/>
    <dgm:cxn modelId="{641C1B8C-79B8-44BD-8659-3E54CF31BD36}" type="presParOf" srcId="{A2150DE7-7B7D-4BFA-BDF3-120B6F52162E}" destId="{BEF668EE-6D79-45B1-B632-90B0A010430A}" srcOrd="3" destOrd="0" presId="urn:microsoft.com/office/officeart/2005/8/layout/vList2"/>
    <dgm:cxn modelId="{933C0569-96DB-4DC6-A81B-72B88A6B5DAA}" type="presParOf" srcId="{A2150DE7-7B7D-4BFA-BDF3-120B6F52162E}" destId="{AB5C436F-B83D-46E6-88A7-9A421EB8D305}" srcOrd="4" destOrd="0" presId="urn:microsoft.com/office/officeart/2005/8/layout/vList2"/>
    <dgm:cxn modelId="{14FEDA98-EE09-40A3-A84B-3FA5FAE4D332}" type="presParOf" srcId="{A2150DE7-7B7D-4BFA-BDF3-120B6F52162E}" destId="{AE7994C9-782F-49CA-A8D4-40163FE1C350}" srcOrd="5" destOrd="0" presId="urn:microsoft.com/office/officeart/2005/8/layout/vList2"/>
    <dgm:cxn modelId="{63F065B4-C919-4D14-B1BE-357318C24327}" type="presParOf" srcId="{A2150DE7-7B7D-4BFA-BDF3-120B6F52162E}" destId="{6E584825-4964-4151-9D6D-A8E5CEC423AC}" srcOrd="6" destOrd="0" presId="urn:microsoft.com/office/officeart/2005/8/layout/vList2"/>
    <dgm:cxn modelId="{7D691A8A-EC14-4AC7-AB06-3AB5FF2FEC56}" type="presParOf" srcId="{A2150DE7-7B7D-4BFA-BDF3-120B6F52162E}" destId="{E631D655-7AD4-4EB2-BD30-0DC26F7F8981}" srcOrd="7" destOrd="0" presId="urn:microsoft.com/office/officeart/2005/8/layout/vList2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63E578B1-CA20-412B-BA29-3D5EECC1794F}">
      <dsp:nvSpPr>
        <dsp:cNvPr id="0" name=""/>
        <dsp:cNvSpPr/>
      </dsp:nvSpPr>
      <dsp:spPr>
        <a:xfrm>
          <a:off x="0" y="476341"/>
          <a:ext cx="8303625" cy="2419200"/>
        </a:xfrm>
        <a:prstGeom prst="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4454" tIns="499872" rIns="644454" bIns="170688" numCol="1" spcCol="1270" anchor="t" anchorCtr="0">
          <a:noAutofit/>
        </a:bodyPr>
        <a:lstStyle/>
        <a:p>
          <a:pPr marL="228600" lvl="1" indent="-228600" algn="l" defTabSz="1066800" rtl="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400" b="0" u="none" kern="1200" dirty="0">
              <a:latin typeface="Calibri Light" panose="020F0302020204030204"/>
            </a:rPr>
            <a:t>Gain</a:t>
          </a:r>
          <a:r>
            <a:rPr lang="en-US" sz="2400" b="0" u="none" kern="1200" dirty="0"/>
            <a:t> the comfort, knowledge</a:t>
          </a:r>
          <a:r>
            <a:rPr lang="en-US" sz="2400" b="0" u="none" kern="1200"/>
            <a:t>, </a:t>
          </a:r>
          <a:r>
            <a:rPr lang="en-US" sz="2400" b="0" u="none" kern="1200">
              <a:latin typeface="Calibri Light" panose="020F0302020204030204"/>
            </a:rPr>
            <a:t>and </a:t>
          </a:r>
          <a:r>
            <a:rPr lang="en-US" sz="2400" b="0" u="none" kern="1200" dirty="0">
              <a:latin typeface="Calibri Light" panose="020F0302020204030204"/>
            </a:rPr>
            <a:t>skills</a:t>
          </a:r>
          <a:r>
            <a:rPr lang="en-US" sz="2400" b="0" u="none" kern="1200" dirty="0"/>
            <a:t> necessary for conducting </a:t>
          </a:r>
          <a:r>
            <a:rPr lang="en-US" sz="2400" b="0" u="none" kern="1200" dirty="0">
              <a:latin typeface="Calibri Light" panose="020F0302020204030204"/>
            </a:rPr>
            <a:t>a</a:t>
          </a:r>
          <a:r>
            <a:rPr lang="en-US" sz="2400" b="0" u="none" kern="1200" dirty="0"/>
            <a:t> geriatric assessment</a:t>
          </a:r>
        </a:p>
        <a:p>
          <a:pPr marL="228600" lvl="1" indent="-228600" algn="l" defTabSz="1066800" rtl="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400" b="0" u="none" kern="1200" dirty="0">
              <a:latin typeface="Calibri Light" panose="020F0302020204030204"/>
            </a:rPr>
            <a:t>Apply</a:t>
          </a:r>
          <a:r>
            <a:rPr lang="en-US" sz="2400" b="0" u="none" kern="1200" dirty="0"/>
            <a:t> the 4Ms</a:t>
          </a:r>
          <a:r>
            <a:rPr lang="en-US" sz="2400" b="0" u="none" kern="1200" dirty="0">
              <a:latin typeface="Calibri Light" panose="020F0302020204030204"/>
            </a:rPr>
            <a:t> framework</a:t>
          </a:r>
          <a:r>
            <a:rPr lang="en-US" sz="2400" b="0" u="none" kern="1200" dirty="0"/>
            <a:t> </a:t>
          </a:r>
          <a:r>
            <a:rPr lang="en-US" sz="2400" b="0" u="none" kern="1200" dirty="0">
              <a:latin typeface="Calibri Light" panose="020F0302020204030204"/>
            </a:rPr>
            <a:t>to complete</a:t>
          </a:r>
          <a:r>
            <a:rPr lang="en-US" sz="2400" b="0" u="none" kern="1200" dirty="0"/>
            <a:t> a Geriatric Assessment during a clinical encounter with an older adult</a:t>
          </a:r>
        </a:p>
      </dsp:txBody>
      <dsp:txXfrm>
        <a:off x="0" y="476341"/>
        <a:ext cx="8303625" cy="2419200"/>
      </dsp:txXfrm>
    </dsp:sp>
    <dsp:sp modelId="{CCA8E483-EF29-487C-934F-FE40AC870AFB}">
      <dsp:nvSpPr>
        <dsp:cNvPr id="0" name=""/>
        <dsp:cNvSpPr/>
      </dsp:nvSpPr>
      <dsp:spPr>
        <a:xfrm>
          <a:off x="415181" y="122101"/>
          <a:ext cx="5812537" cy="708480"/>
        </a:xfrm>
        <a:prstGeom prst="round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19700" tIns="0" rIns="219700" bIns="0" numCol="1" spcCol="1270" anchor="ctr" anchorCtr="0">
          <a:noAutofit/>
        </a:bodyPr>
        <a:lstStyle/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400" b="1" u="sng" kern="1200" dirty="0"/>
            <a:t>Goals:</a:t>
          </a:r>
          <a:r>
            <a:rPr lang="en-US" sz="2400" b="1" kern="1200" dirty="0"/>
            <a:t>​</a:t>
          </a:r>
        </a:p>
      </dsp:txBody>
      <dsp:txXfrm>
        <a:off x="449766" y="156686"/>
        <a:ext cx="5743367" cy="639310"/>
      </dsp:txXfrm>
    </dsp:sp>
    <dsp:sp modelId="{6D6B8878-16C9-4FD6-BA2B-AB8493B513D4}">
      <dsp:nvSpPr>
        <dsp:cNvPr id="0" name=""/>
        <dsp:cNvSpPr/>
      </dsp:nvSpPr>
      <dsp:spPr>
        <a:xfrm>
          <a:off x="0" y="3379381"/>
          <a:ext cx="8303625" cy="2797200"/>
        </a:xfrm>
        <a:prstGeom prst="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4454" tIns="499872" rIns="644454" bIns="170688" numCol="1" spcCol="1270" anchor="t" anchorCtr="0">
          <a:noAutofit/>
        </a:bodyPr>
        <a:lstStyle/>
        <a:p>
          <a:pPr marL="228600" lvl="1" indent="-228600" algn="l" defTabSz="1066800" rtl="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400" kern="1200" dirty="0">
              <a:latin typeface="Calibri Light" panose="020F0302020204030204"/>
            </a:rPr>
            <a:t> </a:t>
          </a:r>
          <a:r>
            <a:rPr lang="en-US" sz="2400" kern="1200" dirty="0"/>
            <a:t>Describe the importance of the geriatric assessment in the care of older adults.</a:t>
          </a:r>
        </a:p>
        <a:p>
          <a:pPr marL="228600" lvl="1" indent="-228600" algn="l" defTabSz="1066800" rtl="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400" kern="1200" dirty="0">
              <a:latin typeface="Calibri Light" panose="020F0302020204030204"/>
            </a:rPr>
            <a:t> </a:t>
          </a:r>
          <a:r>
            <a:rPr lang="en-US" sz="2400" kern="1200" dirty="0"/>
            <a:t>Describe how to conduct a geriatric assessment using the </a:t>
          </a:r>
          <a:r>
            <a:rPr lang="en-US" sz="2400" kern="1200" dirty="0">
              <a:latin typeface="Calibri Light" panose="020F0302020204030204"/>
            </a:rPr>
            <a:t>4Ms Framework:</a:t>
          </a:r>
          <a:r>
            <a:rPr lang="en-US" sz="2400" kern="1200" dirty="0"/>
            <a:t> Mind/Memory, Medications, Mobility, Matters Most.</a:t>
          </a:r>
        </a:p>
        <a:p>
          <a:pPr marL="228600" lvl="1" indent="-228600" algn="l" defTabSz="1066800" rtl="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400" kern="1200" dirty="0">
              <a:latin typeface="Calibri Light" panose="020F0302020204030204"/>
            </a:rPr>
            <a:t> </a:t>
          </a:r>
          <a:r>
            <a:rPr lang="en-US" sz="2400" kern="1200" dirty="0"/>
            <a:t>Apply the skills learned to patient scenarios.</a:t>
          </a:r>
        </a:p>
      </dsp:txBody>
      <dsp:txXfrm>
        <a:off x="0" y="3379381"/>
        <a:ext cx="8303625" cy="2797200"/>
      </dsp:txXfrm>
    </dsp:sp>
    <dsp:sp modelId="{87B9EDF3-1CC9-4217-8C60-8FD36C210050}">
      <dsp:nvSpPr>
        <dsp:cNvPr id="0" name=""/>
        <dsp:cNvSpPr/>
      </dsp:nvSpPr>
      <dsp:spPr>
        <a:xfrm>
          <a:off x="415181" y="3025141"/>
          <a:ext cx="5812537" cy="708480"/>
        </a:xfrm>
        <a:prstGeom prst="round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19700" tIns="0" rIns="219700" bIns="0" numCol="1" spcCol="1270" anchor="ctr" anchorCtr="0">
          <a:noAutofit/>
        </a:bodyPr>
        <a:lstStyle/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400" b="1" u="sng" kern="1200" dirty="0"/>
            <a:t>Learning Objectives:</a:t>
          </a:r>
          <a:r>
            <a:rPr lang="en-US" sz="2400" b="1" kern="1200" dirty="0"/>
            <a:t>​</a:t>
          </a:r>
        </a:p>
      </dsp:txBody>
      <dsp:txXfrm>
        <a:off x="449766" y="3059726"/>
        <a:ext cx="5743367" cy="639310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97CEB4D-FFBD-472D-A5D0-C8D6563C94FC}">
      <dsp:nvSpPr>
        <dsp:cNvPr id="0" name=""/>
        <dsp:cNvSpPr/>
      </dsp:nvSpPr>
      <dsp:spPr>
        <a:xfrm>
          <a:off x="0" y="472887"/>
          <a:ext cx="4697730" cy="1483157"/>
        </a:xfrm>
        <a:prstGeom prst="roundRect">
          <a:avLst/>
        </a:prstGeom>
        <a:solidFill>
          <a:schemeClr val="accent5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2390" tIns="72390" rIns="72390" bIns="72390" numCol="1" spcCol="1270" anchor="ctr" anchorCtr="0">
          <a:noAutofit/>
        </a:bodyPr>
        <a:lstStyle/>
        <a:p>
          <a:pPr marL="0" lvl="0" indent="0" algn="l" defTabSz="8445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900" kern="1200" dirty="0"/>
            <a:t>Use memory and mood screening assessment tools as part of your geriatric assessment visit to evaluate for cognitive decline or depression.</a:t>
          </a:r>
        </a:p>
      </dsp:txBody>
      <dsp:txXfrm>
        <a:off x="72402" y="545289"/>
        <a:ext cx="4552926" cy="1338353"/>
      </dsp:txXfrm>
    </dsp:sp>
    <dsp:sp modelId="{3A02DBF4-80B1-497D-8F5C-25337D53CF3F}">
      <dsp:nvSpPr>
        <dsp:cNvPr id="0" name=""/>
        <dsp:cNvSpPr/>
      </dsp:nvSpPr>
      <dsp:spPr>
        <a:xfrm>
          <a:off x="0" y="2010765"/>
          <a:ext cx="4697730" cy="1483157"/>
        </a:xfrm>
        <a:prstGeom prst="roundRect">
          <a:avLst/>
        </a:prstGeom>
        <a:solidFill>
          <a:schemeClr val="accent5">
            <a:hueOff val="-3379271"/>
            <a:satOff val="-8710"/>
            <a:lumOff val="-5883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2390" tIns="72390" rIns="72390" bIns="72390" numCol="1" spcCol="1270" anchor="ctr" anchorCtr="0">
          <a:noAutofit/>
        </a:bodyPr>
        <a:lstStyle/>
        <a:p>
          <a:pPr marL="0" lvl="0" indent="0" algn="l" defTabSz="844550" rtl="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900" kern="1200" dirty="0"/>
            <a:t>Hospitalized patients are at risk for delirium</a:t>
          </a:r>
        </a:p>
        <a:p>
          <a:pPr marL="0" lvl="0" indent="0" algn="l" defTabSz="844550" rtl="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900" kern="1200" dirty="0"/>
            <a:t>- The Confusion Assessment Method (CAM) is a standardized evidence-based tool </a:t>
          </a:r>
          <a:r>
            <a:rPr lang="en-US" sz="1900" kern="1200" dirty="0">
              <a:latin typeface="Calibri Light" panose="020F0302020204030204"/>
            </a:rPr>
            <a:t>used</a:t>
          </a:r>
          <a:r>
            <a:rPr lang="en-US" sz="1900" kern="1200" dirty="0"/>
            <a:t> to </a:t>
          </a:r>
          <a:r>
            <a:rPr lang="en-US" sz="1900" kern="1200" dirty="0">
              <a:latin typeface="Calibri Light" panose="020F0302020204030204"/>
            </a:rPr>
            <a:t>screen for</a:t>
          </a:r>
          <a:r>
            <a:rPr lang="en-US" sz="1900" kern="1200" dirty="0"/>
            <a:t> delirium. </a:t>
          </a:r>
        </a:p>
      </dsp:txBody>
      <dsp:txXfrm>
        <a:off x="72402" y="2083167"/>
        <a:ext cx="4552926" cy="1338353"/>
      </dsp:txXfrm>
    </dsp:sp>
    <dsp:sp modelId="{FC647B1D-8D91-46AB-8508-FC7F5C934004}">
      <dsp:nvSpPr>
        <dsp:cNvPr id="0" name=""/>
        <dsp:cNvSpPr/>
      </dsp:nvSpPr>
      <dsp:spPr>
        <a:xfrm>
          <a:off x="0" y="3548642"/>
          <a:ext cx="4697730" cy="1483157"/>
        </a:xfrm>
        <a:prstGeom prst="roundRect">
          <a:avLst/>
        </a:prstGeom>
        <a:solidFill>
          <a:schemeClr val="accent5">
            <a:hueOff val="-6758543"/>
            <a:satOff val="-17419"/>
            <a:lumOff val="-11765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2390" tIns="72390" rIns="72390" bIns="72390" numCol="1" spcCol="1270" anchor="ctr" anchorCtr="0">
          <a:noAutofit/>
        </a:bodyPr>
        <a:lstStyle/>
        <a:p>
          <a:pPr marL="0" lvl="0" indent="0" algn="l" defTabSz="8445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900" kern="1200" dirty="0"/>
            <a:t>Screening tools can be used to monitor treatment response or progression of disease. </a:t>
          </a:r>
        </a:p>
      </dsp:txBody>
      <dsp:txXfrm>
        <a:off x="72402" y="3621044"/>
        <a:ext cx="4552926" cy="1338353"/>
      </dsp:txXfrm>
    </dsp:sp>
  </dsp:spTree>
</dsp:drawing>
</file>

<file path=ppt/diagrams/drawing3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10AF9E04-2DAF-4B5E-8AA5-8F549E2A4F3D}">
      <dsp:nvSpPr>
        <dsp:cNvPr id="0" name=""/>
        <dsp:cNvSpPr/>
      </dsp:nvSpPr>
      <dsp:spPr>
        <a:xfrm>
          <a:off x="0" y="192476"/>
          <a:ext cx="8168317" cy="914940"/>
        </a:xfrm>
        <a:prstGeom prst="round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7630" tIns="87630" rIns="87630" bIns="87630" numCol="1" spcCol="1270" anchor="ctr" anchorCtr="0">
          <a:noAutofit/>
        </a:bodyPr>
        <a:lstStyle/>
        <a:p>
          <a:pPr marL="0" lvl="0" indent="0" algn="l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300" b="1" kern="1200" dirty="0"/>
            <a:t>Changes to medications</a:t>
          </a:r>
          <a:r>
            <a:rPr lang="en-US" sz="2300" kern="1200" dirty="0"/>
            <a:t> occur during hospitalizations and other medical visits – medications </a:t>
          </a:r>
          <a:r>
            <a:rPr lang="en-US" sz="2300" b="1" kern="1200" dirty="0"/>
            <a:t>must be reviewed at each visit</a:t>
          </a:r>
          <a:endParaRPr lang="en-US" sz="2300" kern="1200" dirty="0"/>
        </a:p>
      </dsp:txBody>
      <dsp:txXfrm>
        <a:off x="44664" y="237140"/>
        <a:ext cx="8078989" cy="825612"/>
      </dsp:txXfrm>
    </dsp:sp>
    <dsp:sp modelId="{AC0877B4-858A-4ADF-985C-59355A165343}">
      <dsp:nvSpPr>
        <dsp:cNvPr id="0" name=""/>
        <dsp:cNvSpPr/>
      </dsp:nvSpPr>
      <dsp:spPr>
        <a:xfrm>
          <a:off x="0" y="1173656"/>
          <a:ext cx="8168317" cy="914940"/>
        </a:xfrm>
        <a:prstGeom prst="round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7630" tIns="87630" rIns="87630" bIns="87630" numCol="1" spcCol="1270" anchor="ctr" anchorCtr="0">
          <a:noAutofit/>
        </a:bodyPr>
        <a:lstStyle/>
        <a:p>
          <a:pPr marL="0" lvl="0" indent="0" algn="l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300" kern="1200" dirty="0"/>
            <a:t>Having actual medication bottles at visit may provide insight into patient adherence</a:t>
          </a:r>
        </a:p>
      </dsp:txBody>
      <dsp:txXfrm>
        <a:off x="44664" y="1218320"/>
        <a:ext cx="8078989" cy="825612"/>
      </dsp:txXfrm>
    </dsp:sp>
    <dsp:sp modelId="{CF9B7A5F-7E82-4680-AEB9-72B3EC3C2534}">
      <dsp:nvSpPr>
        <dsp:cNvPr id="0" name=""/>
        <dsp:cNvSpPr/>
      </dsp:nvSpPr>
      <dsp:spPr>
        <a:xfrm>
          <a:off x="0" y="2154836"/>
          <a:ext cx="8168317" cy="914940"/>
        </a:xfrm>
        <a:prstGeom prst="round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7630" tIns="87630" rIns="87630" bIns="87630" numCol="1" spcCol="1270" anchor="ctr" anchorCtr="0">
          <a:noAutofit/>
        </a:bodyPr>
        <a:lstStyle/>
        <a:p>
          <a:pPr marL="0" lvl="0" indent="0" algn="l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300" kern="1200" dirty="0"/>
            <a:t>Aspects to consider regarding medications:</a:t>
          </a:r>
        </a:p>
      </dsp:txBody>
      <dsp:txXfrm>
        <a:off x="44664" y="2199500"/>
        <a:ext cx="8078989" cy="825612"/>
      </dsp:txXfrm>
    </dsp:sp>
    <dsp:sp modelId="{C760E194-0288-4519-B5A3-B23A401B8504}">
      <dsp:nvSpPr>
        <dsp:cNvPr id="0" name=""/>
        <dsp:cNvSpPr/>
      </dsp:nvSpPr>
      <dsp:spPr>
        <a:xfrm>
          <a:off x="0" y="3069776"/>
          <a:ext cx="8168317" cy="1237860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59344" tIns="29210" rIns="163576" bIns="29210" numCol="1" spcCol="1270" anchor="t" anchorCtr="0">
          <a:noAutofit/>
        </a:bodyPr>
        <a:lstStyle/>
        <a:p>
          <a:pPr marL="171450" lvl="1" indent="-171450" algn="l" defTabSz="80010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1800" kern="1200"/>
            <a:t>Beers Criteria</a:t>
          </a:r>
        </a:p>
        <a:p>
          <a:pPr marL="171450" lvl="1" indent="-171450" algn="l" defTabSz="80010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1800" kern="1200"/>
            <a:t>Polypharmacy </a:t>
          </a:r>
        </a:p>
        <a:p>
          <a:pPr marL="171450" lvl="1" indent="-171450" algn="l" defTabSz="80010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1800" kern="1200"/>
            <a:t>Adverse reactions caused by individual medications/drug-drug interactions</a:t>
          </a:r>
        </a:p>
        <a:p>
          <a:pPr marL="171450" lvl="1" indent="-171450" algn="l" defTabSz="80010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1800" kern="1200"/>
            <a:t>Changes in pharmacokinetics as we age</a:t>
          </a:r>
        </a:p>
      </dsp:txBody>
      <dsp:txXfrm>
        <a:off x="0" y="3069776"/>
        <a:ext cx="8168317" cy="1237860"/>
      </dsp:txXfrm>
    </dsp:sp>
  </dsp:spTree>
</dsp:drawing>
</file>

<file path=ppt/diagrams/drawing4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436932E2-3971-46F3-B630-7D4526867AE9}">
      <dsp:nvSpPr>
        <dsp:cNvPr id="0" name=""/>
        <dsp:cNvSpPr/>
      </dsp:nvSpPr>
      <dsp:spPr>
        <a:xfrm>
          <a:off x="0" y="3322370"/>
          <a:ext cx="4697730" cy="2179834"/>
        </a:xfrm>
        <a:prstGeom prst="rect">
          <a:avLst/>
        </a:prstGeom>
        <a:solidFill>
          <a:schemeClr val="accent2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70688" tIns="170688" rIns="170688" bIns="170688" numCol="1" spcCol="1270" anchor="ctr" anchorCtr="0">
          <a:noAutofit/>
        </a:bodyPr>
        <a:lstStyle/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400" kern="1200" dirty="0"/>
            <a:t>Most important consideration is history of previous fall</a:t>
          </a:r>
        </a:p>
      </dsp:txBody>
      <dsp:txXfrm>
        <a:off x="0" y="3322370"/>
        <a:ext cx="4697730" cy="2179834"/>
      </dsp:txXfrm>
    </dsp:sp>
    <dsp:sp modelId="{69993709-72A8-4D97-B316-4713817BB2CE}">
      <dsp:nvSpPr>
        <dsp:cNvPr id="0" name=""/>
        <dsp:cNvSpPr/>
      </dsp:nvSpPr>
      <dsp:spPr>
        <a:xfrm rot="10800000">
          <a:off x="0" y="2482"/>
          <a:ext cx="4697730" cy="3352586"/>
        </a:xfrm>
        <a:prstGeom prst="upArrowCallout">
          <a:avLst/>
        </a:prstGeom>
        <a:solidFill>
          <a:schemeClr val="accent2">
            <a:hueOff val="-1455363"/>
            <a:satOff val="-83928"/>
            <a:lumOff val="8628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70688" tIns="170688" rIns="170688" bIns="170688" numCol="1" spcCol="1270" anchor="ctr" anchorCtr="0">
          <a:noAutofit/>
        </a:bodyPr>
        <a:lstStyle/>
        <a:p>
          <a:pPr marL="0" lvl="0" indent="0" algn="ctr" defTabSz="1066800" rtl="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400" kern="1200" dirty="0"/>
            <a:t>All older adults should be screened yearly </a:t>
          </a:r>
          <a:r>
            <a:rPr lang="en-US" sz="2400" kern="1200" dirty="0">
              <a:latin typeface="Calibri Light" panose="020F0302020204030204"/>
            </a:rPr>
            <a:t>and ideally on every visit for</a:t>
          </a:r>
          <a:r>
            <a:rPr lang="en-US" sz="2400" kern="1200" dirty="0"/>
            <a:t> </a:t>
          </a:r>
        </a:p>
      </dsp:txBody>
      <dsp:txXfrm rot="-10800000">
        <a:off x="0" y="2482"/>
        <a:ext cx="4697730" cy="1176757"/>
      </dsp:txXfrm>
    </dsp:sp>
    <dsp:sp modelId="{4E05B6C6-7E42-48CE-AB4A-4CBC2D248630}">
      <dsp:nvSpPr>
        <dsp:cNvPr id="0" name=""/>
        <dsp:cNvSpPr/>
      </dsp:nvSpPr>
      <dsp:spPr>
        <a:xfrm>
          <a:off x="2293" y="1179239"/>
          <a:ext cx="1564380" cy="1002423"/>
        </a:xfrm>
        <a:prstGeom prst="rect">
          <a:avLst/>
        </a:prstGeom>
        <a:solidFill>
          <a:schemeClr val="accent2">
            <a:tint val="40000"/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2">
              <a:tint val="40000"/>
              <a:alpha val="9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56464" tIns="27940" rIns="156464" bIns="27940" numCol="1" spcCol="1270" anchor="ctr" anchorCtr="0">
          <a:noAutofit/>
        </a:bodyPr>
        <a:lstStyle/>
        <a:p>
          <a:pPr marL="0" lvl="0" indent="0" algn="ctr" defTabSz="9779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200" kern="1200" dirty="0"/>
            <a:t>Falls</a:t>
          </a:r>
        </a:p>
      </dsp:txBody>
      <dsp:txXfrm>
        <a:off x="2293" y="1179239"/>
        <a:ext cx="1564380" cy="1002423"/>
      </dsp:txXfrm>
    </dsp:sp>
    <dsp:sp modelId="{C45E72CE-60D5-4067-8F01-E43FDF138B55}">
      <dsp:nvSpPr>
        <dsp:cNvPr id="0" name=""/>
        <dsp:cNvSpPr/>
      </dsp:nvSpPr>
      <dsp:spPr>
        <a:xfrm>
          <a:off x="1566674" y="1179239"/>
          <a:ext cx="1564380" cy="1002423"/>
        </a:xfrm>
        <a:prstGeom prst="rect">
          <a:avLst/>
        </a:prstGeom>
        <a:solidFill>
          <a:schemeClr val="accent2">
            <a:tint val="40000"/>
            <a:alpha val="90000"/>
            <a:hueOff val="-424613"/>
            <a:satOff val="-37673"/>
            <a:lumOff val="-385"/>
            <a:alphaOff val="0"/>
          </a:schemeClr>
        </a:solidFill>
        <a:ln w="12700" cap="flat" cmpd="sng" algn="ctr">
          <a:solidFill>
            <a:schemeClr val="accent2">
              <a:tint val="40000"/>
              <a:alpha val="90000"/>
              <a:hueOff val="-424613"/>
              <a:satOff val="-37673"/>
              <a:lumOff val="-385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56464" tIns="27940" rIns="156464" bIns="27940" numCol="1" spcCol="1270" anchor="ctr" anchorCtr="0">
          <a:noAutofit/>
        </a:bodyPr>
        <a:lstStyle/>
        <a:p>
          <a:pPr marL="0" lvl="0" indent="0" algn="ctr" defTabSz="9779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200" kern="1200" dirty="0"/>
            <a:t>Frequency</a:t>
          </a:r>
        </a:p>
      </dsp:txBody>
      <dsp:txXfrm>
        <a:off x="1566674" y="1179239"/>
        <a:ext cx="1564380" cy="1002423"/>
      </dsp:txXfrm>
    </dsp:sp>
    <dsp:sp modelId="{5E61AFC8-56A1-479A-8649-7A172B262C41}">
      <dsp:nvSpPr>
        <dsp:cNvPr id="0" name=""/>
        <dsp:cNvSpPr/>
      </dsp:nvSpPr>
      <dsp:spPr>
        <a:xfrm>
          <a:off x="3131055" y="1179239"/>
          <a:ext cx="1564380" cy="1002423"/>
        </a:xfrm>
        <a:prstGeom prst="rect">
          <a:avLst/>
        </a:prstGeom>
        <a:solidFill>
          <a:schemeClr val="accent2">
            <a:tint val="40000"/>
            <a:alpha val="90000"/>
            <a:hueOff val="-849226"/>
            <a:satOff val="-75346"/>
            <a:lumOff val="-769"/>
            <a:alphaOff val="0"/>
          </a:schemeClr>
        </a:solidFill>
        <a:ln w="12700" cap="flat" cmpd="sng" algn="ctr">
          <a:solidFill>
            <a:schemeClr val="accent2">
              <a:tint val="40000"/>
              <a:alpha val="90000"/>
              <a:hueOff val="-849226"/>
              <a:satOff val="-75346"/>
              <a:lumOff val="-769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56464" tIns="27940" rIns="156464" bIns="27940" numCol="1" spcCol="1270" anchor="ctr" anchorCtr="0">
          <a:noAutofit/>
        </a:bodyPr>
        <a:lstStyle/>
        <a:p>
          <a:pPr marL="0" lvl="0" indent="0" algn="ctr" defTabSz="9779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200" kern="1200" dirty="0"/>
            <a:t>Difficulties in gait or balance</a:t>
          </a:r>
        </a:p>
      </dsp:txBody>
      <dsp:txXfrm>
        <a:off x="3131055" y="1179239"/>
        <a:ext cx="1564380" cy="1002423"/>
      </dsp:txXfrm>
    </dsp:sp>
  </dsp:spTree>
</dsp:drawing>
</file>

<file path=ppt/diagrams/drawing5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6FA29F4E-5EE0-473C-8D3F-6F46F251FE29}">
      <dsp:nvSpPr>
        <dsp:cNvPr id="0" name=""/>
        <dsp:cNvSpPr/>
      </dsp:nvSpPr>
      <dsp:spPr>
        <a:xfrm>
          <a:off x="0" y="27814"/>
          <a:ext cx="7886700" cy="503685"/>
        </a:xfrm>
        <a:prstGeom prst="roundRect">
          <a:avLst/>
        </a:prstGeom>
        <a:solidFill>
          <a:schemeClr val="accent5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0010" tIns="80010" rIns="80010" bIns="80010" numCol="1" spcCol="1270" anchor="ctr" anchorCtr="0">
          <a:noAutofit/>
        </a:bodyPr>
        <a:lstStyle/>
        <a:p>
          <a:pPr marL="0" lvl="0" indent="0" algn="l" defTabSz="933450" rtl="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100" kern="1200"/>
            <a:t>Living Will</a:t>
          </a:r>
        </a:p>
      </dsp:txBody>
      <dsp:txXfrm>
        <a:off x="24588" y="52402"/>
        <a:ext cx="7837524" cy="454509"/>
      </dsp:txXfrm>
    </dsp:sp>
    <dsp:sp modelId="{BF2F4E81-20C8-4FF8-9440-07A456E5AD32}">
      <dsp:nvSpPr>
        <dsp:cNvPr id="0" name=""/>
        <dsp:cNvSpPr/>
      </dsp:nvSpPr>
      <dsp:spPr>
        <a:xfrm>
          <a:off x="0" y="531499"/>
          <a:ext cx="7886700" cy="554242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50403" tIns="26670" rIns="149352" bIns="26670" numCol="1" spcCol="1270" anchor="t" anchorCtr="0">
          <a:noAutofit/>
        </a:bodyPr>
        <a:lstStyle/>
        <a:p>
          <a:pPr marL="171450" lvl="1" indent="-171450" algn="l" defTabSz="711200" rtl="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1600" kern="1200"/>
            <a:t>Most Limited</a:t>
          </a:r>
          <a:r>
            <a:rPr lang="en-US" sz="1600" kern="1200">
              <a:latin typeface="Calibri Light" panose="020F0302020204030204"/>
            </a:rPr>
            <a:t> as often refers to very specific, uncommon clinical scenario</a:t>
          </a:r>
          <a:endParaRPr lang="en-US" sz="1600" kern="1200"/>
        </a:p>
        <a:p>
          <a:pPr marL="171450" lvl="1" indent="-171450" algn="l" defTabSz="711200" rtl="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1600" kern="1200">
              <a:latin typeface="Calibri Light" panose="020F0302020204030204"/>
            </a:rPr>
            <a:t>Applicability varies by state</a:t>
          </a:r>
        </a:p>
      </dsp:txBody>
      <dsp:txXfrm>
        <a:off x="0" y="531499"/>
        <a:ext cx="7886700" cy="554242"/>
      </dsp:txXfrm>
    </dsp:sp>
    <dsp:sp modelId="{1EC99BCF-341F-4281-B8FA-B5ED4CA36149}">
      <dsp:nvSpPr>
        <dsp:cNvPr id="0" name=""/>
        <dsp:cNvSpPr/>
      </dsp:nvSpPr>
      <dsp:spPr>
        <a:xfrm>
          <a:off x="0" y="1085742"/>
          <a:ext cx="7886700" cy="503685"/>
        </a:xfrm>
        <a:prstGeom prst="roundRect">
          <a:avLst/>
        </a:prstGeom>
        <a:solidFill>
          <a:schemeClr val="accent5">
            <a:hueOff val="-2252848"/>
            <a:satOff val="-5806"/>
            <a:lumOff val="-3922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0010" tIns="80010" rIns="80010" bIns="80010" numCol="1" spcCol="1270" anchor="ctr" anchorCtr="0">
          <a:noAutofit/>
        </a:bodyPr>
        <a:lstStyle/>
        <a:p>
          <a:pPr marL="0" lvl="0" indent="0" algn="l" defTabSz="9334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100" kern="1200"/>
            <a:t>Health Care Proxy</a:t>
          </a:r>
        </a:p>
      </dsp:txBody>
      <dsp:txXfrm>
        <a:off x="24588" y="1110330"/>
        <a:ext cx="7837524" cy="454509"/>
      </dsp:txXfrm>
    </dsp:sp>
    <dsp:sp modelId="{D7397A06-3D1C-4358-9755-2A3F85A14B71}">
      <dsp:nvSpPr>
        <dsp:cNvPr id="0" name=""/>
        <dsp:cNvSpPr/>
      </dsp:nvSpPr>
      <dsp:spPr>
        <a:xfrm>
          <a:off x="0" y="1589427"/>
          <a:ext cx="7886700" cy="347760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50403" tIns="26670" rIns="149352" bIns="26670" numCol="1" spcCol="1270" anchor="t" anchorCtr="0">
          <a:noAutofit/>
        </a:bodyPr>
        <a:lstStyle/>
        <a:p>
          <a:pPr marL="171450" lvl="1" indent="-171450" algn="l" defTabSz="711200" rtl="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1600" kern="1200">
              <a:latin typeface="Calibri Light" panose="020F0302020204030204"/>
            </a:rPr>
            <a:t>Durable Power of Attorney for Healthcare</a:t>
          </a:r>
        </a:p>
      </dsp:txBody>
      <dsp:txXfrm>
        <a:off x="0" y="1589427"/>
        <a:ext cx="7886700" cy="347760"/>
      </dsp:txXfrm>
    </dsp:sp>
    <dsp:sp modelId="{45876708-A133-4E40-95D5-CB51BF5D56A8}">
      <dsp:nvSpPr>
        <dsp:cNvPr id="0" name=""/>
        <dsp:cNvSpPr/>
      </dsp:nvSpPr>
      <dsp:spPr>
        <a:xfrm>
          <a:off x="0" y="1937187"/>
          <a:ext cx="7886700" cy="503685"/>
        </a:xfrm>
        <a:prstGeom prst="roundRect">
          <a:avLst/>
        </a:prstGeom>
        <a:solidFill>
          <a:schemeClr val="accent5">
            <a:hueOff val="-4505695"/>
            <a:satOff val="-11613"/>
            <a:lumOff val="-7843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0010" tIns="80010" rIns="80010" bIns="80010" numCol="1" spcCol="1270" anchor="ctr" anchorCtr="0">
          <a:noAutofit/>
        </a:bodyPr>
        <a:lstStyle/>
        <a:p>
          <a:pPr marL="0" lvl="0" indent="0" algn="l" defTabSz="933450" rtl="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100" kern="1200"/>
            <a:t>Advance Care </a:t>
          </a:r>
          <a:r>
            <a:rPr lang="en-US" sz="2100" kern="1200">
              <a:latin typeface="Calibri Light" panose="020F0302020204030204"/>
            </a:rPr>
            <a:t>Plan </a:t>
          </a:r>
          <a:endParaRPr lang="en-US" sz="2100" kern="1200"/>
        </a:p>
      </dsp:txBody>
      <dsp:txXfrm>
        <a:off x="24588" y="1961775"/>
        <a:ext cx="7837524" cy="454509"/>
      </dsp:txXfrm>
    </dsp:sp>
    <dsp:sp modelId="{16DACAB5-FFE8-4C7D-BC0E-2D97DD1D01EB}">
      <dsp:nvSpPr>
        <dsp:cNvPr id="0" name=""/>
        <dsp:cNvSpPr/>
      </dsp:nvSpPr>
      <dsp:spPr>
        <a:xfrm>
          <a:off x="0" y="2440872"/>
          <a:ext cx="7886700" cy="825930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50403" tIns="26670" rIns="149352" bIns="26670" numCol="1" spcCol="1270" anchor="t" anchorCtr="0">
          <a:noAutofit/>
        </a:bodyPr>
        <a:lstStyle/>
        <a:p>
          <a:pPr marL="171450" lvl="1" indent="-171450" algn="l" defTabSz="71120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1600" kern="1200"/>
            <a:t>Most </a:t>
          </a:r>
          <a:r>
            <a:rPr lang="en-US" sz="1600" kern="1200">
              <a:latin typeface="Calibri Light" panose="020F0302020204030204"/>
            </a:rPr>
            <a:t>Comprehensive</a:t>
          </a:r>
          <a:endParaRPr lang="en-US" sz="1600" kern="1200"/>
        </a:p>
        <a:p>
          <a:pPr marL="171450" lvl="1" indent="-171450" algn="l" defTabSz="711200" rtl="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1600" kern="1200"/>
            <a:t>5 Wishes </a:t>
          </a:r>
          <a:endParaRPr lang="en-US" sz="1600" kern="1200">
            <a:latin typeface="Calibri Light" panose="020F0302020204030204"/>
          </a:endParaRPr>
        </a:p>
        <a:p>
          <a:pPr marL="342900" lvl="2" indent="-171450" algn="l" defTabSz="711200" rtl="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1600" kern="1200">
              <a:latin typeface="Calibri Light" panose="020F0302020204030204"/>
            </a:rPr>
            <a:t>Includes</a:t>
          </a:r>
          <a:r>
            <a:rPr lang="en-US" sz="1600" kern="1200"/>
            <a:t> </a:t>
          </a:r>
          <a:r>
            <a:rPr lang="en-US" sz="1600" kern="1200">
              <a:latin typeface="Calibri Light" panose="020F0302020204030204"/>
            </a:rPr>
            <a:t>wishes as well as appointment</a:t>
          </a:r>
          <a:r>
            <a:rPr lang="en-US" sz="1600" kern="1200"/>
            <a:t> of </a:t>
          </a:r>
          <a:r>
            <a:rPr lang="en-US" sz="1600" kern="1200">
              <a:latin typeface="Calibri Light" panose="020F0302020204030204"/>
            </a:rPr>
            <a:t>HCP</a:t>
          </a:r>
        </a:p>
      </dsp:txBody>
      <dsp:txXfrm>
        <a:off x="0" y="2440872"/>
        <a:ext cx="7886700" cy="825930"/>
      </dsp:txXfrm>
    </dsp:sp>
    <dsp:sp modelId="{EC463F86-71ED-43C1-B649-54D38585F1D2}">
      <dsp:nvSpPr>
        <dsp:cNvPr id="0" name=""/>
        <dsp:cNvSpPr/>
      </dsp:nvSpPr>
      <dsp:spPr>
        <a:xfrm>
          <a:off x="0" y="3266802"/>
          <a:ext cx="7886700" cy="503685"/>
        </a:xfrm>
        <a:prstGeom prst="roundRect">
          <a:avLst/>
        </a:prstGeom>
        <a:solidFill>
          <a:schemeClr val="accent5">
            <a:hueOff val="-6758543"/>
            <a:satOff val="-17419"/>
            <a:lumOff val="-11765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0010" tIns="80010" rIns="80010" bIns="80010" numCol="1" spcCol="1270" anchor="ctr" anchorCtr="0">
          <a:noAutofit/>
        </a:bodyPr>
        <a:lstStyle/>
        <a:p>
          <a:pPr marL="0" lvl="0" indent="0" algn="l" defTabSz="933450" rtl="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100" kern="1200">
              <a:latin typeface="Calibri Light" panose="020F0302020204030204"/>
            </a:rPr>
            <a:t>Medical Orders</a:t>
          </a:r>
        </a:p>
      </dsp:txBody>
      <dsp:txXfrm>
        <a:off x="24588" y="3291390"/>
        <a:ext cx="7837524" cy="454509"/>
      </dsp:txXfrm>
    </dsp:sp>
    <dsp:sp modelId="{1F6C8B97-1BB1-4F06-B01C-C66ADA29B0AD}">
      <dsp:nvSpPr>
        <dsp:cNvPr id="0" name=""/>
        <dsp:cNvSpPr/>
      </dsp:nvSpPr>
      <dsp:spPr>
        <a:xfrm>
          <a:off x="0" y="3770487"/>
          <a:ext cx="7886700" cy="554242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50403" tIns="26670" rIns="149352" bIns="26670" numCol="1" spcCol="1270" anchor="t" anchorCtr="0">
          <a:noAutofit/>
        </a:bodyPr>
        <a:lstStyle/>
        <a:p>
          <a:pPr marL="171450" lvl="1" indent="-171450" algn="l" defTabSz="711200" rtl="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1600" kern="1200">
              <a:latin typeface="Calibri Light" panose="020F0302020204030204"/>
            </a:rPr>
            <a:t>DNR/DNI</a:t>
          </a:r>
        </a:p>
        <a:p>
          <a:pPr marL="171450" lvl="1" indent="-171450" algn="l" defTabSz="71120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1600" kern="1200">
              <a:latin typeface="Calibri Light" panose="020F0302020204030204"/>
            </a:rPr>
            <a:t>MOLST</a:t>
          </a:r>
          <a:endParaRPr lang="en-US" sz="1600" kern="1200"/>
        </a:p>
      </dsp:txBody>
      <dsp:txXfrm>
        <a:off x="0" y="3770487"/>
        <a:ext cx="7886700" cy="554242"/>
      </dsp:txXfrm>
    </dsp:sp>
  </dsp:spTree>
</dsp:drawing>
</file>

<file path=ppt/diagrams/drawing6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B04C2D1F-AA0C-431E-B913-BD15A5A68341}">
      <dsp:nvSpPr>
        <dsp:cNvPr id="0" name=""/>
        <dsp:cNvSpPr/>
      </dsp:nvSpPr>
      <dsp:spPr>
        <a:xfrm rot="5400000">
          <a:off x="5208597" y="-2179560"/>
          <a:ext cx="691716" cy="5227722"/>
        </a:xfrm>
        <a:prstGeom prst="round2SameRect">
          <a:avLst/>
        </a:prstGeom>
        <a:solidFill>
          <a:schemeClr val="accent1">
            <a:alpha val="90000"/>
            <a:tint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72390" tIns="36195" rIns="72390" bIns="36195" numCol="1" spcCol="1270" anchor="ctr" anchorCtr="0">
          <a:noAutofit/>
        </a:bodyPr>
        <a:lstStyle/>
        <a:p>
          <a:pPr marL="171450" lvl="1" indent="-171450" algn="l" defTabSz="8445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900" kern="1200" dirty="0"/>
            <a:t>The Person I Want to Make Care Decisions for Me When I Can't.</a:t>
          </a:r>
        </a:p>
      </dsp:txBody>
      <dsp:txXfrm rot="-5400000">
        <a:off x="2940595" y="122209"/>
        <a:ext cx="5193955" cy="624182"/>
      </dsp:txXfrm>
    </dsp:sp>
    <dsp:sp modelId="{906258DB-6FC9-4D3D-B180-8972FF31F239}">
      <dsp:nvSpPr>
        <dsp:cNvPr id="0" name=""/>
        <dsp:cNvSpPr/>
      </dsp:nvSpPr>
      <dsp:spPr>
        <a:xfrm>
          <a:off x="0" y="1977"/>
          <a:ext cx="2940594" cy="864645"/>
        </a:xfrm>
        <a:prstGeom prst="round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63830" tIns="81915" rIns="163830" bIns="81915" numCol="1" spcCol="1270" anchor="ctr" anchorCtr="0">
          <a:noAutofit/>
        </a:bodyPr>
        <a:lstStyle/>
        <a:p>
          <a:pPr marL="0" lvl="0" indent="0" algn="ctr" defTabSz="1911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4300" b="1" kern="1200" dirty="0"/>
            <a:t>Wish</a:t>
          </a:r>
          <a:r>
            <a:rPr lang="en-US" sz="4300" kern="1200" dirty="0"/>
            <a:t> </a:t>
          </a:r>
          <a:r>
            <a:rPr lang="en-US" sz="4300" b="1" kern="1200" dirty="0"/>
            <a:t>1: </a:t>
          </a:r>
          <a:endParaRPr lang="en-US" sz="4300" kern="1200" dirty="0"/>
        </a:p>
      </dsp:txBody>
      <dsp:txXfrm>
        <a:off x="42208" y="44185"/>
        <a:ext cx="2856178" cy="780229"/>
      </dsp:txXfrm>
    </dsp:sp>
    <dsp:sp modelId="{050E84B2-B3B6-4FB3-8E57-7B93FD0BD6AB}">
      <dsp:nvSpPr>
        <dsp:cNvPr id="0" name=""/>
        <dsp:cNvSpPr/>
      </dsp:nvSpPr>
      <dsp:spPr>
        <a:xfrm rot="5400000">
          <a:off x="5208597" y="-1271682"/>
          <a:ext cx="691716" cy="5227722"/>
        </a:xfrm>
        <a:prstGeom prst="round2SameRect">
          <a:avLst/>
        </a:prstGeom>
        <a:solidFill>
          <a:schemeClr val="accent1">
            <a:alpha val="90000"/>
            <a:tint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72390" tIns="36195" rIns="72390" bIns="36195" numCol="1" spcCol="1270" anchor="ctr" anchorCtr="0">
          <a:noAutofit/>
        </a:bodyPr>
        <a:lstStyle/>
        <a:p>
          <a:pPr marL="171450" lvl="1" indent="-171450" algn="l" defTabSz="8445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900" kern="1200" dirty="0"/>
            <a:t>The Kind of Medical Treatment I Want or Don't Want. </a:t>
          </a:r>
        </a:p>
      </dsp:txBody>
      <dsp:txXfrm rot="-5400000">
        <a:off x="2940595" y="1030087"/>
        <a:ext cx="5193955" cy="624182"/>
      </dsp:txXfrm>
    </dsp:sp>
    <dsp:sp modelId="{69DD7001-72C9-4BDC-BAD1-6A0EC562260E}">
      <dsp:nvSpPr>
        <dsp:cNvPr id="0" name=""/>
        <dsp:cNvSpPr/>
      </dsp:nvSpPr>
      <dsp:spPr>
        <a:xfrm>
          <a:off x="0" y="909855"/>
          <a:ext cx="2940594" cy="864645"/>
        </a:xfrm>
        <a:prstGeom prst="round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63830" tIns="81915" rIns="163830" bIns="81915" numCol="1" spcCol="1270" anchor="ctr" anchorCtr="0">
          <a:noAutofit/>
        </a:bodyPr>
        <a:lstStyle/>
        <a:p>
          <a:pPr marL="0" lvl="0" indent="0" algn="ctr" defTabSz="1911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4300" b="1" kern="1200" dirty="0"/>
            <a:t>Wish</a:t>
          </a:r>
          <a:r>
            <a:rPr lang="en-US" sz="4300" kern="1200" dirty="0"/>
            <a:t> </a:t>
          </a:r>
          <a:r>
            <a:rPr lang="en-US" sz="4300" b="1" kern="1200" dirty="0"/>
            <a:t>2: </a:t>
          </a:r>
          <a:endParaRPr lang="en-US" sz="4300" kern="1200" dirty="0"/>
        </a:p>
      </dsp:txBody>
      <dsp:txXfrm>
        <a:off x="42208" y="952063"/>
        <a:ext cx="2856178" cy="780229"/>
      </dsp:txXfrm>
    </dsp:sp>
    <dsp:sp modelId="{6358C847-9F3F-487A-A8BB-4C78CF3449D3}">
      <dsp:nvSpPr>
        <dsp:cNvPr id="0" name=""/>
        <dsp:cNvSpPr/>
      </dsp:nvSpPr>
      <dsp:spPr>
        <a:xfrm rot="5400000">
          <a:off x="5208597" y="-363804"/>
          <a:ext cx="691716" cy="5227722"/>
        </a:xfrm>
        <a:prstGeom prst="round2SameRect">
          <a:avLst/>
        </a:prstGeom>
        <a:solidFill>
          <a:schemeClr val="accent1">
            <a:alpha val="90000"/>
            <a:tint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72390" tIns="36195" rIns="72390" bIns="36195" numCol="1" spcCol="1270" anchor="ctr" anchorCtr="0">
          <a:noAutofit/>
        </a:bodyPr>
        <a:lstStyle/>
        <a:p>
          <a:pPr marL="171450" lvl="1" indent="-171450" algn="l" defTabSz="8445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900" kern="1200" dirty="0"/>
            <a:t>How Comfortable I Want to Be. </a:t>
          </a:r>
        </a:p>
      </dsp:txBody>
      <dsp:txXfrm rot="-5400000">
        <a:off x="2940595" y="1937965"/>
        <a:ext cx="5193955" cy="624182"/>
      </dsp:txXfrm>
    </dsp:sp>
    <dsp:sp modelId="{6BF90CC7-7F3B-4561-AB5C-0A0995681E49}">
      <dsp:nvSpPr>
        <dsp:cNvPr id="0" name=""/>
        <dsp:cNvSpPr/>
      </dsp:nvSpPr>
      <dsp:spPr>
        <a:xfrm>
          <a:off x="0" y="1817733"/>
          <a:ext cx="2940594" cy="864645"/>
        </a:xfrm>
        <a:prstGeom prst="round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63830" tIns="81915" rIns="163830" bIns="81915" numCol="1" spcCol="1270" anchor="ctr" anchorCtr="0">
          <a:noAutofit/>
        </a:bodyPr>
        <a:lstStyle/>
        <a:p>
          <a:pPr marL="0" lvl="0" indent="0" algn="ctr" defTabSz="1911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4300" b="1" kern="1200" dirty="0"/>
            <a:t>Wish</a:t>
          </a:r>
          <a:r>
            <a:rPr lang="en-US" sz="4300" kern="1200" dirty="0"/>
            <a:t> </a:t>
          </a:r>
          <a:r>
            <a:rPr lang="en-US" sz="4300" b="1" kern="1200" dirty="0"/>
            <a:t>3: </a:t>
          </a:r>
          <a:endParaRPr lang="en-US" sz="4300" kern="1200" dirty="0"/>
        </a:p>
      </dsp:txBody>
      <dsp:txXfrm>
        <a:off x="42208" y="1859941"/>
        <a:ext cx="2856178" cy="780229"/>
      </dsp:txXfrm>
    </dsp:sp>
    <dsp:sp modelId="{38764332-774A-4377-B7DC-D7E55AF52C83}">
      <dsp:nvSpPr>
        <dsp:cNvPr id="0" name=""/>
        <dsp:cNvSpPr/>
      </dsp:nvSpPr>
      <dsp:spPr>
        <a:xfrm rot="5400000">
          <a:off x="5208597" y="544073"/>
          <a:ext cx="691716" cy="5227722"/>
        </a:xfrm>
        <a:prstGeom prst="round2SameRect">
          <a:avLst/>
        </a:prstGeom>
        <a:solidFill>
          <a:schemeClr val="accent1">
            <a:alpha val="90000"/>
            <a:tint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72390" tIns="36195" rIns="72390" bIns="36195" numCol="1" spcCol="1270" anchor="ctr" anchorCtr="0">
          <a:noAutofit/>
        </a:bodyPr>
        <a:lstStyle/>
        <a:p>
          <a:pPr marL="171450" lvl="1" indent="-171450" algn="l" defTabSz="8445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900" kern="1200" dirty="0"/>
            <a:t>How I Want People to Treat Me. </a:t>
          </a:r>
        </a:p>
      </dsp:txBody>
      <dsp:txXfrm rot="-5400000">
        <a:off x="2940595" y="2845843"/>
        <a:ext cx="5193955" cy="624182"/>
      </dsp:txXfrm>
    </dsp:sp>
    <dsp:sp modelId="{788D4F97-436C-48B9-A7F5-A4329330DBEC}">
      <dsp:nvSpPr>
        <dsp:cNvPr id="0" name=""/>
        <dsp:cNvSpPr/>
      </dsp:nvSpPr>
      <dsp:spPr>
        <a:xfrm>
          <a:off x="0" y="2725611"/>
          <a:ext cx="2940594" cy="864645"/>
        </a:xfrm>
        <a:prstGeom prst="round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63830" tIns="81915" rIns="163830" bIns="81915" numCol="1" spcCol="1270" anchor="ctr" anchorCtr="0">
          <a:noAutofit/>
        </a:bodyPr>
        <a:lstStyle/>
        <a:p>
          <a:pPr marL="0" lvl="0" indent="0" algn="ctr" defTabSz="1911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4300" b="1" kern="1200" dirty="0"/>
            <a:t>Wish 4: </a:t>
          </a:r>
          <a:endParaRPr lang="en-US" sz="4300" kern="1200" dirty="0"/>
        </a:p>
      </dsp:txBody>
      <dsp:txXfrm>
        <a:off x="42208" y="2767819"/>
        <a:ext cx="2856178" cy="780229"/>
      </dsp:txXfrm>
    </dsp:sp>
    <dsp:sp modelId="{355B8FFA-D55C-4F28-951A-8F8D0024F412}">
      <dsp:nvSpPr>
        <dsp:cNvPr id="0" name=""/>
        <dsp:cNvSpPr/>
      </dsp:nvSpPr>
      <dsp:spPr>
        <a:xfrm rot="5400000">
          <a:off x="5208597" y="1451951"/>
          <a:ext cx="691716" cy="5227722"/>
        </a:xfrm>
        <a:prstGeom prst="round2SameRect">
          <a:avLst/>
        </a:prstGeom>
        <a:solidFill>
          <a:schemeClr val="accent1">
            <a:alpha val="90000"/>
            <a:tint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72390" tIns="36195" rIns="72390" bIns="36195" numCol="1" spcCol="1270" anchor="ctr" anchorCtr="0">
          <a:noAutofit/>
        </a:bodyPr>
        <a:lstStyle/>
        <a:p>
          <a:pPr marL="171450" lvl="1" indent="-171450" algn="l" defTabSz="8445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900" kern="1200" dirty="0"/>
            <a:t>What I Want My Loved Ones to Know.</a:t>
          </a:r>
        </a:p>
      </dsp:txBody>
      <dsp:txXfrm rot="-5400000">
        <a:off x="2940595" y="3753721"/>
        <a:ext cx="5193955" cy="624182"/>
      </dsp:txXfrm>
    </dsp:sp>
    <dsp:sp modelId="{FE6B50C1-CC06-45B9-BAE2-6AD10635FB58}">
      <dsp:nvSpPr>
        <dsp:cNvPr id="0" name=""/>
        <dsp:cNvSpPr/>
      </dsp:nvSpPr>
      <dsp:spPr>
        <a:xfrm>
          <a:off x="0" y="3633489"/>
          <a:ext cx="2940594" cy="864645"/>
        </a:xfrm>
        <a:prstGeom prst="round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63830" tIns="81915" rIns="163830" bIns="81915" numCol="1" spcCol="1270" anchor="ctr" anchorCtr="0">
          <a:noAutofit/>
        </a:bodyPr>
        <a:lstStyle/>
        <a:p>
          <a:pPr marL="0" lvl="0" indent="0" algn="ctr" defTabSz="1911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4300" b="1" kern="1200" dirty="0"/>
            <a:t>Wish 5</a:t>
          </a:r>
          <a:r>
            <a:rPr lang="en-US" sz="4300" kern="1200" dirty="0"/>
            <a:t>: </a:t>
          </a:r>
        </a:p>
      </dsp:txBody>
      <dsp:txXfrm>
        <a:off x="42208" y="3675697"/>
        <a:ext cx="2856178" cy="780229"/>
      </dsp:txXfrm>
    </dsp:sp>
  </dsp:spTree>
</dsp:drawing>
</file>

<file path=ppt/diagrams/drawing7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3927CAF-1FDB-4164-AE21-F2C81D8A5A11}">
      <dsp:nvSpPr>
        <dsp:cNvPr id="0" name=""/>
        <dsp:cNvSpPr/>
      </dsp:nvSpPr>
      <dsp:spPr>
        <a:xfrm>
          <a:off x="0" y="142343"/>
          <a:ext cx="4697730" cy="2574000"/>
        </a:xfrm>
        <a:prstGeom prst="roundRect">
          <a:avLst/>
        </a:prstGeom>
        <a:solidFill>
          <a:schemeClr val="accent5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5250" tIns="95250" rIns="95250" bIns="95250" numCol="1" spcCol="1270" anchor="ctr" anchorCtr="0">
          <a:noAutofit/>
        </a:bodyPr>
        <a:lstStyle/>
        <a:p>
          <a:pPr marL="0" lvl="0" indent="0" algn="l" defTabSz="1111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500" kern="1200" dirty="0"/>
            <a:t>Care of older adults is </a:t>
          </a:r>
          <a:r>
            <a:rPr lang="en-US" sz="2500" b="1" kern="1200" dirty="0"/>
            <a:t>complex</a:t>
          </a:r>
          <a:r>
            <a:rPr lang="en-US" sz="2500" kern="1200" dirty="0"/>
            <a:t> and requires a </a:t>
          </a:r>
          <a:r>
            <a:rPr lang="en-US" sz="2500" b="1" kern="1200" dirty="0"/>
            <a:t>multimodal, interprofessional approach</a:t>
          </a:r>
          <a:r>
            <a:rPr lang="en-US" sz="2500" kern="1200" dirty="0"/>
            <a:t> with the goal to </a:t>
          </a:r>
          <a:r>
            <a:rPr lang="en-US" sz="2500" b="1" kern="1200" dirty="0"/>
            <a:t>maintain function and quality of life</a:t>
          </a:r>
          <a:r>
            <a:rPr lang="en-US" sz="2500" kern="1200" dirty="0"/>
            <a:t>.</a:t>
          </a:r>
        </a:p>
      </dsp:txBody>
      <dsp:txXfrm>
        <a:off x="125652" y="267995"/>
        <a:ext cx="4446426" cy="2322696"/>
      </dsp:txXfrm>
    </dsp:sp>
    <dsp:sp modelId="{AFC5DA36-22FA-4FDE-9399-7B599EFC5914}">
      <dsp:nvSpPr>
        <dsp:cNvPr id="0" name=""/>
        <dsp:cNvSpPr/>
      </dsp:nvSpPr>
      <dsp:spPr>
        <a:xfrm>
          <a:off x="0" y="2788343"/>
          <a:ext cx="4697730" cy="2574000"/>
        </a:xfrm>
        <a:prstGeom prst="roundRect">
          <a:avLst/>
        </a:prstGeom>
        <a:solidFill>
          <a:schemeClr val="accent5">
            <a:hueOff val="-6758543"/>
            <a:satOff val="-17419"/>
            <a:lumOff val="-11765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5250" tIns="95250" rIns="95250" bIns="95250" numCol="1" spcCol="1270" anchor="ctr" anchorCtr="0">
          <a:noAutofit/>
        </a:bodyPr>
        <a:lstStyle/>
        <a:p>
          <a:pPr marL="0" lvl="0" indent="0" algn="l" defTabSz="1111250" rtl="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500" kern="1200" dirty="0">
              <a:latin typeface="Calibri Light" panose="020F0302020204030204"/>
            </a:rPr>
            <a:t>The</a:t>
          </a:r>
          <a:r>
            <a:rPr lang="en-US" sz="2500" b="1" kern="1200" dirty="0">
              <a:latin typeface="Calibri Light" panose="020F0302020204030204"/>
            </a:rPr>
            <a:t> 4Ms Framework</a:t>
          </a:r>
          <a:r>
            <a:rPr lang="en-US" sz="2500" kern="1200" dirty="0">
              <a:latin typeface="Calibri Light" panose="020F0302020204030204"/>
            </a:rPr>
            <a:t> provides an easy to remember approach to the care of the older adult</a:t>
          </a:r>
        </a:p>
      </dsp:txBody>
      <dsp:txXfrm>
        <a:off x="125652" y="2913995"/>
        <a:ext cx="4446426" cy="2322696"/>
      </dsp:txXfrm>
    </dsp:sp>
  </dsp:spTree>
</dsp:drawing>
</file>

<file path=ppt/diagrams/drawing8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EC181DF9-FAB8-4DE5-B5DA-2D2177BC5084}">
      <dsp:nvSpPr>
        <dsp:cNvPr id="0" name=""/>
        <dsp:cNvSpPr/>
      </dsp:nvSpPr>
      <dsp:spPr>
        <a:xfrm>
          <a:off x="0" y="24668"/>
          <a:ext cx="4697730" cy="719549"/>
        </a:xfrm>
        <a:prstGeom prst="roundRect">
          <a:avLst/>
        </a:prstGeom>
        <a:solidFill>
          <a:schemeClr val="accent5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14300" tIns="114300" rIns="114300" bIns="114300" numCol="1" spcCol="1270" anchor="ctr" anchorCtr="0">
          <a:noAutofit/>
        </a:bodyPr>
        <a:lstStyle/>
        <a:p>
          <a:pPr marL="0" lvl="0" indent="0" algn="l" defTabSz="1333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000" b="1" kern="1200"/>
            <a:t>M</a:t>
          </a:r>
          <a:r>
            <a:rPr lang="en-US" sz="3000" kern="1200"/>
            <a:t>ind/</a:t>
          </a:r>
          <a:r>
            <a:rPr lang="en-US" sz="3000" b="1" kern="1200"/>
            <a:t>M</a:t>
          </a:r>
          <a:r>
            <a:rPr lang="en-US" sz="3000" kern="1200"/>
            <a:t>emory </a:t>
          </a:r>
        </a:p>
      </dsp:txBody>
      <dsp:txXfrm>
        <a:off x="35125" y="59793"/>
        <a:ext cx="4627480" cy="649299"/>
      </dsp:txXfrm>
    </dsp:sp>
    <dsp:sp modelId="{BE6D830B-DE30-46EB-B08F-42BCD7901A27}">
      <dsp:nvSpPr>
        <dsp:cNvPr id="0" name=""/>
        <dsp:cNvSpPr/>
      </dsp:nvSpPr>
      <dsp:spPr>
        <a:xfrm>
          <a:off x="0" y="744218"/>
          <a:ext cx="4697730" cy="791774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49153" tIns="38100" rIns="213360" bIns="38100" numCol="1" spcCol="1270" anchor="t" anchorCtr="0">
          <a:noAutofit/>
        </a:bodyPr>
        <a:lstStyle/>
        <a:p>
          <a:pPr marL="228600" lvl="1" indent="-228600" algn="l" defTabSz="102235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2300" kern="1200"/>
            <a:t>Cognition Assessment</a:t>
          </a:r>
        </a:p>
        <a:p>
          <a:pPr marL="228600" lvl="1" indent="-228600" algn="l" defTabSz="102235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2300" b="0" kern="1200"/>
            <a:t>M</a:t>
          </a:r>
          <a:r>
            <a:rPr lang="en-US" sz="2300" kern="1200"/>
            <a:t>ood assessment</a:t>
          </a:r>
        </a:p>
      </dsp:txBody>
      <dsp:txXfrm>
        <a:off x="0" y="744218"/>
        <a:ext cx="4697730" cy="791774"/>
      </dsp:txXfrm>
    </dsp:sp>
    <dsp:sp modelId="{57EDF7AA-05BB-41D3-BCCF-AB3FCECE4D24}">
      <dsp:nvSpPr>
        <dsp:cNvPr id="0" name=""/>
        <dsp:cNvSpPr/>
      </dsp:nvSpPr>
      <dsp:spPr>
        <a:xfrm>
          <a:off x="0" y="1535993"/>
          <a:ext cx="4697730" cy="719549"/>
        </a:xfrm>
        <a:prstGeom prst="roundRect">
          <a:avLst/>
        </a:prstGeom>
        <a:solidFill>
          <a:schemeClr val="accent5">
            <a:hueOff val="-2252848"/>
            <a:satOff val="-5806"/>
            <a:lumOff val="-3922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14300" tIns="114300" rIns="114300" bIns="114300" numCol="1" spcCol="1270" anchor="ctr" anchorCtr="0">
          <a:noAutofit/>
        </a:bodyPr>
        <a:lstStyle/>
        <a:p>
          <a:pPr marL="0" lvl="0" indent="0" algn="l" defTabSz="1333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000" b="1" kern="1200"/>
            <a:t>M</a:t>
          </a:r>
          <a:r>
            <a:rPr lang="en-US" sz="3000" kern="1200"/>
            <a:t>edication review </a:t>
          </a:r>
        </a:p>
      </dsp:txBody>
      <dsp:txXfrm>
        <a:off x="35125" y="1571118"/>
        <a:ext cx="4627480" cy="649299"/>
      </dsp:txXfrm>
    </dsp:sp>
    <dsp:sp modelId="{BEF668EE-6D79-45B1-B632-90B0A010430A}">
      <dsp:nvSpPr>
        <dsp:cNvPr id="0" name=""/>
        <dsp:cNvSpPr/>
      </dsp:nvSpPr>
      <dsp:spPr>
        <a:xfrm>
          <a:off x="0" y="2255543"/>
          <a:ext cx="4697730" cy="496800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49153" tIns="38100" rIns="213360" bIns="38100" numCol="1" spcCol="1270" anchor="t" anchorCtr="0">
          <a:noAutofit/>
        </a:bodyPr>
        <a:lstStyle/>
        <a:p>
          <a:pPr marL="228600" lvl="1" indent="-228600" algn="l" defTabSz="102235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2300" kern="1200"/>
            <a:t>Mindful prescribing</a:t>
          </a:r>
        </a:p>
      </dsp:txBody>
      <dsp:txXfrm>
        <a:off x="0" y="2255543"/>
        <a:ext cx="4697730" cy="496800"/>
      </dsp:txXfrm>
    </dsp:sp>
    <dsp:sp modelId="{AB5C436F-B83D-46E6-88A7-9A421EB8D305}">
      <dsp:nvSpPr>
        <dsp:cNvPr id="0" name=""/>
        <dsp:cNvSpPr/>
      </dsp:nvSpPr>
      <dsp:spPr>
        <a:xfrm>
          <a:off x="0" y="2752343"/>
          <a:ext cx="4697730" cy="719549"/>
        </a:xfrm>
        <a:prstGeom prst="roundRect">
          <a:avLst/>
        </a:prstGeom>
        <a:solidFill>
          <a:schemeClr val="accent5">
            <a:hueOff val="-4505695"/>
            <a:satOff val="-11613"/>
            <a:lumOff val="-7843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14300" tIns="114300" rIns="114300" bIns="114300" numCol="1" spcCol="1270" anchor="ctr" anchorCtr="0">
          <a:noAutofit/>
        </a:bodyPr>
        <a:lstStyle/>
        <a:p>
          <a:pPr marL="0" lvl="0" indent="0" algn="l" defTabSz="1333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000" b="1" kern="1200"/>
            <a:t>M</a:t>
          </a:r>
          <a:r>
            <a:rPr lang="en-US" sz="3000" kern="1200"/>
            <a:t>obility </a:t>
          </a:r>
        </a:p>
      </dsp:txBody>
      <dsp:txXfrm>
        <a:off x="35125" y="2787468"/>
        <a:ext cx="4627480" cy="649299"/>
      </dsp:txXfrm>
    </dsp:sp>
    <dsp:sp modelId="{AE7994C9-782F-49CA-A8D4-40163FE1C350}">
      <dsp:nvSpPr>
        <dsp:cNvPr id="0" name=""/>
        <dsp:cNvSpPr/>
      </dsp:nvSpPr>
      <dsp:spPr>
        <a:xfrm>
          <a:off x="0" y="3471893"/>
          <a:ext cx="4697730" cy="791774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49153" tIns="38100" rIns="213360" bIns="38100" numCol="1" spcCol="1270" anchor="t" anchorCtr="0">
          <a:noAutofit/>
        </a:bodyPr>
        <a:lstStyle/>
        <a:p>
          <a:pPr marL="228600" lvl="1" indent="-228600" algn="l" defTabSz="102235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2300" kern="1200"/>
            <a:t>Functional Assessment</a:t>
          </a:r>
        </a:p>
        <a:p>
          <a:pPr marL="228600" lvl="1" indent="-228600" algn="l" defTabSz="102235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2300" kern="1200"/>
            <a:t>Falls Risk Assessment</a:t>
          </a:r>
        </a:p>
      </dsp:txBody>
      <dsp:txXfrm>
        <a:off x="0" y="3471893"/>
        <a:ext cx="4697730" cy="791774"/>
      </dsp:txXfrm>
    </dsp:sp>
    <dsp:sp modelId="{6E584825-4964-4151-9D6D-A8E5CEC423AC}">
      <dsp:nvSpPr>
        <dsp:cNvPr id="0" name=""/>
        <dsp:cNvSpPr/>
      </dsp:nvSpPr>
      <dsp:spPr>
        <a:xfrm>
          <a:off x="0" y="4263668"/>
          <a:ext cx="4697730" cy="719549"/>
        </a:xfrm>
        <a:prstGeom prst="roundRect">
          <a:avLst/>
        </a:prstGeom>
        <a:solidFill>
          <a:schemeClr val="accent5">
            <a:hueOff val="-6758543"/>
            <a:satOff val="-17419"/>
            <a:lumOff val="-11765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14300" tIns="114300" rIns="114300" bIns="114300" numCol="1" spcCol="1270" anchor="ctr" anchorCtr="0">
          <a:noAutofit/>
        </a:bodyPr>
        <a:lstStyle/>
        <a:p>
          <a:pPr marL="0" lvl="0" indent="0" algn="l" defTabSz="1333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000" b="1" kern="1200"/>
            <a:t>M</a:t>
          </a:r>
          <a:r>
            <a:rPr lang="en-US" sz="3000" kern="1200"/>
            <a:t>atters Most</a:t>
          </a:r>
        </a:p>
      </dsp:txBody>
      <dsp:txXfrm>
        <a:off x="35125" y="4298793"/>
        <a:ext cx="4627480" cy="649299"/>
      </dsp:txXfrm>
    </dsp:sp>
    <dsp:sp modelId="{E631D655-7AD4-4EB2-BD30-0DC26F7F8981}">
      <dsp:nvSpPr>
        <dsp:cNvPr id="0" name=""/>
        <dsp:cNvSpPr/>
      </dsp:nvSpPr>
      <dsp:spPr>
        <a:xfrm>
          <a:off x="0" y="4983219"/>
          <a:ext cx="4697730" cy="496800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49153" tIns="38100" rIns="213360" bIns="38100" numCol="1" spcCol="1270" anchor="t" anchorCtr="0">
          <a:noAutofit/>
        </a:bodyPr>
        <a:lstStyle/>
        <a:p>
          <a:pPr marL="228600" lvl="1" indent="-228600" algn="l" defTabSz="1022350" rtl="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2300" kern="1200">
              <a:latin typeface="Calibri Light" panose="020F0302020204030204"/>
            </a:rPr>
            <a:t>Advance Care Planning</a:t>
          </a:r>
        </a:p>
      </dsp:txBody>
      <dsp:txXfrm>
        <a:off x="0" y="4983219"/>
        <a:ext cx="4697730" cy="496800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list1">
  <dgm:title val=""/>
  <dgm:desc val=""/>
  <dgm:catLst>
    <dgm:cat type="list" pri="4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4" srcId="0" destId="1" srcOrd="0" destOrd="0"/>
        <dgm:cxn modelId="5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linear">
    <dgm:varLst>
      <dgm:dir/>
      <dgm:animLvl val="lvl"/>
      <dgm:resizeHandles val="exact"/>
    </dgm:varLst>
    <dgm:choose name="Name0">
      <dgm:if name="Name1" func="var" arg="dir" op="equ" val="norm">
        <dgm:alg type="lin">
          <dgm:param type="linDir" val="fromT"/>
          <dgm:param type="vertAlign" val="mid"/>
          <dgm:param type="horzAlign" val="l"/>
          <dgm:param type="nodeHorzAlign" val="l"/>
        </dgm:alg>
      </dgm:if>
      <dgm:else name="Name2">
        <dgm:alg type="lin">
          <dgm:param type="linDir" val="fromT"/>
          <dgm:param type="vertAlign" val="mid"/>
          <dgm:param type="horzAlign" val="r"/>
          <dgm:param type="nodeHorzAlign" val="r"/>
        </dgm:alg>
      </dgm:else>
    </dgm:choose>
    <dgm:shape xmlns:r="http://schemas.openxmlformats.org/officeDocument/2006/relationships" r:blip="">
      <dgm:adjLst/>
    </dgm:shape>
    <dgm:presOf/>
    <dgm:constrLst>
      <dgm:constr type="w" for="ch" forName="parentLin" refType="w"/>
      <dgm:constr type="h" for="ch" forName="parentLin" val="INF"/>
      <dgm:constr type="w" for="des" forName="parentLeftMargin" refType="w" fact="0.05"/>
      <dgm:constr type="w" for="des" forName="parentText" refType="w" fact="0.7"/>
      <dgm:constr type="h" for="des" forName="parentText" refType="primFontSz" refFor="des" refForName="parentText" fact="0.82"/>
      <dgm:constr type="h" for="ch" forName="negativeSpace" refType="primFontSz" refFor="des" refForName="parentText" fact="-0.41"/>
      <dgm:constr type="h" for="ch" forName="negativeSpace" refType="h" refFor="des" refForName="parentText" op="lte" fact="-0.82"/>
      <dgm:constr type="h" for="ch" forName="negativeSpace" refType="h" refFor="des" refForName="parentText" op="gte" fact="-0.82"/>
      <dgm:constr type="w" for="ch" forName="childText" refType="w"/>
      <dgm:constr type="h" for="ch" forName="childText" refType="primFontSz" refFor="des" refForName="parentText" fact="0.7"/>
      <dgm:constr type="primFontSz" for="des" forName="parentText" val="65"/>
      <dgm:constr type="primFontSz" for="ch" forName="childText" refType="primFontSz" refFor="des" refForName="parentText"/>
      <dgm:constr type="tMarg" for="ch" forName="childText" refType="primFontSz" refFor="des" refForName="parentText" fact="1.64"/>
      <dgm:constr type="tMarg" for="ch" forName="childText" refType="h" refFor="des" refForName="parentText" op="lte" fact="3.28"/>
      <dgm:constr type="tMarg" for="ch" forName="childText" refType="h" refFor="des" refForName="parentText" op="gte" fact="3.28"/>
      <dgm:constr type="lMarg" for="ch" forName="childText" refType="w" fact="0.22"/>
      <dgm:constr type="rMarg" for="ch" forName="childText" refType="lMarg" refFor="ch" refForName="childText"/>
      <dgm:constr type="lMarg" for="des" forName="parentText" refType="w" fact="0.075"/>
      <dgm:constr type="rMarg" for="des" forName="parentText" refType="lMarg" refFor="des" refForName="parentText"/>
      <dgm:constr type="h" for="ch" forName="spaceBetweenRectangles" refType="primFontSz" refFor="des" refForName="parentText" fact="0.15"/>
    </dgm:constrLst>
    <dgm:ruleLst>
      <dgm:rule type="primFontSz" for="des" forName="parentText" val="5" fact="NaN" max="NaN"/>
    </dgm:ruleLst>
    <dgm:forEach name="Name3" axis="ch" ptType="node">
      <dgm:layoutNode name="parentLin">
        <dgm:choose name="Name4">
          <dgm:if name="Name5" func="var" arg="dir" op="equ" val="norm">
            <dgm:alg type="lin">
              <dgm:param type="linDir" val="fromL"/>
              <dgm:param type="horzAlign" val="l"/>
              <dgm:param type="nodeHorzAlign" val="l"/>
            </dgm:alg>
          </dgm:if>
          <dgm:else name="Name6">
            <dgm:alg type="lin">
              <dgm:param type="linDir" val="fromR"/>
              <dgm:param type="horzAlign" val="r"/>
              <dgm:param type="nodeHorzAlign" val="r"/>
            </dgm:alg>
          </dgm:else>
        </dgm:choose>
        <dgm:shape xmlns:r="http://schemas.openxmlformats.org/officeDocument/2006/relationships" r:blip="">
          <dgm:adjLst/>
        </dgm:shape>
        <dgm:presOf/>
        <dgm:constrLst/>
        <dgm:ruleLst/>
        <dgm:layoutNode name="parentLeftMargin">
          <dgm:alg type="sp"/>
          <dgm:shape xmlns:r="http://schemas.openxmlformats.org/officeDocument/2006/relationships" type="rect" r:blip="" hideGeom="1">
            <dgm:adjLst/>
          </dgm:shape>
          <dgm:presOf axis="self"/>
          <dgm:constrLst>
            <dgm:constr type="h"/>
          </dgm:constrLst>
          <dgm:ruleLst/>
        </dgm:layoutNode>
        <dgm:layoutNode name="parentText" styleLbl="node1">
          <dgm:varLst>
            <dgm:chMax val="0"/>
            <dgm:bulletEnabled val="1"/>
          </dgm:varLst>
          <dgm:choose name="Name7">
            <dgm:if name="Name8" func="var" arg="dir" op="equ" val="norm">
              <dgm:alg type="tx">
                <dgm:param type="parTxLTRAlign" val="l"/>
                <dgm:param type="parTxRTLAlign" val="l"/>
              </dgm:alg>
            </dgm:if>
            <dgm:else name="Name9">
              <dgm:alg type="tx">
                <dgm:param type="parTxLTRAlign" val="r"/>
                <dgm:param type="parTxRTLAlign" val="r"/>
              </dgm:alg>
            </dgm:else>
          </dgm:choose>
          <dgm:shape xmlns:r="http://schemas.openxmlformats.org/officeDocument/2006/relationships" type="roundRect" r:blip="">
            <dgm:adjLst/>
          </dgm:shape>
          <dgm:presOf axis="self" ptType="node"/>
          <dgm:constrLst>
            <dgm:constr type="tMarg"/>
            <dgm:constr type="bMarg"/>
          </dgm:constrLst>
          <dgm:ruleLst/>
        </dgm:layoutNode>
      </dgm:layoutNode>
      <dgm:layoutNode name="negativeSpace">
        <dgm:alg type="sp"/>
        <dgm:shape xmlns:r="http://schemas.openxmlformats.org/officeDocument/2006/relationships" r:blip="">
          <dgm:adjLst/>
        </dgm:shape>
        <dgm:presOf/>
        <dgm:constrLst/>
        <dgm:ruleLst/>
      </dgm:layoutNode>
      <dgm:layoutNode name="childText" styleLbl="conFgAcc1">
        <dgm:varLst>
          <dgm:bulletEnabled val="1"/>
        </dgm:varLst>
        <dgm:alg type="tx">
          <dgm:param type="stBulletLvl" val="1"/>
        </dgm:alg>
        <dgm:shape xmlns:r="http://schemas.openxmlformats.org/officeDocument/2006/relationships" type="rect" r:blip="" zOrderOff="-2">
          <dgm:adjLst/>
        </dgm:shape>
        <dgm:presOf axis="des" ptType="node"/>
        <dgm:constrLst>
          <dgm:constr type="secFontSz" refType="primFontSz"/>
        </dgm:constrLst>
        <dgm:ruleLst>
          <dgm:rule type="h" val="INF" fact="NaN" max="NaN"/>
        </dgm:ruleLst>
      </dgm:layoutNode>
      <dgm:forEach name="Name10" axis="followSib" ptType="sibTrans" cnt="1">
        <dgm:layoutNode name="spaceBetweenRectangles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vList2">
  <dgm:title val=""/>
  <dgm:desc val=""/>
  <dgm:catLst>
    <dgm:cat type="list" pri="3000"/>
    <dgm:cat type="convert" pri="1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2">
          <dgm:prSet phldr="1"/>
        </dgm:pt>
        <dgm:pt modelId="21">
          <dgm:prSet phldr="1"/>
        </dgm:pt>
      </dgm:ptLst>
      <dgm:cxnLst>
        <dgm:cxn modelId="4" srcId="0" destId="1" srcOrd="0" destOrd="0"/>
        <dgm:cxn modelId="5" srcId="0" destId="2" srcOrd="1" destOrd="0"/>
        <dgm:cxn modelId="12" srcId="1" destId="11" srcOrd="0" destOrd="0"/>
        <dgm:cxn modelId="23" srcId="2" destId="21" srcOrd="0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linear">
    <dgm:varLst>
      <dgm:animLvl val="lvl"/>
      <dgm:resizeHandles val="exact"/>
    </dgm:varLst>
    <dgm:alg type="lin">
      <dgm:param type="linDir" val="fromT"/>
      <dgm:param type="vertAlign" val="mid"/>
    </dgm:alg>
    <dgm:shape xmlns:r="http://schemas.openxmlformats.org/officeDocument/2006/relationships" r:blip="">
      <dgm:adjLst/>
    </dgm:shape>
    <dgm:presOf/>
    <dgm:constrLst>
      <dgm:constr type="w" for="ch" forName="parentText" refType="w"/>
      <dgm:constr type="h" for="ch" forName="parentText" refType="primFontSz" refFor="ch" refForName="parentText" fact="0.52"/>
      <dgm:constr type="w" for="ch" forName="childText" refType="w"/>
      <dgm:constr type="h" for="ch" forName="childText" refType="primFontSz" refFor="ch" refForName="parentText" fact="0.46"/>
      <dgm:constr type="h" for="ch" forName="parentText" op="equ"/>
      <dgm:constr type="primFontSz" for="ch" forName="parentText" op="equ" val="65"/>
      <dgm:constr type="primFontSz" for="ch" forName="childText" refType="primFontSz" refFor="ch" refForName="parentText" op="equ"/>
      <dgm:constr type="h" for="ch" forName="spacer" refType="primFontSz" refFor="ch" refForName="parentText" fact="0.08"/>
    </dgm:constrLst>
    <dgm:ruleLst>
      <dgm:rule type="primFontSz" for="ch" forName="parentText" val="5" fact="NaN" max="NaN"/>
    </dgm:ruleLst>
    <dgm:forEach name="Name0" axis="ch" ptType="node">
      <dgm:layoutNode name="parentText" styleLbl="node1">
        <dgm:varLst>
          <dgm:chMax val="0"/>
          <dgm:bulletEnabled val="1"/>
        </dgm:varLst>
        <dgm:alg type="tx">
          <dgm:param type="parTxLTRAlign" val="l"/>
          <dgm:param type="parTxRTLAlign" val="r"/>
        </dgm:alg>
        <dgm:shape xmlns:r="http://schemas.openxmlformats.org/officeDocument/2006/relationships" type="roundRect" r:blip="">
          <dgm:adjLst/>
        </dgm:shape>
        <dgm:presOf axis="self"/>
        <dgm:constrLst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h" val="INF" fact="NaN" max="NaN"/>
        </dgm:ruleLst>
      </dgm:layoutNode>
      <dgm:choose name="Name1">
        <dgm:if name="Name2" axis="ch" ptType="node" func="cnt" op="gte" val="1">
          <dgm:layoutNode name="childText" styleLbl="revTx">
            <dgm:varLst>
              <dgm:bulletEnabled val="1"/>
            </dgm:varLst>
            <dgm:alg type="tx">
              <dgm:param type="stBulletLvl" val="1"/>
              <dgm:param type="lnSpAfChP" val="20"/>
            </dgm:alg>
            <dgm:shape xmlns:r="http://schemas.openxmlformats.org/officeDocument/2006/relationships" type="rect" r:blip="">
              <dgm:adjLst/>
            </dgm:shape>
            <dgm:presOf axis="des" ptType="node"/>
            <dgm:constrLst>
              <dgm:constr type="tMarg" refType="primFontSz" fact="0.1"/>
              <dgm:constr type="bMarg" refType="primFontSz" fact="0.1"/>
              <dgm:constr type="lMarg" refType="w" fact="0.09"/>
            </dgm:constrLst>
            <dgm:ruleLst>
              <dgm:rule type="h" val="INF" fact="NaN" max="NaN"/>
            </dgm:ruleLst>
          </dgm:layoutNode>
        </dgm:if>
        <dgm:else name="Name3">
          <dgm:choose name="Name4">
            <dgm:if name="Name5" axis="par ch" ptType="doc node" func="cnt" op="gte" val="2">
              <dgm:forEach name="Name6" axis="followSib" ptType="sibTrans" cnt="1">
                <dgm:layoutNode name="spacer">
                  <dgm:alg type="sp"/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</dgm:layoutNode>
              </dgm:forEach>
            </dgm:if>
            <dgm:else name="Name7"/>
          </dgm:choose>
        </dgm:else>
      </dgm:choose>
    </dgm:forEach>
  </dgm:layoutNode>
</dgm:layoutDef>
</file>

<file path=ppt/diagrams/layout3.xml><?xml version="1.0" encoding="utf-8"?>
<dgm:layoutDef xmlns:dgm="http://schemas.openxmlformats.org/drawingml/2006/diagram" xmlns:a="http://schemas.openxmlformats.org/drawingml/2006/main" uniqueId="urn:microsoft.com/office/officeart/2005/8/layout/vList2">
  <dgm:title val=""/>
  <dgm:desc val=""/>
  <dgm:catLst>
    <dgm:cat type="list" pri="3000"/>
    <dgm:cat type="convert" pri="1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2">
          <dgm:prSet phldr="1"/>
        </dgm:pt>
        <dgm:pt modelId="21">
          <dgm:prSet phldr="1"/>
        </dgm:pt>
      </dgm:ptLst>
      <dgm:cxnLst>
        <dgm:cxn modelId="4" srcId="0" destId="1" srcOrd="0" destOrd="0"/>
        <dgm:cxn modelId="5" srcId="0" destId="2" srcOrd="1" destOrd="0"/>
        <dgm:cxn modelId="12" srcId="1" destId="11" srcOrd="0" destOrd="0"/>
        <dgm:cxn modelId="23" srcId="2" destId="21" srcOrd="0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linear">
    <dgm:varLst>
      <dgm:animLvl val="lvl"/>
      <dgm:resizeHandles val="exact"/>
    </dgm:varLst>
    <dgm:alg type="lin">
      <dgm:param type="linDir" val="fromT"/>
      <dgm:param type="vertAlign" val="mid"/>
    </dgm:alg>
    <dgm:shape xmlns:r="http://schemas.openxmlformats.org/officeDocument/2006/relationships" r:blip="">
      <dgm:adjLst/>
    </dgm:shape>
    <dgm:presOf/>
    <dgm:constrLst>
      <dgm:constr type="w" for="ch" forName="parentText" refType="w"/>
      <dgm:constr type="h" for="ch" forName="parentText" refType="primFontSz" refFor="ch" refForName="parentText" fact="0.52"/>
      <dgm:constr type="w" for="ch" forName="childText" refType="w"/>
      <dgm:constr type="h" for="ch" forName="childText" refType="primFontSz" refFor="ch" refForName="parentText" fact="0.46"/>
      <dgm:constr type="h" for="ch" forName="parentText" op="equ"/>
      <dgm:constr type="primFontSz" for="ch" forName="parentText" op="equ" val="65"/>
      <dgm:constr type="primFontSz" for="ch" forName="childText" refType="primFontSz" refFor="ch" refForName="parentText" op="equ"/>
      <dgm:constr type="h" for="ch" forName="spacer" refType="primFontSz" refFor="ch" refForName="parentText" fact="0.08"/>
    </dgm:constrLst>
    <dgm:ruleLst>
      <dgm:rule type="primFontSz" for="ch" forName="parentText" val="5" fact="NaN" max="NaN"/>
    </dgm:ruleLst>
    <dgm:forEach name="Name0" axis="ch" ptType="node">
      <dgm:layoutNode name="parentText" styleLbl="node1">
        <dgm:varLst>
          <dgm:chMax val="0"/>
          <dgm:bulletEnabled val="1"/>
        </dgm:varLst>
        <dgm:alg type="tx">
          <dgm:param type="parTxLTRAlign" val="l"/>
          <dgm:param type="parTxRTLAlign" val="r"/>
        </dgm:alg>
        <dgm:shape xmlns:r="http://schemas.openxmlformats.org/officeDocument/2006/relationships" type="roundRect" r:blip="">
          <dgm:adjLst/>
        </dgm:shape>
        <dgm:presOf axis="self"/>
        <dgm:constrLst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h" val="INF" fact="NaN" max="NaN"/>
        </dgm:ruleLst>
      </dgm:layoutNode>
      <dgm:choose name="Name1">
        <dgm:if name="Name2" axis="ch" ptType="node" func="cnt" op="gte" val="1">
          <dgm:layoutNode name="childText" styleLbl="revTx">
            <dgm:varLst>
              <dgm:bulletEnabled val="1"/>
            </dgm:varLst>
            <dgm:alg type="tx">
              <dgm:param type="stBulletLvl" val="1"/>
              <dgm:param type="lnSpAfChP" val="20"/>
            </dgm:alg>
            <dgm:shape xmlns:r="http://schemas.openxmlformats.org/officeDocument/2006/relationships" type="rect" r:blip="">
              <dgm:adjLst/>
            </dgm:shape>
            <dgm:presOf axis="des" ptType="node"/>
            <dgm:constrLst>
              <dgm:constr type="tMarg" refType="primFontSz" fact="0.1"/>
              <dgm:constr type="bMarg" refType="primFontSz" fact="0.1"/>
              <dgm:constr type="lMarg" refType="w" fact="0.09"/>
            </dgm:constrLst>
            <dgm:ruleLst>
              <dgm:rule type="h" val="INF" fact="NaN" max="NaN"/>
            </dgm:ruleLst>
          </dgm:layoutNode>
        </dgm:if>
        <dgm:else name="Name3">
          <dgm:choose name="Name4">
            <dgm:if name="Name5" axis="par ch" ptType="doc node" func="cnt" op="gte" val="2">
              <dgm:forEach name="Name6" axis="followSib" ptType="sibTrans" cnt="1">
                <dgm:layoutNode name="spacer">
                  <dgm:alg type="sp"/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</dgm:layoutNode>
              </dgm:forEach>
            </dgm:if>
            <dgm:else name="Name7"/>
          </dgm:choose>
        </dgm:else>
      </dgm:choose>
    </dgm:forEach>
  </dgm:layoutNode>
</dgm:layoutDef>
</file>

<file path=ppt/diagrams/layout4.xml><?xml version="1.0" encoding="utf-8"?>
<dgm:layoutDef xmlns:dgm="http://schemas.openxmlformats.org/drawingml/2006/diagram" xmlns:a="http://schemas.openxmlformats.org/drawingml/2006/main" uniqueId="urn:microsoft.com/office/officeart/2005/8/layout/process4">
  <dgm:title val=""/>
  <dgm:desc val=""/>
  <dgm:catLst>
    <dgm:cat type="process" pri="16000"/>
    <dgm:cat type="list" pri="20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Name0">
    <dgm:varLst>
      <dgm:dir/>
      <dgm:animLvl val="lvl"/>
      <dgm:resizeHandles val="exact"/>
    </dgm:varLst>
    <dgm:alg type="lin">
      <dgm:param type="linDir" val="fromB"/>
    </dgm:alg>
    <dgm:shape xmlns:r="http://schemas.openxmlformats.org/officeDocument/2006/relationships" r:blip="">
      <dgm:adjLst/>
    </dgm:shape>
    <dgm:presOf/>
    <dgm:constrLst>
      <dgm:constr type="h" for="ch" forName="boxAndChildren" refType="h"/>
      <dgm:constr type="h" for="ch" forName="arrowAndChildren" refType="h" refFor="ch" refForName="boxAndChildren" op="equ" fact="1.538"/>
      <dgm:constr type="w" for="ch" forName="arrowAndChildren" refType="w"/>
      <dgm:constr type="w" for="ch" forName="boxAndChildren" refType="w"/>
      <dgm:constr type="h" for="ch" forName="sp" refType="h" fact="-0.015"/>
      <dgm:constr type="primFontSz" for="des" forName="parentTextBox" val="65"/>
      <dgm:constr type="primFontSz" for="des" forName="parentTextArrow" refType="primFontSz" refFor="des" refForName="parentTextBox" op="equ"/>
      <dgm:constr type="primFontSz" for="des" forName="childTextArrow" val="65"/>
      <dgm:constr type="primFontSz" for="des" forName="childTextBox" refType="primFontSz" refFor="des" refForName="childTextArrow" op="equ"/>
    </dgm:constrLst>
    <dgm:ruleLst/>
    <dgm:forEach name="Name1" axis="ch" ptType="node" st="-1" step="-1">
      <dgm:choose name="Name2">
        <dgm:if name="Name3" axis="self" ptType="node" func="revPos" op="equ" val="1">
          <dgm:layoutNode name="boxAndChildren">
            <dgm:alg type="composite"/>
            <dgm:shape xmlns:r="http://schemas.openxmlformats.org/officeDocument/2006/relationships" r:blip="">
              <dgm:adjLst/>
            </dgm:shape>
            <dgm:presOf/>
            <dgm:choose name="Name4">
              <dgm:if name="Name5" axis="ch" ptType="node" func="cnt" op="gte" val="1">
                <dgm:constrLst>
                  <dgm:constr type="w" for="ch" forName="parentTextBox" refType="w"/>
                  <dgm:constr type="h" for="ch" forName="parentTextBox" refType="h" fact="0.54"/>
                  <dgm:constr type="t" for="ch" forName="parentTextBox"/>
                  <dgm:constr type="w" for="ch" forName="entireBox" refType="w"/>
                  <dgm:constr type="h" for="ch" forName="entireBox" refType="h"/>
                  <dgm:constr type="w" for="ch" forName="descendantBox" refType="w"/>
                  <dgm:constr type="b" for="ch" forName="descendantBox" refType="h" fact="0.98"/>
                  <dgm:constr type="h" for="ch" forName="descendantBox" refType="h" fact="0.46"/>
                </dgm:constrLst>
              </dgm:if>
              <dgm:else name="Name6">
                <dgm:constrLst>
                  <dgm:constr type="w" for="ch" forName="parentTextBox" refType="w"/>
                  <dgm:constr type="h" for="ch" forName="parentTextBox" refType="h"/>
                </dgm:constrLst>
              </dgm:else>
            </dgm:choose>
            <dgm:ruleLst/>
            <dgm:layoutNode name="parentTextBox">
              <dgm:alg type="tx"/>
              <dgm:choose name="Name7">
                <dgm:if name="Name8" axis="ch" ptType="node" func="cnt" op="gte" val="1">
                  <dgm:shape xmlns:r="http://schemas.openxmlformats.org/officeDocument/2006/relationships" type="rect" r:blip="" zOrderOff="1" hideGeom="1">
                    <dgm:adjLst/>
                  </dgm:shape>
                </dgm:if>
                <dgm:else name="Name9">
                  <dgm:shape xmlns:r="http://schemas.openxmlformats.org/officeDocument/2006/relationships" type="rect" r:blip="">
                    <dgm:adjLst/>
                  </dgm:shape>
                </dgm:else>
              </dgm:choose>
              <dgm:presOf axis="self"/>
              <dgm:constrLst/>
              <dgm:ruleLst>
                <dgm:rule type="primFontSz" val="5" fact="NaN" max="NaN"/>
              </dgm:ruleLst>
            </dgm:layoutNode>
            <dgm:choose name="Name10">
              <dgm:if name="Name11" axis="ch" ptType="node" func="cnt" op="gte" val="1">
                <dgm:layoutNode name="entireBox">
                  <dgm:alg type="sp"/>
                  <dgm:shape xmlns:r="http://schemas.openxmlformats.org/officeDocument/2006/relationships" type="rect" r:blip="">
                    <dgm:adjLst/>
                  </dgm:shape>
                  <dgm:presOf axis="self"/>
                  <dgm:constrLst/>
                  <dgm:ruleLst/>
                </dgm:layoutNode>
                <dgm:layoutNode name="descendantBox" styleLbl="fgAccFollowNode1">
                  <dgm:choose name="Name12">
                    <dgm:if name="Name13" func="var" arg="dir" op="equ" val="norm">
                      <dgm:alg type="lin"/>
                    </dgm:if>
                    <dgm:else name="Name14">
                      <dgm:alg type="lin">
                        <dgm:param type="linDir" val="fromR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w" for="ch" forName="childTextBox" refType="w"/>
                    <dgm:constr type="h" for="ch" forName="childTextBox" refType="h"/>
                  </dgm:constrLst>
                  <dgm:ruleLst/>
                  <dgm:forEach name="Name15" axis="ch" ptType="node">
                    <dgm:layoutNode name="childTextBox" styleLbl="fgAccFollowNode1">
                      <dgm:varLst>
                        <dgm:bulletEnabled val="1"/>
                      </dgm:varLst>
                      <dgm:alg type="tx"/>
                      <dgm:shape xmlns:r="http://schemas.openxmlformats.org/officeDocument/2006/relationships" type="rect" r:blip="">
                        <dgm:adjLst/>
                      </dgm:shape>
                      <dgm:presOf axis="desOrSelf" ptType="node"/>
                      <dgm:constrLst>
                        <dgm:constr type="tMarg" refType="primFontSz" fact="0.1"/>
                        <dgm:constr type="bMarg" refType="primFontSz" fact="0.1"/>
                      </dgm:constrLst>
                      <dgm:ruleLst>
                        <dgm:rule type="primFontSz" val="5" fact="NaN" max="NaN"/>
                      </dgm:ruleLst>
                    </dgm:layoutNode>
                  </dgm:forEach>
                </dgm:layoutNode>
              </dgm:if>
              <dgm:else name="Name16"/>
            </dgm:choose>
          </dgm:layoutNode>
        </dgm:if>
        <dgm:else name="Name17">
          <dgm:layoutNode name="arrowAndChildren">
            <dgm:alg type="composite"/>
            <dgm:shape xmlns:r="http://schemas.openxmlformats.org/officeDocument/2006/relationships" r:blip="">
              <dgm:adjLst/>
            </dgm:shape>
            <dgm:presOf/>
            <dgm:choose name="Name18">
              <dgm:if name="Name19" axis="ch" ptType="node" func="cnt" op="gte" val="1">
                <dgm:constrLst>
                  <dgm:constr type="w" for="ch" forName="parentTextArrow" refType="w"/>
                  <dgm:constr type="t" for="ch" forName="parentTextArrow"/>
                  <dgm:constr type="h" for="ch" forName="parentTextArrow" refType="h" fact="0.351"/>
                  <dgm:constr type="w" for="ch" forName="arrow" refType="w"/>
                  <dgm:constr type="h" for="ch" forName="arrow" refType="h"/>
                  <dgm:constr type="w" for="ch" forName="descendantArrow" refType="w"/>
                  <dgm:constr type="b" for="ch" forName="descendantArrow" refType="h" fact="0.65"/>
                  <dgm:constr type="h" for="ch" forName="descendantArrow" refType="h" fact="0.299"/>
                </dgm:constrLst>
              </dgm:if>
              <dgm:else name="Name20">
                <dgm:constrLst>
                  <dgm:constr type="w" for="ch" forName="parentTextArrow" refType="w"/>
                  <dgm:constr type="h" for="ch" forName="parentTextArrow" refType="h"/>
                </dgm:constrLst>
              </dgm:else>
            </dgm:choose>
            <dgm:ruleLst/>
            <dgm:layoutNode name="parentTextArrow">
              <dgm:alg type="tx"/>
              <dgm:choose name="Name21">
                <dgm:if name="Name22" axis="ch" ptType="node" func="cnt" op="gte" val="1">
                  <dgm:shape xmlns:r="http://schemas.openxmlformats.org/officeDocument/2006/relationships" type="rect" r:blip="" zOrderOff="1" hideGeom="1">
                    <dgm:adjLst/>
                  </dgm:shape>
                </dgm:if>
                <dgm:else name="Name23">
                  <dgm:shape xmlns:r="http://schemas.openxmlformats.org/officeDocument/2006/relationships" rot="180" type="upArrowCallout" r:blip="">
                    <dgm:adjLst/>
                  </dgm:shape>
                </dgm:else>
              </dgm:choose>
              <dgm:presOf axis="self"/>
              <dgm:constrLst/>
              <dgm:ruleLst>
                <dgm:rule type="primFontSz" val="5" fact="NaN" max="NaN"/>
              </dgm:ruleLst>
            </dgm:layoutNode>
            <dgm:choose name="Name24">
              <dgm:if name="Name25" axis="ch" ptType="node" func="cnt" op="gte" val="1">
                <dgm:layoutNode name="arrow">
                  <dgm:alg type="sp"/>
                  <dgm:shape xmlns:r="http://schemas.openxmlformats.org/officeDocument/2006/relationships" rot="180" type="upArrowCallout" r:blip="">
                    <dgm:adjLst/>
                  </dgm:shape>
                  <dgm:presOf axis="self"/>
                  <dgm:constrLst/>
                  <dgm:ruleLst/>
                </dgm:layoutNode>
                <dgm:layoutNode name="descendantArrow">
                  <dgm:choose name="Name26">
                    <dgm:if name="Name27" func="var" arg="dir" op="equ" val="norm">
                      <dgm:alg type="lin"/>
                    </dgm:if>
                    <dgm:else name="Name28">
                      <dgm:alg type="lin">
                        <dgm:param type="linDir" val="fromR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w" for="ch" forName="childTextArrow" refType="w"/>
                    <dgm:constr type="h" for="ch" forName="childTextArrow" refType="h"/>
                  </dgm:constrLst>
                  <dgm:ruleLst/>
                  <dgm:forEach name="Name29" axis="ch" ptType="node">
                    <dgm:layoutNode name="childTextArrow" styleLbl="fgAccFollowNode1">
                      <dgm:varLst>
                        <dgm:bulletEnabled val="1"/>
                      </dgm:varLst>
                      <dgm:alg type="tx"/>
                      <dgm:shape xmlns:r="http://schemas.openxmlformats.org/officeDocument/2006/relationships" type="rect" r:blip="">
                        <dgm:adjLst/>
                      </dgm:shape>
                      <dgm:presOf axis="desOrSelf" ptType="node"/>
                      <dgm:constrLst>
                        <dgm:constr type="tMarg" refType="primFontSz" fact="0.1"/>
                        <dgm:constr type="bMarg" refType="primFontSz" fact="0.1"/>
                      </dgm:constrLst>
                      <dgm:ruleLst>
                        <dgm:rule type="primFontSz" val="5" fact="NaN" max="NaN"/>
                      </dgm:ruleLst>
                    </dgm:layoutNode>
                  </dgm:forEach>
                </dgm:layoutNode>
              </dgm:if>
              <dgm:else name="Name30"/>
            </dgm:choose>
          </dgm:layoutNode>
        </dgm:else>
      </dgm:choose>
      <dgm:forEach name="Name31" axis="precedSib" ptType="sibTrans" st="-1" cnt="1">
        <dgm:layoutNode name="sp">
          <dgm:alg type="sp"/>
          <dgm:shape xmlns:r="http://schemas.openxmlformats.org/officeDocument/2006/relationships" r:blip="">
            <dgm:adjLst/>
          </dgm:shape>
          <dgm:presOf axis="self"/>
          <dgm:constrLst/>
          <dgm:ruleLst/>
        </dgm:layoutNode>
      </dgm:forEach>
    </dgm:forEach>
  </dgm:layoutNode>
</dgm:layoutDef>
</file>

<file path=ppt/diagrams/layout5.xml><?xml version="1.0" encoding="utf-8"?>
<dgm:layoutDef xmlns:dgm="http://schemas.openxmlformats.org/drawingml/2006/diagram" xmlns:a="http://schemas.openxmlformats.org/drawingml/2006/main" uniqueId="urn:microsoft.com/office/officeart/2005/8/layout/vList2">
  <dgm:title val=""/>
  <dgm:desc val=""/>
  <dgm:catLst>
    <dgm:cat type="list" pri="3000"/>
    <dgm:cat type="convert" pri="1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2">
          <dgm:prSet phldr="1"/>
        </dgm:pt>
        <dgm:pt modelId="21">
          <dgm:prSet phldr="1"/>
        </dgm:pt>
      </dgm:ptLst>
      <dgm:cxnLst>
        <dgm:cxn modelId="4" srcId="0" destId="1" srcOrd="0" destOrd="0"/>
        <dgm:cxn modelId="5" srcId="0" destId="2" srcOrd="1" destOrd="0"/>
        <dgm:cxn modelId="12" srcId="1" destId="11" srcOrd="0" destOrd="0"/>
        <dgm:cxn modelId="23" srcId="2" destId="21" srcOrd="0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linear">
    <dgm:varLst>
      <dgm:animLvl val="lvl"/>
      <dgm:resizeHandles val="exact"/>
    </dgm:varLst>
    <dgm:alg type="lin">
      <dgm:param type="linDir" val="fromT"/>
      <dgm:param type="vertAlign" val="mid"/>
    </dgm:alg>
    <dgm:shape xmlns:r="http://schemas.openxmlformats.org/officeDocument/2006/relationships" r:blip="">
      <dgm:adjLst/>
    </dgm:shape>
    <dgm:presOf/>
    <dgm:constrLst>
      <dgm:constr type="w" for="ch" forName="parentText" refType="w"/>
      <dgm:constr type="h" for="ch" forName="parentText" refType="primFontSz" refFor="ch" refForName="parentText" fact="0.52"/>
      <dgm:constr type="w" for="ch" forName="childText" refType="w"/>
      <dgm:constr type="h" for="ch" forName="childText" refType="primFontSz" refFor="ch" refForName="parentText" fact="0.46"/>
      <dgm:constr type="h" for="ch" forName="parentText" op="equ"/>
      <dgm:constr type="primFontSz" for="ch" forName="parentText" op="equ" val="65"/>
      <dgm:constr type="primFontSz" for="ch" forName="childText" refType="primFontSz" refFor="ch" refForName="parentText" op="equ"/>
      <dgm:constr type="h" for="ch" forName="spacer" refType="primFontSz" refFor="ch" refForName="parentText" fact="0.08"/>
    </dgm:constrLst>
    <dgm:ruleLst>
      <dgm:rule type="primFontSz" for="ch" forName="parentText" val="5" fact="NaN" max="NaN"/>
    </dgm:ruleLst>
    <dgm:forEach name="Name0" axis="ch" ptType="node">
      <dgm:layoutNode name="parentText" styleLbl="node1">
        <dgm:varLst>
          <dgm:chMax val="0"/>
          <dgm:bulletEnabled val="1"/>
        </dgm:varLst>
        <dgm:alg type="tx">
          <dgm:param type="parTxLTRAlign" val="l"/>
          <dgm:param type="parTxRTLAlign" val="r"/>
        </dgm:alg>
        <dgm:shape xmlns:r="http://schemas.openxmlformats.org/officeDocument/2006/relationships" type="roundRect" r:blip="">
          <dgm:adjLst/>
        </dgm:shape>
        <dgm:presOf axis="self"/>
        <dgm:constrLst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h" val="INF" fact="NaN" max="NaN"/>
        </dgm:ruleLst>
      </dgm:layoutNode>
      <dgm:choose name="Name1">
        <dgm:if name="Name2" axis="ch" ptType="node" func="cnt" op="gte" val="1">
          <dgm:layoutNode name="childText" styleLbl="revTx">
            <dgm:varLst>
              <dgm:bulletEnabled val="1"/>
            </dgm:varLst>
            <dgm:alg type="tx">
              <dgm:param type="stBulletLvl" val="1"/>
              <dgm:param type="lnSpAfChP" val="20"/>
            </dgm:alg>
            <dgm:shape xmlns:r="http://schemas.openxmlformats.org/officeDocument/2006/relationships" type="rect" r:blip="">
              <dgm:adjLst/>
            </dgm:shape>
            <dgm:presOf axis="des" ptType="node"/>
            <dgm:constrLst>
              <dgm:constr type="tMarg" refType="primFontSz" fact="0.1"/>
              <dgm:constr type="bMarg" refType="primFontSz" fact="0.1"/>
              <dgm:constr type="lMarg" refType="w" fact="0.09"/>
            </dgm:constrLst>
            <dgm:ruleLst>
              <dgm:rule type="h" val="INF" fact="NaN" max="NaN"/>
            </dgm:ruleLst>
          </dgm:layoutNode>
        </dgm:if>
        <dgm:else name="Name3">
          <dgm:choose name="Name4">
            <dgm:if name="Name5" axis="par ch" ptType="doc node" func="cnt" op="gte" val="2">
              <dgm:forEach name="Name6" axis="followSib" ptType="sibTrans" cnt="1">
                <dgm:layoutNode name="spacer">
                  <dgm:alg type="sp"/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</dgm:layoutNode>
              </dgm:forEach>
            </dgm:if>
            <dgm:else name="Name7"/>
          </dgm:choose>
        </dgm:else>
      </dgm:choose>
    </dgm:forEach>
  </dgm:layoutNode>
</dgm:layoutDef>
</file>

<file path=ppt/diagrams/layout6.xml><?xml version="1.0" encoding="utf-8"?>
<dgm:layoutDef xmlns:dgm="http://schemas.openxmlformats.org/drawingml/2006/diagram" xmlns:a="http://schemas.openxmlformats.org/drawingml/2006/main" uniqueId="urn:microsoft.com/office/officeart/2005/8/layout/vList5">
  <dgm:title val=""/>
  <dgm:desc val=""/>
  <dgm:catLst>
    <dgm:cat type="list" pri="15000"/>
    <dgm:cat type="convert" pri="2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Name0">
    <dgm:varLst>
      <dgm:dir/>
      <dgm:animLvl val="lvl"/>
      <dgm:resizeHandles val="exact"/>
    </dgm:varLst>
    <dgm:choose name="Name1">
      <dgm:if name="Name2" func="var" arg="dir" op="equ" val="norm">
        <dgm:alg type="lin">
          <dgm:param type="linDir" val="fromT"/>
          <dgm:param type="nodeHorzAlign" val="l"/>
        </dgm:alg>
      </dgm:if>
      <dgm:else name="Name3">
        <dgm:alg type="lin">
          <dgm:param type="linDir" val="fromT"/>
          <dgm:param type="nodeHorzAlign" val="r"/>
        </dgm:alg>
      </dgm:else>
    </dgm:choose>
    <dgm:shape xmlns:r="http://schemas.openxmlformats.org/officeDocument/2006/relationships" r:blip="">
      <dgm:adjLst/>
    </dgm:shape>
    <dgm:presOf/>
    <dgm:constrLst>
      <dgm:constr type="h" for="ch" forName="linNode" refType="h"/>
      <dgm:constr type="w" for="ch" forName="linNode" refType="w"/>
      <dgm:constr type="h" for="ch" forName="sp" refType="h" fact="0.05"/>
      <dgm:constr type="primFontSz" for="des" forName="parentText" op="equ" val="65"/>
      <dgm:constr type="secFontSz" for="des" forName="descendantText" op="equ"/>
    </dgm:constrLst>
    <dgm:ruleLst/>
    <dgm:forEach name="Name4" axis="ch" ptType="node">
      <dgm:layoutNode name="linNode">
        <dgm:choose name="Name5">
          <dgm:if name="Name6" func="var" arg="dir" op="equ" val="norm">
            <dgm:alg type="lin">
              <dgm:param type="linDir" val="fromL"/>
            </dgm:alg>
          </dgm:if>
          <dgm:else name="Name7">
            <dgm:alg type="lin">
              <dgm:param type="linDir" val="fromR"/>
            </dgm:alg>
          </dgm:else>
        </dgm:choose>
        <dgm:shape xmlns:r="http://schemas.openxmlformats.org/officeDocument/2006/relationships" r:blip="">
          <dgm:adjLst/>
        </dgm:shape>
        <dgm:presOf/>
        <dgm:constrLst>
          <dgm:constr type="w" for="ch" forName="parentText" refType="w" fact="0.36"/>
          <dgm:constr type="w" for="ch" forName="descendantText" refType="w" fact="0.64"/>
          <dgm:constr type="h" for="ch" forName="parentText" refType="h"/>
          <dgm:constr type="h" for="ch" forName="descendantText" refType="h" refFor="ch" refForName="parentText" fact="0.8"/>
        </dgm:constrLst>
        <dgm:ruleLst/>
        <dgm:layoutNode name="parentText">
          <dgm:varLst>
            <dgm:chMax val="1"/>
            <dgm:bulletEnabled val="1"/>
          </dgm:varLst>
          <dgm:alg type="tx"/>
          <dgm:shape xmlns:r="http://schemas.openxmlformats.org/officeDocument/2006/relationships" type="roundRect" r:blip="" zOrderOff="3">
            <dgm:adjLst/>
          </dgm:shape>
          <dgm:presOf axis="self" ptType="node"/>
          <dgm:constrLst>
            <dgm:constr type="tMarg" refType="primFontSz" fact="0.15"/>
            <dgm:constr type="bMarg" refType="primFontSz" fact="0.15"/>
            <dgm:constr type="lMarg" refType="primFontSz" fact="0.3"/>
            <dgm:constr type="rMarg" refType="primFontSz" fact="0.3"/>
          </dgm:constrLst>
          <dgm:ruleLst>
            <dgm:rule type="primFontSz" val="5" fact="NaN" max="NaN"/>
          </dgm:ruleLst>
        </dgm:layoutNode>
        <dgm:choose name="Name8">
          <dgm:if name="Name9" axis="ch" ptType="node" func="cnt" op="gte" val="1">
            <dgm:layoutNode name="descendantText" styleLbl="alignAccFollowNode1">
              <dgm:varLst>
                <dgm:bulletEnabled val="1"/>
              </dgm:varLst>
              <dgm:alg type="tx">
                <dgm:param type="stBulletLvl" val="1"/>
                <dgm:param type="txAnchorVertCh" val="mid"/>
              </dgm:alg>
              <dgm:choose name="Name10">
                <dgm:if name="Name11" func="var" arg="dir" op="equ" val="norm">
                  <dgm:shape xmlns:r="http://schemas.openxmlformats.org/officeDocument/2006/relationships" rot="90" type="round2SameRect" r:blip="">
                    <dgm:adjLst/>
                  </dgm:shape>
                </dgm:if>
                <dgm:else name="Name12">
                  <dgm:shape xmlns:r="http://schemas.openxmlformats.org/officeDocument/2006/relationships" rot="-90" type="round2SameRect" r:blip="">
                    <dgm:adjLst/>
                  </dgm:shape>
                </dgm:else>
              </dgm:choose>
              <dgm:presOf axis="des" ptType="node"/>
              <dgm:constrLst>
                <dgm:constr type="secFontSz" val="65"/>
                <dgm:constr type="primFontSz" refType="secFontSz"/>
                <dgm:constr type="lMarg" refType="secFontSz" fact="0.3"/>
                <dgm:constr type="rMarg" refType="secFontSz" fact="0.3"/>
                <dgm:constr type="tMarg" refType="secFontSz" fact="0.15"/>
                <dgm:constr type="bMarg" refType="secFontSz" fact="0.15"/>
              </dgm:constrLst>
              <dgm:ruleLst>
                <dgm:rule type="secFontSz" val="5" fact="NaN" max="NaN"/>
              </dgm:ruleLst>
            </dgm:layoutNode>
          </dgm:if>
          <dgm:else name="Name13"/>
        </dgm:choose>
      </dgm:layoutNode>
      <dgm:forEach name="Name14" axis="followSib" ptType="sibTrans" cnt="1">
        <dgm:layoutNode name="sp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layout7.xml><?xml version="1.0" encoding="utf-8"?>
<dgm:layoutDef xmlns:dgm="http://schemas.openxmlformats.org/drawingml/2006/diagram" xmlns:a="http://schemas.openxmlformats.org/drawingml/2006/main" uniqueId="urn:microsoft.com/office/officeart/2005/8/layout/vList2">
  <dgm:title val=""/>
  <dgm:desc val=""/>
  <dgm:catLst>
    <dgm:cat type="list" pri="3000"/>
    <dgm:cat type="convert" pri="1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2">
          <dgm:prSet phldr="1"/>
        </dgm:pt>
        <dgm:pt modelId="21">
          <dgm:prSet phldr="1"/>
        </dgm:pt>
      </dgm:ptLst>
      <dgm:cxnLst>
        <dgm:cxn modelId="4" srcId="0" destId="1" srcOrd="0" destOrd="0"/>
        <dgm:cxn modelId="5" srcId="0" destId="2" srcOrd="1" destOrd="0"/>
        <dgm:cxn modelId="12" srcId="1" destId="11" srcOrd="0" destOrd="0"/>
        <dgm:cxn modelId="23" srcId="2" destId="21" srcOrd="0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linear">
    <dgm:varLst>
      <dgm:animLvl val="lvl"/>
      <dgm:resizeHandles val="exact"/>
    </dgm:varLst>
    <dgm:alg type="lin">
      <dgm:param type="linDir" val="fromT"/>
      <dgm:param type="vertAlign" val="mid"/>
    </dgm:alg>
    <dgm:shape xmlns:r="http://schemas.openxmlformats.org/officeDocument/2006/relationships" r:blip="">
      <dgm:adjLst/>
    </dgm:shape>
    <dgm:presOf/>
    <dgm:constrLst>
      <dgm:constr type="w" for="ch" forName="parentText" refType="w"/>
      <dgm:constr type="h" for="ch" forName="parentText" refType="primFontSz" refFor="ch" refForName="parentText" fact="0.52"/>
      <dgm:constr type="w" for="ch" forName="childText" refType="w"/>
      <dgm:constr type="h" for="ch" forName="childText" refType="primFontSz" refFor="ch" refForName="parentText" fact="0.46"/>
      <dgm:constr type="h" for="ch" forName="parentText" op="equ"/>
      <dgm:constr type="primFontSz" for="ch" forName="parentText" op="equ" val="65"/>
      <dgm:constr type="primFontSz" for="ch" forName="childText" refType="primFontSz" refFor="ch" refForName="parentText" op="equ"/>
      <dgm:constr type="h" for="ch" forName="spacer" refType="primFontSz" refFor="ch" refForName="parentText" fact="0.08"/>
    </dgm:constrLst>
    <dgm:ruleLst>
      <dgm:rule type="primFontSz" for="ch" forName="parentText" val="5" fact="NaN" max="NaN"/>
    </dgm:ruleLst>
    <dgm:forEach name="Name0" axis="ch" ptType="node">
      <dgm:layoutNode name="parentText" styleLbl="node1">
        <dgm:varLst>
          <dgm:chMax val="0"/>
          <dgm:bulletEnabled val="1"/>
        </dgm:varLst>
        <dgm:alg type="tx">
          <dgm:param type="parTxLTRAlign" val="l"/>
          <dgm:param type="parTxRTLAlign" val="r"/>
        </dgm:alg>
        <dgm:shape xmlns:r="http://schemas.openxmlformats.org/officeDocument/2006/relationships" type="roundRect" r:blip="">
          <dgm:adjLst/>
        </dgm:shape>
        <dgm:presOf axis="self"/>
        <dgm:constrLst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h" val="INF" fact="NaN" max="NaN"/>
        </dgm:ruleLst>
      </dgm:layoutNode>
      <dgm:choose name="Name1">
        <dgm:if name="Name2" axis="ch" ptType="node" func="cnt" op="gte" val="1">
          <dgm:layoutNode name="childText" styleLbl="revTx">
            <dgm:varLst>
              <dgm:bulletEnabled val="1"/>
            </dgm:varLst>
            <dgm:alg type="tx">
              <dgm:param type="stBulletLvl" val="1"/>
              <dgm:param type="lnSpAfChP" val="20"/>
            </dgm:alg>
            <dgm:shape xmlns:r="http://schemas.openxmlformats.org/officeDocument/2006/relationships" type="rect" r:blip="">
              <dgm:adjLst/>
            </dgm:shape>
            <dgm:presOf axis="des" ptType="node"/>
            <dgm:constrLst>
              <dgm:constr type="tMarg" refType="primFontSz" fact="0.1"/>
              <dgm:constr type="bMarg" refType="primFontSz" fact="0.1"/>
              <dgm:constr type="lMarg" refType="w" fact="0.09"/>
            </dgm:constrLst>
            <dgm:ruleLst>
              <dgm:rule type="h" val="INF" fact="NaN" max="NaN"/>
            </dgm:ruleLst>
          </dgm:layoutNode>
        </dgm:if>
        <dgm:else name="Name3">
          <dgm:choose name="Name4">
            <dgm:if name="Name5" axis="par ch" ptType="doc node" func="cnt" op="gte" val="2">
              <dgm:forEach name="Name6" axis="followSib" ptType="sibTrans" cnt="1">
                <dgm:layoutNode name="spacer">
                  <dgm:alg type="sp"/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</dgm:layoutNode>
              </dgm:forEach>
            </dgm:if>
            <dgm:else name="Name7"/>
          </dgm:choose>
        </dgm:else>
      </dgm:choose>
    </dgm:forEach>
  </dgm:layoutNode>
</dgm:layoutDef>
</file>

<file path=ppt/diagrams/layout8.xml><?xml version="1.0" encoding="utf-8"?>
<dgm:layoutDef xmlns:dgm="http://schemas.openxmlformats.org/drawingml/2006/diagram" xmlns:a="http://schemas.openxmlformats.org/drawingml/2006/main" uniqueId="urn:microsoft.com/office/officeart/2005/8/layout/vList2">
  <dgm:title val=""/>
  <dgm:desc val=""/>
  <dgm:catLst>
    <dgm:cat type="list" pri="3000"/>
    <dgm:cat type="convert" pri="1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2">
          <dgm:prSet phldr="1"/>
        </dgm:pt>
        <dgm:pt modelId="21">
          <dgm:prSet phldr="1"/>
        </dgm:pt>
      </dgm:ptLst>
      <dgm:cxnLst>
        <dgm:cxn modelId="4" srcId="0" destId="1" srcOrd="0" destOrd="0"/>
        <dgm:cxn modelId="5" srcId="0" destId="2" srcOrd="1" destOrd="0"/>
        <dgm:cxn modelId="12" srcId="1" destId="11" srcOrd="0" destOrd="0"/>
        <dgm:cxn modelId="23" srcId="2" destId="21" srcOrd="0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linear">
    <dgm:varLst>
      <dgm:animLvl val="lvl"/>
      <dgm:resizeHandles val="exact"/>
    </dgm:varLst>
    <dgm:alg type="lin">
      <dgm:param type="linDir" val="fromT"/>
      <dgm:param type="vertAlign" val="mid"/>
    </dgm:alg>
    <dgm:shape xmlns:r="http://schemas.openxmlformats.org/officeDocument/2006/relationships" r:blip="">
      <dgm:adjLst/>
    </dgm:shape>
    <dgm:presOf/>
    <dgm:constrLst>
      <dgm:constr type="w" for="ch" forName="parentText" refType="w"/>
      <dgm:constr type="h" for="ch" forName="parentText" refType="primFontSz" refFor="ch" refForName="parentText" fact="0.52"/>
      <dgm:constr type="w" for="ch" forName="childText" refType="w"/>
      <dgm:constr type="h" for="ch" forName="childText" refType="primFontSz" refFor="ch" refForName="parentText" fact="0.46"/>
      <dgm:constr type="h" for="ch" forName="parentText" op="equ"/>
      <dgm:constr type="primFontSz" for="ch" forName="parentText" op="equ" val="65"/>
      <dgm:constr type="primFontSz" for="ch" forName="childText" refType="primFontSz" refFor="ch" refForName="parentText" op="equ"/>
      <dgm:constr type="h" for="ch" forName="spacer" refType="primFontSz" refFor="ch" refForName="parentText" fact="0.08"/>
    </dgm:constrLst>
    <dgm:ruleLst>
      <dgm:rule type="primFontSz" for="ch" forName="parentText" val="5" fact="NaN" max="NaN"/>
    </dgm:ruleLst>
    <dgm:forEach name="Name0" axis="ch" ptType="node">
      <dgm:layoutNode name="parentText" styleLbl="node1">
        <dgm:varLst>
          <dgm:chMax val="0"/>
          <dgm:bulletEnabled val="1"/>
        </dgm:varLst>
        <dgm:alg type="tx">
          <dgm:param type="parTxLTRAlign" val="l"/>
          <dgm:param type="parTxRTLAlign" val="r"/>
        </dgm:alg>
        <dgm:shape xmlns:r="http://schemas.openxmlformats.org/officeDocument/2006/relationships" type="roundRect" r:blip="">
          <dgm:adjLst/>
        </dgm:shape>
        <dgm:presOf axis="self"/>
        <dgm:constrLst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h" val="INF" fact="NaN" max="NaN"/>
        </dgm:ruleLst>
      </dgm:layoutNode>
      <dgm:choose name="Name1">
        <dgm:if name="Name2" axis="ch" ptType="node" func="cnt" op="gte" val="1">
          <dgm:layoutNode name="childText" styleLbl="revTx">
            <dgm:varLst>
              <dgm:bulletEnabled val="1"/>
            </dgm:varLst>
            <dgm:alg type="tx">
              <dgm:param type="stBulletLvl" val="1"/>
              <dgm:param type="lnSpAfChP" val="20"/>
            </dgm:alg>
            <dgm:shape xmlns:r="http://schemas.openxmlformats.org/officeDocument/2006/relationships" type="rect" r:blip="">
              <dgm:adjLst/>
            </dgm:shape>
            <dgm:presOf axis="des" ptType="node"/>
            <dgm:constrLst>
              <dgm:constr type="tMarg" refType="primFontSz" fact="0.1"/>
              <dgm:constr type="bMarg" refType="primFontSz" fact="0.1"/>
              <dgm:constr type="lMarg" refType="w" fact="0.09"/>
            </dgm:constrLst>
            <dgm:ruleLst>
              <dgm:rule type="h" val="INF" fact="NaN" max="NaN"/>
            </dgm:ruleLst>
          </dgm:layoutNode>
        </dgm:if>
        <dgm:else name="Name3">
          <dgm:choose name="Name4">
            <dgm:if name="Name5" axis="par ch" ptType="doc node" func="cnt" op="gte" val="2">
              <dgm:forEach name="Name6" axis="followSib" ptType="sibTrans" cnt="1">
                <dgm:layoutNode name="spacer">
                  <dgm:alg type="sp"/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</dgm:layoutNode>
              </dgm:forEach>
            </dgm:if>
            <dgm:else name="Name7"/>
          </dgm:choose>
        </dgm:else>
      </dgm:choos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3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4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5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6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7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8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38145" cy="464205"/>
          </a:xfrm>
          <a:prstGeom prst="rect">
            <a:avLst/>
          </a:prstGeom>
        </p:spPr>
        <p:txBody>
          <a:bodyPr vert="horz" lIns="88139" tIns="44070" rIns="88139" bIns="4407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734" y="1"/>
            <a:ext cx="3038145" cy="464205"/>
          </a:xfrm>
          <a:prstGeom prst="rect">
            <a:avLst/>
          </a:prstGeom>
        </p:spPr>
        <p:txBody>
          <a:bodyPr vert="horz" lIns="88139" tIns="44070" rIns="88139" bIns="44070" rtlCol="0"/>
          <a:lstStyle>
            <a:lvl1pPr algn="r">
              <a:defRPr sz="1200"/>
            </a:lvl1pPr>
          </a:lstStyle>
          <a:p>
            <a:fld id="{1C53532B-C57D-4D24-B5CC-FD4E156EBF4C}" type="datetimeFigureOut">
              <a:rPr lang="en-US" smtClean="0"/>
              <a:pPr/>
              <a:t>4/22/22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30659"/>
            <a:ext cx="3038145" cy="464205"/>
          </a:xfrm>
          <a:prstGeom prst="rect">
            <a:avLst/>
          </a:prstGeom>
        </p:spPr>
        <p:txBody>
          <a:bodyPr vert="horz" lIns="88139" tIns="44070" rIns="88139" bIns="4407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734" y="8830659"/>
            <a:ext cx="3038145" cy="464205"/>
          </a:xfrm>
          <a:prstGeom prst="rect">
            <a:avLst/>
          </a:prstGeom>
        </p:spPr>
        <p:txBody>
          <a:bodyPr vert="horz" lIns="88139" tIns="44070" rIns="88139" bIns="44070" rtlCol="0" anchor="b"/>
          <a:lstStyle>
            <a:lvl1pPr algn="r">
              <a:defRPr sz="1200"/>
            </a:lvl1pPr>
          </a:lstStyle>
          <a:p>
            <a:fld id="{F320033E-69DD-47DE-B3F6-3166F8E20CF8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0638142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2" tIns="46586" rIns="93172" bIns="46586" rtlCol="0"/>
          <a:lstStyle>
            <a:lvl1pPr algn="l">
              <a:defRPr sz="13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2" tIns="46586" rIns="93172" bIns="46586" rtlCol="0"/>
          <a:lstStyle>
            <a:lvl1pPr algn="r">
              <a:defRPr sz="1300"/>
            </a:lvl1pPr>
          </a:lstStyle>
          <a:p>
            <a:fld id="{FA7AFE93-D4DC-0B4F-94AB-7CE5EAF59665}" type="datetimeFigureOut">
              <a:rPr lang="en-US" smtClean="0"/>
              <a:pPr/>
              <a:t>4/22/22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8500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2" tIns="46586" rIns="93172" bIns="46586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2" tIns="46586" rIns="93172" bIns="46586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2" tIns="46586" rIns="93172" bIns="46586" rtlCol="0" anchor="b"/>
          <a:lstStyle>
            <a:lvl1pPr algn="l">
              <a:defRPr sz="13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2" tIns="46586" rIns="93172" bIns="46586" rtlCol="0" anchor="b"/>
          <a:lstStyle>
            <a:lvl1pPr algn="r">
              <a:defRPr sz="1300"/>
            </a:lvl1pPr>
          </a:lstStyle>
          <a:p>
            <a:fld id="{8BBF9976-16FA-684A-9B34-75E06317153C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896672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0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1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4.xml"/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6.xml"/><Relationship Id="rId1" Type="http://schemas.openxmlformats.org/officeDocument/2006/relationships/notesMaster" Target="../notesMasters/notesMaster1.xml"/></Relationships>
</file>

<file path=ppt/notesSlides/_rels/notesSlide2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7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BF9976-16FA-684A-9B34-75E06317153C}" type="slidenum">
              <a:rPr lang="en-US" smtClean="0"/>
              <a:t>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06312013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BF9976-16FA-684A-9B34-75E06317153C}" type="slidenum">
              <a:rPr lang="en-US" smtClean="0"/>
              <a:t>1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69220266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BF9976-16FA-684A-9B34-75E06317153C}" type="slidenum">
              <a:rPr lang="en-US" smtClean="0"/>
              <a:t>1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91810549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BF9976-16FA-684A-9B34-75E06317153C}" type="slidenum">
              <a:rPr lang="en-US" smtClean="0"/>
              <a:t>1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61816292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BF9976-16FA-684A-9B34-75E06317153C}" type="slidenum">
              <a:rPr lang="en-US" smtClean="0"/>
              <a:t>18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86316213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30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1287463" y="906463"/>
            <a:ext cx="4143375" cy="3108325"/>
          </a:xfrm>
          <a:solidFill>
            <a:srgbClr val="FFFFFF"/>
          </a:solidFill>
          <a:ln/>
        </p:spPr>
      </p:sp>
      <p:sp>
        <p:nvSpPr>
          <p:cNvPr id="22531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1024853" y="4314674"/>
            <a:ext cx="4673262" cy="3448926"/>
          </a:xfrm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pPr defTabSz="449068"/>
            <a:endParaRPr lang="en-US" altLang="en-US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134894633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BF9976-16FA-684A-9B34-75E06317153C}" type="slidenum">
              <a:rPr lang="en-US" smtClean="0"/>
              <a:pPr/>
              <a:t>20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19560141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BF9976-16FA-684A-9B34-75E06317153C}" type="slidenum">
              <a:rPr lang="en-US" smtClean="0"/>
              <a:pPr/>
              <a:t>2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85403240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BF9976-16FA-684A-9B34-75E06317153C}" type="slidenum">
              <a:rPr lang="en-US" smtClean="0"/>
              <a:pPr/>
              <a:t>2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67227442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BF9976-16FA-684A-9B34-75E06317153C}" type="slidenum">
              <a:rPr lang="en-US" smtClean="0"/>
              <a:pPr/>
              <a:t>2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42148384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BF9976-16FA-684A-9B34-75E06317153C}" type="slidenum">
              <a:rPr lang="en-US" smtClean="0"/>
              <a:pPr/>
              <a:t>2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3024022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BF9976-16FA-684A-9B34-75E06317153C}" type="slidenum">
              <a:rPr lang="en-US" smtClean="0"/>
              <a:t>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23211651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BF9976-16FA-684A-9B34-75E06317153C}" type="slidenum">
              <a:rPr lang="en-US" smtClean="0"/>
              <a:pPr/>
              <a:t>2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26108772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BF9976-16FA-684A-9B34-75E06317153C}" type="slidenum">
              <a:rPr lang="en-US" smtClean="0"/>
              <a:pPr/>
              <a:t>2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8359357"/>
      </p:ext>
    </p:extLst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BF9976-16FA-684A-9B34-75E06317153C}" type="slidenum">
              <a:rPr lang="en-US" smtClean="0"/>
              <a:pPr/>
              <a:t>28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93504539"/>
      </p:ext>
    </p:extLst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BF9976-16FA-684A-9B34-75E06317153C}" type="slidenum">
              <a:rPr lang="en-US" smtClean="0"/>
              <a:pPr/>
              <a:t>2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34349571"/>
      </p:ext>
    </p:extLst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BF9976-16FA-684A-9B34-75E06317153C}" type="slidenum">
              <a:rPr lang="en-US" smtClean="0"/>
              <a:pPr/>
              <a:t>30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7272516"/>
      </p:ext>
    </p:extLst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BF9976-16FA-684A-9B34-75E06317153C}" type="slidenum">
              <a:rPr lang="en-US" smtClean="0"/>
              <a:pPr/>
              <a:t>3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12999087"/>
      </p:ext>
    </p:extLst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BF9976-16FA-684A-9B34-75E06317153C}" type="slidenum">
              <a:rPr lang="en-US" smtClean="0"/>
              <a:pPr/>
              <a:t>3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74082986"/>
      </p:ext>
    </p:extLst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BF9976-16FA-684A-9B34-75E06317153C}" type="slidenum">
              <a:rPr lang="en-US" smtClean="0"/>
              <a:pPr/>
              <a:t>3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9074365"/>
      </p:ext>
    </p:extLst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BF9976-16FA-684A-9B34-75E06317153C}" type="slidenum">
              <a:rPr lang="en-US" smtClean="0"/>
              <a:pPr/>
              <a:t>3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7293195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BF9976-16FA-684A-9B34-75E06317153C}" type="slidenum">
              <a:rPr lang="en-US" smtClean="0"/>
              <a:t>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3575134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BF9976-16FA-684A-9B34-75E06317153C}" type="slidenum">
              <a:rPr lang="en-US" smtClean="0"/>
              <a:t>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5473709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BF9976-16FA-684A-9B34-75E06317153C}" type="slidenum">
              <a:rPr lang="en-US" smtClean="0"/>
              <a:t>8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9695809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BF9976-16FA-684A-9B34-75E06317153C}" type="slidenum">
              <a:rPr lang="en-US" smtClean="0"/>
              <a:pPr/>
              <a:t>10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7957969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BF9976-16FA-684A-9B34-75E06317153C}" type="slidenum">
              <a:rPr lang="en-US" smtClean="0"/>
              <a:t>1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2132528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BF9976-16FA-684A-9B34-75E06317153C}" type="slidenum">
              <a:rPr lang="en-US" smtClean="0"/>
              <a:t>1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1950984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BF9976-16FA-684A-9B34-75E06317153C}" type="slidenum">
              <a:rPr lang="en-US" smtClean="0"/>
              <a:t>1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366071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/>
              <a:t>4/22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665501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/>
              <a:t>4/22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749194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/>
              <a:t>4/22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0561364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710112" y="2103120"/>
            <a:ext cx="3976687" cy="1898429"/>
          </a:xfrm>
        </p:spPr>
        <p:txBody>
          <a:bodyPr>
            <a:noAutofit/>
          </a:bodyPr>
          <a:lstStyle>
            <a:lvl1pPr>
              <a:defRPr sz="3000">
                <a:solidFill>
                  <a:schemeClr val="tx1"/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4710112" y="4331020"/>
            <a:ext cx="3976687" cy="580938"/>
          </a:xfrm>
        </p:spPr>
        <p:txBody>
          <a:bodyPr anchor="t" anchorCtr="0"/>
          <a:lstStyle>
            <a:lvl1pPr marL="0" indent="0" algn="l" defTabSz="457200" rtl="0" eaLnBrk="1" latinLnBrk="0" hangingPunct="1">
              <a:spcBef>
                <a:spcPts val="0"/>
              </a:spcBef>
              <a:buFontTx/>
              <a:buNone/>
              <a:defRPr lang="en-US" sz="1600" b="0" kern="1200" smtClean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lvl1pPr>
            <a:lvl2pPr>
              <a:defRPr sz="1600"/>
            </a:lvl2pPr>
            <a:lvl3pPr>
              <a:defRPr sz="16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indent="-3657600"/>
            <a:r>
              <a:rPr lang="en-US" dirty="0"/>
              <a:t>Month Day, Year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5E8BC936-0928-C346-B13E-04BD58031644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5072248"/>
            <a:ext cx="2343917" cy="12771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3122186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Agena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58788" y="1373188"/>
            <a:ext cx="8229600" cy="796925"/>
          </a:xfrm>
        </p:spPr>
        <p:txBody>
          <a:bodyPr>
            <a:noAutofit/>
          </a:bodyPr>
          <a:lstStyle>
            <a:lvl1pPr>
              <a:defRPr sz="4400" b="0">
                <a:solidFill>
                  <a:schemeClr val="accent1"/>
                </a:solidFill>
              </a:defRPr>
            </a:lvl1pPr>
          </a:lstStyle>
          <a:p>
            <a:r>
              <a:rPr lang="en-US"/>
              <a:t>Today’s Agenda</a:t>
            </a:r>
          </a:p>
        </p:txBody>
      </p:sp>
      <p:sp>
        <p:nvSpPr>
          <p:cNvPr id="9" name="Content Placeholder 8"/>
          <p:cNvSpPr>
            <a:spLocks noGrp="1"/>
          </p:cNvSpPr>
          <p:nvPr>
            <p:ph sz="quarter" idx="12"/>
          </p:nvPr>
        </p:nvSpPr>
        <p:spPr>
          <a:xfrm>
            <a:off x="457200" y="2286000"/>
            <a:ext cx="8229600" cy="3657600"/>
          </a:xfrm>
        </p:spPr>
        <p:txBody>
          <a:bodyPr>
            <a:noAutofit/>
          </a:bodyPr>
          <a:lstStyle>
            <a:lvl1pPr marL="342900" indent="-342900">
              <a:buFont typeface="+mj-lt"/>
              <a:buAutoNum type="arabicPeriod"/>
              <a:defRPr sz="2800" baseline="0">
                <a:solidFill>
                  <a:schemeClr val="accent1"/>
                </a:solidFill>
              </a:defRPr>
            </a:lvl1pPr>
            <a:lvl2pPr marL="628650" indent="-284163">
              <a:buFont typeface="Arial" panose="020B0604020202020204" pitchFamily="34" charset="0"/>
              <a:buChar char="•"/>
              <a:defRPr sz="2800">
                <a:solidFill>
                  <a:schemeClr val="accent1"/>
                </a:solidFill>
              </a:defRPr>
            </a:lvl2pPr>
            <a:lvl3pPr marL="630936" indent="-283464">
              <a:buFont typeface="Arial" panose="020B0604020202020204" pitchFamily="34" charset="0"/>
              <a:buChar char="•"/>
              <a:defRPr sz="2800">
                <a:solidFill>
                  <a:schemeClr val="accent1"/>
                </a:solidFill>
              </a:defRPr>
            </a:lvl3pPr>
            <a:lvl4pPr marL="630936" indent="-283464">
              <a:buFont typeface="Arial" panose="020B0604020202020204" pitchFamily="34" charset="0"/>
              <a:buChar char="•"/>
              <a:defRPr sz="2800">
                <a:solidFill>
                  <a:srgbClr val="003CA5"/>
                </a:solidFill>
              </a:defRPr>
            </a:lvl4pPr>
            <a:lvl5pPr marL="630936" indent="-283464">
              <a:buFont typeface="Arial" panose="020B0604020202020204" pitchFamily="34" charset="0"/>
              <a:buChar char="•"/>
              <a:defRPr sz="2800">
                <a:solidFill>
                  <a:srgbClr val="003CA5"/>
                </a:solidFill>
              </a:defRPr>
            </a:lvl5pPr>
            <a:lvl6pPr marL="630936" indent="-283464">
              <a:buFont typeface="Arial" panose="020B0604020202020204" pitchFamily="34" charset="0"/>
              <a:buChar char="•"/>
              <a:defRPr sz="2800">
                <a:solidFill>
                  <a:schemeClr val="accent1"/>
                </a:solidFill>
              </a:defRPr>
            </a:lvl6pPr>
            <a:lvl7pPr marL="630936" indent="-283464">
              <a:buFont typeface="Arial" panose="020B0604020202020204" pitchFamily="34" charset="0"/>
              <a:buChar char="•"/>
              <a:defRPr sz="2800">
                <a:solidFill>
                  <a:srgbClr val="003CA5"/>
                </a:solidFill>
              </a:defRPr>
            </a:lvl7pPr>
            <a:lvl8pPr marL="630936" indent="-283464">
              <a:buFont typeface="Arial" panose="020B0604020202020204" pitchFamily="34" charset="0"/>
              <a:buChar char="•"/>
              <a:defRPr sz="2800">
                <a:solidFill>
                  <a:srgbClr val="003CA5"/>
                </a:solidFill>
              </a:defRPr>
            </a:lvl8pPr>
            <a:lvl9pPr marL="630936" indent="-283464">
              <a:buFont typeface="Arial" panose="020B0604020202020204" pitchFamily="34" charset="0"/>
              <a:buChar char="•"/>
              <a:defRPr sz="2800">
                <a:solidFill>
                  <a:srgbClr val="003CA5"/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3"/>
          </p:nvPr>
        </p:nvSpPr>
        <p:spPr/>
        <p:txBody>
          <a:bodyPr/>
          <a:lstStyle/>
          <a:p>
            <a:r>
              <a:rPr lang="en-US" dirty="0"/>
              <a:t>Month Day, Year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4"/>
          </p:nvPr>
        </p:nvSpPr>
        <p:spPr/>
        <p:txBody>
          <a:bodyPr/>
          <a:lstStyle/>
          <a:p>
            <a:fld id="{5E8BC936-0928-C346-B13E-04BD58031644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6254496"/>
            <a:ext cx="1536195" cy="4114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485867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-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solidFill>
                  <a:schemeClr val="accent1"/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9" name="Content Placeholder 8"/>
          <p:cNvSpPr>
            <a:spLocks noGrp="1"/>
          </p:cNvSpPr>
          <p:nvPr>
            <p:ph sz="quarter" idx="10"/>
          </p:nvPr>
        </p:nvSpPr>
        <p:spPr>
          <a:xfrm>
            <a:off x="458788" y="1373188"/>
            <a:ext cx="3975100" cy="4572000"/>
          </a:xfrm>
        </p:spPr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  <a:lvl2pPr>
              <a:defRPr>
                <a:solidFill>
                  <a:schemeClr val="tx1"/>
                </a:solidFill>
              </a:defRPr>
            </a:lvl2pPr>
            <a:lvl3pPr>
              <a:defRPr>
                <a:solidFill>
                  <a:schemeClr val="tx1"/>
                </a:solidFill>
              </a:defRPr>
            </a:lvl3pPr>
            <a:lvl4pPr>
              <a:defRPr>
                <a:solidFill>
                  <a:schemeClr val="tx1"/>
                </a:solidFill>
              </a:defRPr>
            </a:lvl4pPr>
            <a:lvl5pPr>
              <a:defRPr>
                <a:solidFill>
                  <a:schemeClr val="tx1"/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1" name="Content Placeholder 10"/>
          <p:cNvSpPr>
            <a:spLocks noGrp="1"/>
          </p:cNvSpPr>
          <p:nvPr>
            <p:ph sz="quarter" idx="11"/>
          </p:nvPr>
        </p:nvSpPr>
        <p:spPr>
          <a:xfrm>
            <a:off x="4710113" y="1373188"/>
            <a:ext cx="3976687" cy="4572000"/>
          </a:xfrm>
        </p:spPr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  <a:lvl2pPr>
              <a:defRPr>
                <a:solidFill>
                  <a:schemeClr val="tx1"/>
                </a:solidFill>
              </a:defRPr>
            </a:lvl2pPr>
            <a:lvl3pPr>
              <a:defRPr>
                <a:solidFill>
                  <a:schemeClr val="tx1"/>
                </a:solidFill>
              </a:defRPr>
            </a:lvl3pPr>
            <a:lvl4pPr>
              <a:defRPr>
                <a:solidFill>
                  <a:schemeClr val="tx1"/>
                </a:solidFill>
              </a:defRPr>
            </a:lvl4pPr>
            <a:lvl5pPr>
              <a:defRPr>
                <a:solidFill>
                  <a:schemeClr val="tx1"/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2"/>
          </p:nvPr>
        </p:nvSpPr>
        <p:spPr/>
        <p:txBody>
          <a:bodyPr/>
          <a:lstStyle/>
          <a:p>
            <a:r>
              <a:rPr lang="en-US" dirty="0"/>
              <a:t>Month Day, Year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5E8BC936-0928-C346-B13E-04BD58031644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6254496"/>
            <a:ext cx="1536195" cy="4114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5850623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ptional Presentation Cov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58788" y="1373187"/>
            <a:ext cx="8229600" cy="4568825"/>
          </a:xfrm>
        </p:spPr>
        <p:txBody>
          <a:bodyPr>
            <a:noAutofit/>
          </a:bodyPr>
          <a:lstStyle>
            <a:lvl1pPr>
              <a:defRPr sz="4400" b="0" baseline="0">
                <a:solidFill>
                  <a:schemeClr val="accent1"/>
                </a:solidFill>
              </a:defRPr>
            </a:lvl1pPr>
          </a:lstStyle>
          <a:p>
            <a:r>
              <a:rPr lang="en-US"/>
              <a:t>Optional Presentation Cover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US" dirty="0"/>
              <a:t>Month Day, Year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5E8BC936-0928-C346-B13E-04BD58031644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6254496"/>
            <a:ext cx="1536195" cy="4114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9338492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Slide 2-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solidFill>
                  <a:schemeClr val="accent1"/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2"/>
          </p:nvPr>
        </p:nvSpPr>
        <p:spPr/>
        <p:txBody>
          <a:bodyPr/>
          <a:lstStyle/>
          <a:p>
            <a:r>
              <a:rPr lang="en-US" dirty="0"/>
              <a:t>Month Day, Year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5E8BC936-0928-C346-B13E-04BD58031644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0" name="Content Placeholder 8"/>
          <p:cNvSpPr>
            <a:spLocks noGrp="1"/>
          </p:cNvSpPr>
          <p:nvPr>
            <p:ph sz="quarter" idx="14"/>
          </p:nvPr>
        </p:nvSpPr>
        <p:spPr>
          <a:xfrm>
            <a:off x="457200" y="1371600"/>
            <a:ext cx="3977640" cy="4572000"/>
          </a:xfrm>
        </p:spPr>
        <p:txBody>
          <a:bodyPr>
            <a:noAutofit/>
          </a:bodyPr>
          <a:lstStyle>
            <a:lvl1pPr>
              <a:defRPr sz="2400">
                <a:solidFill>
                  <a:schemeClr val="tx2"/>
                </a:solidFill>
              </a:defRPr>
            </a:lvl1pPr>
            <a:lvl2pPr marL="173736" indent="-173736">
              <a:buFont typeface="Arial" panose="020B0604020202020204" pitchFamily="34" charset="0"/>
              <a:buChar char="•"/>
              <a:defRPr sz="2400">
                <a:solidFill>
                  <a:schemeClr val="tx2"/>
                </a:solidFill>
              </a:defRPr>
            </a:lvl2pPr>
            <a:lvl3pPr marL="173736" indent="-173736">
              <a:buFont typeface="Arial" panose="020B0604020202020204" pitchFamily="34" charset="0"/>
              <a:buChar char="•"/>
              <a:defRPr sz="2400">
                <a:solidFill>
                  <a:schemeClr val="tx2"/>
                </a:solidFill>
              </a:defRPr>
            </a:lvl3pPr>
            <a:lvl4pPr marL="173736" indent="-173736">
              <a:buFont typeface="Arial" panose="020B0604020202020204" pitchFamily="34" charset="0"/>
              <a:buChar char="•"/>
              <a:defRPr sz="2400">
                <a:solidFill>
                  <a:schemeClr val="tx2"/>
                </a:solidFill>
              </a:defRPr>
            </a:lvl4pPr>
            <a:lvl5pPr marL="173736" indent="-173736">
              <a:buFont typeface="Arial" panose="020B0604020202020204" pitchFamily="34" charset="0"/>
              <a:buChar char="•"/>
              <a:defRPr sz="2400">
                <a:solidFill>
                  <a:schemeClr val="tx2"/>
                </a:solidFill>
              </a:defRPr>
            </a:lvl5pPr>
            <a:lvl6pPr marL="173736" indent="-173736">
              <a:buFont typeface="Arial" panose="020B0604020202020204" pitchFamily="34" charset="0"/>
              <a:buChar char="•"/>
              <a:defRPr sz="2400">
                <a:solidFill>
                  <a:schemeClr val="tx2"/>
                </a:solidFill>
              </a:defRPr>
            </a:lvl6pPr>
            <a:lvl7pPr marL="173736" indent="-173736">
              <a:buFont typeface="Arial" panose="020B0604020202020204" pitchFamily="34" charset="0"/>
              <a:buChar char="•"/>
              <a:defRPr sz="2400">
                <a:solidFill>
                  <a:schemeClr val="tx2"/>
                </a:solidFill>
              </a:defRPr>
            </a:lvl7pPr>
            <a:lvl8pPr marL="173736" indent="-173736">
              <a:buFont typeface="Arial" panose="020B0604020202020204" pitchFamily="34" charset="0"/>
              <a:buChar char="•"/>
              <a:defRPr sz="2400">
                <a:solidFill>
                  <a:schemeClr val="tx2"/>
                </a:solidFill>
              </a:defRPr>
            </a:lvl8pPr>
            <a:lvl9pPr marL="173736" indent="-173736">
              <a:buFont typeface="Arial" panose="020B0604020202020204" pitchFamily="34" charset="0"/>
              <a:buChar char="•"/>
              <a:defRPr sz="2400">
                <a:solidFill>
                  <a:schemeClr val="tx2"/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12" name="Content Placeholder 8"/>
          <p:cNvSpPr>
            <a:spLocks noGrp="1"/>
          </p:cNvSpPr>
          <p:nvPr>
            <p:ph sz="quarter" idx="15"/>
          </p:nvPr>
        </p:nvSpPr>
        <p:spPr>
          <a:xfrm>
            <a:off x="4707621" y="1371600"/>
            <a:ext cx="3977640" cy="4572000"/>
          </a:xfrm>
        </p:spPr>
        <p:txBody>
          <a:bodyPr>
            <a:noAutofit/>
          </a:bodyPr>
          <a:lstStyle>
            <a:lvl1pPr>
              <a:defRPr sz="2400">
                <a:solidFill>
                  <a:schemeClr val="tx2"/>
                </a:solidFill>
              </a:defRPr>
            </a:lvl1pPr>
            <a:lvl2pPr marL="173736" indent="-173736">
              <a:buFont typeface="Arial" panose="020B0604020202020204" pitchFamily="34" charset="0"/>
              <a:buChar char="•"/>
              <a:defRPr sz="2400">
                <a:solidFill>
                  <a:schemeClr val="tx2"/>
                </a:solidFill>
              </a:defRPr>
            </a:lvl2pPr>
            <a:lvl3pPr marL="173736" indent="-173736">
              <a:buFont typeface="Arial" panose="020B0604020202020204" pitchFamily="34" charset="0"/>
              <a:buChar char="•"/>
              <a:defRPr sz="2400">
                <a:solidFill>
                  <a:schemeClr val="tx2"/>
                </a:solidFill>
              </a:defRPr>
            </a:lvl3pPr>
            <a:lvl4pPr marL="173736" indent="-173736">
              <a:buFont typeface="Arial" panose="020B0604020202020204" pitchFamily="34" charset="0"/>
              <a:buChar char="•"/>
              <a:defRPr sz="2400">
                <a:solidFill>
                  <a:schemeClr val="tx2"/>
                </a:solidFill>
              </a:defRPr>
            </a:lvl4pPr>
            <a:lvl5pPr marL="173736" indent="-173736">
              <a:buFont typeface="Arial" panose="020B0604020202020204" pitchFamily="34" charset="0"/>
              <a:buChar char="•"/>
              <a:defRPr sz="2400">
                <a:solidFill>
                  <a:schemeClr val="tx2"/>
                </a:solidFill>
              </a:defRPr>
            </a:lvl5pPr>
            <a:lvl6pPr marL="173736" indent="-173736">
              <a:buFont typeface="Arial" panose="020B0604020202020204" pitchFamily="34" charset="0"/>
              <a:buChar char="•"/>
              <a:defRPr sz="2400">
                <a:solidFill>
                  <a:schemeClr val="tx2"/>
                </a:solidFill>
              </a:defRPr>
            </a:lvl6pPr>
            <a:lvl7pPr marL="173736" indent="-173736">
              <a:buFont typeface="Arial" panose="020B0604020202020204" pitchFamily="34" charset="0"/>
              <a:buChar char="•"/>
              <a:defRPr sz="2400">
                <a:solidFill>
                  <a:schemeClr val="tx2"/>
                </a:solidFill>
              </a:defRPr>
            </a:lvl7pPr>
            <a:lvl8pPr marL="173736" indent="-173736">
              <a:buFont typeface="Arial" panose="020B0604020202020204" pitchFamily="34" charset="0"/>
              <a:buChar char="•"/>
              <a:defRPr sz="2400">
                <a:solidFill>
                  <a:schemeClr val="tx2"/>
                </a:solidFill>
              </a:defRPr>
            </a:lvl8pPr>
            <a:lvl9pPr marL="173736" indent="-173736">
              <a:buFont typeface="Arial" panose="020B0604020202020204" pitchFamily="34" charset="0"/>
              <a:buChar char="•"/>
              <a:defRPr sz="2400">
                <a:solidFill>
                  <a:schemeClr val="tx2"/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6254496"/>
            <a:ext cx="1536195" cy="4114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5324328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nd Column W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11" name="Content Placeholder 10"/>
          <p:cNvSpPr>
            <a:spLocks noGrp="1"/>
          </p:cNvSpPr>
          <p:nvPr>
            <p:ph sz="quarter" idx="10"/>
          </p:nvPr>
        </p:nvSpPr>
        <p:spPr>
          <a:xfrm>
            <a:off x="457200" y="1373188"/>
            <a:ext cx="2560320" cy="4572000"/>
          </a:xfrm>
        </p:spPr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  <a:lvl2pPr>
              <a:defRPr>
                <a:solidFill>
                  <a:schemeClr val="tx1"/>
                </a:solidFill>
              </a:defRPr>
            </a:lvl2pPr>
            <a:lvl3pPr>
              <a:defRPr>
                <a:solidFill>
                  <a:schemeClr val="tx1"/>
                </a:solidFill>
              </a:defRPr>
            </a:lvl3pPr>
            <a:lvl4pPr>
              <a:defRPr>
                <a:solidFill>
                  <a:schemeClr val="tx1"/>
                </a:solidFill>
              </a:defRPr>
            </a:lvl4pPr>
            <a:lvl5pPr>
              <a:defRPr>
                <a:solidFill>
                  <a:schemeClr val="tx1"/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3" name="Content Placeholder 12"/>
          <p:cNvSpPr>
            <a:spLocks noGrp="1"/>
          </p:cNvSpPr>
          <p:nvPr>
            <p:ph sz="quarter" idx="11"/>
          </p:nvPr>
        </p:nvSpPr>
        <p:spPr>
          <a:xfrm>
            <a:off x="3295650" y="1373188"/>
            <a:ext cx="5391150" cy="4572000"/>
          </a:xfrm>
        </p:spPr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  <a:lvl2pPr>
              <a:defRPr>
                <a:solidFill>
                  <a:schemeClr val="tx1"/>
                </a:solidFill>
              </a:defRPr>
            </a:lvl2pPr>
            <a:lvl3pPr>
              <a:defRPr>
                <a:solidFill>
                  <a:schemeClr val="tx1"/>
                </a:solidFill>
              </a:defRPr>
            </a:lvl3pPr>
            <a:lvl4pPr>
              <a:defRPr>
                <a:solidFill>
                  <a:schemeClr val="tx1"/>
                </a:solidFill>
              </a:defRPr>
            </a:lvl4pPr>
            <a:lvl5pPr>
              <a:defRPr>
                <a:solidFill>
                  <a:schemeClr val="tx1"/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2"/>
          </p:nvPr>
        </p:nvSpPr>
        <p:spPr/>
        <p:txBody>
          <a:bodyPr/>
          <a:lstStyle/>
          <a:p>
            <a:r>
              <a:rPr lang="en-US" dirty="0"/>
              <a:t>Month Day, Year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5E8BC936-0928-C346-B13E-04BD58031644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6254496"/>
            <a:ext cx="1536195" cy="4114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52298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/>
              <a:t>4/22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136545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/>
              <a:t>4/22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08244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/>
              <a:t>4/22/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872655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/>
              <a:t>4/22/22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632394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/>
              <a:t>4/22/22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135948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/>
              <a:t>4/22/22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64907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/>
              <a:t>4/22/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863136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/>
              <a:t>4/22/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781525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4DE79-268F-4C1A-8933-263129D2AF90}" type="datetimeFigureOut">
              <a:rPr lang="en-US"/>
              <a:t>4/22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F63A3B-78C7-47BE-AE5E-E10140E04643}" type="slidenum">
              <a:rPr lang="en-US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487144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6" r:id="rId1"/>
    <p:sldLayoutId id="2147483697" r:id="rId2"/>
    <p:sldLayoutId id="2147483698" r:id="rId3"/>
    <p:sldLayoutId id="2147483699" r:id="rId4"/>
    <p:sldLayoutId id="2147483700" r:id="rId5"/>
    <p:sldLayoutId id="2147483701" r:id="rId6"/>
    <p:sldLayoutId id="2147483702" r:id="rId7"/>
    <p:sldLayoutId id="2147483703" r:id="rId8"/>
    <p:sldLayoutId id="2147483704" r:id="rId9"/>
    <p:sldLayoutId id="2147483705" r:id="rId10"/>
    <p:sldLayoutId id="2147483706" r:id="rId11"/>
    <p:sldLayoutId id="2147483707" r:id="rId12"/>
    <p:sldLayoutId id="2147483708" r:id="rId13"/>
    <p:sldLayoutId id="2147483709" r:id="rId14"/>
    <p:sldLayoutId id="2147483710" r:id="rId15"/>
    <p:sldLayoutId id="2147483711" r:id="rId16"/>
    <p:sldLayoutId id="2147483712" r:id="rId17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2.xml"/><Relationship Id="rId7" Type="http://schemas.microsoft.com/office/2007/relationships/diagramDrawing" Target="../diagrams/drawing2.xml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2.xml"/><Relationship Id="rId5" Type="http://schemas.openxmlformats.org/officeDocument/2006/relationships/diagramQuickStyle" Target="../diagrams/quickStyle2.xml"/><Relationship Id="rId4" Type="http://schemas.openxmlformats.org/officeDocument/2006/relationships/diagramLayout" Target="../diagrams/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3.xml"/><Relationship Id="rId7" Type="http://schemas.microsoft.com/office/2007/relationships/diagramDrawing" Target="../diagrams/drawing3.xml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3.xml"/><Relationship Id="rId5" Type="http://schemas.openxmlformats.org/officeDocument/2006/relationships/diagramQuickStyle" Target="../diagrams/quickStyle3.xml"/><Relationship Id="rId4" Type="http://schemas.openxmlformats.org/officeDocument/2006/relationships/diagramLayout" Target="../diagrams/layout3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4.xml"/><Relationship Id="rId7" Type="http://schemas.microsoft.com/office/2007/relationships/diagramDrawing" Target="../diagrams/drawing4.xml"/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4.xml"/><Relationship Id="rId5" Type="http://schemas.openxmlformats.org/officeDocument/2006/relationships/diagramQuickStyle" Target="../diagrams/quickStyle4.xml"/><Relationship Id="rId4" Type="http://schemas.openxmlformats.org/officeDocument/2006/relationships/diagramLayout" Target="../diagrams/layout4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5.xml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5.xml"/><Relationship Id="rId2" Type="http://schemas.openxmlformats.org/officeDocument/2006/relationships/diagramData" Target="../diagrams/data5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5.xml"/><Relationship Id="rId5" Type="http://schemas.openxmlformats.org/officeDocument/2006/relationships/diagramColors" Target="../diagrams/colors5.xml"/><Relationship Id="rId4" Type="http://schemas.openxmlformats.org/officeDocument/2006/relationships/diagramQuickStyle" Target="../diagrams/quickStyle5.xml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6.xml"/><Relationship Id="rId7" Type="http://schemas.microsoft.com/office/2007/relationships/diagramDrawing" Target="../diagrams/drawing6.xml"/><Relationship Id="rId2" Type="http://schemas.openxmlformats.org/officeDocument/2006/relationships/notesSlide" Target="../notesSlides/notesSlide26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6.xml"/><Relationship Id="rId5" Type="http://schemas.openxmlformats.org/officeDocument/2006/relationships/diagramQuickStyle" Target="../diagrams/quickStyle6.xml"/><Relationship Id="rId4" Type="http://schemas.openxmlformats.org/officeDocument/2006/relationships/diagramLayout" Target="../diagrams/layout6.xml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hyperlink" Target="http://www.prepareforyourcare.org" TargetMode="External"/><Relationship Id="rId2" Type="http://schemas.openxmlformats.org/officeDocument/2006/relationships/hyperlink" Target="https://patientprioritiescare.org/about/" TargetMode="External"/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7.xml"/><Relationship Id="rId7" Type="http://schemas.microsoft.com/office/2007/relationships/diagramDrawing" Target="../diagrams/drawing7.xml"/><Relationship Id="rId2" Type="http://schemas.openxmlformats.org/officeDocument/2006/relationships/notesSlide" Target="../notesSlides/notesSlide27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7.xml"/><Relationship Id="rId5" Type="http://schemas.openxmlformats.org/officeDocument/2006/relationships/diagramQuickStyle" Target="../diagrams/quickStyle7.xml"/><Relationship Id="rId4" Type="http://schemas.openxmlformats.org/officeDocument/2006/relationships/diagramLayout" Target="../diagrams/layout7.xml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8.xml"/><Relationship Id="rId7" Type="http://schemas.microsoft.com/office/2007/relationships/diagramDrawing" Target="../diagrams/drawing8.xml"/><Relationship Id="rId2" Type="http://schemas.openxmlformats.org/officeDocument/2006/relationships/notesSlide" Target="../notesSlides/notesSlide28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8.xml"/><Relationship Id="rId5" Type="http://schemas.openxmlformats.org/officeDocument/2006/relationships/diagramQuickStyle" Target="../diagrams/quickStyle8.xml"/><Relationship Id="rId4" Type="http://schemas.openxmlformats.org/officeDocument/2006/relationships/diagramLayout" Target="../diagrams/layout8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commons.wikimedia.org/wiki/File:Percentage_of_US_Population_Over_Age_65_1950-2050.png" TargetMode="Externa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>
            <a:extLst>
              <a:ext uri="{FF2B5EF4-FFF2-40B4-BE49-F238E27FC236}">
                <a16:creationId xmlns:a16="http://schemas.microsoft.com/office/drawing/2014/main" id="{2B81FEFF-2091-470B-97BD-B2221C0ED1FB}"/>
              </a:ext>
            </a:extLst>
          </p:cNvPr>
          <p:cNvSpPr txBox="1">
            <a:spLocks/>
          </p:cNvSpPr>
          <p:nvPr/>
        </p:nvSpPr>
        <p:spPr>
          <a:xfrm>
            <a:off x="963930" y="1008993"/>
            <a:ext cx="7584916" cy="4361554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b="1" dirty="0">
                <a:solidFill>
                  <a:schemeClr val="accent1"/>
                </a:solidFill>
                <a:latin typeface="Calibri"/>
                <a:cs typeface="Calibri"/>
              </a:rPr>
              <a:t>The 4Ms Approach to the Care of the Older Adult </a:t>
            </a:r>
            <a:br>
              <a:rPr lang="en-US" sz="4000" dirty="0">
                <a:latin typeface="Calibri"/>
              </a:rPr>
            </a:br>
            <a:br>
              <a:rPr lang="en-US" sz="4000" dirty="0">
                <a:latin typeface="Calibri"/>
              </a:rPr>
            </a:br>
            <a:br>
              <a:rPr lang="en-US" sz="4000" dirty="0"/>
            </a:br>
            <a:endParaRPr lang="en-US" sz="4000" dirty="0">
              <a:cs typeface="Calibri Light" panose="020F0302020204030204"/>
            </a:endParaRPr>
          </a:p>
        </p:txBody>
      </p:sp>
    </p:spTree>
    <p:extLst>
      <p:ext uri="{BB962C8B-B14F-4D97-AF65-F5344CB8AC3E}">
        <p14:creationId xmlns:p14="http://schemas.microsoft.com/office/powerpoint/2010/main" val="27827245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7ABD9D-8BDE-4579-A098-9E3D7A18F9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pPr algn="ctr"/>
            <a:r>
              <a:rPr lang="en-US" sz="4900" b="1" dirty="0">
                <a:solidFill>
                  <a:schemeClr val="accent1"/>
                </a:solidFill>
              </a:rPr>
              <a:t>Mini-Mental State Exam(MMSE)</a:t>
            </a:r>
          </a:p>
        </p:txBody>
      </p:sp>
      <p:sp>
        <p:nvSpPr>
          <p:cNvPr id="11" name="Content Placeholder 10">
            <a:extLst>
              <a:ext uri="{FF2B5EF4-FFF2-40B4-BE49-F238E27FC236}">
                <a16:creationId xmlns:a16="http://schemas.microsoft.com/office/drawing/2014/main" id="{089DD99E-0D17-4C5D-B955-09FF7808AF3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33552" y="2135038"/>
            <a:ext cx="3602891" cy="3795623"/>
          </a:xfrm>
        </p:spPr>
        <p:txBody>
          <a:bodyPr vert="horz" lIns="0" tIns="0" rIns="0" bIns="0" rtlCol="0" anchor="t">
            <a:noAutofit/>
          </a:bodyPr>
          <a:lstStyle/>
          <a:p>
            <a:r>
              <a:rPr lang="en-US" sz="2400" dirty="0">
                <a:latin typeface="Calibri"/>
                <a:cs typeface="Calibri"/>
              </a:rPr>
              <a:t>Widely used proprietary screening test of cognitive function among the elderly. </a:t>
            </a:r>
            <a:endParaRPr lang="en-US" dirty="0"/>
          </a:p>
          <a:p>
            <a:r>
              <a:rPr lang="en-US" sz="2400" dirty="0">
                <a:ea typeface="+mn-lt"/>
                <a:cs typeface="+mn-lt"/>
              </a:rPr>
              <a:t>It</a:t>
            </a:r>
            <a:r>
              <a:rPr lang="en-US" sz="2400" dirty="0">
                <a:latin typeface="Calibri"/>
                <a:cs typeface="Calibri"/>
              </a:rPr>
              <a:t> includes test of:</a:t>
            </a:r>
            <a:endParaRPr lang="en-US" dirty="0"/>
          </a:p>
          <a:p>
            <a:pPr marL="457200" lvl="1" indent="-285750">
              <a:buFont typeface="Arial"/>
              <a:buChar char="•"/>
            </a:pPr>
            <a:r>
              <a:rPr lang="en-US" sz="2000" dirty="0">
                <a:latin typeface="Calibri"/>
                <a:cs typeface="Calibri"/>
              </a:rPr>
              <a:t>Orientation</a:t>
            </a:r>
          </a:p>
          <a:p>
            <a:pPr marL="457200" lvl="1" indent="-285750">
              <a:buFont typeface="Arial"/>
              <a:buChar char="•"/>
            </a:pPr>
            <a:r>
              <a:rPr lang="en-US" sz="2000" dirty="0">
                <a:latin typeface="Calibri"/>
                <a:cs typeface="Calibri"/>
              </a:rPr>
              <a:t>Attention</a:t>
            </a:r>
          </a:p>
          <a:p>
            <a:pPr marL="457200" lvl="1" indent="-285750">
              <a:buFont typeface="Arial"/>
              <a:buChar char="•"/>
            </a:pPr>
            <a:r>
              <a:rPr lang="en-US" sz="2000" dirty="0">
                <a:latin typeface="Calibri"/>
                <a:cs typeface="Calibri"/>
              </a:rPr>
              <a:t>Memory</a:t>
            </a:r>
          </a:p>
          <a:p>
            <a:pPr marL="457200" lvl="1" indent="-285750">
              <a:buFont typeface="Arial"/>
              <a:buChar char="•"/>
            </a:pPr>
            <a:r>
              <a:rPr lang="en-US" sz="2000" dirty="0">
                <a:latin typeface="Calibri"/>
                <a:cs typeface="Calibri"/>
              </a:rPr>
              <a:t>Language</a:t>
            </a:r>
          </a:p>
          <a:p>
            <a:pPr marL="457200" lvl="1" indent="-285750">
              <a:buFont typeface="Arial"/>
              <a:buChar char="•"/>
            </a:pPr>
            <a:r>
              <a:rPr lang="en-US" sz="2000" dirty="0">
                <a:latin typeface="Calibri"/>
                <a:cs typeface="Calibri"/>
              </a:rPr>
              <a:t>Visual Spatial Skills</a:t>
            </a:r>
          </a:p>
          <a:p>
            <a:endParaRPr lang="en-US" sz="2400" dirty="0">
              <a:latin typeface="Calibri"/>
              <a:cs typeface="Calibri"/>
            </a:endParaRPr>
          </a:p>
          <a:p>
            <a:endParaRPr lang="en-US" dirty="0">
              <a:latin typeface="Calibri"/>
              <a:cs typeface="Calibri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B26ACB8-94F9-48F1-AC83-F44DCA055732}"/>
              </a:ext>
            </a:extLst>
          </p:cNvPr>
          <p:cNvSpPr txBox="1"/>
          <p:nvPr/>
        </p:nvSpPr>
        <p:spPr>
          <a:xfrm>
            <a:off x="4408099" y="2136476"/>
            <a:ext cx="4281577" cy="184665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>
              <a:spcAft>
                <a:spcPts val="300"/>
              </a:spcAft>
            </a:pPr>
            <a:r>
              <a:rPr lang="en-US" sz="2400" dirty="0">
                <a:latin typeface="Calibri"/>
                <a:ea typeface="+mn-lt"/>
                <a:cs typeface="Calibri"/>
              </a:rPr>
              <a:t>30-point questionnaire, score:</a:t>
            </a:r>
          </a:p>
          <a:p>
            <a:pPr lvl="1" indent="-285750">
              <a:spcAft>
                <a:spcPts val="300"/>
              </a:spcAft>
              <a:buFont typeface="Arial,Sans-Serif"/>
              <a:buChar char="•"/>
            </a:pPr>
            <a:r>
              <a:rPr lang="en-US" sz="2000" b="1" dirty="0">
                <a:latin typeface="Calibri"/>
                <a:ea typeface="+mn-lt"/>
                <a:cs typeface="Calibri"/>
              </a:rPr>
              <a:t>24 or more</a:t>
            </a:r>
            <a:r>
              <a:rPr lang="en-US" sz="2000" dirty="0">
                <a:latin typeface="Calibri"/>
                <a:ea typeface="+mn-lt"/>
                <a:cs typeface="Calibri"/>
              </a:rPr>
              <a:t>  = Normal cognition **</a:t>
            </a:r>
          </a:p>
          <a:p>
            <a:pPr lvl="1" indent="-285750">
              <a:spcAft>
                <a:spcPts val="300"/>
              </a:spcAft>
              <a:buFont typeface="Arial,Sans-Serif"/>
              <a:buChar char="•"/>
            </a:pPr>
            <a:r>
              <a:rPr lang="en-US" sz="2000" b="1" dirty="0">
                <a:latin typeface="Calibri"/>
                <a:ea typeface="+mn-lt"/>
                <a:cs typeface="Calibri"/>
              </a:rPr>
              <a:t>19-23 </a:t>
            </a:r>
            <a:r>
              <a:rPr lang="en-US" sz="2000" dirty="0">
                <a:latin typeface="Calibri"/>
                <a:ea typeface="+mn-lt"/>
                <a:cs typeface="Calibri"/>
              </a:rPr>
              <a:t>= Mild cognitive impairment</a:t>
            </a:r>
          </a:p>
          <a:p>
            <a:pPr lvl="1" indent="-285750">
              <a:spcAft>
                <a:spcPts val="300"/>
              </a:spcAft>
              <a:buFont typeface="Arial,Sans-Serif"/>
              <a:buChar char="•"/>
            </a:pPr>
            <a:r>
              <a:rPr lang="en-US" sz="2000" b="1" dirty="0">
                <a:latin typeface="Calibri"/>
                <a:ea typeface="+mn-lt"/>
                <a:cs typeface="Calibri"/>
              </a:rPr>
              <a:t>10-18</a:t>
            </a:r>
            <a:r>
              <a:rPr lang="en-US" sz="2000" dirty="0">
                <a:latin typeface="Calibri"/>
                <a:ea typeface="+mn-lt"/>
                <a:cs typeface="Calibri"/>
              </a:rPr>
              <a:t> = Moderate dementia</a:t>
            </a:r>
          </a:p>
          <a:p>
            <a:pPr lvl="1" indent="-285750">
              <a:spcAft>
                <a:spcPts val="300"/>
              </a:spcAft>
              <a:buFont typeface="Arial,Sans-Serif"/>
              <a:buChar char="•"/>
            </a:pPr>
            <a:r>
              <a:rPr lang="en-US" sz="2000" b="1" dirty="0">
                <a:latin typeface="Calibri"/>
                <a:ea typeface="+mn-lt"/>
                <a:cs typeface="Calibri"/>
              </a:rPr>
              <a:t>9 or lower</a:t>
            </a:r>
            <a:r>
              <a:rPr lang="en-US" sz="2000" dirty="0">
                <a:latin typeface="Calibri"/>
                <a:ea typeface="+mn-lt"/>
                <a:cs typeface="Calibri"/>
              </a:rPr>
              <a:t> = Severe dementia</a:t>
            </a:r>
            <a:endParaRPr lang="en-US" sz="2000" dirty="0">
              <a:latin typeface="Calibri"/>
              <a:cs typeface="Calibri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139FB9B-AEAA-DF4D-FA01-2BFDEEC1256D}"/>
              </a:ext>
            </a:extLst>
          </p:cNvPr>
          <p:cNvSpPr txBox="1"/>
          <p:nvPr/>
        </p:nvSpPr>
        <p:spPr>
          <a:xfrm>
            <a:off x="503162" y="5921829"/>
            <a:ext cx="8137676" cy="46166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ea typeface="+mn-lt"/>
                <a:cs typeface="+mn-lt"/>
              </a:rPr>
              <a:t>Source: Folstein MF, Folstein SE, McHugh PR. "Mini‐mental state". A practical method for grading the cognitive state of patients for the clinician. </a:t>
            </a:r>
            <a:r>
              <a:rPr lang="en-US" sz="1200" i="1" dirty="0">
                <a:ea typeface="+mn-lt"/>
                <a:cs typeface="+mn-lt"/>
              </a:rPr>
              <a:t>Journal of Psychiatric Research</a:t>
            </a:r>
            <a:r>
              <a:rPr lang="en-US" sz="1200" dirty="0">
                <a:ea typeface="+mn-lt"/>
                <a:cs typeface="+mn-lt"/>
              </a:rPr>
              <a:t> 1975;12(3):189‐98. [PUBMED: 1202204]</a:t>
            </a:r>
            <a:endParaRPr lang="en-US" sz="12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422B267-CF78-04F0-0FCC-7107B82B1B5C}"/>
              </a:ext>
            </a:extLst>
          </p:cNvPr>
          <p:cNvSpPr txBox="1"/>
          <p:nvPr/>
        </p:nvSpPr>
        <p:spPr>
          <a:xfrm>
            <a:off x="4132979" y="4316363"/>
            <a:ext cx="4634860" cy="138499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400" dirty="0"/>
              <a:t>** A normal score must be interpreted in the broader context for the individual patient such as how they are managing at home and in daily life. </a:t>
            </a:r>
            <a:endParaRPr lang="en-US" sz="1400" dirty="0">
              <a:cs typeface="Calibri"/>
            </a:endParaRPr>
          </a:p>
          <a:p>
            <a:r>
              <a:rPr lang="en-US" sz="1400" dirty="0"/>
              <a:t>Studies have shown sensitivity 0.85 and specificity 0.9, meaning 85% with dementia correctly identified while 15% would be wrongly classified as not having dementia.</a:t>
            </a:r>
            <a:endParaRPr lang="en-US" sz="1400" dirty="0"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41859272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8650" y="523277"/>
            <a:ext cx="7886700" cy="1325563"/>
          </a:xfrm>
        </p:spPr>
        <p:txBody>
          <a:bodyPr>
            <a:normAutofit/>
          </a:bodyPr>
          <a:lstStyle/>
          <a:p>
            <a:pPr algn="ctr"/>
            <a:r>
              <a:rPr lang="en-US" sz="4900" b="1" dirty="0">
                <a:solidFill>
                  <a:schemeClr val="accent1"/>
                </a:solidFill>
                <a:ea typeface="+mj-lt"/>
                <a:cs typeface="+mj-lt"/>
              </a:rPr>
              <a:t>Pseudodementia</a:t>
            </a:r>
            <a:endParaRPr lang="en-US" dirty="0">
              <a:solidFill>
                <a:schemeClr val="accent1"/>
              </a:solidFill>
            </a:endParaRP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>
          <a:xfrm>
            <a:off x="628650" y="1983776"/>
            <a:ext cx="7886700" cy="4351338"/>
          </a:xfrm>
        </p:spPr>
        <p:txBody>
          <a:bodyPr vert="horz" lIns="0" tIns="0" rIns="0" bIns="0" rtlCol="0" anchor="t">
            <a:noAutofit/>
          </a:bodyPr>
          <a:lstStyle/>
          <a:p>
            <a:pPr>
              <a:buFont typeface="Arial,Sans-Serif" panose="020B0604020202020204" pitchFamily="34" charset="0"/>
              <a:buChar char="•"/>
            </a:pPr>
            <a:r>
              <a:rPr lang="en-US" b="1" dirty="0">
                <a:ea typeface="+mn-lt"/>
                <a:cs typeface="+mn-lt"/>
              </a:rPr>
              <a:t>Pseudodementia</a:t>
            </a:r>
            <a:endParaRPr lang="en-US" dirty="0">
              <a:ea typeface="+mn-lt"/>
              <a:cs typeface="+mn-lt"/>
            </a:endParaRPr>
          </a:p>
          <a:p>
            <a:pPr marL="800100" lvl="1" indent="-342900">
              <a:lnSpc>
                <a:spcPct val="100000"/>
              </a:lnSpc>
              <a:spcBef>
                <a:spcPts val="0"/>
              </a:spcBef>
              <a:buFont typeface="Arial,Sans-Serif" panose="020B0604020202020204" pitchFamily="34" charset="0"/>
              <a:buChar char="•"/>
            </a:pPr>
            <a:r>
              <a:rPr lang="en-US" dirty="0">
                <a:ea typeface="+mn-lt"/>
                <a:cs typeface="+mn-lt"/>
              </a:rPr>
              <a:t>Appearance of slowed cognition may result from potentially reversible conditions including depression and delirium</a:t>
            </a:r>
          </a:p>
          <a:p>
            <a:pPr marL="457200" indent="-457200">
              <a:lnSpc>
                <a:spcPct val="100000"/>
              </a:lnSpc>
              <a:spcBef>
                <a:spcPts val="0"/>
              </a:spcBef>
              <a:buFont typeface="Arial,Sans-Serif" panose="020B0604020202020204" pitchFamily="34" charset="0"/>
              <a:buChar char="•"/>
            </a:pPr>
            <a:r>
              <a:rPr lang="en-US" b="1" dirty="0">
                <a:solidFill>
                  <a:srgbClr val="003CA5"/>
                </a:solidFill>
                <a:ea typeface="+mn-lt"/>
                <a:cs typeface="+mn-lt"/>
              </a:rPr>
              <a:t>Use screening tool (PHQ-9 or GDS) to evaluate for depression. </a:t>
            </a:r>
          </a:p>
          <a:p>
            <a:pPr marL="457200" indent="-457200">
              <a:lnSpc>
                <a:spcPct val="100000"/>
              </a:lnSpc>
              <a:spcBef>
                <a:spcPts val="0"/>
              </a:spcBef>
              <a:buFont typeface="Arial,Sans-Serif" panose="020B0604020202020204" pitchFamily="34" charset="0"/>
              <a:buChar char="•"/>
            </a:pPr>
            <a:r>
              <a:rPr lang="en-US" b="1" dirty="0">
                <a:solidFill>
                  <a:srgbClr val="003CA5"/>
                </a:solidFill>
                <a:ea typeface="+mn-lt"/>
                <a:cs typeface="+mn-lt"/>
              </a:rPr>
              <a:t>In hospitalized patients consider the possibility of delirium and screen using the Confusion Assessment Method (CAM)</a:t>
            </a:r>
            <a:endParaRPr lang="en-US" dirty="0">
              <a:solidFill>
                <a:srgbClr val="003CA5"/>
              </a:solidFill>
              <a:ea typeface="+mn-lt"/>
              <a:cs typeface="+mn-lt"/>
            </a:endParaRPr>
          </a:p>
          <a:p>
            <a:pPr marL="457200" indent="-457200">
              <a:buFont typeface="Arial,Sans-Serif" panose="020B0604020202020204" pitchFamily="34" charset="0"/>
              <a:buChar char="•"/>
            </a:pPr>
            <a:endParaRPr lang="en-US" dirty="0"/>
          </a:p>
          <a:p>
            <a:pPr>
              <a:buFont typeface="Arial,Sans-Serif" panose="020B0604020202020204" pitchFamily="34" charset="0"/>
              <a:buChar char="•"/>
            </a:pPr>
            <a:endParaRPr lang="en-US" dirty="0"/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5971453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8613" y="106334"/>
            <a:ext cx="8519303" cy="1325563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ctr">
              <a:lnSpc>
                <a:spcPct val="100000"/>
              </a:lnSpc>
              <a:spcBef>
                <a:spcPts val="0"/>
              </a:spcBef>
            </a:pPr>
            <a:r>
              <a:rPr lang="en-US" sz="2900" dirty="0">
                <a:solidFill>
                  <a:schemeClr val="accent1"/>
                </a:solidFill>
                <a:ea typeface="+mj-lt"/>
                <a:cs typeface="+mj-lt"/>
              </a:rPr>
              <a:t>Case Vignette #1 Mind/Memory Assessment </a:t>
            </a:r>
            <a:br>
              <a:rPr lang="en-US" sz="2900" dirty="0">
                <a:solidFill>
                  <a:schemeClr val="accent1"/>
                </a:solidFill>
                <a:ea typeface="+mj-lt"/>
                <a:cs typeface="+mj-lt"/>
              </a:rPr>
            </a:br>
            <a:r>
              <a:rPr lang="en-US" sz="2900" b="1" dirty="0">
                <a:solidFill>
                  <a:srgbClr val="C445BA"/>
                </a:solidFill>
                <a:ea typeface="+mj-lt"/>
                <a:cs typeface="+mj-lt"/>
              </a:rPr>
              <a:t>BREAKOUT SESSION</a:t>
            </a:r>
            <a:r>
              <a:rPr lang="en-US" sz="4900" b="1" dirty="0">
                <a:solidFill>
                  <a:srgbClr val="C445BA"/>
                </a:solidFill>
                <a:ea typeface="+mj-lt"/>
                <a:cs typeface="+mj-lt"/>
              </a:rPr>
              <a:t> </a:t>
            </a:r>
            <a:endParaRPr lang="en-US" b="1" dirty="0">
              <a:solidFill>
                <a:srgbClr val="C445BA"/>
              </a:solidFill>
              <a:cs typeface="Calibri Light" panose="020F0302020204030204"/>
            </a:endParaRP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>
          <a:xfrm>
            <a:off x="398613" y="1379927"/>
            <a:ext cx="5945758" cy="3733112"/>
          </a:xfrm>
        </p:spPr>
        <p:txBody>
          <a:bodyPr vert="horz" lIns="0" tIns="0" rIns="0" bIns="0" rtlCol="0" anchor="t">
            <a:noAutofit/>
          </a:bodyPr>
          <a:lstStyle/>
          <a:p>
            <a:pPr marL="0" indent="0">
              <a:buNone/>
            </a:pPr>
            <a:r>
              <a:rPr lang="en-US" dirty="0">
                <a:ea typeface="+mn-lt"/>
                <a:cs typeface="+mn-lt"/>
              </a:rPr>
              <a:t>Julia Cortes is a 78-year-old woman who presents to establish care accompanied by her son. She hasn’t seen a physician in over a year.</a:t>
            </a:r>
            <a:endParaRPr lang="en-US" dirty="0"/>
          </a:p>
          <a:p>
            <a:pPr marL="0" indent="0">
              <a:buNone/>
            </a:pPr>
            <a:r>
              <a:rPr lang="en-US" dirty="0">
                <a:ea typeface="+mn-lt"/>
                <a:cs typeface="+mn-lt"/>
              </a:rPr>
              <a:t>Past medical history: hypertension, hyperlipidemia and depression</a:t>
            </a:r>
          </a:p>
          <a:p>
            <a:pPr marL="0" indent="0">
              <a:buNone/>
            </a:pPr>
            <a:r>
              <a:rPr lang="en-US" dirty="0">
                <a:ea typeface="+mn-lt"/>
                <a:cs typeface="+mn-lt"/>
              </a:rPr>
              <a:t>Her son expresses concern about her missing her medications and not paying her bills on time.</a:t>
            </a:r>
            <a:r>
              <a:rPr lang="en-US" b="1" dirty="0">
                <a:ea typeface="+mn-lt"/>
                <a:cs typeface="+mn-lt"/>
              </a:rPr>
              <a:t> </a:t>
            </a:r>
            <a:endParaRPr lang="en-US" dirty="0">
              <a:ea typeface="+mn-lt"/>
              <a:cs typeface="+mn-lt"/>
            </a:endParaRPr>
          </a:p>
          <a:p>
            <a:pPr>
              <a:buFont typeface="Arial" panose="020B0604020202020204" pitchFamily="34" charset="0"/>
              <a:buChar char="•"/>
            </a:pPr>
            <a:endParaRPr lang="en-US" dirty="0">
              <a:ea typeface="+mn-lt"/>
              <a:cs typeface="+mn-lt"/>
            </a:endParaRPr>
          </a:p>
          <a:p>
            <a:pPr marL="457200" indent="-457200">
              <a:buFont typeface="Arial,Sans-Serif" panose="020B0604020202020204" pitchFamily="34" charset="0"/>
              <a:buChar char="•"/>
            </a:pPr>
            <a:endParaRPr lang="en-US" dirty="0">
              <a:ea typeface="+mn-lt"/>
              <a:cs typeface="+mn-lt"/>
            </a:endParaRPr>
          </a:p>
          <a:p>
            <a:pPr>
              <a:buFont typeface="Arial,Sans-Serif" panose="020B0604020202020204" pitchFamily="34" charset="0"/>
              <a:buChar char="•"/>
            </a:pPr>
            <a:endParaRPr lang="en-US" dirty="0"/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dirty="0"/>
          </a:p>
          <a:p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E531B93-120A-4961-AF55-8A03F7FC04F5}"/>
              </a:ext>
            </a:extLst>
          </p:cNvPr>
          <p:cNvSpPr txBox="1"/>
          <p:nvPr/>
        </p:nvSpPr>
        <p:spPr>
          <a:xfrm>
            <a:off x="399554" y="4979541"/>
            <a:ext cx="8637915" cy="1661993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dirty="0">
                <a:cs typeface="Segoe UI"/>
              </a:rPr>
              <a:t>​</a:t>
            </a:r>
          </a:p>
          <a:p>
            <a:r>
              <a:rPr lang="en-US" sz="2800" dirty="0">
                <a:solidFill>
                  <a:srgbClr val="53565A"/>
                </a:solidFill>
                <a:cs typeface="Segoe UI"/>
              </a:rPr>
              <a:t>You are to:​</a:t>
            </a:r>
            <a:r>
              <a:rPr lang="en-US" sz="2800" dirty="0">
                <a:cs typeface="Segoe UI"/>
              </a:rPr>
              <a:t>​</a:t>
            </a:r>
          </a:p>
          <a:p>
            <a:pPr>
              <a:buChar char="•"/>
            </a:pPr>
            <a:r>
              <a:rPr lang="en-US" sz="2800" b="1" dirty="0">
                <a:solidFill>
                  <a:srgbClr val="53565A"/>
                </a:solidFill>
                <a:cs typeface="Arial"/>
              </a:rPr>
              <a:t>Perform a Cognitive Screen Using the Mini Mental State Exam (MMSE) </a:t>
            </a:r>
            <a:endParaRPr lang="en-US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EDF41568-E631-4422-BF69-DBFC18B99030}"/>
              </a:ext>
            </a:extLst>
          </p:cNvPr>
          <p:cNvSpPr/>
          <p:nvPr/>
        </p:nvSpPr>
        <p:spPr>
          <a:xfrm>
            <a:off x="6272963" y="1381455"/>
            <a:ext cx="2625968" cy="1723293"/>
          </a:xfrm>
          <a:prstGeom prst="rect">
            <a:avLst/>
          </a:prstGeom>
          <a:noFill/>
          <a:ln>
            <a:solidFill>
              <a:srgbClr val="C445BA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endParaRPr lang="en-US" dirty="0">
              <a:solidFill>
                <a:srgbClr val="C445BA"/>
              </a:solidFill>
              <a:cs typeface="Calibri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D80AC44-A8FF-4E8D-832C-51B1FCE7B9D8}"/>
              </a:ext>
            </a:extLst>
          </p:cNvPr>
          <p:cNvSpPr txBox="1"/>
          <p:nvPr/>
        </p:nvSpPr>
        <p:spPr>
          <a:xfrm>
            <a:off x="6334664" y="1518249"/>
            <a:ext cx="2743200" cy="132343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2000" b="1" dirty="0">
                <a:solidFill>
                  <a:srgbClr val="C445BA"/>
                </a:solidFill>
                <a:cs typeface="Arial"/>
              </a:rPr>
              <a:t>Student Guide</a:t>
            </a:r>
            <a:r>
              <a:rPr lang="en-US" sz="2000" dirty="0">
                <a:solidFill>
                  <a:srgbClr val="C445BA"/>
                </a:solidFill>
                <a:cs typeface="Arial"/>
              </a:rPr>
              <a:t>​</a:t>
            </a:r>
            <a:endParaRPr lang="en-US" dirty="0"/>
          </a:p>
          <a:p>
            <a:pPr>
              <a:buChar char="•"/>
            </a:pPr>
            <a:r>
              <a:rPr lang="en-US" sz="2000" dirty="0">
                <a:solidFill>
                  <a:srgbClr val="C445BA"/>
                </a:solidFill>
                <a:cs typeface="Arial"/>
              </a:rPr>
              <a:t>Student A – Clinician​</a:t>
            </a:r>
          </a:p>
          <a:p>
            <a:pPr>
              <a:buChar char="•"/>
            </a:pPr>
            <a:r>
              <a:rPr lang="en-US" sz="2000" dirty="0">
                <a:solidFill>
                  <a:srgbClr val="C445BA"/>
                </a:solidFill>
                <a:cs typeface="Arial"/>
              </a:rPr>
              <a:t>Student B – Patient​</a:t>
            </a:r>
          </a:p>
          <a:p>
            <a:pPr>
              <a:buChar char="•"/>
            </a:pPr>
            <a:r>
              <a:rPr lang="en-US" sz="2000" dirty="0">
                <a:solidFill>
                  <a:srgbClr val="C445BA"/>
                </a:solidFill>
                <a:cs typeface="Arial"/>
              </a:rPr>
              <a:t>Student C – Observer​</a:t>
            </a:r>
          </a:p>
        </p:txBody>
      </p:sp>
    </p:spTree>
    <p:extLst>
      <p:ext uri="{BB962C8B-B14F-4D97-AF65-F5344CB8AC3E}">
        <p14:creationId xmlns:p14="http://schemas.microsoft.com/office/powerpoint/2010/main" val="371173402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E1D0ED-644E-4D9E-A6DC-E5004188598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>
                <a:cs typeface="Calibri Light"/>
              </a:rPr>
              <a:t>Vignette #1 Debrief</a:t>
            </a:r>
            <a:endParaRPr lang="en-US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1EBB56C-74C8-4200-B370-66C2A19BF72D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6480991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3555" y="620392"/>
            <a:ext cx="3344932" cy="5504688"/>
          </a:xfrm>
        </p:spPr>
        <p:txBody>
          <a:bodyPr>
            <a:normAutofit/>
          </a:bodyPr>
          <a:lstStyle/>
          <a:p>
            <a:r>
              <a:rPr lang="en-US" sz="4000" b="1" dirty="0">
                <a:solidFill>
                  <a:schemeClr val="accent5"/>
                </a:solidFill>
                <a:ea typeface="+mj-lt"/>
                <a:cs typeface="+mj-lt"/>
              </a:rPr>
              <a:t>Summary: Mind/Memory Assessment</a:t>
            </a:r>
            <a:endParaRPr lang="en-US" sz="4000" dirty="0">
              <a:solidFill>
                <a:schemeClr val="accent5"/>
              </a:solidFill>
              <a:cs typeface="Calibri Light" panose="020F0302020204030204"/>
            </a:endParaRPr>
          </a:p>
        </p:txBody>
      </p:sp>
      <p:graphicFrame>
        <p:nvGraphicFramePr>
          <p:cNvPr id="8" name="Content Placeholder 5">
            <a:extLst>
              <a:ext uri="{FF2B5EF4-FFF2-40B4-BE49-F238E27FC236}">
                <a16:creationId xmlns:a16="http://schemas.microsoft.com/office/drawing/2014/main" id="{A7BF77DA-70BD-4B1F-8966-83423723D9A4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005874188"/>
              </p:ext>
            </p:extLst>
          </p:nvPr>
        </p:nvGraphicFramePr>
        <p:xfrm>
          <a:off x="3819906" y="620392"/>
          <a:ext cx="4697730" cy="5504688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15648578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5518" y="206975"/>
            <a:ext cx="7886700" cy="1325563"/>
          </a:xfrm>
        </p:spPr>
        <p:txBody>
          <a:bodyPr>
            <a:normAutofit/>
          </a:bodyPr>
          <a:lstStyle/>
          <a:p>
            <a:pPr algn="ctr"/>
            <a:r>
              <a:rPr lang="en-US" sz="4900" b="1" dirty="0">
                <a:solidFill>
                  <a:schemeClr val="accent1"/>
                </a:solidFill>
                <a:ea typeface="+mj-lt"/>
                <a:cs typeface="+mj-lt"/>
              </a:rPr>
              <a:t>Case Vignette #2</a:t>
            </a:r>
            <a:endParaRPr lang="en-US" dirty="0">
              <a:solidFill>
                <a:schemeClr val="accent1"/>
              </a:solidFill>
            </a:endParaRP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>
          <a:xfrm>
            <a:off x="182952" y="1840002"/>
            <a:ext cx="8591190" cy="4351338"/>
          </a:xfrm>
        </p:spPr>
        <p:txBody>
          <a:bodyPr vert="horz" lIns="0" tIns="0" rIns="0" bIns="0" rtlCol="0" anchor="t">
            <a:noAutofit/>
          </a:bodyPr>
          <a:lstStyle/>
          <a:p>
            <a:pPr marL="800100" lvl="1" indent="-342900"/>
            <a:r>
              <a:rPr lang="en-US" sz="2800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Maria Clark is an 85-year-old woman with a history of bipolar disorder, type 2 diabetes, hypertension, hyperlipidemia, hypothyroidism, and anxiety being seen after a recent hospitalization for tremors.</a:t>
            </a:r>
            <a:endParaRPr lang="en-US" sz="2800" dirty="0">
              <a:solidFill>
                <a:schemeClr val="tx1">
                  <a:lumMod val="75000"/>
                </a:schemeClr>
              </a:solidFill>
              <a:cs typeface="Calibri"/>
            </a:endParaRPr>
          </a:p>
          <a:p>
            <a:pPr marL="800100" lvl="1" indent="-342900"/>
            <a:r>
              <a:rPr lang="en-US" sz="2800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MRI brain was negative for stroke.  Tremors were thought to be due to benzodiazepine withdrawal from medication nonadherence. </a:t>
            </a:r>
          </a:p>
          <a:p>
            <a:pPr marL="800100" lvl="1" indent="-342900"/>
            <a:r>
              <a:rPr lang="en-US" sz="2800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She presents with her daughter who reports that she thinks Ms. Clark has been missing her medications and that she had a recent fall.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dirty="0"/>
          </a:p>
          <a:p>
            <a:pPr>
              <a:buFont typeface="Arial,Sans-Serif" panose="020B0604020202020204" pitchFamily="34" charset="0"/>
              <a:buChar char="•"/>
            </a:pPr>
            <a:endParaRPr lang="en-US" dirty="0"/>
          </a:p>
          <a:p>
            <a:pPr marL="457200" indent="-457200">
              <a:buFont typeface="Arial,Sans-Serif" panose="020B0604020202020204" pitchFamily="34" charset="0"/>
              <a:buChar char="•"/>
            </a:pPr>
            <a:endParaRPr lang="en-US" dirty="0"/>
          </a:p>
          <a:p>
            <a:pPr>
              <a:buFont typeface="Arial,Sans-Serif" panose="020B0604020202020204" pitchFamily="34" charset="0"/>
              <a:buChar char="•"/>
            </a:pPr>
            <a:endParaRPr lang="en-US" dirty="0"/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0412915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5518" y="206975"/>
            <a:ext cx="7886700" cy="1325563"/>
          </a:xfrm>
        </p:spPr>
        <p:txBody>
          <a:bodyPr>
            <a:normAutofit fontScale="90000"/>
          </a:bodyPr>
          <a:lstStyle/>
          <a:p>
            <a:pPr algn="ctr"/>
            <a:r>
              <a:rPr lang="en-US" sz="4900" b="1" dirty="0">
                <a:solidFill>
                  <a:schemeClr val="accent1"/>
                </a:solidFill>
                <a:ea typeface="+mj-lt"/>
                <a:cs typeface="+mj-lt"/>
              </a:rPr>
              <a:t>Case Vignette #2 Medication List</a:t>
            </a:r>
            <a:endParaRPr lang="en-US" dirty="0">
              <a:solidFill>
                <a:schemeClr val="accent1"/>
              </a:solidFill>
            </a:endParaRP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>
          <a:xfrm>
            <a:off x="844311" y="1782493"/>
            <a:ext cx="7383492" cy="4351338"/>
          </a:xfrm>
        </p:spPr>
        <p:txBody>
          <a:bodyPr vert="horz" lIns="0" tIns="0" rIns="0" bIns="0" rtlCol="0" anchor="t">
            <a:noAutofit/>
          </a:bodyPr>
          <a:lstStyle/>
          <a:p>
            <a:pPr marL="0" indent="0">
              <a:buNone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Medication List from the last </a:t>
            </a:r>
            <a:r>
              <a:rPr lang="en-US" sz="2800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visit</a:t>
            </a: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:</a:t>
            </a:r>
            <a:endParaRPr lang="en-US" dirty="0">
              <a:solidFill>
                <a:schemeClr val="tx1">
                  <a:lumMod val="75000"/>
                </a:schemeClr>
              </a:solidFill>
            </a:endParaRPr>
          </a:p>
          <a:p>
            <a:pPr marL="457200" indent="-457200">
              <a:buFont typeface="Wingdings,Sans-Serif" panose="020B0604020202020204" pitchFamily="34" charset="0"/>
              <a:buChar char="§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Alprazolam 1mg q6hrs as needed</a:t>
            </a:r>
          </a:p>
          <a:p>
            <a:pPr marL="457200" indent="-457200">
              <a:buFont typeface="Wingdings,Sans-Serif" panose="020B0604020202020204" pitchFamily="34" charset="0"/>
              <a:buChar char="§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Atorvastatin 20mg bedtime</a:t>
            </a:r>
          </a:p>
          <a:p>
            <a:pPr marL="457200" indent="-457200">
              <a:buFont typeface="Wingdings,Sans-Serif" panose="020B0604020202020204" pitchFamily="34" charset="0"/>
              <a:buChar char="§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Lisinopril 20mg daily</a:t>
            </a:r>
          </a:p>
          <a:p>
            <a:pPr marL="457200" indent="-457200">
              <a:buFont typeface="Wingdings,Sans-Serif" panose="020B0604020202020204" pitchFamily="34" charset="0"/>
              <a:buChar char="§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Metoprolol Tartrate 50mg TID</a:t>
            </a:r>
          </a:p>
          <a:p>
            <a:pPr marL="457200" indent="-457200">
              <a:buFont typeface="Wingdings,Sans-Serif" panose="020B0604020202020204" pitchFamily="34" charset="0"/>
              <a:buChar char="§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Metformin 500mg BID</a:t>
            </a:r>
          </a:p>
          <a:p>
            <a:pPr marL="457200" indent="-457200">
              <a:buFont typeface="Wingdings,Sans-Serif" panose="020B0604020202020204" pitchFamily="34" charset="0"/>
              <a:buChar char="§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Ibuprofen 600mg as needed 3 times</a:t>
            </a:r>
            <a:r>
              <a:rPr lang="en-US" sz="2800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 a</a:t>
            </a: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 day</a:t>
            </a:r>
          </a:p>
          <a:p>
            <a:pPr marL="457200" indent="-457200">
              <a:buFont typeface="Wingdings,Sans-Serif" panose="020B0604020202020204" pitchFamily="34" charset="0"/>
              <a:buChar char="§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Pantoprazole 40mg daily</a:t>
            </a:r>
            <a:endParaRPr lang="en-US" sz="2800" dirty="0">
              <a:solidFill>
                <a:schemeClr val="tx1">
                  <a:lumMod val="75000"/>
                </a:schemeClr>
              </a:solidFill>
              <a:ea typeface="+mn-lt"/>
              <a:cs typeface="+mn-lt"/>
            </a:endParaRPr>
          </a:p>
          <a:p>
            <a:pPr marL="457200" indent="-457200">
              <a:buFont typeface="Wingdings,Sans-Serif" panose="020B0604020202020204" pitchFamily="34" charset="0"/>
              <a:buChar char="§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Quetiapine 100mg bedtime</a:t>
            </a:r>
            <a:endParaRPr lang="en-US" dirty="0">
              <a:solidFill>
                <a:schemeClr val="tx1">
                  <a:lumMod val="75000"/>
                </a:schemeClr>
              </a:solidFill>
            </a:endParaRPr>
          </a:p>
          <a:p>
            <a:pPr marL="457200" lvl="1" indent="0">
              <a:buNone/>
            </a:pPr>
            <a:endParaRPr lang="en-US" sz="2800" dirty="0">
              <a:solidFill>
                <a:schemeClr val="tx1">
                  <a:lumMod val="75000"/>
                </a:schemeClr>
              </a:solidFill>
              <a:cs typeface="Calibri"/>
            </a:endParaRP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dirty="0"/>
          </a:p>
          <a:p>
            <a:pPr>
              <a:buFont typeface="Arial,Sans-Serif" panose="020B0604020202020204" pitchFamily="34" charset="0"/>
              <a:buChar char="•"/>
            </a:pPr>
            <a:endParaRPr lang="en-US" dirty="0"/>
          </a:p>
          <a:p>
            <a:pPr marL="457200" indent="-457200">
              <a:buFont typeface="Arial,Sans-Serif" panose="020B0604020202020204" pitchFamily="34" charset="0"/>
              <a:buChar char="•"/>
            </a:pPr>
            <a:endParaRPr lang="en-US" dirty="0"/>
          </a:p>
          <a:p>
            <a:pPr>
              <a:buFont typeface="Arial,Sans-Serif" panose="020B0604020202020204" pitchFamily="34" charset="0"/>
              <a:buChar char="•"/>
            </a:pPr>
            <a:endParaRPr lang="en-US" dirty="0"/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4642646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1" name="Rectangle 10">
            <a:extLst>
              <a:ext uri="{FF2B5EF4-FFF2-40B4-BE49-F238E27FC236}">
                <a16:creationId xmlns:a16="http://schemas.microsoft.com/office/drawing/2014/main" id="{6A1473A6-3F22-483E-8A30-80B9D2B1459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1714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AA1375E3-3E53-4D75-BAB7-E5929BFCB25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 flipH="1">
            <a:off x="400762" y="563918"/>
            <a:ext cx="3089954" cy="5978614"/>
            <a:chOff x="7513372" y="803186"/>
            <a:chExt cx="4163968" cy="5978614"/>
          </a:xfrm>
        </p:grpSpPr>
        <p:sp>
          <p:nvSpPr>
            <p:cNvPr id="14" name="Freeform 6">
              <a:extLst>
                <a:ext uri="{FF2B5EF4-FFF2-40B4-BE49-F238E27FC236}">
                  <a16:creationId xmlns:a16="http://schemas.microsoft.com/office/drawing/2014/main" id="{0BBEEF67-3DDF-46CF-8CD5-EA5F0E4FB07D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0989586" y="1070835"/>
              <a:ext cx="687754" cy="5710965"/>
            </a:xfrm>
            <a:custGeom>
              <a:avLst/>
              <a:gdLst>
                <a:gd name="T0" fmla="*/ 414 w 414"/>
                <a:gd name="T1" fmla="*/ 2447 h 2447"/>
                <a:gd name="T2" fmla="*/ 0 w 414"/>
                <a:gd name="T3" fmla="*/ 2247 h 2447"/>
                <a:gd name="T4" fmla="*/ 0 w 414"/>
                <a:gd name="T5" fmla="*/ 0 h 2447"/>
                <a:gd name="T6" fmla="*/ 414 w 414"/>
                <a:gd name="T7" fmla="*/ 200 h 2447"/>
                <a:gd name="T8" fmla="*/ 414 w 414"/>
                <a:gd name="T9" fmla="*/ 2447 h 24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14" h="2447">
                  <a:moveTo>
                    <a:pt x="414" y="2447"/>
                  </a:moveTo>
                  <a:lnTo>
                    <a:pt x="0" y="2247"/>
                  </a:lnTo>
                  <a:lnTo>
                    <a:pt x="0" y="0"/>
                  </a:lnTo>
                  <a:lnTo>
                    <a:pt x="414" y="200"/>
                  </a:lnTo>
                  <a:lnTo>
                    <a:pt x="414" y="2447"/>
                  </a:lnTo>
                  <a:close/>
                </a:path>
              </a:pathLst>
            </a:custGeom>
            <a:solidFill>
              <a:schemeClr val="accent1">
                <a:lumMod val="75000"/>
              </a:schemeClr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5" name="Freeform 7">
              <a:extLst>
                <a:ext uri="{FF2B5EF4-FFF2-40B4-BE49-F238E27FC236}">
                  <a16:creationId xmlns:a16="http://schemas.microsoft.com/office/drawing/2014/main" id="{8FAC1C95-F817-487C-B8B2-CF141FBB1C2E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0988949" y="803186"/>
              <a:ext cx="409371" cy="5521414"/>
            </a:xfrm>
            <a:custGeom>
              <a:avLst/>
              <a:gdLst>
                <a:gd name="T0" fmla="*/ 209 w 209"/>
                <a:gd name="T1" fmla="*/ 2246 h 2358"/>
                <a:gd name="T2" fmla="*/ 0 w 209"/>
                <a:gd name="T3" fmla="*/ 2358 h 2358"/>
                <a:gd name="T4" fmla="*/ 0 w 209"/>
                <a:gd name="T5" fmla="*/ 111 h 2358"/>
                <a:gd name="T6" fmla="*/ 209 w 209"/>
                <a:gd name="T7" fmla="*/ 0 h 2358"/>
                <a:gd name="T8" fmla="*/ 209 w 209"/>
                <a:gd name="T9" fmla="*/ 2246 h 23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09" h="2358">
                  <a:moveTo>
                    <a:pt x="209" y="2246"/>
                  </a:moveTo>
                  <a:lnTo>
                    <a:pt x="0" y="2358"/>
                  </a:lnTo>
                  <a:lnTo>
                    <a:pt x="0" y="111"/>
                  </a:lnTo>
                  <a:lnTo>
                    <a:pt x="209" y="0"/>
                  </a:lnTo>
                  <a:lnTo>
                    <a:pt x="209" y="2246"/>
                  </a:lnTo>
                  <a:close/>
                </a:path>
              </a:pathLst>
            </a:custGeom>
            <a:solidFill>
              <a:schemeClr val="accent1">
                <a:lumMod val="50000"/>
              </a:schemeClr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6" name="Rectangle 8">
              <a:extLst>
                <a:ext uri="{FF2B5EF4-FFF2-40B4-BE49-F238E27FC236}">
                  <a16:creationId xmlns:a16="http://schemas.microsoft.com/office/drawing/2014/main" id="{C2C5363A-D941-4AA1-8D38-D7E44A1E2E01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ChangeArrowhead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7513372" y="804101"/>
              <a:ext cx="3880238" cy="5251646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23851" y="885651"/>
            <a:ext cx="2422352" cy="4624603"/>
          </a:xfrm>
        </p:spPr>
        <p:txBody>
          <a:bodyPr>
            <a:normAutofit/>
          </a:bodyPr>
          <a:lstStyle/>
          <a:p>
            <a:r>
              <a:rPr lang="en-US" sz="3700" b="1" dirty="0">
                <a:solidFill>
                  <a:srgbClr val="FFFFFF"/>
                </a:solidFill>
                <a:ea typeface="+mj-lt"/>
                <a:cs typeface="+mj-lt"/>
              </a:rPr>
              <a:t>Medication Assessment</a:t>
            </a:r>
            <a:endParaRPr lang="en-US" sz="3700" dirty="0">
              <a:solidFill>
                <a:srgbClr val="FFFFFF"/>
              </a:solidFill>
            </a:endParaRP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>
          <a:xfrm>
            <a:off x="3694481" y="284489"/>
            <a:ext cx="5139126" cy="5827083"/>
          </a:xfrm>
        </p:spPr>
        <p:txBody>
          <a:bodyPr vert="horz" lIns="0" tIns="0" rIns="0" bIns="0" rtlCol="0" anchor="ctr">
            <a:normAutofit/>
          </a:bodyPr>
          <a:lstStyle/>
          <a:p>
            <a:r>
              <a:rPr lang="en-US" sz="2100" b="1" dirty="0">
                <a:ea typeface="+mn-lt"/>
                <a:cs typeface="+mn-lt"/>
              </a:rPr>
              <a:t>Medication reconciliation</a:t>
            </a:r>
            <a:r>
              <a:rPr lang="en-US" sz="2100" dirty="0">
                <a:ea typeface="+mn-lt"/>
                <a:cs typeface="+mn-lt"/>
              </a:rPr>
              <a:t> is the process of creating the </a:t>
            </a:r>
            <a:r>
              <a:rPr lang="en-US" sz="2100" b="1" dirty="0">
                <a:ea typeface="+mn-lt"/>
                <a:cs typeface="+mn-lt"/>
              </a:rPr>
              <a:t>most accurate list possible</a:t>
            </a:r>
            <a:r>
              <a:rPr lang="en-US" sz="2100" dirty="0">
                <a:ea typeface="+mn-lt"/>
                <a:cs typeface="+mn-lt"/>
              </a:rPr>
              <a:t> of all the </a:t>
            </a:r>
            <a:r>
              <a:rPr lang="en-US" sz="2100" b="1" dirty="0">
                <a:ea typeface="+mn-lt"/>
                <a:cs typeface="+mn-lt"/>
              </a:rPr>
              <a:t>medications</a:t>
            </a:r>
            <a:r>
              <a:rPr lang="en-US" sz="2100" dirty="0">
                <a:ea typeface="+mn-lt"/>
                <a:cs typeface="+mn-lt"/>
              </a:rPr>
              <a:t> a </a:t>
            </a:r>
            <a:r>
              <a:rPr lang="en-US" sz="2100" b="1" dirty="0">
                <a:ea typeface="+mn-lt"/>
                <a:cs typeface="+mn-lt"/>
              </a:rPr>
              <a:t>patient is taking </a:t>
            </a:r>
            <a:r>
              <a:rPr lang="en-US" sz="2100" dirty="0">
                <a:ea typeface="+mn-lt"/>
                <a:cs typeface="+mn-lt"/>
              </a:rPr>
              <a:t>(including drug name, dose, frequency and route). </a:t>
            </a:r>
          </a:p>
          <a:p>
            <a:pPr lvl="1"/>
            <a:r>
              <a:rPr lang="en-US" sz="1700" dirty="0">
                <a:ea typeface="+mn-lt"/>
                <a:cs typeface="+mn-lt"/>
              </a:rPr>
              <a:t>**Important to include supplements.**</a:t>
            </a:r>
            <a:endParaRPr lang="en-US" sz="1700" dirty="0">
              <a:cs typeface="Calibri"/>
            </a:endParaRPr>
          </a:p>
          <a:p>
            <a:r>
              <a:rPr lang="en-US" sz="2100" dirty="0">
                <a:ea typeface="+mn-lt"/>
                <a:cs typeface="+mn-lt"/>
              </a:rPr>
              <a:t>Compare this list after a </a:t>
            </a:r>
            <a:r>
              <a:rPr lang="en-US" sz="2100" b="1" dirty="0">
                <a:ea typeface="+mn-lt"/>
                <a:cs typeface="+mn-lt"/>
              </a:rPr>
              <a:t>recent hospital admission,</a:t>
            </a:r>
            <a:r>
              <a:rPr lang="en-US" sz="2100" dirty="0">
                <a:ea typeface="+mn-lt"/>
                <a:cs typeface="+mn-lt"/>
              </a:rPr>
              <a:t> doctor's office, or new medication adjustments.</a:t>
            </a:r>
            <a:endParaRPr lang="en-US" sz="2100" dirty="0">
              <a:cs typeface="Calibri"/>
            </a:endParaRPr>
          </a:p>
          <a:p>
            <a:r>
              <a:rPr lang="en-US" sz="2100" dirty="0">
                <a:ea typeface="+mn-lt"/>
                <a:cs typeface="+mn-lt"/>
              </a:rPr>
              <a:t>Recommend asking your patient to </a:t>
            </a:r>
            <a:r>
              <a:rPr lang="en-US" sz="2100" b="1" dirty="0">
                <a:ea typeface="+mn-lt"/>
                <a:cs typeface="+mn-lt"/>
              </a:rPr>
              <a:t>bring the medication</a:t>
            </a:r>
            <a:r>
              <a:rPr lang="en-US" sz="2100" dirty="0">
                <a:ea typeface="+mn-lt"/>
                <a:cs typeface="+mn-lt"/>
              </a:rPr>
              <a:t> </a:t>
            </a:r>
            <a:r>
              <a:rPr lang="en-US" sz="2100" b="1" dirty="0">
                <a:ea typeface="+mn-lt"/>
                <a:cs typeface="+mn-lt"/>
              </a:rPr>
              <a:t>bottles</a:t>
            </a:r>
            <a:r>
              <a:rPr lang="en-US" sz="2100" dirty="0">
                <a:ea typeface="+mn-lt"/>
                <a:cs typeface="+mn-lt"/>
              </a:rPr>
              <a:t> to the office visit. </a:t>
            </a:r>
          </a:p>
          <a:p>
            <a:r>
              <a:rPr lang="en-US" sz="2100" dirty="0">
                <a:ea typeface="+mn-lt"/>
                <a:cs typeface="+mn-lt"/>
              </a:rPr>
              <a:t>This process is designed to </a:t>
            </a:r>
            <a:r>
              <a:rPr lang="en-US" sz="2100" b="1" dirty="0">
                <a:ea typeface="+mn-lt"/>
                <a:cs typeface="+mn-lt"/>
              </a:rPr>
              <a:t>limit errors</a:t>
            </a:r>
            <a:r>
              <a:rPr lang="en-US" sz="2100" dirty="0">
                <a:ea typeface="+mn-lt"/>
                <a:cs typeface="+mn-lt"/>
              </a:rPr>
              <a:t> and </a:t>
            </a:r>
            <a:r>
              <a:rPr lang="en-US" sz="2100" b="1" dirty="0">
                <a:ea typeface="+mn-lt"/>
                <a:cs typeface="+mn-lt"/>
              </a:rPr>
              <a:t>discrepancies during transitions in care</a:t>
            </a:r>
            <a:r>
              <a:rPr lang="en-US" sz="2100" dirty="0">
                <a:ea typeface="+mn-lt"/>
                <a:cs typeface="+mn-lt"/>
              </a:rPr>
              <a:t>. </a:t>
            </a:r>
            <a:endParaRPr lang="en-US" sz="2100" dirty="0">
              <a:cs typeface="Calibri" panose="020F0502020204030204"/>
            </a:endParaRPr>
          </a:p>
        </p:txBody>
      </p:sp>
    </p:spTree>
    <p:extLst>
      <p:ext uri="{BB962C8B-B14F-4D97-AF65-F5344CB8AC3E}">
        <p14:creationId xmlns:p14="http://schemas.microsoft.com/office/powerpoint/2010/main" val="19861543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5518" y="206975"/>
            <a:ext cx="7886700" cy="1325563"/>
          </a:xfrm>
        </p:spPr>
        <p:txBody>
          <a:bodyPr>
            <a:normAutofit fontScale="90000"/>
          </a:bodyPr>
          <a:lstStyle/>
          <a:p>
            <a:pPr algn="ctr"/>
            <a:r>
              <a:rPr lang="en-US" sz="4900" b="1" dirty="0">
                <a:solidFill>
                  <a:schemeClr val="accent1"/>
                </a:solidFill>
                <a:ea typeface="+mj-lt"/>
                <a:cs typeface="+mj-lt"/>
              </a:rPr>
              <a:t>Pharmacokinetic Changes </a:t>
            </a:r>
            <a:br>
              <a:rPr lang="en-US" sz="4900" b="1" dirty="0">
                <a:ea typeface="+mj-lt"/>
                <a:cs typeface="+mj-lt"/>
              </a:rPr>
            </a:br>
            <a:r>
              <a:rPr lang="en-US" sz="4900" b="1" dirty="0">
                <a:solidFill>
                  <a:schemeClr val="accent1"/>
                </a:solidFill>
                <a:ea typeface="+mj-lt"/>
                <a:cs typeface="+mj-lt"/>
              </a:rPr>
              <a:t>with Age</a:t>
            </a:r>
            <a:endParaRPr lang="en-US" dirty="0">
              <a:solidFill>
                <a:schemeClr val="accent1"/>
              </a:solidFill>
            </a:endParaRP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>
          <a:xfrm>
            <a:off x="484877" y="1710606"/>
            <a:ext cx="8116737" cy="4595752"/>
          </a:xfrm>
        </p:spPr>
        <p:txBody>
          <a:bodyPr vert="horz" lIns="0" tIns="0" rIns="0" bIns="0" rtlCol="0" anchor="t">
            <a:noAutofit/>
          </a:bodyPr>
          <a:lstStyle/>
          <a:p>
            <a:endParaRPr lang="en-US" sz="2400" dirty="0">
              <a:solidFill>
                <a:schemeClr val="tx1">
                  <a:lumMod val="75000"/>
                </a:schemeClr>
              </a:solidFill>
              <a:cs typeface="Calibri"/>
            </a:endParaRPr>
          </a:p>
          <a:p>
            <a:pPr marL="744855" lvl="1" indent="-342900"/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Absorption</a:t>
            </a:r>
          </a:p>
          <a:p>
            <a:pPr lvl="3"/>
            <a:r>
              <a:rPr lang="en-US" sz="2400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Gastrointestinal – </a:t>
            </a:r>
            <a:r>
              <a:rPr lang="en-US" sz="2400" i="1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delayed, but no significant </a:t>
            </a:r>
          </a:p>
          <a:p>
            <a:pPr lvl="3"/>
            <a:r>
              <a:rPr lang="en-US" sz="2400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Intramuscular – </a:t>
            </a:r>
            <a:r>
              <a:rPr lang="en-US" sz="2400" i="1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possible </a:t>
            </a:r>
            <a:endParaRPr lang="en-US" sz="2400" i="1" dirty="0">
              <a:solidFill>
                <a:schemeClr val="tx1">
                  <a:lumMod val="75000"/>
                </a:schemeClr>
              </a:solidFill>
              <a:cs typeface="Calibri"/>
            </a:endParaRPr>
          </a:p>
          <a:p>
            <a:pPr lvl="3"/>
            <a:r>
              <a:rPr lang="en-US" sz="2400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Transdermal – </a:t>
            </a:r>
            <a:r>
              <a:rPr lang="en-US" sz="2400" i="1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possible </a:t>
            </a:r>
          </a:p>
          <a:p>
            <a:pPr marL="744855" lvl="1" indent="-342900"/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Distribution – </a:t>
            </a:r>
            <a:r>
              <a:rPr lang="en-US" i="1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larger Vd for fat soluble meds</a:t>
            </a:r>
            <a:endParaRPr lang="en-US" dirty="0">
              <a:solidFill>
                <a:schemeClr val="tx1">
                  <a:lumMod val="75000"/>
                </a:schemeClr>
              </a:solidFill>
              <a:ea typeface="+mn-lt"/>
              <a:cs typeface="+mn-lt"/>
            </a:endParaRPr>
          </a:p>
          <a:p>
            <a:pPr marL="800100" lvl="4" indent="-342900"/>
            <a:r>
              <a:rPr lang="en-US" sz="2400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protein binding - </a:t>
            </a:r>
            <a:r>
              <a:rPr lang="en-US" sz="2400" i="1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   albumin,    free fraction</a:t>
            </a:r>
            <a:endParaRPr lang="en-US" sz="2400" dirty="0">
              <a:solidFill>
                <a:schemeClr val="tx1">
                  <a:lumMod val="75000"/>
                </a:schemeClr>
              </a:solidFill>
              <a:ea typeface="+mn-lt"/>
              <a:cs typeface="+mn-lt"/>
            </a:endParaRPr>
          </a:p>
          <a:p>
            <a:pPr marL="744855" lvl="1" indent="-342900"/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Metabolism – </a:t>
            </a:r>
            <a:r>
              <a:rPr lang="en-US" i="1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some pathways </a:t>
            </a:r>
            <a:endParaRPr lang="en-US" sz="2400" i="1" dirty="0">
              <a:solidFill>
                <a:schemeClr val="tx1">
                  <a:lumMod val="75000"/>
                </a:schemeClr>
              </a:solidFill>
              <a:ea typeface="+mn-lt"/>
              <a:cs typeface="+mn-lt"/>
            </a:endParaRPr>
          </a:p>
          <a:p>
            <a:pPr marL="744855" lvl="1" indent="-342900"/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Elimination -    </a:t>
            </a:r>
            <a:r>
              <a:rPr lang="en-US" i="1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renal function</a:t>
            </a:r>
            <a:endParaRPr lang="en-US" dirty="0">
              <a:solidFill>
                <a:schemeClr val="tx1">
                  <a:lumMod val="75000"/>
                </a:schemeClr>
              </a:solidFill>
              <a:cs typeface="Calibri" panose="020F0502020204030204"/>
            </a:endParaRPr>
          </a:p>
          <a:p>
            <a:pPr marL="744855" lvl="1" indent="-342900"/>
            <a:endParaRPr lang="en-US" sz="1400" i="1" dirty="0">
              <a:solidFill>
                <a:schemeClr val="tx1">
                  <a:lumMod val="75000"/>
                </a:schemeClr>
              </a:solidFill>
              <a:cs typeface="Calibri" panose="020F0502020204030204"/>
            </a:endParaRPr>
          </a:p>
          <a:p>
            <a:pPr marL="401955" lvl="1" indent="0">
              <a:buNone/>
            </a:pPr>
            <a:r>
              <a:rPr lang="en-US" sz="1400" dirty="0">
                <a:ea typeface="+mn-lt"/>
                <a:cs typeface="+mn-lt"/>
              </a:rPr>
              <a:t>*Vd = Volume of distribution</a:t>
            </a:r>
            <a:endParaRPr lang="en-US" sz="1400" i="1" dirty="0">
              <a:solidFill>
                <a:schemeClr val="tx1">
                  <a:lumMod val="75000"/>
                </a:schemeClr>
              </a:solidFill>
              <a:cs typeface="Calibri" panose="020F0502020204030204"/>
            </a:endParaRPr>
          </a:p>
          <a:p>
            <a:pPr lvl="1"/>
            <a:endParaRPr lang="en-US" dirty="0">
              <a:solidFill>
                <a:schemeClr val="tx1">
                  <a:lumMod val="75000"/>
                </a:schemeClr>
              </a:solidFill>
              <a:cs typeface="Calibri"/>
            </a:endParaRPr>
          </a:p>
          <a:p>
            <a:pPr>
              <a:buFont typeface="Arial" panose="020B0604020202020204" pitchFamily="34" charset="0"/>
              <a:buChar char="•"/>
            </a:pPr>
            <a:endParaRPr lang="en-US" dirty="0">
              <a:cs typeface="Calibri" panose="020F0502020204030204"/>
            </a:endParaRPr>
          </a:p>
          <a:p>
            <a:pPr>
              <a:buFont typeface="Arial,Sans-Serif" panose="020B0604020202020204" pitchFamily="34" charset="0"/>
              <a:buChar char="•"/>
            </a:pPr>
            <a:endParaRPr lang="en-US" dirty="0">
              <a:cs typeface="Calibri" panose="020F0502020204030204"/>
            </a:endParaRPr>
          </a:p>
          <a:p>
            <a:pPr>
              <a:buFont typeface="Arial,Sans-Serif" panose="020B0604020202020204" pitchFamily="34" charset="0"/>
              <a:buChar char="•"/>
            </a:pPr>
            <a:endParaRPr lang="en-US" dirty="0">
              <a:cs typeface="Calibri" panose="020F0502020204030204"/>
            </a:endParaRPr>
          </a:p>
          <a:p>
            <a:pPr>
              <a:buFont typeface="Arial,Sans-Serif" panose="020B0604020202020204" pitchFamily="34" charset="0"/>
              <a:buChar char="•"/>
            </a:pPr>
            <a:endParaRPr lang="en-US" dirty="0">
              <a:cs typeface="Calibri" panose="020F0502020204030204"/>
            </a:endParaRPr>
          </a:p>
          <a:p>
            <a:endParaRPr lang="en-US" dirty="0">
              <a:cs typeface="Calibri" panose="020F0502020204030204"/>
            </a:endParaRPr>
          </a:p>
          <a:p>
            <a:endParaRPr lang="en-US" dirty="0">
              <a:cs typeface="Calibri" panose="020F0502020204030204"/>
            </a:endParaRP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50D20C01-B162-4BB1-9410-4384BA49EF18}"/>
              </a:ext>
            </a:extLst>
          </p:cNvPr>
          <p:cNvCxnSpPr/>
          <p:nvPr/>
        </p:nvCxnSpPr>
        <p:spPr>
          <a:xfrm flipH="1">
            <a:off x="7660258" y="2540479"/>
            <a:ext cx="5750" cy="224287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A3B1B14B-3E1F-484D-A15D-FF88316AF03C}"/>
              </a:ext>
            </a:extLst>
          </p:cNvPr>
          <p:cNvCxnSpPr>
            <a:cxnSpLocks/>
          </p:cNvCxnSpPr>
          <p:nvPr/>
        </p:nvCxnSpPr>
        <p:spPr>
          <a:xfrm flipH="1">
            <a:off x="5172974" y="2943044"/>
            <a:ext cx="5750" cy="253041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F3F43E86-CED6-4534-B585-4256BFDCB905}"/>
              </a:ext>
            </a:extLst>
          </p:cNvPr>
          <p:cNvCxnSpPr>
            <a:cxnSpLocks/>
          </p:cNvCxnSpPr>
          <p:nvPr/>
        </p:nvCxnSpPr>
        <p:spPr>
          <a:xfrm flipH="1">
            <a:off x="5029200" y="3345610"/>
            <a:ext cx="5750" cy="224287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38AFD662-4CE6-4E58-B479-7342D3F5DF1D}"/>
              </a:ext>
            </a:extLst>
          </p:cNvPr>
          <p:cNvCxnSpPr>
            <a:cxnSpLocks/>
          </p:cNvCxnSpPr>
          <p:nvPr/>
        </p:nvCxnSpPr>
        <p:spPr>
          <a:xfrm flipH="1">
            <a:off x="3476445" y="4165119"/>
            <a:ext cx="5750" cy="224287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73C94A57-C434-42FA-A4A1-F916F81A6687}"/>
              </a:ext>
            </a:extLst>
          </p:cNvPr>
          <p:cNvCxnSpPr>
            <a:cxnSpLocks/>
          </p:cNvCxnSpPr>
          <p:nvPr/>
        </p:nvCxnSpPr>
        <p:spPr>
          <a:xfrm flipH="1">
            <a:off x="5014823" y="4567686"/>
            <a:ext cx="5750" cy="224287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25C888BA-02F1-4E49-8370-3C0FCA500A51}"/>
              </a:ext>
            </a:extLst>
          </p:cNvPr>
          <p:cNvCxnSpPr>
            <a:cxnSpLocks/>
          </p:cNvCxnSpPr>
          <p:nvPr/>
        </p:nvCxnSpPr>
        <p:spPr>
          <a:xfrm flipH="1">
            <a:off x="2872596" y="4999005"/>
            <a:ext cx="5750" cy="224287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0875CED3-5085-49C6-9ECD-F750A56F5CC8}"/>
              </a:ext>
            </a:extLst>
          </p:cNvPr>
          <p:cNvCxnSpPr>
            <a:cxnSpLocks/>
          </p:cNvCxnSpPr>
          <p:nvPr/>
        </p:nvCxnSpPr>
        <p:spPr>
          <a:xfrm flipV="1">
            <a:off x="4819290" y="4116236"/>
            <a:ext cx="23004" cy="307675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2860608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1"/>
          <p:cNvSpPr txBox="1">
            <a:spLocks/>
          </p:cNvSpPr>
          <p:nvPr/>
        </p:nvSpPr>
        <p:spPr>
          <a:xfrm>
            <a:off x="355757" y="381515"/>
            <a:ext cx="8229600" cy="1471669"/>
          </a:xfrm>
          <a:prstGeom prst="rect">
            <a:avLst/>
          </a:prstGeom>
        </p:spPr>
        <p:txBody>
          <a:bodyPr lIns="91440" tIns="45720" rIns="91440" bIns="45720" anchor="t"/>
          <a:lstStyle>
            <a:lvl1pPr algn="l" defTabSz="457200" rtl="0" eaLnBrk="1" latinLnBrk="0" hangingPunct="1">
              <a:spcBef>
                <a:spcPct val="0"/>
              </a:spcBef>
              <a:buNone/>
              <a:defRPr sz="2600" b="1" i="0" kern="1200">
                <a:solidFill>
                  <a:schemeClr val="accent1"/>
                </a:solidFill>
                <a:latin typeface="Calibri"/>
                <a:ea typeface="+mj-ea"/>
                <a:cs typeface="Calibri"/>
              </a:defRPr>
            </a:lvl1pPr>
          </a:lstStyle>
          <a:p>
            <a:pPr algn="ctr"/>
            <a:r>
              <a:rPr lang="en-US" sz="4800" dirty="0"/>
              <a:t>Medication Assessment:</a:t>
            </a:r>
          </a:p>
          <a:p>
            <a:pPr algn="ctr"/>
            <a:r>
              <a:rPr lang="en-US" sz="4800" b="0" dirty="0"/>
              <a:t>Prescribing Cascade 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930DA7B-D557-49D6-8C7F-07AB68A8383B}"/>
              </a:ext>
            </a:extLst>
          </p:cNvPr>
          <p:cNvSpPr txBox="1"/>
          <p:nvPr/>
        </p:nvSpPr>
        <p:spPr>
          <a:xfrm>
            <a:off x="611284" y="4614941"/>
            <a:ext cx="274320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endParaRPr lang="en-US" dirty="0">
              <a:cs typeface="Calibri"/>
            </a:endParaRP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6A99C90-F5FF-4D70-B824-644F0A4974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28650" y="2017625"/>
            <a:ext cx="7886700" cy="4351338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dirty="0">
                <a:cs typeface="Calibri"/>
              </a:rPr>
              <a:t>Given these pharmacologic changes it is not uncommon for older adults to experience drug side effects</a:t>
            </a:r>
          </a:p>
          <a:p>
            <a:pPr lvl="1"/>
            <a:r>
              <a:rPr lang="en-US" sz="2800" dirty="0">
                <a:cs typeface="Calibri"/>
              </a:rPr>
              <a:t>Adverse drug effects may be misinterpreted as a new medical condition</a:t>
            </a:r>
          </a:p>
          <a:p>
            <a:pPr lvl="2"/>
            <a:r>
              <a:rPr lang="en-US" sz="2800" dirty="0">
                <a:cs typeface="Calibri"/>
              </a:rPr>
              <a:t>A new drug is then prescribed to address the symptom, which can then in turn, result in an adverse drug effect</a:t>
            </a:r>
          </a:p>
          <a:p>
            <a:r>
              <a:rPr lang="en-US" dirty="0">
                <a:cs typeface="Calibri"/>
              </a:rPr>
              <a:t>This leads to a "Prescribing Cascade" causing unnecessary increasing medication list</a:t>
            </a:r>
          </a:p>
        </p:txBody>
      </p:sp>
    </p:spTree>
    <p:extLst>
      <p:ext uri="{BB962C8B-B14F-4D97-AF65-F5344CB8AC3E}">
        <p14:creationId xmlns:p14="http://schemas.microsoft.com/office/powerpoint/2010/main" val="13876118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>
            <a:extLst>
              <a:ext uri="{FF2B5EF4-FFF2-40B4-BE49-F238E27FC236}">
                <a16:creationId xmlns:a16="http://schemas.microsoft.com/office/drawing/2014/main" id="{BE41D8D5-BF1B-48E1-95BE-A2FA1D45D696}"/>
              </a:ext>
            </a:extLst>
          </p:cNvPr>
          <p:cNvSpPr txBox="1">
            <a:spLocks/>
          </p:cNvSpPr>
          <p:nvPr/>
        </p:nvSpPr>
        <p:spPr>
          <a:xfrm>
            <a:off x="719515" y="691161"/>
            <a:ext cx="7695129" cy="12590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>
              <a:spcAft>
                <a:spcPts val="600"/>
              </a:spcAft>
            </a:pPr>
            <a:r>
              <a:rPr lang="en-US" sz="4900" b="1" kern="1200" dirty="0">
                <a:solidFill>
                  <a:schemeClr val="accent1"/>
                </a:solidFill>
                <a:latin typeface="Calibri Light"/>
                <a:cs typeface="Calibri"/>
              </a:rPr>
              <a:t>Session Outline</a:t>
            </a:r>
            <a:endParaRPr lang="en-US" sz="4900" kern="1200" dirty="0">
              <a:solidFill>
                <a:schemeClr val="accent1"/>
              </a:solidFill>
              <a:latin typeface="Calibri Light"/>
              <a:cs typeface="Calibri"/>
            </a:endParaRPr>
          </a:p>
        </p:txBody>
      </p:sp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7CACB6FB-1027-4FD0-8C7E-D2E2B4263D4D}"/>
              </a:ext>
            </a:extLst>
          </p:cNvPr>
          <p:cNvSpPr txBox="1">
            <a:spLocks/>
          </p:cNvSpPr>
          <p:nvPr/>
        </p:nvSpPr>
        <p:spPr>
          <a:xfrm>
            <a:off x="777025" y="2322489"/>
            <a:ext cx="7565733" cy="3950582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>
            <a:defPPr>
              <a:defRPr lang="en-US"/>
            </a:defPPr>
            <a:lvl1pPr marL="0" algn="r" defTabSz="457200" rtl="0" eaLnBrk="1" latinLnBrk="0" hangingPunct="1"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285750" indent="-228600" algn="l" defTabSz="9144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3600" dirty="0">
                <a:solidFill>
                  <a:schemeClr val="tx1"/>
                </a:solidFill>
              </a:rPr>
              <a:t>Brief Didactics</a:t>
            </a:r>
            <a:endParaRPr lang="en-US" sz="3600" dirty="0">
              <a:solidFill>
                <a:schemeClr val="tx1"/>
              </a:solidFill>
              <a:cs typeface="Calibri"/>
            </a:endParaRPr>
          </a:p>
          <a:p>
            <a:pPr marL="285750" indent="-228600" algn="l" defTabSz="9144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3600" dirty="0">
                <a:solidFill>
                  <a:schemeClr val="tx1"/>
                </a:solidFill>
              </a:rPr>
              <a:t>Case Based Practice</a:t>
            </a:r>
            <a:endParaRPr lang="en-US" sz="3600" dirty="0">
              <a:solidFill>
                <a:schemeClr val="tx1"/>
              </a:solidFill>
              <a:cs typeface="Calibri"/>
            </a:endParaRPr>
          </a:p>
          <a:p>
            <a:pPr marL="630555" lvl="4" indent="-228600" defTabSz="9144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2400" dirty="0"/>
              <a:t>3 Small Group Breakouts with role playing of cases</a:t>
            </a:r>
            <a:endParaRPr lang="en-US" sz="2400" dirty="0">
              <a:cs typeface="Calibri"/>
            </a:endParaRPr>
          </a:p>
          <a:p>
            <a:pPr marL="630555" lvl="2" indent="-228600" defTabSz="9144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2400" dirty="0"/>
              <a:t>Students will work in Triads</a:t>
            </a:r>
          </a:p>
          <a:p>
            <a:pPr marL="1087755" lvl="3" indent="-228600" defTabSz="9144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2400" dirty="0"/>
              <a:t>A packet of handouts is available for each triad</a:t>
            </a:r>
            <a:endParaRPr lang="en-US" sz="2400" dirty="0">
              <a:cs typeface="Calibri"/>
            </a:endParaRPr>
          </a:p>
          <a:p>
            <a:pPr marL="1087755" lvl="3" indent="-228600" defTabSz="9144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2400" dirty="0"/>
              <a:t>Each student will be assigned letter A, B, or C and should follow their assigned handout instruction for each role-play</a:t>
            </a:r>
            <a:endParaRPr lang="en-US" sz="2400" dirty="0">
              <a:cs typeface="Calibri"/>
            </a:endParaRPr>
          </a:p>
          <a:p>
            <a:pPr marL="401955" lvl="2" defTabSz="914400">
              <a:lnSpc>
                <a:spcPct val="90000"/>
              </a:lnSpc>
              <a:spcAft>
                <a:spcPts val="600"/>
              </a:spcAft>
            </a:pPr>
            <a:endParaRPr lang="en-US" sz="2400" dirty="0"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695886494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780179-0182-4210-AB55-A169922803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8445" y="342181"/>
            <a:ext cx="8229600" cy="795528"/>
          </a:xfrm>
        </p:spPr>
        <p:txBody>
          <a:bodyPr>
            <a:normAutofit fontScale="90000"/>
          </a:bodyPr>
          <a:lstStyle/>
          <a:p>
            <a:pPr algn="ctr"/>
            <a:r>
              <a:rPr lang="en-US" sz="3200" b="1" dirty="0">
                <a:solidFill>
                  <a:schemeClr val="accent1"/>
                </a:solidFill>
              </a:rPr>
              <a:t>Case Vignette #2 - Medication Assessment </a:t>
            </a:r>
            <a:br>
              <a:rPr lang="en-US" sz="3200" b="0" dirty="0"/>
            </a:br>
            <a:r>
              <a:rPr lang="en-US" sz="3200" b="1" dirty="0">
                <a:solidFill>
                  <a:srgbClr val="C445BA"/>
                </a:solidFill>
              </a:rPr>
              <a:t>BREAKOUT SESSION 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392957-BD48-49DE-8599-0E44A1AE6D0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28445" y="1472241"/>
            <a:ext cx="5781675" cy="4572000"/>
          </a:xfrm>
        </p:spPr>
        <p:txBody>
          <a:bodyPr vert="horz" lIns="0" tIns="0" rIns="0" bIns="0" rtlCol="0" anchor="t">
            <a:noAutofit/>
          </a:bodyPr>
          <a:lstStyle/>
          <a:p>
            <a:r>
              <a:rPr lang="en-US" sz="2200" dirty="0">
                <a:latin typeface="Calibri"/>
                <a:ea typeface="Calibri"/>
                <a:cs typeface="Calibri"/>
              </a:rPr>
              <a:t>Maria Clark is an 85-year-old woman with a history of bipolar disorder, type 2 diabetes, hypertension, hyperlipidemia, hypothyroidism and anxiety coming in for a visit after a recent hospitalization for tremors.   </a:t>
            </a:r>
          </a:p>
          <a:p>
            <a:pPr rtl="0"/>
            <a:r>
              <a:rPr lang="en-US" sz="2200" dirty="0">
                <a:latin typeface="Calibri"/>
                <a:ea typeface="Calibri"/>
                <a:cs typeface="Calibri"/>
              </a:rPr>
              <a:t>MRI brain was negative for stroke.  Tremors thought to be due to benzodiazepine withdrawal from medication nonadherence.   </a:t>
            </a:r>
          </a:p>
          <a:p>
            <a:r>
              <a:rPr lang="en-US" sz="2200" dirty="0">
                <a:latin typeface="Calibri"/>
                <a:ea typeface="Calibri"/>
                <a:cs typeface="Calibri"/>
              </a:rPr>
              <a:t>She presents with her daughter who reports that she thinks Ms. Clark has been missing her medications and that she had a recent fall. 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F3F3D626-C811-4A4E-852E-878C7BE355E5}"/>
              </a:ext>
            </a:extLst>
          </p:cNvPr>
          <p:cNvSpPr/>
          <p:nvPr/>
        </p:nvSpPr>
        <p:spPr>
          <a:xfrm>
            <a:off x="6235128" y="1413516"/>
            <a:ext cx="2625968" cy="1723293"/>
          </a:xfrm>
          <a:prstGeom prst="rect">
            <a:avLst/>
          </a:prstGeom>
          <a:noFill/>
          <a:ln>
            <a:solidFill>
              <a:srgbClr val="C445BA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DB2EEFF-530F-4694-B201-0A930B600A3C}"/>
              </a:ext>
            </a:extLst>
          </p:cNvPr>
          <p:cNvSpPr txBox="1"/>
          <p:nvPr/>
        </p:nvSpPr>
        <p:spPr>
          <a:xfrm>
            <a:off x="6331125" y="1648530"/>
            <a:ext cx="2405222" cy="1261884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900" b="1" dirty="0">
                <a:solidFill>
                  <a:srgbClr val="C445BA"/>
                </a:solidFill>
                <a:ea typeface="+mn-lt"/>
                <a:cs typeface="+mn-lt"/>
              </a:rPr>
              <a:t>Student Guide</a:t>
            </a:r>
            <a:endParaRPr lang="en-US" sz="1900" dirty="0">
              <a:solidFill>
                <a:srgbClr val="C445BA"/>
              </a:solidFill>
              <a:ea typeface="+mn-lt"/>
              <a:cs typeface="+mn-lt"/>
            </a:endParaRPr>
          </a:p>
          <a:p>
            <a:r>
              <a:rPr lang="en-US" sz="1900" dirty="0">
                <a:solidFill>
                  <a:srgbClr val="C445BA"/>
                </a:solidFill>
                <a:cs typeface="Segoe UI"/>
              </a:rPr>
              <a:t>Student A – </a:t>
            </a:r>
            <a:r>
              <a:rPr lang="en-US" sz="1900" dirty="0">
                <a:solidFill>
                  <a:srgbClr val="C445BA"/>
                </a:solidFill>
                <a:ea typeface="+mn-lt"/>
                <a:cs typeface="+mn-lt"/>
              </a:rPr>
              <a:t>Observer</a:t>
            </a:r>
            <a:endParaRPr lang="en-US" sz="1900" dirty="0">
              <a:solidFill>
                <a:srgbClr val="C445BA"/>
              </a:solidFill>
              <a:cs typeface="Segoe UI"/>
            </a:endParaRPr>
          </a:p>
          <a:p>
            <a:r>
              <a:rPr lang="en-US" sz="1900" dirty="0">
                <a:solidFill>
                  <a:srgbClr val="C445BA"/>
                </a:solidFill>
                <a:cs typeface="Segoe UI"/>
              </a:rPr>
              <a:t>Student B – </a:t>
            </a:r>
            <a:r>
              <a:rPr lang="en-US" sz="1900" dirty="0">
                <a:solidFill>
                  <a:srgbClr val="C445BA"/>
                </a:solidFill>
                <a:ea typeface="+mn-lt"/>
                <a:cs typeface="+mn-lt"/>
              </a:rPr>
              <a:t>Clinician </a:t>
            </a:r>
            <a:endParaRPr lang="en-US" sz="1900" dirty="0">
              <a:solidFill>
                <a:srgbClr val="C445BA"/>
              </a:solidFill>
              <a:cs typeface="Segoe UI"/>
            </a:endParaRPr>
          </a:p>
          <a:p>
            <a:r>
              <a:rPr lang="en-US" sz="1900" dirty="0">
                <a:solidFill>
                  <a:srgbClr val="C445BA"/>
                </a:solidFill>
                <a:cs typeface="Segoe UI"/>
              </a:rPr>
              <a:t>Student C – </a:t>
            </a:r>
            <a:r>
              <a:rPr lang="en-US" sz="1900" dirty="0">
                <a:solidFill>
                  <a:srgbClr val="C445BA"/>
                </a:solidFill>
                <a:ea typeface="+mn-lt"/>
                <a:cs typeface="+mn-lt"/>
              </a:rPr>
              <a:t>Patient </a:t>
            </a:r>
            <a:endParaRPr lang="en-US" sz="1900" dirty="0">
              <a:solidFill>
                <a:srgbClr val="C445BA"/>
              </a:solidFill>
              <a:cs typeface="Segoe UI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1141BC7-349B-4BD4-A9CA-AE55A6EE3D44}"/>
              </a:ext>
            </a:extLst>
          </p:cNvPr>
          <p:cNvSpPr txBox="1"/>
          <p:nvPr/>
        </p:nvSpPr>
        <p:spPr>
          <a:xfrm>
            <a:off x="840896" y="5116363"/>
            <a:ext cx="8058150" cy="16389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>
              <a:spcAft>
                <a:spcPts val="300"/>
              </a:spcAft>
            </a:pPr>
            <a:r>
              <a:rPr lang="en-US" sz="2000" dirty="0"/>
              <a:t>You are to: </a:t>
            </a:r>
            <a:endParaRPr lang="en-US" sz="2000" dirty="0">
              <a:ea typeface="+mn-lt"/>
              <a:cs typeface="+mn-lt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b="1" dirty="0"/>
              <a:t>Perform a Medication Reconciliation for this patient</a:t>
            </a:r>
            <a:endParaRPr lang="en-US" sz="2000" b="1" dirty="0">
              <a:cs typeface="Calibri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b="1" dirty="0"/>
              <a:t>Note: </a:t>
            </a:r>
            <a:r>
              <a:rPr lang="en-US" sz="2000" dirty="0"/>
              <a:t>patient had a fall, but you will not assess that in this case, you will only focus on medications as this could be the underlying issue</a:t>
            </a:r>
            <a:endParaRPr lang="en-US" sz="2000" dirty="0">
              <a:ea typeface="+mn-lt"/>
              <a:cs typeface="+mn-lt"/>
            </a:endParaRPr>
          </a:p>
          <a:p>
            <a:pPr marL="285750" indent="-285750" algn="l">
              <a:buFont typeface="Arial" panose="020B0604020202020204" pitchFamily="34" charset="0"/>
              <a:buChar char="•"/>
            </a:pPr>
            <a:endParaRPr lang="en-US" dirty="0"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99530026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780179-0182-4210-AB55-A169922803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8445" y="342181"/>
            <a:ext cx="8301486" cy="1600660"/>
          </a:xfrm>
        </p:spPr>
        <p:txBody>
          <a:bodyPr>
            <a:noAutofit/>
          </a:bodyPr>
          <a:lstStyle/>
          <a:p>
            <a:pPr algn="ctr"/>
            <a:r>
              <a:rPr lang="en-US" sz="4900" b="1" dirty="0">
                <a:solidFill>
                  <a:schemeClr val="accent1"/>
                </a:solidFill>
                <a:ea typeface="+mj-lt"/>
                <a:cs typeface="+mj-lt"/>
              </a:rPr>
              <a:t>Summary: Medication Assessment</a:t>
            </a:r>
            <a:endParaRPr lang="en-US" sz="4900" dirty="0">
              <a:solidFill>
                <a:schemeClr val="accent1"/>
              </a:solidFill>
              <a:ea typeface="+mj-lt"/>
              <a:cs typeface="+mj-lt"/>
            </a:endParaRPr>
          </a:p>
        </p:txBody>
      </p:sp>
      <p:graphicFrame>
        <p:nvGraphicFramePr>
          <p:cNvPr id="8" name="Content Placeholder 2">
            <a:extLst>
              <a:ext uri="{FF2B5EF4-FFF2-40B4-BE49-F238E27FC236}">
                <a16:creationId xmlns:a16="http://schemas.microsoft.com/office/drawing/2014/main" id="{9D32441B-BB1B-4EC3-A3D6-DAB2DF5E11A6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617580247"/>
              </p:ext>
            </p:extLst>
          </p:nvPr>
        </p:nvGraphicFramePr>
        <p:xfrm>
          <a:off x="428445" y="1759788"/>
          <a:ext cx="8168317" cy="4500113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807323245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780179-0182-4210-AB55-A169922803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8445" y="342181"/>
            <a:ext cx="8301486" cy="1600660"/>
          </a:xfrm>
        </p:spPr>
        <p:txBody>
          <a:bodyPr>
            <a:noAutofit/>
          </a:bodyPr>
          <a:lstStyle/>
          <a:p>
            <a:pPr algn="ctr"/>
            <a:r>
              <a:rPr lang="en-US" sz="4900" b="1" dirty="0">
                <a:solidFill>
                  <a:schemeClr val="accent1"/>
                </a:solidFill>
                <a:ea typeface="+mj-lt"/>
                <a:cs typeface="+mj-lt"/>
              </a:rPr>
              <a:t>Case Vignette #3</a:t>
            </a:r>
            <a:endParaRPr lang="en-US" dirty="0">
              <a:solidFill>
                <a:schemeClr val="accent1"/>
              </a:solidFill>
            </a:endParaRP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392957-BD48-49DE-8599-0E44A1AE6D0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85954" y="1817299"/>
            <a:ext cx="8441486" cy="4543244"/>
          </a:xfrm>
        </p:spPr>
        <p:txBody>
          <a:bodyPr vert="horz" lIns="0" tIns="0" rIns="0" bIns="0" rtlCol="0" anchor="t">
            <a:noAutofit/>
          </a:bodyPr>
          <a:lstStyle/>
          <a:p>
            <a:endParaRPr lang="en-US" dirty="0">
              <a:latin typeface="Calibri"/>
              <a:ea typeface="+mn-lt"/>
              <a:cs typeface="Calibri"/>
            </a:endParaRPr>
          </a:p>
          <a:p>
            <a:pPr marL="457200" indent="-457200">
              <a:buFont typeface="Arial,Sans-Serif" panose="020B0604020202020204" pitchFamily="34" charset="0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Catherine James is an 82-year-old woman with a history of anxiety, osteoporosis, type 2 diabetes, spinal stenosis, and atrial fibrillation who is coming in to establish care.  </a:t>
            </a:r>
          </a:p>
          <a:p>
            <a:pPr marL="457200" indent="-457200">
              <a:buFont typeface="Arial,Sans-Serif" panose="020B0604020202020204" pitchFamily="34" charset="0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She was hospitalized earlier this month after a fall. She presents with her husband and aide who report that she fell in the bathroom last night. </a:t>
            </a:r>
            <a:endParaRPr lang="en-US" dirty="0">
              <a:solidFill>
                <a:schemeClr val="tx1">
                  <a:lumMod val="75000"/>
                </a:schemeClr>
              </a:solidFill>
            </a:endParaRPr>
          </a:p>
          <a:p>
            <a:pPr marL="457200" indent="-457200">
              <a:buFont typeface="Arial,Sans-Serif" panose="020B0604020202020204" pitchFamily="34" charset="0"/>
            </a:pP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70372529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D05B-1A6A-4785-9233-25614CFC03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44105" y="529282"/>
            <a:ext cx="8042695" cy="795528"/>
          </a:xfrm>
        </p:spPr>
        <p:txBody>
          <a:bodyPr>
            <a:normAutofit/>
          </a:bodyPr>
          <a:lstStyle/>
          <a:p>
            <a:pPr algn="ctr"/>
            <a:r>
              <a:rPr lang="en-US" sz="4900" b="1" dirty="0">
                <a:solidFill>
                  <a:schemeClr val="accent1"/>
                </a:solidFill>
              </a:rPr>
              <a:t>Falls in the Older Adul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EBB642-A9A1-4273-829D-59C1EBAD24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1817297"/>
            <a:ext cx="8229600" cy="4572000"/>
          </a:xfrm>
        </p:spPr>
        <p:txBody>
          <a:bodyPr vert="horz" lIns="0" tIns="0" rIns="0" bIns="0" rtlCol="0" anchor="t">
            <a:noAutofit/>
          </a:bodyPr>
          <a:lstStyle/>
          <a:p>
            <a:pPr marL="571500" indent="-571500">
              <a:buFont typeface="Arial"/>
              <a:buChar char="•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</a:rPr>
              <a:t>Leading cause of unintentional injury </a:t>
            </a:r>
          </a:p>
          <a:p>
            <a:pPr marL="742950" lvl="1">
              <a:buFont typeface="Arial"/>
              <a:buChar char="•"/>
            </a:pPr>
            <a:r>
              <a:rPr lang="en-US" sz="2800" dirty="0">
                <a:solidFill>
                  <a:schemeClr val="tx1">
                    <a:lumMod val="75000"/>
                  </a:schemeClr>
                </a:solidFill>
              </a:rPr>
              <a:t>6th leading cause of death in geriatric patient</a:t>
            </a:r>
            <a:endParaRPr lang="en-US" sz="2800" dirty="0">
              <a:solidFill>
                <a:schemeClr val="tx1">
                  <a:lumMod val="75000"/>
                </a:schemeClr>
              </a:solidFill>
              <a:cs typeface="Calibri"/>
            </a:endParaRPr>
          </a:p>
          <a:p>
            <a:pPr marL="571500" indent="-571500">
              <a:buFont typeface="Arial"/>
              <a:buChar char="•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</a:rPr>
              <a:t>Lead to functional decline, hospitalization, institutionalization, and increased healthcare costs</a:t>
            </a:r>
            <a:endParaRPr lang="en-US" dirty="0">
              <a:solidFill>
                <a:schemeClr val="tx1">
                  <a:lumMod val="75000"/>
                </a:schemeClr>
              </a:solidFill>
              <a:cs typeface="Calibri"/>
            </a:endParaRPr>
          </a:p>
          <a:p>
            <a:pPr marL="571500" indent="-571500">
              <a:buFont typeface="Arial"/>
              <a:buChar char="•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</a:rPr>
              <a:t>Risk factors </a:t>
            </a:r>
            <a:endParaRPr lang="en-US" dirty="0">
              <a:solidFill>
                <a:schemeClr val="tx1">
                  <a:lumMod val="75000"/>
                </a:schemeClr>
              </a:solidFill>
              <a:cs typeface="Calibri"/>
            </a:endParaRPr>
          </a:p>
          <a:p>
            <a:pPr marL="918845" lvl="2" indent="-164465">
              <a:buFont typeface="Arial"/>
              <a:buChar char="•"/>
            </a:pPr>
            <a:r>
              <a:rPr lang="en-US" sz="2800" dirty="0">
                <a:solidFill>
                  <a:schemeClr val="tx1">
                    <a:lumMod val="75000"/>
                  </a:schemeClr>
                </a:solidFill>
              </a:rPr>
              <a:t>Older age</a:t>
            </a:r>
            <a:endParaRPr lang="en-US" sz="2800" b="1" dirty="0">
              <a:solidFill>
                <a:schemeClr val="tx1">
                  <a:lumMod val="75000"/>
                </a:schemeClr>
              </a:solidFill>
            </a:endParaRPr>
          </a:p>
          <a:p>
            <a:pPr marL="918845" lvl="2" indent="-164465">
              <a:buFont typeface="Arial"/>
              <a:buChar char="•"/>
            </a:pPr>
            <a:r>
              <a:rPr lang="en-US" sz="2800" dirty="0">
                <a:solidFill>
                  <a:schemeClr val="tx1">
                    <a:lumMod val="75000"/>
                  </a:schemeClr>
                </a:solidFill>
              </a:rPr>
              <a:t>Cognitive impairment</a:t>
            </a:r>
            <a:endParaRPr lang="en-US" sz="2800" b="1" dirty="0">
              <a:solidFill>
                <a:schemeClr val="tx1">
                  <a:lumMod val="75000"/>
                </a:schemeClr>
              </a:solidFill>
            </a:endParaRPr>
          </a:p>
          <a:p>
            <a:pPr marL="918845" lvl="2" indent="-164465">
              <a:buFont typeface="Arial"/>
              <a:buChar char="•"/>
            </a:pPr>
            <a:r>
              <a:rPr lang="en-US" sz="2800" b="1" dirty="0">
                <a:solidFill>
                  <a:schemeClr val="tx1">
                    <a:lumMod val="75000"/>
                  </a:schemeClr>
                </a:solidFill>
              </a:rPr>
              <a:t>Functional impairment</a:t>
            </a:r>
            <a:endParaRPr lang="en-US" sz="2800" b="1" dirty="0">
              <a:solidFill>
                <a:schemeClr val="tx1">
                  <a:lumMod val="75000"/>
                </a:schemeClr>
              </a:solidFill>
              <a:cs typeface="Calibri"/>
            </a:endParaRPr>
          </a:p>
          <a:p>
            <a:pPr marL="918845" lvl="2" indent="-164465">
              <a:buFont typeface="Arial"/>
              <a:buChar char="•"/>
            </a:pPr>
            <a:r>
              <a:rPr lang="en-US" sz="2800" b="1" dirty="0">
                <a:solidFill>
                  <a:schemeClr val="tx1">
                    <a:lumMod val="75000"/>
                  </a:schemeClr>
                </a:solidFill>
              </a:rPr>
              <a:t>Impaired mobility </a:t>
            </a:r>
            <a:endParaRPr lang="en-US" sz="3600" b="1" dirty="0">
              <a:solidFill>
                <a:schemeClr val="tx1">
                  <a:lumMod val="7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39297039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D05B-1A6A-4785-9233-25614CFC03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57500" y="641"/>
            <a:ext cx="8430883" cy="2089491"/>
          </a:xfrm>
        </p:spPr>
        <p:txBody>
          <a:bodyPr>
            <a:normAutofit/>
          </a:bodyPr>
          <a:lstStyle/>
          <a:p>
            <a:pPr algn="ctr"/>
            <a:r>
              <a:rPr lang="en-US" sz="3600" b="1" dirty="0">
                <a:solidFill>
                  <a:schemeClr val="accent1"/>
                </a:solidFill>
                <a:ea typeface="+mj-lt"/>
                <a:cs typeface="+mj-lt"/>
              </a:rPr>
              <a:t>Activities of Daily Living (ADL)</a:t>
            </a:r>
            <a:br>
              <a:rPr lang="en-US" sz="3600" b="1" dirty="0">
                <a:ea typeface="+mj-lt"/>
                <a:cs typeface="+mj-lt"/>
              </a:rPr>
            </a:br>
            <a:r>
              <a:rPr lang="en-US" sz="3600" b="1" dirty="0">
                <a:solidFill>
                  <a:schemeClr val="accent1"/>
                </a:solidFill>
                <a:ea typeface="+mj-lt"/>
                <a:cs typeface="+mj-lt"/>
              </a:rPr>
              <a:t>Instrumental Activities of Daily Living (IADL) </a:t>
            </a:r>
            <a:endParaRPr lang="en-US" sz="3600" dirty="0">
              <a:solidFill>
                <a:schemeClr val="accent1"/>
              </a:solidFill>
            </a:endParaRP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EBB642-A9A1-4273-829D-59C1EBAD24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89723" y="1866577"/>
            <a:ext cx="4100373" cy="4510623"/>
          </a:xfrm>
        </p:spPr>
        <p:txBody>
          <a:bodyPr vert="horz" lIns="0" tIns="0" rIns="0" bIns="0" rtlCol="0" anchor="t">
            <a:noAutofit/>
          </a:bodyPr>
          <a:lstStyle/>
          <a:p>
            <a:pPr marL="0" indent="0" algn="ctr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2400" b="1" dirty="0">
                <a:ea typeface="+mn-lt"/>
                <a:cs typeface="+mn-lt"/>
              </a:rPr>
              <a:t>ADL</a:t>
            </a:r>
            <a:endParaRPr lang="en-US" sz="2400" dirty="0">
              <a:ea typeface="+mn-lt"/>
              <a:cs typeface="+mn-lt"/>
            </a:endParaRP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sz="2400" dirty="0">
                <a:ea typeface="+mn-lt"/>
                <a:cs typeface="+mn-lt"/>
              </a:rPr>
              <a:t>Bathing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sz="2400" dirty="0">
                <a:ea typeface="+mn-lt"/>
                <a:cs typeface="+mn-lt"/>
              </a:rPr>
              <a:t>Dressing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sz="2400" dirty="0">
                <a:ea typeface="+mn-lt"/>
                <a:cs typeface="+mn-lt"/>
              </a:rPr>
              <a:t>Toileting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sz="2400" dirty="0">
                <a:ea typeface="+mn-lt"/>
                <a:cs typeface="+mn-lt"/>
              </a:rPr>
              <a:t>Maintaining continence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sz="2400" dirty="0">
                <a:ea typeface="+mn-lt"/>
                <a:cs typeface="+mn-lt"/>
              </a:rPr>
              <a:t>Grooming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sz="2400" dirty="0">
                <a:ea typeface="+mn-lt"/>
                <a:cs typeface="+mn-lt"/>
              </a:rPr>
              <a:t>Feeding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sz="2400" dirty="0">
                <a:ea typeface="+mn-lt"/>
                <a:cs typeface="+mn-lt"/>
              </a:rPr>
              <a:t>Transferring</a:t>
            </a:r>
          </a:p>
          <a:p>
            <a:pPr>
              <a:buFont typeface="Arial"/>
              <a:buChar char="•"/>
            </a:pPr>
            <a:endParaRPr lang="en-US" sz="2400" dirty="0">
              <a:solidFill>
                <a:schemeClr val="tx1">
                  <a:lumMod val="75000"/>
                </a:schemeClr>
              </a:solidFill>
              <a:cs typeface="Calibri"/>
            </a:endParaRPr>
          </a:p>
        </p:txBody>
      </p:sp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4D827504-E1A9-459B-AC84-683A2E7257BC}"/>
              </a:ext>
            </a:extLst>
          </p:cNvPr>
          <p:cNvSpPr txBox="1">
            <a:spLocks/>
          </p:cNvSpPr>
          <p:nvPr/>
        </p:nvSpPr>
        <p:spPr>
          <a:xfrm>
            <a:off x="4848640" y="1867766"/>
            <a:ext cx="3211903" cy="5578415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2400" b="1" dirty="0">
                <a:ea typeface="+mn-lt"/>
                <a:cs typeface="+mn-lt"/>
              </a:rPr>
              <a:t>IADLs</a:t>
            </a:r>
            <a:endParaRPr lang="en-US" sz="2400" dirty="0">
              <a:ea typeface="+mn-lt"/>
              <a:cs typeface="+mn-lt"/>
            </a:endParaRP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sz="2400" dirty="0">
                <a:ea typeface="+mn-lt"/>
                <a:cs typeface="+mn-lt"/>
              </a:rPr>
              <a:t>Shopping for groceries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sz="2400" dirty="0">
                <a:ea typeface="+mn-lt"/>
                <a:cs typeface="+mn-lt"/>
              </a:rPr>
              <a:t>Driving or using public transportation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sz="2400" dirty="0">
                <a:ea typeface="+mn-lt"/>
                <a:cs typeface="+mn-lt"/>
              </a:rPr>
              <a:t>Using the telephone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sz="2400" dirty="0">
                <a:ea typeface="+mn-lt"/>
                <a:cs typeface="+mn-lt"/>
              </a:rPr>
              <a:t>Performing housework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sz="2400" dirty="0">
                <a:ea typeface="+mn-lt"/>
                <a:cs typeface="+mn-lt"/>
              </a:rPr>
              <a:t>Doing home repair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sz="2400" dirty="0">
                <a:ea typeface="+mn-lt"/>
                <a:cs typeface="+mn-lt"/>
              </a:rPr>
              <a:t>Preparing meals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sz="2400" dirty="0">
                <a:ea typeface="+mn-lt"/>
                <a:cs typeface="+mn-lt"/>
              </a:rPr>
              <a:t>Doing laundry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sz="2400" dirty="0">
                <a:ea typeface="+mn-lt"/>
                <a:cs typeface="+mn-lt"/>
              </a:rPr>
              <a:t>Taking medications</a:t>
            </a:r>
          </a:p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sz="2400" dirty="0">
                <a:ea typeface="+mn-lt"/>
                <a:cs typeface="+mn-lt"/>
              </a:rPr>
              <a:t>Handling finances</a:t>
            </a:r>
          </a:p>
          <a:p>
            <a:pPr algn="ctr">
              <a:buFont typeface="Arial,Sans-Serif"/>
              <a:buChar char="•"/>
            </a:pPr>
            <a:endParaRPr lang="en-US" dirty="0">
              <a:cs typeface="Calibri" panose="020F0502020204030204"/>
            </a:endParaRPr>
          </a:p>
          <a:p>
            <a:pPr marL="0" indent="0" algn="ctr">
              <a:lnSpc>
                <a:spcPct val="100000"/>
              </a:lnSpc>
              <a:spcBef>
                <a:spcPts val="0"/>
              </a:spcBef>
              <a:buNone/>
            </a:pPr>
            <a:endParaRPr lang="en-US" sz="2400" b="1" dirty="0">
              <a:ea typeface="+mn-lt"/>
              <a:cs typeface="+mn-lt"/>
            </a:endParaRPr>
          </a:p>
          <a:p>
            <a:pPr marL="571500" indent="-571500">
              <a:buFont typeface="Arial"/>
              <a:buChar char="•"/>
            </a:pPr>
            <a:endParaRPr lang="en-US" sz="2400" dirty="0">
              <a:solidFill>
                <a:schemeClr val="tx1">
                  <a:lumMod val="75000"/>
                </a:schemeClr>
              </a:solidFill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176268020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D05B-1A6A-4785-9233-25614CFC03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93555" y="620392"/>
            <a:ext cx="3081389" cy="5504688"/>
          </a:xfrm>
        </p:spPr>
        <p:txBody>
          <a:bodyPr>
            <a:normAutofit/>
          </a:bodyPr>
          <a:lstStyle/>
          <a:p>
            <a:pPr algn="ctr"/>
            <a:r>
              <a:rPr lang="en-US" b="1" dirty="0">
                <a:solidFill>
                  <a:schemeClr val="accent5"/>
                </a:solidFill>
                <a:ea typeface="+mj-lt"/>
                <a:cs typeface="+mj-lt"/>
              </a:rPr>
              <a:t>Mobility Assessment  </a:t>
            </a:r>
            <a:endParaRPr lang="en-US" dirty="0">
              <a:solidFill>
                <a:schemeClr val="accent5"/>
              </a:solidFill>
            </a:endParaRPr>
          </a:p>
        </p:txBody>
      </p:sp>
      <p:graphicFrame>
        <p:nvGraphicFramePr>
          <p:cNvPr id="5" name="Content Placeholder 2">
            <a:extLst>
              <a:ext uri="{FF2B5EF4-FFF2-40B4-BE49-F238E27FC236}">
                <a16:creationId xmlns:a16="http://schemas.microsoft.com/office/drawing/2014/main" id="{A30DB580-B4D2-4174-8E60-270C1221623D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601150070"/>
              </p:ext>
            </p:extLst>
          </p:nvPr>
        </p:nvGraphicFramePr>
        <p:xfrm>
          <a:off x="3819906" y="620392"/>
          <a:ext cx="4697730" cy="5504688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3614030429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D05B-1A6A-4785-9233-25614CFC03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15992" y="543659"/>
            <a:ext cx="8071448" cy="910549"/>
          </a:xfrm>
        </p:spPr>
        <p:txBody>
          <a:bodyPr>
            <a:normAutofit/>
          </a:bodyPr>
          <a:lstStyle/>
          <a:p>
            <a:pPr algn="ctr"/>
            <a:r>
              <a:rPr lang="en-US" sz="4900" b="1" dirty="0">
                <a:solidFill>
                  <a:schemeClr val="accent1"/>
                </a:solidFill>
                <a:ea typeface="+mj-lt"/>
                <a:cs typeface="+mj-lt"/>
              </a:rPr>
              <a:t>Fall History</a:t>
            </a:r>
            <a:endParaRPr lang="en-US" sz="4900" dirty="0">
              <a:solidFill>
                <a:schemeClr val="accent1"/>
              </a:solidFill>
              <a:cs typeface="Calibri Light" panose="020F0302020204030204"/>
            </a:endParaRP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EBB642-A9A1-4273-829D-59C1EBAD24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42823" y="1716656"/>
            <a:ext cx="3902015" cy="4471358"/>
          </a:xfrm>
        </p:spPr>
        <p:txBody>
          <a:bodyPr vert="horz" lIns="0" tIns="0" rIns="0" bIns="0" rtlCol="0" anchor="t">
            <a:noAutofit/>
          </a:bodyPr>
          <a:lstStyle/>
          <a:p>
            <a:pPr marL="342900" indent="-342900">
              <a:buFont typeface="Arial,Sans-Serif"/>
              <a:buChar char="•"/>
            </a:pPr>
            <a:r>
              <a:rPr lang="en-US" sz="2400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Activity of the faller at the time of the incident</a:t>
            </a:r>
          </a:p>
          <a:p>
            <a:pPr marL="285750" indent="-285750">
              <a:buFont typeface="Arial,Sans-Serif"/>
              <a:buChar char="•"/>
            </a:pPr>
            <a:r>
              <a:rPr lang="en-US" sz="2400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Prodromal symptoms (lightheadedness, imbalance, dizziness)</a:t>
            </a:r>
          </a:p>
          <a:p>
            <a:pPr marL="285750" indent="-285750">
              <a:buFont typeface="Arial,Sans-Serif"/>
              <a:buChar char="•"/>
            </a:pPr>
            <a:r>
              <a:rPr lang="en-US" sz="2400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Location / timing</a:t>
            </a:r>
          </a:p>
          <a:p>
            <a:pPr marL="285750" indent="-285750">
              <a:buFont typeface="Arial,Sans-Serif"/>
              <a:buChar char="•"/>
            </a:pPr>
            <a:r>
              <a:rPr lang="en-US" sz="2400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Loss of consciousness </a:t>
            </a:r>
            <a:endParaRPr lang="en-US" dirty="0">
              <a:solidFill>
                <a:schemeClr val="tx1">
                  <a:lumMod val="75000"/>
                </a:schemeClr>
              </a:solidFill>
              <a:ea typeface="+mn-lt"/>
              <a:cs typeface="+mn-lt"/>
            </a:endParaRPr>
          </a:p>
          <a:p>
            <a:pPr marL="742950" lvl="1" indent="-342900">
              <a:buFont typeface="Arial,Sans-Serif"/>
              <a:buChar char="•"/>
            </a:pPr>
            <a:r>
              <a:rPr lang="en-US" sz="1800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Consider orthostatic hypotension, cardiac disease or neurologic disease.</a:t>
            </a:r>
            <a:endParaRPr lang="en-US" sz="1800" dirty="0">
              <a:solidFill>
                <a:schemeClr val="tx1">
                  <a:lumMod val="75000"/>
                </a:schemeClr>
              </a:solidFill>
              <a:cs typeface="Calibri" panose="020F0502020204030204"/>
            </a:endParaRPr>
          </a:p>
          <a:p>
            <a:pPr marL="285750" indent="-285750">
              <a:buFont typeface="Arial,Sans-Serif"/>
              <a:buChar char="•"/>
            </a:pPr>
            <a:r>
              <a:rPr lang="en-US" sz="2400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Information on previous falls </a:t>
            </a:r>
            <a:endParaRPr lang="en-US" dirty="0">
              <a:solidFill>
                <a:schemeClr val="tx1">
                  <a:lumMod val="75000"/>
                </a:schemeClr>
              </a:solidFill>
            </a:endParaRPr>
          </a:p>
          <a:p>
            <a:pPr marL="571500" indent="-571500">
              <a:buFont typeface="Arial"/>
              <a:buChar char="•"/>
            </a:pPr>
            <a:endParaRPr lang="en-US" sz="2400" dirty="0">
              <a:solidFill>
                <a:schemeClr val="tx1">
                  <a:lumMod val="75000"/>
                </a:schemeClr>
              </a:solidFill>
              <a:cs typeface="Calibri"/>
            </a:endParaRPr>
          </a:p>
        </p:txBody>
      </p:sp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4D827504-E1A9-459B-AC84-683A2E7257BC}"/>
              </a:ext>
            </a:extLst>
          </p:cNvPr>
          <p:cNvSpPr txBox="1">
            <a:spLocks/>
          </p:cNvSpPr>
          <p:nvPr/>
        </p:nvSpPr>
        <p:spPr>
          <a:xfrm>
            <a:off x="4505864" y="1710905"/>
            <a:ext cx="4477110" cy="4066002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285750" indent="-285750">
              <a:buFont typeface="Arial,Sans-Serif"/>
              <a:buChar char="•"/>
            </a:pPr>
            <a:r>
              <a:rPr lang="en-US" sz="2400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Underlying chronic diseases </a:t>
            </a:r>
            <a:endParaRPr lang="en-US" dirty="0">
              <a:solidFill>
                <a:schemeClr val="tx1">
                  <a:lumMod val="75000"/>
                </a:schemeClr>
              </a:solidFill>
            </a:endParaRPr>
          </a:p>
          <a:p>
            <a:pPr marL="742950" lvl="1" indent="-342900">
              <a:buFont typeface="Arial,Sans-Serif"/>
              <a:buChar char="•"/>
            </a:pPr>
            <a:r>
              <a:rPr lang="en-US" sz="1800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Parkinson's Disease, knee osteoarthritis, cognitive  impairment, stroke, diabetes</a:t>
            </a:r>
            <a:endParaRPr lang="en-US" sz="1800" dirty="0">
              <a:solidFill>
                <a:schemeClr val="tx1">
                  <a:lumMod val="75000"/>
                </a:schemeClr>
              </a:solidFill>
              <a:cs typeface="Calibri"/>
            </a:endParaRPr>
          </a:p>
          <a:p>
            <a:pPr marL="285750" indent="-285750">
              <a:buFont typeface="Arial,Sans-Serif"/>
              <a:buChar char="•"/>
            </a:pPr>
            <a:r>
              <a:rPr lang="en-US" sz="2400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 Medications: </a:t>
            </a:r>
          </a:p>
          <a:p>
            <a:pPr marL="916305" lvl="2" indent="-285750">
              <a:buFont typeface="Arial,Sans-Serif"/>
              <a:buChar char="•"/>
            </a:pPr>
            <a:r>
              <a:rPr lang="en-US" sz="1800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Psychotropic medications, sedative hypnotic, antidepressant and BP meds</a:t>
            </a:r>
          </a:p>
          <a:p>
            <a:pPr marL="285750" indent="-285750">
              <a:buFont typeface="Arial,Sans-Serif"/>
              <a:buChar char="•"/>
            </a:pPr>
            <a:r>
              <a:rPr lang="en-US" sz="2400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Social History:</a:t>
            </a:r>
          </a:p>
          <a:p>
            <a:pPr marL="914400" lvl="2" indent="-285750">
              <a:buFont typeface="Arial,Sans-Serif"/>
              <a:buChar char="•"/>
            </a:pPr>
            <a:r>
              <a:rPr lang="en-US" sz="1800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Alcohol use </a:t>
            </a:r>
          </a:p>
          <a:p>
            <a:pPr marL="914400" lvl="2" indent="-285750">
              <a:buFont typeface="Arial,Sans-Serif"/>
              <a:buChar char="•"/>
            </a:pPr>
            <a:r>
              <a:rPr lang="en-US" sz="1800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Environmental factors in home</a:t>
            </a:r>
            <a:endParaRPr lang="en-US" sz="1800" dirty="0">
              <a:solidFill>
                <a:schemeClr val="tx1">
                  <a:lumMod val="75000"/>
                </a:schemeClr>
              </a:solidFill>
              <a:cs typeface="Calibri"/>
            </a:endParaRPr>
          </a:p>
          <a:p>
            <a:pPr>
              <a:buFont typeface="Arial,Sans-Serif"/>
              <a:buChar char="•"/>
            </a:pPr>
            <a:endParaRPr lang="en-US" dirty="0">
              <a:cs typeface="Calibri" panose="020F0502020204030204"/>
            </a:endParaRP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en-US" sz="2400" b="1" dirty="0">
              <a:ea typeface="+mn-lt"/>
              <a:cs typeface="+mn-lt"/>
            </a:endParaRPr>
          </a:p>
          <a:p>
            <a:pPr marL="571500" indent="-571500">
              <a:buFont typeface="Arial"/>
              <a:buChar char="•"/>
            </a:pPr>
            <a:endParaRPr lang="en-US" sz="2400" dirty="0">
              <a:solidFill>
                <a:schemeClr val="tx1">
                  <a:lumMod val="75000"/>
                </a:schemeClr>
              </a:solidFill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307065593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780179-0182-4210-AB55-A169922803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sz="4000" b="1" dirty="0">
                <a:solidFill>
                  <a:schemeClr val="accent1"/>
                </a:solidFill>
              </a:rPr>
              <a:t>Case Vignette #3 - Mobility</a:t>
            </a:r>
            <a:br>
              <a:rPr lang="en-US" sz="4000" b="0" dirty="0"/>
            </a:br>
            <a:r>
              <a:rPr lang="en-US" sz="4000" b="0" dirty="0">
                <a:solidFill>
                  <a:srgbClr val="C445BA"/>
                </a:solidFill>
              </a:rPr>
              <a:t>BREAKOUT SESSION </a:t>
            </a:r>
            <a:endParaRPr lang="en-US" sz="4000" dirty="0">
              <a:solidFill>
                <a:srgbClr val="C445BA"/>
              </a:solidFill>
            </a:endParaRP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392957-BD48-49DE-8599-0E44A1AE6D0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1788543"/>
            <a:ext cx="5334000" cy="4572000"/>
          </a:xfrm>
        </p:spPr>
        <p:txBody>
          <a:bodyPr vert="horz" lIns="0" tIns="0" rIns="0" bIns="0" rtlCol="0" anchor="t">
            <a:noAutofit/>
          </a:bodyPr>
          <a:lstStyle/>
          <a:p>
            <a:r>
              <a:rPr lang="en-US" sz="2400" dirty="0">
                <a:solidFill>
                  <a:schemeClr val="tx1">
                    <a:lumMod val="50000"/>
                  </a:schemeClr>
                </a:solidFill>
              </a:rPr>
              <a:t>Catherine James is an 82-year-old woman with a history of anxiety, osteoporosis, type 2 diabetes, spinal stenosis, and atrial fibrillation who is coming to see you to establish care.  </a:t>
            </a:r>
          </a:p>
          <a:p>
            <a:r>
              <a:rPr lang="en-US" sz="2400" dirty="0">
                <a:solidFill>
                  <a:schemeClr val="tx1">
                    <a:lumMod val="50000"/>
                  </a:schemeClr>
                </a:solidFill>
              </a:rPr>
              <a:t>She was hospitalized earlier this month after a fall. She presents today with her husband and aide who report that she fell in the bathroom </a:t>
            </a:r>
            <a:r>
              <a:rPr lang="en-US" sz="2400" dirty="0">
                <a:solidFill>
                  <a:schemeClr val="tx1">
                    <a:lumMod val="50000"/>
                  </a:schemeClr>
                </a:solidFill>
                <a:ea typeface="+mn-lt"/>
                <a:cs typeface="+mn-lt"/>
              </a:rPr>
              <a:t>last night</a:t>
            </a:r>
            <a:r>
              <a:rPr lang="en-US" sz="2400" dirty="0">
                <a:solidFill>
                  <a:schemeClr val="tx1">
                    <a:lumMod val="50000"/>
                  </a:schemeClr>
                </a:solidFill>
              </a:rPr>
              <a:t>. </a:t>
            </a:r>
            <a:endParaRPr lang="en-US" sz="2400" dirty="0">
              <a:solidFill>
                <a:schemeClr val="tx1">
                  <a:lumMod val="50000"/>
                </a:schemeClr>
              </a:solidFill>
              <a:cs typeface="Calibri"/>
            </a:endParaRPr>
          </a:p>
          <a:p>
            <a:endParaRPr lang="en-US" sz="2200" dirty="0">
              <a:latin typeface="Calibri"/>
              <a:ea typeface="Calibri"/>
              <a:cs typeface="Calibri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F3F3D626-C811-4A4E-852E-878C7BE355E5}"/>
              </a:ext>
            </a:extLst>
          </p:cNvPr>
          <p:cNvSpPr/>
          <p:nvPr/>
        </p:nvSpPr>
        <p:spPr>
          <a:xfrm>
            <a:off x="6042623" y="1952819"/>
            <a:ext cx="2625968" cy="1723293"/>
          </a:xfrm>
          <a:prstGeom prst="rect">
            <a:avLst/>
          </a:prstGeom>
          <a:noFill/>
          <a:ln>
            <a:solidFill>
              <a:srgbClr val="C445BA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DB2EEFF-530F-4694-B201-0A930B600A3C}"/>
              </a:ext>
            </a:extLst>
          </p:cNvPr>
          <p:cNvSpPr txBox="1"/>
          <p:nvPr/>
        </p:nvSpPr>
        <p:spPr>
          <a:xfrm>
            <a:off x="6196971" y="2114442"/>
            <a:ext cx="2490407" cy="1261884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900" b="1" dirty="0">
                <a:solidFill>
                  <a:srgbClr val="C445BA"/>
                </a:solidFill>
                <a:ea typeface="+mn-lt"/>
                <a:cs typeface="+mn-lt"/>
              </a:rPr>
              <a:t>Student Guide</a:t>
            </a:r>
            <a:endParaRPr lang="en-US" sz="1900" dirty="0">
              <a:solidFill>
                <a:srgbClr val="C445BA"/>
              </a:solidFill>
              <a:ea typeface="+mn-lt"/>
              <a:cs typeface="+mn-lt"/>
            </a:endParaRPr>
          </a:p>
          <a:p>
            <a:r>
              <a:rPr lang="en-US" sz="1900" dirty="0">
                <a:solidFill>
                  <a:srgbClr val="9E29B5"/>
                </a:solidFill>
                <a:cs typeface="Segoe UI"/>
              </a:rPr>
              <a:t>Student A – </a:t>
            </a:r>
            <a:r>
              <a:rPr lang="en-US" sz="1900" dirty="0">
                <a:solidFill>
                  <a:srgbClr val="9E29B5"/>
                </a:solidFill>
                <a:ea typeface="+mn-lt"/>
                <a:cs typeface="+mn-lt"/>
              </a:rPr>
              <a:t>Patient</a:t>
            </a:r>
            <a:endParaRPr lang="en-US" sz="1900" dirty="0">
              <a:cs typeface="Segoe UI"/>
            </a:endParaRPr>
          </a:p>
          <a:p>
            <a:r>
              <a:rPr lang="en-US" sz="1900" dirty="0">
                <a:solidFill>
                  <a:srgbClr val="9E29B5"/>
                </a:solidFill>
                <a:cs typeface="Segoe UI"/>
              </a:rPr>
              <a:t>Student B – </a:t>
            </a:r>
            <a:r>
              <a:rPr lang="en-US" sz="1900" dirty="0">
                <a:solidFill>
                  <a:srgbClr val="9E29B5"/>
                </a:solidFill>
                <a:ea typeface="+mn-lt"/>
                <a:cs typeface="+mn-lt"/>
              </a:rPr>
              <a:t>Observer </a:t>
            </a:r>
            <a:r>
              <a:rPr lang="en-US" sz="1900" dirty="0">
                <a:ea typeface="+mn-lt"/>
                <a:cs typeface="+mn-lt"/>
              </a:rPr>
              <a:t> </a:t>
            </a:r>
            <a:endParaRPr lang="en-US" sz="1900" dirty="0">
              <a:cs typeface="Segoe UI"/>
            </a:endParaRPr>
          </a:p>
          <a:p>
            <a:r>
              <a:rPr lang="en-US" sz="1900" dirty="0">
                <a:solidFill>
                  <a:srgbClr val="9E29B5"/>
                </a:solidFill>
                <a:cs typeface="Segoe UI"/>
              </a:rPr>
              <a:t>Student C – </a:t>
            </a:r>
            <a:r>
              <a:rPr lang="en-US" sz="1900" dirty="0">
                <a:solidFill>
                  <a:srgbClr val="9E29B5"/>
                </a:solidFill>
                <a:ea typeface="+mn-lt"/>
                <a:cs typeface="+mn-lt"/>
              </a:rPr>
              <a:t>Clinician</a:t>
            </a:r>
            <a:endParaRPr lang="en-US" sz="1900" dirty="0">
              <a:solidFill>
                <a:srgbClr val="53565A"/>
              </a:solidFill>
              <a:cs typeface="Calibri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1141BC7-349B-4BD4-A9CA-AE55A6EE3D44}"/>
              </a:ext>
            </a:extLst>
          </p:cNvPr>
          <p:cNvSpPr txBox="1"/>
          <p:nvPr/>
        </p:nvSpPr>
        <p:spPr>
          <a:xfrm>
            <a:off x="872157" y="4940959"/>
            <a:ext cx="8274718" cy="191590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>
              <a:spcAft>
                <a:spcPts val="300"/>
              </a:spcAft>
            </a:pPr>
            <a:r>
              <a:rPr lang="en-US" sz="2400" dirty="0"/>
              <a:t>You are to: </a:t>
            </a:r>
            <a:endParaRPr lang="en-US" sz="2400" dirty="0">
              <a:ea typeface="+mn-lt"/>
              <a:cs typeface="+mn-lt"/>
            </a:endParaRPr>
          </a:p>
          <a:p>
            <a:pPr>
              <a:buFont typeface="Arial" panose="020B0604020202020204" pitchFamily="34" charset="0"/>
              <a:buChar char="•"/>
            </a:pPr>
            <a:r>
              <a:rPr lang="en-US" sz="2800" b="1" dirty="0">
                <a:ea typeface="+mn-lt"/>
                <a:cs typeface="+mn-lt"/>
              </a:rPr>
              <a:t> Conduct a mobility assessment/fall history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sz="2800" b="1" dirty="0">
                <a:ea typeface="+mn-lt"/>
                <a:cs typeface="+mn-lt"/>
              </a:rPr>
              <a:t> Assess the patient's ADLs and IADL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dirty="0">
              <a:ea typeface="+mn-lt"/>
              <a:cs typeface="+mn-lt"/>
            </a:endParaRPr>
          </a:p>
          <a:p>
            <a:pPr marL="285750" indent="-285750" algn="l">
              <a:buFont typeface="Arial" panose="020B0604020202020204" pitchFamily="34" charset="0"/>
              <a:buChar char="•"/>
            </a:pPr>
            <a:endParaRPr lang="en-US" dirty="0"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956818366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D05B-1A6A-4785-9233-25614CFC03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199" y="629924"/>
            <a:ext cx="7712016" cy="1140584"/>
          </a:xfrm>
        </p:spPr>
        <p:txBody>
          <a:bodyPr>
            <a:normAutofit/>
          </a:bodyPr>
          <a:lstStyle/>
          <a:p>
            <a:pPr algn="ctr"/>
            <a:r>
              <a:rPr lang="en-US" sz="4900" b="1" dirty="0">
                <a:solidFill>
                  <a:schemeClr val="accent1"/>
                </a:solidFill>
                <a:ea typeface="+mj-lt"/>
                <a:cs typeface="+mj-lt"/>
              </a:rPr>
              <a:t>Debrief: Mobility Assessment</a:t>
            </a:r>
            <a:endParaRPr lang="en-US" dirty="0">
              <a:solidFill>
                <a:schemeClr val="accent1"/>
              </a:solidFill>
              <a:ea typeface="+mj-lt"/>
              <a:cs typeface="+mj-lt"/>
            </a:endParaRP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EBB642-A9A1-4273-829D-59C1EBAD24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1817297"/>
            <a:ext cx="8229600" cy="4572000"/>
          </a:xfrm>
        </p:spPr>
        <p:txBody>
          <a:bodyPr vert="horz" lIns="0" tIns="0" rIns="0" bIns="0" rtlCol="0" anchor="t">
            <a:noAutofit/>
          </a:bodyPr>
          <a:lstStyle/>
          <a:p>
            <a:pPr>
              <a:buFont typeface="Arial,Sans-Serif"/>
              <a:buChar char="•"/>
            </a:pPr>
            <a:endParaRPr lang="en-US" sz="2400" dirty="0">
              <a:solidFill>
                <a:schemeClr val="tx1">
                  <a:lumMod val="75000"/>
                </a:schemeClr>
              </a:solidFill>
              <a:cs typeface="Calibri"/>
            </a:endParaRPr>
          </a:p>
          <a:p>
            <a:pPr marL="457200" indent="-457200">
              <a:buFont typeface="Arial,Sans-Serif"/>
              <a:buChar char="•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Why did the patient fall or how did they fall?</a:t>
            </a:r>
          </a:p>
          <a:p>
            <a:pPr marL="457200" indent="-457200">
              <a:buFont typeface="Arial,Sans-Serif"/>
              <a:buChar char="•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What medication classes could be contributing to the risk of falls? </a:t>
            </a:r>
          </a:p>
          <a:p>
            <a:pPr lvl="2" indent="-457200">
              <a:buFont typeface="Courier New,monospace"/>
              <a:buChar char="o"/>
            </a:pPr>
            <a:r>
              <a:rPr lang="en-US" sz="2400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History of anxiety, osteoporosis, type II diabetes, spinal stenosis, and atrial fibrillation</a:t>
            </a:r>
          </a:p>
          <a:p>
            <a:pPr marL="457200" indent="-457200">
              <a:buFont typeface="Arial,Sans-Serif"/>
              <a:buChar char="•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What physical exam findings will you look for to test this hypothesis?</a:t>
            </a:r>
            <a:endParaRPr lang="en-US" dirty="0">
              <a:solidFill>
                <a:schemeClr val="tx1">
                  <a:lumMod val="75000"/>
                </a:schemeClr>
              </a:solidFill>
            </a:endParaRPr>
          </a:p>
          <a:p>
            <a:pPr>
              <a:buFont typeface="Arial,Sans-Serif"/>
              <a:buChar char="•"/>
            </a:pPr>
            <a:endParaRPr lang="en-US" dirty="0"/>
          </a:p>
          <a:p>
            <a:pPr marL="457200" indent="-457200">
              <a:buFont typeface="Arial,Sans-Serif"/>
              <a:buChar char="•"/>
            </a:pPr>
            <a:endParaRPr lang="en-US" sz="2400" dirty="0">
              <a:solidFill>
                <a:schemeClr val="tx1">
                  <a:lumMod val="75000"/>
                </a:schemeClr>
              </a:solidFill>
              <a:cs typeface="Calibri"/>
            </a:endParaRPr>
          </a:p>
          <a:p>
            <a:pPr marL="571500" indent="-571500">
              <a:buFont typeface="Arial"/>
              <a:buChar char="•"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16746710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1D05B-1A6A-4785-9233-25614CFC03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199" y="629924"/>
            <a:ext cx="7712016" cy="1140584"/>
          </a:xfrm>
        </p:spPr>
        <p:txBody>
          <a:bodyPr>
            <a:normAutofit fontScale="90000"/>
          </a:bodyPr>
          <a:lstStyle/>
          <a:p>
            <a:pPr algn="ctr"/>
            <a:r>
              <a:rPr lang="en-US" sz="4900" b="1" dirty="0">
                <a:solidFill>
                  <a:schemeClr val="accent1"/>
                </a:solidFill>
                <a:ea typeface="+mj-lt"/>
                <a:cs typeface="+mj-lt"/>
              </a:rPr>
              <a:t>Mobility Assessment – Physical Exam component </a:t>
            </a:r>
            <a:endParaRPr lang="en-US" b="1" dirty="0">
              <a:solidFill>
                <a:schemeClr val="accent1"/>
              </a:solidFill>
            </a:endParaRP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EBB642-A9A1-4273-829D-59C1EBAD24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86597" y="2291750"/>
            <a:ext cx="7582620" cy="2832342"/>
          </a:xfrm>
        </p:spPr>
        <p:txBody>
          <a:bodyPr vert="horz" lIns="0" tIns="0" rIns="0" bIns="0" rtlCol="0" anchor="t">
            <a:noAutofit/>
          </a:bodyPr>
          <a:lstStyle/>
          <a:p>
            <a:pPr>
              <a:buFont typeface="Arial"/>
              <a:buChar char="•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Most important part of the physical examination when assessing for falls risk is the musculoskeletal examination including assessment of postural stability</a:t>
            </a:r>
          </a:p>
          <a:p>
            <a:pPr>
              <a:buFont typeface="Arial"/>
              <a:buChar char="•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Timed "Get up and Go"</a:t>
            </a:r>
          </a:p>
          <a:p>
            <a:pPr marL="742950" lvl="1" indent="-285750">
              <a:buFont typeface="Arial,Sans-Serif"/>
              <a:buChar char="•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Qualitative and Quantitative component</a:t>
            </a:r>
            <a:endParaRPr lang="en-US" dirty="0">
              <a:solidFill>
                <a:schemeClr val="tx1">
                  <a:lumMod val="75000"/>
                </a:schemeClr>
              </a:solidFill>
              <a:cs typeface="Calibri" panose="020F0502020204030204"/>
            </a:endParaRPr>
          </a:p>
          <a:p>
            <a:pPr marL="742950" lvl="1" indent="-285750">
              <a:buFont typeface="Arial,Sans-Serif"/>
              <a:buChar char="•"/>
            </a:pPr>
            <a:r>
              <a:rPr lang="en-US" dirty="0">
                <a:ea typeface="+mn-lt"/>
                <a:cs typeface="+mn-lt"/>
              </a:rPr>
              <a:t>Of less value in healthy community-dwelling </a:t>
            </a:r>
            <a:endParaRPr lang="en-US" dirty="0">
              <a:solidFill>
                <a:schemeClr val="tx1">
                  <a:lumMod val="75000"/>
                </a:schemeClr>
              </a:solidFill>
              <a:cs typeface="Calibri"/>
            </a:endParaRPr>
          </a:p>
          <a:p>
            <a:pPr marL="457200" indent="-457200">
              <a:buFont typeface="Arial,Sans-Serif"/>
              <a:buChar char="•"/>
            </a:pPr>
            <a:endParaRPr lang="en-US" sz="2400" dirty="0">
              <a:cs typeface="Calibri"/>
            </a:endParaRPr>
          </a:p>
          <a:p>
            <a:pPr marL="571500" indent="-571500">
              <a:buFont typeface="Arial"/>
              <a:buChar char="•"/>
            </a:pPr>
            <a:endParaRPr lang="en-US" dirty="0">
              <a:cs typeface="Calibri" panose="020F0502020204030204"/>
            </a:endParaRPr>
          </a:p>
        </p:txBody>
      </p:sp>
    </p:spTree>
    <p:extLst>
      <p:ext uri="{BB962C8B-B14F-4D97-AF65-F5344CB8AC3E}">
        <p14:creationId xmlns:p14="http://schemas.microsoft.com/office/powerpoint/2010/main" val="21309720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4" name="Rectangle 13">
            <a:extLst>
              <a:ext uri="{FF2B5EF4-FFF2-40B4-BE49-F238E27FC236}">
                <a16:creationId xmlns:a16="http://schemas.microsoft.com/office/drawing/2014/main" id="{6C4028FD-8BAA-4A19-BFDE-594D991B755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1713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aphicFrame>
        <p:nvGraphicFramePr>
          <p:cNvPr id="4" name="TextBox 1">
            <a:extLst>
              <a:ext uri="{FF2B5EF4-FFF2-40B4-BE49-F238E27FC236}">
                <a16:creationId xmlns:a16="http://schemas.microsoft.com/office/drawing/2014/main" id="{C1FFCE84-EBCA-4D7F-9C21-DF600EF51E09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726418006"/>
              </p:ext>
            </p:extLst>
          </p:nvPr>
        </p:nvGraphicFramePr>
        <p:xfrm>
          <a:off x="419116" y="209972"/>
          <a:ext cx="8303625" cy="629868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3150183129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780179-0182-4210-AB55-A169922803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8445" y="342181"/>
            <a:ext cx="8301486" cy="1600660"/>
          </a:xfrm>
        </p:spPr>
        <p:txBody>
          <a:bodyPr>
            <a:noAutofit/>
          </a:bodyPr>
          <a:lstStyle/>
          <a:p>
            <a:pPr algn="ctr"/>
            <a:r>
              <a:rPr lang="en-US" sz="4900" b="1" dirty="0">
                <a:solidFill>
                  <a:schemeClr val="accent1"/>
                </a:solidFill>
                <a:ea typeface="+mj-lt"/>
                <a:cs typeface="+mj-lt"/>
              </a:rPr>
              <a:t>Case Vignette # 4</a:t>
            </a:r>
            <a:endParaRPr lang="en-US" dirty="0">
              <a:solidFill>
                <a:schemeClr val="accent1"/>
              </a:solidFill>
            </a:endParaRP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392957-BD48-49DE-8599-0E44A1AE6D0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28445" y="1759788"/>
            <a:ext cx="8168317" cy="4500113"/>
          </a:xfrm>
        </p:spPr>
        <p:txBody>
          <a:bodyPr vert="horz" lIns="0" tIns="0" rIns="0" bIns="0" rtlCol="0" anchor="t">
            <a:noAutofit/>
          </a:bodyPr>
          <a:lstStyle/>
          <a:p>
            <a:endParaRPr lang="en-US" dirty="0">
              <a:latin typeface="Calibri"/>
              <a:ea typeface="+mn-lt"/>
              <a:cs typeface="Calibri"/>
            </a:endParaRPr>
          </a:p>
          <a:p>
            <a:pPr marL="342900">
              <a:buFont typeface="Arial,Sans-Serif" panose="020B0604020202020204" pitchFamily="34" charset="0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Marcus Hoover is a 90-year-old man with history of hypertension and hypercholesterolemia who is coming in to see you for his annual check-up.  </a:t>
            </a:r>
          </a:p>
          <a:p>
            <a:pPr marL="342900">
              <a:buFont typeface="Arial,Sans-Serif" panose="020B0604020202020204" pitchFamily="34" charset="0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During your history he reports he had 2 recent falls.  </a:t>
            </a:r>
            <a:endParaRPr lang="en-US" dirty="0">
              <a:solidFill>
                <a:schemeClr val="tx1">
                  <a:lumMod val="75000"/>
                </a:schemeClr>
              </a:solidFill>
            </a:endParaRPr>
          </a:p>
          <a:p>
            <a:pPr marL="342900">
              <a:buFont typeface="Arial,Sans-Serif" panose="020B0604020202020204" pitchFamily="34" charset="0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He also reports some memory issues.  </a:t>
            </a:r>
          </a:p>
          <a:p>
            <a:pPr marL="342900">
              <a:buFont typeface="Arial,Sans-Serif" panose="020B0604020202020204" pitchFamily="34" charset="0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He currently lives alone.</a:t>
            </a:r>
          </a:p>
          <a:p>
            <a:pPr marL="457200" indent="-457200">
              <a:buFont typeface="Arial,Sans-Serif" panose="020B0604020202020204" pitchFamily="34" charset="0"/>
            </a:pPr>
            <a:endParaRPr lang="en-US" dirty="0"/>
          </a:p>
          <a:p>
            <a:pPr marL="457200" indent="-457200">
              <a:buFont typeface="Arial,Sans-Serif" panose="020B0604020202020204" pitchFamily="34" charset="0"/>
            </a:pP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438913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780179-0182-4210-AB55-A169922803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8445" y="225640"/>
            <a:ext cx="8301486" cy="1600660"/>
          </a:xfrm>
        </p:spPr>
        <p:txBody>
          <a:bodyPr>
            <a:noAutofit/>
          </a:bodyPr>
          <a:lstStyle/>
          <a:p>
            <a:pPr algn="ctr"/>
            <a:r>
              <a:rPr lang="en-US" sz="4800" b="1" dirty="0">
                <a:solidFill>
                  <a:schemeClr val="accent1"/>
                </a:solidFill>
                <a:ea typeface="+mj-lt"/>
                <a:cs typeface="+mj-lt"/>
              </a:rPr>
              <a:t>Comprehensive Geriatric Assessment</a:t>
            </a:r>
            <a:endParaRPr lang="en-US" sz="4000" dirty="0">
              <a:solidFill>
                <a:schemeClr val="accent1"/>
              </a:solidFill>
              <a:cs typeface="Calibri Light" panose="020F0302020204030204"/>
            </a:endParaRP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392957-BD48-49DE-8599-0E44A1AE6D0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28445" y="1831675"/>
            <a:ext cx="8168317" cy="4500113"/>
          </a:xfrm>
        </p:spPr>
        <p:txBody>
          <a:bodyPr vert="horz" lIns="0" tIns="0" rIns="0" bIns="0" rtlCol="0" anchor="t">
            <a:noAutofit/>
          </a:bodyPr>
          <a:lstStyle/>
          <a:p>
            <a:endParaRPr lang="en-US" dirty="0">
              <a:latin typeface="Calibri"/>
              <a:ea typeface="+mn-lt"/>
              <a:cs typeface="Calibri"/>
            </a:endParaRPr>
          </a:p>
          <a:p>
            <a:pPr marL="457200" indent="-457200">
              <a:buFont typeface="Arial,Sans-Serif" panose="020B0604020202020204" pitchFamily="34" charset="0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How would you evaluate this patient?</a:t>
            </a:r>
          </a:p>
          <a:p>
            <a:pPr marL="1200150" lvl="2" indent="-457200">
              <a:buFont typeface="Arial,Sans-Serif" panose="020B0604020202020204" pitchFamily="34" charset="0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What tools could you use?</a:t>
            </a:r>
          </a:p>
          <a:p>
            <a:pPr marL="1200150" lvl="2" indent="-457200">
              <a:buFont typeface="Arial,Sans-Serif" panose="020B0604020202020204" pitchFamily="34" charset="0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What other information would you want to know?</a:t>
            </a:r>
          </a:p>
          <a:p>
            <a:pPr marL="457200" indent="-457200">
              <a:buFont typeface="Arial,Sans-Serif" panose="020B0604020202020204" pitchFamily="34" charset="0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What are the important issues you want to discuss with your patient?</a:t>
            </a:r>
          </a:p>
          <a:p>
            <a:pPr marL="0"/>
            <a:endParaRPr lang="en-US" dirty="0">
              <a:ea typeface="+mn-lt"/>
              <a:cs typeface="+mn-lt"/>
            </a:endParaRPr>
          </a:p>
          <a:p>
            <a:pPr marL="342900">
              <a:buFont typeface="Arial,Sans-Serif" panose="020B0604020202020204" pitchFamily="34" charset="0"/>
            </a:pPr>
            <a:endParaRPr lang="en-US" dirty="0">
              <a:ea typeface="+mn-lt"/>
              <a:cs typeface="+mn-lt"/>
            </a:endParaRPr>
          </a:p>
          <a:p>
            <a:pPr marL="457200" indent="-457200">
              <a:buFont typeface="Arial,Sans-Serif" panose="020B0604020202020204" pitchFamily="34" charset="0"/>
            </a:pPr>
            <a:endParaRPr lang="en-US" dirty="0"/>
          </a:p>
          <a:p>
            <a:pPr marL="457200" indent="-457200">
              <a:buFont typeface="Arial,Sans-Serif" panose="020B0604020202020204" pitchFamily="34" charset="0"/>
            </a:pP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99099135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955A2079-FA98-4876-80F0-72364A7D2EA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1713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1B25B5AE-101B-4598-9301-A7C3DA5C0A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557188"/>
            <a:ext cx="7886700" cy="1133499"/>
          </a:xfrm>
        </p:spPr>
        <p:txBody>
          <a:bodyPr>
            <a:normAutofit/>
          </a:bodyPr>
          <a:lstStyle/>
          <a:p>
            <a:pPr algn="ctr"/>
            <a:r>
              <a:rPr lang="en-US" sz="3500" b="1" dirty="0">
                <a:solidFill>
                  <a:schemeClr val="accent1"/>
                </a:solidFill>
                <a:ea typeface="+mj-lt"/>
                <a:cs typeface="+mj-lt"/>
              </a:rPr>
              <a:t>What Matters Most</a:t>
            </a:r>
            <a:endParaRPr lang="en-US" sz="3500" dirty="0">
              <a:solidFill>
                <a:schemeClr val="accent1"/>
              </a:solidFill>
              <a:ea typeface="+mj-lt"/>
              <a:cs typeface="+mj-lt"/>
            </a:endParaRPr>
          </a:p>
          <a:p>
            <a:pPr algn="ctr"/>
            <a:r>
              <a:rPr lang="en-US" sz="3500" dirty="0">
                <a:solidFill>
                  <a:schemeClr val="accent1"/>
                </a:solidFill>
                <a:ea typeface="+mj-lt"/>
                <a:cs typeface="+mj-lt"/>
              </a:rPr>
              <a:t>Advanced Care Planning - Review</a:t>
            </a:r>
          </a:p>
          <a:p>
            <a:pPr algn="ctr"/>
            <a:endParaRPr lang="en-US" sz="3500" dirty="0">
              <a:cs typeface="Calibri Light"/>
            </a:endParaRPr>
          </a:p>
        </p:txBody>
      </p:sp>
      <p:graphicFrame>
        <p:nvGraphicFramePr>
          <p:cNvPr id="7" name="Content Placeholder 2">
            <a:extLst>
              <a:ext uri="{FF2B5EF4-FFF2-40B4-BE49-F238E27FC236}">
                <a16:creationId xmlns:a16="http://schemas.microsoft.com/office/drawing/2014/main" id="{77F6D1B8-AA4D-48AA-A891-C19EDB350E62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383883195"/>
              </p:ext>
            </p:extLst>
          </p:nvPr>
        </p:nvGraphicFramePr>
        <p:xfrm>
          <a:off x="628650" y="1828800"/>
          <a:ext cx="7886700" cy="435254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3459968171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F982F6-EF45-43D4-9379-C9D0714B15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 vert="horz" lIns="91440" tIns="45720" rIns="91440" bIns="45720" rtlCol="0" anchor="b">
            <a:normAutofit/>
          </a:bodyPr>
          <a:lstStyle/>
          <a:p>
            <a:pPr algn="ctr"/>
            <a:r>
              <a:rPr lang="en-US" sz="4900" b="1" dirty="0">
                <a:solidFill>
                  <a:schemeClr val="accent1"/>
                </a:solidFill>
              </a:rPr>
              <a:t>MOLST </a:t>
            </a:r>
            <a:br>
              <a:rPr lang="en-US" sz="3400" b="1" dirty="0">
                <a:solidFill>
                  <a:schemeClr val="accent1"/>
                </a:solidFill>
              </a:rPr>
            </a:br>
            <a:r>
              <a:rPr lang="en-US" sz="3400" b="1" dirty="0">
                <a:solidFill>
                  <a:schemeClr val="accent1"/>
                </a:solidFill>
              </a:rPr>
              <a:t>Medical Orders of Life Sustaining Treatment</a:t>
            </a:r>
            <a:endParaRPr lang="en-US" sz="3400" dirty="0">
              <a:solidFill>
                <a:schemeClr val="accent1"/>
              </a:solidFill>
              <a:cs typeface="Calibri Light" panose="020F0302020204030204"/>
            </a:endParaRPr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51CA8824-B909-4AC5-BC01-6A9216C30F4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vert="horz" lIns="91440" tIns="45720" rIns="91440" bIns="45720" rtlCol="0" anchor="t">
            <a:normAutofit fontScale="92500" lnSpcReduction="10000"/>
          </a:bodyPr>
          <a:lstStyle/>
          <a:p>
            <a:r>
              <a:rPr lang="en-US" b="1" dirty="0">
                <a:ea typeface="+mn-lt"/>
                <a:cs typeface="+mn-lt"/>
              </a:rPr>
              <a:t>For Patients that:</a:t>
            </a:r>
            <a:endParaRPr lang="en-US" dirty="0">
              <a:ea typeface="+mn-lt"/>
              <a:cs typeface="+mn-lt"/>
            </a:endParaRPr>
          </a:p>
          <a:p>
            <a:pPr marL="516255" lvl="1"/>
            <a:r>
              <a:rPr lang="en-US" dirty="0">
                <a:ea typeface="+mn-lt"/>
                <a:cs typeface="+mn-lt"/>
              </a:rPr>
              <a:t>Want to avoid or receive any or all life-sustaining treatment </a:t>
            </a:r>
          </a:p>
          <a:p>
            <a:pPr marL="516255" lvl="1"/>
            <a:r>
              <a:rPr lang="en-US" dirty="0">
                <a:ea typeface="+mn-lt"/>
                <a:cs typeface="+mn-lt"/>
              </a:rPr>
              <a:t>Reside in a long-term care facility or requires long-term care services </a:t>
            </a:r>
          </a:p>
          <a:p>
            <a:pPr marL="516255" lvl="1"/>
            <a:r>
              <a:rPr lang="en-US" dirty="0">
                <a:ea typeface="+mn-lt"/>
                <a:cs typeface="+mn-lt"/>
              </a:rPr>
              <a:t>Or might die in the next year</a:t>
            </a:r>
          </a:p>
          <a:p>
            <a:r>
              <a:rPr lang="en-US" b="1" dirty="0">
                <a:ea typeface="+mn-lt"/>
                <a:cs typeface="+mn-lt"/>
              </a:rPr>
              <a:t>MOLST Protocol outlines:</a:t>
            </a:r>
            <a:endParaRPr lang="en-US" dirty="0">
              <a:ea typeface="+mn-lt"/>
              <a:cs typeface="+mn-lt"/>
            </a:endParaRPr>
          </a:p>
          <a:p>
            <a:pPr marL="516255" lvl="1"/>
            <a:r>
              <a:rPr lang="en-US" dirty="0">
                <a:ea typeface="+mn-lt"/>
                <a:cs typeface="+mn-lt"/>
              </a:rPr>
              <a:t>Resuscitation Preferences</a:t>
            </a:r>
          </a:p>
          <a:p>
            <a:pPr marL="516255" lvl="1"/>
            <a:r>
              <a:rPr lang="en-US" dirty="0">
                <a:ea typeface="+mn-lt"/>
                <a:cs typeface="+mn-lt"/>
              </a:rPr>
              <a:t>Respiratory Support</a:t>
            </a:r>
          </a:p>
          <a:p>
            <a:pPr marL="516255" lvl="1"/>
            <a:r>
              <a:rPr lang="en-US" dirty="0">
                <a:ea typeface="+mn-lt"/>
                <a:cs typeface="+mn-lt"/>
              </a:rPr>
              <a:t>Future Hospitalization/Transfer</a:t>
            </a:r>
          </a:p>
          <a:p>
            <a:pPr marL="516255" lvl="1"/>
            <a:r>
              <a:rPr lang="en-US" dirty="0">
                <a:ea typeface="+mn-lt"/>
                <a:cs typeface="+mn-lt"/>
              </a:rPr>
              <a:t>Feeding Tubes</a:t>
            </a:r>
          </a:p>
          <a:p>
            <a:pPr marL="516255" lvl="1"/>
            <a:r>
              <a:rPr lang="en-US" dirty="0">
                <a:ea typeface="+mn-lt"/>
                <a:cs typeface="+mn-lt"/>
              </a:rPr>
              <a:t>Antibiotics</a:t>
            </a:r>
          </a:p>
          <a:p>
            <a:pPr marL="516255" lvl="1"/>
            <a:r>
              <a:rPr lang="en-US" dirty="0">
                <a:ea typeface="+mn-lt"/>
                <a:cs typeface="+mn-lt"/>
              </a:rPr>
              <a:t>Dialysis</a:t>
            </a:r>
          </a:p>
          <a:p>
            <a:endParaRPr lang="en-US" dirty="0">
              <a:cs typeface="Calibri"/>
            </a:endParaRPr>
          </a:p>
        </p:txBody>
      </p:sp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4F29D8EB-B36E-4E1C-A0A9-F3C87AE78047}"/>
              </a:ext>
            </a:extLst>
          </p:cNvPr>
          <p:cNvSpPr txBox="1">
            <a:spLocks/>
          </p:cNvSpPr>
          <p:nvPr/>
        </p:nvSpPr>
        <p:spPr>
          <a:xfrm>
            <a:off x="3313523" y="3680579"/>
            <a:ext cx="5630148" cy="4386053"/>
          </a:xfrm>
          <a:prstGeom prst="rect">
            <a:avLst/>
          </a:prstGeom>
        </p:spPr>
        <p:txBody>
          <a:bodyPr vert="horz" lIns="0" tIns="0" rIns="0" bIns="0" rtlCol="0" anchor="t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2000" b="1" dirty="0">
              <a:cs typeface="Calibri"/>
            </a:endParaRPr>
          </a:p>
          <a:p>
            <a:pPr marL="457200" indent="-457200">
              <a:buFont typeface="Arial,Sans-Serif" panose="020B0604020202020204" pitchFamily="34" charset="0"/>
              <a:buChar char="•"/>
            </a:pPr>
            <a:endParaRPr lang="en-US" sz="2000" dirty="0">
              <a:cs typeface="Calibri"/>
            </a:endParaRPr>
          </a:p>
          <a:p>
            <a:pPr marL="0"/>
            <a:endParaRPr lang="en-US" sz="2000" dirty="0">
              <a:ea typeface="+mn-lt"/>
              <a:cs typeface="+mn-lt"/>
            </a:endParaRPr>
          </a:p>
          <a:p>
            <a:pPr marL="342900">
              <a:buFont typeface="Arial,Sans-Serif" panose="020B0604020202020204" pitchFamily="34" charset="0"/>
              <a:buChar char="•"/>
            </a:pPr>
            <a:endParaRPr lang="en-US" sz="2000" dirty="0">
              <a:ea typeface="+mn-lt"/>
              <a:cs typeface="+mn-lt"/>
            </a:endParaRPr>
          </a:p>
          <a:p>
            <a:pPr marL="457200" indent="-457200">
              <a:buFont typeface="Arial,Sans-Serif" panose="020B0604020202020204" pitchFamily="34" charset="0"/>
              <a:buChar char="•"/>
            </a:pPr>
            <a:endParaRPr lang="en-US" sz="2000" dirty="0">
              <a:cs typeface="Calibri"/>
            </a:endParaRPr>
          </a:p>
          <a:p>
            <a:pPr marL="457200" indent="-457200">
              <a:buFont typeface="Arial,Sans-Serif" panose="020B0604020202020204" pitchFamily="34" charset="0"/>
              <a:buChar char="•"/>
            </a:pPr>
            <a:endParaRPr lang="en-US" sz="2000" dirty="0">
              <a:cs typeface="Calibri"/>
            </a:endParaRPr>
          </a:p>
          <a:p>
            <a:endParaRPr lang="en-US" sz="2000" dirty="0">
              <a:cs typeface="Calibri"/>
            </a:endParaRPr>
          </a:p>
        </p:txBody>
      </p:sp>
      <p:sp>
        <p:nvSpPr>
          <p:cNvPr id="10" name="Content Placeholder 3">
            <a:extLst>
              <a:ext uri="{FF2B5EF4-FFF2-40B4-BE49-F238E27FC236}">
                <a16:creationId xmlns:a16="http://schemas.microsoft.com/office/drawing/2014/main" id="{A24E8223-70D1-41D8-9E71-20F6F80F3BA3}"/>
              </a:ext>
            </a:extLst>
          </p:cNvPr>
          <p:cNvSpPr>
            <a:spLocks noGrp="1"/>
          </p:cNvSpPr>
          <p:nvPr/>
        </p:nvSpPr>
        <p:spPr>
          <a:xfrm>
            <a:off x="4203700" y="2252663"/>
            <a:ext cx="4940300" cy="4227512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2400" b="1" dirty="0">
              <a:cs typeface="Calibri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B180ABE-F388-4A99-A29D-DADED593A780}"/>
              </a:ext>
            </a:extLst>
          </p:cNvPr>
          <p:cNvSpPr txBox="1"/>
          <p:nvPr/>
        </p:nvSpPr>
        <p:spPr>
          <a:xfrm>
            <a:off x="5067452" y="6087499"/>
            <a:ext cx="4063797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endParaRPr lang="en-US" i="1" dirty="0">
              <a:cs typeface="Calibri"/>
            </a:endParaRPr>
          </a:p>
          <a:p>
            <a:r>
              <a:rPr lang="en-US" dirty="0">
                <a:cs typeface="Calibri"/>
              </a:rPr>
              <a:t>For more information: https://molst.org/</a:t>
            </a:r>
          </a:p>
        </p:txBody>
      </p:sp>
    </p:spTree>
    <p:extLst>
      <p:ext uri="{BB962C8B-B14F-4D97-AF65-F5344CB8AC3E}">
        <p14:creationId xmlns:p14="http://schemas.microsoft.com/office/powerpoint/2010/main" val="162437508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780179-0182-4210-AB55-A169922803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28445" y="342181"/>
            <a:ext cx="8416504" cy="1011189"/>
          </a:xfrm>
        </p:spPr>
        <p:txBody>
          <a:bodyPr>
            <a:noAutofit/>
          </a:bodyPr>
          <a:lstStyle/>
          <a:p>
            <a:pPr algn="ctr"/>
            <a:r>
              <a:rPr lang="en-US" sz="4900" b="1" dirty="0">
                <a:solidFill>
                  <a:schemeClr val="accent1"/>
                </a:solidFill>
                <a:ea typeface="+mj-lt"/>
                <a:cs typeface="+mj-lt"/>
              </a:rPr>
              <a:t>The 5 Wishes</a:t>
            </a:r>
            <a:endParaRPr lang="en-US" b="1" dirty="0">
              <a:solidFill>
                <a:schemeClr val="accent1"/>
              </a:solidFill>
            </a:endParaRPr>
          </a:p>
        </p:txBody>
      </p:sp>
      <p:graphicFrame>
        <p:nvGraphicFramePr>
          <p:cNvPr id="5" name="Content Placeholder 2">
            <a:extLst>
              <a:ext uri="{FF2B5EF4-FFF2-40B4-BE49-F238E27FC236}">
                <a16:creationId xmlns:a16="http://schemas.microsoft.com/office/drawing/2014/main" id="{FB2B1999-E146-48D9-993B-7224F4B2C90C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428445" y="1500996"/>
          <a:ext cx="8168317" cy="4500113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sp>
        <p:nvSpPr>
          <p:cNvPr id="26" name="TextBox 25">
            <a:extLst>
              <a:ext uri="{FF2B5EF4-FFF2-40B4-BE49-F238E27FC236}">
                <a16:creationId xmlns:a16="http://schemas.microsoft.com/office/drawing/2014/main" id="{91F1832B-6891-4A64-8B05-87ACC589EC41}"/>
              </a:ext>
            </a:extLst>
          </p:cNvPr>
          <p:cNvSpPr txBox="1"/>
          <p:nvPr/>
        </p:nvSpPr>
        <p:spPr>
          <a:xfrm>
            <a:off x="4572000" y="6414449"/>
            <a:ext cx="4565175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dirty="0"/>
              <a:t>For more information: https://fivewishes.org/</a:t>
            </a:r>
          </a:p>
        </p:txBody>
      </p:sp>
    </p:spTree>
    <p:extLst>
      <p:ext uri="{BB962C8B-B14F-4D97-AF65-F5344CB8AC3E}">
        <p14:creationId xmlns:p14="http://schemas.microsoft.com/office/powerpoint/2010/main" val="2623007478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DED9B5-6E86-C20B-6B9E-3F1C72E806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b="1" dirty="0">
                <a:solidFill>
                  <a:schemeClr val="accent1"/>
                </a:solidFill>
                <a:cs typeface="Calibri Light"/>
              </a:rPr>
              <a:t>Additional Resources for Advance Care Planning</a:t>
            </a:r>
            <a:endParaRPr lang="en-US" dirty="0">
              <a:solidFill>
                <a:schemeClr val="accent1"/>
              </a:solidFill>
            </a:endParaRP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AACC01-B4DC-53C5-CD7E-B49F8C033D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vert="horz" lIns="91440" tIns="45720" rIns="91440" bIns="45720" rtlCol="0" anchor="t">
            <a:normAutofit fontScale="85000" lnSpcReduction="10000"/>
          </a:bodyPr>
          <a:lstStyle/>
          <a:p>
            <a:r>
              <a:rPr lang="en-US" dirty="0">
                <a:ea typeface="+mn-lt"/>
                <a:cs typeface="+mn-lt"/>
                <a:hlinkClick r:id="rId2"/>
              </a:rPr>
              <a:t>https://patientprioritiescare.org/about/</a:t>
            </a:r>
            <a:r>
              <a:rPr lang="en-US" dirty="0">
                <a:ea typeface="+mn-lt"/>
                <a:cs typeface="+mn-lt"/>
              </a:rPr>
              <a:t> </a:t>
            </a:r>
          </a:p>
          <a:p>
            <a:pPr lvl="1"/>
            <a:r>
              <a:rPr lang="en-US" dirty="0">
                <a:ea typeface="+mn-lt"/>
                <a:cs typeface="+mn-lt"/>
              </a:rPr>
              <a:t>Guide for patients and clinicians</a:t>
            </a:r>
          </a:p>
          <a:p>
            <a:pPr lvl="1"/>
            <a:r>
              <a:rPr lang="en-US" dirty="0">
                <a:ea typeface="+mn-lt"/>
                <a:cs typeface="+mn-lt"/>
              </a:rPr>
              <a:t>5-steps</a:t>
            </a:r>
            <a:endParaRPr lang="en-US" dirty="0"/>
          </a:p>
          <a:p>
            <a:pPr lvl="2"/>
            <a:r>
              <a:rPr lang="en-US" dirty="0">
                <a:ea typeface="+mn-lt"/>
                <a:cs typeface="+mn-lt"/>
              </a:rPr>
              <a:t>Exploring what matters most</a:t>
            </a:r>
          </a:p>
          <a:p>
            <a:pPr lvl="2"/>
            <a:r>
              <a:rPr lang="en-US" dirty="0">
                <a:ea typeface="+mn-lt"/>
                <a:cs typeface="+mn-lt"/>
              </a:rPr>
              <a:t>Setting meaningful health goals</a:t>
            </a:r>
          </a:p>
          <a:p>
            <a:pPr lvl="2"/>
            <a:r>
              <a:rPr lang="en-US" dirty="0">
                <a:ea typeface="+mn-lt"/>
                <a:cs typeface="+mn-lt"/>
              </a:rPr>
              <a:t>What the patient is willing and not willing to do to meet their goals</a:t>
            </a:r>
            <a:endParaRPr lang="en-US" dirty="0">
              <a:cs typeface="Calibri"/>
            </a:endParaRPr>
          </a:p>
          <a:p>
            <a:pPr lvl="2"/>
            <a:r>
              <a:rPr lang="en-US" dirty="0">
                <a:ea typeface="+mn-lt"/>
                <a:cs typeface="+mn-lt"/>
              </a:rPr>
              <a:t>Communicating about the importance of meeting goals and healthcare preferences</a:t>
            </a:r>
            <a:endParaRPr lang="en-US" dirty="0">
              <a:cs typeface="Calibri" panose="020F0502020204030204"/>
            </a:endParaRPr>
          </a:p>
          <a:p>
            <a:pPr lvl="2"/>
            <a:r>
              <a:rPr lang="en-US" dirty="0">
                <a:ea typeface="+mn-lt"/>
                <a:cs typeface="+mn-lt"/>
              </a:rPr>
              <a:t>Adapting current healthcare to the patient’s overall health priorities</a:t>
            </a:r>
            <a:endParaRPr lang="en-US" dirty="0">
              <a:cs typeface="Calibri" panose="020F0502020204030204"/>
            </a:endParaRPr>
          </a:p>
          <a:p>
            <a:r>
              <a:rPr lang="en-US" dirty="0">
                <a:ea typeface="+mn-lt"/>
                <a:cs typeface="+mn-lt"/>
                <a:hlinkClick r:id="rId3"/>
              </a:rPr>
              <a:t>www.prepareforyourcare.org</a:t>
            </a:r>
            <a:r>
              <a:rPr lang="en-US">
                <a:ea typeface="+mn-lt"/>
                <a:cs typeface="+mn-lt"/>
              </a:rPr>
              <a:t>   </a:t>
            </a:r>
          </a:p>
          <a:p>
            <a:pPr lvl="1"/>
            <a:r>
              <a:rPr lang="en-US" dirty="0">
                <a:ea typeface="+mn-lt"/>
                <a:cs typeface="+mn-lt"/>
              </a:rPr>
              <a:t>Guide for patients</a:t>
            </a:r>
          </a:p>
          <a:p>
            <a:pPr lvl="1"/>
            <a:r>
              <a:rPr lang="en-US" dirty="0">
                <a:ea typeface="+mn-lt"/>
                <a:cs typeface="+mn-lt"/>
              </a:rPr>
              <a:t>Provides video</a:t>
            </a:r>
            <a:r>
              <a:rPr lang="en-US" dirty="0">
                <a:cs typeface="Calibri"/>
              </a:rPr>
              <a:t> guidance addressing 5-steps including:</a:t>
            </a:r>
          </a:p>
          <a:p>
            <a:pPr lvl="2"/>
            <a:r>
              <a:rPr lang="en-US" dirty="0">
                <a:ea typeface="+mn-lt"/>
                <a:cs typeface="+mn-lt"/>
              </a:rPr>
              <a:t>Designating a medical decision maker with links to State Specific Legal Documents</a:t>
            </a:r>
            <a:endParaRPr lang="en-US" dirty="0"/>
          </a:p>
          <a:p>
            <a:pPr lvl="2"/>
            <a:r>
              <a:rPr lang="en-US" dirty="0">
                <a:ea typeface="+mn-lt"/>
                <a:cs typeface="+mn-lt"/>
              </a:rPr>
              <a:t>Summary of Wishes</a:t>
            </a:r>
          </a:p>
        </p:txBody>
      </p:sp>
    </p:spTree>
    <p:extLst>
      <p:ext uri="{BB962C8B-B14F-4D97-AF65-F5344CB8AC3E}">
        <p14:creationId xmlns:p14="http://schemas.microsoft.com/office/powerpoint/2010/main" val="2584455186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780179-0182-4210-AB55-A169922803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93555" y="620392"/>
            <a:ext cx="2856201" cy="5504688"/>
          </a:xfrm>
        </p:spPr>
        <p:txBody>
          <a:bodyPr>
            <a:normAutofit/>
          </a:bodyPr>
          <a:lstStyle/>
          <a:p>
            <a:r>
              <a:rPr lang="en-US" sz="5200" b="1" dirty="0">
                <a:solidFill>
                  <a:schemeClr val="accent5"/>
                </a:solidFill>
                <a:ea typeface="+mj-lt"/>
                <a:cs typeface="+mj-lt"/>
              </a:rPr>
              <a:t>Take Home Points</a:t>
            </a:r>
            <a:endParaRPr lang="en-US" sz="5200" dirty="0">
              <a:solidFill>
                <a:schemeClr val="accent5"/>
              </a:solidFill>
            </a:endParaRPr>
          </a:p>
        </p:txBody>
      </p:sp>
      <p:graphicFrame>
        <p:nvGraphicFramePr>
          <p:cNvPr id="5" name="Content Placeholder 2">
            <a:extLst>
              <a:ext uri="{FF2B5EF4-FFF2-40B4-BE49-F238E27FC236}">
                <a16:creationId xmlns:a16="http://schemas.microsoft.com/office/drawing/2014/main" id="{DD58BD53-D491-4E27-8E29-0A4691C5DA68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157582219"/>
              </p:ext>
            </p:extLst>
          </p:nvPr>
        </p:nvGraphicFramePr>
        <p:xfrm>
          <a:off x="3819906" y="620392"/>
          <a:ext cx="4697730" cy="5504688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3380947776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780179-0182-4210-AB55-A169922803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93555" y="620392"/>
            <a:ext cx="2856201" cy="5504688"/>
          </a:xfrm>
        </p:spPr>
        <p:txBody>
          <a:bodyPr>
            <a:normAutofit/>
          </a:bodyPr>
          <a:lstStyle/>
          <a:p>
            <a:r>
              <a:rPr lang="en-US" b="1" dirty="0">
                <a:solidFill>
                  <a:schemeClr val="accent5"/>
                </a:solidFill>
                <a:ea typeface="+mj-lt"/>
                <a:cs typeface="+mj-lt"/>
              </a:rPr>
              <a:t>Take Home Points</a:t>
            </a:r>
            <a:br>
              <a:rPr lang="en-US" b="1" dirty="0">
                <a:ea typeface="+mj-lt"/>
                <a:cs typeface="+mj-lt"/>
              </a:rPr>
            </a:br>
            <a:r>
              <a:rPr lang="en-US" sz="2400" b="1" dirty="0">
                <a:solidFill>
                  <a:schemeClr val="accent5"/>
                </a:solidFill>
                <a:ea typeface="+mj-lt"/>
                <a:cs typeface="+mj-lt"/>
              </a:rPr>
              <a:t>(continued)</a:t>
            </a:r>
            <a:endParaRPr lang="en-US" sz="4000" dirty="0">
              <a:solidFill>
                <a:schemeClr val="accent5"/>
              </a:solidFill>
              <a:cs typeface="Calibri Light"/>
            </a:endParaRPr>
          </a:p>
        </p:txBody>
      </p:sp>
      <p:graphicFrame>
        <p:nvGraphicFramePr>
          <p:cNvPr id="5" name="Content Placeholder 2">
            <a:extLst>
              <a:ext uri="{FF2B5EF4-FFF2-40B4-BE49-F238E27FC236}">
                <a16:creationId xmlns:a16="http://schemas.microsoft.com/office/drawing/2014/main" id="{0ADEBD4D-C405-418D-A69A-EFB34A29C241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550253002"/>
              </p:ext>
            </p:extLst>
          </p:nvPr>
        </p:nvGraphicFramePr>
        <p:xfrm>
          <a:off x="3890851" y="880523"/>
          <a:ext cx="4697730" cy="5504688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sp>
        <p:nvSpPr>
          <p:cNvPr id="174" name="TextBox 173">
            <a:extLst>
              <a:ext uri="{FF2B5EF4-FFF2-40B4-BE49-F238E27FC236}">
                <a16:creationId xmlns:a16="http://schemas.microsoft.com/office/drawing/2014/main" id="{EE82F5CD-5D44-44C5-99D2-7F62A3C64B55}"/>
              </a:ext>
            </a:extLst>
          </p:cNvPr>
          <p:cNvSpPr txBox="1"/>
          <p:nvPr/>
        </p:nvSpPr>
        <p:spPr>
          <a:xfrm>
            <a:off x="3247696" y="268013"/>
            <a:ext cx="6282557" cy="52322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2800" b="1" dirty="0">
                <a:solidFill>
                  <a:srgbClr val="040404"/>
                </a:solidFill>
              </a:rPr>
              <a:t>The 4Ms of the Geriatric Assessment</a:t>
            </a:r>
            <a:endParaRPr lang="en-US" sz="2800" b="1" dirty="0"/>
          </a:p>
        </p:txBody>
      </p:sp>
    </p:spTree>
    <p:extLst>
      <p:ext uri="{BB962C8B-B14F-4D97-AF65-F5344CB8AC3E}">
        <p14:creationId xmlns:p14="http://schemas.microsoft.com/office/powerpoint/2010/main" val="14552242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4900" b="1" dirty="0">
                <a:solidFill>
                  <a:schemeClr val="accent1"/>
                </a:solidFill>
              </a:rPr>
              <a:t>Geriatric Medicin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/>
        <p:txBody>
          <a:bodyPr vert="horz" lIns="0" tIns="0" rIns="0" bIns="0" rtlCol="0" anchor="t">
            <a:noAutofit/>
          </a:bodyPr>
          <a:lstStyle/>
          <a:p>
            <a:pPr marL="285750" indent="-285750"/>
            <a:r>
              <a:rPr lang="en-US" sz="2400" b="1" dirty="0"/>
              <a:t>Focus </a:t>
            </a:r>
            <a:r>
              <a:rPr lang="en-US" sz="2400" dirty="0"/>
              <a:t>on diagnosis, treatment and prevention of disease in older people and studying the physical processes and problems specific to</a:t>
            </a:r>
            <a:r>
              <a:rPr lang="en-US" sz="2400" b="1" dirty="0"/>
              <a:t> </a:t>
            </a:r>
            <a:r>
              <a:rPr lang="en-US" sz="2400" dirty="0"/>
              <a:t>aging</a:t>
            </a:r>
            <a:endParaRPr lang="en-US" sz="2400" dirty="0">
              <a:cs typeface="Calibri" panose="020F0502020204030204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400" b="1" dirty="0"/>
              <a:t>Aging</a:t>
            </a:r>
            <a:r>
              <a:rPr lang="en-US" sz="2400" dirty="0"/>
              <a:t> in humans refers to a multidimensional process of physical, psychological and social change.</a:t>
            </a:r>
            <a:endParaRPr lang="en-US" sz="2400" dirty="0">
              <a:cs typeface="Calibri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400" dirty="0"/>
              <a:t>Requires a multi/interprofessional approach </a:t>
            </a:r>
            <a:endParaRPr lang="en-US" sz="2400" dirty="0">
              <a:cs typeface="Calibri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400" dirty="0"/>
              <a:t>Improves and focuses on health, independence, and quality of life of older adults</a:t>
            </a:r>
            <a:endParaRPr lang="en-US" sz="2400" dirty="0">
              <a:cs typeface="Calibri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400" dirty="0"/>
              <a:t>Addresses functional age not just chronological age</a:t>
            </a:r>
            <a:endParaRPr lang="en-US" sz="2400" dirty="0">
              <a:cs typeface="Calibri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613365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Flowchart: Document 16">
            <a:extLst>
              <a:ext uri="{FF2B5EF4-FFF2-40B4-BE49-F238E27FC236}">
                <a16:creationId xmlns:a16="http://schemas.microsoft.com/office/drawing/2014/main" id="{D12DDE76-C203-4047-9998-63900085B5E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78631" y="0"/>
            <a:ext cx="2436019" cy="3400426"/>
          </a:xfrm>
          <a:prstGeom prst="flowChartDocument">
            <a:avLst/>
          </a:prstGeom>
          <a:solidFill>
            <a:srgbClr val="282B6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8650" y="171162"/>
            <a:ext cx="2130136" cy="2371148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2800" b="1" kern="1200">
                <a:solidFill>
                  <a:srgbClr val="FFFFFF"/>
                </a:solidFill>
                <a:latin typeface="+mj-lt"/>
                <a:ea typeface="+mj-ea"/>
                <a:cs typeface="+mj-cs"/>
              </a:rPr>
              <a:t>US Population Distribution Over 65 </a:t>
            </a:r>
            <a:br>
              <a:rPr lang="en-US" sz="2800" b="1" kern="1200">
                <a:solidFill>
                  <a:srgbClr val="FFFFFF"/>
                </a:solidFill>
                <a:latin typeface="+mj-lt"/>
                <a:ea typeface="+mj-ea"/>
                <a:cs typeface="+mj-cs"/>
              </a:rPr>
            </a:br>
            <a:r>
              <a:rPr lang="en-US" sz="2800" b="1" kern="1200">
                <a:solidFill>
                  <a:srgbClr val="FFFFFF"/>
                </a:solidFill>
                <a:latin typeface="+mj-lt"/>
                <a:ea typeface="+mj-ea"/>
                <a:cs typeface="+mj-cs"/>
              </a:rPr>
              <a:t>1950- 2050</a:t>
            </a:r>
            <a:endParaRPr lang="en-US" sz="2800" kern="1200">
              <a:solidFill>
                <a:srgbClr val="FFFFFF"/>
              </a:solidFill>
              <a:latin typeface="+mj-lt"/>
              <a:ea typeface="+mj-ea"/>
              <a:cs typeface="+mj-cs"/>
            </a:endParaRPr>
          </a:p>
        </p:txBody>
      </p:sp>
      <p:pic>
        <p:nvPicPr>
          <p:cNvPr id="5" name="Picture 5" descr="Chart, line chart&#10;&#10;Description automatically generated">
            <a:extLst>
              <a:ext uri="{FF2B5EF4-FFF2-40B4-BE49-F238E27FC236}">
                <a16:creationId xmlns:a16="http://schemas.microsoft.com/office/drawing/2014/main" id="{CDF35EC7-FE28-4B97-99F5-11B79C9B045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3064669" y="620109"/>
            <a:ext cx="6055712" cy="409411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FCFA2E4-A458-9866-F755-D443D717A02F}"/>
              </a:ext>
            </a:extLst>
          </p:cNvPr>
          <p:cNvSpPr txBox="1"/>
          <p:nvPr/>
        </p:nvSpPr>
        <p:spPr>
          <a:xfrm>
            <a:off x="473202" y="5783300"/>
            <a:ext cx="8564888" cy="2149400"/>
          </a:xfrm>
          <a:prstGeom prst="rect">
            <a:avLst/>
          </a:prstGeom>
        </p:spPr>
        <p:txBody>
          <a:bodyPr rot="0" spcFirstLastPara="0" vertOverflow="overflow" horzOverflow="overflow" vert="horz" lIns="91440" tIns="45720" rIns="91440" bIns="45720" numCol="1" spcCol="0" rtlCol="0" fromWordArt="0" anchor="t" anchorCtr="0" forceAA="0" compatLnSpc="1">
            <a:prstTxWarp prst="textNoShape">
              <a:avLst/>
            </a:prstTxWarp>
            <a:normAutofit/>
          </a:bodyPr>
          <a:lstStyle/>
          <a:p>
            <a:pPr indent="-228600" defTabSz="9144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200" dirty="0"/>
              <a:t>Image by Wikimedia commons, "Percentage of US Population Over Age 65 1950-2050", UN World Population Prospects 2008. Retrieved from: </a:t>
            </a:r>
            <a:r>
              <a:rPr lang="en-US" sz="1200" dirty="0">
                <a:hlinkClick r:id="rId4"/>
              </a:rPr>
              <a:t>https://commons.wikimedia.org/wiki/File:Percentage_of_US_Population_Over_Age_65_1950-2050.png</a:t>
            </a:r>
            <a:r>
              <a:rPr lang="en-US" sz="1200" dirty="0"/>
              <a:t> on August 2021. Creative Commons Attribution 3.0 Unported license.</a:t>
            </a:r>
          </a:p>
        </p:txBody>
      </p:sp>
    </p:spTree>
    <p:extLst>
      <p:ext uri="{BB962C8B-B14F-4D97-AF65-F5344CB8AC3E}">
        <p14:creationId xmlns:p14="http://schemas.microsoft.com/office/powerpoint/2010/main" val="6592588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8008" y="206975"/>
            <a:ext cx="7886700" cy="1325563"/>
          </a:xfrm>
        </p:spPr>
        <p:txBody>
          <a:bodyPr/>
          <a:lstStyle/>
          <a:p>
            <a:pPr algn="ctr"/>
            <a:r>
              <a:rPr lang="en-US" sz="4000" b="1" dirty="0">
                <a:solidFill>
                  <a:schemeClr val="accent1"/>
                </a:solidFill>
                <a:ea typeface="+mj-lt"/>
                <a:cs typeface="+mj-lt"/>
              </a:rPr>
              <a:t>Impact of Chronic Illness</a:t>
            </a:r>
            <a:endParaRPr lang="en-US" sz="4000" b="1" dirty="0">
              <a:solidFill>
                <a:schemeClr val="accent1"/>
              </a:solidFill>
              <a:cs typeface="Calibri Light" panose="020F0302020204030204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82D95C8-4312-5A8A-7ED5-8D5288D73915}"/>
              </a:ext>
            </a:extLst>
          </p:cNvPr>
          <p:cNvSpPr txBox="1"/>
          <p:nvPr/>
        </p:nvSpPr>
        <p:spPr>
          <a:xfrm>
            <a:off x="488576" y="1710016"/>
            <a:ext cx="8178051" cy="526297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marL="285750" indent="-285750">
              <a:buFont typeface="Arial"/>
              <a:buChar char="•"/>
            </a:pPr>
            <a:r>
              <a:rPr lang="en-US" sz="2400" dirty="0">
                <a:ea typeface="+mn-lt"/>
                <a:cs typeface="+mn-lt"/>
              </a:rPr>
              <a:t>Older adults are more likely to experience multiple chronic diseases</a:t>
            </a:r>
            <a:endParaRPr lang="en-US" sz="2400" dirty="0">
              <a:cs typeface="Calibri" panose="020F0502020204030204"/>
            </a:endParaRPr>
          </a:p>
          <a:p>
            <a:endParaRPr lang="en-US" sz="2400" dirty="0">
              <a:ea typeface="+mn-lt"/>
              <a:cs typeface="+mn-lt"/>
            </a:endParaRPr>
          </a:p>
          <a:p>
            <a:pPr marL="285750" indent="-285750">
              <a:buFont typeface="Arial"/>
              <a:buChar char="•"/>
            </a:pPr>
            <a:r>
              <a:rPr lang="en-US" sz="2400" dirty="0">
                <a:ea typeface="+mn-lt"/>
                <a:cs typeface="+mn-lt"/>
              </a:rPr>
              <a:t>The presence of geriatric syndromes (cognitive impairment, falls, incontinence, vision or hearing impairment, etc.) are highly associated with dependency in activities of daily living </a:t>
            </a:r>
            <a:endParaRPr lang="en-US" sz="2400" dirty="0">
              <a:cs typeface="Calibri"/>
            </a:endParaRPr>
          </a:p>
          <a:p>
            <a:pPr marL="285750" indent="-285750">
              <a:buFont typeface="Arial"/>
              <a:buChar char="•"/>
            </a:pPr>
            <a:endParaRPr lang="en-US" sz="2400" dirty="0">
              <a:ea typeface="+mn-lt"/>
              <a:cs typeface="+mn-lt"/>
            </a:endParaRPr>
          </a:p>
          <a:p>
            <a:pPr marL="342900" indent="-342900">
              <a:buFont typeface="Arial"/>
              <a:buChar char="•"/>
            </a:pPr>
            <a:r>
              <a:rPr lang="en-US" sz="2800" b="1" dirty="0">
                <a:ea typeface="+mn-lt"/>
                <a:cs typeface="+mn-lt"/>
              </a:rPr>
              <a:t>Physicians must have the knowledge, skills and ability to work with an interprofessional team to address the needs of older adults - to help maximize quality of life and maintain independence</a:t>
            </a:r>
            <a:endParaRPr lang="en-US" sz="2800" b="1" dirty="0">
              <a:cs typeface="Calibri"/>
            </a:endParaRPr>
          </a:p>
          <a:p>
            <a:endParaRPr lang="en-US" sz="2000" b="1" dirty="0">
              <a:ea typeface="+mn-lt"/>
              <a:cs typeface="+mn-lt"/>
            </a:endParaRPr>
          </a:p>
          <a:p>
            <a:endParaRPr lang="en-US" dirty="0">
              <a:ea typeface="+mn-lt"/>
              <a:cs typeface="+mn-lt"/>
            </a:endParaRPr>
          </a:p>
          <a:p>
            <a:endParaRPr lang="en-US" dirty="0"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37500729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4900" b="1" dirty="0">
                <a:solidFill>
                  <a:schemeClr val="accent1"/>
                </a:solidFill>
              </a:rPr>
              <a:t>Case</a:t>
            </a:r>
            <a:r>
              <a:rPr lang="en-US" sz="4900" b="1" dirty="0">
                <a:solidFill>
                  <a:schemeClr val="accent1"/>
                </a:solidFill>
                <a:ea typeface="+mj-lt"/>
                <a:cs typeface="+mj-lt"/>
              </a:rPr>
              <a:t> Vignette #1</a:t>
            </a:r>
            <a:endParaRPr lang="en-US" dirty="0">
              <a:solidFill>
                <a:schemeClr val="accent1"/>
              </a:solidFill>
            </a:endParaRP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>
          <a:xfrm>
            <a:off x="628650" y="1983776"/>
            <a:ext cx="8179019" cy="4351338"/>
          </a:xfrm>
        </p:spPr>
        <p:txBody>
          <a:bodyPr vert="horz" lIns="0" tIns="0" rIns="0" bIns="0" rtlCol="0" anchor="t">
            <a:noAutofit/>
          </a:bodyPr>
          <a:lstStyle/>
          <a:p>
            <a:pPr>
              <a:buFont typeface="Arial,Sans-Serif" panose="020B0604020202020204" pitchFamily="34" charset="0"/>
              <a:buChar char="•"/>
            </a:pPr>
            <a:r>
              <a:rPr lang="en-US" dirty="0">
                <a:latin typeface="Calibri"/>
                <a:ea typeface="+mn-lt"/>
                <a:cs typeface="Calibri"/>
              </a:rPr>
              <a:t>Julia Cortes is a 78-year-old woman who presents to establish care accompanied by her son. She hasn’t seen a physician in over a year.</a:t>
            </a:r>
          </a:p>
          <a:p>
            <a:pPr>
              <a:buFont typeface="Arial,Sans-Serif" panose="020B0604020202020204" pitchFamily="34" charset="0"/>
              <a:buChar char="•"/>
            </a:pPr>
            <a:r>
              <a:rPr lang="en-US" dirty="0">
                <a:latin typeface="Calibri"/>
                <a:ea typeface="+mn-lt"/>
                <a:cs typeface="Calibri"/>
              </a:rPr>
              <a:t>Past medical history: Hypertension, Hyperlipidemia, and Depression</a:t>
            </a:r>
          </a:p>
          <a:p>
            <a:pPr>
              <a:buFont typeface="Arial,Sans-Serif" panose="020B0604020202020204" pitchFamily="34" charset="0"/>
              <a:buChar char="•"/>
            </a:pPr>
            <a:r>
              <a:rPr lang="en-US" dirty="0">
                <a:latin typeface="Calibri"/>
                <a:ea typeface="+mn-lt"/>
                <a:cs typeface="Calibri"/>
              </a:rPr>
              <a:t>Her son expresses concern about her missing her medications and not paying her bills on time.</a:t>
            </a:r>
            <a:r>
              <a:rPr lang="en-US" b="1" dirty="0">
                <a:latin typeface="Calibri"/>
                <a:ea typeface="+mn-lt"/>
                <a:cs typeface="Calibri"/>
              </a:rPr>
              <a:t> </a:t>
            </a:r>
            <a:endParaRPr lang="en-US" dirty="0">
              <a:latin typeface="Calibri"/>
              <a:cs typeface="Calibri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dirty="0">
              <a:latin typeface="Calibri"/>
              <a:cs typeface="Calibri"/>
            </a:endParaRPr>
          </a:p>
          <a:p>
            <a:endParaRPr lang="en-US" dirty="0">
              <a:latin typeface="Calibri"/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07195468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8650" y="523277"/>
            <a:ext cx="7886700" cy="1325563"/>
          </a:xfrm>
        </p:spPr>
        <p:txBody>
          <a:bodyPr>
            <a:normAutofit fontScale="90000"/>
          </a:bodyPr>
          <a:lstStyle/>
          <a:p>
            <a:pPr algn="ctr"/>
            <a:r>
              <a:rPr lang="en-US" sz="4900" b="1" dirty="0">
                <a:solidFill>
                  <a:schemeClr val="accent1"/>
                </a:solidFill>
                <a:ea typeface="+mj-lt"/>
                <a:cs typeface="+mj-lt"/>
              </a:rPr>
              <a:t>When to consider memory assessment? </a:t>
            </a:r>
            <a:endParaRPr lang="en-US" dirty="0">
              <a:solidFill>
                <a:schemeClr val="accent1"/>
              </a:solidFill>
            </a:endParaRP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>
          <a:xfrm>
            <a:off x="628650" y="1983776"/>
            <a:ext cx="7886700" cy="4351338"/>
          </a:xfrm>
        </p:spPr>
        <p:txBody>
          <a:bodyPr vert="horz" lIns="0" tIns="0" rIns="0" bIns="0" rtlCol="0" anchor="t">
            <a:noAutofit/>
          </a:bodyPr>
          <a:lstStyle/>
          <a:p>
            <a:pPr>
              <a:buFont typeface="Arial,Sans-Serif" panose="020B0604020202020204" pitchFamily="34" charset="0"/>
              <a:buChar char="•"/>
            </a:pPr>
            <a:endParaRPr lang="en-US" dirty="0">
              <a:solidFill>
                <a:schemeClr val="tx1">
                  <a:lumMod val="75000"/>
                </a:schemeClr>
              </a:solidFill>
              <a:latin typeface="Calibri Light"/>
              <a:ea typeface="+mn-lt"/>
              <a:cs typeface="+mn-lt"/>
            </a:endParaRPr>
          </a:p>
          <a:p>
            <a:pPr marL="457200" indent="-457200">
              <a:buFont typeface="Arial,Sans-Serif" panose="020B0604020202020204" pitchFamily="34" charset="0"/>
              <a:buChar char="•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During an </a:t>
            </a:r>
            <a:r>
              <a:rPr lang="en-US" b="1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annual visit</a:t>
            </a: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 to get a </a:t>
            </a:r>
            <a:r>
              <a:rPr lang="en-US" b="1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baseline</a:t>
            </a: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 on a geriatric patient for both mood and memory</a:t>
            </a:r>
          </a:p>
          <a:p>
            <a:pPr marL="457200" indent="-457200">
              <a:buFont typeface="Arial,Sans-Serif" panose="020B0604020202020204" pitchFamily="34" charset="0"/>
              <a:buChar char="•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If </a:t>
            </a:r>
            <a:r>
              <a:rPr lang="en-US" b="1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concerns are brought up by family</a:t>
            </a: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 or during doctor's office </a:t>
            </a:r>
            <a:endParaRPr lang="en-US" dirty="0">
              <a:solidFill>
                <a:schemeClr val="tx1">
                  <a:lumMod val="75000"/>
                </a:schemeClr>
              </a:solidFill>
            </a:endParaRPr>
          </a:p>
          <a:p>
            <a:pPr marL="457200" indent="-457200">
              <a:buFont typeface="Arial,Sans-Serif" panose="020B0604020202020204" pitchFamily="34" charset="0"/>
              <a:buChar char="•"/>
            </a:pPr>
            <a:r>
              <a:rPr lang="en-US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Monitor known </a:t>
            </a:r>
            <a:r>
              <a:rPr lang="en-US" b="1" dirty="0">
                <a:solidFill>
                  <a:schemeClr val="tx1">
                    <a:lumMod val="75000"/>
                  </a:schemeClr>
                </a:solidFill>
                <a:ea typeface="+mn-lt"/>
                <a:cs typeface="+mn-lt"/>
              </a:rPr>
              <a:t>diagnosis of dementia and to evaluate for progression of illness </a:t>
            </a:r>
            <a:endParaRPr lang="en-US" dirty="0">
              <a:solidFill>
                <a:schemeClr val="tx1">
                  <a:lumMod val="75000"/>
                </a:schemeClr>
              </a:solidFill>
              <a:ea typeface="+mn-lt"/>
              <a:cs typeface="+mn-lt"/>
            </a:endParaRPr>
          </a:p>
          <a:p>
            <a:pPr marL="0" indent="0">
              <a:buNone/>
            </a:pPr>
            <a:endParaRPr lang="en-US" b="1" dirty="0">
              <a:solidFill>
                <a:schemeClr val="tx1">
                  <a:lumMod val="75000"/>
                </a:schemeClr>
              </a:solidFill>
              <a:cs typeface="Calibri"/>
            </a:endParaRPr>
          </a:p>
          <a:p>
            <a:pPr>
              <a:buFont typeface="Arial,Sans-Serif" panose="020B0604020202020204" pitchFamily="34" charset="0"/>
              <a:buChar char="•"/>
            </a:pPr>
            <a:endParaRPr lang="en-US" dirty="0"/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0764566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DB7307-1746-4922-9F95-1D256AAE3C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58651" y="393465"/>
            <a:ext cx="7886700" cy="1325563"/>
          </a:xfrm>
        </p:spPr>
        <p:txBody>
          <a:bodyPr/>
          <a:lstStyle/>
          <a:p>
            <a:pPr algn="ctr">
              <a:lnSpc>
                <a:spcPct val="100000"/>
              </a:lnSpc>
              <a:spcBef>
                <a:spcPts val="0"/>
              </a:spcBef>
            </a:pPr>
            <a:r>
              <a:rPr lang="en-US" b="1" dirty="0">
                <a:solidFill>
                  <a:schemeClr val="accent1"/>
                </a:solidFill>
                <a:ea typeface="+mj-lt"/>
                <a:cs typeface="+mj-lt"/>
              </a:rPr>
              <a:t>Mind/Memory/Mood Assessment</a:t>
            </a:r>
            <a:endParaRPr lang="en-US" dirty="0">
              <a:solidFill>
                <a:schemeClr val="accent1"/>
              </a:solidFill>
              <a:ea typeface="+mj-lt"/>
              <a:cs typeface="+mj-lt"/>
            </a:endParaRPr>
          </a:p>
          <a:p>
            <a:endParaRPr lang="en-US" dirty="0">
              <a:cs typeface="Calibri Light"/>
            </a:endParaRP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EDFBA1-7150-400B-8F65-B9FCC70F6A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52289" y="1504153"/>
            <a:ext cx="4056990" cy="823912"/>
          </a:xfrm>
        </p:spPr>
        <p:txBody>
          <a:bodyPr>
            <a:noAutofit/>
          </a:bodyPr>
          <a:lstStyle/>
          <a:p>
            <a:pPr algn="ctr">
              <a:lnSpc>
                <a:spcPct val="100000"/>
              </a:lnSpc>
              <a:spcBef>
                <a:spcPts val="0"/>
              </a:spcBef>
            </a:pPr>
            <a:r>
              <a:rPr lang="en-US" sz="2800" dirty="0">
                <a:ea typeface="+mn-lt"/>
                <a:cs typeface="+mn-lt"/>
              </a:rPr>
              <a:t>Cognitive Screening and Assessment Tool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F87B560-4C68-4A2F-B481-48FC61CDA60E}"/>
              </a:ext>
            </a:extLst>
          </p:cNvPr>
          <p:cNvSpPr>
            <a:spLocks noGrp="1"/>
          </p:cNvSpPr>
          <p:nvPr>
            <p:ph sz="half" idx="2"/>
          </p:nvPr>
        </p:nvSpPr>
        <p:spPr/>
        <p:txBody>
          <a:bodyPr vert="horz" lIns="91440" tIns="45720" rIns="91440" bIns="45720" rtlCol="0" anchor="t">
            <a:normAutofit/>
          </a:bodyPr>
          <a:lstStyle/>
          <a:p>
            <a:pPr marL="342900" indent="-342900">
              <a:lnSpc>
                <a:spcPct val="100000"/>
              </a:lnSpc>
              <a:spcBef>
                <a:spcPts val="0"/>
              </a:spcBef>
              <a:buFont typeface="Arial,Sans-Serif" panose="020B0604020202020204" pitchFamily="34" charset="0"/>
            </a:pPr>
            <a:r>
              <a:rPr lang="en-US" dirty="0">
                <a:ea typeface="+mn-lt"/>
                <a:cs typeface="+mn-lt"/>
              </a:rPr>
              <a:t>Mini Cognitive Assessment (Mini-Cog)</a:t>
            </a:r>
          </a:p>
          <a:p>
            <a:pPr marL="342900" indent="-342900">
              <a:lnSpc>
                <a:spcPct val="100000"/>
              </a:lnSpc>
              <a:spcBef>
                <a:spcPts val="0"/>
              </a:spcBef>
              <a:buFont typeface="Arial,Sans-Serif" panose="020B0604020202020204" pitchFamily="34" charset="0"/>
            </a:pPr>
            <a:r>
              <a:rPr lang="en-US" dirty="0">
                <a:ea typeface="+mn-lt"/>
                <a:cs typeface="+mn-lt"/>
              </a:rPr>
              <a:t>Mini Mental State Exam (MMSE)</a:t>
            </a:r>
            <a:endParaRPr lang="en-US" dirty="0">
              <a:cs typeface="Calibri" panose="020F0502020204030204"/>
            </a:endParaRPr>
          </a:p>
          <a:p>
            <a:pPr marL="342900" indent="-342900">
              <a:lnSpc>
                <a:spcPct val="100000"/>
              </a:lnSpc>
              <a:spcBef>
                <a:spcPts val="0"/>
              </a:spcBef>
              <a:buFont typeface="Arial,Sans-Serif" panose="020B0604020202020204" pitchFamily="34" charset="0"/>
            </a:pPr>
            <a:r>
              <a:rPr lang="en-US" dirty="0">
                <a:ea typeface="+mn-lt"/>
                <a:cs typeface="+mn-lt"/>
              </a:rPr>
              <a:t>Montreal Cognitive Assessment (MoCA)</a:t>
            </a:r>
            <a:endParaRPr lang="en-US" dirty="0">
              <a:cs typeface="Calibri" panose="020F0502020204030204"/>
            </a:endParaRP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27BCAED-3F39-4CA1-90F6-B019F51809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507143"/>
            <a:ext cx="3887391" cy="823912"/>
          </a:xfrm>
        </p:spPr>
        <p:txBody>
          <a:bodyPr>
            <a:noAutofit/>
          </a:bodyPr>
          <a:lstStyle/>
          <a:p>
            <a:pPr algn="ctr">
              <a:lnSpc>
                <a:spcPct val="100000"/>
              </a:lnSpc>
              <a:spcBef>
                <a:spcPts val="0"/>
              </a:spcBef>
            </a:pPr>
            <a:r>
              <a:rPr lang="en-US" sz="2800" dirty="0">
                <a:cs typeface="Calibri"/>
              </a:rPr>
              <a:t>Depression Screening Tool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8B8DFB9-1F78-4DD6-8614-43290A1C6FC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4157498" cy="3684588"/>
          </a:xfrm>
        </p:spPr>
        <p:txBody>
          <a:bodyPr vert="horz" lIns="91440" tIns="45720" rIns="91440" bIns="45720" rtlCol="0" anchor="t">
            <a:normAutofit/>
          </a:bodyPr>
          <a:lstStyle/>
          <a:p>
            <a:pPr marL="742950" lvl="1" indent="-457200">
              <a:lnSpc>
                <a:spcPct val="100000"/>
              </a:lnSpc>
              <a:spcBef>
                <a:spcPts val="0"/>
              </a:spcBef>
              <a:buFont typeface="Arial,Sans-Serif" panose="020B0604020202020204" pitchFamily="34" charset="0"/>
            </a:pPr>
            <a:r>
              <a:rPr lang="en-US" sz="2800" dirty="0">
                <a:ea typeface="+mn-lt"/>
                <a:cs typeface="+mn-lt"/>
              </a:rPr>
              <a:t>Patient Health Questionnaire (PHQ9)</a:t>
            </a:r>
          </a:p>
          <a:p>
            <a:pPr marL="742950" lvl="1" indent="-457200">
              <a:lnSpc>
                <a:spcPct val="100000"/>
              </a:lnSpc>
              <a:spcBef>
                <a:spcPts val="0"/>
              </a:spcBef>
              <a:buFont typeface="Arial,Sans-Serif" panose="020B0604020202020204" pitchFamily="34" charset="0"/>
            </a:pPr>
            <a:r>
              <a:rPr lang="en-US" sz="2800" dirty="0">
                <a:ea typeface="+mn-lt"/>
                <a:cs typeface="+mn-lt"/>
              </a:rPr>
              <a:t>Geriatric Depression Scale (GDS)</a:t>
            </a:r>
            <a:endParaRPr lang="en-US" sz="28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E6E634D-2125-44BD-9263-CAA78BF43F72}"/>
              </a:ext>
            </a:extLst>
          </p:cNvPr>
          <p:cNvSpPr txBox="1"/>
          <p:nvPr/>
        </p:nvSpPr>
        <p:spPr>
          <a:xfrm>
            <a:off x="458986" y="152298"/>
            <a:ext cx="8220186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894328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nwh_masterbrand_ppt_blue_4x3_161212</Template>
  <TotalTime>25</TotalTime>
  <Words>2364</Words>
  <Application>Microsoft Macintosh PowerPoint</Application>
  <PresentationFormat>On-screen Show (4:3)</PresentationFormat>
  <Paragraphs>356</Paragraphs>
  <Slides>37</Slides>
  <Notes>28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7</vt:i4>
      </vt:variant>
    </vt:vector>
  </HeadingPairs>
  <TitlesOfParts>
    <vt:vector size="44" baseType="lpstr">
      <vt:lpstr>Arial</vt:lpstr>
      <vt:lpstr>Arial,Sans-Serif</vt:lpstr>
      <vt:lpstr>Calibri</vt:lpstr>
      <vt:lpstr>Calibri Light</vt:lpstr>
      <vt:lpstr>Courier New,monospace</vt:lpstr>
      <vt:lpstr>Wingdings,Sans-Serif</vt:lpstr>
      <vt:lpstr>Office Theme</vt:lpstr>
      <vt:lpstr>PowerPoint Presentation</vt:lpstr>
      <vt:lpstr>PowerPoint Presentation</vt:lpstr>
      <vt:lpstr>PowerPoint Presentation</vt:lpstr>
      <vt:lpstr>Geriatric Medicine</vt:lpstr>
      <vt:lpstr>US Population Distribution Over 65  1950- 2050</vt:lpstr>
      <vt:lpstr>Impact of Chronic Illness</vt:lpstr>
      <vt:lpstr>Case Vignette #1</vt:lpstr>
      <vt:lpstr>When to consider memory assessment? </vt:lpstr>
      <vt:lpstr>Mind/Memory/Mood Assessment </vt:lpstr>
      <vt:lpstr>Mini-Mental State Exam(MMSE)</vt:lpstr>
      <vt:lpstr>Pseudodementia</vt:lpstr>
      <vt:lpstr>Case Vignette #1 Mind/Memory Assessment  BREAKOUT SESSION </vt:lpstr>
      <vt:lpstr>Vignette #1 Debrief</vt:lpstr>
      <vt:lpstr>Summary: Mind/Memory Assessment</vt:lpstr>
      <vt:lpstr>Case Vignette #2</vt:lpstr>
      <vt:lpstr>Case Vignette #2 Medication List</vt:lpstr>
      <vt:lpstr>Medication Assessment</vt:lpstr>
      <vt:lpstr>Pharmacokinetic Changes  with Age</vt:lpstr>
      <vt:lpstr>PowerPoint Presentation</vt:lpstr>
      <vt:lpstr>Case Vignette #2 - Medication Assessment  BREAKOUT SESSION </vt:lpstr>
      <vt:lpstr>Summary: Medication Assessment</vt:lpstr>
      <vt:lpstr>Case Vignette #3</vt:lpstr>
      <vt:lpstr>Falls in the Older Adult</vt:lpstr>
      <vt:lpstr>Activities of Daily Living (ADL) Instrumental Activities of Daily Living (IADL) </vt:lpstr>
      <vt:lpstr>Mobility Assessment  </vt:lpstr>
      <vt:lpstr>Fall History</vt:lpstr>
      <vt:lpstr>Case Vignette #3 - Mobility BREAKOUT SESSION </vt:lpstr>
      <vt:lpstr>Debrief: Mobility Assessment</vt:lpstr>
      <vt:lpstr>Mobility Assessment – Physical Exam component </vt:lpstr>
      <vt:lpstr>Case Vignette # 4</vt:lpstr>
      <vt:lpstr>Comprehensive Geriatric Assessment</vt:lpstr>
      <vt:lpstr>What Matters Most Advanced Care Planning - Review </vt:lpstr>
      <vt:lpstr>MOLST  Medical Orders of Life Sustaining Treatment</vt:lpstr>
      <vt:lpstr>The 5 Wishes</vt:lpstr>
      <vt:lpstr>Additional Resources for Advance Care Planning</vt:lpstr>
      <vt:lpstr>Take Home Points</vt:lpstr>
      <vt:lpstr>Take Home Points (continued)</vt:lpstr>
    </vt:vector>
  </TitlesOfParts>
  <Company>Northwell Healt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itle Case, 30pt Calibri Bold, NWH Gray Sentence Case, 30pt Calibri, NWH Gray</dc:title>
  <dc:creator>Roofeh, Regina</dc:creator>
  <cp:lastModifiedBy>Gabrielle Goldberg</cp:lastModifiedBy>
  <cp:revision>203</cp:revision>
  <cp:lastPrinted>2020-01-17T19:35:08Z</cp:lastPrinted>
  <dcterms:created xsi:type="dcterms:W3CDTF">2017-10-09T12:59:18Z</dcterms:created>
  <dcterms:modified xsi:type="dcterms:W3CDTF">2022-04-22T15:02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NewReviewCycle">
    <vt:lpwstr/>
  </property>
</Properties>
</file>